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62" r:id="rId2"/>
    <p:sldId id="264" r:id="rId3"/>
    <p:sldId id="265" r:id="rId4"/>
    <p:sldId id="356" r:id="rId5"/>
    <p:sldId id="257" r:id="rId6"/>
    <p:sldId id="258" r:id="rId7"/>
    <p:sldId id="299" r:id="rId8"/>
    <p:sldId id="371" r:id="rId9"/>
    <p:sldId id="372" r:id="rId10"/>
    <p:sldId id="365" r:id="rId11"/>
    <p:sldId id="369" r:id="rId12"/>
    <p:sldId id="358" r:id="rId13"/>
  </p:sldIdLst>
  <p:sldSz cx="12192000" cy="6858000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F2BAA8"/>
    <a:srgbClr val="BB5611"/>
    <a:srgbClr val="183775"/>
    <a:srgbClr val="D8DFFB"/>
    <a:srgbClr val="EA7F54"/>
    <a:srgbClr val="FFFFFF"/>
    <a:srgbClr val="BFBFBF"/>
    <a:srgbClr val="643215"/>
    <a:srgbClr val="A8BD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97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76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2020.05.03%20FT2018%20T2%20T3%20T4%20mol%5e1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\\salt\omega-3-flagship\11.%20MANUSCRIPT\1.%20%202018%20FT%202019.12.01\As%20submitted%20(JAN)\SS%20singe%20seed%20DHA%20series__Lihua%20edit%20Figure%20S7+S8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\\salt\omega-3-flagship\17.%20PEOPLE\Peter%20Robertson\Manuscript%20help\old%20files\EPA%20lines%20updated__Figure%20S7.%20S8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alt\lipids115\2.%20CAMELINA%20Omega-3%20Project\4.%20%20Susana%20-%20FAME&amp;TAG\TAG%20-%20Field%20Trial%202018\TAG_FT18-05-09112020%20-%20Analysed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424344650ccb3b4/Documents/DHA%2015%20single%20seed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298737466425405E-2"/>
          <c:y val="3.8541848935549718E-2"/>
          <c:w val="0.89240626724519279"/>
          <c:h val="0.838419240639647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ppl. Greenhouse charts'!$X$7</c:f>
              <c:strCache>
                <c:ptCount val="1"/>
                <c:pt idx="0">
                  <c:v>GH_WT</c:v>
                </c:pt>
              </c:strCache>
            </c:strRef>
          </c:tx>
          <c:spPr>
            <a:solidFill>
              <a:srgbClr val="BFBFB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15:$AM$15</c:f>
                <c:numCache>
                  <c:formatCode>General</c:formatCode>
                  <c:ptCount val="15"/>
                  <c:pt idx="0">
                    <c:v>0.36410937106143687</c:v>
                  </c:pt>
                  <c:pt idx="1">
                    <c:v>9.3863043413392674E-2</c:v>
                  </c:pt>
                  <c:pt idx="2">
                    <c:v>0.35898563932047173</c:v>
                  </c:pt>
                  <c:pt idx="3">
                    <c:v>0.57800063028875204</c:v>
                  </c:pt>
                  <c:pt idx="4">
                    <c:v>0</c:v>
                  </c:pt>
                  <c:pt idx="5">
                    <c:v>0.77806637065733364</c:v>
                  </c:pt>
                  <c:pt idx="6">
                    <c:v>0</c:v>
                  </c:pt>
                  <c:pt idx="7">
                    <c:v>0.49524757571612221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35073039938635298</c:v>
                  </c:pt>
                </c:numCache>
              </c:numRef>
            </c:plus>
            <c:minus>
              <c:numRef>
                <c:f>'Suppl. Greenhouse charts'!$Y$15:$AM$15</c:f>
                <c:numCache>
                  <c:formatCode>General</c:formatCode>
                  <c:ptCount val="15"/>
                  <c:pt idx="0">
                    <c:v>0.36410937106143687</c:v>
                  </c:pt>
                  <c:pt idx="1">
                    <c:v>9.3863043413392674E-2</c:v>
                  </c:pt>
                  <c:pt idx="2">
                    <c:v>0.35898563932047173</c:v>
                  </c:pt>
                  <c:pt idx="3">
                    <c:v>0.57800063028875204</c:v>
                  </c:pt>
                  <c:pt idx="4">
                    <c:v>0</c:v>
                  </c:pt>
                  <c:pt idx="5">
                    <c:v>0.77806637065733364</c:v>
                  </c:pt>
                  <c:pt idx="6">
                    <c:v>0</c:v>
                  </c:pt>
                  <c:pt idx="7">
                    <c:v>0.49524757571612221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35073039938635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7:$AM$7</c:f>
              <c:numCache>
                <c:formatCode>0</c:formatCode>
                <c:ptCount val="15"/>
                <c:pt idx="0">
                  <c:v>7.8602916746462741</c:v>
                </c:pt>
                <c:pt idx="1">
                  <c:v>2.6956111089633947</c:v>
                </c:pt>
                <c:pt idx="2">
                  <c:v>12.17714359989237</c:v>
                </c:pt>
                <c:pt idx="3">
                  <c:v>23.455585641736963</c:v>
                </c:pt>
                <c:pt idx="4">
                  <c:v>0</c:v>
                </c:pt>
                <c:pt idx="5">
                  <c:v>36.528729484179024</c:v>
                </c:pt>
                <c:pt idx="6">
                  <c:v>0</c:v>
                </c:pt>
                <c:pt idx="7">
                  <c:v>9.519787123409571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7.7628513671724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A0-4098-B685-D1FDB4016371}"/>
            </c:ext>
          </c:extLst>
        </c:ser>
        <c:ser>
          <c:idx val="1"/>
          <c:order val="1"/>
          <c:tx>
            <c:strRef>
              <c:f>'Suppl. Greenhouse charts'!$X$8</c:f>
              <c:strCache>
                <c:ptCount val="1"/>
                <c:pt idx="0">
                  <c:v>GH_DHA2015.1</c:v>
                </c:pt>
              </c:strCache>
            </c:strRef>
          </c:tx>
          <c:spPr>
            <a:solidFill>
              <a:srgbClr val="18377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16:$AM$16</c:f>
                <c:numCache>
                  <c:formatCode>General</c:formatCode>
                  <c:ptCount val="15"/>
                  <c:pt idx="0">
                    <c:v>0.26919075203091936</c:v>
                  </c:pt>
                  <c:pt idx="1">
                    <c:v>0.19338233479628436</c:v>
                  </c:pt>
                  <c:pt idx="2">
                    <c:v>3.4477723209662206E-2</c:v>
                  </c:pt>
                  <c:pt idx="3">
                    <c:v>0.20074716583592664</c:v>
                  </c:pt>
                  <c:pt idx="4">
                    <c:v>0.21838791338823177</c:v>
                  </c:pt>
                  <c:pt idx="5">
                    <c:v>1.1521088625086726</c:v>
                  </c:pt>
                  <c:pt idx="6">
                    <c:v>0.19905137129397277</c:v>
                  </c:pt>
                  <c:pt idx="7">
                    <c:v>0.10012826048351439</c:v>
                  </c:pt>
                  <c:pt idx="8">
                    <c:v>2.9022275902828455E-2</c:v>
                  </c:pt>
                  <c:pt idx="9">
                    <c:v>9.3249844144547886E-2</c:v>
                  </c:pt>
                  <c:pt idx="10">
                    <c:v>0.13079627663740848</c:v>
                  </c:pt>
                  <c:pt idx="11">
                    <c:v>0.32297125328850307</c:v>
                  </c:pt>
                  <c:pt idx="12">
                    <c:v>0.17306167579056209</c:v>
                  </c:pt>
                  <c:pt idx="13">
                    <c:v>0.43582220458546411</c:v>
                  </c:pt>
                  <c:pt idx="14">
                    <c:v>0.13698534336894239</c:v>
                  </c:pt>
                </c:numCache>
              </c:numRef>
            </c:plus>
            <c:minus>
              <c:numRef>
                <c:f>'Suppl. Greenhouse charts'!$Y$16:$AM$16</c:f>
                <c:numCache>
                  <c:formatCode>General</c:formatCode>
                  <c:ptCount val="15"/>
                  <c:pt idx="0">
                    <c:v>0.26919075203091936</c:v>
                  </c:pt>
                  <c:pt idx="1">
                    <c:v>0.19338233479628436</c:v>
                  </c:pt>
                  <c:pt idx="2">
                    <c:v>3.4477723209662206E-2</c:v>
                  </c:pt>
                  <c:pt idx="3">
                    <c:v>0.20074716583592664</c:v>
                  </c:pt>
                  <c:pt idx="4">
                    <c:v>0.21838791338823177</c:v>
                  </c:pt>
                  <c:pt idx="5">
                    <c:v>1.1521088625086726</c:v>
                  </c:pt>
                  <c:pt idx="6">
                    <c:v>0.19905137129397277</c:v>
                  </c:pt>
                  <c:pt idx="7">
                    <c:v>0.10012826048351439</c:v>
                  </c:pt>
                  <c:pt idx="8">
                    <c:v>2.9022275902828455E-2</c:v>
                  </c:pt>
                  <c:pt idx="9">
                    <c:v>9.3249844144547886E-2</c:v>
                  </c:pt>
                  <c:pt idx="10">
                    <c:v>0.13079627663740848</c:v>
                  </c:pt>
                  <c:pt idx="11">
                    <c:v>0.32297125328850307</c:v>
                  </c:pt>
                  <c:pt idx="12">
                    <c:v>0.17306167579056209</c:v>
                  </c:pt>
                  <c:pt idx="13">
                    <c:v>0.43582220458546411</c:v>
                  </c:pt>
                  <c:pt idx="14">
                    <c:v>0.136985343368942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8:$AM$8</c:f>
              <c:numCache>
                <c:formatCode>0</c:formatCode>
                <c:ptCount val="15"/>
                <c:pt idx="0">
                  <c:v>7.941095269000872</c:v>
                </c:pt>
                <c:pt idx="1">
                  <c:v>3.7813781879781465</c:v>
                </c:pt>
                <c:pt idx="2">
                  <c:v>4.5986391629189827</c:v>
                </c:pt>
                <c:pt idx="3">
                  <c:v>17.423539673569138</c:v>
                </c:pt>
                <c:pt idx="4">
                  <c:v>2.2287769570542699</c:v>
                </c:pt>
                <c:pt idx="5">
                  <c:v>15.974853007439096</c:v>
                </c:pt>
                <c:pt idx="6">
                  <c:v>2.0768219735041833</c:v>
                </c:pt>
                <c:pt idx="7">
                  <c:v>5.0971156098771937</c:v>
                </c:pt>
                <c:pt idx="8">
                  <c:v>0.66660001678159198</c:v>
                </c:pt>
                <c:pt idx="9">
                  <c:v>2.3479094440396349</c:v>
                </c:pt>
                <c:pt idx="10">
                  <c:v>3.2230719675339716</c:v>
                </c:pt>
                <c:pt idx="11">
                  <c:v>9.1378225534281032</c:v>
                </c:pt>
                <c:pt idx="12">
                  <c:v>5.0907199954871736</c:v>
                </c:pt>
                <c:pt idx="13">
                  <c:v>10.106394813168421</c:v>
                </c:pt>
                <c:pt idx="14">
                  <c:v>10.3052613682192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1A0-4098-B685-D1FDB4016371}"/>
            </c:ext>
          </c:extLst>
        </c:ser>
        <c:ser>
          <c:idx val="2"/>
          <c:order val="2"/>
          <c:tx>
            <c:strRef>
              <c:f>'Suppl. Greenhouse charts'!$X$9</c:f>
              <c:strCache>
                <c:ptCount val="1"/>
                <c:pt idx="0">
                  <c:v>GH_DHA2015.2 </c:v>
                </c:pt>
              </c:strCache>
            </c:strRef>
          </c:tx>
          <c:spPr>
            <a:solidFill>
              <a:srgbClr val="395BA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17:$AM$17</c:f>
                <c:numCache>
                  <c:formatCode>General</c:formatCode>
                  <c:ptCount val="15"/>
                  <c:pt idx="0">
                    <c:v>0.13810816010739008</c:v>
                  </c:pt>
                  <c:pt idx="1">
                    <c:v>0.12473649218692223</c:v>
                  </c:pt>
                  <c:pt idx="2">
                    <c:v>0.1406016460886986</c:v>
                  </c:pt>
                  <c:pt idx="3">
                    <c:v>0.17118255424337586</c:v>
                  </c:pt>
                  <c:pt idx="4">
                    <c:v>0.60130767976099297</c:v>
                  </c:pt>
                  <c:pt idx="5">
                    <c:v>1.3241778414827179</c:v>
                  </c:pt>
                  <c:pt idx="6">
                    <c:v>0.9510719619701079</c:v>
                  </c:pt>
                  <c:pt idx="7">
                    <c:v>0.48693563106743237</c:v>
                  </c:pt>
                  <c:pt idx="8">
                    <c:v>0.29981254893864845</c:v>
                  </c:pt>
                  <c:pt idx="9">
                    <c:v>0</c:v>
                  </c:pt>
                  <c:pt idx="10">
                    <c:v>0.35020827101793889</c:v>
                  </c:pt>
                  <c:pt idx="11">
                    <c:v>0</c:v>
                  </c:pt>
                  <c:pt idx="12">
                    <c:v>0.31729637794922988</c:v>
                  </c:pt>
                  <c:pt idx="13">
                    <c:v>0</c:v>
                  </c:pt>
                  <c:pt idx="14">
                    <c:v>0.32733308693819496</c:v>
                  </c:pt>
                </c:numCache>
              </c:numRef>
            </c:plus>
            <c:minus>
              <c:numRef>
                <c:f>'Suppl. Greenhouse charts'!$Y$17:$AM$17</c:f>
                <c:numCache>
                  <c:formatCode>General</c:formatCode>
                  <c:ptCount val="15"/>
                  <c:pt idx="0">
                    <c:v>0.13810816010739008</c:v>
                  </c:pt>
                  <c:pt idx="1">
                    <c:v>0.12473649218692223</c:v>
                  </c:pt>
                  <c:pt idx="2">
                    <c:v>0.1406016460886986</c:v>
                  </c:pt>
                  <c:pt idx="3">
                    <c:v>0.17118255424337586</c:v>
                  </c:pt>
                  <c:pt idx="4">
                    <c:v>0.60130767976099297</c:v>
                  </c:pt>
                  <c:pt idx="5">
                    <c:v>1.3241778414827179</c:v>
                  </c:pt>
                  <c:pt idx="6">
                    <c:v>0.9510719619701079</c:v>
                  </c:pt>
                  <c:pt idx="7">
                    <c:v>0.48693563106743237</c:v>
                  </c:pt>
                  <c:pt idx="8">
                    <c:v>0.29981254893864845</c:v>
                  </c:pt>
                  <c:pt idx="9">
                    <c:v>0</c:v>
                  </c:pt>
                  <c:pt idx="10">
                    <c:v>0.35020827101793889</c:v>
                  </c:pt>
                  <c:pt idx="11">
                    <c:v>0</c:v>
                  </c:pt>
                  <c:pt idx="12">
                    <c:v>0.31729637794922988</c:v>
                  </c:pt>
                  <c:pt idx="13">
                    <c:v>0</c:v>
                  </c:pt>
                  <c:pt idx="14">
                    <c:v>0.327333086938194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9:$AM$9</c:f>
              <c:numCache>
                <c:formatCode>0</c:formatCode>
                <c:ptCount val="15"/>
                <c:pt idx="0">
                  <c:v>6.9525695710669426</c:v>
                </c:pt>
                <c:pt idx="1">
                  <c:v>2.5730217776073752</c:v>
                </c:pt>
                <c:pt idx="2">
                  <c:v>8.3830362734438104</c:v>
                </c:pt>
                <c:pt idx="3">
                  <c:v>12.117332687350682</c:v>
                </c:pt>
                <c:pt idx="4">
                  <c:v>13.871223998685585</c:v>
                </c:pt>
                <c:pt idx="5">
                  <c:v>15.599867200296936</c:v>
                </c:pt>
                <c:pt idx="6">
                  <c:v>20.388327698174503</c:v>
                </c:pt>
                <c:pt idx="7">
                  <c:v>8.1377477100739686</c:v>
                </c:pt>
                <c:pt idx="8">
                  <c:v>0.34248556161879606</c:v>
                </c:pt>
                <c:pt idx="9">
                  <c:v>0</c:v>
                </c:pt>
                <c:pt idx="10">
                  <c:v>0.39322351840569986</c:v>
                </c:pt>
                <c:pt idx="11">
                  <c:v>0</c:v>
                </c:pt>
                <c:pt idx="12">
                  <c:v>0.35581994876359085</c:v>
                </c:pt>
                <c:pt idx="13">
                  <c:v>0</c:v>
                </c:pt>
                <c:pt idx="14">
                  <c:v>10.885344054512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1A0-4098-B685-D1FDB4016371}"/>
            </c:ext>
          </c:extLst>
        </c:ser>
        <c:ser>
          <c:idx val="3"/>
          <c:order val="3"/>
          <c:tx>
            <c:strRef>
              <c:f>'Suppl. Greenhouse charts'!$X$10</c:f>
              <c:strCache>
                <c:ptCount val="1"/>
                <c:pt idx="0">
                  <c:v>GH_DHA2015.3</c:v>
                </c:pt>
              </c:strCache>
            </c:strRef>
          </c:tx>
          <c:spPr>
            <a:solidFill>
              <a:srgbClr val="6D89CB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18:$AM$18</c:f>
                <c:numCache>
                  <c:formatCode>General</c:formatCode>
                  <c:ptCount val="15"/>
                  <c:pt idx="0">
                    <c:v>2.1421711974269102E-2</c:v>
                  </c:pt>
                  <c:pt idx="1">
                    <c:v>6.4431175858061379E-2</c:v>
                  </c:pt>
                  <c:pt idx="2">
                    <c:v>0.64399226024774492</c:v>
                  </c:pt>
                  <c:pt idx="3">
                    <c:v>0.62566508610331562</c:v>
                  </c:pt>
                  <c:pt idx="4">
                    <c:v>6.8050426344708412E-2</c:v>
                  </c:pt>
                  <c:pt idx="5">
                    <c:v>0.52204207118371837</c:v>
                  </c:pt>
                  <c:pt idx="6">
                    <c:v>4.2436703154689358E-2</c:v>
                  </c:pt>
                  <c:pt idx="7">
                    <c:v>0.27057153873721579</c:v>
                  </c:pt>
                  <c:pt idx="8">
                    <c:v>0.10339487012709132</c:v>
                  </c:pt>
                  <c:pt idx="9">
                    <c:v>4.8846325345623283E-3</c:v>
                  </c:pt>
                  <c:pt idx="10">
                    <c:v>2.2891114089002244E-2</c:v>
                  </c:pt>
                  <c:pt idx="11">
                    <c:v>0.9798198874480234</c:v>
                  </c:pt>
                  <c:pt idx="12">
                    <c:v>3.081671294990436E-2</c:v>
                  </c:pt>
                  <c:pt idx="13">
                    <c:v>0.55321901801742901</c:v>
                  </c:pt>
                  <c:pt idx="14">
                    <c:v>0.12892831652173867</c:v>
                  </c:pt>
                </c:numCache>
              </c:numRef>
            </c:plus>
            <c:minus>
              <c:numRef>
                <c:f>'Suppl. Greenhouse charts'!$Y$18:$AM$18</c:f>
                <c:numCache>
                  <c:formatCode>General</c:formatCode>
                  <c:ptCount val="15"/>
                  <c:pt idx="0">
                    <c:v>2.1421711974269102E-2</c:v>
                  </c:pt>
                  <c:pt idx="1">
                    <c:v>6.4431175858061379E-2</c:v>
                  </c:pt>
                  <c:pt idx="2">
                    <c:v>0.64399226024774492</c:v>
                  </c:pt>
                  <c:pt idx="3">
                    <c:v>0.62566508610331562</c:v>
                  </c:pt>
                  <c:pt idx="4">
                    <c:v>6.8050426344708412E-2</c:v>
                  </c:pt>
                  <c:pt idx="5">
                    <c:v>0.52204207118371837</c:v>
                  </c:pt>
                  <c:pt idx="6">
                    <c:v>4.2436703154689358E-2</c:v>
                  </c:pt>
                  <c:pt idx="7">
                    <c:v>0.27057153873721579</c:v>
                  </c:pt>
                  <c:pt idx="8">
                    <c:v>0.10339487012709132</c:v>
                  </c:pt>
                  <c:pt idx="9">
                    <c:v>4.8846325345623283E-3</c:v>
                  </c:pt>
                  <c:pt idx="10">
                    <c:v>2.2891114089002244E-2</c:v>
                  </c:pt>
                  <c:pt idx="11">
                    <c:v>0.9798198874480234</c:v>
                  </c:pt>
                  <c:pt idx="12">
                    <c:v>3.081671294990436E-2</c:v>
                  </c:pt>
                  <c:pt idx="13">
                    <c:v>0.55321901801742901</c:v>
                  </c:pt>
                  <c:pt idx="14">
                    <c:v>0.12892831652173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10:$AM$10</c:f>
              <c:numCache>
                <c:formatCode>0</c:formatCode>
                <c:ptCount val="15"/>
                <c:pt idx="0">
                  <c:v>6.2025540978468001</c:v>
                </c:pt>
                <c:pt idx="1">
                  <c:v>4.0701540833839243</c:v>
                </c:pt>
                <c:pt idx="2">
                  <c:v>11.822107536012084</c:v>
                </c:pt>
                <c:pt idx="3">
                  <c:v>12.274004677040111</c:v>
                </c:pt>
                <c:pt idx="4">
                  <c:v>0.99107658437750257</c:v>
                </c:pt>
                <c:pt idx="5">
                  <c:v>10.790330944517777</c:v>
                </c:pt>
                <c:pt idx="6">
                  <c:v>1.3362579680196061</c:v>
                </c:pt>
                <c:pt idx="7">
                  <c:v>7.9953808878908275</c:v>
                </c:pt>
                <c:pt idx="8">
                  <c:v>1.4640385845456567</c:v>
                </c:pt>
                <c:pt idx="9">
                  <c:v>5.7981323783783187</c:v>
                </c:pt>
                <c:pt idx="10">
                  <c:v>2.6071590583848518</c:v>
                </c:pt>
                <c:pt idx="11">
                  <c:v>18.071860280161964</c:v>
                </c:pt>
                <c:pt idx="12">
                  <c:v>1.2649037863457591</c:v>
                </c:pt>
                <c:pt idx="13">
                  <c:v>3.9266284626642904</c:v>
                </c:pt>
                <c:pt idx="14">
                  <c:v>11.3854106704305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1A0-4098-B685-D1FDB4016371}"/>
            </c:ext>
          </c:extLst>
        </c:ser>
        <c:ser>
          <c:idx val="4"/>
          <c:order val="4"/>
          <c:tx>
            <c:strRef>
              <c:f>'Suppl. Greenhouse charts'!$X$11</c:f>
              <c:strCache>
                <c:ptCount val="1"/>
                <c:pt idx="0">
                  <c:v>GH_DHA2015.4 </c:v>
                </c:pt>
              </c:strCache>
            </c:strRef>
          </c:tx>
          <c:spPr>
            <a:solidFill>
              <a:srgbClr val="A8BDE7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19:$AM$19</c:f>
                <c:numCache>
                  <c:formatCode>General</c:formatCode>
                  <c:ptCount val="15"/>
                  <c:pt idx="0">
                    <c:v>0.25811384695673989</c:v>
                  </c:pt>
                  <c:pt idx="1">
                    <c:v>0.16457095557660398</c:v>
                  </c:pt>
                  <c:pt idx="2">
                    <c:v>0.37314243324136509</c:v>
                  </c:pt>
                  <c:pt idx="3">
                    <c:v>0.20340589785683577</c:v>
                  </c:pt>
                  <c:pt idx="4">
                    <c:v>0.88857142333483297</c:v>
                  </c:pt>
                  <c:pt idx="5">
                    <c:v>0.87242308418523229</c:v>
                  </c:pt>
                  <c:pt idx="6">
                    <c:v>1.2370599313424886</c:v>
                  </c:pt>
                  <c:pt idx="7">
                    <c:v>0.31726009771871622</c:v>
                  </c:pt>
                  <c:pt idx="8">
                    <c:v>0.18868461322210009</c:v>
                  </c:pt>
                  <c:pt idx="9">
                    <c:v>0.51664344260459205</c:v>
                  </c:pt>
                  <c:pt idx="10">
                    <c:v>0.26215800900193137</c:v>
                  </c:pt>
                  <c:pt idx="11">
                    <c:v>2.2185757586430532</c:v>
                  </c:pt>
                  <c:pt idx="12">
                    <c:v>6.7907046644407235E-2</c:v>
                  </c:pt>
                  <c:pt idx="13">
                    <c:v>0.28690458126998197</c:v>
                  </c:pt>
                  <c:pt idx="14">
                    <c:v>0.23059851667222711</c:v>
                  </c:pt>
                </c:numCache>
              </c:numRef>
            </c:plus>
            <c:minus>
              <c:numRef>
                <c:f>'Suppl. Greenhouse charts'!$Y$19:$AM$19</c:f>
                <c:numCache>
                  <c:formatCode>General</c:formatCode>
                  <c:ptCount val="15"/>
                  <c:pt idx="0">
                    <c:v>0.25811384695673989</c:v>
                  </c:pt>
                  <c:pt idx="1">
                    <c:v>0.16457095557660398</c:v>
                  </c:pt>
                  <c:pt idx="2">
                    <c:v>0.37314243324136509</c:v>
                  </c:pt>
                  <c:pt idx="3">
                    <c:v>0.20340589785683577</c:v>
                  </c:pt>
                  <c:pt idx="4">
                    <c:v>0.88857142333483297</c:v>
                  </c:pt>
                  <c:pt idx="5">
                    <c:v>0.87242308418523229</c:v>
                  </c:pt>
                  <c:pt idx="6">
                    <c:v>1.2370599313424886</c:v>
                  </c:pt>
                  <c:pt idx="7">
                    <c:v>0.31726009771871622</c:v>
                  </c:pt>
                  <c:pt idx="8">
                    <c:v>0.18868461322210009</c:v>
                  </c:pt>
                  <c:pt idx="9">
                    <c:v>0.51664344260459205</c:v>
                  </c:pt>
                  <c:pt idx="10">
                    <c:v>0.26215800900193137</c:v>
                  </c:pt>
                  <c:pt idx="11">
                    <c:v>2.2185757586430532</c:v>
                  </c:pt>
                  <c:pt idx="12">
                    <c:v>6.7907046644407235E-2</c:v>
                  </c:pt>
                  <c:pt idx="13">
                    <c:v>0.28690458126998197</c:v>
                  </c:pt>
                  <c:pt idx="14">
                    <c:v>0.230598516672227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11:$AM$11</c:f>
              <c:numCache>
                <c:formatCode>0</c:formatCode>
                <c:ptCount val="15"/>
                <c:pt idx="0">
                  <c:v>8.4721822617983324</c:v>
                </c:pt>
                <c:pt idx="1">
                  <c:v>2.8605242694068251</c:v>
                </c:pt>
                <c:pt idx="2">
                  <c:v>9.0695297211871573</c:v>
                </c:pt>
                <c:pt idx="3">
                  <c:v>16.628648759582116</c:v>
                </c:pt>
                <c:pt idx="4">
                  <c:v>5.0906553216003578</c:v>
                </c:pt>
                <c:pt idx="5">
                  <c:v>12.873013821535489</c:v>
                </c:pt>
                <c:pt idx="6">
                  <c:v>5.6277144505836416</c:v>
                </c:pt>
                <c:pt idx="7">
                  <c:v>5.854120927887462</c:v>
                </c:pt>
                <c:pt idx="8">
                  <c:v>1.5748348809972059</c:v>
                </c:pt>
                <c:pt idx="9">
                  <c:v>5.6831594793205147</c:v>
                </c:pt>
                <c:pt idx="10">
                  <c:v>2.2090705036016911</c:v>
                </c:pt>
                <c:pt idx="11">
                  <c:v>11.238361064387187</c:v>
                </c:pt>
                <c:pt idx="12">
                  <c:v>1.4441509025783208</c:v>
                </c:pt>
                <c:pt idx="13">
                  <c:v>1.5288929277476662</c:v>
                </c:pt>
                <c:pt idx="14">
                  <c:v>9.84514070778604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1A0-4098-B685-D1FDB4016371}"/>
            </c:ext>
          </c:extLst>
        </c:ser>
        <c:ser>
          <c:idx val="5"/>
          <c:order val="5"/>
          <c:tx>
            <c:strRef>
              <c:f>'Suppl. Greenhouse charts'!$X$12</c:f>
              <c:strCache>
                <c:ptCount val="1"/>
                <c:pt idx="0">
                  <c:v>GH_DHA2015.5 </c:v>
                </c:pt>
              </c:strCache>
            </c:strRef>
          </c:tx>
          <c:spPr>
            <a:solidFill>
              <a:srgbClr val="D8DFFB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20:$AM$20</c:f>
                <c:numCache>
                  <c:formatCode>General</c:formatCode>
                  <c:ptCount val="15"/>
                  <c:pt idx="0">
                    <c:v>0.27887744446159124</c:v>
                  </c:pt>
                  <c:pt idx="1">
                    <c:v>0.54666222284031141</c:v>
                  </c:pt>
                  <c:pt idx="2">
                    <c:v>4.9240653926941332E-2</c:v>
                  </c:pt>
                  <c:pt idx="3">
                    <c:v>0.16257792732050105</c:v>
                  </c:pt>
                  <c:pt idx="4">
                    <c:v>0.19799899930011586</c:v>
                  </c:pt>
                  <c:pt idx="5">
                    <c:v>0.6075247831791698</c:v>
                  </c:pt>
                  <c:pt idx="6">
                    <c:v>0.23990987522309645</c:v>
                  </c:pt>
                  <c:pt idx="7">
                    <c:v>9.4425280165650466E-2</c:v>
                  </c:pt>
                  <c:pt idx="8">
                    <c:v>3.8514788666844664E-2</c:v>
                  </c:pt>
                  <c:pt idx="9">
                    <c:v>0.14935337465358631</c:v>
                  </c:pt>
                  <c:pt idx="10">
                    <c:v>0.10045800408195764</c:v>
                  </c:pt>
                  <c:pt idx="11">
                    <c:v>0.13306852059101767</c:v>
                  </c:pt>
                  <c:pt idx="12">
                    <c:v>0.23754288213895322</c:v>
                  </c:pt>
                  <c:pt idx="13">
                    <c:v>0.37117436033723272</c:v>
                  </c:pt>
                  <c:pt idx="14">
                    <c:v>0.84499765859700937</c:v>
                  </c:pt>
                </c:numCache>
              </c:numRef>
            </c:plus>
            <c:minus>
              <c:numRef>
                <c:f>'Suppl. Greenhouse charts'!$Y$20:$AM$20</c:f>
                <c:numCache>
                  <c:formatCode>General</c:formatCode>
                  <c:ptCount val="15"/>
                  <c:pt idx="0">
                    <c:v>0.27887744446159124</c:v>
                  </c:pt>
                  <c:pt idx="1">
                    <c:v>0.54666222284031141</c:v>
                  </c:pt>
                  <c:pt idx="2">
                    <c:v>4.9240653926941332E-2</c:v>
                  </c:pt>
                  <c:pt idx="3">
                    <c:v>0.16257792732050105</c:v>
                  </c:pt>
                  <c:pt idx="4">
                    <c:v>0.19799899930011586</c:v>
                  </c:pt>
                  <c:pt idx="5">
                    <c:v>0.6075247831791698</c:v>
                  </c:pt>
                  <c:pt idx="6">
                    <c:v>0.23990987522309645</c:v>
                  </c:pt>
                  <c:pt idx="7">
                    <c:v>9.4425280165650466E-2</c:v>
                  </c:pt>
                  <c:pt idx="8">
                    <c:v>3.8514788666844664E-2</c:v>
                  </c:pt>
                  <c:pt idx="9">
                    <c:v>0.14935337465358631</c:v>
                  </c:pt>
                  <c:pt idx="10">
                    <c:v>0.10045800408195764</c:v>
                  </c:pt>
                  <c:pt idx="11">
                    <c:v>0.13306852059101767</c:v>
                  </c:pt>
                  <c:pt idx="12">
                    <c:v>0.23754288213895322</c:v>
                  </c:pt>
                  <c:pt idx="13">
                    <c:v>0.37117436033723272</c:v>
                  </c:pt>
                  <c:pt idx="14">
                    <c:v>0.844997658597009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6:$AM$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12:$AM$12</c:f>
              <c:numCache>
                <c:formatCode>0</c:formatCode>
                <c:ptCount val="15"/>
                <c:pt idx="0">
                  <c:v>8.6023664024622786</c:v>
                </c:pt>
                <c:pt idx="1">
                  <c:v>4.2947900389510592</c:v>
                </c:pt>
                <c:pt idx="2">
                  <c:v>4.6963349624061204</c:v>
                </c:pt>
                <c:pt idx="3">
                  <c:v>18.687372849318603</c:v>
                </c:pt>
                <c:pt idx="4">
                  <c:v>3.0018777726927208</c:v>
                </c:pt>
                <c:pt idx="5">
                  <c:v>17.304383860288798</c:v>
                </c:pt>
                <c:pt idx="6">
                  <c:v>3.3461605934396133</c:v>
                </c:pt>
                <c:pt idx="7">
                  <c:v>3.7020161360405268</c:v>
                </c:pt>
                <c:pt idx="8">
                  <c:v>0.35298055993978616</c:v>
                </c:pt>
                <c:pt idx="9">
                  <c:v>2.3880758328565417</c:v>
                </c:pt>
                <c:pt idx="10">
                  <c:v>1.8613335195691691</c:v>
                </c:pt>
                <c:pt idx="11">
                  <c:v>11.566506367353048</c:v>
                </c:pt>
                <c:pt idx="12">
                  <c:v>4.6476110330287037</c:v>
                </c:pt>
                <c:pt idx="13">
                  <c:v>7.2160879874300994</c:v>
                </c:pt>
                <c:pt idx="14">
                  <c:v>8.3321020842229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1A0-4098-B685-D1FDB40163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8412256"/>
        <c:axId val="798078256"/>
      </c:barChart>
      <c:catAx>
        <c:axId val="528412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8078256"/>
        <c:crosses val="autoZero"/>
        <c:auto val="1"/>
        <c:lblAlgn val="ctr"/>
        <c:lblOffset val="100"/>
        <c:noMultiLvlLbl val="0"/>
      </c:catAx>
      <c:valAx>
        <c:axId val="798078256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2.4251480917217742E-2"/>
              <c:y val="0.278044840796212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41225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253447342730434"/>
          <c:y val="6.6661556250635814E-2"/>
          <c:w val="0.43010184440882798"/>
          <c:h val="0.167421788321698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DHA2</a:t>
            </a:r>
          </a:p>
        </c:rich>
      </c:tx>
      <c:layout>
        <c:manualLayout>
          <c:xMode val="edge"/>
          <c:yMode val="edge"/>
          <c:x val="0.23294311982569491"/>
          <c:y val="0.215606115797116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13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4:$B$1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14:$C$16</c:f>
              <c:numCache>
                <c:formatCode>0</c:formatCode>
                <c:ptCount val="3"/>
                <c:pt idx="0">
                  <c:v>6.3778224041303941</c:v>
                </c:pt>
                <c:pt idx="1">
                  <c:v>0</c:v>
                </c:pt>
                <c:pt idx="2">
                  <c:v>1.51682710440328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04-4D17-90F0-A468659D715D}"/>
            </c:ext>
          </c:extLst>
        </c:ser>
        <c:ser>
          <c:idx val="1"/>
          <c:order val="1"/>
          <c:tx>
            <c:strRef>
              <c:f>'[2020.05.03 FT2018 T2 T3 T4 mol^1.xlsx]mol% simple (3)'!$D$13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4:$B$1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14:$D$16</c:f>
              <c:numCache>
                <c:formatCode>0</c:formatCode>
                <c:ptCount val="3"/>
                <c:pt idx="0">
                  <c:v>4.1014470982333169</c:v>
                </c:pt>
                <c:pt idx="1">
                  <c:v>0.35581994876359085</c:v>
                </c:pt>
                <c:pt idx="2">
                  <c:v>0.36503088649721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04-4D17-90F0-A468659D715D}"/>
            </c:ext>
          </c:extLst>
        </c:ser>
        <c:ser>
          <c:idx val="2"/>
          <c:order val="2"/>
          <c:tx>
            <c:strRef>
              <c:f>'[2020.05.03 FT2018 T2 T3 T4 mol^1.xlsx]mol% simple (3)'!$E$13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4:$B$1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14:$E$16</c:f>
              <c:numCache>
                <c:formatCode>0</c:formatCode>
                <c:ptCount val="3"/>
                <c:pt idx="0">
                  <c:v>8.5657842181197452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04-4D17-90F0-A468659D71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96202336"/>
        <c:axId val="1796740352"/>
      </c:barChart>
      <c:catAx>
        <c:axId val="1796202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740352"/>
        <c:crosses val="autoZero"/>
        <c:auto val="1"/>
        <c:lblAlgn val="ctr"/>
        <c:lblOffset val="100"/>
        <c:noMultiLvlLbl val="0"/>
      </c:catAx>
      <c:valAx>
        <c:axId val="1796740352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202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DHA3   </a:t>
            </a:r>
          </a:p>
        </c:rich>
      </c:tx>
      <c:layout>
        <c:manualLayout>
          <c:xMode val="edge"/>
          <c:yMode val="edge"/>
          <c:x val="0.23277036468320866"/>
          <c:y val="0.203581288477193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18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9:$B$2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19:$C$21</c:f>
              <c:numCache>
                <c:formatCode>0</c:formatCode>
                <c:ptCount val="3"/>
                <c:pt idx="0">
                  <c:v>16.695066053101236</c:v>
                </c:pt>
                <c:pt idx="1">
                  <c:v>18.071860280161964</c:v>
                </c:pt>
                <c:pt idx="2">
                  <c:v>13.8738457822218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27-4E43-9260-3BACF28FFCF8}"/>
            </c:ext>
          </c:extLst>
        </c:ser>
        <c:ser>
          <c:idx val="1"/>
          <c:order val="1"/>
          <c:tx>
            <c:strRef>
              <c:f>'[2020.05.03 FT2018 T2 T3 T4 mol^1.xlsx]mol% simple (3)'!$D$18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9:$B$2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19:$D$21</c:f>
              <c:numCache>
                <c:formatCode>0</c:formatCode>
                <c:ptCount val="3"/>
                <c:pt idx="0">
                  <c:v>0.83516095309517158</c:v>
                </c:pt>
                <c:pt idx="1">
                  <c:v>1.2649037863457591</c:v>
                </c:pt>
                <c:pt idx="2">
                  <c:v>1.70390427950346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27-4E43-9260-3BACF28FFCF8}"/>
            </c:ext>
          </c:extLst>
        </c:ser>
        <c:ser>
          <c:idx val="2"/>
          <c:order val="2"/>
          <c:tx>
            <c:strRef>
              <c:f>'[2020.05.03 FT2018 T2 T3 T4 mol^1.xlsx]mol% simple (3)'!$E$18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19:$B$2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19:$E$21</c:f>
              <c:numCache>
                <c:formatCode>0</c:formatCode>
                <c:ptCount val="3"/>
                <c:pt idx="0">
                  <c:v>3.4500398822543374</c:v>
                </c:pt>
                <c:pt idx="1">
                  <c:v>3.9266284626642904</c:v>
                </c:pt>
                <c:pt idx="2">
                  <c:v>2.7883958908280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27-4E43-9260-3BACF28FFC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96196736"/>
        <c:axId val="1796745344"/>
      </c:barChart>
      <c:catAx>
        <c:axId val="1796196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745344"/>
        <c:crosses val="autoZero"/>
        <c:auto val="1"/>
        <c:lblAlgn val="ctr"/>
        <c:lblOffset val="100"/>
        <c:noMultiLvlLbl val="0"/>
      </c:catAx>
      <c:valAx>
        <c:axId val="1796745344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196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l"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DHA4</a:t>
            </a:r>
          </a:p>
        </c:rich>
      </c:tx>
      <c:layout>
        <c:manualLayout>
          <c:xMode val="edge"/>
          <c:yMode val="edge"/>
          <c:x val="0.24701760532539194"/>
          <c:y val="0.2159960780019709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l"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23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4:$B$2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24:$C$26</c:f>
              <c:numCache>
                <c:formatCode>0</c:formatCode>
                <c:ptCount val="3"/>
                <c:pt idx="0">
                  <c:v>17.567534324189761</c:v>
                </c:pt>
                <c:pt idx="1">
                  <c:v>11.238361064387187</c:v>
                </c:pt>
                <c:pt idx="2">
                  <c:v>14.260406264357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87-479E-934F-BA8D33C98829}"/>
            </c:ext>
          </c:extLst>
        </c:ser>
        <c:ser>
          <c:idx val="1"/>
          <c:order val="1"/>
          <c:tx>
            <c:strRef>
              <c:f>'[2020.05.03 FT2018 T2 T3 T4 mol^1.xlsx]mol% simple (3)'!$D$23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4:$B$2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24:$D$26</c:f>
              <c:numCache>
                <c:formatCode>0</c:formatCode>
                <c:ptCount val="3"/>
                <c:pt idx="0">
                  <c:v>1.3546211914853816</c:v>
                </c:pt>
                <c:pt idx="1">
                  <c:v>1.4441509025783208</c:v>
                </c:pt>
                <c:pt idx="2">
                  <c:v>0.986633542710844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87-479E-934F-BA8D33C98829}"/>
            </c:ext>
          </c:extLst>
        </c:ser>
        <c:ser>
          <c:idx val="2"/>
          <c:order val="2"/>
          <c:tx>
            <c:strRef>
              <c:f>'[2020.05.03 FT2018 T2 T3 T4 mol^1.xlsx]mol% simple (3)'!$E$23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4:$B$2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24:$E$26</c:f>
              <c:numCache>
                <c:formatCode>0</c:formatCode>
                <c:ptCount val="3"/>
                <c:pt idx="0">
                  <c:v>3.1357479808115869</c:v>
                </c:pt>
                <c:pt idx="1">
                  <c:v>1.5288929277476662</c:v>
                </c:pt>
                <c:pt idx="2">
                  <c:v>2.2514278179197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87-479E-934F-BA8D33C988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2493616"/>
        <c:axId val="75698208"/>
      </c:barChart>
      <c:catAx>
        <c:axId val="2002493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698208"/>
        <c:crosses val="autoZero"/>
        <c:auto val="1"/>
        <c:lblAlgn val="ctr"/>
        <c:lblOffset val="100"/>
        <c:noMultiLvlLbl val="0"/>
      </c:catAx>
      <c:valAx>
        <c:axId val="75698208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2493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DHA5</a:t>
            </a:r>
          </a:p>
        </c:rich>
      </c:tx>
      <c:layout>
        <c:manualLayout>
          <c:xMode val="edge"/>
          <c:yMode val="edge"/>
          <c:x val="0.22867462681162701"/>
          <c:y val="0.217781183599571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28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9:$B$3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29:$C$31</c:f>
              <c:numCache>
                <c:formatCode>0</c:formatCode>
                <c:ptCount val="3"/>
                <c:pt idx="0">
                  <c:v>13.479210034933493</c:v>
                </c:pt>
                <c:pt idx="1">
                  <c:v>11.566506367353048</c:v>
                </c:pt>
                <c:pt idx="2">
                  <c:v>10.688852504645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15-450B-ADC4-8BD6AAAF32E8}"/>
            </c:ext>
          </c:extLst>
        </c:ser>
        <c:ser>
          <c:idx val="1"/>
          <c:order val="1"/>
          <c:tx>
            <c:strRef>
              <c:f>'[2020.05.03 FT2018 T2 T3 T4 mol^1.xlsx]mol% simple (3)'!$D$28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9:$B$3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29:$D$31</c:f>
              <c:numCache>
                <c:formatCode>0</c:formatCode>
                <c:ptCount val="3"/>
                <c:pt idx="0">
                  <c:v>4.4122094949443627</c:v>
                </c:pt>
                <c:pt idx="1">
                  <c:v>4.6476110330287037</c:v>
                </c:pt>
                <c:pt idx="2">
                  <c:v>4.7882792880524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15-450B-ADC4-8BD6AAAF32E8}"/>
            </c:ext>
          </c:extLst>
        </c:ser>
        <c:ser>
          <c:idx val="2"/>
          <c:order val="2"/>
          <c:tx>
            <c:strRef>
              <c:f>'[2020.05.03 FT2018 T2 T3 T4 mol^1.xlsx]mol% simple (3)'!$E$28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29:$B$3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29:$E$31</c:f>
              <c:numCache>
                <c:formatCode>0</c:formatCode>
                <c:ptCount val="3"/>
                <c:pt idx="0">
                  <c:v>11.695850023359222</c:v>
                </c:pt>
                <c:pt idx="1">
                  <c:v>7.2160879874300994</c:v>
                </c:pt>
                <c:pt idx="2">
                  <c:v>7.617961910966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15-450B-ADC4-8BD6AAAF32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2510816"/>
        <c:axId val="75680320"/>
      </c:barChart>
      <c:catAx>
        <c:axId val="2002510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680320"/>
        <c:crosses val="autoZero"/>
        <c:auto val="1"/>
        <c:lblAlgn val="ctr"/>
        <c:lblOffset val="100"/>
        <c:noMultiLvlLbl val="0"/>
      </c:catAx>
      <c:valAx>
        <c:axId val="75680320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2510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EPA4</a:t>
            </a:r>
          </a:p>
        </c:rich>
      </c:tx>
      <c:layout>
        <c:manualLayout>
          <c:xMode val="edge"/>
          <c:yMode val="edge"/>
          <c:x val="0.23771961352248461"/>
          <c:y val="0.210766548992921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33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4:$B$3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34:$C$36</c:f>
              <c:numCache>
                <c:formatCode>0</c:formatCode>
                <c:ptCount val="3"/>
                <c:pt idx="0">
                  <c:v>15.526640894843739</c:v>
                </c:pt>
                <c:pt idx="1">
                  <c:v>13.577693853951823</c:v>
                </c:pt>
                <c:pt idx="2">
                  <c:v>10.0845839306958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D5-4307-8BC6-6365E1A8BC82}"/>
            </c:ext>
          </c:extLst>
        </c:ser>
        <c:ser>
          <c:idx val="1"/>
          <c:order val="1"/>
          <c:tx>
            <c:strRef>
              <c:f>'[2020.05.03 FT2018 T2 T3 T4 mol^1.xlsx]mol% simple (3)'!$D$33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4:$B$3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34:$D$36</c:f>
              <c:numCache>
                <c:formatCode>0</c:formatCode>
                <c:ptCount val="3"/>
                <c:pt idx="0">
                  <c:v>0.49040823393848898</c:v>
                </c:pt>
                <c:pt idx="1">
                  <c:v>0.83043352603823051</c:v>
                </c:pt>
                <c:pt idx="2">
                  <c:v>0.527847580081068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D5-4307-8BC6-6365E1A8BC82}"/>
            </c:ext>
          </c:extLst>
        </c:ser>
        <c:ser>
          <c:idx val="2"/>
          <c:order val="2"/>
          <c:tx>
            <c:strRef>
              <c:f>'[2020.05.03 FT2018 T2 T3 T4 mol^1.xlsx]mol% simple (3)'!$E$33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4:$B$3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34:$E$36</c:f>
              <c:numCache>
                <c:formatCode>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1D5-4307-8BC6-6365E1A8BC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2336192"/>
        <c:axId val="75679904"/>
      </c:barChart>
      <c:catAx>
        <c:axId val="132336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679904"/>
        <c:crosses val="autoZero"/>
        <c:auto val="1"/>
        <c:lblAlgn val="ctr"/>
        <c:lblOffset val="100"/>
        <c:noMultiLvlLbl val="0"/>
      </c:catAx>
      <c:valAx>
        <c:axId val="75679904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233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EPA8</a:t>
            </a:r>
          </a:p>
        </c:rich>
      </c:tx>
      <c:layout>
        <c:manualLayout>
          <c:xMode val="edge"/>
          <c:yMode val="edge"/>
          <c:x val="0.25506827362566231"/>
          <c:y val="0.20450631600951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38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9:$B$4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C$39:$C$41</c:f>
              <c:numCache>
                <c:formatCode>0</c:formatCode>
                <c:ptCount val="3"/>
                <c:pt idx="0">
                  <c:v>20.827371770637761</c:v>
                </c:pt>
                <c:pt idx="1">
                  <c:v>21.07631682178209</c:v>
                </c:pt>
                <c:pt idx="2">
                  <c:v>20.571515126115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FE-4A63-B272-C736A173BFC4}"/>
            </c:ext>
          </c:extLst>
        </c:ser>
        <c:ser>
          <c:idx val="1"/>
          <c:order val="1"/>
          <c:tx>
            <c:strRef>
              <c:f>'[2020.05.03 FT2018 T2 T3 T4 mol^1.xlsx]mol% simple (3)'!$D$38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9:$B$4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D$39:$D$41</c:f>
              <c:numCache>
                <c:formatCode>0</c:formatCode>
                <c:ptCount val="3"/>
                <c:pt idx="0">
                  <c:v>0.86117596942324148</c:v>
                </c:pt>
                <c:pt idx="1">
                  <c:v>0.94370813126985131</c:v>
                </c:pt>
                <c:pt idx="2">
                  <c:v>1.0682126083042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FE-4A63-B272-C736A173BFC4}"/>
            </c:ext>
          </c:extLst>
        </c:ser>
        <c:ser>
          <c:idx val="2"/>
          <c:order val="2"/>
          <c:tx>
            <c:strRef>
              <c:f>'[2020.05.03 FT2018 T2 T3 T4 mol^1.xlsx]mol% simple (3)'!$E$38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39:$B$41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[2020.05.03 FT2018 T2 T3 T4 mol^1.xlsx]mol% simple (3)'!$E$39:$E$41</c:f>
              <c:numCache>
                <c:formatCode>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6FE-4A63-B272-C736A173BF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2364192"/>
        <c:axId val="75705696"/>
      </c:barChart>
      <c:catAx>
        <c:axId val="132364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705696"/>
        <c:crosses val="autoZero"/>
        <c:auto val="1"/>
        <c:lblAlgn val="ctr"/>
        <c:lblOffset val="100"/>
        <c:noMultiLvlLbl val="0"/>
      </c:catAx>
      <c:valAx>
        <c:axId val="75705696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2364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EPA1</a:t>
            </a:r>
          </a:p>
        </c:rich>
      </c:tx>
      <c:layout>
        <c:manualLayout>
          <c:xMode val="edge"/>
          <c:yMode val="edge"/>
          <c:x val="0.23702986771595999"/>
          <c:y val="0.203904577987039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ol% simple (3)'!$C$43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mol% simple (3)'!$B$44:$B$4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mol% simple (3)'!$C$44:$C$46</c:f>
              <c:numCache>
                <c:formatCode>0</c:formatCode>
                <c:ptCount val="3"/>
                <c:pt idx="0">
                  <c:v>21.311163860961603</c:v>
                </c:pt>
                <c:pt idx="1">
                  <c:v>20.417210115804409</c:v>
                </c:pt>
                <c:pt idx="2">
                  <c:v>21.58133769203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EB-465B-BEB3-D2BB4C1F7165}"/>
            </c:ext>
          </c:extLst>
        </c:ser>
        <c:ser>
          <c:idx val="1"/>
          <c:order val="1"/>
          <c:tx>
            <c:strRef>
              <c:f>'mol% simple (3)'!$D$43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mol% simple (3)'!$B$44:$B$4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mol% simple (3)'!$D$44:$D$46</c:f>
              <c:numCache>
                <c:formatCode>0</c:formatCode>
                <c:ptCount val="3"/>
                <c:pt idx="0">
                  <c:v>1.1237649825734066</c:v>
                </c:pt>
                <c:pt idx="1">
                  <c:v>0.93278536109490851</c:v>
                </c:pt>
                <c:pt idx="2">
                  <c:v>0.820741608067079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EB-465B-BEB3-D2BB4C1F7165}"/>
            </c:ext>
          </c:extLst>
        </c:ser>
        <c:ser>
          <c:idx val="2"/>
          <c:order val="2"/>
          <c:tx>
            <c:strRef>
              <c:f>'mol% simple (3)'!$E$43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mol% simple (3)'!$B$44:$B$46</c:f>
              <c:strCache>
                <c:ptCount val="3"/>
                <c:pt idx="0">
                  <c:v>T2 GH</c:v>
                </c:pt>
                <c:pt idx="1">
                  <c:v>T3 GH</c:v>
                </c:pt>
                <c:pt idx="2">
                  <c:v>T4 (FT2018)</c:v>
                </c:pt>
              </c:strCache>
            </c:strRef>
          </c:cat>
          <c:val>
            <c:numRef>
              <c:f>'mol% simple (3)'!$E$44:$E$46</c:f>
              <c:numCache>
                <c:formatCode>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AEB-465B-BEB3-D2BB4C1F71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09371488"/>
        <c:axId val="75677408"/>
      </c:barChart>
      <c:catAx>
        <c:axId val="2009371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677408"/>
        <c:crosses val="autoZero"/>
        <c:auto val="1"/>
        <c:lblAlgn val="ctr"/>
        <c:lblOffset val="100"/>
        <c:noMultiLvlLbl val="0"/>
      </c:catAx>
      <c:valAx>
        <c:axId val="75677408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9371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DHA1</a:t>
            </a:r>
          </a:p>
        </c:rich>
      </c:tx>
      <c:layout>
        <c:manualLayout>
          <c:xMode val="edge"/>
          <c:yMode val="edge"/>
          <c:x val="0.12850178322605357"/>
          <c:y val="0.215332398339434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2020.05.03 FT2018 T2 T3 T4 mol^1.xlsx]mol% simple (3)'!$C$4</c:f>
              <c:strCache>
                <c:ptCount val="1"/>
                <c:pt idx="0">
                  <c:v>EPA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5:$B$10</c:f>
              <c:strCache>
                <c:ptCount val="6"/>
                <c:pt idx="0">
                  <c:v>T2 GH</c:v>
                </c:pt>
                <c:pt idx="1">
                  <c:v>T3 GH</c:v>
                </c:pt>
                <c:pt idx="2">
                  <c:v>T4 (FT2016)</c:v>
                </c:pt>
                <c:pt idx="3">
                  <c:v>T5 (FT2017)</c:v>
                </c:pt>
                <c:pt idx="4">
                  <c:v>T6 (FT2018)</c:v>
                </c:pt>
                <c:pt idx="5">
                  <c:v>T7 (FT2019)</c:v>
                </c:pt>
              </c:strCache>
            </c:strRef>
          </c:cat>
          <c:val>
            <c:numRef>
              <c:f>'[2020.05.03 FT2018 T2 T3 T4 mol^1.xlsx]mol% simple (3)'!$C$5:$C$10</c:f>
              <c:numCache>
                <c:formatCode>0</c:formatCode>
                <c:ptCount val="6"/>
                <c:pt idx="0">
                  <c:v>10.765441631646871</c:v>
                </c:pt>
                <c:pt idx="1">
                  <c:v>9.1378225534281032</c:v>
                </c:pt>
                <c:pt idx="2" formatCode="0.0">
                  <c:v>7.9843069712488255</c:v>
                </c:pt>
                <c:pt idx="3" formatCode="0.0">
                  <c:v>7.6948014278559915</c:v>
                </c:pt>
                <c:pt idx="4">
                  <c:v>10.605406223208179</c:v>
                </c:pt>
                <c:pt idx="5">
                  <c:v>9.31331440284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EF-458B-9980-E93759379502}"/>
            </c:ext>
          </c:extLst>
        </c:ser>
        <c:ser>
          <c:idx val="1"/>
          <c:order val="1"/>
          <c:tx>
            <c:strRef>
              <c:f>'[2020.05.03 FT2018 T2 T3 T4 mol^1.xlsx]mol% simple (3)'!$D$4</c:f>
              <c:strCache>
                <c:ptCount val="1"/>
                <c:pt idx="0">
                  <c:v>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5:$B$10</c:f>
              <c:strCache>
                <c:ptCount val="6"/>
                <c:pt idx="0">
                  <c:v>T2 GH</c:v>
                </c:pt>
                <c:pt idx="1">
                  <c:v>T3 GH</c:v>
                </c:pt>
                <c:pt idx="2">
                  <c:v>T4 (FT2016)</c:v>
                </c:pt>
                <c:pt idx="3">
                  <c:v>T5 (FT2017)</c:v>
                </c:pt>
                <c:pt idx="4">
                  <c:v>T6 (FT2018)</c:v>
                </c:pt>
                <c:pt idx="5">
                  <c:v>T7 (FT2019)</c:v>
                </c:pt>
              </c:strCache>
            </c:strRef>
          </c:cat>
          <c:val>
            <c:numRef>
              <c:f>'[2020.05.03 FT2018 T2 T3 T4 mol^1.xlsx]mol% simple (3)'!$D$5:$D$10</c:f>
              <c:numCache>
                <c:formatCode>0</c:formatCode>
                <c:ptCount val="6"/>
                <c:pt idx="0">
                  <c:v>5.190894298939237</c:v>
                </c:pt>
                <c:pt idx="1">
                  <c:v>5.0907199954871736</c:v>
                </c:pt>
                <c:pt idx="2" formatCode="0.0">
                  <c:v>5.730486737011482</c:v>
                </c:pt>
                <c:pt idx="3" formatCode="0.0">
                  <c:v>5.8463133163002041</c:v>
                </c:pt>
                <c:pt idx="4">
                  <c:v>4.0354133372372276</c:v>
                </c:pt>
                <c:pt idx="5">
                  <c:v>5.20742238834758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EF-458B-9980-E93759379502}"/>
            </c:ext>
          </c:extLst>
        </c:ser>
        <c:ser>
          <c:idx val="2"/>
          <c:order val="2"/>
          <c:tx>
            <c:strRef>
              <c:f>'[2020.05.03 FT2018 T2 T3 T4 mol^1.xlsx]mol% simple (3)'!$E$4</c:f>
              <c:strCache>
                <c:ptCount val="1"/>
                <c:pt idx="0">
                  <c:v>DH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2020.05.03 FT2018 T2 T3 T4 mol^1.xlsx]mol% simple (3)'!$B$5:$B$10</c:f>
              <c:strCache>
                <c:ptCount val="6"/>
                <c:pt idx="0">
                  <c:v>T2 GH</c:v>
                </c:pt>
                <c:pt idx="1">
                  <c:v>T3 GH</c:v>
                </c:pt>
                <c:pt idx="2">
                  <c:v>T4 (FT2016)</c:v>
                </c:pt>
                <c:pt idx="3">
                  <c:v>T5 (FT2017)</c:v>
                </c:pt>
                <c:pt idx="4">
                  <c:v>T6 (FT2018)</c:v>
                </c:pt>
                <c:pt idx="5">
                  <c:v>T7 (FT2019)</c:v>
                </c:pt>
              </c:strCache>
            </c:strRef>
          </c:cat>
          <c:val>
            <c:numRef>
              <c:f>'[2020.05.03 FT2018 T2 T3 T4 mol^1.xlsx]mol% simple (3)'!$E$5:$E$10</c:f>
              <c:numCache>
                <c:formatCode>0</c:formatCode>
                <c:ptCount val="6"/>
                <c:pt idx="0">
                  <c:v>15.383350210809988</c:v>
                </c:pt>
                <c:pt idx="1">
                  <c:v>10.106394813168421</c:v>
                </c:pt>
                <c:pt idx="2" formatCode="0.0">
                  <c:v>9.3466581845869801</c:v>
                </c:pt>
                <c:pt idx="3" formatCode="0.0">
                  <c:v>9.7526728385253563</c:v>
                </c:pt>
                <c:pt idx="4">
                  <c:v>8.5803454825515466</c:v>
                </c:pt>
                <c:pt idx="5">
                  <c:v>9.7038870455637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EF-458B-9980-E937593795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9767376"/>
        <c:axId val="80024656"/>
      </c:barChart>
      <c:catAx>
        <c:axId val="79767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024656"/>
        <c:crosses val="autoZero"/>
        <c:auto val="1"/>
        <c:lblAlgn val="ctr"/>
        <c:lblOffset val="100"/>
        <c:noMultiLvlLbl val="0"/>
      </c:catAx>
      <c:valAx>
        <c:axId val="80024656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0"/>
                  <a:t>FAMEs (mol%)</a:t>
                </a:r>
                <a:endParaRPr lang="zh-CN" b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767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 dirty="0"/>
              <a:t>DHA2015.4</a:t>
            </a:r>
          </a:p>
        </c:rich>
      </c:tx>
      <c:layout>
        <c:manualLayout>
          <c:xMode val="edge"/>
          <c:yMode val="edge"/>
          <c:x val="0.42226473359119387"/>
          <c:y val="4.70583411085153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3074264165361145E-2"/>
          <c:y val="5.3914830638725576E-2"/>
          <c:w val="0.88563262243263186"/>
          <c:h val="0.654173011795620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HA4'!$B$4</c:f>
              <c:strCache>
                <c:ptCount val="1"/>
                <c:pt idx="0">
                  <c:v>409</c:v>
                </c:pt>
              </c:strCache>
            </c:strRef>
          </c:tx>
          <c:spPr>
            <a:solidFill>
              <a:schemeClr val="accent3">
                <a:tint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4:$Q$4</c:f>
              <c:numCache>
                <c:formatCode>General</c:formatCode>
                <c:ptCount val="15"/>
                <c:pt idx="0">
                  <c:v>7.2777809024211999</c:v>
                </c:pt>
                <c:pt idx="1">
                  <c:v>3.640985887719034</c:v>
                </c:pt>
                <c:pt idx="2">
                  <c:v>9.0663868899984905</c:v>
                </c:pt>
                <c:pt idx="3">
                  <c:v>19.677462105480409</c:v>
                </c:pt>
                <c:pt idx="4">
                  <c:v>2.8936583337003774</c:v>
                </c:pt>
                <c:pt idx="5">
                  <c:v>13.153155756839015</c:v>
                </c:pt>
                <c:pt idx="6">
                  <c:v>2.8878460362089635</c:v>
                </c:pt>
                <c:pt idx="7">
                  <c:v>4.4482799804560074</c:v>
                </c:pt>
                <c:pt idx="8">
                  <c:v>2.5259523702928881</c:v>
                </c:pt>
                <c:pt idx="9">
                  <c:v>5.7026719694063503</c:v>
                </c:pt>
                <c:pt idx="10">
                  <c:v>3.1414262943011537</c:v>
                </c:pt>
                <c:pt idx="11">
                  <c:v>14.200168348638419</c:v>
                </c:pt>
                <c:pt idx="12">
                  <c:v>0.80120640051081216</c:v>
                </c:pt>
                <c:pt idx="13">
                  <c:v>1.6808787786232331</c:v>
                </c:pt>
                <c:pt idx="14">
                  <c:v>8.3676078819003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60-4C3C-A71C-E64E896B428F}"/>
            </c:ext>
          </c:extLst>
        </c:ser>
        <c:ser>
          <c:idx val="1"/>
          <c:order val="1"/>
          <c:tx>
            <c:strRef>
              <c:f>'DHA4'!$B$5</c:f>
              <c:strCache>
                <c:ptCount val="1"/>
                <c:pt idx="0">
                  <c:v>423</c:v>
                </c:pt>
              </c:strCache>
            </c:strRef>
          </c:tx>
          <c:spPr>
            <a:solidFill>
              <a:schemeClr val="accent3">
                <a:tint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5:$Q$5</c:f>
              <c:numCache>
                <c:formatCode>General</c:formatCode>
                <c:ptCount val="15"/>
                <c:pt idx="0">
                  <c:v>8.7443748791008513</c:v>
                </c:pt>
                <c:pt idx="1">
                  <c:v>3.1443348590422588</c:v>
                </c:pt>
                <c:pt idx="2">
                  <c:v>11.174558611335383</c:v>
                </c:pt>
                <c:pt idx="3">
                  <c:v>20.696119615516238</c:v>
                </c:pt>
                <c:pt idx="4">
                  <c:v>2.8281962061773807</c:v>
                </c:pt>
                <c:pt idx="5">
                  <c:v>9.8684577272321352</c:v>
                </c:pt>
                <c:pt idx="6">
                  <c:v>2.4332117624052052</c:v>
                </c:pt>
                <c:pt idx="7">
                  <c:v>4.8947807317351479</c:v>
                </c:pt>
                <c:pt idx="8">
                  <c:v>2.7804660480099859</c:v>
                </c:pt>
                <c:pt idx="9">
                  <c:v>7.8132481721576683</c:v>
                </c:pt>
                <c:pt idx="10">
                  <c:v>2.6176601326554461</c:v>
                </c:pt>
                <c:pt idx="11">
                  <c:v>13.129884718164433</c:v>
                </c:pt>
                <c:pt idx="12">
                  <c:v>0.73925368476404307</c:v>
                </c:pt>
                <c:pt idx="13">
                  <c:v>1.929917769026072</c:v>
                </c:pt>
                <c:pt idx="14">
                  <c:v>6.0696181439819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60-4C3C-A71C-E64E896B428F}"/>
            </c:ext>
          </c:extLst>
        </c:ser>
        <c:ser>
          <c:idx val="2"/>
          <c:order val="2"/>
          <c:tx>
            <c:strRef>
              <c:f>'DHA4'!$B$6</c:f>
              <c:strCache>
                <c:ptCount val="1"/>
                <c:pt idx="0">
                  <c:v>401</c:v>
                </c:pt>
              </c:strCache>
            </c:strRef>
          </c:tx>
          <c:spPr>
            <a:solidFill>
              <a:schemeClr val="accent3">
                <a:tint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6:$Q$6</c:f>
              <c:numCache>
                <c:formatCode>General</c:formatCode>
                <c:ptCount val="15"/>
                <c:pt idx="0">
                  <c:v>7.0863318760618181</c:v>
                </c:pt>
                <c:pt idx="1">
                  <c:v>3.3332763075542857</c:v>
                </c:pt>
                <c:pt idx="2">
                  <c:v>10.483968901691233</c:v>
                </c:pt>
                <c:pt idx="3">
                  <c:v>16.916576411116086</c:v>
                </c:pt>
                <c:pt idx="4">
                  <c:v>2.7197357894948304</c:v>
                </c:pt>
                <c:pt idx="5">
                  <c:v>11.718245020693448</c:v>
                </c:pt>
                <c:pt idx="6">
                  <c:v>2.580268207231434</c:v>
                </c:pt>
                <c:pt idx="7">
                  <c:v>5.610471557819956</c:v>
                </c:pt>
                <c:pt idx="8">
                  <c:v>2.7423858878927287</c:v>
                </c:pt>
                <c:pt idx="9">
                  <c:v>6.9328923935768056</c:v>
                </c:pt>
                <c:pt idx="10">
                  <c:v>3.271753270577217</c:v>
                </c:pt>
                <c:pt idx="11">
                  <c:v>14.502840224969825</c:v>
                </c:pt>
                <c:pt idx="12">
                  <c:v>1.0574414898176445</c:v>
                </c:pt>
                <c:pt idx="13">
                  <c:v>1.9312542673670816</c:v>
                </c:pt>
                <c:pt idx="14">
                  <c:v>8.47696396372127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560-4C3C-A71C-E64E896B428F}"/>
            </c:ext>
          </c:extLst>
        </c:ser>
        <c:ser>
          <c:idx val="3"/>
          <c:order val="3"/>
          <c:tx>
            <c:strRef>
              <c:f>'DHA4'!$B$7</c:f>
              <c:strCache>
                <c:ptCount val="1"/>
                <c:pt idx="0">
                  <c:v>412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7:$Q$7</c:f>
              <c:numCache>
                <c:formatCode>General</c:formatCode>
                <c:ptCount val="15"/>
                <c:pt idx="0">
                  <c:v>8.4252744346003308</c:v>
                </c:pt>
                <c:pt idx="1">
                  <c:v>3.1303185242413183</c:v>
                </c:pt>
                <c:pt idx="2">
                  <c:v>10.155796741403265</c:v>
                </c:pt>
                <c:pt idx="3">
                  <c:v>18.011859732789354</c:v>
                </c:pt>
                <c:pt idx="4">
                  <c:v>2.6856462912034731</c:v>
                </c:pt>
                <c:pt idx="5">
                  <c:v>12.258945945909918</c:v>
                </c:pt>
                <c:pt idx="6">
                  <c:v>2.6917417598787221</c:v>
                </c:pt>
                <c:pt idx="7">
                  <c:v>5.1374317441400379</c:v>
                </c:pt>
                <c:pt idx="8">
                  <c:v>3.028372501844288</c:v>
                </c:pt>
                <c:pt idx="9">
                  <c:v>5.7838277560835056</c:v>
                </c:pt>
                <c:pt idx="10">
                  <c:v>3.7974044813665859</c:v>
                </c:pt>
                <c:pt idx="11">
                  <c:v>13.329139812271494</c:v>
                </c:pt>
                <c:pt idx="12">
                  <c:v>1.0236130558567038</c:v>
                </c:pt>
                <c:pt idx="13">
                  <c:v>2.0749589643399444</c:v>
                </c:pt>
                <c:pt idx="14">
                  <c:v>7.8344852545383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560-4C3C-A71C-E64E896B428F}"/>
            </c:ext>
          </c:extLst>
        </c:ser>
        <c:ser>
          <c:idx val="4"/>
          <c:order val="4"/>
          <c:tx>
            <c:strRef>
              <c:f>'DHA4'!$B$8</c:f>
              <c:strCache>
                <c:ptCount val="1"/>
                <c:pt idx="0">
                  <c:v>414</c:v>
                </c:pt>
              </c:strCache>
            </c:strRef>
          </c:tx>
          <c:spPr>
            <a:solidFill>
              <a:schemeClr val="accent3">
                <a:tint val="7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8:$Q$8</c:f>
              <c:numCache>
                <c:formatCode>General</c:formatCode>
                <c:ptCount val="15"/>
                <c:pt idx="0">
                  <c:v>7.0002897775457846</c:v>
                </c:pt>
                <c:pt idx="1">
                  <c:v>3.0703336969822881</c:v>
                </c:pt>
                <c:pt idx="2">
                  <c:v>12.226196832633661</c:v>
                </c:pt>
                <c:pt idx="3">
                  <c:v>17.872632552352339</c:v>
                </c:pt>
                <c:pt idx="4">
                  <c:v>3.1703890878596748</c:v>
                </c:pt>
                <c:pt idx="5">
                  <c:v>8.3991857310944074</c:v>
                </c:pt>
                <c:pt idx="6">
                  <c:v>2.618413562819335</c:v>
                </c:pt>
                <c:pt idx="7">
                  <c:v>5.5877051610870208</c:v>
                </c:pt>
                <c:pt idx="8">
                  <c:v>2.5269469740212882</c:v>
                </c:pt>
                <c:pt idx="9">
                  <c:v>10.14862215802188</c:v>
                </c:pt>
                <c:pt idx="10">
                  <c:v>2.2993162933798197</c:v>
                </c:pt>
                <c:pt idx="11">
                  <c:v>13.452658316246563</c:v>
                </c:pt>
                <c:pt idx="12">
                  <c:v>1.0809808441778304</c:v>
                </c:pt>
                <c:pt idx="13">
                  <c:v>2.014429755027344</c:v>
                </c:pt>
                <c:pt idx="14">
                  <c:v>7.778025400088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60-4C3C-A71C-E64E896B428F}"/>
            </c:ext>
          </c:extLst>
        </c:ser>
        <c:ser>
          <c:idx val="5"/>
          <c:order val="5"/>
          <c:tx>
            <c:strRef>
              <c:f>'DHA4'!$B$9</c:f>
              <c:strCache>
                <c:ptCount val="1"/>
                <c:pt idx="0">
                  <c:v>427</c:v>
                </c:pt>
              </c:strCache>
            </c:strRef>
          </c:tx>
          <c:spPr>
            <a:solidFill>
              <a:schemeClr val="accent3">
                <a:tint val="8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9:$Q$9</c:f>
              <c:numCache>
                <c:formatCode>General</c:formatCode>
                <c:ptCount val="15"/>
                <c:pt idx="0">
                  <c:v>7.7189344037246146</c:v>
                </c:pt>
                <c:pt idx="1">
                  <c:v>3.3499786258689253</c:v>
                </c:pt>
                <c:pt idx="2">
                  <c:v>11.643775204951682</c:v>
                </c:pt>
                <c:pt idx="3">
                  <c:v>19.341984944429452</c:v>
                </c:pt>
                <c:pt idx="4">
                  <c:v>2.6361796910499931</c:v>
                </c:pt>
                <c:pt idx="5">
                  <c:v>8.4106316311188056</c:v>
                </c:pt>
                <c:pt idx="6">
                  <c:v>1.8310475253755463</c:v>
                </c:pt>
                <c:pt idx="7">
                  <c:v>5.9429992774063782</c:v>
                </c:pt>
                <c:pt idx="8">
                  <c:v>3.0249849573771526</c:v>
                </c:pt>
                <c:pt idx="9">
                  <c:v>7.7480938723157395</c:v>
                </c:pt>
                <c:pt idx="10">
                  <c:v>2.6713942029300228</c:v>
                </c:pt>
                <c:pt idx="11">
                  <c:v>13.57015483722812</c:v>
                </c:pt>
                <c:pt idx="12">
                  <c:v>0.99921131890651116</c:v>
                </c:pt>
                <c:pt idx="13">
                  <c:v>2.1798345814477744</c:v>
                </c:pt>
                <c:pt idx="14">
                  <c:v>8.2865858875783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560-4C3C-A71C-E64E896B428F}"/>
            </c:ext>
          </c:extLst>
        </c:ser>
        <c:ser>
          <c:idx val="6"/>
          <c:order val="6"/>
          <c:tx>
            <c:strRef>
              <c:f>'DHA4'!$B$10</c:f>
              <c:strCache>
                <c:ptCount val="1"/>
                <c:pt idx="0">
                  <c:v>428</c:v>
                </c:pt>
              </c:strCache>
            </c:strRef>
          </c:tx>
          <c:spPr>
            <a:solidFill>
              <a:schemeClr val="accent3">
                <a:tint val="9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0:$Q$10</c:f>
              <c:numCache>
                <c:formatCode>General</c:formatCode>
                <c:ptCount val="15"/>
                <c:pt idx="0">
                  <c:v>8.3373740830461749</c:v>
                </c:pt>
                <c:pt idx="1">
                  <c:v>3.7400150473089679</c:v>
                </c:pt>
                <c:pt idx="2">
                  <c:v>11.791082052930973</c:v>
                </c:pt>
                <c:pt idx="3">
                  <c:v>17.9392707140433</c:v>
                </c:pt>
                <c:pt idx="4">
                  <c:v>2.9811671716715811</c:v>
                </c:pt>
                <c:pt idx="5">
                  <c:v>7.1940809298085551</c:v>
                </c:pt>
                <c:pt idx="6">
                  <c:v>2.1902930805156835</c:v>
                </c:pt>
                <c:pt idx="7">
                  <c:v>4.7568109510449395</c:v>
                </c:pt>
                <c:pt idx="8">
                  <c:v>2.5078509720454667</c:v>
                </c:pt>
                <c:pt idx="9">
                  <c:v>9.7011867748889173</c:v>
                </c:pt>
                <c:pt idx="10">
                  <c:v>2.095267975092189</c:v>
                </c:pt>
                <c:pt idx="11">
                  <c:v>14.282394521550398</c:v>
                </c:pt>
                <c:pt idx="12">
                  <c:v>0.83524672223068686</c:v>
                </c:pt>
                <c:pt idx="13">
                  <c:v>2.2755431297361959</c:v>
                </c:pt>
                <c:pt idx="14">
                  <c:v>8.2813783006240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560-4C3C-A71C-E64E896B428F}"/>
            </c:ext>
          </c:extLst>
        </c:ser>
        <c:ser>
          <c:idx val="7"/>
          <c:order val="7"/>
          <c:tx>
            <c:strRef>
              <c:f>'DHA4'!$B$11</c:f>
              <c:strCache>
                <c:ptCount val="1"/>
                <c:pt idx="0">
                  <c:v>40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1:$Q$11</c:f>
              <c:numCache>
                <c:formatCode>General</c:formatCode>
                <c:ptCount val="15"/>
                <c:pt idx="0">
                  <c:v>8.9015879495611649</c:v>
                </c:pt>
                <c:pt idx="1">
                  <c:v>4.5529352811456496</c:v>
                </c:pt>
                <c:pt idx="2">
                  <c:v>15.709241297242782</c:v>
                </c:pt>
                <c:pt idx="3">
                  <c:v>17.065553920582346</c:v>
                </c:pt>
                <c:pt idx="4">
                  <c:v>2.5498598689853358</c:v>
                </c:pt>
                <c:pt idx="5">
                  <c:v>6.4952238439239451</c:v>
                </c:pt>
                <c:pt idx="6">
                  <c:v>1.8077027120168079</c:v>
                </c:pt>
                <c:pt idx="7">
                  <c:v>4.4330047761293079</c:v>
                </c:pt>
                <c:pt idx="8">
                  <c:v>1.5980213148551607</c:v>
                </c:pt>
                <c:pt idx="9">
                  <c:v>7.4860971751488989</c:v>
                </c:pt>
                <c:pt idx="10">
                  <c:v>1.5546558477042685</c:v>
                </c:pt>
                <c:pt idx="11">
                  <c:v>14.718585297124392</c:v>
                </c:pt>
                <c:pt idx="12">
                  <c:v>0.81369600355636962</c:v>
                </c:pt>
                <c:pt idx="13">
                  <c:v>2.2790286258267858</c:v>
                </c:pt>
                <c:pt idx="14">
                  <c:v>8.8918292284193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560-4C3C-A71C-E64E896B428F}"/>
            </c:ext>
          </c:extLst>
        </c:ser>
        <c:ser>
          <c:idx val="8"/>
          <c:order val="8"/>
          <c:tx>
            <c:strRef>
              <c:f>'DHA4'!$B$12</c:f>
              <c:strCache>
                <c:ptCount val="1"/>
                <c:pt idx="0">
                  <c:v>417</c:v>
                </c:pt>
              </c:strCache>
            </c:strRef>
          </c:tx>
          <c:spPr>
            <a:solidFill>
              <a:schemeClr val="accent3">
                <a:shade val="9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2:$Q$12</c:f>
              <c:numCache>
                <c:formatCode>General</c:formatCode>
                <c:ptCount val="15"/>
                <c:pt idx="0">
                  <c:v>7.3246112444096321</c:v>
                </c:pt>
                <c:pt idx="1">
                  <c:v>3.0627789741184976</c:v>
                </c:pt>
                <c:pt idx="2">
                  <c:v>9.7051802117279387</c:v>
                </c:pt>
                <c:pt idx="3">
                  <c:v>18.498191891653317</c:v>
                </c:pt>
                <c:pt idx="4">
                  <c:v>2.8454935950663285</c:v>
                </c:pt>
                <c:pt idx="5">
                  <c:v>9.1114144659824046</c:v>
                </c:pt>
                <c:pt idx="6">
                  <c:v>2.3957049670327746</c:v>
                </c:pt>
                <c:pt idx="7">
                  <c:v>4.8703293879947811</c:v>
                </c:pt>
                <c:pt idx="8">
                  <c:v>3.1244731210480774</c:v>
                </c:pt>
                <c:pt idx="9">
                  <c:v>7.9609545437067073</c:v>
                </c:pt>
                <c:pt idx="10">
                  <c:v>3.122393645385233</c:v>
                </c:pt>
                <c:pt idx="11">
                  <c:v>15.820579635386983</c:v>
                </c:pt>
                <c:pt idx="12">
                  <c:v>0.98092380617861674</c:v>
                </c:pt>
                <c:pt idx="13">
                  <c:v>2.3589095492603005</c:v>
                </c:pt>
                <c:pt idx="14">
                  <c:v>8.1663001892179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560-4C3C-A71C-E64E896B428F}"/>
            </c:ext>
          </c:extLst>
        </c:ser>
        <c:ser>
          <c:idx val="9"/>
          <c:order val="9"/>
          <c:tx>
            <c:strRef>
              <c:f>'DHA4'!$B$13</c:f>
              <c:strCache>
                <c:ptCount val="1"/>
                <c:pt idx="0">
                  <c:v>406</c:v>
                </c:pt>
              </c:strCache>
            </c:strRef>
          </c:tx>
          <c:spPr>
            <a:solidFill>
              <a:schemeClr val="accent3">
                <a:shade val="8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3:$Q$13</c:f>
              <c:numCache>
                <c:formatCode>General</c:formatCode>
                <c:ptCount val="15"/>
                <c:pt idx="0">
                  <c:v>8.3323222757045361</c:v>
                </c:pt>
                <c:pt idx="1">
                  <c:v>3.7972799862695221</c:v>
                </c:pt>
                <c:pt idx="2">
                  <c:v>10.304009621931211</c:v>
                </c:pt>
                <c:pt idx="3">
                  <c:v>17.556329760245891</c:v>
                </c:pt>
                <c:pt idx="4">
                  <c:v>2.8149987097141196</c:v>
                </c:pt>
                <c:pt idx="5">
                  <c:v>11.110673116876104</c:v>
                </c:pt>
                <c:pt idx="6">
                  <c:v>2.7124838712969153</c:v>
                </c:pt>
                <c:pt idx="7">
                  <c:v>5.5869592275884283</c:v>
                </c:pt>
                <c:pt idx="8">
                  <c:v>3.1486351725238437</c:v>
                </c:pt>
                <c:pt idx="9">
                  <c:v>7.0298656225663381</c:v>
                </c:pt>
                <c:pt idx="10">
                  <c:v>3.4065389298976614</c:v>
                </c:pt>
                <c:pt idx="11">
                  <c:v>12.235023792404764</c:v>
                </c:pt>
                <c:pt idx="12">
                  <c:v>1.0540849457023471</c:v>
                </c:pt>
                <c:pt idx="13">
                  <c:v>2.3636787942347164</c:v>
                </c:pt>
                <c:pt idx="14">
                  <c:v>8.1273367164836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560-4C3C-A71C-E64E896B428F}"/>
            </c:ext>
          </c:extLst>
        </c:ser>
        <c:ser>
          <c:idx val="10"/>
          <c:order val="10"/>
          <c:tx>
            <c:strRef>
              <c:f>'DHA4'!$B$14</c:f>
              <c:strCache>
                <c:ptCount val="1"/>
                <c:pt idx="0">
                  <c:v>415</c:v>
                </c:pt>
              </c:strCache>
            </c:strRef>
          </c:tx>
          <c:spPr>
            <a:solidFill>
              <a:schemeClr val="accent3">
                <a:shade val="7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4:$Q$14</c:f>
              <c:numCache>
                <c:formatCode>General</c:formatCode>
                <c:ptCount val="15"/>
                <c:pt idx="0">
                  <c:v>7.5761412171209068</c:v>
                </c:pt>
                <c:pt idx="1">
                  <c:v>3.1603228896015292</c:v>
                </c:pt>
                <c:pt idx="2">
                  <c:v>11.294971656775598</c:v>
                </c:pt>
                <c:pt idx="3">
                  <c:v>17.765130810538871</c:v>
                </c:pt>
                <c:pt idx="4">
                  <c:v>2.4275393184164868</c:v>
                </c:pt>
                <c:pt idx="5">
                  <c:v>9.6620466538813723</c:v>
                </c:pt>
                <c:pt idx="6">
                  <c:v>2.2529957280283153</c:v>
                </c:pt>
                <c:pt idx="7">
                  <c:v>5.2850800057615466</c:v>
                </c:pt>
                <c:pt idx="8">
                  <c:v>2.5340914038568694</c:v>
                </c:pt>
                <c:pt idx="9">
                  <c:v>8.7548466305922741</c:v>
                </c:pt>
                <c:pt idx="10">
                  <c:v>2.655814370463403</c:v>
                </c:pt>
                <c:pt idx="11">
                  <c:v>13.95242365539989</c:v>
                </c:pt>
                <c:pt idx="12">
                  <c:v>1.3000688791765636</c:v>
                </c:pt>
                <c:pt idx="13">
                  <c:v>2.3931427934035638</c:v>
                </c:pt>
                <c:pt idx="14">
                  <c:v>7.68551552932396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560-4C3C-A71C-E64E896B428F}"/>
            </c:ext>
          </c:extLst>
        </c:ser>
        <c:ser>
          <c:idx val="11"/>
          <c:order val="11"/>
          <c:tx>
            <c:strRef>
              <c:f>'DHA4'!$B$15</c:f>
              <c:strCache>
                <c:ptCount val="1"/>
                <c:pt idx="0">
                  <c:v>430</c:v>
                </c:pt>
              </c:strCache>
            </c:strRef>
          </c:tx>
          <c:spPr>
            <a:solidFill>
              <a:schemeClr val="accent3">
                <a:shade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5:$Q$15</c:f>
              <c:numCache>
                <c:formatCode>General</c:formatCode>
                <c:ptCount val="15"/>
                <c:pt idx="0">
                  <c:v>8.1650899131749259</c:v>
                </c:pt>
                <c:pt idx="1">
                  <c:v>3.5492017638641862</c:v>
                </c:pt>
                <c:pt idx="2">
                  <c:v>11.98885828635324</c:v>
                </c:pt>
                <c:pt idx="3">
                  <c:v>15.137183651727689</c:v>
                </c:pt>
                <c:pt idx="4">
                  <c:v>2.593783092495753</c:v>
                </c:pt>
                <c:pt idx="5">
                  <c:v>10.945191881493734</c:v>
                </c:pt>
                <c:pt idx="6">
                  <c:v>2.9658586206505579</c:v>
                </c:pt>
                <c:pt idx="7">
                  <c:v>4.7525577380521984</c:v>
                </c:pt>
                <c:pt idx="8">
                  <c:v>2.4349104792092287</c:v>
                </c:pt>
                <c:pt idx="9">
                  <c:v>6.9244908931745028</c:v>
                </c:pt>
                <c:pt idx="10">
                  <c:v>3.3368655354124477</c:v>
                </c:pt>
                <c:pt idx="11">
                  <c:v>14.397589121055752</c:v>
                </c:pt>
                <c:pt idx="12">
                  <c:v>1.2592935696026424</c:v>
                </c:pt>
                <c:pt idx="13">
                  <c:v>2.4434055440150075</c:v>
                </c:pt>
                <c:pt idx="14">
                  <c:v>7.8809797935887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560-4C3C-A71C-E64E896B428F}"/>
            </c:ext>
          </c:extLst>
        </c:ser>
        <c:ser>
          <c:idx val="12"/>
          <c:order val="12"/>
          <c:tx>
            <c:strRef>
              <c:f>'DHA4'!$B$16</c:f>
              <c:strCache>
                <c:ptCount val="1"/>
                <c:pt idx="0">
                  <c:v>425</c:v>
                </c:pt>
              </c:strCache>
            </c:strRef>
          </c:tx>
          <c:spPr>
            <a:solidFill>
              <a:schemeClr val="accent3">
                <a:shade val="5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6:$Q$16</c:f>
              <c:numCache>
                <c:formatCode>General</c:formatCode>
                <c:ptCount val="15"/>
                <c:pt idx="0">
                  <c:v>7.7540719221247656</c:v>
                </c:pt>
                <c:pt idx="1">
                  <c:v>3.1982703826280718</c:v>
                </c:pt>
                <c:pt idx="2">
                  <c:v>9.909522710989533</c:v>
                </c:pt>
                <c:pt idx="3">
                  <c:v>18.474772401138065</c:v>
                </c:pt>
                <c:pt idx="4">
                  <c:v>2.7198196340182648</c:v>
                </c:pt>
                <c:pt idx="5">
                  <c:v>9.6722395353182602</c:v>
                </c:pt>
                <c:pt idx="6">
                  <c:v>2.1657497856526513</c:v>
                </c:pt>
                <c:pt idx="7">
                  <c:v>5.0832472483521727</c:v>
                </c:pt>
                <c:pt idx="8">
                  <c:v>2.5067531338144242</c:v>
                </c:pt>
                <c:pt idx="9">
                  <c:v>8.2482392167723315</c:v>
                </c:pt>
                <c:pt idx="10">
                  <c:v>2.5504833199987309</c:v>
                </c:pt>
                <c:pt idx="11">
                  <c:v>15.249113665768613</c:v>
                </c:pt>
                <c:pt idx="12">
                  <c:v>1.0354803742394727</c:v>
                </c:pt>
                <c:pt idx="13">
                  <c:v>2.4502011323201365</c:v>
                </c:pt>
                <c:pt idx="14">
                  <c:v>8.277438626659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560-4C3C-A71C-E64E896B428F}"/>
            </c:ext>
          </c:extLst>
        </c:ser>
        <c:ser>
          <c:idx val="13"/>
          <c:order val="13"/>
          <c:tx>
            <c:strRef>
              <c:f>'DHA4'!$B$17</c:f>
              <c:strCache>
                <c:ptCount val="1"/>
                <c:pt idx="0">
                  <c:v>404</c:v>
                </c:pt>
              </c:strCache>
            </c:strRef>
          </c:tx>
          <c:spPr>
            <a:solidFill>
              <a:schemeClr val="accent3">
                <a:shade val="4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7:$Q$17</c:f>
              <c:numCache>
                <c:formatCode>General</c:formatCode>
                <c:ptCount val="15"/>
                <c:pt idx="0">
                  <c:v>8.2722538331768973</c:v>
                </c:pt>
                <c:pt idx="1">
                  <c:v>3.6396449738995651</c:v>
                </c:pt>
                <c:pt idx="2">
                  <c:v>12.232634269307352</c:v>
                </c:pt>
                <c:pt idx="3">
                  <c:v>17.253389767156357</c:v>
                </c:pt>
                <c:pt idx="4">
                  <c:v>2.8555768459576556</c:v>
                </c:pt>
                <c:pt idx="5">
                  <c:v>7.535943963260415</c:v>
                </c:pt>
                <c:pt idx="6">
                  <c:v>2.2814178478283651</c:v>
                </c:pt>
                <c:pt idx="7">
                  <c:v>4.4399799904869717</c:v>
                </c:pt>
                <c:pt idx="8">
                  <c:v>1.960357165779792</c:v>
                </c:pt>
                <c:pt idx="9">
                  <c:v>9.1792727648976111</c:v>
                </c:pt>
                <c:pt idx="10">
                  <c:v>1.9025225768328917</c:v>
                </c:pt>
                <c:pt idx="11">
                  <c:v>15.797773044214923</c:v>
                </c:pt>
                <c:pt idx="12">
                  <c:v>0.99437436561838655</c:v>
                </c:pt>
                <c:pt idx="13">
                  <c:v>2.4821963039115937</c:v>
                </c:pt>
                <c:pt idx="14">
                  <c:v>8.1242559527972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560-4C3C-A71C-E64E896B428F}"/>
            </c:ext>
          </c:extLst>
        </c:ser>
        <c:ser>
          <c:idx val="14"/>
          <c:order val="14"/>
          <c:tx>
            <c:strRef>
              <c:f>'DHA4'!$B$18</c:f>
              <c:strCache>
                <c:ptCount val="1"/>
                <c:pt idx="0">
                  <c:v>405</c:v>
                </c:pt>
              </c:strCache>
            </c:strRef>
          </c:tx>
          <c:spPr>
            <a:solidFill>
              <a:schemeClr val="accent3">
                <a:shade val="3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4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4'!$C$18:$Q$18</c:f>
              <c:numCache>
                <c:formatCode>General</c:formatCode>
                <c:ptCount val="15"/>
                <c:pt idx="0">
                  <c:v>8.4429992372397464</c:v>
                </c:pt>
                <c:pt idx="1">
                  <c:v>4.1875850733351658</c:v>
                </c:pt>
                <c:pt idx="2">
                  <c:v>9.4141854975596875</c:v>
                </c:pt>
                <c:pt idx="3">
                  <c:v>18.144547452801795</c:v>
                </c:pt>
                <c:pt idx="4">
                  <c:v>2.9901621530325961</c:v>
                </c:pt>
                <c:pt idx="5">
                  <c:v>7.7483064362166498</c:v>
                </c:pt>
                <c:pt idx="6">
                  <c:v>2.29288551033788</c:v>
                </c:pt>
                <c:pt idx="7">
                  <c:v>4.9609969784885726</c:v>
                </c:pt>
                <c:pt idx="8">
                  <c:v>3.0758382658102077</c:v>
                </c:pt>
                <c:pt idx="9">
                  <c:v>8.790510785449305</c:v>
                </c:pt>
                <c:pt idx="10">
                  <c:v>2.9297955505111153</c:v>
                </c:pt>
                <c:pt idx="11">
                  <c:v>15.267764974932451</c:v>
                </c:pt>
                <c:pt idx="12">
                  <c:v>0.82462768032403744</c:v>
                </c:pt>
                <c:pt idx="13">
                  <c:v>2.9140372802568129</c:v>
                </c:pt>
                <c:pt idx="14">
                  <c:v>7.2311591999142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560-4C3C-A71C-E64E896B42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058355376"/>
        <c:axId val="1058355704"/>
      </c:barChart>
      <c:catAx>
        <c:axId val="1058355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8355704"/>
        <c:crosses val="autoZero"/>
        <c:auto val="1"/>
        <c:lblAlgn val="ctr"/>
        <c:lblOffset val="100"/>
        <c:noMultiLvlLbl val="0"/>
      </c:catAx>
      <c:valAx>
        <c:axId val="1058355704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</a:p>
            </c:rich>
          </c:tx>
          <c:layout>
            <c:manualLayout>
              <c:xMode val="edge"/>
              <c:yMode val="edge"/>
              <c:x val="0"/>
              <c:y val="0.140768709231084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835537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605877058864333"/>
          <c:y val="0.80558936815716109"/>
          <c:w val="0.79602779717555983"/>
          <c:h val="9.45362892693500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50"/>
              <a:t>DHA2015.1</a:t>
            </a:r>
          </a:p>
        </c:rich>
      </c:tx>
      <c:layout>
        <c:manualLayout>
          <c:xMode val="edge"/>
          <c:yMode val="edge"/>
          <c:x val="0.43441246695659597"/>
          <c:y val="3.94744817161142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90067792274239"/>
          <c:y val="3.7589224224801397E-2"/>
          <c:w val="0.86444981687542888"/>
          <c:h val="0.601520144491022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HA1'!$B$4</c:f>
              <c:strCache>
                <c:ptCount val="1"/>
                <c:pt idx="0">
                  <c:v>104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4:$Q$4</c:f>
              <c:numCache>
                <c:formatCode>General</c:formatCode>
                <c:ptCount val="15"/>
                <c:pt idx="0">
                  <c:v>8.1125853206972067</c:v>
                </c:pt>
                <c:pt idx="1">
                  <c:v>6.0249819486982776</c:v>
                </c:pt>
                <c:pt idx="2">
                  <c:v>5.599860778965251</c:v>
                </c:pt>
                <c:pt idx="3">
                  <c:v>26.075171021842415</c:v>
                </c:pt>
                <c:pt idx="4">
                  <c:v>2.2315813003487532</c:v>
                </c:pt>
                <c:pt idx="5">
                  <c:v>13.353351009885678</c:v>
                </c:pt>
                <c:pt idx="6">
                  <c:v>1.2243997557760411</c:v>
                </c:pt>
                <c:pt idx="7">
                  <c:v>4.7891738365784944</c:v>
                </c:pt>
                <c:pt idx="8">
                  <c:v>0.68061629711760652</c:v>
                </c:pt>
                <c:pt idx="9">
                  <c:v>2.7104338894003672</c:v>
                </c:pt>
                <c:pt idx="10">
                  <c:v>2.1947227337838959</c:v>
                </c:pt>
                <c:pt idx="11">
                  <c:v>8.4429417929841009</c:v>
                </c:pt>
                <c:pt idx="12">
                  <c:v>3.5125849724734595</c:v>
                </c:pt>
                <c:pt idx="13">
                  <c:v>5.7314205541466317</c:v>
                </c:pt>
                <c:pt idx="14">
                  <c:v>8.55217782388710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F1-4AC5-92D2-D90D3B4159D7}"/>
            </c:ext>
          </c:extLst>
        </c:ser>
        <c:ser>
          <c:idx val="1"/>
          <c:order val="1"/>
          <c:tx>
            <c:strRef>
              <c:f>'DHA1'!$B$5</c:f>
              <c:strCache>
                <c:ptCount val="1"/>
                <c:pt idx="0">
                  <c:v>122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5:$Q$5</c:f>
              <c:numCache>
                <c:formatCode>General</c:formatCode>
                <c:ptCount val="15"/>
                <c:pt idx="0">
                  <c:v>7.6778886866299221</c:v>
                </c:pt>
                <c:pt idx="1">
                  <c:v>4.2682101799640666</c:v>
                </c:pt>
                <c:pt idx="2">
                  <c:v>7.0135465439242424</c:v>
                </c:pt>
                <c:pt idx="3">
                  <c:v>24.178725167939973</c:v>
                </c:pt>
                <c:pt idx="4">
                  <c:v>2.6219294108211741</c:v>
                </c:pt>
                <c:pt idx="5">
                  <c:v>14.854232857498442</c:v>
                </c:pt>
                <c:pt idx="6">
                  <c:v>1.69899371915298</c:v>
                </c:pt>
                <c:pt idx="7">
                  <c:v>4.9087791261113694</c:v>
                </c:pt>
                <c:pt idx="8">
                  <c:v>0.68505457896808863</c:v>
                </c:pt>
                <c:pt idx="9">
                  <c:v>2.8835771564862562</c:v>
                </c:pt>
                <c:pt idx="10">
                  <c:v>2.1014156914251219</c:v>
                </c:pt>
                <c:pt idx="11">
                  <c:v>8.5844878425182163</c:v>
                </c:pt>
                <c:pt idx="12">
                  <c:v>4.0794062780223506</c:v>
                </c:pt>
                <c:pt idx="13">
                  <c:v>5.7356490240961344</c:v>
                </c:pt>
                <c:pt idx="14">
                  <c:v>7.40418080074532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F1-4AC5-92D2-D90D3B4159D7}"/>
            </c:ext>
          </c:extLst>
        </c:ser>
        <c:ser>
          <c:idx val="2"/>
          <c:order val="2"/>
          <c:tx>
            <c:strRef>
              <c:f>'DHA1'!$B$6</c:f>
              <c:strCache>
                <c:ptCount val="1"/>
                <c:pt idx="0">
                  <c:v>112</c:v>
                </c:pt>
              </c:strCache>
            </c:strRef>
          </c:tx>
          <c:spPr>
            <a:solidFill>
              <a:schemeClr val="accent3">
                <a:tint val="4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6:$Q$6</c:f>
              <c:numCache>
                <c:formatCode>General</c:formatCode>
                <c:ptCount val="15"/>
                <c:pt idx="0">
                  <c:v>8.7271175065189901</c:v>
                </c:pt>
                <c:pt idx="1">
                  <c:v>3.8641811376214994</c:v>
                </c:pt>
                <c:pt idx="2">
                  <c:v>6.9701359912749732</c:v>
                </c:pt>
                <c:pt idx="3">
                  <c:v>25.255769530680585</c:v>
                </c:pt>
                <c:pt idx="4">
                  <c:v>2.7671513474587486</c:v>
                </c:pt>
                <c:pt idx="5">
                  <c:v>12.98711503437301</c:v>
                </c:pt>
                <c:pt idx="6">
                  <c:v>2.1488748784257088</c:v>
                </c:pt>
                <c:pt idx="7">
                  <c:v>5.6397129314060717</c:v>
                </c:pt>
                <c:pt idx="8">
                  <c:v>0.62696629607922105</c:v>
                </c:pt>
                <c:pt idx="9">
                  <c:v>3.298406362821896</c:v>
                </c:pt>
                <c:pt idx="10">
                  <c:v>1.783503279808208</c:v>
                </c:pt>
                <c:pt idx="11">
                  <c:v>7.9446427212638175</c:v>
                </c:pt>
                <c:pt idx="12">
                  <c:v>3.5690150621136461</c:v>
                </c:pt>
                <c:pt idx="13">
                  <c:v>6.1629307356712211</c:v>
                </c:pt>
                <c:pt idx="14">
                  <c:v>6.6781094545269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FF1-4AC5-92D2-D90D3B4159D7}"/>
            </c:ext>
          </c:extLst>
        </c:ser>
        <c:ser>
          <c:idx val="3"/>
          <c:order val="3"/>
          <c:tx>
            <c:strRef>
              <c:f>'DHA1'!$B$7</c:f>
              <c:strCache>
                <c:ptCount val="1"/>
                <c:pt idx="0">
                  <c:v>119</c:v>
                </c:pt>
              </c:strCache>
            </c:strRef>
          </c:tx>
          <c:spPr>
            <a:solidFill>
              <a:schemeClr val="accent3">
                <a:tint val="4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7:$Q$7</c:f>
              <c:numCache>
                <c:formatCode>General</c:formatCode>
                <c:ptCount val="15"/>
                <c:pt idx="0">
                  <c:v>8.407010760783276</c:v>
                </c:pt>
                <c:pt idx="1">
                  <c:v>4.8536547758148707</c:v>
                </c:pt>
                <c:pt idx="2">
                  <c:v>6.460555205322291</c:v>
                </c:pt>
                <c:pt idx="3">
                  <c:v>22.798891512900518</c:v>
                </c:pt>
                <c:pt idx="4">
                  <c:v>2.5566121180848951</c:v>
                </c:pt>
                <c:pt idx="5">
                  <c:v>11.507476505983682</c:v>
                </c:pt>
                <c:pt idx="6">
                  <c:v>1.5093616410004183</c:v>
                </c:pt>
                <c:pt idx="7">
                  <c:v>4.9546715687366936</c:v>
                </c:pt>
                <c:pt idx="8">
                  <c:v>0.79359061142508702</c:v>
                </c:pt>
                <c:pt idx="9">
                  <c:v>3.29842414227141</c:v>
                </c:pt>
                <c:pt idx="10">
                  <c:v>2.5904339194478743</c:v>
                </c:pt>
                <c:pt idx="11">
                  <c:v>9.7601890264757127</c:v>
                </c:pt>
                <c:pt idx="12">
                  <c:v>3.9581768030702356</c:v>
                </c:pt>
                <c:pt idx="13">
                  <c:v>6.9045114535524732</c:v>
                </c:pt>
                <c:pt idx="14">
                  <c:v>8.3115045117256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FF1-4AC5-92D2-D90D3B4159D7}"/>
            </c:ext>
          </c:extLst>
        </c:ser>
        <c:ser>
          <c:idx val="4"/>
          <c:order val="4"/>
          <c:tx>
            <c:strRef>
              <c:f>'DHA1'!$B$8</c:f>
              <c:strCache>
                <c:ptCount val="1"/>
                <c:pt idx="0">
                  <c:v>108</c:v>
                </c:pt>
              </c:strCache>
            </c:strRef>
          </c:tx>
          <c:spPr>
            <a:solidFill>
              <a:schemeClr val="accent3">
                <a:tint val="5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8:$Q$8</c:f>
              <c:numCache>
                <c:formatCode>General</c:formatCode>
                <c:ptCount val="15"/>
                <c:pt idx="0">
                  <c:v>8.5634071064553314</c:v>
                </c:pt>
                <c:pt idx="1">
                  <c:v>3.9712956336905267</c:v>
                </c:pt>
                <c:pt idx="2">
                  <c:v>6.9649577657054111</c:v>
                </c:pt>
                <c:pt idx="3">
                  <c:v>25.133600524500814</c:v>
                </c:pt>
                <c:pt idx="4">
                  <c:v>1.8476368517001283</c:v>
                </c:pt>
                <c:pt idx="5">
                  <c:v>12.632468961918789</c:v>
                </c:pt>
                <c:pt idx="6">
                  <c:v>1.2707119311770134</c:v>
                </c:pt>
                <c:pt idx="7">
                  <c:v>5.5014565824904871</c:v>
                </c:pt>
                <c:pt idx="8">
                  <c:v>0.66742009291962956</c:v>
                </c:pt>
                <c:pt idx="9">
                  <c:v>3.1615111879381033</c:v>
                </c:pt>
                <c:pt idx="10">
                  <c:v>2.052612079666627</c:v>
                </c:pt>
                <c:pt idx="11">
                  <c:v>8.1108087107923179</c:v>
                </c:pt>
                <c:pt idx="12">
                  <c:v>4.1116372252489466</c:v>
                </c:pt>
                <c:pt idx="13">
                  <c:v>6.9403265618028493</c:v>
                </c:pt>
                <c:pt idx="14">
                  <c:v>7.5040891549959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FF1-4AC5-92D2-D90D3B4159D7}"/>
            </c:ext>
          </c:extLst>
        </c:ser>
        <c:ser>
          <c:idx val="5"/>
          <c:order val="5"/>
          <c:tx>
            <c:strRef>
              <c:f>'DHA1'!$B$9</c:f>
              <c:strCache>
                <c:ptCount val="1"/>
                <c:pt idx="0">
                  <c:v>110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9:$Q$9</c:f>
              <c:numCache>
                <c:formatCode>General</c:formatCode>
                <c:ptCount val="15"/>
                <c:pt idx="0">
                  <c:v>8.6681988161351953</c:v>
                </c:pt>
                <c:pt idx="1">
                  <c:v>3.9650701674988986</c:v>
                </c:pt>
                <c:pt idx="2">
                  <c:v>6.0549537073662165</c:v>
                </c:pt>
                <c:pt idx="3">
                  <c:v>24.332119273236632</c:v>
                </c:pt>
                <c:pt idx="4">
                  <c:v>2.530714919420912</c:v>
                </c:pt>
                <c:pt idx="5">
                  <c:v>13.173346393566657</c:v>
                </c:pt>
                <c:pt idx="6">
                  <c:v>1.8752770692162977</c:v>
                </c:pt>
                <c:pt idx="7">
                  <c:v>4.92600015002688</c:v>
                </c:pt>
                <c:pt idx="8">
                  <c:v>0.60676966429614454</c:v>
                </c:pt>
                <c:pt idx="9">
                  <c:v>3.1575555814045657</c:v>
                </c:pt>
                <c:pt idx="10">
                  <c:v>2.1429191865348609</c:v>
                </c:pt>
                <c:pt idx="11">
                  <c:v>8.7701969788442966</c:v>
                </c:pt>
                <c:pt idx="12">
                  <c:v>3.8564511636582934</c:v>
                </c:pt>
                <c:pt idx="13">
                  <c:v>6.9626936204969496</c:v>
                </c:pt>
                <c:pt idx="14">
                  <c:v>7.1624414204499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FF1-4AC5-92D2-D90D3B4159D7}"/>
            </c:ext>
          </c:extLst>
        </c:ser>
        <c:ser>
          <c:idx val="6"/>
          <c:order val="6"/>
          <c:tx>
            <c:strRef>
              <c:f>'DHA1'!$B$10</c:f>
              <c:strCache>
                <c:ptCount val="1"/>
                <c:pt idx="0">
                  <c:v>127</c:v>
                </c:pt>
              </c:strCache>
            </c:strRef>
          </c:tx>
          <c:spPr>
            <a:solidFill>
              <a:schemeClr val="accent3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0:$Q$10</c:f>
              <c:numCache>
                <c:formatCode>General</c:formatCode>
                <c:ptCount val="15"/>
                <c:pt idx="0">
                  <c:v>7.5936495608155585</c:v>
                </c:pt>
                <c:pt idx="1">
                  <c:v>3.4814189066659456</c:v>
                </c:pt>
                <c:pt idx="2">
                  <c:v>6.3066068379507438</c:v>
                </c:pt>
                <c:pt idx="3">
                  <c:v>25.072534196433388</c:v>
                </c:pt>
                <c:pt idx="4">
                  <c:v>2.1565384422782858</c:v>
                </c:pt>
                <c:pt idx="5">
                  <c:v>13.525895441620969</c:v>
                </c:pt>
                <c:pt idx="6">
                  <c:v>1.665456325431957</c:v>
                </c:pt>
                <c:pt idx="7">
                  <c:v>4.9306245588617159</c:v>
                </c:pt>
                <c:pt idx="8">
                  <c:v>0.68495881781833223</c:v>
                </c:pt>
                <c:pt idx="9">
                  <c:v>3.1212646941500841</c:v>
                </c:pt>
                <c:pt idx="10">
                  <c:v>2.2827591918098493</c:v>
                </c:pt>
                <c:pt idx="11">
                  <c:v>9.481803155310109</c:v>
                </c:pt>
                <c:pt idx="12">
                  <c:v>3.9509278212696755</c:v>
                </c:pt>
                <c:pt idx="13">
                  <c:v>6.9801318178945087</c:v>
                </c:pt>
                <c:pt idx="14">
                  <c:v>7.1323698686450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FF1-4AC5-92D2-D90D3B4159D7}"/>
            </c:ext>
          </c:extLst>
        </c:ser>
        <c:ser>
          <c:idx val="7"/>
          <c:order val="7"/>
          <c:tx>
            <c:strRef>
              <c:f>'DHA1'!$B$11</c:f>
              <c:strCache>
                <c:ptCount val="1"/>
                <c:pt idx="0">
                  <c:v>115</c:v>
                </c:pt>
              </c:strCache>
            </c:strRef>
          </c:tx>
          <c:spPr>
            <a:solidFill>
              <a:schemeClr val="accent3">
                <a:tint val="6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1:$Q$11</c:f>
              <c:numCache>
                <c:formatCode>General</c:formatCode>
                <c:ptCount val="15"/>
                <c:pt idx="0">
                  <c:v>8.7527274801242232</c:v>
                </c:pt>
                <c:pt idx="1">
                  <c:v>5.1286133429473972</c:v>
                </c:pt>
                <c:pt idx="2">
                  <c:v>6.4937613752815695</c:v>
                </c:pt>
                <c:pt idx="3">
                  <c:v>24.867702206248634</c:v>
                </c:pt>
                <c:pt idx="4">
                  <c:v>3.147227065540414</c:v>
                </c:pt>
                <c:pt idx="5">
                  <c:v>9.9613142018564123</c:v>
                </c:pt>
                <c:pt idx="6">
                  <c:v>1.8737936189139606</c:v>
                </c:pt>
                <c:pt idx="7">
                  <c:v>4.446196839127885</c:v>
                </c:pt>
                <c:pt idx="8">
                  <c:v>0.52515899821183576</c:v>
                </c:pt>
                <c:pt idx="9">
                  <c:v>3.688362460714163</c:v>
                </c:pt>
                <c:pt idx="10">
                  <c:v>1.7213973028765062</c:v>
                </c:pt>
                <c:pt idx="11">
                  <c:v>10.226495966063105</c:v>
                </c:pt>
                <c:pt idx="12">
                  <c:v>3.2433826393840084</c:v>
                </c:pt>
                <c:pt idx="13">
                  <c:v>7.0218049377160945</c:v>
                </c:pt>
                <c:pt idx="14">
                  <c:v>7.54733985198561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FF1-4AC5-92D2-D90D3B4159D7}"/>
            </c:ext>
          </c:extLst>
        </c:ser>
        <c:ser>
          <c:idx val="8"/>
          <c:order val="8"/>
          <c:tx>
            <c:strRef>
              <c:f>'DHA1'!$B$12</c:f>
              <c:strCache>
                <c:ptCount val="1"/>
                <c:pt idx="0">
                  <c:v>121</c:v>
                </c:pt>
              </c:strCache>
            </c:strRef>
          </c:tx>
          <c:spPr>
            <a:solidFill>
              <a:schemeClr val="accent3">
                <a:tint val="7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2:$Q$12</c:f>
              <c:numCache>
                <c:formatCode>General</c:formatCode>
                <c:ptCount val="15"/>
                <c:pt idx="0">
                  <c:v>7.0202314137325272</c:v>
                </c:pt>
                <c:pt idx="1">
                  <c:v>3.3427078682663409</c:v>
                </c:pt>
                <c:pt idx="2">
                  <c:v>5.5253552904531098</c:v>
                </c:pt>
                <c:pt idx="3">
                  <c:v>20.392065796017352</c:v>
                </c:pt>
                <c:pt idx="4">
                  <c:v>2.7945772396887252</c:v>
                </c:pt>
                <c:pt idx="5">
                  <c:v>17.884302552798093</c:v>
                </c:pt>
                <c:pt idx="6">
                  <c:v>2.0822259740456777</c:v>
                </c:pt>
                <c:pt idx="7">
                  <c:v>5.5988334343055026</c:v>
                </c:pt>
                <c:pt idx="8">
                  <c:v>0.64038684927984968</c:v>
                </c:pt>
                <c:pt idx="9">
                  <c:v>2.5290522929565662</c:v>
                </c:pt>
                <c:pt idx="10">
                  <c:v>2.3438800355402121</c:v>
                </c:pt>
                <c:pt idx="11">
                  <c:v>9.8862261569685739</c:v>
                </c:pt>
                <c:pt idx="12">
                  <c:v>4.6799215703306771</c:v>
                </c:pt>
                <c:pt idx="13">
                  <c:v>7.0650777104960119</c:v>
                </c:pt>
                <c:pt idx="14">
                  <c:v>7.4439396514066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FF1-4AC5-92D2-D90D3B4159D7}"/>
            </c:ext>
          </c:extLst>
        </c:ser>
        <c:ser>
          <c:idx val="9"/>
          <c:order val="9"/>
          <c:tx>
            <c:strRef>
              <c:f>'DHA1'!$B$13</c:f>
              <c:strCache>
                <c:ptCount val="1"/>
                <c:pt idx="0">
                  <c:v>120</c:v>
                </c:pt>
              </c:strCache>
            </c:strRef>
          </c:tx>
          <c:spPr>
            <a:solidFill>
              <a:schemeClr val="accent3">
                <a:tint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3:$Q$13</c:f>
              <c:numCache>
                <c:formatCode>General</c:formatCode>
                <c:ptCount val="15"/>
                <c:pt idx="0">
                  <c:v>8.4716929462244401</c:v>
                </c:pt>
                <c:pt idx="1">
                  <c:v>4.441378288555522</c:v>
                </c:pt>
                <c:pt idx="2">
                  <c:v>6.3019183227059949</c:v>
                </c:pt>
                <c:pt idx="3">
                  <c:v>24.709740543883058</c:v>
                </c:pt>
                <c:pt idx="4">
                  <c:v>2.3149819316125679</c:v>
                </c:pt>
                <c:pt idx="5">
                  <c:v>12.137245274397841</c:v>
                </c:pt>
                <c:pt idx="6">
                  <c:v>1.4972206709768539</c:v>
                </c:pt>
                <c:pt idx="7">
                  <c:v>4.7433759202628218</c:v>
                </c:pt>
                <c:pt idx="8">
                  <c:v>0.68009102471200877</c:v>
                </c:pt>
                <c:pt idx="9">
                  <c:v>3.0403650253789816</c:v>
                </c:pt>
                <c:pt idx="10">
                  <c:v>2.2246454902756012</c:v>
                </c:pt>
                <c:pt idx="11">
                  <c:v>9.6016632397754318</c:v>
                </c:pt>
                <c:pt idx="12">
                  <c:v>3.5877203285039774</c:v>
                </c:pt>
                <c:pt idx="13">
                  <c:v>7.0665967944373573</c:v>
                </c:pt>
                <c:pt idx="14">
                  <c:v>7.612044551693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FF1-4AC5-92D2-D90D3B4159D7}"/>
            </c:ext>
          </c:extLst>
        </c:ser>
        <c:ser>
          <c:idx val="10"/>
          <c:order val="10"/>
          <c:tx>
            <c:strRef>
              <c:f>'DHA1'!$B$14</c:f>
              <c:strCache>
                <c:ptCount val="1"/>
                <c:pt idx="0">
                  <c:v>123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4:$Q$14</c:f>
              <c:numCache>
                <c:formatCode>General</c:formatCode>
                <c:ptCount val="15"/>
                <c:pt idx="0">
                  <c:v>9.1699813611067178</c:v>
                </c:pt>
                <c:pt idx="1">
                  <c:v>4.40775388041261</c:v>
                </c:pt>
                <c:pt idx="2">
                  <c:v>5.9249405386973963</c:v>
                </c:pt>
                <c:pt idx="3">
                  <c:v>24.271163075163297</c:v>
                </c:pt>
                <c:pt idx="4">
                  <c:v>2.6062304144896538</c:v>
                </c:pt>
                <c:pt idx="5">
                  <c:v>12.021148781196542</c:v>
                </c:pt>
                <c:pt idx="6">
                  <c:v>1.8197226013067138</c:v>
                </c:pt>
                <c:pt idx="7">
                  <c:v>4.4748152401865067</c:v>
                </c:pt>
                <c:pt idx="8">
                  <c:v>0.61923298086720047</c:v>
                </c:pt>
                <c:pt idx="9">
                  <c:v>3.2745642079870998</c:v>
                </c:pt>
                <c:pt idx="10">
                  <c:v>2.1762163403023633</c:v>
                </c:pt>
                <c:pt idx="11">
                  <c:v>9.343307570146985</c:v>
                </c:pt>
                <c:pt idx="12">
                  <c:v>3.7495388416797129</c:v>
                </c:pt>
                <c:pt idx="13">
                  <c:v>7.1210829141513843</c:v>
                </c:pt>
                <c:pt idx="14">
                  <c:v>7.2497667731090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FF1-4AC5-92D2-D90D3B4159D7}"/>
            </c:ext>
          </c:extLst>
        </c:ser>
        <c:ser>
          <c:idx val="11"/>
          <c:order val="11"/>
          <c:tx>
            <c:strRef>
              <c:f>'DHA1'!$B$15</c:f>
              <c:strCache>
                <c:ptCount val="1"/>
                <c:pt idx="0">
                  <c:v>101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5:$Q$15</c:f>
              <c:numCache>
                <c:formatCode>General</c:formatCode>
                <c:ptCount val="15"/>
                <c:pt idx="0">
                  <c:v>7.2486498928947034</c:v>
                </c:pt>
                <c:pt idx="1">
                  <c:v>4.3471241066994555</c:v>
                </c:pt>
                <c:pt idx="2">
                  <c:v>5.4543670867322618</c:v>
                </c:pt>
                <c:pt idx="3">
                  <c:v>21.459952948059971</c:v>
                </c:pt>
                <c:pt idx="4">
                  <c:v>2.5250765270185767</c:v>
                </c:pt>
                <c:pt idx="5">
                  <c:v>15.563290823873135</c:v>
                </c:pt>
                <c:pt idx="6">
                  <c:v>1.5975779016535745</c:v>
                </c:pt>
                <c:pt idx="7">
                  <c:v>5.5878209297589434</c:v>
                </c:pt>
                <c:pt idx="8">
                  <c:v>0.7039605663438584</c:v>
                </c:pt>
                <c:pt idx="9">
                  <c:v>2.6404601293865819</c:v>
                </c:pt>
                <c:pt idx="10">
                  <c:v>2.2916702768718831</c:v>
                </c:pt>
                <c:pt idx="11">
                  <c:v>9.8313867538326445</c:v>
                </c:pt>
                <c:pt idx="12">
                  <c:v>4.5119097620572539</c:v>
                </c:pt>
                <c:pt idx="13">
                  <c:v>7.1376931084007218</c:v>
                </c:pt>
                <c:pt idx="14">
                  <c:v>8.2613293455833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FF1-4AC5-92D2-D90D3B4159D7}"/>
            </c:ext>
          </c:extLst>
        </c:ser>
        <c:ser>
          <c:idx val="12"/>
          <c:order val="12"/>
          <c:tx>
            <c:strRef>
              <c:f>'DHA1'!$B$16</c:f>
              <c:strCache>
                <c:ptCount val="1"/>
                <c:pt idx="0">
                  <c:v>103</c:v>
                </c:pt>
              </c:strCache>
            </c:strRef>
          </c:tx>
          <c:spPr>
            <a:solidFill>
              <a:schemeClr val="accent3">
                <a:tint val="8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6:$Q$16</c:f>
              <c:numCache>
                <c:formatCode>General</c:formatCode>
                <c:ptCount val="15"/>
                <c:pt idx="0">
                  <c:v>9.0857128882892617</c:v>
                </c:pt>
                <c:pt idx="1">
                  <c:v>3.9700833421993966</c:v>
                </c:pt>
                <c:pt idx="2">
                  <c:v>5.9144452184663683</c:v>
                </c:pt>
                <c:pt idx="3">
                  <c:v>24.019534759412881</c:v>
                </c:pt>
                <c:pt idx="4">
                  <c:v>2.2466376899324003</c:v>
                </c:pt>
                <c:pt idx="5">
                  <c:v>13.656444435996598</c:v>
                </c:pt>
                <c:pt idx="6">
                  <c:v>1.5952745905841339</c:v>
                </c:pt>
                <c:pt idx="7">
                  <c:v>4.5817639872834564</c:v>
                </c:pt>
                <c:pt idx="8">
                  <c:v>0.67833060196008677</c:v>
                </c:pt>
                <c:pt idx="9">
                  <c:v>2.9227082921841507</c:v>
                </c:pt>
                <c:pt idx="10">
                  <c:v>2.4794476734810753</c:v>
                </c:pt>
                <c:pt idx="11">
                  <c:v>8.8435292457153665</c:v>
                </c:pt>
                <c:pt idx="12">
                  <c:v>3.3857925910113993</c:v>
                </c:pt>
                <c:pt idx="13">
                  <c:v>7.2428970612971852</c:v>
                </c:pt>
                <c:pt idx="14">
                  <c:v>7.69122133100040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FF1-4AC5-92D2-D90D3B4159D7}"/>
            </c:ext>
          </c:extLst>
        </c:ser>
        <c:ser>
          <c:idx val="13"/>
          <c:order val="13"/>
          <c:tx>
            <c:strRef>
              <c:f>'DHA1'!$B$17</c:f>
              <c:strCache>
                <c:ptCount val="1"/>
                <c:pt idx="0">
                  <c:v>113</c:v>
                </c:pt>
              </c:strCache>
            </c:strRef>
          </c:tx>
          <c:spPr>
            <a:solidFill>
              <a:schemeClr val="accent3">
                <a:tint val="9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7:$Q$17</c:f>
              <c:numCache>
                <c:formatCode>General</c:formatCode>
                <c:ptCount val="15"/>
                <c:pt idx="0">
                  <c:v>8.6718630707779987</c:v>
                </c:pt>
                <c:pt idx="1">
                  <c:v>4.9226387303854677</c:v>
                </c:pt>
                <c:pt idx="2">
                  <c:v>5.8466489230891083</c:v>
                </c:pt>
                <c:pt idx="3">
                  <c:v>20.928268656512305</c:v>
                </c:pt>
                <c:pt idx="4">
                  <c:v>2.6809757193548975</c:v>
                </c:pt>
                <c:pt idx="5">
                  <c:v>13.231151093969046</c:v>
                </c:pt>
                <c:pt idx="6">
                  <c:v>1.681392514083984</c:v>
                </c:pt>
                <c:pt idx="7">
                  <c:v>4.6280664190343597</c:v>
                </c:pt>
                <c:pt idx="8">
                  <c:v>0.67550582661124847</c:v>
                </c:pt>
                <c:pt idx="9">
                  <c:v>2.7466558967612436</c:v>
                </c:pt>
                <c:pt idx="10">
                  <c:v>2.7297799875230595</c:v>
                </c:pt>
                <c:pt idx="11">
                  <c:v>9.8446655136378425</c:v>
                </c:pt>
                <c:pt idx="12">
                  <c:v>3.940942786257601</c:v>
                </c:pt>
                <c:pt idx="13">
                  <c:v>7.5398694823279593</c:v>
                </c:pt>
                <c:pt idx="14">
                  <c:v>8.36941359290909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FF1-4AC5-92D2-D90D3B4159D7}"/>
            </c:ext>
          </c:extLst>
        </c:ser>
        <c:ser>
          <c:idx val="14"/>
          <c:order val="14"/>
          <c:tx>
            <c:strRef>
              <c:f>'DHA1'!$B$18</c:f>
              <c:strCache>
                <c:ptCount val="1"/>
                <c:pt idx="0">
                  <c:v>102</c:v>
                </c:pt>
              </c:strCache>
            </c:strRef>
          </c:tx>
          <c:spPr>
            <a:solidFill>
              <a:schemeClr val="accent3">
                <a:tint val="9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8:$Q$18</c:f>
              <c:numCache>
                <c:formatCode>General</c:formatCode>
                <c:ptCount val="15"/>
                <c:pt idx="0">
                  <c:v>7.3517286327767364</c:v>
                </c:pt>
                <c:pt idx="1">
                  <c:v>4.4911460032828119</c:v>
                </c:pt>
                <c:pt idx="2">
                  <c:v>4.8512355023467588</c:v>
                </c:pt>
                <c:pt idx="3">
                  <c:v>22.74514073719882</c:v>
                </c:pt>
                <c:pt idx="4">
                  <c:v>3.5074832769996971</c:v>
                </c:pt>
                <c:pt idx="5">
                  <c:v>11.145604764411566</c:v>
                </c:pt>
                <c:pt idx="6">
                  <c:v>2.0498410198075265</c:v>
                </c:pt>
                <c:pt idx="7">
                  <c:v>3.9416250035352256</c:v>
                </c:pt>
                <c:pt idx="8">
                  <c:v>0.81151742092272006</c:v>
                </c:pt>
                <c:pt idx="9">
                  <c:v>2.9641096695436184</c:v>
                </c:pt>
                <c:pt idx="10">
                  <c:v>3.0025613748950986</c:v>
                </c:pt>
                <c:pt idx="11">
                  <c:v>12.541038601833028</c:v>
                </c:pt>
                <c:pt idx="12">
                  <c:v>3.7347252520304934</c:v>
                </c:pt>
                <c:pt idx="13">
                  <c:v>7.6240130646989721</c:v>
                </c:pt>
                <c:pt idx="14">
                  <c:v>8.3266390276735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2FF1-4AC5-92D2-D90D3B4159D7}"/>
            </c:ext>
          </c:extLst>
        </c:ser>
        <c:ser>
          <c:idx val="15"/>
          <c:order val="15"/>
          <c:tx>
            <c:strRef>
              <c:f>'DHA1'!$B$19</c:f>
              <c:strCache>
                <c:ptCount val="1"/>
                <c:pt idx="0">
                  <c:v>126</c:v>
                </c:pt>
              </c:strCache>
            </c:strRef>
          </c:tx>
          <c:spPr>
            <a:solidFill>
              <a:schemeClr val="accent3">
                <a:shade val="9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19:$Q$19</c:f>
              <c:numCache>
                <c:formatCode>General</c:formatCode>
                <c:ptCount val="15"/>
                <c:pt idx="0">
                  <c:v>8.0185893285461365</c:v>
                </c:pt>
                <c:pt idx="1">
                  <c:v>4.5654648316091979</c:v>
                </c:pt>
                <c:pt idx="2">
                  <c:v>5.6471413052649666</c:v>
                </c:pt>
                <c:pt idx="3">
                  <c:v>19.577540877435862</c:v>
                </c:pt>
                <c:pt idx="4">
                  <c:v>2.8980658744168171</c:v>
                </c:pt>
                <c:pt idx="5">
                  <c:v>15.644154989778908</c:v>
                </c:pt>
                <c:pt idx="6">
                  <c:v>2.0212260225716205</c:v>
                </c:pt>
                <c:pt idx="7">
                  <c:v>4.1631885619112561</c:v>
                </c:pt>
                <c:pt idx="8">
                  <c:v>0.73554275199298202</c:v>
                </c:pt>
                <c:pt idx="9">
                  <c:v>2.656952923544861</c:v>
                </c:pt>
                <c:pt idx="10">
                  <c:v>2.8946821634256166</c:v>
                </c:pt>
                <c:pt idx="11">
                  <c:v>10.226238513290003</c:v>
                </c:pt>
                <c:pt idx="12">
                  <c:v>3.930658431157831</c:v>
                </c:pt>
                <c:pt idx="13">
                  <c:v>7.7713173424521482</c:v>
                </c:pt>
                <c:pt idx="14">
                  <c:v>7.63521445853990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2FF1-4AC5-92D2-D90D3B4159D7}"/>
            </c:ext>
          </c:extLst>
        </c:ser>
        <c:ser>
          <c:idx val="16"/>
          <c:order val="16"/>
          <c:tx>
            <c:strRef>
              <c:f>'DHA1'!$B$20</c:f>
              <c:strCache>
                <c:ptCount val="1"/>
                <c:pt idx="0">
                  <c:v>128</c:v>
                </c:pt>
              </c:strCache>
            </c:strRef>
          </c:tx>
          <c:spPr>
            <a:solidFill>
              <a:schemeClr val="accent3">
                <a:shade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0:$Q$20</c:f>
              <c:numCache>
                <c:formatCode>General</c:formatCode>
                <c:ptCount val="15"/>
                <c:pt idx="0">
                  <c:v>8.5721871246474102</c:v>
                </c:pt>
                <c:pt idx="1">
                  <c:v>5.0156785386734519</c:v>
                </c:pt>
                <c:pt idx="2">
                  <c:v>5.7451559561730701</c:v>
                </c:pt>
                <c:pt idx="3">
                  <c:v>20.499888742605588</c:v>
                </c:pt>
                <c:pt idx="4">
                  <c:v>2.4958052685566159</c:v>
                </c:pt>
                <c:pt idx="5">
                  <c:v>12.660426166018958</c:v>
                </c:pt>
                <c:pt idx="6">
                  <c:v>1.617162179172386</c:v>
                </c:pt>
                <c:pt idx="7">
                  <c:v>4.7514120733608358</c:v>
                </c:pt>
                <c:pt idx="8">
                  <c:v>0.73681364584042641</c:v>
                </c:pt>
                <c:pt idx="9">
                  <c:v>2.9012049128951087</c:v>
                </c:pt>
                <c:pt idx="10">
                  <c:v>2.9255147881256889</c:v>
                </c:pt>
                <c:pt idx="11">
                  <c:v>9.9448649313038278</c:v>
                </c:pt>
                <c:pt idx="12">
                  <c:v>4.2690699022706839</c:v>
                </c:pt>
                <c:pt idx="13">
                  <c:v>7.7850520049850944</c:v>
                </c:pt>
                <c:pt idx="14">
                  <c:v>8.480689678109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FF1-4AC5-92D2-D90D3B4159D7}"/>
            </c:ext>
          </c:extLst>
        </c:ser>
        <c:ser>
          <c:idx val="17"/>
          <c:order val="17"/>
          <c:tx>
            <c:strRef>
              <c:f>'DHA1'!$B$21</c:f>
              <c:strCache>
                <c:ptCount val="1"/>
                <c:pt idx="0">
                  <c:v>114</c:v>
                </c:pt>
              </c:strCache>
            </c:strRef>
          </c:tx>
          <c:spPr>
            <a:solidFill>
              <a:schemeClr val="accent3">
                <a:shade val="8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1:$Q$21</c:f>
              <c:numCache>
                <c:formatCode>General</c:formatCode>
                <c:ptCount val="15"/>
                <c:pt idx="0">
                  <c:v>8.6023614736706318</c:v>
                </c:pt>
                <c:pt idx="1">
                  <c:v>3.6467687197471612</c:v>
                </c:pt>
                <c:pt idx="2">
                  <c:v>6.3136891843083944</c:v>
                </c:pt>
                <c:pt idx="3">
                  <c:v>21.427065062016535</c:v>
                </c:pt>
                <c:pt idx="4">
                  <c:v>1.8074548490255979</c:v>
                </c:pt>
                <c:pt idx="5">
                  <c:v>15.981494650921206</c:v>
                </c:pt>
                <c:pt idx="6">
                  <c:v>1.6508076710481736</c:v>
                </c:pt>
                <c:pt idx="7">
                  <c:v>5.8722811164055573</c:v>
                </c:pt>
                <c:pt idx="8">
                  <c:v>0.58517532191052601</c:v>
                </c:pt>
                <c:pt idx="9">
                  <c:v>2.8131272376487821</c:v>
                </c:pt>
                <c:pt idx="10">
                  <c:v>2.3130556613261861</c:v>
                </c:pt>
                <c:pt idx="11">
                  <c:v>8.2305161193537675</c:v>
                </c:pt>
                <c:pt idx="12">
                  <c:v>4.5293587633084949</c:v>
                </c:pt>
                <c:pt idx="13">
                  <c:v>7.8073733750583685</c:v>
                </c:pt>
                <c:pt idx="14">
                  <c:v>7.035128744651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2FF1-4AC5-92D2-D90D3B4159D7}"/>
            </c:ext>
          </c:extLst>
        </c:ser>
        <c:ser>
          <c:idx val="18"/>
          <c:order val="18"/>
          <c:tx>
            <c:strRef>
              <c:f>'DHA1'!$B$22</c:f>
              <c:strCache>
                <c:ptCount val="1"/>
                <c:pt idx="0">
                  <c:v>106</c:v>
                </c:pt>
              </c:strCache>
            </c:strRef>
          </c:tx>
          <c:spPr>
            <a:solidFill>
              <a:schemeClr val="accent3">
                <a:shade val="8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2:$Q$22</c:f>
              <c:numCache>
                <c:formatCode>General</c:formatCode>
                <c:ptCount val="15"/>
                <c:pt idx="0">
                  <c:v>8.2717057231271145</c:v>
                </c:pt>
                <c:pt idx="1">
                  <c:v>4.0910069410080041</c:v>
                </c:pt>
                <c:pt idx="2">
                  <c:v>6.017671104746471</c:v>
                </c:pt>
                <c:pt idx="3">
                  <c:v>23.24290861561354</c:v>
                </c:pt>
                <c:pt idx="4">
                  <c:v>2.3598134600678851</c:v>
                </c:pt>
                <c:pt idx="5">
                  <c:v>11.899230636534325</c:v>
                </c:pt>
                <c:pt idx="6">
                  <c:v>1.6472946553488776</c:v>
                </c:pt>
                <c:pt idx="7">
                  <c:v>5.0675782449061675</c:v>
                </c:pt>
                <c:pt idx="8">
                  <c:v>0.64869317199649124</c:v>
                </c:pt>
                <c:pt idx="9">
                  <c:v>3.4787070249065892</c:v>
                </c:pt>
                <c:pt idx="10">
                  <c:v>2.2384140825546321</c:v>
                </c:pt>
                <c:pt idx="11">
                  <c:v>9.8607560035407928</c:v>
                </c:pt>
                <c:pt idx="12">
                  <c:v>4.5920858124788984</c:v>
                </c:pt>
                <c:pt idx="13">
                  <c:v>7.8872897603902752</c:v>
                </c:pt>
                <c:pt idx="14">
                  <c:v>7.67601013180924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2FF1-4AC5-92D2-D90D3B4159D7}"/>
            </c:ext>
          </c:extLst>
        </c:ser>
        <c:ser>
          <c:idx val="19"/>
          <c:order val="19"/>
          <c:tx>
            <c:strRef>
              <c:f>'DHA1'!$B$23</c:f>
              <c:strCache>
                <c:ptCount val="1"/>
                <c:pt idx="0">
                  <c:v>118</c:v>
                </c:pt>
              </c:strCache>
            </c:strRef>
          </c:tx>
          <c:spPr>
            <a:solidFill>
              <a:schemeClr val="accent3">
                <a:shade val="7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3:$Q$23</c:f>
              <c:numCache>
                <c:formatCode>General</c:formatCode>
                <c:ptCount val="15"/>
                <c:pt idx="0">
                  <c:v>7.7477484579974147</c:v>
                </c:pt>
                <c:pt idx="1">
                  <c:v>4.353138304760928</c:v>
                </c:pt>
                <c:pt idx="2">
                  <c:v>5.8243875185737375</c:v>
                </c:pt>
                <c:pt idx="3">
                  <c:v>24.585033026380728</c:v>
                </c:pt>
                <c:pt idx="4">
                  <c:v>2.5524514342856759</c:v>
                </c:pt>
                <c:pt idx="5">
                  <c:v>11.850021806727728</c:v>
                </c:pt>
                <c:pt idx="6">
                  <c:v>1.8692498102179669</c:v>
                </c:pt>
                <c:pt idx="7">
                  <c:v>4.4890910020942965</c:v>
                </c:pt>
                <c:pt idx="8">
                  <c:v>0.66160389996161229</c:v>
                </c:pt>
                <c:pt idx="9">
                  <c:v>3.4982636375408531</c:v>
                </c:pt>
                <c:pt idx="10">
                  <c:v>2.3664795091681246</c:v>
                </c:pt>
                <c:pt idx="11">
                  <c:v>10.670068258566273</c:v>
                </c:pt>
                <c:pt idx="12">
                  <c:v>3.6186829654384534</c:v>
                </c:pt>
                <c:pt idx="13">
                  <c:v>7.8981544964896369</c:v>
                </c:pt>
                <c:pt idx="14">
                  <c:v>7.11507695725747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2FF1-4AC5-92D2-D90D3B4159D7}"/>
            </c:ext>
          </c:extLst>
        </c:ser>
        <c:ser>
          <c:idx val="20"/>
          <c:order val="20"/>
          <c:tx>
            <c:strRef>
              <c:f>'DHA1'!$B$24</c:f>
              <c:strCache>
                <c:ptCount val="1"/>
                <c:pt idx="0">
                  <c:v>107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4:$Q$24</c:f>
              <c:numCache>
                <c:formatCode>General</c:formatCode>
                <c:ptCount val="15"/>
                <c:pt idx="0">
                  <c:v>8.5391115496984042</c:v>
                </c:pt>
                <c:pt idx="1">
                  <c:v>5.1987308960269942</c:v>
                </c:pt>
                <c:pt idx="2">
                  <c:v>4.9631777364447602</c:v>
                </c:pt>
                <c:pt idx="3">
                  <c:v>19.755576914286046</c:v>
                </c:pt>
                <c:pt idx="4">
                  <c:v>2.5785696062630445</c:v>
                </c:pt>
                <c:pt idx="5">
                  <c:v>15.302807262966926</c:v>
                </c:pt>
                <c:pt idx="6">
                  <c:v>1.907636106704556</c:v>
                </c:pt>
                <c:pt idx="7">
                  <c:v>4.353480739031335</c:v>
                </c:pt>
                <c:pt idx="8">
                  <c:v>0.6572313967196538</c:v>
                </c:pt>
                <c:pt idx="9">
                  <c:v>2.445977769511519</c:v>
                </c:pt>
                <c:pt idx="10">
                  <c:v>2.8269959173049171</c:v>
                </c:pt>
                <c:pt idx="11">
                  <c:v>10.13609321618196</c:v>
                </c:pt>
                <c:pt idx="12">
                  <c:v>3.4723277422520531</c:v>
                </c:pt>
                <c:pt idx="13">
                  <c:v>7.9058266488473343</c:v>
                </c:pt>
                <c:pt idx="14">
                  <c:v>8.1576680339000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2FF1-4AC5-92D2-D90D3B4159D7}"/>
            </c:ext>
          </c:extLst>
        </c:ser>
        <c:ser>
          <c:idx val="21"/>
          <c:order val="21"/>
          <c:tx>
            <c:strRef>
              <c:f>'DHA1'!$B$25</c:f>
              <c:strCache>
                <c:ptCount val="1"/>
                <c:pt idx="0">
                  <c:v>111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5:$Q$25</c:f>
              <c:numCache>
                <c:formatCode>General</c:formatCode>
                <c:ptCount val="15"/>
                <c:pt idx="0">
                  <c:v>7.578811348554666</c:v>
                </c:pt>
                <c:pt idx="1">
                  <c:v>4.5264525166589848</c:v>
                </c:pt>
                <c:pt idx="2">
                  <c:v>6.4632129130266742</c:v>
                </c:pt>
                <c:pt idx="3">
                  <c:v>23.530003320746232</c:v>
                </c:pt>
                <c:pt idx="4">
                  <c:v>2.243692002970155</c:v>
                </c:pt>
                <c:pt idx="5">
                  <c:v>11.677133796111219</c:v>
                </c:pt>
                <c:pt idx="6">
                  <c:v>1.5820338440660626</c:v>
                </c:pt>
                <c:pt idx="7">
                  <c:v>5.0612595425038105</c:v>
                </c:pt>
                <c:pt idx="8">
                  <c:v>0.80903539000154712</c:v>
                </c:pt>
                <c:pt idx="9">
                  <c:v>3.4658055342200367</c:v>
                </c:pt>
                <c:pt idx="10">
                  <c:v>2.6532432303908458</c:v>
                </c:pt>
                <c:pt idx="11">
                  <c:v>9.6267415849460924</c:v>
                </c:pt>
                <c:pt idx="12">
                  <c:v>4.4306620393334253</c:v>
                </c:pt>
                <c:pt idx="13">
                  <c:v>8.1616459650263042</c:v>
                </c:pt>
                <c:pt idx="14">
                  <c:v>7.28707906242067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2FF1-4AC5-92D2-D90D3B4159D7}"/>
            </c:ext>
          </c:extLst>
        </c:ser>
        <c:ser>
          <c:idx val="22"/>
          <c:order val="22"/>
          <c:tx>
            <c:strRef>
              <c:f>'DHA1'!$B$26</c:f>
              <c:strCache>
                <c:ptCount val="1"/>
                <c:pt idx="0">
                  <c:v>116</c:v>
                </c:pt>
              </c:strCache>
            </c:strRef>
          </c:tx>
          <c:spPr>
            <a:solidFill>
              <a:schemeClr val="accent3">
                <a:shade val="6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6:$Q$26</c:f>
              <c:numCache>
                <c:formatCode>General</c:formatCode>
                <c:ptCount val="15"/>
                <c:pt idx="0">
                  <c:v>7.8397791041046512</c:v>
                </c:pt>
                <c:pt idx="1">
                  <c:v>4.6229697995707291</c:v>
                </c:pt>
                <c:pt idx="2">
                  <c:v>5.1368470354739868</c:v>
                </c:pt>
                <c:pt idx="3">
                  <c:v>21.779934455734093</c:v>
                </c:pt>
                <c:pt idx="4">
                  <c:v>2.1278066880064124</c:v>
                </c:pt>
                <c:pt idx="5">
                  <c:v>12.654137300941287</c:v>
                </c:pt>
                <c:pt idx="6">
                  <c:v>1.4317615911665491</c:v>
                </c:pt>
                <c:pt idx="7">
                  <c:v>5.1995613960633325</c:v>
                </c:pt>
                <c:pt idx="8">
                  <c:v>0.83559863880893692</c:v>
                </c:pt>
                <c:pt idx="9">
                  <c:v>2.8112738796392049</c:v>
                </c:pt>
                <c:pt idx="10">
                  <c:v>2.9778328950109487</c:v>
                </c:pt>
                <c:pt idx="11">
                  <c:v>10.365008620868544</c:v>
                </c:pt>
                <c:pt idx="12">
                  <c:v>4.4865929888052607</c:v>
                </c:pt>
                <c:pt idx="13">
                  <c:v>8.5346836884264761</c:v>
                </c:pt>
                <c:pt idx="14">
                  <c:v>8.4670061098563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2FF1-4AC5-92D2-D90D3B4159D7}"/>
            </c:ext>
          </c:extLst>
        </c:ser>
        <c:ser>
          <c:idx val="23"/>
          <c:order val="23"/>
          <c:tx>
            <c:strRef>
              <c:f>'DHA1'!$B$27</c:f>
              <c:strCache>
                <c:ptCount val="1"/>
                <c:pt idx="0">
                  <c:v>105</c:v>
                </c:pt>
              </c:strCache>
            </c:strRef>
          </c:tx>
          <c:spPr>
            <a:solidFill>
              <a:schemeClr val="accent3">
                <a:shade val="6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7:$Q$27</c:f>
              <c:numCache>
                <c:formatCode>General</c:formatCode>
                <c:ptCount val="15"/>
                <c:pt idx="0">
                  <c:v>7.9629996340111635</c:v>
                </c:pt>
                <c:pt idx="1">
                  <c:v>5.1607744749890765</c:v>
                </c:pt>
                <c:pt idx="2">
                  <c:v>4.955272790472276</c:v>
                </c:pt>
                <c:pt idx="3">
                  <c:v>18.330703100174375</c:v>
                </c:pt>
                <c:pt idx="4">
                  <c:v>2.4764106809474331</c:v>
                </c:pt>
                <c:pt idx="5">
                  <c:v>16.330229541317401</c:v>
                </c:pt>
                <c:pt idx="6">
                  <c:v>2.2606470096321409</c:v>
                </c:pt>
                <c:pt idx="7">
                  <c:v>4.3957056435661812</c:v>
                </c:pt>
                <c:pt idx="8">
                  <c:v>0.58835581274188198</c:v>
                </c:pt>
                <c:pt idx="9">
                  <c:v>2.4382785481358322</c:v>
                </c:pt>
                <c:pt idx="10">
                  <c:v>2.866202496486788</c:v>
                </c:pt>
                <c:pt idx="11">
                  <c:v>9.9134673688404895</c:v>
                </c:pt>
                <c:pt idx="12">
                  <c:v>3.8440191158204762</c:v>
                </c:pt>
                <c:pt idx="13">
                  <c:v>8.5487023883132949</c:v>
                </c:pt>
                <c:pt idx="14">
                  <c:v>7.9574223721893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2FF1-4AC5-92D2-D90D3B4159D7}"/>
            </c:ext>
          </c:extLst>
        </c:ser>
        <c:ser>
          <c:idx val="24"/>
          <c:order val="24"/>
          <c:tx>
            <c:strRef>
              <c:f>'DHA1'!$B$28</c:f>
              <c:strCache>
                <c:ptCount val="1"/>
                <c:pt idx="0">
                  <c:v>125</c:v>
                </c:pt>
              </c:strCache>
            </c:strRef>
          </c:tx>
          <c:spPr>
            <a:solidFill>
              <a:schemeClr val="accent3">
                <a:shade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8:$Q$28</c:f>
              <c:numCache>
                <c:formatCode>General</c:formatCode>
                <c:ptCount val="15"/>
                <c:pt idx="0">
                  <c:v>9.5292006920472119</c:v>
                </c:pt>
                <c:pt idx="1">
                  <c:v>4.6361146670799327</c:v>
                </c:pt>
                <c:pt idx="2">
                  <c:v>4.5137078390648151</c:v>
                </c:pt>
                <c:pt idx="3">
                  <c:v>21.904784721633458</c:v>
                </c:pt>
                <c:pt idx="4">
                  <c:v>2.8372006651496284</c:v>
                </c:pt>
                <c:pt idx="5">
                  <c:v>12.04882700789882</c:v>
                </c:pt>
                <c:pt idx="6">
                  <c:v>1.9501280652331143</c:v>
                </c:pt>
                <c:pt idx="7">
                  <c:v>3.8960002976215535</c:v>
                </c:pt>
                <c:pt idx="8">
                  <c:v>0.82826942115189872</c:v>
                </c:pt>
                <c:pt idx="9">
                  <c:v>2.7037549149275466</c:v>
                </c:pt>
                <c:pt idx="10">
                  <c:v>3.163447641609038</c:v>
                </c:pt>
                <c:pt idx="11">
                  <c:v>10.602476307403144</c:v>
                </c:pt>
                <c:pt idx="12">
                  <c:v>3.5448408319622602</c:v>
                </c:pt>
                <c:pt idx="13">
                  <c:v>8.7547257708914135</c:v>
                </c:pt>
                <c:pt idx="14">
                  <c:v>7.88079078780428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2FF1-4AC5-92D2-D90D3B4159D7}"/>
            </c:ext>
          </c:extLst>
        </c:ser>
        <c:ser>
          <c:idx val="25"/>
          <c:order val="25"/>
          <c:tx>
            <c:strRef>
              <c:f>'DHA1'!$B$29</c:f>
              <c:strCache>
                <c:ptCount val="1"/>
                <c:pt idx="0">
                  <c:v>109</c:v>
                </c:pt>
              </c:strCache>
            </c:strRef>
          </c:tx>
          <c:spPr>
            <a:solidFill>
              <a:schemeClr val="accent3">
                <a:shade val="5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29:$Q$29</c:f>
              <c:numCache>
                <c:formatCode>General</c:formatCode>
                <c:ptCount val="15"/>
                <c:pt idx="0">
                  <c:v>10.393881094282685</c:v>
                </c:pt>
                <c:pt idx="1">
                  <c:v>4.3933136275077533</c:v>
                </c:pt>
                <c:pt idx="2">
                  <c:v>1.7349983153653719</c:v>
                </c:pt>
                <c:pt idx="3">
                  <c:v>21.520387930824104</c:v>
                </c:pt>
                <c:pt idx="4">
                  <c:v>2.7035044149976253</c:v>
                </c:pt>
                <c:pt idx="5">
                  <c:v>18.08903522011234</c:v>
                </c:pt>
                <c:pt idx="6">
                  <c:v>2.2286256763691688</c:v>
                </c:pt>
                <c:pt idx="7">
                  <c:v>3.3129996145726479</c:v>
                </c:pt>
                <c:pt idx="8">
                  <c:v>0.59949911306588333</c:v>
                </c:pt>
                <c:pt idx="9">
                  <c:v>2.6922246921652615</c:v>
                </c:pt>
                <c:pt idx="10">
                  <c:v>2.6050432085078046</c:v>
                </c:pt>
                <c:pt idx="11">
                  <c:v>10.786509229078826</c:v>
                </c:pt>
                <c:pt idx="12">
                  <c:v>3.8379849280863092</c:v>
                </c:pt>
                <c:pt idx="13">
                  <c:v>8.8068862665297196</c:v>
                </c:pt>
                <c:pt idx="14">
                  <c:v>5.16075521282008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2FF1-4AC5-92D2-D90D3B4159D7}"/>
            </c:ext>
          </c:extLst>
        </c:ser>
        <c:ser>
          <c:idx val="26"/>
          <c:order val="26"/>
          <c:tx>
            <c:strRef>
              <c:f>'DHA1'!$B$30</c:f>
              <c:strCache>
                <c:ptCount val="1"/>
                <c:pt idx="0">
                  <c:v>124</c:v>
                </c:pt>
              </c:strCache>
            </c:strRef>
          </c:tx>
          <c:spPr>
            <a:solidFill>
              <a:schemeClr val="accent3">
                <a:shade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30:$Q$30</c:f>
              <c:numCache>
                <c:formatCode>General</c:formatCode>
                <c:ptCount val="15"/>
                <c:pt idx="0">
                  <c:v>8.1671068709912706</c:v>
                </c:pt>
                <c:pt idx="1">
                  <c:v>4.1518508290777607</c:v>
                </c:pt>
                <c:pt idx="2">
                  <c:v>5.4189024244732584</c:v>
                </c:pt>
                <c:pt idx="3">
                  <c:v>23.1030895900528</c:v>
                </c:pt>
                <c:pt idx="4">
                  <c:v>3.4511865573739868</c:v>
                </c:pt>
                <c:pt idx="5">
                  <c:v>10.05242331188715</c:v>
                </c:pt>
                <c:pt idx="6">
                  <c:v>2.270133470715153</c:v>
                </c:pt>
                <c:pt idx="7">
                  <c:v>4.2400280877906393</c:v>
                </c:pt>
                <c:pt idx="8">
                  <c:v>0.52208910219219196</c:v>
                </c:pt>
                <c:pt idx="9">
                  <c:v>3.8155402169126571</c:v>
                </c:pt>
                <c:pt idx="10">
                  <c:v>2.017915577823453</c:v>
                </c:pt>
                <c:pt idx="11">
                  <c:v>11.568234815736673</c:v>
                </c:pt>
                <c:pt idx="12">
                  <c:v>3.6354695923485103</c:v>
                </c:pt>
                <c:pt idx="13">
                  <c:v>8.9822137054841722</c:v>
                </c:pt>
                <c:pt idx="14">
                  <c:v>7.83108946436117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2FF1-4AC5-92D2-D90D3B4159D7}"/>
            </c:ext>
          </c:extLst>
        </c:ser>
        <c:ser>
          <c:idx val="27"/>
          <c:order val="27"/>
          <c:tx>
            <c:strRef>
              <c:f>'DHA1'!$B$31</c:f>
              <c:strCache>
                <c:ptCount val="1"/>
                <c:pt idx="0">
                  <c:v>117</c:v>
                </c:pt>
              </c:strCache>
            </c:strRef>
          </c:tx>
          <c:spPr>
            <a:solidFill>
              <a:schemeClr val="accent3">
                <a:shade val="4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31:$Q$31</c:f>
              <c:numCache>
                <c:formatCode>General</c:formatCode>
                <c:ptCount val="15"/>
                <c:pt idx="0">
                  <c:v>8.5146166183339407</c:v>
                </c:pt>
                <c:pt idx="1">
                  <c:v>5.7401634738795044</c:v>
                </c:pt>
                <c:pt idx="2">
                  <c:v>5.2607203730811385</c:v>
                </c:pt>
                <c:pt idx="3">
                  <c:v>21.055351138060754</c:v>
                </c:pt>
                <c:pt idx="4">
                  <c:v>3.5255768788668491</c:v>
                </c:pt>
                <c:pt idx="5">
                  <c:v>9.3370896120599554</c:v>
                </c:pt>
                <c:pt idx="6">
                  <c:v>2.1441041926360866</c:v>
                </c:pt>
                <c:pt idx="7">
                  <c:v>3.9905989802751316</c:v>
                </c:pt>
                <c:pt idx="8">
                  <c:v>0.48150512585855759</c:v>
                </c:pt>
                <c:pt idx="9">
                  <c:v>3.2687479046498766</c:v>
                </c:pt>
                <c:pt idx="10">
                  <c:v>2.2076458661135465</c:v>
                </c:pt>
                <c:pt idx="11">
                  <c:v>11.631384608587158</c:v>
                </c:pt>
                <c:pt idx="12">
                  <c:v>3.6788701375125217</c:v>
                </c:pt>
                <c:pt idx="13">
                  <c:v>9.4542033096591656</c:v>
                </c:pt>
                <c:pt idx="14">
                  <c:v>8.764712270334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2FF1-4AC5-92D2-D90D3B4159D7}"/>
            </c:ext>
          </c:extLst>
        </c:ser>
        <c:ser>
          <c:idx val="28"/>
          <c:order val="28"/>
          <c:tx>
            <c:strRef>
              <c:f>'DHA1'!$B$32</c:f>
              <c:strCache>
                <c:ptCount val="1"/>
                <c:pt idx="0">
                  <c:v>130</c:v>
                </c:pt>
              </c:strCache>
            </c:strRef>
          </c:tx>
          <c:spPr>
            <a:solidFill>
              <a:schemeClr val="accent3">
                <a:shade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32:$Q$32</c:f>
              <c:numCache>
                <c:formatCode>General</c:formatCode>
                <c:ptCount val="15"/>
                <c:pt idx="0">
                  <c:v>8.0678295873248711</c:v>
                </c:pt>
                <c:pt idx="1">
                  <c:v>4.7053611024437592</c:v>
                </c:pt>
                <c:pt idx="2">
                  <c:v>4.7585334185198054</c:v>
                </c:pt>
                <c:pt idx="3">
                  <c:v>18.758576415601514</c:v>
                </c:pt>
                <c:pt idx="4">
                  <c:v>3.155273710777136</c:v>
                </c:pt>
                <c:pt idx="5">
                  <c:v>15.043696626095411</c:v>
                </c:pt>
                <c:pt idx="6">
                  <c:v>2.7386013178345587</c:v>
                </c:pt>
                <c:pt idx="7">
                  <c:v>4.0471566647583339</c:v>
                </c:pt>
                <c:pt idx="8">
                  <c:v>0.34563744723206685</c:v>
                </c:pt>
                <c:pt idx="9">
                  <c:v>2.8774239799654042</c:v>
                </c:pt>
                <c:pt idx="10">
                  <c:v>1.8643607620525429</c:v>
                </c:pt>
                <c:pt idx="11">
                  <c:v>11.125554979877002</c:v>
                </c:pt>
                <c:pt idx="12">
                  <c:v>3.9607566482987742</c:v>
                </c:pt>
                <c:pt idx="13">
                  <c:v>9.5172639075634589</c:v>
                </c:pt>
                <c:pt idx="14">
                  <c:v>7.34111506719202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2FF1-4AC5-92D2-D90D3B4159D7}"/>
            </c:ext>
          </c:extLst>
        </c:ser>
        <c:ser>
          <c:idx val="29"/>
          <c:order val="29"/>
          <c:tx>
            <c:strRef>
              <c:f>'DHA1'!$B$33</c:f>
              <c:strCache>
                <c:ptCount val="1"/>
                <c:pt idx="0">
                  <c:v>129</c:v>
                </c:pt>
              </c:strCache>
            </c:strRef>
          </c:tx>
          <c:spPr>
            <a:solidFill>
              <a:schemeClr val="accent3">
                <a:shade val="3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1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1'!$C$33:$Q$33</c:f>
              <c:numCache>
                <c:formatCode>General</c:formatCode>
                <c:ptCount val="15"/>
                <c:pt idx="0">
                  <c:v>7.509920830515072</c:v>
                </c:pt>
                <c:pt idx="1">
                  <c:v>3.170041504757132</c:v>
                </c:pt>
                <c:pt idx="2">
                  <c:v>3.7644872506022056</c:v>
                </c:pt>
                <c:pt idx="3">
                  <c:v>14.405257161204876</c:v>
                </c:pt>
                <c:pt idx="4">
                  <c:v>1.9250867013761663</c:v>
                </c:pt>
                <c:pt idx="5">
                  <c:v>20.50065933603376</c:v>
                </c:pt>
                <c:pt idx="6">
                  <c:v>2.1359058060639251</c:v>
                </c:pt>
                <c:pt idx="7">
                  <c:v>4.8555213968999817</c:v>
                </c:pt>
                <c:pt idx="8">
                  <c:v>0.52879951487974386</c:v>
                </c:pt>
                <c:pt idx="9">
                  <c:v>1.8492580996613832</c:v>
                </c:pt>
                <c:pt idx="10">
                  <c:v>3.6496041714413603</c:v>
                </c:pt>
                <c:pt idx="11">
                  <c:v>10.0826563080689</c:v>
                </c:pt>
                <c:pt idx="12">
                  <c:v>5.4944536707624563</c:v>
                </c:pt>
                <c:pt idx="13">
                  <c:v>11.073203918515739</c:v>
                </c:pt>
                <c:pt idx="14">
                  <c:v>7.8961042819639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2FF1-4AC5-92D2-D90D3B4159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041738920"/>
        <c:axId val="1041735640"/>
      </c:barChart>
      <c:catAx>
        <c:axId val="1041738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41735640"/>
        <c:crosses val="autoZero"/>
        <c:auto val="1"/>
        <c:lblAlgn val="ctr"/>
        <c:lblOffset val="100"/>
        <c:noMultiLvlLbl val="0"/>
      </c:catAx>
      <c:valAx>
        <c:axId val="1041735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900" dirty="0"/>
                  <a:t>FAMEs (</a:t>
                </a:r>
                <a:r>
                  <a:rPr lang="en-GB" sz="1000" dirty="0"/>
                  <a:t>mol</a:t>
                </a:r>
                <a:r>
                  <a:rPr lang="en-GB" sz="900" dirty="0"/>
                  <a:t>%)</a:t>
                </a:r>
              </a:p>
            </c:rich>
          </c:tx>
          <c:layout>
            <c:manualLayout>
              <c:xMode val="edge"/>
              <c:yMode val="edge"/>
              <c:x val="1.5891958727722349E-2"/>
              <c:y val="0.11691699117418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4173892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6186151615929046E-2"/>
          <c:y val="0.77182308949958989"/>
          <c:w val="0.8790686023705977"/>
          <c:h val="9.51944207040078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558428388841806E-2"/>
          <c:y val="5.6175912201809508E-2"/>
          <c:w val="0.89147415708119115"/>
          <c:h val="0.813036566088017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ppl. Greenhouse charts'!$X$26</c:f>
              <c:strCache>
                <c:ptCount val="1"/>
                <c:pt idx="0">
                  <c:v>GH_WT</c:v>
                </c:pt>
              </c:strCache>
            </c:strRef>
          </c:tx>
          <c:spPr>
            <a:solidFill>
              <a:srgbClr val="BFBFB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32:$AM$32</c:f>
                <c:numCache>
                  <c:formatCode>General</c:formatCode>
                  <c:ptCount val="15"/>
                  <c:pt idx="0">
                    <c:v>0.36410937106143687</c:v>
                  </c:pt>
                  <c:pt idx="1">
                    <c:v>9.3863043413392674E-2</c:v>
                  </c:pt>
                  <c:pt idx="2">
                    <c:v>0.35898563932047173</c:v>
                  </c:pt>
                  <c:pt idx="3">
                    <c:v>0.57800063028875204</c:v>
                  </c:pt>
                  <c:pt idx="4">
                    <c:v>0</c:v>
                  </c:pt>
                  <c:pt idx="5">
                    <c:v>0.77806637065733364</c:v>
                  </c:pt>
                  <c:pt idx="6">
                    <c:v>0</c:v>
                  </c:pt>
                  <c:pt idx="7">
                    <c:v>0.49524757571612221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35073039938635298</c:v>
                  </c:pt>
                </c:numCache>
              </c:numRef>
            </c:plus>
            <c:minus>
              <c:numRef>
                <c:f>'Suppl. Greenhouse charts'!$Y$32:$AM$32</c:f>
                <c:numCache>
                  <c:formatCode>General</c:formatCode>
                  <c:ptCount val="15"/>
                  <c:pt idx="0">
                    <c:v>0.36410937106143687</c:v>
                  </c:pt>
                  <c:pt idx="1">
                    <c:v>9.3863043413392674E-2</c:v>
                  </c:pt>
                  <c:pt idx="2">
                    <c:v>0.35898563932047173</c:v>
                  </c:pt>
                  <c:pt idx="3">
                    <c:v>0.57800063028875204</c:v>
                  </c:pt>
                  <c:pt idx="4">
                    <c:v>0</c:v>
                  </c:pt>
                  <c:pt idx="5">
                    <c:v>0.77806637065733364</c:v>
                  </c:pt>
                  <c:pt idx="6">
                    <c:v>0</c:v>
                  </c:pt>
                  <c:pt idx="7">
                    <c:v>0.49524757571612221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35073039938635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25:$AM$2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26:$AM$26</c:f>
              <c:numCache>
                <c:formatCode>0</c:formatCode>
                <c:ptCount val="15"/>
                <c:pt idx="0">
                  <c:v>7.8602916746462741</c:v>
                </c:pt>
                <c:pt idx="1">
                  <c:v>2.6956111089633947</c:v>
                </c:pt>
                <c:pt idx="2">
                  <c:v>12.17714359989237</c:v>
                </c:pt>
                <c:pt idx="3">
                  <c:v>23.455585641736963</c:v>
                </c:pt>
                <c:pt idx="4">
                  <c:v>0</c:v>
                </c:pt>
                <c:pt idx="5">
                  <c:v>36.528729484179024</c:v>
                </c:pt>
                <c:pt idx="6">
                  <c:v>0</c:v>
                </c:pt>
                <c:pt idx="7">
                  <c:v>9.519787123409571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7.7628513671724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BA-43B9-ACA3-71B753E71039}"/>
            </c:ext>
          </c:extLst>
        </c:ser>
        <c:ser>
          <c:idx val="1"/>
          <c:order val="1"/>
          <c:tx>
            <c:strRef>
              <c:f>'Suppl. Greenhouse charts'!$X$27</c:f>
              <c:strCache>
                <c:ptCount val="1"/>
                <c:pt idx="0">
                  <c:v>GH_EPA2015.4</c:v>
                </c:pt>
              </c:strCache>
            </c:strRef>
          </c:tx>
          <c:spPr>
            <a:solidFill>
              <a:srgbClr val="BB561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33:$AM$33</c:f>
                <c:numCache>
                  <c:formatCode>General</c:formatCode>
                  <c:ptCount val="15"/>
                  <c:pt idx="0">
                    <c:v>0.21901531565259563</c:v>
                  </c:pt>
                  <c:pt idx="1">
                    <c:v>0.13109588025125937</c:v>
                  </c:pt>
                  <c:pt idx="2">
                    <c:v>0.1620218882140603</c:v>
                  </c:pt>
                  <c:pt idx="3">
                    <c:v>0.60471887144198733</c:v>
                  </c:pt>
                  <c:pt idx="4">
                    <c:v>3.6074511805225522E-2</c:v>
                  </c:pt>
                  <c:pt idx="5">
                    <c:v>0.92915453634213729</c:v>
                  </c:pt>
                  <c:pt idx="6">
                    <c:v>0.10216161914253542</c:v>
                  </c:pt>
                  <c:pt idx="7">
                    <c:v>0.89761820161084349</c:v>
                  </c:pt>
                  <c:pt idx="8">
                    <c:v>6.8877152371179515E-2</c:v>
                  </c:pt>
                  <c:pt idx="9">
                    <c:v>0.2711197929786256</c:v>
                  </c:pt>
                  <c:pt idx="10">
                    <c:v>0.2977612440879302</c:v>
                  </c:pt>
                  <c:pt idx="11">
                    <c:v>1.9874219484619109</c:v>
                  </c:pt>
                  <c:pt idx="12">
                    <c:v>0.10308221273810313</c:v>
                  </c:pt>
                  <c:pt idx="13">
                    <c:v>0</c:v>
                  </c:pt>
                  <c:pt idx="14">
                    <c:v>0.42395745595786916</c:v>
                  </c:pt>
                </c:numCache>
              </c:numRef>
            </c:plus>
            <c:minus>
              <c:numRef>
                <c:f>'Suppl. Greenhouse charts'!$Y$33:$AM$33</c:f>
                <c:numCache>
                  <c:formatCode>General</c:formatCode>
                  <c:ptCount val="15"/>
                  <c:pt idx="0">
                    <c:v>0.21901531565259563</c:v>
                  </c:pt>
                  <c:pt idx="1">
                    <c:v>0.13109588025125937</c:v>
                  </c:pt>
                  <c:pt idx="2">
                    <c:v>0.1620218882140603</c:v>
                  </c:pt>
                  <c:pt idx="3">
                    <c:v>0.60471887144198733</c:v>
                  </c:pt>
                  <c:pt idx="4">
                    <c:v>3.6074511805225522E-2</c:v>
                  </c:pt>
                  <c:pt idx="5">
                    <c:v>0.92915453634213729</c:v>
                  </c:pt>
                  <c:pt idx="6">
                    <c:v>0.10216161914253542</c:v>
                  </c:pt>
                  <c:pt idx="7">
                    <c:v>0.89761820161084349</c:v>
                  </c:pt>
                  <c:pt idx="8">
                    <c:v>6.8877152371179515E-2</c:v>
                  </c:pt>
                  <c:pt idx="9">
                    <c:v>0.2711197929786256</c:v>
                  </c:pt>
                  <c:pt idx="10">
                    <c:v>0.2977612440879302</c:v>
                  </c:pt>
                  <c:pt idx="11">
                    <c:v>1.9874219484619109</c:v>
                  </c:pt>
                  <c:pt idx="12">
                    <c:v>0.10308221273810313</c:v>
                  </c:pt>
                  <c:pt idx="13">
                    <c:v>0</c:v>
                  </c:pt>
                  <c:pt idx="14">
                    <c:v>0.423957455957869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25:$AM$2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27:$AM$27</c:f>
              <c:numCache>
                <c:formatCode>0</c:formatCode>
                <c:ptCount val="15"/>
                <c:pt idx="0">
                  <c:v>6.9962394503047518</c:v>
                </c:pt>
                <c:pt idx="1">
                  <c:v>2.7627148560629826</c:v>
                </c:pt>
                <c:pt idx="2">
                  <c:v>10.809114285624149</c:v>
                </c:pt>
                <c:pt idx="3">
                  <c:v>20.339031004941845</c:v>
                </c:pt>
                <c:pt idx="4">
                  <c:v>0.4260761494713709</c:v>
                </c:pt>
                <c:pt idx="5">
                  <c:v>20.54530652480074</c:v>
                </c:pt>
                <c:pt idx="6">
                  <c:v>1.3264123847279496</c:v>
                </c:pt>
                <c:pt idx="7">
                  <c:v>7.0016518370447374</c:v>
                </c:pt>
                <c:pt idx="8">
                  <c:v>1.3627073989960554</c:v>
                </c:pt>
                <c:pt idx="9">
                  <c:v>2.0668959534519638</c:v>
                </c:pt>
                <c:pt idx="10">
                  <c:v>5.5800824200108927</c:v>
                </c:pt>
                <c:pt idx="11">
                  <c:v>13.577693853951823</c:v>
                </c:pt>
                <c:pt idx="12">
                  <c:v>0.83043352603823051</c:v>
                </c:pt>
                <c:pt idx="13">
                  <c:v>0</c:v>
                </c:pt>
                <c:pt idx="14">
                  <c:v>6.3756403545724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BA-43B9-ACA3-71B753E71039}"/>
            </c:ext>
          </c:extLst>
        </c:ser>
        <c:ser>
          <c:idx val="2"/>
          <c:order val="2"/>
          <c:tx>
            <c:strRef>
              <c:f>'Suppl. Greenhouse charts'!$X$28</c:f>
              <c:strCache>
                <c:ptCount val="1"/>
                <c:pt idx="0">
                  <c:v>GH_EPA2015.8</c:v>
                </c:pt>
              </c:strCache>
            </c:strRef>
          </c:tx>
          <c:spPr>
            <a:solidFill>
              <a:srgbClr val="EA7F5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34:$AM$34</c:f>
                <c:numCache>
                  <c:formatCode>General</c:formatCode>
                  <c:ptCount val="15"/>
                  <c:pt idx="0">
                    <c:v>0.19748130040984208</c:v>
                  </c:pt>
                  <c:pt idx="1">
                    <c:v>0.15101914991911503</c:v>
                  </c:pt>
                  <c:pt idx="2">
                    <c:v>0.95749334086589688</c:v>
                  </c:pt>
                  <c:pt idx="3">
                    <c:v>0.40383333483229489</c:v>
                  </c:pt>
                  <c:pt idx="4">
                    <c:v>9.8853290342125588E-2</c:v>
                  </c:pt>
                  <c:pt idx="5">
                    <c:v>0.39538846436763714</c:v>
                  </c:pt>
                  <c:pt idx="6">
                    <c:v>0.23987526791539387</c:v>
                  </c:pt>
                  <c:pt idx="7">
                    <c:v>0.1489819373327371</c:v>
                  </c:pt>
                  <c:pt idx="8">
                    <c:v>2.8868357743405397E-2</c:v>
                  </c:pt>
                  <c:pt idx="9">
                    <c:v>0.27999276638856985</c:v>
                  </c:pt>
                  <c:pt idx="10">
                    <c:v>0.11570438511045346</c:v>
                  </c:pt>
                  <c:pt idx="11">
                    <c:v>1.2218479471022325</c:v>
                  </c:pt>
                  <c:pt idx="12">
                    <c:v>0.12891397587263639</c:v>
                  </c:pt>
                  <c:pt idx="13">
                    <c:v>0</c:v>
                  </c:pt>
                  <c:pt idx="14">
                    <c:v>0.23407896029930997</c:v>
                  </c:pt>
                </c:numCache>
              </c:numRef>
            </c:plus>
            <c:minus>
              <c:numRef>
                <c:f>'Suppl. Greenhouse charts'!$Y$34:$AM$34</c:f>
                <c:numCache>
                  <c:formatCode>General</c:formatCode>
                  <c:ptCount val="15"/>
                  <c:pt idx="0">
                    <c:v>0.19748130040984208</c:v>
                  </c:pt>
                  <c:pt idx="1">
                    <c:v>0.15101914991911503</c:v>
                  </c:pt>
                  <c:pt idx="2">
                    <c:v>0.95749334086589688</c:v>
                  </c:pt>
                  <c:pt idx="3">
                    <c:v>0.40383333483229489</c:v>
                  </c:pt>
                  <c:pt idx="4">
                    <c:v>9.8853290342125588E-2</c:v>
                  </c:pt>
                  <c:pt idx="5">
                    <c:v>0.39538846436763714</c:v>
                  </c:pt>
                  <c:pt idx="6">
                    <c:v>0.23987526791539387</c:v>
                  </c:pt>
                  <c:pt idx="7">
                    <c:v>0.1489819373327371</c:v>
                  </c:pt>
                  <c:pt idx="8">
                    <c:v>2.8868357743405397E-2</c:v>
                  </c:pt>
                  <c:pt idx="9">
                    <c:v>0.27999276638856985</c:v>
                  </c:pt>
                  <c:pt idx="10">
                    <c:v>0.11570438511045346</c:v>
                  </c:pt>
                  <c:pt idx="11">
                    <c:v>1.2218479471022325</c:v>
                  </c:pt>
                  <c:pt idx="12">
                    <c:v>0.12891397587263639</c:v>
                  </c:pt>
                  <c:pt idx="13">
                    <c:v>0</c:v>
                  </c:pt>
                  <c:pt idx="14">
                    <c:v>0.23407896029930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25:$AM$2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28:$AM$28</c:f>
              <c:numCache>
                <c:formatCode>0</c:formatCode>
                <c:ptCount val="15"/>
                <c:pt idx="0">
                  <c:v>7.8295282113103317</c:v>
                </c:pt>
                <c:pt idx="1">
                  <c:v>3.46898715356406</c:v>
                </c:pt>
                <c:pt idx="2">
                  <c:v>13.255169977500751</c:v>
                </c:pt>
                <c:pt idx="3">
                  <c:v>12.512474174821884</c:v>
                </c:pt>
                <c:pt idx="4">
                  <c:v>2.8379526137548132</c:v>
                </c:pt>
                <c:pt idx="5">
                  <c:v>10.84604212259746</c:v>
                </c:pt>
                <c:pt idx="6">
                  <c:v>3.4457636039106649</c:v>
                </c:pt>
                <c:pt idx="7">
                  <c:v>4.2023498281296723</c:v>
                </c:pt>
                <c:pt idx="8">
                  <c:v>1.0724928671871623</c:v>
                </c:pt>
                <c:pt idx="9">
                  <c:v>5.7121632222831344</c:v>
                </c:pt>
                <c:pt idx="10">
                  <c:v>1.9157588429341514</c:v>
                </c:pt>
                <c:pt idx="11">
                  <c:v>21.07631682178209</c:v>
                </c:pt>
                <c:pt idx="12">
                  <c:v>0.94370813126985131</c:v>
                </c:pt>
                <c:pt idx="13">
                  <c:v>0</c:v>
                </c:pt>
                <c:pt idx="14">
                  <c:v>10.8812924289539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5BA-43B9-ACA3-71B753E71039}"/>
            </c:ext>
          </c:extLst>
        </c:ser>
        <c:ser>
          <c:idx val="3"/>
          <c:order val="3"/>
          <c:tx>
            <c:strRef>
              <c:f>'Suppl. Greenhouse charts'!$X$29</c:f>
              <c:strCache>
                <c:ptCount val="1"/>
                <c:pt idx="0">
                  <c:v>GH_EPA2016.1</c:v>
                </c:pt>
              </c:strCache>
            </c:strRef>
          </c:tx>
          <c:spPr>
            <a:solidFill>
              <a:srgbClr val="F2BAA8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uppl. Greenhouse charts'!$Y$35:$AM$35</c:f>
                <c:numCache>
                  <c:formatCode>General</c:formatCode>
                  <c:ptCount val="15"/>
                  <c:pt idx="0">
                    <c:v>0.11303172382168843</c:v>
                  </c:pt>
                  <c:pt idx="1">
                    <c:v>5.8354200011187927E-2</c:v>
                  </c:pt>
                  <c:pt idx="2">
                    <c:v>0.22855287025715545</c:v>
                  </c:pt>
                  <c:pt idx="3">
                    <c:v>0.24337001315997611</c:v>
                  </c:pt>
                  <c:pt idx="4">
                    <c:v>4.9370347164319317E-2</c:v>
                  </c:pt>
                  <c:pt idx="5">
                    <c:v>0.62780826419140601</c:v>
                  </c:pt>
                  <c:pt idx="6">
                    <c:v>0.11689276532988188</c:v>
                  </c:pt>
                  <c:pt idx="7">
                    <c:v>0.30510777720553889</c:v>
                  </c:pt>
                  <c:pt idx="8">
                    <c:v>0.26248526992256616</c:v>
                  </c:pt>
                  <c:pt idx="9">
                    <c:v>9.0715397067511611E-2</c:v>
                  </c:pt>
                  <c:pt idx="10">
                    <c:v>2.8909161316547166E-2</c:v>
                  </c:pt>
                  <c:pt idx="11">
                    <c:v>0.14903296001390381</c:v>
                  </c:pt>
                  <c:pt idx="12">
                    <c:v>4.1270002986517288E-3</c:v>
                  </c:pt>
                  <c:pt idx="13">
                    <c:v>0</c:v>
                  </c:pt>
                  <c:pt idx="14">
                    <c:v>0.45011744377891827</c:v>
                  </c:pt>
                </c:numCache>
              </c:numRef>
            </c:plus>
            <c:minus>
              <c:numRef>
                <c:f>'Suppl. Greenhouse charts'!$Y$35:$AM$35</c:f>
                <c:numCache>
                  <c:formatCode>General</c:formatCode>
                  <c:ptCount val="15"/>
                  <c:pt idx="0">
                    <c:v>0.11303172382168843</c:v>
                  </c:pt>
                  <c:pt idx="1">
                    <c:v>5.8354200011187927E-2</c:v>
                  </c:pt>
                  <c:pt idx="2">
                    <c:v>0.22855287025715545</c:v>
                  </c:pt>
                  <c:pt idx="3">
                    <c:v>0.24337001315997611</c:v>
                  </c:pt>
                  <c:pt idx="4">
                    <c:v>4.9370347164319317E-2</c:v>
                  </c:pt>
                  <c:pt idx="5">
                    <c:v>0.62780826419140601</c:v>
                  </c:pt>
                  <c:pt idx="6">
                    <c:v>0.11689276532988188</c:v>
                  </c:pt>
                  <c:pt idx="7">
                    <c:v>0.30510777720553889</c:v>
                  </c:pt>
                  <c:pt idx="8">
                    <c:v>0.26248526992256616</c:v>
                  </c:pt>
                  <c:pt idx="9">
                    <c:v>9.0715397067511611E-2</c:v>
                  </c:pt>
                  <c:pt idx="10">
                    <c:v>2.8909161316547166E-2</c:v>
                  </c:pt>
                  <c:pt idx="11">
                    <c:v>0.14903296001390381</c:v>
                  </c:pt>
                  <c:pt idx="12">
                    <c:v>4.1270002986517288E-3</c:v>
                  </c:pt>
                  <c:pt idx="13">
                    <c:v>0</c:v>
                  </c:pt>
                  <c:pt idx="14">
                    <c:v>0.450117443778918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ppl. Greenhouse charts'!$Y$25:$AM$2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Suppl. Greenhouse charts'!$Y$29:$AM$29</c:f>
              <c:numCache>
                <c:formatCode>0</c:formatCode>
                <c:ptCount val="15"/>
                <c:pt idx="0">
                  <c:v>6.6953941330390281</c:v>
                </c:pt>
                <c:pt idx="1">
                  <c:v>3.8042504920071907</c:v>
                </c:pt>
                <c:pt idx="2">
                  <c:v>13.499096273707137</c:v>
                </c:pt>
                <c:pt idx="3">
                  <c:v>10.341469386630465</c:v>
                </c:pt>
                <c:pt idx="4">
                  <c:v>1.6553597104471123</c:v>
                </c:pt>
                <c:pt idx="5">
                  <c:v>17.498636020711409</c:v>
                </c:pt>
                <c:pt idx="6">
                  <c:v>3.2903283686307923</c:v>
                </c:pt>
                <c:pt idx="7">
                  <c:v>7.1163968996406366</c:v>
                </c:pt>
                <c:pt idx="8">
                  <c:v>0.3029907785781133</c:v>
                </c:pt>
                <c:pt idx="9">
                  <c:v>3.195660611337813</c:v>
                </c:pt>
                <c:pt idx="10">
                  <c:v>1.4772948588564498</c:v>
                </c:pt>
                <c:pt idx="11">
                  <c:v>20.417210115804409</c:v>
                </c:pt>
                <c:pt idx="12">
                  <c:v>0.93278536109490851</c:v>
                </c:pt>
                <c:pt idx="13">
                  <c:v>0</c:v>
                </c:pt>
                <c:pt idx="14">
                  <c:v>9.77312698951453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5BA-43B9-ACA3-71B753E710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2487552"/>
        <c:axId val="915574640"/>
      </c:barChart>
      <c:catAx>
        <c:axId val="962487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5574640"/>
        <c:crosses val="autoZero"/>
        <c:auto val="1"/>
        <c:lblAlgn val="ctr"/>
        <c:lblOffset val="100"/>
        <c:noMultiLvlLbl val="0"/>
      </c:catAx>
      <c:valAx>
        <c:axId val="91557464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2.7934714751968927E-2"/>
              <c:y val="0.2340695308266251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2487552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1747659298898316"/>
          <c:y val="5.5303784750294759E-2"/>
          <c:w val="0.27930638473945096"/>
          <c:h val="0.20795822397200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/>
              <a:t>DHA2015.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900272874562974"/>
          <c:y val="4.2850969825432392E-2"/>
          <c:w val="0.85121557090474975"/>
          <c:h val="0.624510269516250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HA2'!$B$4</c:f>
              <c:strCache>
                <c:ptCount val="1"/>
                <c:pt idx="0">
                  <c:v>201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4:$Q$4</c:f>
              <c:numCache>
                <c:formatCode>General</c:formatCode>
                <c:ptCount val="15"/>
                <c:pt idx="0">
                  <c:v>7.1423524341054678</c:v>
                </c:pt>
                <c:pt idx="1">
                  <c:v>2.9603798220356117</c:v>
                </c:pt>
                <c:pt idx="2">
                  <c:v>10.851421004982461</c:v>
                </c:pt>
                <c:pt idx="3">
                  <c:v>15.461763512560292</c:v>
                </c:pt>
                <c:pt idx="4">
                  <c:v>10.946568546926322</c:v>
                </c:pt>
                <c:pt idx="5">
                  <c:v>17.394471124617311</c:v>
                </c:pt>
                <c:pt idx="6">
                  <c:v>14.830513775862743</c:v>
                </c:pt>
                <c:pt idx="7">
                  <c:v>9.5623118463757777</c:v>
                </c:pt>
                <c:pt idx="8">
                  <c:v>1.0617143477984279</c:v>
                </c:pt>
                <c:pt idx="9">
                  <c:v>0.5578756892168405</c:v>
                </c:pt>
                <c:pt idx="10">
                  <c:v>1.3516086039918782</c:v>
                </c:pt>
                <c:pt idx="11">
                  <c:v>0.13338393931540576</c:v>
                </c:pt>
                <c:pt idx="12">
                  <c:v>0.35623984751665577</c:v>
                </c:pt>
                <c:pt idx="13">
                  <c:v>0</c:v>
                </c:pt>
                <c:pt idx="14">
                  <c:v>5.20178832431684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95-4F3E-B6BD-5B243CCA0B52}"/>
            </c:ext>
          </c:extLst>
        </c:ser>
        <c:ser>
          <c:idx val="1"/>
          <c:order val="1"/>
          <c:tx>
            <c:strRef>
              <c:f>'DHA2'!$B$5</c:f>
              <c:strCache>
                <c:ptCount val="1"/>
                <c:pt idx="0">
                  <c:v>223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5:$Q$5</c:f>
              <c:numCache>
                <c:formatCode>General</c:formatCode>
                <c:ptCount val="15"/>
                <c:pt idx="0">
                  <c:v>7.6812964172693716</c:v>
                </c:pt>
                <c:pt idx="1">
                  <c:v>2.8782674582493581</c:v>
                </c:pt>
                <c:pt idx="2">
                  <c:v>11.770169785248161</c:v>
                </c:pt>
                <c:pt idx="3">
                  <c:v>14.154073069926643</c:v>
                </c:pt>
                <c:pt idx="4">
                  <c:v>12.458851651816449</c:v>
                </c:pt>
                <c:pt idx="5">
                  <c:v>18.144802255716957</c:v>
                </c:pt>
                <c:pt idx="6">
                  <c:v>14.16</c:v>
                </c:pt>
                <c:pt idx="7">
                  <c:v>9.4122427937548263</c:v>
                </c:pt>
                <c:pt idx="8">
                  <c:v>0.11914253405624368</c:v>
                </c:pt>
                <c:pt idx="9">
                  <c:v>6.1565626324408276E-2</c:v>
                </c:pt>
                <c:pt idx="10">
                  <c:v>0.23489654351466541</c:v>
                </c:pt>
                <c:pt idx="11">
                  <c:v>1.2846008135772446</c:v>
                </c:pt>
                <c:pt idx="12">
                  <c:v>0.30020387923302216</c:v>
                </c:pt>
                <c:pt idx="13">
                  <c:v>0</c:v>
                </c:pt>
                <c:pt idx="14">
                  <c:v>6.85075225378124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95-4F3E-B6BD-5B243CCA0B52}"/>
            </c:ext>
          </c:extLst>
        </c:ser>
        <c:ser>
          <c:idx val="2"/>
          <c:order val="2"/>
          <c:tx>
            <c:strRef>
              <c:f>'DHA2'!$B$6</c:f>
              <c:strCache>
                <c:ptCount val="1"/>
                <c:pt idx="0">
                  <c:v>225</c:v>
                </c:pt>
              </c:strCache>
            </c:strRef>
          </c:tx>
          <c:spPr>
            <a:solidFill>
              <a:schemeClr val="accent3">
                <a:tint val="4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6:$Q$6</c:f>
              <c:numCache>
                <c:formatCode>General</c:formatCode>
                <c:ptCount val="15"/>
                <c:pt idx="0">
                  <c:v>7.5940074194460232</c:v>
                </c:pt>
                <c:pt idx="1">
                  <c:v>2.4715568971635169</c:v>
                </c:pt>
                <c:pt idx="2">
                  <c:v>10.308630967519223</c:v>
                </c:pt>
                <c:pt idx="3">
                  <c:v>18.102972539602604</c:v>
                </c:pt>
                <c:pt idx="4">
                  <c:v>8.8369982289216118</c:v>
                </c:pt>
                <c:pt idx="5">
                  <c:v>22.410094413766902</c:v>
                </c:pt>
                <c:pt idx="6">
                  <c:v>14.351222718089863</c:v>
                </c:pt>
                <c:pt idx="7">
                  <c:v>8.4152551531009134</c:v>
                </c:pt>
                <c:pt idx="8">
                  <c:v>6.5348565813951986E-2</c:v>
                </c:pt>
                <c:pt idx="9">
                  <c:v>0.11491002417006653</c:v>
                </c:pt>
                <c:pt idx="10">
                  <c:v>0.23776774782235605</c:v>
                </c:pt>
                <c:pt idx="11">
                  <c:v>0</c:v>
                </c:pt>
                <c:pt idx="12">
                  <c:v>0.35363314550488967</c:v>
                </c:pt>
                <c:pt idx="13">
                  <c:v>0</c:v>
                </c:pt>
                <c:pt idx="14">
                  <c:v>4.2236126061200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95-4F3E-B6BD-5B243CCA0B52}"/>
            </c:ext>
          </c:extLst>
        </c:ser>
        <c:ser>
          <c:idx val="3"/>
          <c:order val="3"/>
          <c:tx>
            <c:strRef>
              <c:f>'DHA2'!$B$7</c:f>
              <c:strCache>
                <c:ptCount val="1"/>
                <c:pt idx="0">
                  <c:v>230</c:v>
                </c:pt>
              </c:strCache>
            </c:strRef>
          </c:tx>
          <c:spPr>
            <a:solidFill>
              <a:schemeClr val="accent3">
                <a:tint val="4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7:$Q$7</c:f>
              <c:numCache>
                <c:formatCode>General</c:formatCode>
                <c:ptCount val="15"/>
                <c:pt idx="0">
                  <c:v>6.9581578633405661</c:v>
                </c:pt>
                <c:pt idx="1">
                  <c:v>2.8865173849879957</c:v>
                </c:pt>
                <c:pt idx="2">
                  <c:v>10.927251127673529</c:v>
                </c:pt>
                <c:pt idx="3">
                  <c:v>14.505718950702748</c:v>
                </c:pt>
                <c:pt idx="4">
                  <c:v>10.29168053790109</c:v>
                </c:pt>
                <c:pt idx="5">
                  <c:v>19.984027608581666</c:v>
                </c:pt>
                <c:pt idx="6">
                  <c:v>14.600893667019674</c:v>
                </c:pt>
                <c:pt idx="7">
                  <c:v>10.21739606821361</c:v>
                </c:pt>
                <c:pt idx="8">
                  <c:v>0</c:v>
                </c:pt>
                <c:pt idx="9">
                  <c:v>0</c:v>
                </c:pt>
                <c:pt idx="10">
                  <c:v>0.26429469558471347</c:v>
                </c:pt>
                <c:pt idx="11">
                  <c:v>1.6023441476056759</c:v>
                </c:pt>
                <c:pt idx="12">
                  <c:v>0.32472575271074128</c:v>
                </c:pt>
                <c:pt idx="13">
                  <c:v>0</c:v>
                </c:pt>
                <c:pt idx="14">
                  <c:v>7.1707656683780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F95-4F3E-B6BD-5B243CCA0B52}"/>
            </c:ext>
          </c:extLst>
        </c:ser>
        <c:ser>
          <c:idx val="4"/>
          <c:order val="4"/>
          <c:tx>
            <c:strRef>
              <c:f>'DHA2'!$B$8</c:f>
              <c:strCache>
                <c:ptCount val="1"/>
                <c:pt idx="0">
                  <c:v>204</c:v>
                </c:pt>
              </c:strCache>
            </c:strRef>
          </c:tx>
          <c:spPr>
            <a:solidFill>
              <a:schemeClr val="accent3">
                <a:tint val="5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8:$Q$8</c:f>
              <c:numCache>
                <c:formatCode>General</c:formatCode>
                <c:ptCount val="15"/>
                <c:pt idx="0">
                  <c:v>7.4166622961161828</c:v>
                </c:pt>
                <c:pt idx="1">
                  <c:v>3.1976178202204002</c:v>
                </c:pt>
                <c:pt idx="2">
                  <c:v>9.421604923374419</c:v>
                </c:pt>
                <c:pt idx="3">
                  <c:v>13.532528583519911</c:v>
                </c:pt>
                <c:pt idx="4">
                  <c:v>10.972231115829109</c:v>
                </c:pt>
                <c:pt idx="5">
                  <c:v>17.326995897229757</c:v>
                </c:pt>
                <c:pt idx="6">
                  <c:v>14.760949634820381</c:v>
                </c:pt>
                <c:pt idx="7">
                  <c:v>9.0578888776700701</c:v>
                </c:pt>
                <c:pt idx="8">
                  <c:v>1.8773445615343065</c:v>
                </c:pt>
                <c:pt idx="9">
                  <c:v>0.62376482976765846</c:v>
                </c:pt>
                <c:pt idx="10">
                  <c:v>2.2778202285158806</c:v>
                </c:pt>
                <c:pt idx="11">
                  <c:v>1.4495192182048269</c:v>
                </c:pt>
                <c:pt idx="12">
                  <c:v>0.46855486189513479</c:v>
                </c:pt>
                <c:pt idx="13">
                  <c:v>0</c:v>
                </c:pt>
                <c:pt idx="14">
                  <c:v>6.24804944248562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F95-4F3E-B6BD-5B243CCA0B52}"/>
            </c:ext>
          </c:extLst>
        </c:ser>
        <c:ser>
          <c:idx val="5"/>
          <c:order val="5"/>
          <c:tx>
            <c:strRef>
              <c:f>'DHA2'!$B$9</c:f>
              <c:strCache>
                <c:ptCount val="1"/>
                <c:pt idx="0">
                  <c:v>221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9:$Q$9</c:f>
              <c:numCache>
                <c:formatCode>General</c:formatCode>
                <c:ptCount val="15"/>
                <c:pt idx="0">
                  <c:v>7.2888873384343356</c:v>
                </c:pt>
                <c:pt idx="1">
                  <c:v>3.2163475718853065</c:v>
                </c:pt>
                <c:pt idx="2">
                  <c:v>10.17745086784578</c:v>
                </c:pt>
                <c:pt idx="3">
                  <c:v>17.73506633920093</c:v>
                </c:pt>
                <c:pt idx="4">
                  <c:v>14.699822691507746</c:v>
                </c:pt>
                <c:pt idx="5">
                  <c:v>13.96436412171219</c:v>
                </c:pt>
                <c:pt idx="6">
                  <c:v>15.034250949789003</c:v>
                </c:pt>
                <c:pt idx="7">
                  <c:v>7.8190686366070308</c:v>
                </c:pt>
                <c:pt idx="8">
                  <c:v>0.32007235452905525</c:v>
                </c:pt>
                <c:pt idx="9">
                  <c:v>8.5815594692639566E-2</c:v>
                </c:pt>
                <c:pt idx="10">
                  <c:v>0.45672251503850003</c:v>
                </c:pt>
                <c:pt idx="11">
                  <c:v>1.008470529144164</c:v>
                </c:pt>
                <c:pt idx="12">
                  <c:v>0.30185643380096927</c:v>
                </c:pt>
                <c:pt idx="13">
                  <c:v>0</c:v>
                </c:pt>
                <c:pt idx="14">
                  <c:v>7.23618946137505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F95-4F3E-B6BD-5B243CCA0B52}"/>
            </c:ext>
          </c:extLst>
        </c:ser>
        <c:ser>
          <c:idx val="6"/>
          <c:order val="6"/>
          <c:tx>
            <c:strRef>
              <c:f>'DHA2'!$B$10</c:f>
              <c:strCache>
                <c:ptCount val="1"/>
                <c:pt idx="0">
                  <c:v>224</c:v>
                </c:pt>
              </c:strCache>
            </c:strRef>
          </c:tx>
          <c:spPr>
            <a:solidFill>
              <a:schemeClr val="accent3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0:$Q$10</c:f>
              <c:numCache>
                <c:formatCode>General</c:formatCode>
                <c:ptCount val="15"/>
                <c:pt idx="0">
                  <c:v>6.9063889419849032</c:v>
                </c:pt>
                <c:pt idx="1">
                  <c:v>2.7897461978216551</c:v>
                </c:pt>
                <c:pt idx="2">
                  <c:v>9.8717040571465677</c:v>
                </c:pt>
                <c:pt idx="3">
                  <c:v>14.099646525123038</c:v>
                </c:pt>
                <c:pt idx="4">
                  <c:v>11.595393788739786</c:v>
                </c:pt>
                <c:pt idx="5">
                  <c:v>18.404279123050564</c:v>
                </c:pt>
                <c:pt idx="6">
                  <c:v>15.286725101403157</c:v>
                </c:pt>
                <c:pt idx="7">
                  <c:v>8.4760705299220156</c:v>
                </c:pt>
                <c:pt idx="8">
                  <c:v>1.0780468653557687</c:v>
                </c:pt>
                <c:pt idx="9">
                  <c:v>0.16641730338578295</c:v>
                </c:pt>
                <c:pt idx="10">
                  <c:v>1.4155047077802398</c:v>
                </c:pt>
                <c:pt idx="11">
                  <c:v>1.175478029857119</c:v>
                </c:pt>
                <c:pt idx="12">
                  <c:v>0.34540331823460058</c:v>
                </c:pt>
                <c:pt idx="13">
                  <c:v>0</c:v>
                </c:pt>
                <c:pt idx="14">
                  <c:v>7.31888084718517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F95-4F3E-B6BD-5B243CCA0B52}"/>
            </c:ext>
          </c:extLst>
        </c:ser>
        <c:ser>
          <c:idx val="7"/>
          <c:order val="7"/>
          <c:tx>
            <c:strRef>
              <c:f>'DHA2'!$B$11</c:f>
              <c:strCache>
                <c:ptCount val="1"/>
                <c:pt idx="0">
                  <c:v>228</c:v>
                </c:pt>
              </c:strCache>
            </c:strRef>
          </c:tx>
          <c:spPr>
            <a:solidFill>
              <a:schemeClr val="accent3">
                <a:tint val="6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1:$Q$11</c:f>
              <c:numCache>
                <c:formatCode>General</c:formatCode>
                <c:ptCount val="15"/>
                <c:pt idx="0">
                  <c:v>6.7802167656510015</c:v>
                </c:pt>
                <c:pt idx="1">
                  <c:v>2.752465682724595</c:v>
                </c:pt>
                <c:pt idx="2">
                  <c:v>9.9804707374547181</c:v>
                </c:pt>
                <c:pt idx="3">
                  <c:v>15.508213584708512</c:v>
                </c:pt>
                <c:pt idx="4">
                  <c:v>11.69356866582592</c:v>
                </c:pt>
                <c:pt idx="5">
                  <c:v>17.213922484130528</c:v>
                </c:pt>
                <c:pt idx="6">
                  <c:v>15.331760264016493</c:v>
                </c:pt>
                <c:pt idx="7">
                  <c:v>9.4184445034319637</c:v>
                </c:pt>
                <c:pt idx="8">
                  <c:v>0.99885101627058459</c:v>
                </c:pt>
                <c:pt idx="9">
                  <c:v>0.15499356828419614</c:v>
                </c:pt>
                <c:pt idx="10">
                  <c:v>1.2908084742284189</c:v>
                </c:pt>
                <c:pt idx="11">
                  <c:v>1.3805946441014985</c:v>
                </c:pt>
                <c:pt idx="12">
                  <c:v>0.31920413564819827</c:v>
                </c:pt>
                <c:pt idx="13">
                  <c:v>0</c:v>
                </c:pt>
                <c:pt idx="14">
                  <c:v>6.59696576841537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F95-4F3E-B6BD-5B243CCA0B52}"/>
            </c:ext>
          </c:extLst>
        </c:ser>
        <c:ser>
          <c:idx val="8"/>
          <c:order val="8"/>
          <c:tx>
            <c:strRef>
              <c:f>'DHA2'!$B$12</c:f>
              <c:strCache>
                <c:ptCount val="1"/>
                <c:pt idx="0">
                  <c:v>213</c:v>
                </c:pt>
              </c:strCache>
            </c:strRef>
          </c:tx>
          <c:spPr>
            <a:solidFill>
              <a:schemeClr val="accent3">
                <a:tint val="7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2:$Q$12</c:f>
              <c:numCache>
                <c:formatCode>General</c:formatCode>
                <c:ptCount val="15"/>
                <c:pt idx="0">
                  <c:v>6.549467934057799</c:v>
                </c:pt>
                <c:pt idx="1">
                  <c:v>2.7189463286006665</c:v>
                </c:pt>
                <c:pt idx="2">
                  <c:v>10.430918079603394</c:v>
                </c:pt>
                <c:pt idx="3">
                  <c:v>15.238193098222746</c:v>
                </c:pt>
                <c:pt idx="4">
                  <c:v>11.456102673055018</c:v>
                </c:pt>
                <c:pt idx="5">
                  <c:v>19.806873247938466</c:v>
                </c:pt>
                <c:pt idx="6">
                  <c:v>16.174274423192575</c:v>
                </c:pt>
                <c:pt idx="7">
                  <c:v>9.0855367796352358</c:v>
                </c:pt>
                <c:pt idx="8">
                  <c:v>0.1054613270973865</c:v>
                </c:pt>
                <c:pt idx="9">
                  <c:v>7.5129912818755765E-2</c:v>
                </c:pt>
                <c:pt idx="10">
                  <c:v>0.28036921152309613</c:v>
                </c:pt>
                <c:pt idx="11">
                  <c:v>0.1283517348326641</c:v>
                </c:pt>
                <c:pt idx="12">
                  <c:v>0.3534228175742854</c:v>
                </c:pt>
                <c:pt idx="13">
                  <c:v>7.5997761246003492E-2</c:v>
                </c:pt>
                <c:pt idx="14">
                  <c:v>6.9982695642011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F95-4F3E-B6BD-5B243CCA0B52}"/>
            </c:ext>
          </c:extLst>
        </c:ser>
        <c:ser>
          <c:idx val="9"/>
          <c:order val="9"/>
          <c:tx>
            <c:strRef>
              <c:f>'DHA2'!$B$13</c:f>
              <c:strCache>
                <c:ptCount val="1"/>
                <c:pt idx="0">
                  <c:v>209</c:v>
                </c:pt>
              </c:strCache>
            </c:strRef>
          </c:tx>
          <c:spPr>
            <a:solidFill>
              <a:schemeClr val="accent3">
                <a:tint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3:$Q$13</c:f>
              <c:numCache>
                <c:formatCode>General</c:formatCode>
                <c:ptCount val="15"/>
                <c:pt idx="0">
                  <c:v>7.4683920842617404</c:v>
                </c:pt>
                <c:pt idx="1">
                  <c:v>2.4743768162695861</c:v>
                </c:pt>
                <c:pt idx="2">
                  <c:v>8.2339835601910973</c:v>
                </c:pt>
                <c:pt idx="3">
                  <c:v>14.054708735385631</c:v>
                </c:pt>
                <c:pt idx="4">
                  <c:v>12.221640655292049</c:v>
                </c:pt>
                <c:pt idx="5">
                  <c:v>18.107036893805859</c:v>
                </c:pt>
                <c:pt idx="6">
                  <c:v>16.198527909468144</c:v>
                </c:pt>
                <c:pt idx="7">
                  <c:v>8.1555254048994232</c:v>
                </c:pt>
                <c:pt idx="8">
                  <c:v>1.564508733788889</c:v>
                </c:pt>
                <c:pt idx="9">
                  <c:v>0.41598978943129811</c:v>
                </c:pt>
                <c:pt idx="10">
                  <c:v>2.0899865190002598</c:v>
                </c:pt>
                <c:pt idx="11">
                  <c:v>0.36017854503134067</c:v>
                </c:pt>
                <c:pt idx="12">
                  <c:v>0.36314519760652625</c:v>
                </c:pt>
                <c:pt idx="13">
                  <c:v>0</c:v>
                </c:pt>
                <c:pt idx="14">
                  <c:v>7.5283033323248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3F95-4F3E-B6BD-5B243CCA0B52}"/>
            </c:ext>
          </c:extLst>
        </c:ser>
        <c:ser>
          <c:idx val="10"/>
          <c:order val="10"/>
          <c:tx>
            <c:strRef>
              <c:f>'DHA2'!$B$14</c:f>
              <c:strCache>
                <c:ptCount val="1"/>
                <c:pt idx="0">
                  <c:v>210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4:$Q$14</c:f>
              <c:numCache>
                <c:formatCode>General</c:formatCode>
                <c:ptCount val="15"/>
                <c:pt idx="0">
                  <c:v>7.520079797958525</c:v>
                </c:pt>
                <c:pt idx="1">
                  <c:v>2.7859036135557389</c:v>
                </c:pt>
                <c:pt idx="2">
                  <c:v>7.9533049144901193</c:v>
                </c:pt>
                <c:pt idx="3">
                  <c:v>13.839622944452444</c:v>
                </c:pt>
                <c:pt idx="4">
                  <c:v>12.900770453119835</c:v>
                </c:pt>
                <c:pt idx="5">
                  <c:v>16.360226312855531</c:v>
                </c:pt>
                <c:pt idx="6">
                  <c:v>16.727653835297303</c:v>
                </c:pt>
                <c:pt idx="7">
                  <c:v>8.4405139380045071</c:v>
                </c:pt>
                <c:pt idx="8">
                  <c:v>1.8567351438886972</c:v>
                </c:pt>
                <c:pt idx="9">
                  <c:v>0.23306932696411681</c:v>
                </c:pt>
                <c:pt idx="10">
                  <c:v>2.1983161354666287</c:v>
                </c:pt>
                <c:pt idx="11">
                  <c:v>1.3670787047239483</c:v>
                </c:pt>
                <c:pt idx="12">
                  <c:v>0.34194372728188843</c:v>
                </c:pt>
                <c:pt idx="13">
                  <c:v>0</c:v>
                </c:pt>
                <c:pt idx="14">
                  <c:v>6.7737204918597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F95-4F3E-B6BD-5B243CCA0B52}"/>
            </c:ext>
          </c:extLst>
        </c:ser>
        <c:ser>
          <c:idx val="11"/>
          <c:order val="11"/>
          <c:tx>
            <c:strRef>
              <c:f>'DHA2'!$B$15</c:f>
              <c:strCache>
                <c:ptCount val="1"/>
                <c:pt idx="0">
                  <c:v>218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5:$Q$15</c:f>
              <c:numCache>
                <c:formatCode>General</c:formatCode>
                <c:ptCount val="15"/>
                <c:pt idx="0">
                  <c:v>6.54430980719121</c:v>
                </c:pt>
                <c:pt idx="1">
                  <c:v>2.7903375856868711</c:v>
                </c:pt>
                <c:pt idx="2">
                  <c:v>10.532993363596736</c:v>
                </c:pt>
                <c:pt idx="3">
                  <c:v>14.944343275715237</c:v>
                </c:pt>
                <c:pt idx="4">
                  <c:v>10.661833969093674</c:v>
                </c:pt>
                <c:pt idx="5">
                  <c:v>19.939701696186635</c:v>
                </c:pt>
                <c:pt idx="6">
                  <c:v>16.860019225834602</c:v>
                </c:pt>
                <c:pt idx="7">
                  <c:v>9.9919762940129022</c:v>
                </c:pt>
                <c:pt idx="8">
                  <c:v>0.52625847380912316</c:v>
                </c:pt>
                <c:pt idx="9">
                  <c:v>0.1138107648261045</c:v>
                </c:pt>
                <c:pt idx="10">
                  <c:v>0.77379292753508044</c:v>
                </c:pt>
                <c:pt idx="11">
                  <c:v>1.4027626115947713</c:v>
                </c:pt>
                <c:pt idx="12">
                  <c:v>0.24657873557050983</c:v>
                </c:pt>
                <c:pt idx="13">
                  <c:v>0</c:v>
                </c:pt>
                <c:pt idx="14">
                  <c:v>4.31266386904495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F95-4F3E-B6BD-5B243CCA0B52}"/>
            </c:ext>
          </c:extLst>
        </c:ser>
        <c:ser>
          <c:idx val="12"/>
          <c:order val="12"/>
          <c:tx>
            <c:strRef>
              <c:f>'DHA2'!$B$16</c:f>
              <c:strCache>
                <c:ptCount val="1"/>
                <c:pt idx="0">
                  <c:v>208</c:v>
                </c:pt>
              </c:strCache>
            </c:strRef>
          </c:tx>
          <c:spPr>
            <a:solidFill>
              <a:schemeClr val="accent3">
                <a:tint val="8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6:$Q$16</c:f>
              <c:numCache>
                <c:formatCode>General</c:formatCode>
                <c:ptCount val="15"/>
                <c:pt idx="0">
                  <c:v>7.3255680847706914</c:v>
                </c:pt>
                <c:pt idx="1">
                  <c:v>3.001569835202599</c:v>
                </c:pt>
                <c:pt idx="2">
                  <c:v>9.8226418601699805</c:v>
                </c:pt>
                <c:pt idx="3">
                  <c:v>14.608201114004585</c:v>
                </c:pt>
                <c:pt idx="4">
                  <c:v>13.500875888369091</c:v>
                </c:pt>
                <c:pt idx="5">
                  <c:v>15.136502886380311</c:v>
                </c:pt>
                <c:pt idx="6">
                  <c:v>16.978266472597326</c:v>
                </c:pt>
                <c:pt idx="7">
                  <c:v>8.7473630382130505</c:v>
                </c:pt>
                <c:pt idx="8">
                  <c:v>0.22913623227290936</c:v>
                </c:pt>
                <c:pt idx="9">
                  <c:v>9.9799322045353994E-2</c:v>
                </c:pt>
                <c:pt idx="10">
                  <c:v>0.39231934609855745</c:v>
                </c:pt>
                <c:pt idx="11">
                  <c:v>1.7458704615395302</c:v>
                </c:pt>
                <c:pt idx="12">
                  <c:v>0.39219616384313771</c:v>
                </c:pt>
                <c:pt idx="13">
                  <c:v>0</c:v>
                </c:pt>
                <c:pt idx="14">
                  <c:v>7.27882364320504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F95-4F3E-B6BD-5B243CCA0B52}"/>
            </c:ext>
          </c:extLst>
        </c:ser>
        <c:ser>
          <c:idx val="13"/>
          <c:order val="13"/>
          <c:tx>
            <c:strRef>
              <c:f>'DHA2'!$B$17</c:f>
              <c:strCache>
                <c:ptCount val="1"/>
                <c:pt idx="0">
                  <c:v>226</c:v>
                </c:pt>
              </c:strCache>
            </c:strRef>
          </c:tx>
          <c:spPr>
            <a:solidFill>
              <a:schemeClr val="accent3">
                <a:tint val="9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7:$Q$17</c:f>
              <c:numCache>
                <c:formatCode>General</c:formatCode>
                <c:ptCount val="15"/>
                <c:pt idx="0">
                  <c:v>7.6856705263109681</c:v>
                </c:pt>
                <c:pt idx="1">
                  <c:v>2.5410442092137036</c:v>
                </c:pt>
                <c:pt idx="2">
                  <c:v>8.4162267641309967</c:v>
                </c:pt>
                <c:pt idx="3">
                  <c:v>16.503544750405471</c:v>
                </c:pt>
                <c:pt idx="4">
                  <c:v>17.825060095744298</c:v>
                </c:pt>
                <c:pt idx="5">
                  <c:v>13.070539661163407</c:v>
                </c:pt>
                <c:pt idx="6">
                  <c:v>17.02</c:v>
                </c:pt>
                <c:pt idx="7">
                  <c:v>8.6735572881345622</c:v>
                </c:pt>
                <c:pt idx="8">
                  <c:v>0.15205153906628177</c:v>
                </c:pt>
                <c:pt idx="9">
                  <c:v>6.0556299989871415E-2</c:v>
                </c:pt>
                <c:pt idx="10">
                  <c:v>0.21377021755377099</c:v>
                </c:pt>
                <c:pt idx="11">
                  <c:v>1.6021122238313685</c:v>
                </c:pt>
                <c:pt idx="12">
                  <c:v>0.25823248874545784</c:v>
                </c:pt>
                <c:pt idx="13">
                  <c:v>0</c:v>
                </c:pt>
                <c:pt idx="14">
                  <c:v>5.34418834718186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F95-4F3E-B6BD-5B243CCA0B52}"/>
            </c:ext>
          </c:extLst>
        </c:ser>
        <c:ser>
          <c:idx val="14"/>
          <c:order val="14"/>
          <c:tx>
            <c:strRef>
              <c:f>'DHA2'!$B$18</c:f>
              <c:strCache>
                <c:ptCount val="1"/>
                <c:pt idx="0">
                  <c:v>222</c:v>
                </c:pt>
              </c:strCache>
            </c:strRef>
          </c:tx>
          <c:spPr>
            <a:solidFill>
              <a:schemeClr val="accent3">
                <a:tint val="9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8:$Q$18</c:f>
              <c:numCache>
                <c:formatCode>General</c:formatCode>
                <c:ptCount val="15"/>
                <c:pt idx="0">
                  <c:v>7.9534180654066819</c:v>
                </c:pt>
                <c:pt idx="1">
                  <c:v>2.7014574007129761</c:v>
                </c:pt>
                <c:pt idx="2">
                  <c:v>9.2296349309822237</c:v>
                </c:pt>
                <c:pt idx="3">
                  <c:v>16.250068116197752</c:v>
                </c:pt>
                <c:pt idx="4">
                  <c:v>12.955501673266282</c:v>
                </c:pt>
                <c:pt idx="5">
                  <c:v>16.249341365644025</c:v>
                </c:pt>
                <c:pt idx="6">
                  <c:v>17.11152711867652</c:v>
                </c:pt>
                <c:pt idx="7">
                  <c:v>8.586040459223641</c:v>
                </c:pt>
                <c:pt idx="8">
                  <c:v>0.13425061297932175</c:v>
                </c:pt>
                <c:pt idx="9">
                  <c:v>0.15443018507958375</c:v>
                </c:pt>
                <c:pt idx="10">
                  <c:v>0.28260298291438335</c:v>
                </c:pt>
                <c:pt idx="11">
                  <c:v>0.16404926756429294</c:v>
                </c:pt>
                <c:pt idx="12">
                  <c:v>5.1802634299532524E-2</c:v>
                </c:pt>
                <c:pt idx="13">
                  <c:v>6.8914342421625682E-2</c:v>
                </c:pt>
                <c:pt idx="14">
                  <c:v>5.8586561500579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3F95-4F3E-B6BD-5B243CCA0B52}"/>
            </c:ext>
          </c:extLst>
        </c:ser>
        <c:ser>
          <c:idx val="15"/>
          <c:order val="15"/>
          <c:tx>
            <c:strRef>
              <c:f>'DHA2'!$B$19</c:f>
              <c:strCache>
                <c:ptCount val="1"/>
                <c:pt idx="0">
                  <c:v>215</c:v>
                </c:pt>
              </c:strCache>
            </c:strRef>
          </c:tx>
          <c:spPr>
            <a:solidFill>
              <a:schemeClr val="accent3">
                <a:shade val="9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19:$Q$19</c:f>
              <c:numCache>
                <c:formatCode>General</c:formatCode>
                <c:ptCount val="15"/>
                <c:pt idx="0">
                  <c:v>7.9813090494089902</c:v>
                </c:pt>
                <c:pt idx="1">
                  <c:v>2.2066047596014116</c:v>
                </c:pt>
                <c:pt idx="2">
                  <c:v>8.9934560172538944</c:v>
                </c:pt>
                <c:pt idx="3">
                  <c:v>18.904712507767051</c:v>
                </c:pt>
                <c:pt idx="4">
                  <c:v>16.006006329789859</c:v>
                </c:pt>
                <c:pt idx="5">
                  <c:v>13.785796170217102</c:v>
                </c:pt>
                <c:pt idx="6">
                  <c:v>17.263957430501772</c:v>
                </c:pt>
                <c:pt idx="7">
                  <c:v>5.4523776401440296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7269384075921419</c:v>
                </c:pt>
                <c:pt idx="12">
                  <c:v>0.23055331021268669</c:v>
                </c:pt>
                <c:pt idx="13">
                  <c:v>0</c:v>
                </c:pt>
                <c:pt idx="14">
                  <c:v>7.14136704912285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3F95-4F3E-B6BD-5B243CCA0B52}"/>
            </c:ext>
          </c:extLst>
        </c:ser>
        <c:ser>
          <c:idx val="16"/>
          <c:order val="16"/>
          <c:tx>
            <c:strRef>
              <c:f>'DHA2'!$B$20</c:f>
              <c:strCache>
                <c:ptCount val="1"/>
                <c:pt idx="0">
                  <c:v>216</c:v>
                </c:pt>
              </c:strCache>
            </c:strRef>
          </c:tx>
          <c:spPr>
            <a:solidFill>
              <a:schemeClr val="accent3">
                <a:shade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0:$Q$20</c:f>
              <c:numCache>
                <c:formatCode>General</c:formatCode>
                <c:ptCount val="15"/>
                <c:pt idx="0">
                  <c:v>8.4417110980190291</c:v>
                </c:pt>
                <c:pt idx="1">
                  <c:v>2.8840870255078377</c:v>
                </c:pt>
                <c:pt idx="2">
                  <c:v>8.9799319632491326</c:v>
                </c:pt>
                <c:pt idx="3">
                  <c:v>15.374622386740631</c:v>
                </c:pt>
                <c:pt idx="4">
                  <c:v>14.401952700195544</c:v>
                </c:pt>
                <c:pt idx="5">
                  <c:v>14.298476604689577</c:v>
                </c:pt>
                <c:pt idx="6">
                  <c:v>17.325647625918727</c:v>
                </c:pt>
                <c:pt idx="7">
                  <c:v>7.47863836068111</c:v>
                </c:pt>
                <c:pt idx="8">
                  <c:v>1.0020092278198469</c:v>
                </c:pt>
                <c:pt idx="9">
                  <c:v>0.181568502351171</c:v>
                </c:pt>
                <c:pt idx="10">
                  <c:v>1.1809706604062362</c:v>
                </c:pt>
                <c:pt idx="11">
                  <c:v>9.6798910880149136E-2</c:v>
                </c:pt>
                <c:pt idx="12">
                  <c:v>0.38211304629008458</c:v>
                </c:pt>
                <c:pt idx="13">
                  <c:v>0</c:v>
                </c:pt>
                <c:pt idx="14">
                  <c:v>5.5405728362346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F95-4F3E-B6BD-5B243CCA0B52}"/>
            </c:ext>
          </c:extLst>
        </c:ser>
        <c:ser>
          <c:idx val="17"/>
          <c:order val="17"/>
          <c:tx>
            <c:strRef>
              <c:f>'DHA2'!$B$21</c:f>
              <c:strCache>
                <c:ptCount val="1"/>
                <c:pt idx="0">
                  <c:v>217</c:v>
                </c:pt>
              </c:strCache>
            </c:strRef>
          </c:tx>
          <c:spPr>
            <a:solidFill>
              <a:schemeClr val="accent3">
                <a:shade val="8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1:$Q$21</c:f>
              <c:numCache>
                <c:formatCode>General</c:formatCode>
                <c:ptCount val="15"/>
                <c:pt idx="0">
                  <c:v>7.193890730613993</c:v>
                </c:pt>
                <c:pt idx="1">
                  <c:v>2.7888876992075735</c:v>
                </c:pt>
                <c:pt idx="2">
                  <c:v>11.058883863457885</c:v>
                </c:pt>
                <c:pt idx="3">
                  <c:v>13.015352747338612</c:v>
                </c:pt>
                <c:pt idx="4">
                  <c:v>11.567480589524207</c:v>
                </c:pt>
                <c:pt idx="5">
                  <c:v>18.615529305521914</c:v>
                </c:pt>
                <c:pt idx="6">
                  <c:v>17.325790980348977</c:v>
                </c:pt>
                <c:pt idx="7">
                  <c:v>9.7045689021356054</c:v>
                </c:pt>
                <c:pt idx="8">
                  <c:v>0.33829561358234184</c:v>
                </c:pt>
                <c:pt idx="9">
                  <c:v>0</c:v>
                </c:pt>
                <c:pt idx="10">
                  <c:v>0.39840936860209969</c:v>
                </c:pt>
                <c:pt idx="11">
                  <c:v>1.3566483101334692</c:v>
                </c:pt>
                <c:pt idx="12">
                  <c:v>0.35868339554086059</c:v>
                </c:pt>
                <c:pt idx="13">
                  <c:v>0</c:v>
                </c:pt>
                <c:pt idx="14">
                  <c:v>5.8072701627327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3F95-4F3E-B6BD-5B243CCA0B52}"/>
            </c:ext>
          </c:extLst>
        </c:ser>
        <c:ser>
          <c:idx val="18"/>
          <c:order val="18"/>
          <c:tx>
            <c:strRef>
              <c:f>'DHA2'!$B$22</c:f>
              <c:strCache>
                <c:ptCount val="1"/>
                <c:pt idx="0">
                  <c:v>202</c:v>
                </c:pt>
              </c:strCache>
            </c:strRef>
          </c:tx>
          <c:spPr>
            <a:solidFill>
              <a:schemeClr val="accent3">
                <a:shade val="8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2:$Q$22</c:f>
              <c:numCache>
                <c:formatCode>General</c:formatCode>
                <c:ptCount val="15"/>
                <c:pt idx="0">
                  <c:v>7.7158129394166126</c:v>
                </c:pt>
                <c:pt idx="1">
                  <c:v>2.5019912579644989</c:v>
                </c:pt>
                <c:pt idx="2">
                  <c:v>10.496521148434159</c:v>
                </c:pt>
                <c:pt idx="3">
                  <c:v>14.298523092070845</c:v>
                </c:pt>
                <c:pt idx="4">
                  <c:v>12.25279298342131</c:v>
                </c:pt>
                <c:pt idx="5">
                  <c:v>17.836851222728068</c:v>
                </c:pt>
                <c:pt idx="6">
                  <c:v>17.41613413133258</c:v>
                </c:pt>
                <c:pt idx="7">
                  <c:v>8.8162296235987654</c:v>
                </c:pt>
                <c:pt idx="8">
                  <c:v>0.60465582638746762</c:v>
                </c:pt>
                <c:pt idx="9">
                  <c:v>0.16392287832442987</c:v>
                </c:pt>
                <c:pt idx="10">
                  <c:v>0.65295097676655189</c:v>
                </c:pt>
                <c:pt idx="11">
                  <c:v>1.4799558342108539</c:v>
                </c:pt>
                <c:pt idx="12">
                  <c:v>0.36057684885383046</c:v>
                </c:pt>
                <c:pt idx="13">
                  <c:v>0</c:v>
                </c:pt>
                <c:pt idx="14">
                  <c:v>4.7966979172617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3F95-4F3E-B6BD-5B243CCA0B52}"/>
            </c:ext>
          </c:extLst>
        </c:ser>
        <c:ser>
          <c:idx val="19"/>
          <c:order val="19"/>
          <c:tx>
            <c:strRef>
              <c:f>'DHA2'!$B$23</c:f>
              <c:strCache>
                <c:ptCount val="1"/>
                <c:pt idx="0">
                  <c:v>205</c:v>
                </c:pt>
              </c:strCache>
            </c:strRef>
          </c:tx>
          <c:spPr>
            <a:solidFill>
              <a:schemeClr val="accent3">
                <a:shade val="7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3:$Q$23</c:f>
              <c:numCache>
                <c:formatCode>General</c:formatCode>
                <c:ptCount val="15"/>
                <c:pt idx="0">
                  <c:v>8.0925474762037126</c:v>
                </c:pt>
                <c:pt idx="1">
                  <c:v>2.8740565901542277</c:v>
                </c:pt>
                <c:pt idx="2">
                  <c:v>8.7899811333092295</c:v>
                </c:pt>
                <c:pt idx="3">
                  <c:v>13.743880170191865</c:v>
                </c:pt>
                <c:pt idx="4">
                  <c:v>15.21556124429965</c:v>
                </c:pt>
                <c:pt idx="5">
                  <c:v>14.213637567165001</c:v>
                </c:pt>
                <c:pt idx="6">
                  <c:v>17.431923075517275</c:v>
                </c:pt>
                <c:pt idx="7">
                  <c:v>8.1146950365924884</c:v>
                </c:pt>
                <c:pt idx="8">
                  <c:v>0.1779320165981049</c:v>
                </c:pt>
                <c:pt idx="9">
                  <c:v>0.1630239350602749</c:v>
                </c:pt>
                <c:pt idx="10">
                  <c:v>0.31658775919099286</c:v>
                </c:pt>
                <c:pt idx="11">
                  <c:v>1.4946775862870483</c:v>
                </c:pt>
                <c:pt idx="12">
                  <c:v>0.39346663151207639</c:v>
                </c:pt>
                <c:pt idx="13">
                  <c:v>0</c:v>
                </c:pt>
                <c:pt idx="14">
                  <c:v>8.0527268846036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3F95-4F3E-B6BD-5B243CCA0B52}"/>
            </c:ext>
          </c:extLst>
        </c:ser>
        <c:ser>
          <c:idx val="20"/>
          <c:order val="20"/>
          <c:tx>
            <c:strRef>
              <c:f>'DHA2'!$B$24</c:f>
              <c:strCache>
                <c:ptCount val="1"/>
                <c:pt idx="0">
                  <c:v>207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4:$Q$24</c:f>
              <c:numCache>
                <c:formatCode>General</c:formatCode>
                <c:ptCount val="15"/>
                <c:pt idx="0">
                  <c:v>8.1069366235126594</c:v>
                </c:pt>
                <c:pt idx="1">
                  <c:v>2.5957576375421971</c:v>
                </c:pt>
                <c:pt idx="2">
                  <c:v>7.6757004439496459</c:v>
                </c:pt>
                <c:pt idx="3">
                  <c:v>16.093922135443087</c:v>
                </c:pt>
                <c:pt idx="4">
                  <c:v>16.900552327774115</c:v>
                </c:pt>
                <c:pt idx="5">
                  <c:v>13.128446816608228</c:v>
                </c:pt>
                <c:pt idx="6">
                  <c:v>17.728558148885817</c:v>
                </c:pt>
                <c:pt idx="7">
                  <c:v>8.4752945615131416</c:v>
                </c:pt>
                <c:pt idx="8">
                  <c:v>0.12883434784794578</c:v>
                </c:pt>
                <c:pt idx="9">
                  <c:v>0</c:v>
                </c:pt>
                <c:pt idx="10">
                  <c:v>0.20607334176652617</c:v>
                </c:pt>
                <c:pt idx="11">
                  <c:v>1.3412068314940162</c:v>
                </c:pt>
                <c:pt idx="12">
                  <c:v>0.26961388843853284</c:v>
                </c:pt>
                <c:pt idx="13">
                  <c:v>0</c:v>
                </c:pt>
                <c:pt idx="14">
                  <c:v>6.8533153820884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3F95-4F3E-B6BD-5B243CCA0B52}"/>
            </c:ext>
          </c:extLst>
        </c:ser>
        <c:ser>
          <c:idx val="21"/>
          <c:order val="21"/>
          <c:tx>
            <c:strRef>
              <c:f>'DHA2'!$B$25</c:f>
              <c:strCache>
                <c:ptCount val="1"/>
                <c:pt idx="0">
                  <c:v>206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5:$Q$25</c:f>
              <c:numCache>
                <c:formatCode>General</c:formatCode>
                <c:ptCount val="15"/>
                <c:pt idx="0">
                  <c:v>7.5563106364781731</c:v>
                </c:pt>
                <c:pt idx="1">
                  <c:v>2.6026864611084131</c:v>
                </c:pt>
                <c:pt idx="2">
                  <c:v>9.4203360333965733</c:v>
                </c:pt>
                <c:pt idx="3">
                  <c:v>14.294616010309237</c:v>
                </c:pt>
                <c:pt idx="4">
                  <c:v>14.405382490645961</c:v>
                </c:pt>
                <c:pt idx="5">
                  <c:v>15.507873068345397</c:v>
                </c:pt>
                <c:pt idx="6">
                  <c:v>18.349048589690227</c:v>
                </c:pt>
                <c:pt idx="7">
                  <c:v>7.846594759566428</c:v>
                </c:pt>
                <c:pt idx="8">
                  <c:v>0.13501170090147341</c:v>
                </c:pt>
                <c:pt idx="9">
                  <c:v>0.11139923422730998</c:v>
                </c:pt>
                <c:pt idx="10">
                  <c:v>0.24980958604268497</c:v>
                </c:pt>
                <c:pt idx="11">
                  <c:v>0</c:v>
                </c:pt>
                <c:pt idx="12">
                  <c:v>0.32122249604131542</c:v>
                </c:pt>
                <c:pt idx="13">
                  <c:v>0</c:v>
                </c:pt>
                <c:pt idx="14">
                  <c:v>7.1389351413257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3F95-4F3E-B6BD-5B243CCA0B52}"/>
            </c:ext>
          </c:extLst>
        </c:ser>
        <c:ser>
          <c:idx val="22"/>
          <c:order val="22"/>
          <c:tx>
            <c:strRef>
              <c:f>'DHA2'!$B$26</c:f>
              <c:strCache>
                <c:ptCount val="1"/>
                <c:pt idx="0">
                  <c:v>212</c:v>
                </c:pt>
              </c:strCache>
            </c:strRef>
          </c:tx>
          <c:spPr>
            <a:solidFill>
              <a:schemeClr val="accent3">
                <a:shade val="6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6:$Q$26</c:f>
              <c:numCache>
                <c:formatCode>General</c:formatCode>
                <c:ptCount val="15"/>
                <c:pt idx="0">
                  <c:v>7.3887649258036463</c:v>
                </c:pt>
                <c:pt idx="1">
                  <c:v>2.7451380657517608</c:v>
                </c:pt>
                <c:pt idx="2">
                  <c:v>11.288178392849222</c:v>
                </c:pt>
                <c:pt idx="3">
                  <c:v>14.52630370991379</c:v>
                </c:pt>
                <c:pt idx="4">
                  <c:v>13.786500132642823</c:v>
                </c:pt>
                <c:pt idx="5">
                  <c:v>15.561196397499957</c:v>
                </c:pt>
                <c:pt idx="6">
                  <c:v>18.402382511552311</c:v>
                </c:pt>
                <c:pt idx="7">
                  <c:v>8.1925994618421374</c:v>
                </c:pt>
                <c:pt idx="8">
                  <c:v>0.51826350552966816</c:v>
                </c:pt>
                <c:pt idx="9">
                  <c:v>0.12991817373556747</c:v>
                </c:pt>
                <c:pt idx="10">
                  <c:v>0.4763104453872975</c:v>
                </c:pt>
                <c:pt idx="11">
                  <c:v>1.3052478804069609</c:v>
                </c:pt>
                <c:pt idx="12">
                  <c:v>0.23700098582019913</c:v>
                </c:pt>
                <c:pt idx="13">
                  <c:v>0</c:v>
                </c:pt>
                <c:pt idx="14">
                  <c:v>4.72938733097964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3F95-4F3E-B6BD-5B243CCA0B52}"/>
            </c:ext>
          </c:extLst>
        </c:ser>
        <c:ser>
          <c:idx val="23"/>
          <c:order val="23"/>
          <c:tx>
            <c:strRef>
              <c:f>'DHA2'!$B$27</c:f>
              <c:strCache>
                <c:ptCount val="1"/>
                <c:pt idx="0">
                  <c:v>219</c:v>
                </c:pt>
              </c:strCache>
            </c:strRef>
          </c:tx>
          <c:spPr>
            <a:solidFill>
              <a:schemeClr val="accent3">
                <a:shade val="6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7:$Q$27</c:f>
              <c:numCache>
                <c:formatCode>General</c:formatCode>
                <c:ptCount val="15"/>
                <c:pt idx="0">
                  <c:v>6.0776696863638824</c:v>
                </c:pt>
                <c:pt idx="1">
                  <c:v>2.7523119976053123</c:v>
                </c:pt>
                <c:pt idx="2">
                  <c:v>8.112143948436632</c:v>
                </c:pt>
                <c:pt idx="3">
                  <c:v>13.492569968925975</c:v>
                </c:pt>
                <c:pt idx="4">
                  <c:v>12.634249615643428</c:v>
                </c:pt>
                <c:pt idx="5">
                  <c:v>18.622082874625253</c:v>
                </c:pt>
                <c:pt idx="6">
                  <c:v>18.482214741241794</c:v>
                </c:pt>
                <c:pt idx="7">
                  <c:v>9.3561654755909558</c:v>
                </c:pt>
                <c:pt idx="8">
                  <c:v>0.13596574574846546</c:v>
                </c:pt>
                <c:pt idx="9">
                  <c:v>0</c:v>
                </c:pt>
                <c:pt idx="10">
                  <c:v>0.28996458564052841</c:v>
                </c:pt>
                <c:pt idx="11">
                  <c:v>1.6416696804310824</c:v>
                </c:pt>
                <c:pt idx="12">
                  <c:v>0.33428210067839914</c:v>
                </c:pt>
                <c:pt idx="13">
                  <c:v>0</c:v>
                </c:pt>
                <c:pt idx="14">
                  <c:v>7.590580726399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3F95-4F3E-B6BD-5B243CCA0B52}"/>
            </c:ext>
          </c:extLst>
        </c:ser>
        <c:ser>
          <c:idx val="24"/>
          <c:order val="24"/>
          <c:tx>
            <c:strRef>
              <c:f>'DHA2'!$B$28</c:f>
              <c:strCache>
                <c:ptCount val="1"/>
                <c:pt idx="0">
                  <c:v>227</c:v>
                </c:pt>
              </c:strCache>
            </c:strRef>
          </c:tx>
          <c:spPr>
            <a:solidFill>
              <a:schemeClr val="accent3">
                <a:shade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8:$Q$28</c:f>
              <c:numCache>
                <c:formatCode>General</c:formatCode>
                <c:ptCount val="15"/>
                <c:pt idx="0">
                  <c:v>7.0447858424239831</c:v>
                </c:pt>
                <c:pt idx="1">
                  <c:v>2.4494568095591065</c:v>
                </c:pt>
                <c:pt idx="2">
                  <c:v>8.7096507402612335</c:v>
                </c:pt>
                <c:pt idx="3">
                  <c:v>13.568258637292699</c:v>
                </c:pt>
                <c:pt idx="4">
                  <c:v>12.363413251203063</c:v>
                </c:pt>
                <c:pt idx="5">
                  <c:v>18.060515916746276</c:v>
                </c:pt>
                <c:pt idx="6">
                  <c:v>18.781817795451119</c:v>
                </c:pt>
                <c:pt idx="7">
                  <c:v>8.6339752011387016</c:v>
                </c:pt>
                <c:pt idx="8">
                  <c:v>0.54595747898133473</c:v>
                </c:pt>
                <c:pt idx="9">
                  <c:v>0.22586160138899383</c:v>
                </c:pt>
                <c:pt idx="10">
                  <c:v>0.8229489622882179</c:v>
                </c:pt>
                <c:pt idx="11">
                  <c:v>1.4433535177794616</c:v>
                </c:pt>
                <c:pt idx="12">
                  <c:v>0.36048510727950295</c:v>
                </c:pt>
                <c:pt idx="13">
                  <c:v>0</c:v>
                </c:pt>
                <c:pt idx="14">
                  <c:v>6.2293445605897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3F95-4F3E-B6BD-5B243CCA0B52}"/>
            </c:ext>
          </c:extLst>
        </c:ser>
        <c:ser>
          <c:idx val="25"/>
          <c:order val="25"/>
          <c:tx>
            <c:strRef>
              <c:f>'DHA2'!$B$29</c:f>
              <c:strCache>
                <c:ptCount val="1"/>
                <c:pt idx="0">
                  <c:v>220</c:v>
                </c:pt>
              </c:strCache>
            </c:strRef>
          </c:tx>
          <c:spPr>
            <a:solidFill>
              <a:schemeClr val="accent3">
                <a:shade val="5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29:$Q$29</c:f>
              <c:numCache>
                <c:formatCode>General</c:formatCode>
                <c:ptCount val="15"/>
                <c:pt idx="0">
                  <c:v>7.2354251613966056</c:v>
                </c:pt>
                <c:pt idx="1">
                  <c:v>2.4932601085339341</c:v>
                </c:pt>
                <c:pt idx="2">
                  <c:v>8.3798414521108118</c:v>
                </c:pt>
                <c:pt idx="3">
                  <c:v>13.849330536523146</c:v>
                </c:pt>
                <c:pt idx="4">
                  <c:v>11.282518955004555</c:v>
                </c:pt>
                <c:pt idx="5">
                  <c:v>20.427772838146058</c:v>
                </c:pt>
                <c:pt idx="6">
                  <c:v>18.832674874305585</c:v>
                </c:pt>
                <c:pt idx="7">
                  <c:v>8.7740259017216911</c:v>
                </c:pt>
                <c:pt idx="8">
                  <c:v>0.48822934364824644</c:v>
                </c:pt>
                <c:pt idx="9">
                  <c:v>0</c:v>
                </c:pt>
                <c:pt idx="10">
                  <c:v>0.56778410320701389</c:v>
                </c:pt>
                <c:pt idx="11">
                  <c:v>0</c:v>
                </c:pt>
                <c:pt idx="12">
                  <c:v>0.31632623178503333</c:v>
                </c:pt>
                <c:pt idx="13">
                  <c:v>0</c:v>
                </c:pt>
                <c:pt idx="14">
                  <c:v>5.26033739969456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3F95-4F3E-B6BD-5B243CCA0B52}"/>
            </c:ext>
          </c:extLst>
        </c:ser>
        <c:ser>
          <c:idx val="26"/>
          <c:order val="26"/>
          <c:tx>
            <c:strRef>
              <c:f>'DHA2'!$B$30</c:f>
              <c:strCache>
                <c:ptCount val="1"/>
                <c:pt idx="0">
                  <c:v>214</c:v>
                </c:pt>
              </c:strCache>
            </c:strRef>
          </c:tx>
          <c:spPr>
            <a:solidFill>
              <a:schemeClr val="accent3">
                <a:shade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30:$Q$30</c:f>
              <c:numCache>
                <c:formatCode>General</c:formatCode>
                <c:ptCount val="15"/>
                <c:pt idx="0">
                  <c:v>6.6140507232815704</c:v>
                </c:pt>
                <c:pt idx="1">
                  <c:v>2.4095065895212664</c:v>
                </c:pt>
                <c:pt idx="2">
                  <c:v>9.1404360896211649</c:v>
                </c:pt>
                <c:pt idx="3">
                  <c:v>13.923447757046267</c:v>
                </c:pt>
                <c:pt idx="4">
                  <c:v>12.490426836359761</c:v>
                </c:pt>
                <c:pt idx="5">
                  <c:v>17.724743302916785</c:v>
                </c:pt>
                <c:pt idx="6">
                  <c:v>19.167318955986854</c:v>
                </c:pt>
                <c:pt idx="7">
                  <c:v>8.6895291128333447</c:v>
                </c:pt>
                <c:pt idx="8">
                  <c:v>0.13608629979523201</c:v>
                </c:pt>
                <c:pt idx="9">
                  <c:v>0.11062238092571937</c:v>
                </c:pt>
                <c:pt idx="10">
                  <c:v>0.2965938105790184</c:v>
                </c:pt>
                <c:pt idx="11">
                  <c:v>1.5796806830195225</c:v>
                </c:pt>
                <c:pt idx="12">
                  <c:v>0.42771680308195753</c:v>
                </c:pt>
                <c:pt idx="13">
                  <c:v>0</c:v>
                </c:pt>
                <c:pt idx="14">
                  <c:v>6.5106710563579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3F95-4F3E-B6BD-5B243CCA0B52}"/>
            </c:ext>
          </c:extLst>
        </c:ser>
        <c:ser>
          <c:idx val="27"/>
          <c:order val="27"/>
          <c:tx>
            <c:strRef>
              <c:f>'DHA2'!$B$31</c:f>
              <c:strCache>
                <c:ptCount val="1"/>
                <c:pt idx="0">
                  <c:v>230</c:v>
                </c:pt>
              </c:strCache>
            </c:strRef>
          </c:tx>
          <c:spPr>
            <a:solidFill>
              <a:schemeClr val="accent3">
                <a:shade val="4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31:$Q$31</c:f>
              <c:numCache>
                <c:formatCode>General</c:formatCode>
                <c:ptCount val="15"/>
                <c:pt idx="0">
                  <c:v>6.1900486764741469</c:v>
                </c:pt>
                <c:pt idx="1">
                  <c:v>2.4620003211115962</c:v>
                </c:pt>
                <c:pt idx="2">
                  <c:v>9.2577335361450608</c:v>
                </c:pt>
                <c:pt idx="3">
                  <c:v>14.964236195458787</c:v>
                </c:pt>
                <c:pt idx="4">
                  <c:v>13.28830859975168</c:v>
                </c:pt>
                <c:pt idx="5">
                  <c:v>16.953885214574907</c:v>
                </c:pt>
                <c:pt idx="6">
                  <c:v>19.19150218277715</c:v>
                </c:pt>
                <c:pt idx="7">
                  <c:v>8.2112105023803377</c:v>
                </c:pt>
                <c:pt idx="8">
                  <c:v>0.1394609670322321</c:v>
                </c:pt>
                <c:pt idx="9">
                  <c:v>0.10458366550072147</c:v>
                </c:pt>
                <c:pt idx="10">
                  <c:v>0.26748261484199515</c:v>
                </c:pt>
                <c:pt idx="11">
                  <c:v>1.4122412603466057</c:v>
                </c:pt>
                <c:pt idx="12">
                  <c:v>0.321248740490785</c:v>
                </c:pt>
                <c:pt idx="13">
                  <c:v>0</c:v>
                </c:pt>
                <c:pt idx="14">
                  <c:v>6.3949428648851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3F95-4F3E-B6BD-5B243CCA0B52}"/>
            </c:ext>
          </c:extLst>
        </c:ser>
        <c:ser>
          <c:idx val="28"/>
          <c:order val="28"/>
          <c:tx>
            <c:strRef>
              <c:f>'DHA2'!$B$32</c:f>
              <c:strCache>
                <c:ptCount val="1"/>
                <c:pt idx="0">
                  <c:v>229</c:v>
                </c:pt>
              </c:strCache>
            </c:strRef>
          </c:tx>
          <c:spPr>
            <a:solidFill>
              <a:schemeClr val="accent3">
                <a:shade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32:$Q$32</c:f>
              <c:numCache>
                <c:formatCode>General</c:formatCode>
                <c:ptCount val="15"/>
                <c:pt idx="0">
                  <c:v>7.9129401726654871</c:v>
                </c:pt>
                <c:pt idx="1">
                  <c:v>2.6442910947112805</c:v>
                </c:pt>
                <c:pt idx="2">
                  <c:v>8.9499310608904814</c:v>
                </c:pt>
                <c:pt idx="3">
                  <c:v>12.636951731676662</c:v>
                </c:pt>
                <c:pt idx="4">
                  <c:v>14.702046578118292</c:v>
                </c:pt>
                <c:pt idx="5">
                  <c:v>15.161838254575011</c:v>
                </c:pt>
                <c:pt idx="6">
                  <c:v>19.348539848965153</c:v>
                </c:pt>
                <c:pt idx="7">
                  <c:v>7.7545534361618511</c:v>
                </c:pt>
                <c:pt idx="8">
                  <c:v>0.15492788095510354</c:v>
                </c:pt>
                <c:pt idx="9">
                  <c:v>7.3704868818966096E-2</c:v>
                </c:pt>
                <c:pt idx="10">
                  <c:v>0.26578338541409935</c:v>
                </c:pt>
                <c:pt idx="11">
                  <c:v>0</c:v>
                </c:pt>
                <c:pt idx="12">
                  <c:v>0.34106620346138283</c:v>
                </c:pt>
                <c:pt idx="13">
                  <c:v>0</c:v>
                </c:pt>
                <c:pt idx="14">
                  <c:v>7.88612097442217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3F95-4F3E-B6BD-5B243CCA0B52}"/>
            </c:ext>
          </c:extLst>
        </c:ser>
        <c:ser>
          <c:idx val="29"/>
          <c:order val="29"/>
          <c:tx>
            <c:strRef>
              <c:f>'DHA2'!$B$33</c:f>
              <c:strCache>
                <c:ptCount val="1"/>
                <c:pt idx="0">
                  <c:v>211</c:v>
                </c:pt>
              </c:strCache>
            </c:strRef>
          </c:tx>
          <c:spPr>
            <a:solidFill>
              <a:schemeClr val="accent3">
                <a:shade val="3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2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2'!$C$33:$Q$33</c:f>
              <c:numCache>
                <c:formatCode>General</c:formatCode>
                <c:ptCount val="15"/>
                <c:pt idx="0">
                  <c:v>7.0301573285051022</c:v>
                </c:pt>
                <c:pt idx="1">
                  <c:v>2.4051738994934655</c:v>
                </c:pt>
                <c:pt idx="2">
                  <c:v>7.0255220278271233</c:v>
                </c:pt>
                <c:pt idx="3">
                  <c:v>12.132013721554035</c:v>
                </c:pt>
                <c:pt idx="4">
                  <c:v>13.703394295756116</c:v>
                </c:pt>
                <c:pt idx="5">
                  <c:v>17.789465956038054</c:v>
                </c:pt>
                <c:pt idx="6">
                  <c:v>22.273069251952908</c:v>
                </c:pt>
                <c:pt idx="7">
                  <c:v>8.3642486883562572</c:v>
                </c:pt>
                <c:pt idx="8">
                  <c:v>0.14099224625455345</c:v>
                </c:pt>
                <c:pt idx="9">
                  <c:v>0</c:v>
                </c:pt>
                <c:pt idx="10">
                  <c:v>0.34397207628674248</c:v>
                </c:pt>
                <c:pt idx="11">
                  <c:v>1.793897682239552</c:v>
                </c:pt>
                <c:pt idx="12">
                  <c:v>0.56756780432573251</c:v>
                </c:pt>
                <c:pt idx="13">
                  <c:v>0</c:v>
                </c:pt>
                <c:pt idx="14">
                  <c:v>5.8565095456412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3F95-4F3E-B6BD-5B243CCA0B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008223520"/>
        <c:axId val="1008224176"/>
      </c:barChart>
      <c:catAx>
        <c:axId val="100822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08224176"/>
        <c:crosses val="autoZero"/>
        <c:auto val="1"/>
        <c:lblAlgn val="ctr"/>
        <c:lblOffset val="100"/>
        <c:noMultiLvlLbl val="0"/>
      </c:catAx>
      <c:valAx>
        <c:axId val="1008224176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dirty="0"/>
                  <a:t>FAMEs</a:t>
                </a:r>
                <a:r>
                  <a:rPr lang="en-GB" sz="1000" baseline="0" dirty="0"/>
                  <a:t> (mol%)</a:t>
                </a:r>
                <a:endParaRPr lang="en-GB" sz="1000" dirty="0"/>
              </a:p>
            </c:rich>
          </c:tx>
          <c:layout>
            <c:manualLayout>
              <c:xMode val="edge"/>
              <c:yMode val="edge"/>
              <c:x val="2.3771211733606207E-2"/>
              <c:y val="7.74216850898288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0822352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867506608680823"/>
          <c:y val="0.79644269523831701"/>
          <c:w val="0.85845804553594274"/>
          <c:h val="0.1039568869305385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/>
              <a:t>DHA2015.3</a:t>
            </a:r>
          </a:p>
        </c:rich>
      </c:tx>
      <c:layout>
        <c:manualLayout>
          <c:xMode val="edge"/>
          <c:yMode val="edge"/>
          <c:x val="0.43226016884113588"/>
          <c:y val="3.59713656599782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548381452318461"/>
          <c:y val="2.5428331875182269E-2"/>
          <c:w val="0.84396062992125986"/>
          <c:h val="0.709915399243975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HA3'!$B$4</c:f>
              <c:strCache>
                <c:ptCount val="1"/>
                <c:pt idx="0">
                  <c:v>302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4:$Q$4</c:f>
              <c:numCache>
                <c:formatCode>General</c:formatCode>
                <c:ptCount val="15"/>
                <c:pt idx="0">
                  <c:v>7.7122628023778885</c:v>
                </c:pt>
                <c:pt idx="1">
                  <c:v>3.5626486809555682</c:v>
                </c:pt>
                <c:pt idx="2">
                  <c:v>11.764390266832663</c:v>
                </c:pt>
                <c:pt idx="3">
                  <c:v>17.699778830619707</c:v>
                </c:pt>
                <c:pt idx="4">
                  <c:v>2.7230370266098478</c:v>
                </c:pt>
                <c:pt idx="5">
                  <c:v>14.366144686549497</c:v>
                </c:pt>
                <c:pt idx="6">
                  <c:v>2.1328305829657315</c:v>
                </c:pt>
                <c:pt idx="7">
                  <c:v>5.7269941617395768</c:v>
                </c:pt>
                <c:pt idx="8">
                  <c:v>3.1452478242048034</c:v>
                </c:pt>
                <c:pt idx="9">
                  <c:v>5.0376634862482854</c:v>
                </c:pt>
                <c:pt idx="10">
                  <c:v>3.945502903267899</c:v>
                </c:pt>
                <c:pt idx="11">
                  <c:v>9.6844008804276847</c:v>
                </c:pt>
                <c:pt idx="12">
                  <c:v>0.97880098095472323</c:v>
                </c:pt>
                <c:pt idx="13">
                  <c:v>1.6440794605266853</c:v>
                </c:pt>
                <c:pt idx="14">
                  <c:v>9.2102908614930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07-4074-ACBA-C40389B6AF43}"/>
            </c:ext>
          </c:extLst>
        </c:ser>
        <c:ser>
          <c:idx val="1"/>
          <c:order val="1"/>
          <c:tx>
            <c:strRef>
              <c:f>'DHA3'!$B$5</c:f>
              <c:strCache>
                <c:ptCount val="1"/>
                <c:pt idx="0">
                  <c:v>308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5:$Q$5</c:f>
              <c:numCache>
                <c:formatCode>General</c:formatCode>
                <c:ptCount val="15"/>
                <c:pt idx="0">
                  <c:v>7.5523947746220816</c:v>
                </c:pt>
                <c:pt idx="1">
                  <c:v>3.5381204074191723</c:v>
                </c:pt>
                <c:pt idx="2">
                  <c:v>13.959087442741184</c:v>
                </c:pt>
                <c:pt idx="3">
                  <c:v>15.182746932227243</c:v>
                </c:pt>
                <c:pt idx="4">
                  <c:v>1.5427368510954089</c:v>
                </c:pt>
                <c:pt idx="5">
                  <c:v>19.902660570544079</c:v>
                </c:pt>
                <c:pt idx="6">
                  <c:v>1.4491008561540757</c:v>
                </c:pt>
                <c:pt idx="7">
                  <c:v>5.6791345094137631</c:v>
                </c:pt>
                <c:pt idx="8">
                  <c:v>0.9286374014378197</c:v>
                </c:pt>
                <c:pt idx="9">
                  <c:v>5.2368305561735244</c:v>
                </c:pt>
                <c:pt idx="10">
                  <c:v>1.8163414240994917</c:v>
                </c:pt>
                <c:pt idx="11">
                  <c:v>12.141034039102495</c:v>
                </c:pt>
                <c:pt idx="12">
                  <c:v>1.3149357508696278</c:v>
                </c:pt>
                <c:pt idx="13">
                  <c:v>1.5429894806177742</c:v>
                </c:pt>
                <c:pt idx="14">
                  <c:v>7.4679840982551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07-4074-ACBA-C40389B6AF43}"/>
            </c:ext>
          </c:extLst>
        </c:ser>
        <c:ser>
          <c:idx val="2"/>
          <c:order val="2"/>
          <c:tx>
            <c:strRef>
              <c:f>'DHA3'!$B$6</c:f>
              <c:strCache>
                <c:ptCount val="1"/>
                <c:pt idx="0">
                  <c:v>325</c:v>
                </c:pt>
              </c:strCache>
            </c:strRef>
          </c:tx>
          <c:spPr>
            <a:solidFill>
              <a:schemeClr val="accent3">
                <a:tint val="4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6:$Q$6</c:f>
              <c:numCache>
                <c:formatCode>General</c:formatCode>
                <c:ptCount val="15"/>
                <c:pt idx="0">
                  <c:v>7.2678305227590885</c:v>
                </c:pt>
                <c:pt idx="1">
                  <c:v>3.7566511008752612</c:v>
                </c:pt>
                <c:pt idx="2">
                  <c:v>14.56315655260161</c:v>
                </c:pt>
                <c:pt idx="3">
                  <c:v>14.996858582721908</c:v>
                </c:pt>
                <c:pt idx="4">
                  <c:v>1.4225403522124864</c:v>
                </c:pt>
                <c:pt idx="5">
                  <c:v>17.061210940219993</c:v>
                </c:pt>
                <c:pt idx="6">
                  <c:v>1.1478224555416936</c:v>
                </c:pt>
                <c:pt idx="7">
                  <c:v>6.8992713746385617</c:v>
                </c:pt>
                <c:pt idx="8">
                  <c:v>1.0957517048194929</c:v>
                </c:pt>
                <c:pt idx="9">
                  <c:v>5.7867352420480218</c:v>
                </c:pt>
                <c:pt idx="10">
                  <c:v>1.8597059912238967</c:v>
                </c:pt>
                <c:pt idx="11">
                  <c:v>11.075130516332486</c:v>
                </c:pt>
                <c:pt idx="12">
                  <c:v>1.6679486763197302</c:v>
                </c:pt>
                <c:pt idx="13">
                  <c:v>1.6698089170805903</c:v>
                </c:pt>
                <c:pt idx="14">
                  <c:v>8.4959331063748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07-4074-ACBA-C40389B6AF43}"/>
            </c:ext>
          </c:extLst>
        </c:ser>
        <c:ser>
          <c:idx val="3"/>
          <c:order val="3"/>
          <c:tx>
            <c:strRef>
              <c:f>'DHA3'!$B$7</c:f>
              <c:strCache>
                <c:ptCount val="1"/>
                <c:pt idx="0">
                  <c:v>303</c:v>
                </c:pt>
              </c:strCache>
            </c:strRef>
          </c:tx>
          <c:spPr>
            <a:solidFill>
              <a:schemeClr val="accent3">
                <a:tint val="4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7:$Q$7</c:f>
              <c:numCache>
                <c:formatCode>General</c:formatCode>
                <c:ptCount val="15"/>
                <c:pt idx="0">
                  <c:v>7.4414998550706555</c:v>
                </c:pt>
                <c:pt idx="1">
                  <c:v>3.2023276293794281</c:v>
                </c:pt>
                <c:pt idx="2">
                  <c:v>12.371690065892166</c:v>
                </c:pt>
                <c:pt idx="3">
                  <c:v>15.623915041887097</c:v>
                </c:pt>
                <c:pt idx="4">
                  <c:v>1.4292296178090984</c:v>
                </c:pt>
                <c:pt idx="5">
                  <c:v>20.835512595477404</c:v>
                </c:pt>
                <c:pt idx="6">
                  <c:v>1.4336939060017011</c:v>
                </c:pt>
                <c:pt idx="7">
                  <c:v>6.124390413212927</c:v>
                </c:pt>
                <c:pt idx="8">
                  <c:v>0.87440958849492179</c:v>
                </c:pt>
                <c:pt idx="9">
                  <c:v>5.1975449489851222</c:v>
                </c:pt>
                <c:pt idx="10">
                  <c:v>1.8316052639429863</c:v>
                </c:pt>
                <c:pt idx="11">
                  <c:v>12.480588719379496</c:v>
                </c:pt>
                <c:pt idx="12">
                  <c:v>1.4446507150525802</c:v>
                </c:pt>
                <c:pt idx="13">
                  <c:v>1.6991808080311264</c:v>
                </c:pt>
                <c:pt idx="14">
                  <c:v>7.0237002640333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707-4074-ACBA-C40389B6AF43}"/>
            </c:ext>
          </c:extLst>
        </c:ser>
        <c:ser>
          <c:idx val="4"/>
          <c:order val="4"/>
          <c:tx>
            <c:strRef>
              <c:f>'DHA3'!$B$8</c:f>
              <c:strCache>
                <c:ptCount val="1"/>
                <c:pt idx="0">
                  <c:v>327</c:v>
                </c:pt>
              </c:strCache>
            </c:strRef>
          </c:tx>
          <c:spPr>
            <a:solidFill>
              <a:schemeClr val="accent3">
                <a:tint val="5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8:$Q$8</c:f>
              <c:numCache>
                <c:formatCode>General</c:formatCode>
                <c:ptCount val="15"/>
                <c:pt idx="0">
                  <c:v>8.1854196353449407</c:v>
                </c:pt>
                <c:pt idx="1">
                  <c:v>3.3766107981299465</c:v>
                </c:pt>
                <c:pt idx="2">
                  <c:v>16.245840317749817</c:v>
                </c:pt>
                <c:pt idx="3">
                  <c:v>17.525813973116104</c:v>
                </c:pt>
                <c:pt idx="4">
                  <c:v>1.3332010311502482</c:v>
                </c:pt>
                <c:pt idx="5">
                  <c:v>17.06955673899839</c:v>
                </c:pt>
                <c:pt idx="6">
                  <c:v>1.0884171898785115</c:v>
                </c:pt>
                <c:pt idx="7">
                  <c:v>5.89003820409215</c:v>
                </c:pt>
                <c:pt idx="8">
                  <c:v>0.76518050718087305</c:v>
                </c:pt>
                <c:pt idx="9">
                  <c:v>6.1030058978359234</c:v>
                </c:pt>
                <c:pt idx="10">
                  <c:v>1.2477170956879662</c:v>
                </c:pt>
                <c:pt idx="11">
                  <c:v>12.17682912706919</c:v>
                </c:pt>
                <c:pt idx="12">
                  <c:v>1.743577747523972</c:v>
                </c:pt>
                <c:pt idx="13">
                  <c:v>1.7880210733942101</c:v>
                </c:pt>
                <c:pt idx="14">
                  <c:v>4.9648147168672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707-4074-ACBA-C40389B6AF43}"/>
            </c:ext>
          </c:extLst>
        </c:ser>
        <c:ser>
          <c:idx val="5"/>
          <c:order val="5"/>
          <c:tx>
            <c:strRef>
              <c:f>'DHA3'!$B$9</c:f>
              <c:strCache>
                <c:ptCount val="1"/>
                <c:pt idx="0">
                  <c:v>317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9:$Q$9</c:f>
              <c:numCache>
                <c:formatCode>General</c:formatCode>
                <c:ptCount val="15"/>
                <c:pt idx="0">
                  <c:v>6.9145024397441253</c:v>
                </c:pt>
                <c:pt idx="1">
                  <c:v>3.575464665231356</c:v>
                </c:pt>
                <c:pt idx="2">
                  <c:v>12.168555867818093</c:v>
                </c:pt>
                <c:pt idx="3">
                  <c:v>15.694150447021348</c:v>
                </c:pt>
                <c:pt idx="4">
                  <c:v>1.6417250933448486</c:v>
                </c:pt>
                <c:pt idx="5">
                  <c:v>18.766351783934386</c:v>
                </c:pt>
                <c:pt idx="6">
                  <c:v>1.703473812474172</c:v>
                </c:pt>
                <c:pt idx="7">
                  <c:v>6.2564133525140777</c:v>
                </c:pt>
                <c:pt idx="8">
                  <c:v>1.2419992764820758</c:v>
                </c:pt>
                <c:pt idx="9">
                  <c:v>5.8792991881798251</c:v>
                </c:pt>
                <c:pt idx="10">
                  <c:v>2.3173334690739926</c:v>
                </c:pt>
                <c:pt idx="11">
                  <c:v>11.650593690676695</c:v>
                </c:pt>
                <c:pt idx="12">
                  <c:v>1.6594091945302178</c:v>
                </c:pt>
                <c:pt idx="13">
                  <c:v>1.8289719515407774</c:v>
                </c:pt>
                <c:pt idx="14">
                  <c:v>7.12859773830847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707-4074-ACBA-C40389B6AF43}"/>
            </c:ext>
          </c:extLst>
        </c:ser>
        <c:ser>
          <c:idx val="6"/>
          <c:order val="6"/>
          <c:tx>
            <c:strRef>
              <c:f>'DHA3'!$B$10</c:f>
              <c:strCache>
                <c:ptCount val="1"/>
                <c:pt idx="0">
                  <c:v>306</c:v>
                </c:pt>
              </c:strCache>
            </c:strRef>
          </c:tx>
          <c:spPr>
            <a:solidFill>
              <a:schemeClr val="accent3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0:$Q$10</c:f>
              <c:numCache>
                <c:formatCode>General</c:formatCode>
                <c:ptCount val="15"/>
                <c:pt idx="0">
                  <c:v>6.9402464836797879</c:v>
                </c:pt>
                <c:pt idx="1">
                  <c:v>3.5565775690594807</c:v>
                </c:pt>
                <c:pt idx="2">
                  <c:v>13.363437574217254</c:v>
                </c:pt>
                <c:pt idx="3">
                  <c:v>16.098705422092511</c:v>
                </c:pt>
                <c:pt idx="4">
                  <c:v>1.3163583375093804</c:v>
                </c:pt>
                <c:pt idx="5">
                  <c:v>18.876983706183335</c:v>
                </c:pt>
                <c:pt idx="6">
                  <c:v>1.3384644614082557</c:v>
                </c:pt>
                <c:pt idx="7">
                  <c:v>6.5352405878848838</c:v>
                </c:pt>
                <c:pt idx="8">
                  <c:v>0.87521951407504128</c:v>
                </c:pt>
                <c:pt idx="9">
                  <c:v>5.6957775767137644</c:v>
                </c:pt>
                <c:pt idx="10">
                  <c:v>1.6829233078243644</c:v>
                </c:pt>
                <c:pt idx="11">
                  <c:v>12.372521275840134</c:v>
                </c:pt>
                <c:pt idx="12">
                  <c:v>1.7249915582499318</c:v>
                </c:pt>
                <c:pt idx="13">
                  <c:v>1.8357231917118391</c:v>
                </c:pt>
                <c:pt idx="14">
                  <c:v>7.14858581337716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07-4074-ACBA-C40389B6AF43}"/>
            </c:ext>
          </c:extLst>
        </c:ser>
        <c:ser>
          <c:idx val="7"/>
          <c:order val="7"/>
          <c:tx>
            <c:strRef>
              <c:f>'DHA3'!$B$11</c:f>
              <c:strCache>
                <c:ptCount val="1"/>
                <c:pt idx="0">
                  <c:v>322</c:v>
                </c:pt>
              </c:strCache>
            </c:strRef>
          </c:tx>
          <c:spPr>
            <a:solidFill>
              <a:schemeClr val="accent3">
                <a:tint val="6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1:$Q$11</c:f>
              <c:numCache>
                <c:formatCode>General</c:formatCode>
                <c:ptCount val="15"/>
                <c:pt idx="0">
                  <c:v>7.664966933580045</c:v>
                </c:pt>
                <c:pt idx="1">
                  <c:v>3.0463726209924062</c:v>
                </c:pt>
                <c:pt idx="2">
                  <c:v>15.585179868260331</c:v>
                </c:pt>
                <c:pt idx="3">
                  <c:v>17.655073112979764</c:v>
                </c:pt>
                <c:pt idx="4">
                  <c:v>1.0860105345555251</c:v>
                </c:pt>
                <c:pt idx="5">
                  <c:v>17.998077214878386</c:v>
                </c:pt>
                <c:pt idx="6">
                  <c:v>1.0653545628484757</c:v>
                </c:pt>
                <c:pt idx="7">
                  <c:v>6.6814827428944179</c:v>
                </c:pt>
                <c:pt idx="8">
                  <c:v>0.71828042316390495</c:v>
                </c:pt>
                <c:pt idx="9">
                  <c:v>5.3421907592313618</c:v>
                </c:pt>
                <c:pt idx="10">
                  <c:v>1.2804035474700437</c:v>
                </c:pt>
                <c:pt idx="11">
                  <c:v>12.281094517024588</c:v>
                </c:pt>
                <c:pt idx="12">
                  <c:v>1.8270226246004351</c:v>
                </c:pt>
                <c:pt idx="13">
                  <c:v>1.8733328403677978</c:v>
                </c:pt>
                <c:pt idx="14">
                  <c:v>5.21051743630844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707-4074-ACBA-C40389B6AF43}"/>
            </c:ext>
          </c:extLst>
        </c:ser>
        <c:ser>
          <c:idx val="8"/>
          <c:order val="8"/>
          <c:tx>
            <c:strRef>
              <c:f>'DHA3'!$B$12</c:f>
              <c:strCache>
                <c:ptCount val="1"/>
                <c:pt idx="0">
                  <c:v>315</c:v>
                </c:pt>
              </c:strCache>
            </c:strRef>
          </c:tx>
          <c:spPr>
            <a:solidFill>
              <a:schemeClr val="accent3">
                <a:tint val="7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2:$Q$12</c:f>
              <c:numCache>
                <c:formatCode>General</c:formatCode>
                <c:ptCount val="15"/>
                <c:pt idx="0">
                  <c:v>7.4691858597428586</c:v>
                </c:pt>
                <c:pt idx="1">
                  <c:v>3.2269608851751679</c:v>
                </c:pt>
                <c:pt idx="2">
                  <c:v>11.715842883944102</c:v>
                </c:pt>
                <c:pt idx="3">
                  <c:v>15.204444407567582</c:v>
                </c:pt>
                <c:pt idx="4">
                  <c:v>1.4770360511033349</c:v>
                </c:pt>
                <c:pt idx="5">
                  <c:v>20.862360827234543</c:v>
                </c:pt>
                <c:pt idx="6">
                  <c:v>1.3266133769524193</c:v>
                </c:pt>
                <c:pt idx="7">
                  <c:v>6.0843454006568196</c:v>
                </c:pt>
                <c:pt idx="8">
                  <c:v>0.79440402647223163</c:v>
                </c:pt>
                <c:pt idx="9">
                  <c:v>5.0664007163266955</c:v>
                </c:pt>
                <c:pt idx="10">
                  <c:v>1.7200411487195622</c:v>
                </c:pt>
                <c:pt idx="11">
                  <c:v>13.444671709657458</c:v>
                </c:pt>
                <c:pt idx="12">
                  <c:v>1.7571562117302058</c:v>
                </c:pt>
                <c:pt idx="13">
                  <c:v>1.8939655374721618</c:v>
                </c:pt>
                <c:pt idx="14">
                  <c:v>7.1309935569130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707-4074-ACBA-C40389B6AF43}"/>
            </c:ext>
          </c:extLst>
        </c:ser>
        <c:ser>
          <c:idx val="9"/>
          <c:order val="9"/>
          <c:tx>
            <c:strRef>
              <c:f>'DHA3'!$B$13</c:f>
              <c:strCache>
                <c:ptCount val="1"/>
                <c:pt idx="0">
                  <c:v>326</c:v>
                </c:pt>
              </c:strCache>
            </c:strRef>
          </c:tx>
          <c:spPr>
            <a:solidFill>
              <a:schemeClr val="accent3">
                <a:tint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3:$Q$13</c:f>
              <c:numCache>
                <c:formatCode>General</c:formatCode>
                <c:ptCount val="15"/>
                <c:pt idx="0">
                  <c:v>6.6169001358620791</c:v>
                </c:pt>
                <c:pt idx="1">
                  <c:v>2.9794840389769925</c:v>
                </c:pt>
                <c:pt idx="2">
                  <c:v>12.611670583354856</c:v>
                </c:pt>
                <c:pt idx="3">
                  <c:v>14.472663782230388</c:v>
                </c:pt>
                <c:pt idx="4">
                  <c:v>1.3097277440897639</c:v>
                </c:pt>
                <c:pt idx="5">
                  <c:v>20.423516109480154</c:v>
                </c:pt>
                <c:pt idx="6">
                  <c:v>1.290590474676111</c:v>
                </c:pt>
                <c:pt idx="7">
                  <c:v>6.8937577249802091</c:v>
                </c:pt>
                <c:pt idx="8">
                  <c:v>0.93874780776694999</c:v>
                </c:pt>
                <c:pt idx="9">
                  <c:v>4.890078465761075</c:v>
                </c:pt>
                <c:pt idx="10">
                  <c:v>2.0434012878069066</c:v>
                </c:pt>
                <c:pt idx="11">
                  <c:v>13.621513331649931</c:v>
                </c:pt>
                <c:pt idx="12">
                  <c:v>1.6129042994985463</c:v>
                </c:pt>
                <c:pt idx="13">
                  <c:v>1.9110150101396339</c:v>
                </c:pt>
                <c:pt idx="14">
                  <c:v>7.384674130277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707-4074-ACBA-C40389B6AF43}"/>
            </c:ext>
          </c:extLst>
        </c:ser>
        <c:ser>
          <c:idx val="10"/>
          <c:order val="10"/>
          <c:tx>
            <c:strRef>
              <c:f>'DHA3'!$B$14</c:f>
              <c:strCache>
                <c:ptCount val="1"/>
                <c:pt idx="0">
                  <c:v>323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4:$Q$14</c:f>
              <c:numCache>
                <c:formatCode>General</c:formatCode>
                <c:ptCount val="15"/>
                <c:pt idx="0">
                  <c:v>7.3002715136084504</c:v>
                </c:pt>
                <c:pt idx="1">
                  <c:v>3.2486834542135452</c:v>
                </c:pt>
                <c:pt idx="2">
                  <c:v>13.398270807969499</c:v>
                </c:pt>
                <c:pt idx="3">
                  <c:v>16.925965212911279</c:v>
                </c:pt>
                <c:pt idx="4">
                  <c:v>1.362352729585389</c:v>
                </c:pt>
                <c:pt idx="5">
                  <c:v>17.481702636257957</c:v>
                </c:pt>
                <c:pt idx="6">
                  <c:v>1.2914119811923526</c:v>
                </c:pt>
                <c:pt idx="7">
                  <c:v>6.6797597399441608</c:v>
                </c:pt>
                <c:pt idx="8">
                  <c:v>1.3097044738998791</c:v>
                </c:pt>
                <c:pt idx="9">
                  <c:v>6.1082957786887908</c:v>
                </c:pt>
                <c:pt idx="10">
                  <c:v>2.1887228189577983</c:v>
                </c:pt>
                <c:pt idx="11">
                  <c:v>11.528195661973353</c:v>
                </c:pt>
                <c:pt idx="12">
                  <c:v>1.5846046910510418</c:v>
                </c:pt>
                <c:pt idx="13">
                  <c:v>1.9524727388379544</c:v>
                </c:pt>
                <c:pt idx="14">
                  <c:v>7.0978591345857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707-4074-ACBA-C40389B6AF43}"/>
            </c:ext>
          </c:extLst>
        </c:ser>
        <c:ser>
          <c:idx val="11"/>
          <c:order val="11"/>
          <c:tx>
            <c:strRef>
              <c:f>'DHA3'!$B$15</c:f>
              <c:strCache>
                <c:ptCount val="1"/>
                <c:pt idx="0">
                  <c:v>318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5:$Q$15</c:f>
              <c:numCache>
                <c:formatCode>General</c:formatCode>
                <c:ptCount val="15"/>
                <c:pt idx="0">
                  <c:v>8.4239312649418547</c:v>
                </c:pt>
                <c:pt idx="1">
                  <c:v>3.1546969567897309</c:v>
                </c:pt>
                <c:pt idx="2">
                  <c:v>14.573019902267282</c:v>
                </c:pt>
                <c:pt idx="3">
                  <c:v>18.190505804109023</c:v>
                </c:pt>
                <c:pt idx="4">
                  <c:v>1.2356042370202152</c:v>
                </c:pt>
                <c:pt idx="5">
                  <c:v>16.227414646021305</c:v>
                </c:pt>
                <c:pt idx="6">
                  <c:v>1.0454486223242438</c:v>
                </c:pt>
                <c:pt idx="7">
                  <c:v>5.1711892407345248</c:v>
                </c:pt>
                <c:pt idx="8">
                  <c:v>0.82613429232838975</c:v>
                </c:pt>
                <c:pt idx="9">
                  <c:v>6.4267269760152388</c:v>
                </c:pt>
                <c:pt idx="10">
                  <c:v>1.2768811508562825</c:v>
                </c:pt>
                <c:pt idx="11">
                  <c:v>12.21542828349796</c:v>
                </c:pt>
                <c:pt idx="12">
                  <c:v>1.5744590522105821</c:v>
                </c:pt>
                <c:pt idx="13">
                  <c:v>1.9997591996112645</c:v>
                </c:pt>
                <c:pt idx="14">
                  <c:v>6.59385092323264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707-4074-ACBA-C40389B6AF43}"/>
            </c:ext>
          </c:extLst>
        </c:ser>
        <c:ser>
          <c:idx val="12"/>
          <c:order val="12"/>
          <c:tx>
            <c:strRef>
              <c:f>'DHA3'!$B$16</c:f>
              <c:strCache>
                <c:ptCount val="1"/>
                <c:pt idx="0">
                  <c:v>304</c:v>
                </c:pt>
              </c:strCache>
            </c:strRef>
          </c:tx>
          <c:spPr>
            <a:solidFill>
              <a:schemeClr val="accent3">
                <a:tint val="8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6:$Q$16</c:f>
              <c:numCache>
                <c:formatCode>General</c:formatCode>
                <c:ptCount val="15"/>
                <c:pt idx="0">
                  <c:v>7.2818123683002547</c:v>
                </c:pt>
                <c:pt idx="1">
                  <c:v>3.9039114779541442</c:v>
                </c:pt>
                <c:pt idx="2">
                  <c:v>12.97025511099052</c:v>
                </c:pt>
                <c:pt idx="3">
                  <c:v>15.801649685865542</c:v>
                </c:pt>
                <c:pt idx="4">
                  <c:v>2.8456487137612827</c:v>
                </c:pt>
                <c:pt idx="5">
                  <c:v>12.381477782616912</c:v>
                </c:pt>
                <c:pt idx="6">
                  <c:v>2.2732627405723482</c:v>
                </c:pt>
                <c:pt idx="7">
                  <c:v>5.6237328634915205</c:v>
                </c:pt>
                <c:pt idx="8">
                  <c:v>3.3381780665729592</c:v>
                </c:pt>
                <c:pt idx="9">
                  <c:v>5.7168172993995352</c:v>
                </c:pt>
                <c:pt idx="10">
                  <c:v>3.8122342834290239</c:v>
                </c:pt>
                <c:pt idx="11">
                  <c:v>10.474406253126567</c:v>
                </c:pt>
                <c:pt idx="12">
                  <c:v>1.0629528809873079</c:v>
                </c:pt>
                <c:pt idx="13">
                  <c:v>1.9997792094869085</c:v>
                </c:pt>
                <c:pt idx="14">
                  <c:v>9.75447120722178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707-4074-ACBA-C40389B6AF43}"/>
            </c:ext>
          </c:extLst>
        </c:ser>
        <c:ser>
          <c:idx val="13"/>
          <c:order val="13"/>
          <c:tx>
            <c:strRef>
              <c:f>'DHA3'!$B$17</c:f>
              <c:strCache>
                <c:ptCount val="1"/>
                <c:pt idx="0">
                  <c:v>312</c:v>
                </c:pt>
              </c:strCache>
            </c:strRef>
          </c:tx>
          <c:spPr>
            <a:solidFill>
              <a:schemeClr val="accent3">
                <a:tint val="9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7:$Q$17</c:f>
              <c:numCache>
                <c:formatCode>General</c:formatCode>
                <c:ptCount val="15"/>
                <c:pt idx="0">
                  <c:v>8.2004441437926836</c:v>
                </c:pt>
                <c:pt idx="1">
                  <c:v>3.5642636849658049</c:v>
                </c:pt>
                <c:pt idx="2">
                  <c:v>16.381619619032804</c:v>
                </c:pt>
                <c:pt idx="3">
                  <c:v>16.751717701429637</c:v>
                </c:pt>
                <c:pt idx="4">
                  <c:v>2.8171597296193274</c:v>
                </c:pt>
                <c:pt idx="5">
                  <c:v>14.567484195685442</c:v>
                </c:pt>
                <c:pt idx="6">
                  <c:v>2.1752546303141371</c:v>
                </c:pt>
                <c:pt idx="7">
                  <c:v>6.3007735244934917</c:v>
                </c:pt>
                <c:pt idx="8">
                  <c:v>0.82330854604772807</c:v>
                </c:pt>
                <c:pt idx="9">
                  <c:v>4.4603059352557946</c:v>
                </c:pt>
                <c:pt idx="10">
                  <c:v>1.2753821616273981</c:v>
                </c:pt>
                <c:pt idx="11">
                  <c:v>9.8248093038868838</c:v>
                </c:pt>
                <c:pt idx="12">
                  <c:v>1.6576611356256787</c:v>
                </c:pt>
                <c:pt idx="13">
                  <c:v>2.0097627840154071</c:v>
                </c:pt>
                <c:pt idx="14">
                  <c:v>8.1358727712510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D707-4074-ACBA-C40389B6AF43}"/>
            </c:ext>
          </c:extLst>
        </c:ser>
        <c:ser>
          <c:idx val="14"/>
          <c:order val="14"/>
          <c:tx>
            <c:strRef>
              <c:f>'DHA3'!$B$18</c:f>
              <c:strCache>
                <c:ptCount val="1"/>
                <c:pt idx="0">
                  <c:v>316</c:v>
                </c:pt>
              </c:strCache>
            </c:strRef>
          </c:tx>
          <c:spPr>
            <a:solidFill>
              <a:schemeClr val="accent3">
                <a:tint val="9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8:$Q$18</c:f>
              <c:numCache>
                <c:formatCode>General</c:formatCode>
                <c:ptCount val="15"/>
                <c:pt idx="0">
                  <c:v>7.5057973607045287</c:v>
                </c:pt>
                <c:pt idx="1">
                  <c:v>3.294462373256291</c:v>
                </c:pt>
                <c:pt idx="2">
                  <c:v>11.939452775667579</c:v>
                </c:pt>
                <c:pt idx="3">
                  <c:v>18.187817413817445</c:v>
                </c:pt>
                <c:pt idx="4">
                  <c:v>1.201984929820773</c:v>
                </c:pt>
                <c:pt idx="5">
                  <c:v>17.688072093254107</c:v>
                </c:pt>
                <c:pt idx="6">
                  <c:v>1.1317294204605957</c:v>
                </c:pt>
                <c:pt idx="7">
                  <c:v>6.3438530205811574</c:v>
                </c:pt>
                <c:pt idx="8">
                  <c:v>1.0552230057878285</c:v>
                </c:pt>
                <c:pt idx="9">
                  <c:v>6.2131685083390416</c:v>
                </c:pt>
                <c:pt idx="10">
                  <c:v>1.6665274255542684</c:v>
                </c:pt>
                <c:pt idx="11">
                  <c:v>11.332681785715783</c:v>
                </c:pt>
                <c:pt idx="12">
                  <c:v>1.7442037169898614</c:v>
                </c:pt>
                <c:pt idx="13">
                  <c:v>2.1440436035672703</c:v>
                </c:pt>
                <c:pt idx="14">
                  <c:v>7.0009825857774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D707-4074-ACBA-C40389B6AF43}"/>
            </c:ext>
          </c:extLst>
        </c:ser>
        <c:ser>
          <c:idx val="15"/>
          <c:order val="15"/>
          <c:tx>
            <c:strRef>
              <c:f>'DHA3'!$B$19</c:f>
              <c:strCache>
                <c:ptCount val="1"/>
                <c:pt idx="0">
                  <c:v>301</c:v>
                </c:pt>
              </c:strCache>
            </c:strRef>
          </c:tx>
          <c:spPr>
            <a:solidFill>
              <a:schemeClr val="accent3">
                <a:shade val="9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19:$Q$19</c:f>
              <c:numCache>
                <c:formatCode>General</c:formatCode>
                <c:ptCount val="15"/>
                <c:pt idx="0">
                  <c:v>6.1461770812235459</c:v>
                </c:pt>
                <c:pt idx="1">
                  <c:v>3.2273294338370326</c:v>
                </c:pt>
                <c:pt idx="2">
                  <c:v>11.50463135218973</c:v>
                </c:pt>
                <c:pt idx="3">
                  <c:v>14.101467832203173</c:v>
                </c:pt>
                <c:pt idx="4">
                  <c:v>1.3319215715889745</c:v>
                </c:pt>
                <c:pt idx="5">
                  <c:v>19.675189649106311</c:v>
                </c:pt>
                <c:pt idx="6">
                  <c:v>1.4125153861248532</c:v>
                </c:pt>
                <c:pt idx="7">
                  <c:v>6.8131249913640568</c:v>
                </c:pt>
                <c:pt idx="8">
                  <c:v>1.0486225216606619</c:v>
                </c:pt>
                <c:pt idx="9">
                  <c:v>5.95966101204968</c:v>
                </c:pt>
                <c:pt idx="10">
                  <c:v>2.1570322600726728</c:v>
                </c:pt>
                <c:pt idx="11">
                  <c:v>14.317478354960354</c:v>
                </c:pt>
                <c:pt idx="12">
                  <c:v>1.927306608485142</c:v>
                </c:pt>
                <c:pt idx="13">
                  <c:v>2.1850974016301299</c:v>
                </c:pt>
                <c:pt idx="14">
                  <c:v>7.62275835673441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D707-4074-ACBA-C40389B6AF43}"/>
            </c:ext>
          </c:extLst>
        </c:ser>
        <c:ser>
          <c:idx val="16"/>
          <c:order val="16"/>
          <c:tx>
            <c:strRef>
              <c:f>'DHA3'!$B$20</c:f>
              <c:strCache>
                <c:ptCount val="1"/>
                <c:pt idx="0">
                  <c:v>328</c:v>
                </c:pt>
              </c:strCache>
            </c:strRef>
          </c:tx>
          <c:spPr>
            <a:solidFill>
              <a:schemeClr val="accent3">
                <a:shade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0:$Q$20</c:f>
              <c:numCache>
                <c:formatCode>General</c:formatCode>
                <c:ptCount val="15"/>
                <c:pt idx="0">
                  <c:v>7.9485028026961553</c:v>
                </c:pt>
                <c:pt idx="1">
                  <c:v>3.3830943031564775</c:v>
                </c:pt>
                <c:pt idx="2">
                  <c:v>14.947232520405775</c:v>
                </c:pt>
                <c:pt idx="3">
                  <c:v>16.511496644494258</c:v>
                </c:pt>
                <c:pt idx="4">
                  <c:v>2.6285390352314888</c:v>
                </c:pt>
                <c:pt idx="5">
                  <c:v>13.186125950407197</c:v>
                </c:pt>
                <c:pt idx="6">
                  <c:v>1.2153335599138726</c:v>
                </c:pt>
                <c:pt idx="7">
                  <c:v>5.3585951689047215</c:v>
                </c:pt>
                <c:pt idx="8">
                  <c:v>2.391053687357855</c:v>
                </c:pt>
                <c:pt idx="9">
                  <c:v>5.1840064109436321</c:v>
                </c:pt>
                <c:pt idx="10">
                  <c:v>2.8573033524538052</c:v>
                </c:pt>
                <c:pt idx="11">
                  <c:v>10.353984487034072</c:v>
                </c:pt>
                <c:pt idx="12">
                  <c:v>1.0605117454713442</c:v>
                </c:pt>
                <c:pt idx="13">
                  <c:v>2.2078880667241343</c:v>
                </c:pt>
                <c:pt idx="14">
                  <c:v>9.09219082968062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707-4074-ACBA-C40389B6AF43}"/>
            </c:ext>
          </c:extLst>
        </c:ser>
        <c:ser>
          <c:idx val="17"/>
          <c:order val="17"/>
          <c:tx>
            <c:strRef>
              <c:f>'DHA3'!$B$21</c:f>
              <c:strCache>
                <c:ptCount val="1"/>
                <c:pt idx="0">
                  <c:v>324</c:v>
                </c:pt>
              </c:strCache>
            </c:strRef>
          </c:tx>
          <c:spPr>
            <a:solidFill>
              <a:schemeClr val="accent3">
                <a:shade val="8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1:$Q$21</c:f>
              <c:numCache>
                <c:formatCode>General</c:formatCode>
                <c:ptCount val="15"/>
                <c:pt idx="0">
                  <c:v>7.3337926377851792</c:v>
                </c:pt>
                <c:pt idx="1">
                  <c:v>3.6059108492640544</c:v>
                </c:pt>
                <c:pt idx="2">
                  <c:v>12.09852131787275</c:v>
                </c:pt>
                <c:pt idx="3">
                  <c:v>14.173012698770084</c:v>
                </c:pt>
                <c:pt idx="4">
                  <c:v>1.4016758712467481</c:v>
                </c:pt>
                <c:pt idx="5">
                  <c:v>18.693405051167279</c:v>
                </c:pt>
                <c:pt idx="6">
                  <c:v>1.4623766772897595</c:v>
                </c:pt>
                <c:pt idx="7">
                  <c:v>5.8797813973210067</c:v>
                </c:pt>
                <c:pt idx="8">
                  <c:v>0.86810155695575331</c:v>
                </c:pt>
                <c:pt idx="9">
                  <c:v>5.8375100102993782</c:v>
                </c:pt>
                <c:pt idx="10">
                  <c:v>1.8887082071920778</c:v>
                </c:pt>
                <c:pt idx="11">
                  <c:v>14.460800485215959</c:v>
                </c:pt>
                <c:pt idx="12">
                  <c:v>1.7336830340188241</c:v>
                </c:pt>
                <c:pt idx="13">
                  <c:v>2.2888251461998306</c:v>
                </c:pt>
                <c:pt idx="14">
                  <c:v>7.3784491589392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D707-4074-ACBA-C40389B6AF43}"/>
            </c:ext>
          </c:extLst>
        </c:ser>
        <c:ser>
          <c:idx val="18"/>
          <c:order val="18"/>
          <c:tx>
            <c:strRef>
              <c:f>'DHA3'!$B$22</c:f>
              <c:strCache>
                <c:ptCount val="1"/>
                <c:pt idx="0">
                  <c:v>319</c:v>
                </c:pt>
              </c:strCache>
            </c:strRef>
          </c:tx>
          <c:spPr>
            <a:solidFill>
              <a:schemeClr val="accent3">
                <a:shade val="8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2:$Q$22</c:f>
              <c:numCache>
                <c:formatCode>General</c:formatCode>
                <c:ptCount val="15"/>
                <c:pt idx="0">
                  <c:v>7.0765913338904562</c:v>
                </c:pt>
                <c:pt idx="1">
                  <c:v>2.89723224707594</c:v>
                </c:pt>
                <c:pt idx="2">
                  <c:v>10.587813776091613</c:v>
                </c:pt>
                <c:pt idx="3">
                  <c:v>16.724190116468321</c:v>
                </c:pt>
                <c:pt idx="4">
                  <c:v>2.0844192651678544</c:v>
                </c:pt>
                <c:pt idx="5">
                  <c:v>17.230709544079605</c:v>
                </c:pt>
                <c:pt idx="6">
                  <c:v>1.9680055601197746</c:v>
                </c:pt>
                <c:pt idx="7">
                  <c:v>5.3046608303170526</c:v>
                </c:pt>
                <c:pt idx="8">
                  <c:v>0.86864159658210716</c:v>
                </c:pt>
                <c:pt idx="9">
                  <c:v>7.4242509181343843</c:v>
                </c:pt>
                <c:pt idx="10">
                  <c:v>1.4554635900423547</c:v>
                </c:pt>
                <c:pt idx="11">
                  <c:v>15.165877579976277</c:v>
                </c:pt>
                <c:pt idx="12">
                  <c:v>1.5092764947117741</c:v>
                </c:pt>
                <c:pt idx="13">
                  <c:v>2.3279660424965525</c:v>
                </c:pt>
                <c:pt idx="14">
                  <c:v>6.8841628967994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D707-4074-ACBA-C40389B6AF43}"/>
            </c:ext>
          </c:extLst>
        </c:ser>
        <c:ser>
          <c:idx val="19"/>
          <c:order val="19"/>
          <c:tx>
            <c:strRef>
              <c:f>'DHA3'!$B$23</c:f>
              <c:strCache>
                <c:ptCount val="1"/>
                <c:pt idx="0">
                  <c:v>329</c:v>
                </c:pt>
              </c:strCache>
            </c:strRef>
          </c:tx>
          <c:spPr>
            <a:solidFill>
              <a:schemeClr val="accent3">
                <a:shade val="7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3:$Q$23</c:f>
              <c:numCache>
                <c:formatCode>General</c:formatCode>
                <c:ptCount val="15"/>
                <c:pt idx="0">
                  <c:v>7.75954085074593</c:v>
                </c:pt>
                <c:pt idx="1">
                  <c:v>3.3897760781676398</c:v>
                </c:pt>
                <c:pt idx="2">
                  <c:v>12.700582552351095</c:v>
                </c:pt>
                <c:pt idx="3">
                  <c:v>17.36281185535001</c:v>
                </c:pt>
                <c:pt idx="4">
                  <c:v>1.3472388558924562</c:v>
                </c:pt>
                <c:pt idx="5">
                  <c:v>15.729034296806258</c:v>
                </c:pt>
                <c:pt idx="6">
                  <c:v>1.1921304421221177</c:v>
                </c:pt>
                <c:pt idx="7">
                  <c:v>5.528787611463911</c:v>
                </c:pt>
                <c:pt idx="8">
                  <c:v>0.94812367160387423</c:v>
                </c:pt>
                <c:pt idx="9">
                  <c:v>7.3270144607334968</c:v>
                </c:pt>
                <c:pt idx="10">
                  <c:v>1.4636740632786476</c:v>
                </c:pt>
                <c:pt idx="11">
                  <c:v>13.750840857575151</c:v>
                </c:pt>
                <c:pt idx="12">
                  <c:v>1.7080508726008834</c:v>
                </c:pt>
                <c:pt idx="13">
                  <c:v>2.3731539620690918</c:v>
                </c:pt>
                <c:pt idx="14">
                  <c:v>6.88047411647563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D707-4074-ACBA-C40389B6AF43}"/>
            </c:ext>
          </c:extLst>
        </c:ser>
        <c:ser>
          <c:idx val="20"/>
          <c:order val="20"/>
          <c:tx>
            <c:strRef>
              <c:f>'DHA3'!$B$24</c:f>
              <c:strCache>
                <c:ptCount val="1"/>
                <c:pt idx="0">
                  <c:v>330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4:$Q$24</c:f>
              <c:numCache>
                <c:formatCode>General</c:formatCode>
                <c:ptCount val="15"/>
                <c:pt idx="0">
                  <c:v>7.5617944368768963</c:v>
                </c:pt>
                <c:pt idx="1">
                  <c:v>3.0559674799296848</c:v>
                </c:pt>
                <c:pt idx="2">
                  <c:v>10.86094228844564</c:v>
                </c:pt>
                <c:pt idx="3">
                  <c:v>15.23699208588136</c:v>
                </c:pt>
                <c:pt idx="4">
                  <c:v>1.3406933229270899</c:v>
                </c:pt>
                <c:pt idx="5">
                  <c:v>18.874580799277002</c:v>
                </c:pt>
                <c:pt idx="6">
                  <c:v>1.5035514038159528</c:v>
                </c:pt>
                <c:pt idx="7">
                  <c:v>5.6111490020618211</c:v>
                </c:pt>
                <c:pt idx="8">
                  <c:v>0.94536297197429786</c:v>
                </c:pt>
                <c:pt idx="9">
                  <c:v>6.2161233568974392</c:v>
                </c:pt>
                <c:pt idx="10">
                  <c:v>1.9134912349827722</c:v>
                </c:pt>
                <c:pt idx="11">
                  <c:v>15.046720254684562</c:v>
                </c:pt>
                <c:pt idx="12">
                  <c:v>1.7606342848148813</c:v>
                </c:pt>
                <c:pt idx="13">
                  <c:v>2.3941075750412932</c:v>
                </c:pt>
                <c:pt idx="14">
                  <c:v>6.8165798296096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D707-4074-ACBA-C40389B6AF43}"/>
            </c:ext>
          </c:extLst>
        </c:ser>
        <c:ser>
          <c:idx val="21"/>
          <c:order val="21"/>
          <c:tx>
            <c:strRef>
              <c:f>'DHA3'!$B$25</c:f>
              <c:strCache>
                <c:ptCount val="1"/>
                <c:pt idx="0">
                  <c:v>313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5:$Q$25</c:f>
              <c:numCache>
                <c:formatCode>General</c:formatCode>
                <c:ptCount val="15"/>
                <c:pt idx="0">
                  <c:v>8.1014568321477931</c:v>
                </c:pt>
                <c:pt idx="1">
                  <c:v>3.1722812302928487</c:v>
                </c:pt>
                <c:pt idx="2">
                  <c:v>13.000493991061285</c:v>
                </c:pt>
                <c:pt idx="3">
                  <c:v>15.724529234459592</c:v>
                </c:pt>
                <c:pt idx="4">
                  <c:v>1.2426045054295183</c:v>
                </c:pt>
                <c:pt idx="5">
                  <c:v>17.221350470286914</c:v>
                </c:pt>
                <c:pt idx="6">
                  <c:v>1.16669789705022</c:v>
                </c:pt>
                <c:pt idx="7">
                  <c:v>5.6587272666482393</c:v>
                </c:pt>
                <c:pt idx="8">
                  <c:v>0.828054762923496</c:v>
                </c:pt>
                <c:pt idx="9">
                  <c:v>6.6453285197107297</c:v>
                </c:pt>
                <c:pt idx="10">
                  <c:v>1.483483410727249</c:v>
                </c:pt>
                <c:pt idx="11">
                  <c:v>13.762428500776576</c:v>
                </c:pt>
                <c:pt idx="12">
                  <c:v>1.6969660080465752</c:v>
                </c:pt>
                <c:pt idx="13">
                  <c:v>2.4647481790013264</c:v>
                </c:pt>
                <c:pt idx="14">
                  <c:v>6.84265803276246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D707-4074-ACBA-C40389B6AF43}"/>
            </c:ext>
          </c:extLst>
        </c:ser>
        <c:ser>
          <c:idx val="22"/>
          <c:order val="22"/>
          <c:tx>
            <c:strRef>
              <c:f>'DHA3'!$B$26</c:f>
              <c:strCache>
                <c:ptCount val="1"/>
                <c:pt idx="0">
                  <c:v>321</c:v>
                </c:pt>
              </c:strCache>
            </c:strRef>
          </c:tx>
          <c:spPr>
            <a:solidFill>
              <a:schemeClr val="accent3">
                <a:shade val="6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6:$Q$26</c:f>
              <c:numCache>
                <c:formatCode>General</c:formatCode>
                <c:ptCount val="15"/>
                <c:pt idx="0">
                  <c:v>8.859808947933308</c:v>
                </c:pt>
                <c:pt idx="1">
                  <c:v>4.1536834126181983</c:v>
                </c:pt>
                <c:pt idx="2">
                  <c:v>18.034113424926868</c:v>
                </c:pt>
                <c:pt idx="3">
                  <c:v>16.136688596932075</c:v>
                </c:pt>
                <c:pt idx="4">
                  <c:v>2.4433197642282241</c:v>
                </c:pt>
                <c:pt idx="5">
                  <c:v>8.952143443837663</c:v>
                </c:pt>
                <c:pt idx="6">
                  <c:v>1.4998097306115759</c:v>
                </c:pt>
                <c:pt idx="7">
                  <c:v>5.9952614104696327</c:v>
                </c:pt>
                <c:pt idx="8">
                  <c:v>1.2569956807661535</c:v>
                </c:pt>
                <c:pt idx="9">
                  <c:v>5.6958016633907587</c:v>
                </c:pt>
                <c:pt idx="10">
                  <c:v>1.0877337871994159</c:v>
                </c:pt>
                <c:pt idx="11">
                  <c:v>11.5757969313586</c:v>
                </c:pt>
                <c:pt idx="12">
                  <c:v>1.4532565503708397</c:v>
                </c:pt>
                <c:pt idx="13">
                  <c:v>2.8571053149457661</c:v>
                </c:pt>
                <c:pt idx="14">
                  <c:v>8.3588805042971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D707-4074-ACBA-C40389B6AF43}"/>
            </c:ext>
          </c:extLst>
        </c:ser>
        <c:ser>
          <c:idx val="23"/>
          <c:order val="23"/>
          <c:tx>
            <c:strRef>
              <c:f>'DHA3'!$B$27</c:f>
              <c:strCache>
                <c:ptCount val="1"/>
                <c:pt idx="0">
                  <c:v>310</c:v>
                </c:pt>
              </c:strCache>
            </c:strRef>
          </c:tx>
          <c:spPr>
            <a:solidFill>
              <a:schemeClr val="accent3">
                <a:shade val="6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7:$Q$27</c:f>
              <c:numCache>
                <c:formatCode>General</c:formatCode>
                <c:ptCount val="15"/>
                <c:pt idx="0">
                  <c:v>7.0911558982418486</c:v>
                </c:pt>
                <c:pt idx="1">
                  <c:v>3.8802296952347852</c:v>
                </c:pt>
                <c:pt idx="2">
                  <c:v>12.022441768942484</c:v>
                </c:pt>
                <c:pt idx="3">
                  <c:v>15.126700498467537</c:v>
                </c:pt>
                <c:pt idx="4">
                  <c:v>2.7316689223205768</c:v>
                </c:pt>
                <c:pt idx="5">
                  <c:v>13.364765449991669</c:v>
                </c:pt>
                <c:pt idx="6">
                  <c:v>2.0483726324290945</c:v>
                </c:pt>
                <c:pt idx="7">
                  <c:v>5.9793122772140714</c:v>
                </c:pt>
                <c:pt idx="8">
                  <c:v>1.8928220398356914</c:v>
                </c:pt>
                <c:pt idx="9">
                  <c:v>5.5623983743708303</c:v>
                </c:pt>
                <c:pt idx="10">
                  <c:v>2.6473350286125954</c:v>
                </c:pt>
                <c:pt idx="11">
                  <c:v>12.871422521178124</c:v>
                </c:pt>
                <c:pt idx="12">
                  <c:v>1.2325979703802912</c:v>
                </c:pt>
                <c:pt idx="13">
                  <c:v>2.9202746823859833</c:v>
                </c:pt>
                <c:pt idx="14">
                  <c:v>9.42769429968097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D707-4074-ACBA-C40389B6AF43}"/>
            </c:ext>
          </c:extLst>
        </c:ser>
        <c:ser>
          <c:idx val="24"/>
          <c:order val="24"/>
          <c:tx>
            <c:strRef>
              <c:f>'DHA3'!$B$28</c:f>
              <c:strCache>
                <c:ptCount val="1"/>
                <c:pt idx="0">
                  <c:v>320</c:v>
                </c:pt>
              </c:strCache>
            </c:strRef>
          </c:tx>
          <c:spPr>
            <a:solidFill>
              <a:schemeClr val="accent3">
                <a:shade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8:$Q$28</c:f>
              <c:numCache>
                <c:formatCode>General</c:formatCode>
                <c:ptCount val="15"/>
                <c:pt idx="0">
                  <c:v>8.4175940607559436</c:v>
                </c:pt>
                <c:pt idx="1">
                  <c:v>3.8055641052314733</c:v>
                </c:pt>
                <c:pt idx="2">
                  <c:v>15.03529932953926</c:v>
                </c:pt>
                <c:pt idx="3">
                  <c:v>14.829853472657099</c:v>
                </c:pt>
                <c:pt idx="4">
                  <c:v>1.7817465153275045</c:v>
                </c:pt>
                <c:pt idx="5">
                  <c:v>11.686117629188235</c:v>
                </c:pt>
                <c:pt idx="6">
                  <c:v>1.5796334131896392</c:v>
                </c:pt>
                <c:pt idx="7">
                  <c:v>5.256219061946811</c:v>
                </c:pt>
                <c:pt idx="8">
                  <c:v>1.7758204582218888</c:v>
                </c:pt>
                <c:pt idx="9">
                  <c:v>6.1230174769345158</c:v>
                </c:pt>
                <c:pt idx="10">
                  <c:v>1.9276172287689768</c:v>
                </c:pt>
                <c:pt idx="11">
                  <c:v>13.005594892475868</c:v>
                </c:pt>
                <c:pt idx="12">
                  <c:v>1.4530570012828692</c:v>
                </c:pt>
                <c:pt idx="13">
                  <c:v>2.9858881426014472</c:v>
                </c:pt>
                <c:pt idx="14">
                  <c:v>9.74615100782987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D707-4074-ACBA-C40389B6AF43}"/>
            </c:ext>
          </c:extLst>
        </c:ser>
        <c:ser>
          <c:idx val="25"/>
          <c:order val="25"/>
          <c:tx>
            <c:strRef>
              <c:f>'DHA3'!$B$29</c:f>
              <c:strCache>
                <c:ptCount val="1"/>
                <c:pt idx="0">
                  <c:v>311</c:v>
                </c:pt>
              </c:strCache>
            </c:strRef>
          </c:tx>
          <c:spPr>
            <a:solidFill>
              <a:schemeClr val="accent3">
                <a:shade val="5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29:$Q$29</c:f>
              <c:numCache>
                <c:formatCode>General</c:formatCode>
                <c:ptCount val="15"/>
                <c:pt idx="0">
                  <c:v>8.401373450540822</c:v>
                </c:pt>
                <c:pt idx="1">
                  <c:v>3.5469098383493241</c:v>
                </c:pt>
                <c:pt idx="2">
                  <c:v>9.6638973035116358</c:v>
                </c:pt>
                <c:pt idx="3">
                  <c:v>17.846476044083275</c:v>
                </c:pt>
                <c:pt idx="4">
                  <c:v>1.293784105887622</c:v>
                </c:pt>
                <c:pt idx="5">
                  <c:v>14.388401505666009</c:v>
                </c:pt>
                <c:pt idx="6">
                  <c:v>1.0120314725581887</c:v>
                </c:pt>
                <c:pt idx="7">
                  <c:v>6.7904900602672642</c:v>
                </c:pt>
                <c:pt idx="8">
                  <c:v>1.3231177837379409</c:v>
                </c:pt>
                <c:pt idx="9">
                  <c:v>6.8582471734003407</c:v>
                </c:pt>
                <c:pt idx="10">
                  <c:v>1.6479830954669217</c:v>
                </c:pt>
                <c:pt idx="11">
                  <c:v>13.759702382985273</c:v>
                </c:pt>
                <c:pt idx="12">
                  <c:v>1.502233113381725</c:v>
                </c:pt>
                <c:pt idx="13">
                  <c:v>3.3043106989464399</c:v>
                </c:pt>
                <c:pt idx="14">
                  <c:v>6.92824129090139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D707-4074-ACBA-C40389B6AF43}"/>
            </c:ext>
          </c:extLst>
        </c:ser>
        <c:ser>
          <c:idx val="26"/>
          <c:order val="26"/>
          <c:tx>
            <c:strRef>
              <c:f>'DHA3'!$B$30</c:f>
              <c:strCache>
                <c:ptCount val="1"/>
                <c:pt idx="0">
                  <c:v>307</c:v>
                </c:pt>
              </c:strCache>
            </c:strRef>
          </c:tx>
          <c:spPr>
            <a:solidFill>
              <a:schemeClr val="accent3">
                <a:shade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30:$Q$30</c:f>
              <c:numCache>
                <c:formatCode>General</c:formatCode>
                <c:ptCount val="15"/>
                <c:pt idx="0">
                  <c:v>9.1511306399313952</c:v>
                </c:pt>
                <c:pt idx="1">
                  <c:v>3.5697105515292273</c:v>
                </c:pt>
                <c:pt idx="2">
                  <c:v>14.507946068946097</c:v>
                </c:pt>
                <c:pt idx="3">
                  <c:v>14.497261823622802</c:v>
                </c:pt>
                <c:pt idx="4">
                  <c:v>2.1692255259950781</c:v>
                </c:pt>
                <c:pt idx="5">
                  <c:v>13.679233929732343</c:v>
                </c:pt>
                <c:pt idx="6">
                  <c:v>1.7493629752308013</c:v>
                </c:pt>
                <c:pt idx="7">
                  <c:v>5.1968507871115719</c:v>
                </c:pt>
                <c:pt idx="8">
                  <c:v>0.93868090554521533</c:v>
                </c:pt>
                <c:pt idx="9">
                  <c:v>5.1304343829111776</c:v>
                </c:pt>
                <c:pt idx="10">
                  <c:v>1.1383125676161066</c:v>
                </c:pt>
                <c:pt idx="11">
                  <c:v>14.245353019649171</c:v>
                </c:pt>
                <c:pt idx="12">
                  <c:v>1.7241393205398248</c:v>
                </c:pt>
                <c:pt idx="13">
                  <c:v>3.4283427287441364</c:v>
                </c:pt>
                <c:pt idx="14">
                  <c:v>7.6826922426047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D707-4074-ACBA-C40389B6AF43}"/>
            </c:ext>
          </c:extLst>
        </c:ser>
        <c:ser>
          <c:idx val="27"/>
          <c:order val="27"/>
          <c:tx>
            <c:strRef>
              <c:f>'DHA3'!$B$31</c:f>
              <c:strCache>
                <c:ptCount val="1"/>
                <c:pt idx="0">
                  <c:v>309</c:v>
                </c:pt>
              </c:strCache>
            </c:strRef>
          </c:tx>
          <c:spPr>
            <a:solidFill>
              <a:schemeClr val="accent3">
                <a:shade val="4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31:$Q$31</c:f>
              <c:numCache>
                <c:formatCode>General</c:formatCode>
                <c:ptCount val="15"/>
                <c:pt idx="0">
                  <c:v>7.4864464315028174</c:v>
                </c:pt>
                <c:pt idx="1">
                  <c:v>3.1144350775341709</c:v>
                </c:pt>
                <c:pt idx="2">
                  <c:v>12.718296917143332</c:v>
                </c:pt>
                <c:pt idx="3">
                  <c:v>15.020319791030094</c:v>
                </c:pt>
                <c:pt idx="4">
                  <c:v>1.2344120859973031</c:v>
                </c:pt>
                <c:pt idx="5">
                  <c:v>15.395545652081294</c:v>
                </c:pt>
                <c:pt idx="6">
                  <c:v>1.2632637201898811</c:v>
                </c:pt>
                <c:pt idx="7">
                  <c:v>6.5015684620045171</c:v>
                </c:pt>
                <c:pt idx="8">
                  <c:v>0.91902251883426544</c:v>
                </c:pt>
                <c:pt idx="9">
                  <c:v>5.0478444022943165</c:v>
                </c:pt>
                <c:pt idx="10">
                  <c:v>1.8319574317872109</c:v>
                </c:pt>
                <c:pt idx="11">
                  <c:v>14.754799065754629</c:v>
                </c:pt>
                <c:pt idx="12">
                  <c:v>2.2438588096319374</c:v>
                </c:pt>
                <c:pt idx="13">
                  <c:v>3.5907097717142453</c:v>
                </c:pt>
                <c:pt idx="14">
                  <c:v>8.26780509108400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D707-4074-ACBA-C40389B6AF43}"/>
            </c:ext>
          </c:extLst>
        </c:ser>
        <c:ser>
          <c:idx val="28"/>
          <c:order val="28"/>
          <c:tx>
            <c:strRef>
              <c:f>'DHA3'!$B$32</c:f>
              <c:strCache>
                <c:ptCount val="1"/>
                <c:pt idx="0">
                  <c:v>314</c:v>
                </c:pt>
              </c:strCache>
            </c:strRef>
          </c:tx>
          <c:spPr>
            <a:solidFill>
              <a:schemeClr val="accent3">
                <a:shade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32:$Q$32</c:f>
              <c:numCache>
                <c:formatCode>General</c:formatCode>
                <c:ptCount val="15"/>
                <c:pt idx="0">
                  <c:v>8.5895828061349597</c:v>
                </c:pt>
                <c:pt idx="1">
                  <c:v>4.1866590823453631</c:v>
                </c:pt>
                <c:pt idx="2">
                  <c:v>14.883685360676004</c:v>
                </c:pt>
                <c:pt idx="3">
                  <c:v>15.124113391637916</c:v>
                </c:pt>
                <c:pt idx="4">
                  <c:v>1.7370832145001189</c:v>
                </c:pt>
                <c:pt idx="5">
                  <c:v>9.7933783361204636</c:v>
                </c:pt>
                <c:pt idx="6">
                  <c:v>1.4115117571094513</c:v>
                </c:pt>
                <c:pt idx="7">
                  <c:v>5.8447168321195884</c:v>
                </c:pt>
                <c:pt idx="8">
                  <c:v>1.8951937872895444</c:v>
                </c:pt>
                <c:pt idx="9">
                  <c:v>5.8682490894746744</c:v>
                </c:pt>
                <c:pt idx="10">
                  <c:v>2.0335438735437732</c:v>
                </c:pt>
                <c:pt idx="11">
                  <c:v>12.527292227304518</c:v>
                </c:pt>
                <c:pt idx="12">
                  <c:v>1.7090294596079876</c:v>
                </c:pt>
                <c:pt idx="13">
                  <c:v>3.7014581319126014</c:v>
                </c:pt>
                <c:pt idx="14">
                  <c:v>9.91537415327548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D707-4074-ACBA-C40389B6AF43}"/>
            </c:ext>
          </c:extLst>
        </c:ser>
        <c:ser>
          <c:idx val="29"/>
          <c:order val="29"/>
          <c:tx>
            <c:strRef>
              <c:f>'DHA3'!$B$33</c:f>
              <c:strCache>
                <c:ptCount val="1"/>
                <c:pt idx="0">
                  <c:v>305</c:v>
                </c:pt>
              </c:strCache>
            </c:strRef>
          </c:tx>
          <c:spPr>
            <a:solidFill>
              <a:schemeClr val="accent3">
                <a:shade val="3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3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3'!$C$33:$Q$33</c:f>
              <c:numCache>
                <c:formatCode>General</c:formatCode>
                <c:ptCount val="15"/>
                <c:pt idx="0">
                  <c:v>7.9842711963320472</c:v>
                </c:pt>
                <c:pt idx="1">
                  <c:v>3.9110373569442016</c:v>
                </c:pt>
                <c:pt idx="2">
                  <c:v>14.099158636594046</c:v>
                </c:pt>
                <c:pt idx="3">
                  <c:v>14.189444034412739</c:v>
                </c:pt>
                <c:pt idx="4">
                  <c:v>1.7160480607208832</c:v>
                </c:pt>
                <c:pt idx="5">
                  <c:v>12.669558139675932</c:v>
                </c:pt>
                <c:pt idx="6">
                  <c:v>1.6363351499366237</c:v>
                </c:pt>
                <c:pt idx="7">
                  <c:v>6.2843050113206962</c:v>
                </c:pt>
                <c:pt idx="8">
                  <c:v>1.3974183063144612</c:v>
                </c:pt>
                <c:pt idx="9">
                  <c:v>5.4561507632843327</c:v>
                </c:pt>
                <c:pt idx="10">
                  <c:v>1.2957996876301334</c:v>
                </c:pt>
                <c:pt idx="11">
                  <c:v>13.373191549483776</c:v>
                </c:pt>
                <c:pt idx="12">
                  <c:v>1.9876707038204429</c:v>
                </c:pt>
                <c:pt idx="13">
                  <c:v>4.056075352066344</c:v>
                </c:pt>
                <c:pt idx="14">
                  <c:v>7.9837975710636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D707-4074-ACBA-C40389B6AF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310096104"/>
        <c:axId val="1310089216"/>
      </c:barChart>
      <c:catAx>
        <c:axId val="1310096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0089216"/>
        <c:crosses val="autoZero"/>
        <c:auto val="1"/>
        <c:lblAlgn val="ctr"/>
        <c:lblOffset val="100"/>
        <c:noMultiLvlLbl val="0"/>
      </c:catAx>
      <c:valAx>
        <c:axId val="1310089216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/>
                  <a:t>FAMEs (mol%)</a:t>
                </a:r>
              </a:p>
            </c:rich>
          </c:tx>
          <c:layout>
            <c:manualLayout>
              <c:xMode val="edge"/>
              <c:yMode val="edge"/>
              <c:x val="2.8140402489980381E-2"/>
              <c:y val="0.125101045548812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00961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041997100707769"/>
          <c:y val="0.8768702985849941"/>
          <c:w val="0.85388296035720068"/>
          <c:h val="0.114131459695162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 dirty="0"/>
              <a:t>DHA2015.5</a:t>
            </a:r>
          </a:p>
        </c:rich>
      </c:tx>
      <c:layout>
        <c:manualLayout>
          <c:xMode val="edge"/>
          <c:yMode val="edge"/>
          <c:x val="0.43350814360023882"/>
          <c:y val="3.57585174445337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548381452318461"/>
          <c:y val="2.8194444444444459E-2"/>
          <c:w val="0.84396062992125986"/>
          <c:h val="0.65651532106947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HA5'!$B$4</c:f>
              <c:strCache>
                <c:ptCount val="1"/>
                <c:pt idx="0">
                  <c:v>D5.17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4:$Q$4</c:f>
              <c:numCache>
                <c:formatCode>General</c:formatCode>
                <c:ptCount val="15"/>
                <c:pt idx="0">
                  <c:v>8.2970916239670149</c:v>
                </c:pt>
                <c:pt idx="1">
                  <c:v>6.2625564196565486</c:v>
                </c:pt>
                <c:pt idx="2">
                  <c:v>5.8810049903600365</c:v>
                </c:pt>
                <c:pt idx="3">
                  <c:v>22.74476063456606</c:v>
                </c:pt>
                <c:pt idx="4">
                  <c:v>1.6795787857978801</c:v>
                </c:pt>
                <c:pt idx="5">
                  <c:v>18.46010272860465</c:v>
                </c:pt>
                <c:pt idx="6">
                  <c:v>1.5263409826013588</c:v>
                </c:pt>
                <c:pt idx="7">
                  <c:v>4.4790660865830736</c:v>
                </c:pt>
                <c:pt idx="8">
                  <c:v>0.41755332517910615</c:v>
                </c:pt>
                <c:pt idx="9">
                  <c:v>2.3234673796595064</c:v>
                </c:pt>
                <c:pt idx="10">
                  <c:v>1.7875488834166191</c:v>
                </c:pt>
                <c:pt idx="11">
                  <c:v>8.2496152852711511</c:v>
                </c:pt>
                <c:pt idx="12">
                  <c:v>3.5016873193162477</c:v>
                </c:pt>
                <c:pt idx="13">
                  <c:v>4.9144596212665528</c:v>
                </c:pt>
                <c:pt idx="14">
                  <c:v>8.14210653172444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9B-4168-92EB-30E74E1DA4E6}"/>
            </c:ext>
          </c:extLst>
        </c:ser>
        <c:ser>
          <c:idx val="1"/>
          <c:order val="1"/>
          <c:tx>
            <c:strRef>
              <c:f>'DHA5'!$B$5</c:f>
              <c:strCache>
                <c:ptCount val="1"/>
                <c:pt idx="0">
                  <c:v>D5.16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5:$Q$5</c:f>
              <c:numCache>
                <c:formatCode>General</c:formatCode>
                <c:ptCount val="15"/>
                <c:pt idx="0">
                  <c:v>7.9211689875839886</c:v>
                </c:pt>
                <c:pt idx="1">
                  <c:v>3.9242695776546728</c:v>
                </c:pt>
                <c:pt idx="2">
                  <c:v>5.066364411041425</c:v>
                </c:pt>
                <c:pt idx="3">
                  <c:v>23.974538932804954</c:v>
                </c:pt>
                <c:pt idx="4">
                  <c:v>1.8436928173193416</c:v>
                </c:pt>
                <c:pt idx="5">
                  <c:v>18.548200177777435</c:v>
                </c:pt>
                <c:pt idx="6">
                  <c:v>1.5156939799076765</c:v>
                </c:pt>
                <c:pt idx="7">
                  <c:v>5.480030794959081</c:v>
                </c:pt>
                <c:pt idx="8">
                  <c:v>0.57833373005662791</c:v>
                </c:pt>
                <c:pt idx="9">
                  <c:v>2.4687014169273067</c:v>
                </c:pt>
                <c:pt idx="10">
                  <c:v>1.9772410187086329</c:v>
                </c:pt>
                <c:pt idx="11">
                  <c:v>8.1792782225905061</c:v>
                </c:pt>
                <c:pt idx="12">
                  <c:v>4.0843273774892221</c:v>
                </c:pt>
                <c:pt idx="13">
                  <c:v>5.4114074716072054</c:v>
                </c:pt>
                <c:pt idx="14">
                  <c:v>8.6336402207315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9B-4168-92EB-30E74E1DA4E6}"/>
            </c:ext>
          </c:extLst>
        </c:ser>
        <c:ser>
          <c:idx val="2"/>
          <c:order val="2"/>
          <c:tx>
            <c:strRef>
              <c:f>'DHA5'!$B$6</c:f>
              <c:strCache>
                <c:ptCount val="1"/>
                <c:pt idx="0">
                  <c:v>D5.11</c:v>
                </c:pt>
              </c:strCache>
            </c:strRef>
          </c:tx>
          <c:spPr>
            <a:solidFill>
              <a:schemeClr val="accent3">
                <a:tint val="4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6:$Q$6</c:f>
              <c:numCache>
                <c:formatCode>General</c:formatCode>
                <c:ptCount val="15"/>
                <c:pt idx="0">
                  <c:v>8.868108881564627</c:v>
                </c:pt>
                <c:pt idx="1">
                  <c:v>5.1292297211258679</c:v>
                </c:pt>
                <c:pt idx="2">
                  <c:v>4.8982157048465051</c:v>
                </c:pt>
                <c:pt idx="3">
                  <c:v>21.88346319361111</c:v>
                </c:pt>
                <c:pt idx="4">
                  <c:v>2.2411468168772579</c:v>
                </c:pt>
                <c:pt idx="5">
                  <c:v>18.326058747793503</c:v>
                </c:pt>
                <c:pt idx="6">
                  <c:v>1.8984320044434346</c:v>
                </c:pt>
                <c:pt idx="7">
                  <c:v>4.1657335509656832</c:v>
                </c:pt>
                <c:pt idx="8">
                  <c:v>0.43767685007457491</c:v>
                </c:pt>
                <c:pt idx="9">
                  <c:v>2.5779034626218573</c:v>
                </c:pt>
                <c:pt idx="10">
                  <c:v>1.7547024576969326</c:v>
                </c:pt>
                <c:pt idx="11">
                  <c:v>9.506489583282935</c:v>
                </c:pt>
                <c:pt idx="12">
                  <c:v>4.0669667488595458</c:v>
                </c:pt>
                <c:pt idx="13">
                  <c:v>5.8644218697423902</c:v>
                </c:pt>
                <c:pt idx="14">
                  <c:v>7.7372917646147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B9B-4168-92EB-30E74E1DA4E6}"/>
            </c:ext>
          </c:extLst>
        </c:ser>
        <c:ser>
          <c:idx val="3"/>
          <c:order val="3"/>
          <c:tx>
            <c:strRef>
              <c:f>'DHA5'!$B$7</c:f>
              <c:strCache>
                <c:ptCount val="1"/>
                <c:pt idx="0">
                  <c:v>D5.25</c:v>
                </c:pt>
              </c:strCache>
            </c:strRef>
          </c:tx>
          <c:spPr>
            <a:solidFill>
              <a:schemeClr val="accent3">
                <a:tint val="4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7:$Q$7</c:f>
              <c:numCache>
                <c:formatCode>General</c:formatCode>
                <c:ptCount val="15"/>
                <c:pt idx="0">
                  <c:v>7.0813823861999996</c:v>
                </c:pt>
                <c:pt idx="1">
                  <c:v>5.9278027208848245</c:v>
                </c:pt>
                <c:pt idx="2">
                  <c:v>5.4757126939142626</c:v>
                </c:pt>
                <c:pt idx="3">
                  <c:v>21.021430497308891</c:v>
                </c:pt>
                <c:pt idx="4">
                  <c:v>1.7563492773513871</c:v>
                </c:pt>
                <c:pt idx="5">
                  <c:v>18.477983405977955</c:v>
                </c:pt>
                <c:pt idx="6">
                  <c:v>1.6187123434821662</c:v>
                </c:pt>
                <c:pt idx="7">
                  <c:v>4.3105539639292676</c:v>
                </c:pt>
                <c:pt idx="8">
                  <c:v>0.41311868786675054</c:v>
                </c:pt>
                <c:pt idx="9">
                  <c:v>2.4055288814147273</c:v>
                </c:pt>
                <c:pt idx="10">
                  <c:v>1.8455599407542416</c:v>
                </c:pt>
                <c:pt idx="11">
                  <c:v>9.8291259409899272</c:v>
                </c:pt>
                <c:pt idx="12">
                  <c:v>4.8876080967326203</c:v>
                </c:pt>
                <c:pt idx="13">
                  <c:v>5.969532890856323</c:v>
                </c:pt>
                <c:pt idx="14">
                  <c:v>8.4986447474622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B9B-4168-92EB-30E74E1DA4E6}"/>
            </c:ext>
          </c:extLst>
        </c:ser>
        <c:ser>
          <c:idx val="4"/>
          <c:order val="4"/>
          <c:tx>
            <c:strRef>
              <c:f>'DHA5'!$B$8</c:f>
              <c:strCache>
                <c:ptCount val="1"/>
                <c:pt idx="0">
                  <c:v>D5.28</c:v>
                </c:pt>
              </c:strCache>
            </c:strRef>
          </c:tx>
          <c:spPr>
            <a:solidFill>
              <a:schemeClr val="accent3">
                <a:tint val="5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8:$Q$8</c:f>
              <c:numCache>
                <c:formatCode>General</c:formatCode>
                <c:ptCount val="15"/>
                <c:pt idx="0">
                  <c:v>8.9007480608707947</c:v>
                </c:pt>
                <c:pt idx="1">
                  <c:v>4.4241065365548469</c:v>
                </c:pt>
                <c:pt idx="2">
                  <c:v>4.94971425746993</c:v>
                </c:pt>
                <c:pt idx="3">
                  <c:v>23.84415825513117</c:v>
                </c:pt>
                <c:pt idx="4">
                  <c:v>2.4554103202352207</c:v>
                </c:pt>
                <c:pt idx="5">
                  <c:v>15.652175404331647</c:v>
                </c:pt>
                <c:pt idx="6">
                  <c:v>1.7527240380041529</c:v>
                </c:pt>
                <c:pt idx="7">
                  <c:v>4.2170691783079883</c:v>
                </c:pt>
                <c:pt idx="8">
                  <c:v>0.51423504892021288</c:v>
                </c:pt>
                <c:pt idx="9">
                  <c:v>3.5496769872912761</c:v>
                </c:pt>
                <c:pt idx="10">
                  <c:v>1.5792428826099072</c:v>
                </c:pt>
                <c:pt idx="11">
                  <c:v>9.7519137681656858</c:v>
                </c:pt>
                <c:pt idx="12">
                  <c:v>4.0603925044556242</c:v>
                </c:pt>
                <c:pt idx="13">
                  <c:v>6.0109314738481574</c:v>
                </c:pt>
                <c:pt idx="14">
                  <c:v>7.8945217874712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B9B-4168-92EB-30E74E1DA4E6}"/>
            </c:ext>
          </c:extLst>
        </c:ser>
        <c:ser>
          <c:idx val="5"/>
          <c:order val="5"/>
          <c:tx>
            <c:strRef>
              <c:f>'DHA5'!$B$9</c:f>
              <c:strCache>
                <c:ptCount val="1"/>
                <c:pt idx="0">
                  <c:v>D5.26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9:$Q$9</c:f>
              <c:numCache>
                <c:formatCode>General</c:formatCode>
                <c:ptCount val="15"/>
                <c:pt idx="0">
                  <c:v>7.9364922673319809</c:v>
                </c:pt>
                <c:pt idx="1">
                  <c:v>4.1107912418280277</c:v>
                </c:pt>
                <c:pt idx="2">
                  <c:v>5.6386566644204734</c:v>
                </c:pt>
                <c:pt idx="3">
                  <c:v>22.121203669211958</c:v>
                </c:pt>
                <c:pt idx="4">
                  <c:v>1.8967501939416713</c:v>
                </c:pt>
                <c:pt idx="5">
                  <c:v>19.043617828895645</c:v>
                </c:pt>
                <c:pt idx="6">
                  <c:v>1.9022885666692813</c:v>
                </c:pt>
                <c:pt idx="7">
                  <c:v>4.3306261185951884</c:v>
                </c:pt>
                <c:pt idx="8">
                  <c:v>0.50350804019148399</c:v>
                </c:pt>
                <c:pt idx="9">
                  <c:v>2.8903186500013698</c:v>
                </c:pt>
                <c:pt idx="10">
                  <c:v>1.9484737446391598</c:v>
                </c:pt>
                <c:pt idx="11">
                  <c:v>9.3559256780557707</c:v>
                </c:pt>
                <c:pt idx="12">
                  <c:v>3.8706934421679278</c:v>
                </c:pt>
                <c:pt idx="13">
                  <c:v>6.3832730071253634</c:v>
                </c:pt>
                <c:pt idx="14">
                  <c:v>6.53388356987891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B9B-4168-92EB-30E74E1DA4E6}"/>
            </c:ext>
          </c:extLst>
        </c:ser>
        <c:ser>
          <c:idx val="6"/>
          <c:order val="6"/>
          <c:tx>
            <c:strRef>
              <c:f>'DHA5'!$B$10</c:f>
              <c:strCache>
                <c:ptCount val="1"/>
                <c:pt idx="0">
                  <c:v>D5.19</c:v>
                </c:pt>
              </c:strCache>
            </c:strRef>
          </c:tx>
          <c:spPr>
            <a:solidFill>
              <a:schemeClr val="accent3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0:$Q$10</c:f>
              <c:numCache>
                <c:formatCode>General</c:formatCode>
                <c:ptCount val="15"/>
                <c:pt idx="0">
                  <c:v>9.5608408770966555</c:v>
                </c:pt>
                <c:pt idx="1">
                  <c:v>3.5214632195852031</c:v>
                </c:pt>
                <c:pt idx="2">
                  <c:v>4.9473768561233129</c:v>
                </c:pt>
                <c:pt idx="3">
                  <c:v>22.707878742187187</c:v>
                </c:pt>
                <c:pt idx="4">
                  <c:v>1.990722195208033</c:v>
                </c:pt>
                <c:pt idx="5">
                  <c:v>17.349363633946258</c:v>
                </c:pt>
                <c:pt idx="6">
                  <c:v>1.8622515814142602</c:v>
                </c:pt>
                <c:pt idx="7">
                  <c:v>3.5811531878919367</c:v>
                </c:pt>
                <c:pt idx="8">
                  <c:v>0.41760459321950782</c:v>
                </c:pt>
                <c:pt idx="9">
                  <c:v>3.4290748579563779</c:v>
                </c:pt>
                <c:pt idx="10">
                  <c:v>1.5386921200915489</c:v>
                </c:pt>
                <c:pt idx="11">
                  <c:v>10.2244419389723</c:v>
                </c:pt>
                <c:pt idx="12">
                  <c:v>4.1286502709977473</c:v>
                </c:pt>
                <c:pt idx="13">
                  <c:v>6.5050043389736052</c:v>
                </c:pt>
                <c:pt idx="14">
                  <c:v>7.4332307686714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B9B-4168-92EB-30E74E1DA4E6}"/>
            </c:ext>
          </c:extLst>
        </c:ser>
        <c:ser>
          <c:idx val="7"/>
          <c:order val="7"/>
          <c:tx>
            <c:strRef>
              <c:f>'DHA5'!$B$11</c:f>
              <c:strCache>
                <c:ptCount val="1"/>
                <c:pt idx="0">
                  <c:v>D5.18</c:v>
                </c:pt>
              </c:strCache>
            </c:strRef>
          </c:tx>
          <c:spPr>
            <a:solidFill>
              <a:schemeClr val="accent3">
                <a:tint val="6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1:$Q$11</c:f>
              <c:numCache>
                <c:formatCode>General</c:formatCode>
                <c:ptCount val="15"/>
                <c:pt idx="0">
                  <c:v>9.024858369355826</c:v>
                </c:pt>
                <c:pt idx="1">
                  <c:v>4.5746157494446322</c:v>
                </c:pt>
                <c:pt idx="2">
                  <c:v>5.0860666851190208</c:v>
                </c:pt>
                <c:pt idx="3">
                  <c:v>20.352175979866672</c:v>
                </c:pt>
                <c:pt idx="4">
                  <c:v>2.0004806056441486</c:v>
                </c:pt>
                <c:pt idx="5">
                  <c:v>19.025061159835406</c:v>
                </c:pt>
                <c:pt idx="6">
                  <c:v>1.999497638382445</c:v>
                </c:pt>
                <c:pt idx="7">
                  <c:v>4.4155359925306579</c:v>
                </c:pt>
                <c:pt idx="8">
                  <c:v>0.43156026831196109</c:v>
                </c:pt>
                <c:pt idx="9">
                  <c:v>2.4443520735346165</c:v>
                </c:pt>
                <c:pt idx="10">
                  <c:v>1.9850509968941275</c:v>
                </c:pt>
                <c:pt idx="11">
                  <c:v>9.3151027636129768</c:v>
                </c:pt>
                <c:pt idx="12">
                  <c:v>4.1948241732224032</c:v>
                </c:pt>
                <c:pt idx="13">
                  <c:v>6.6867982805757169</c:v>
                </c:pt>
                <c:pt idx="14">
                  <c:v>6.9407568126512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B9B-4168-92EB-30E74E1DA4E6}"/>
            </c:ext>
          </c:extLst>
        </c:ser>
        <c:ser>
          <c:idx val="8"/>
          <c:order val="8"/>
          <c:tx>
            <c:strRef>
              <c:f>'DHA5'!$B$12</c:f>
              <c:strCache>
                <c:ptCount val="1"/>
                <c:pt idx="0">
                  <c:v>D5.22</c:v>
                </c:pt>
              </c:strCache>
            </c:strRef>
          </c:tx>
          <c:spPr>
            <a:solidFill>
              <a:schemeClr val="accent3">
                <a:tint val="7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2:$Q$12</c:f>
              <c:numCache>
                <c:formatCode>General</c:formatCode>
                <c:ptCount val="15"/>
                <c:pt idx="0">
                  <c:v>8.5419204813962732</c:v>
                </c:pt>
                <c:pt idx="1">
                  <c:v>3.9690797762664194</c:v>
                </c:pt>
                <c:pt idx="2">
                  <c:v>4.1864689522768161</c:v>
                </c:pt>
                <c:pt idx="3">
                  <c:v>20.626614619905634</c:v>
                </c:pt>
                <c:pt idx="4">
                  <c:v>2.2289678346523174</c:v>
                </c:pt>
                <c:pt idx="5">
                  <c:v>19.20584008152419</c:v>
                </c:pt>
                <c:pt idx="6">
                  <c:v>2.0166351903872521</c:v>
                </c:pt>
                <c:pt idx="7">
                  <c:v>3.5928178904548442</c:v>
                </c:pt>
                <c:pt idx="8">
                  <c:v>0.47438632915090095</c:v>
                </c:pt>
                <c:pt idx="9">
                  <c:v>2.6380460085193449</c:v>
                </c:pt>
                <c:pt idx="10">
                  <c:v>1.9404880112800118</c:v>
                </c:pt>
                <c:pt idx="11">
                  <c:v>10.909568825955848</c:v>
                </c:pt>
                <c:pt idx="12">
                  <c:v>4.4353611876591792</c:v>
                </c:pt>
                <c:pt idx="13">
                  <c:v>6.7120776753053857</c:v>
                </c:pt>
                <c:pt idx="14">
                  <c:v>7.8426036874108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B9B-4168-92EB-30E74E1DA4E6}"/>
            </c:ext>
          </c:extLst>
        </c:ser>
        <c:ser>
          <c:idx val="9"/>
          <c:order val="9"/>
          <c:tx>
            <c:strRef>
              <c:f>'DHA5'!$B$13</c:f>
              <c:strCache>
                <c:ptCount val="1"/>
                <c:pt idx="0">
                  <c:v>D5.21</c:v>
                </c:pt>
              </c:strCache>
            </c:strRef>
          </c:tx>
          <c:spPr>
            <a:solidFill>
              <a:schemeClr val="accent3">
                <a:tint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3:$Q$13</c:f>
              <c:numCache>
                <c:formatCode>General</c:formatCode>
                <c:ptCount val="15"/>
                <c:pt idx="0">
                  <c:v>8.8310767170175577</c:v>
                </c:pt>
                <c:pt idx="1">
                  <c:v>4.2809332545329619</c:v>
                </c:pt>
                <c:pt idx="2">
                  <c:v>5.3636283170003791</c:v>
                </c:pt>
                <c:pt idx="3">
                  <c:v>22.934307723484341</c:v>
                </c:pt>
                <c:pt idx="4">
                  <c:v>2.0613466592518135</c:v>
                </c:pt>
                <c:pt idx="5">
                  <c:v>15.820079701093873</c:v>
                </c:pt>
                <c:pt idx="6">
                  <c:v>1.7691276523459438</c:v>
                </c:pt>
                <c:pt idx="7">
                  <c:v>4.2698620955329716</c:v>
                </c:pt>
                <c:pt idx="8">
                  <c:v>0.50322814659249526</c:v>
                </c:pt>
                <c:pt idx="9">
                  <c:v>3.0678347042801715</c:v>
                </c:pt>
                <c:pt idx="10">
                  <c:v>1.8856586795598171</c:v>
                </c:pt>
                <c:pt idx="11">
                  <c:v>9.2680762808521475</c:v>
                </c:pt>
                <c:pt idx="12">
                  <c:v>4.2881363827740442</c:v>
                </c:pt>
                <c:pt idx="13">
                  <c:v>6.7912926254643899</c:v>
                </c:pt>
                <c:pt idx="14">
                  <c:v>7.6983162369492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AB9B-4168-92EB-30E74E1DA4E6}"/>
            </c:ext>
          </c:extLst>
        </c:ser>
        <c:ser>
          <c:idx val="10"/>
          <c:order val="10"/>
          <c:tx>
            <c:strRef>
              <c:f>'DHA5'!$B$14</c:f>
              <c:strCache>
                <c:ptCount val="1"/>
                <c:pt idx="0">
                  <c:v>D5.06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4:$Q$14</c:f>
              <c:numCache>
                <c:formatCode>General</c:formatCode>
                <c:ptCount val="15"/>
                <c:pt idx="0">
                  <c:v>8.7868697007146501</c:v>
                </c:pt>
                <c:pt idx="1">
                  <c:v>4.1164162289715538</c:v>
                </c:pt>
                <c:pt idx="2">
                  <c:v>4.8103390791368499</c:v>
                </c:pt>
                <c:pt idx="3">
                  <c:v>18.909450042128064</c:v>
                </c:pt>
                <c:pt idx="4">
                  <c:v>1.9282205626459656</c:v>
                </c:pt>
                <c:pt idx="5">
                  <c:v>21.172944505327401</c:v>
                </c:pt>
                <c:pt idx="6">
                  <c:v>1.9873551142655843</c:v>
                </c:pt>
                <c:pt idx="7">
                  <c:v>4.3145894196908623</c:v>
                </c:pt>
                <c:pt idx="8">
                  <c:v>0.42630159818540914</c:v>
                </c:pt>
                <c:pt idx="9">
                  <c:v>2.3267478771234384</c:v>
                </c:pt>
                <c:pt idx="10">
                  <c:v>2.0310960408273147</c:v>
                </c:pt>
                <c:pt idx="11">
                  <c:v>9.410644589481489</c:v>
                </c:pt>
                <c:pt idx="12">
                  <c:v>4.3129951014075854</c:v>
                </c:pt>
                <c:pt idx="13">
                  <c:v>6.8281842610281807</c:v>
                </c:pt>
                <c:pt idx="14">
                  <c:v>7.50917923463650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B9B-4168-92EB-30E74E1DA4E6}"/>
            </c:ext>
          </c:extLst>
        </c:ser>
        <c:ser>
          <c:idx val="11"/>
          <c:order val="11"/>
          <c:tx>
            <c:strRef>
              <c:f>'DHA5'!$B$15</c:f>
              <c:strCache>
                <c:ptCount val="1"/>
                <c:pt idx="0">
                  <c:v>D5.27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5:$Q$15</c:f>
              <c:numCache>
                <c:formatCode>General</c:formatCode>
                <c:ptCount val="15"/>
                <c:pt idx="0">
                  <c:v>6.9791584833145537</c:v>
                </c:pt>
                <c:pt idx="1">
                  <c:v>3.9845520188985373</c:v>
                </c:pt>
                <c:pt idx="2">
                  <c:v>5.8282204785106266</c:v>
                </c:pt>
                <c:pt idx="3">
                  <c:v>23.219300386425111</c:v>
                </c:pt>
                <c:pt idx="4">
                  <c:v>1.8270301576520367</c:v>
                </c:pt>
                <c:pt idx="5">
                  <c:v>15.405358227300665</c:v>
                </c:pt>
                <c:pt idx="6">
                  <c:v>1.4700855234027084</c:v>
                </c:pt>
                <c:pt idx="7">
                  <c:v>5.2584952775902059</c:v>
                </c:pt>
                <c:pt idx="8">
                  <c:v>0.57479468304920056</c:v>
                </c:pt>
                <c:pt idx="9">
                  <c:v>3.5137094108213192</c:v>
                </c:pt>
                <c:pt idx="10">
                  <c:v>1.9357877830891128</c:v>
                </c:pt>
                <c:pt idx="11">
                  <c:v>9.975066373678235</c:v>
                </c:pt>
                <c:pt idx="12">
                  <c:v>5.2123818001886004</c:v>
                </c:pt>
                <c:pt idx="13">
                  <c:v>6.9302867784270905</c:v>
                </c:pt>
                <c:pt idx="14">
                  <c:v>7.06520260483534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AB9B-4168-92EB-30E74E1DA4E6}"/>
            </c:ext>
          </c:extLst>
        </c:ser>
        <c:ser>
          <c:idx val="12"/>
          <c:order val="12"/>
          <c:tx>
            <c:strRef>
              <c:f>'DHA5'!$B$16</c:f>
              <c:strCache>
                <c:ptCount val="1"/>
                <c:pt idx="0">
                  <c:v>D5.24</c:v>
                </c:pt>
              </c:strCache>
            </c:strRef>
          </c:tx>
          <c:spPr>
            <a:solidFill>
              <a:schemeClr val="accent3">
                <a:tint val="8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6:$Q$16</c:f>
              <c:numCache>
                <c:formatCode>General</c:formatCode>
                <c:ptCount val="15"/>
                <c:pt idx="0">
                  <c:v>8.9476570442174399</c:v>
                </c:pt>
                <c:pt idx="1">
                  <c:v>3.6765300816436999</c:v>
                </c:pt>
                <c:pt idx="2">
                  <c:v>4.6958192417943225</c:v>
                </c:pt>
                <c:pt idx="3">
                  <c:v>19.28274828672053</c:v>
                </c:pt>
                <c:pt idx="4">
                  <c:v>1.9028931894241163</c:v>
                </c:pt>
                <c:pt idx="5">
                  <c:v>19.928034843781386</c:v>
                </c:pt>
                <c:pt idx="6">
                  <c:v>1.9557110223160266</c:v>
                </c:pt>
                <c:pt idx="7">
                  <c:v>4.5671981058574325</c:v>
                </c:pt>
                <c:pt idx="8">
                  <c:v>0.47218382175697277</c:v>
                </c:pt>
                <c:pt idx="9">
                  <c:v>2.4756618525922467</c:v>
                </c:pt>
                <c:pt idx="10">
                  <c:v>2.2075544496237498</c:v>
                </c:pt>
                <c:pt idx="11">
                  <c:v>9.8930317920448552</c:v>
                </c:pt>
                <c:pt idx="12">
                  <c:v>4.4449470701572649</c:v>
                </c:pt>
                <c:pt idx="13">
                  <c:v>6.9588991177839192</c:v>
                </c:pt>
                <c:pt idx="14">
                  <c:v>7.1035526766580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B9B-4168-92EB-30E74E1DA4E6}"/>
            </c:ext>
          </c:extLst>
        </c:ser>
        <c:ser>
          <c:idx val="13"/>
          <c:order val="13"/>
          <c:tx>
            <c:strRef>
              <c:f>'DHA5'!$B$17</c:f>
              <c:strCache>
                <c:ptCount val="1"/>
                <c:pt idx="0">
                  <c:v>D5.10</c:v>
                </c:pt>
              </c:strCache>
            </c:strRef>
          </c:tx>
          <c:spPr>
            <a:solidFill>
              <a:schemeClr val="accent3">
                <a:tint val="9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7:$Q$17</c:f>
              <c:numCache>
                <c:formatCode>General</c:formatCode>
                <c:ptCount val="15"/>
                <c:pt idx="0">
                  <c:v>9.2480882164996707</c:v>
                </c:pt>
                <c:pt idx="1">
                  <c:v>4.0944996292270446</c:v>
                </c:pt>
                <c:pt idx="2">
                  <c:v>4.5462995255519587</c:v>
                </c:pt>
                <c:pt idx="3">
                  <c:v>20.011485742765522</c:v>
                </c:pt>
                <c:pt idx="4">
                  <c:v>2.084888965238421</c:v>
                </c:pt>
                <c:pt idx="5">
                  <c:v>17.277824548312797</c:v>
                </c:pt>
                <c:pt idx="6">
                  <c:v>2.1103878212685179</c:v>
                </c:pt>
                <c:pt idx="7">
                  <c:v>4.3312870915757919</c:v>
                </c:pt>
                <c:pt idx="8">
                  <c:v>0.4715364131448409</c:v>
                </c:pt>
                <c:pt idx="9">
                  <c:v>2.8020279802660597</c:v>
                </c:pt>
                <c:pt idx="10">
                  <c:v>2.181805347582551</c:v>
                </c:pt>
                <c:pt idx="11">
                  <c:v>10.456731597956068</c:v>
                </c:pt>
                <c:pt idx="12">
                  <c:v>4.7985982845377091</c:v>
                </c:pt>
                <c:pt idx="13">
                  <c:v>7.0102500359991975</c:v>
                </c:pt>
                <c:pt idx="14">
                  <c:v>7.86792270107612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AB9B-4168-92EB-30E74E1DA4E6}"/>
            </c:ext>
          </c:extLst>
        </c:ser>
        <c:ser>
          <c:idx val="14"/>
          <c:order val="14"/>
          <c:tx>
            <c:strRef>
              <c:f>'DHA5'!$B$18</c:f>
              <c:strCache>
                <c:ptCount val="1"/>
                <c:pt idx="0">
                  <c:v>D5.30</c:v>
                </c:pt>
              </c:strCache>
            </c:strRef>
          </c:tx>
          <c:spPr>
            <a:solidFill>
              <a:schemeClr val="accent3">
                <a:tint val="9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8:$Q$18</c:f>
              <c:numCache>
                <c:formatCode>General</c:formatCode>
                <c:ptCount val="15"/>
                <c:pt idx="0">
                  <c:v>8.1277771196487745</c:v>
                </c:pt>
                <c:pt idx="1">
                  <c:v>4.2939082438419325</c:v>
                </c:pt>
                <c:pt idx="2">
                  <c:v>4.8845305598499271</c:v>
                </c:pt>
                <c:pt idx="3">
                  <c:v>21.397175128907932</c:v>
                </c:pt>
                <c:pt idx="4">
                  <c:v>2.2798045615706957</c:v>
                </c:pt>
                <c:pt idx="5">
                  <c:v>15.839495693501922</c:v>
                </c:pt>
                <c:pt idx="6">
                  <c:v>2.1402744354853476</c:v>
                </c:pt>
                <c:pt idx="7">
                  <c:v>4.1007451476741146</c:v>
                </c:pt>
                <c:pt idx="8">
                  <c:v>0.48169494880724323</c:v>
                </c:pt>
                <c:pt idx="9">
                  <c:v>3.3817583476588693</c:v>
                </c:pt>
                <c:pt idx="10">
                  <c:v>1.8800106107960373</c:v>
                </c:pt>
                <c:pt idx="11">
                  <c:v>10.637935782008617</c:v>
                </c:pt>
                <c:pt idx="12">
                  <c:v>4.4153024066867301</c:v>
                </c:pt>
                <c:pt idx="13">
                  <c:v>7.0822150645943029</c:v>
                </c:pt>
                <c:pt idx="14">
                  <c:v>7.7351879943742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AB9B-4168-92EB-30E74E1DA4E6}"/>
            </c:ext>
          </c:extLst>
        </c:ser>
        <c:ser>
          <c:idx val="15"/>
          <c:order val="15"/>
          <c:tx>
            <c:strRef>
              <c:f>'DHA5'!$B$19</c:f>
              <c:strCache>
                <c:ptCount val="1"/>
                <c:pt idx="0">
                  <c:v>D5.09</c:v>
                </c:pt>
              </c:strCache>
            </c:strRef>
          </c:tx>
          <c:spPr>
            <a:solidFill>
              <a:schemeClr val="accent3">
                <a:shade val="9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19:$Q$19</c:f>
              <c:numCache>
                <c:formatCode>General</c:formatCode>
                <c:ptCount val="15"/>
                <c:pt idx="0">
                  <c:v>8.3367373971001193</c:v>
                </c:pt>
                <c:pt idx="1">
                  <c:v>3.7011028553054248</c:v>
                </c:pt>
                <c:pt idx="2">
                  <c:v>5.0675480215268962</c:v>
                </c:pt>
                <c:pt idx="3">
                  <c:v>22.017704453738819</c:v>
                </c:pt>
                <c:pt idx="4">
                  <c:v>2.0861418880061828</c:v>
                </c:pt>
                <c:pt idx="5">
                  <c:v>17.499514751703135</c:v>
                </c:pt>
                <c:pt idx="6">
                  <c:v>2.081163579567153</c:v>
                </c:pt>
                <c:pt idx="7">
                  <c:v>4.4773676884175373</c:v>
                </c:pt>
                <c:pt idx="8">
                  <c:v>0.38325865663226388</c:v>
                </c:pt>
                <c:pt idx="9">
                  <c:v>3.133703841716605</c:v>
                </c:pt>
                <c:pt idx="10">
                  <c:v>1.6378859630364038</c:v>
                </c:pt>
                <c:pt idx="11">
                  <c:v>9.8206760396984585</c:v>
                </c:pt>
                <c:pt idx="12">
                  <c:v>4.5180771172125551</c:v>
                </c:pt>
                <c:pt idx="13">
                  <c:v>7.1322718468142181</c:v>
                </c:pt>
                <c:pt idx="14">
                  <c:v>7.4071974204902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AB9B-4168-92EB-30E74E1DA4E6}"/>
            </c:ext>
          </c:extLst>
        </c:ser>
        <c:ser>
          <c:idx val="16"/>
          <c:order val="16"/>
          <c:tx>
            <c:strRef>
              <c:f>'DHA5'!$B$20</c:f>
              <c:strCache>
                <c:ptCount val="1"/>
                <c:pt idx="0">
                  <c:v>D5.05</c:v>
                </c:pt>
              </c:strCache>
            </c:strRef>
          </c:tx>
          <c:spPr>
            <a:solidFill>
              <a:schemeClr val="accent3">
                <a:shade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0:$Q$20</c:f>
              <c:numCache>
                <c:formatCode>General</c:formatCode>
                <c:ptCount val="15"/>
                <c:pt idx="0">
                  <c:v>8.6966616888434096</c:v>
                </c:pt>
                <c:pt idx="1">
                  <c:v>4.2377252077721668</c:v>
                </c:pt>
                <c:pt idx="2">
                  <c:v>5.2227271613798427</c:v>
                </c:pt>
                <c:pt idx="3">
                  <c:v>21.045765193610471</c:v>
                </c:pt>
                <c:pt idx="4">
                  <c:v>2.1879172931747823</c:v>
                </c:pt>
                <c:pt idx="5">
                  <c:v>15.787895668156411</c:v>
                </c:pt>
                <c:pt idx="6">
                  <c:v>1.8885991135654792</c:v>
                </c:pt>
                <c:pt idx="7">
                  <c:v>3.8946716726816244</c:v>
                </c:pt>
                <c:pt idx="8">
                  <c:v>0.43896854469177621</c:v>
                </c:pt>
                <c:pt idx="9">
                  <c:v>3.1166985131286444</c:v>
                </c:pt>
                <c:pt idx="10">
                  <c:v>1.887460060201654</c:v>
                </c:pt>
                <c:pt idx="11">
                  <c:v>11.17859564834836</c:v>
                </c:pt>
                <c:pt idx="12">
                  <c:v>4.5483047235502942</c:v>
                </c:pt>
                <c:pt idx="13">
                  <c:v>7.1674049404521867</c:v>
                </c:pt>
                <c:pt idx="14">
                  <c:v>7.7101134411037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B9B-4168-92EB-30E74E1DA4E6}"/>
            </c:ext>
          </c:extLst>
        </c:ser>
        <c:ser>
          <c:idx val="17"/>
          <c:order val="17"/>
          <c:tx>
            <c:strRef>
              <c:f>'DHA5'!$B$21</c:f>
              <c:strCache>
                <c:ptCount val="1"/>
                <c:pt idx="0">
                  <c:v>D5.15</c:v>
                </c:pt>
              </c:strCache>
            </c:strRef>
          </c:tx>
          <c:spPr>
            <a:solidFill>
              <a:schemeClr val="accent3">
                <a:shade val="8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1:$Q$21</c:f>
              <c:numCache>
                <c:formatCode>General</c:formatCode>
                <c:ptCount val="15"/>
                <c:pt idx="0">
                  <c:v>9.1089587455211287</c:v>
                </c:pt>
                <c:pt idx="1">
                  <c:v>4.0942148748720957</c:v>
                </c:pt>
                <c:pt idx="2">
                  <c:v>4.8483428384289864</c:v>
                </c:pt>
                <c:pt idx="3">
                  <c:v>22.069312064856263</c:v>
                </c:pt>
                <c:pt idx="4">
                  <c:v>2.2330351097672416</c:v>
                </c:pt>
                <c:pt idx="5">
                  <c:v>16.444931267873066</c:v>
                </c:pt>
                <c:pt idx="6">
                  <c:v>2.1251500025974641</c:v>
                </c:pt>
                <c:pt idx="7">
                  <c:v>3.7686254792754958</c:v>
                </c:pt>
                <c:pt idx="8">
                  <c:v>0.49492146648427621</c:v>
                </c:pt>
                <c:pt idx="9">
                  <c:v>3.0369405546847608</c:v>
                </c:pt>
                <c:pt idx="10">
                  <c:v>1.9684925618641671</c:v>
                </c:pt>
                <c:pt idx="11">
                  <c:v>9.8038260904570169</c:v>
                </c:pt>
                <c:pt idx="12">
                  <c:v>3.9814908052435038</c:v>
                </c:pt>
                <c:pt idx="13">
                  <c:v>7.2688472209072641</c:v>
                </c:pt>
                <c:pt idx="14">
                  <c:v>7.344691592400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AB9B-4168-92EB-30E74E1DA4E6}"/>
            </c:ext>
          </c:extLst>
        </c:ser>
        <c:ser>
          <c:idx val="18"/>
          <c:order val="18"/>
          <c:tx>
            <c:strRef>
              <c:f>'DHA5'!$B$22</c:f>
              <c:strCache>
                <c:ptCount val="1"/>
                <c:pt idx="0">
                  <c:v>D5.03</c:v>
                </c:pt>
              </c:strCache>
            </c:strRef>
          </c:tx>
          <c:spPr>
            <a:solidFill>
              <a:schemeClr val="accent3">
                <a:shade val="8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2:$Q$22</c:f>
              <c:numCache>
                <c:formatCode>General</c:formatCode>
                <c:ptCount val="15"/>
                <c:pt idx="0">
                  <c:v>7.5161647002312666</c:v>
                </c:pt>
                <c:pt idx="1">
                  <c:v>4.0624916042068744</c:v>
                </c:pt>
                <c:pt idx="2">
                  <c:v>4.5329286199680645</c:v>
                </c:pt>
                <c:pt idx="3">
                  <c:v>22.362365883151497</c:v>
                </c:pt>
                <c:pt idx="4">
                  <c:v>2.0484176121975848</c:v>
                </c:pt>
                <c:pt idx="5">
                  <c:v>16.088924297272097</c:v>
                </c:pt>
                <c:pt idx="6">
                  <c:v>1.8452835122618403</c:v>
                </c:pt>
                <c:pt idx="7">
                  <c:v>3.8337849935787607</c:v>
                </c:pt>
                <c:pt idx="8">
                  <c:v>0.50612896826502018</c:v>
                </c:pt>
                <c:pt idx="9">
                  <c:v>3.3809927014894692</c:v>
                </c:pt>
                <c:pt idx="10">
                  <c:v>1.8144018185644288</c:v>
                </c:pt>
                <c:pt idx="11">
                  <c:v>11.044522130857979</c:v>
                </c:pt>
                <c:pt idx="12">
                  <c:v>5.1380698757764351</c:v>
                </c:pt>
                <c:pt idx="13">
                  <c:v>7.3279821993232579</c:v>
                </c:pt>
                <c:pt idx="14">
                  <c:v>7.96846309073233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AB9B-4168-92EB-30E74E1DA4E6}"/>
            </c:ext>
          </c:extLst>
        </c:ser>
        <c:ser>
          <c:idx val="19"/>
          <c:order val="19"/>
          <c:tx>
            <c:strRef>
              <c:f>'DHA5'!$B$23</c:f>
              <c:strCache>
                <c:ptCount val="1"/>
                <c:pt idx="0">
                  <c:v>D5.12</c:v>
                </c:pt>
              </c:strCache>
            </c:strRef>
          </c:tx>
          <c:spPr>
            <a:solidFill>
              <a:schemeClr val="accent3">
                <a:shade val="7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3:$Q$23</c:f>
              <c:numCache>
                <c:formatCode>General</c:formatCode>
                <c:ptCount val="15"/>
                <c:pt idx="0">
                  <c:v>8.8865672428050804</c:v>
                </c:pt>
                <c:pt idx="1">
                  <c:v>3.886463359282196</c:v>
                </c:pt>
                <c:pt idx="2">
                  <c:v>5.3203745041269528</c:v>
                </c:pt>
                <c:pt idx="3">
                  <c:v>24.166313756881173</c:v>
                </c:pt>
                <c:pt idx="4">
                  <c:v>0.12677731738869213</c:v>
                </c:pt>
                <c:pt idx="5">
                  <c:v>16.230409641536113</c:v>
                </c:pt>
                <c:pt idx="6">
                  <c:v>1.5590335711494492</c:v>
                </c:pt>
                <c:pt idx="7">
                  <c:v>4.5662592753031364</c:v>
                </c:pt>
                <c:pt idx="8">
                  <c:v>0.50800582193545096</c:v>
                </c:pt>
                <c:pt idx="9">
                  <c:v>3.3833022885026827</c:v>
                </c:pt>
                <c:pt idx="10">
                  <c:v>1.965011781735847</c:v>
                </c:pt>
                <c:pt idx="11">
                  <c:v>9.915268090050553</c:v>
                </c:pt>
                <c:pt idx="12">
                  <c:v>4.8446585915105782</c:v>
                </c:pt>
                <c:pt idx="13">
                  <c:v>7.4847844913553843</c:v>
                </c:pt>
                <c:pt idx="14">
                  <c:v>5.61712979953550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AB9B-4168-92EB-30E74E1DA4E6}"/>
            </c:ext>
          </c:extLst>
        </c:ser>
        <c:ser>
          <c:idx val="20"/>
          <c:order val="20"/>
          <c:tx>
            <c:strRef>
              <c:f>'DHA5'!$B$24</c:f>
              <c:strCache>
                <c:ptCount val="1"/>
                <c:pt idx="0">
                  <c:v>D5.14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4:$Q$24</c:f>
              <c:numCache>
                <c:formatCode>General</c:formatCode>
                <c:ptCount val="15"/>
                <c:pt idx="0">
                  <c:v>7.5238238903091563</c:v>
                </c:pt>
                <c:pt idx="1">
                  <c:v>3.4677546960344179</c:v>
                </c:pt>
                <c:pt idx="2">
                  <c:v>4.0791779803487414</c:v>
                </c:pt>
                <c:pt idx="3">
                  <c:v>20.603404763347399</c:v>
                </c:pt>
                <c:pt idx="4">
                  <c:v>2.0389243495091232</c:v>
                </c:pt>
                <c:pt idx="5">
                  <c:v>19.620926615621524</c:v>
                </c:pt>
                <c:pt idx="6">
                  <c:v>1.9003722212207699</c:v>
                </c:pt>
                <c:pt idx="7">
                  <c:v>4.8827042375934901</c:v>
                </c:pt>
                <c:pt idx="8">
                  <c:v>0.49787635013775167</c:v>
                </c:pt>
                <c:pt idx="9">
                  <c:v>2.6091470262338161</c:v>
                </c:pt>
                <c:pt idx="10">
                  <c:v>1.9917302636590251</c:v>
                </c:pt>
                <c:pt idx="11">
                  <c:v>10.206481645615396</c:v>
                </c:pt>
                <c:pt idx="12">
                  <c:v>5.0779851546161252</c:v>
                </c:pt>
                <c:pt idx="13">
                  <c:v>7.4917617643038774</c:v>
                </c:pt>
                <c:pt idx="14">
                  <c:v>7.5242304373870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AB9B-4168-92EB-30E74E1DA4E6}"/>
            </c:ext>
          </c:extLst>
        </c:ser>
        <c:ser>
          <c:idx val="21"/>
          <c:order val="21"/>
          <c:tx>
            <c:strRef>
              <c:f>'DHA5'!$B$25</c:f>
              <c:strCache>
                <c:ptCount val="1"/>
                <c:pt idx="0">
                  <c:v>D5.29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5:$Q$25</c:f>
              <c:numCache>
                <c:formatCode>General</c:formatCode>
                <c:ptCount val="15"/>
                <c:pt idx="0">
                  <c:v>8.3576094260685139</c:v>
                </c:pt>
                <c:pt idx="1">
                  <c:v>3.8495848827773611</c:v>
                </c:pt>
                <c:pt idx="2">
                  <c:v>4.8425102589616404</c:v>
                </c:pt>
                <c:pt idx="3">
                  <c:v>20.345603755261212</c:v>
                </c:pt>
                <c:pt idx="4">
                  <c:v>1.841146508290477</c:v>
                </c:pt>
                <c:pt idx="5">
                  <c:v>17.780294979510511</c:v>
                </c:pt>
                <c:pt idx="6">
                  <c:v>1.7962949696779384</c:v>
                </c:pt>
                <c:pt idx="7">
                  <c:v>4.4528241680762708</c:v>
                </c:pt>
                <c:pt idx="8">
                  <c:v>0.49011553846807115</c:v>
                </c:pt>
                <c:pt idx="9">
                  <c:v>2.8854119408617751</c:v>
                </c:pt>
                <c:pt idx="10">
                  <c:v>2.0494217962920178</c:v>
                </c:pt>
                <c:pt idx="11">
                  <c:v>10.972093279579207</c:v>
                </c:pt>
                <c:pt idx="12">
                  <c:v>4.9085513948803037</c:v>
                </c:pt>
                <c:pt idx="13">
                  <c:v>7.6663013876147215</c:v>
                </c:pt>
                <c:pt idx="14">
                  <c:v>6.7767584696828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AB9B-4168-92EB-30E74E1DA4E6}"/>
            </c:ext>
          </c:extLst>
        </c:ser>
        <c:ser>
          <c:idx val="22"/>
          <c:order val="22"/>
          <c:tx>
            <c:strRef>
              <c:f>'DHA5'!$B$26</c:f>
              <c:strCache>
                <c:ptCount val="1"/>
                <c:pt idx="0">
                  <c:v>D5.13</c:v>
                </c:pt>
              </c:strCache>
            </c:strRef>
          </c:tx>
          <c:spPr>
            <a:solidFill>
              <a:schemeClr val="accent3">
                <a:shade val="66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6:$Q$26</c:f>
              <c:numCache>
                <c:formatCode>General</c:formatCode>
                <c:ptCount val="15"/>
                <c:pt idx="0">
                  <c:v>7.8696143025032397</c:v>
                </c:pt>
                <c:pt idx="1">
                  <c:v>3.4367587465573108</c:v>
                </c:pt>
                <c:pt idx="2">
                  <c:v>4.5132130834578899</c:v>
                </c:pt>
                <c:pt idx="3">
                  <c:v>18.646115727199547</c:v>
                </c:pt>
                <c:pt idx="4">
                  <c:v>1.559745722624444</c:v>
                </c:pt>
                <c:pt idx="5">
                  <c:v>21.309248238447715</c:v>
                </c:pt>
                <c:pt idx="6">
                  <c:v>1.7292639257189955</c:v>
                </c:pt>
                <c:pt idx="7">
                  <c:v>5.080076108874608</c:v>
                </c:pt>
                <c:pt idx="8">
                  <c:v>0.46898111427325012</c:v>
                </c:pt>
                <c:pt idx="9">
                  <c:v>2.4667887959501495</c:v>
                </c:pt>
                <c:pt idx="10">
                  <c:v>2.2726010503276766</c:v>
                </c:pt>
                <c:pt idx="11">
                  <c:v>9.9902940832631124</c:v>
                </c:pt>
                <c:pt idx="12">
                  <c:v>4.8438634916982179</c:v>
                </c:pt>
                <c:pt idx="13">
                  <c:v>7.6931330189801743</c:v>
                </c:pt>
                <c:pt idx="14">
                  <c:v>6.64156723244557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AB9B-4168-92EB-30E74E1DA4E6}"/>
            </c:ext>
          </c:extLst>
        </c:ser>
        <c:ser>
          <c:idx val="23"/>
          <c:order val="23"/>
          <c:tx>
            <c:strRef>
              <c:f>'DHA5'!$B$27</c:f>
              <c:strCache>
                <c:ptCount val="1"/>
                <c:pt idx="0">
                  <c:v>D5.08</c:v>
                </c:pt>
              </c:strCache>
            </c:strRef>
          </c:tx>
          <c:spPr>
            <a:solidFill>
              <a:schemeClr val="accent3">
                <a:shade val="61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7:$Q$27</c:f>
              <c:numCache>
                <c:formatCode>General</c:formatCode>
                <c:ptCount val="15"/>
                <c:pt idx="0">
                  <c:v>9.412929910293407</c:v>
                </c:pt>
                <c:pt idx="1">
                  <c:v>3.8965025245494935</c:v>
                </c:pt>
                <c:pt idx="2">
                  <c:v>4.1967459674970424</c:v>
                </c:pt>
                <c:pt idx="3">
                  <c:v>17.004827101525169</c:v>
                </c:pt>
                <c:pt idx="4">
                  <c:v>1.952584825035552</c:v>
                </c:pt>
                <c:pt idx="5">
                  <c:v>21.86425580924773</c:v>
                </c:pt>
                <c:pt idx="6">
                  <c:v>2.3599651967754558</c:v>
                </c:pt>
                <c:pt idx="7">
                  <c:v>3.8787379371536437</c:v>
                </c:pt>
                <c:pt idx="8">
                  <c:v>0.34719931896532058</c:v>
                </c:pt>
                <c:pt idx="9">
                  <c:v>2.1490128712806098</c:v>
                </c:pt>
                <c:pt idx="10">
                  <c:v>2.0741634097165251</c:v>
                </c:pt>
                <c:pt idx="11">
                  <c:v>11.221613648715129</c:v>
                </c:pt>
                <c:pt idx="12">
                  <c:v>4.1751379161789233</c:v>
                </c:pt>
                <c:pt idx="13">
                  <c:v>7.6938676717391132</c:v>
                </c:pt>
                <c:pt idx="14">
                  <c:v>6.6813498547376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AB9B-4168-92EB-30E74E1DA4E6}"/>
            </c:ext>
          </c:extLst>
        </c:ser>
        <c:ser>
          <c:idx val="24"/>
          <c:order val="24"/>
          <c:tx>
            <c:strRef>
              <c:f>'DHA5'!$B$28</c:f>
              <c:strCache>
                <c:ptCount val="1"/>
                <c:pt idx="0">
                  <c:v>D5.04</c:v>
                </c:pt>
              </c:strCache>
            </c:strRef>
          </c:tx>
          <c:spPr>
            <a:solidFill>
              <a:schemeClr val="accent3">
                <a:shade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8:$Q$28</c:f>
              <c:numCache>
                <c:formatCode>General</c:formatCode>
                <c:ptCount val="15"/>
                <c:pt idx="0">
                  <c:v>7.9985313338807495</c:v>
                </c:pt>
                <c:pt idx="1">
                  <c:v>3.4125670525902922</c:v>
                </c:pt>
                <c:pt idx="2">
                  <c:v>4.1841837511686109</c:v>
                </c:pt>
                <c:pt idx="3">
                  <c:v>16.902687951519802</c:v>
                </c:pt>
                <c:pt idx="4">
                  <c:v>2.3013612685899054</c:v>
                </c:pt>
                <c:pt idx="5">
                  <c:v>20.607754045425207</c:v>
                </c:pt>
                <c:pt idx="6">
                  <c:v>2.3515806682348508</c:v>
                </c:pt>
                <c:pt idx="7">
                  <c:v>3.937044012329308</c:v>
                </c:pt>
                <c:pt idx="8">
                  <c:v>0.40176076865532995</c:v>
                </c:pt>
                <c:pt idx="9">
                  <c:v>2.4562917909903681</c:v>
                </c:pt>
                <c:pt idx="10">
                  <c:v>2.1307135027331254</c:v>
                </c:pt>
                <c:pt idx="11">
                  <c:v>11.857729603424396</c:v>
                </c:pt>
                <c:pt idx="12">
                  <c:v>4.8580497869526296</c:v>
                </c:pt>
                <c:pt idx="13">
                  <c:v>7.8808338203343142</c:v>
                </c:pt>
                <c:pt idx="14">
                  <c:v>7.2275341878805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AB9B-4168-92EB-30E74E1DA4E6}"/>
            </c:ext>
          </c:extLst>
        </c:ser>
        <c:ser>
          <c:idx val="25"/>
          <c:order val="25"/>
          <c:tx>
            <c:strRef>
              <c:f>'DHA5'!$B$29</c:f>
              <c:strCache>
                <c:ptCount val="1"/>
                <c:pt idx="0">
                  <c:v>D5.20</c:v>
                </c:pt>
              </c:strCache>
            </c:strRef>
          </c:tx>
          <c:spPr>
            <a:solidFill>
              <a:schemeClr val="accent3">
                <a:shade val="52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29:$Q$29</c:f>
              <c:numCache>
                <c:formatCode>General</c:formatCode>
                <c:ptCount val="15"/>
                <c:pt idx="0">
                  <c:v>8.8265338979050494</c:v>
                </c:pt>
                <c:pt idx="1">
                  <c:v>3.5443161663148142</c:v>
                </c:pt>
                <c:pt idx="2">
                  <c:v>3.7537228416354935</c:v>
                </c:pt>
                <c:pt idx="3">
                  <c:v>18.487789725549817</c:v>
                </c:pt>
                <c:pt idx="4">
                  <c:v>2.0854428589097194</c:v>
                </c:pt>
                <c:pt idx="5">
                  <c:v>17.443740070998295</c:v>
                </c:pt>
                <c:pt idx="6">
                  <c:v>2.2062295431415473</c:v>
                </c:pt>
                <c:pt idx="7">
                  <c:v>4.154910136133565</c:v>
                </c:pt>
                <c:pt idx="8">
                  <c:v>0.48093533391463505</c:v>
                </c:pt>
                <c:pt idx="9">
                  <c:v>2.8144760131474498</c:v>
                </c:pt>
                <c:pt idx="10">
                  <c:v>2.4102438251142053</c:v>
                </c:pt>
                <c:pt idx="11">
                  <c:v>11.763473247783882</c:v>
                </c:pt>
                <c:pt idx="12">
                  <c:v>4.5038068350296667</c:v>
                </c:pt>
                <c:pt idx="13">
                  <c:v>7.9601379362388096</c:v>
                </c:pt>
                <c:pt idx="14">
                  <c:v>7.6145666146338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AB9B-4168-92EB-30E74E1DA4E6}"/>
            </c:ext>
          </c:extLst>
        </c:ser>
        <c:ser>
          <c:idx val="26"/>
          <c:order val="26"/>
          <c:tx>
            <c:strRef>
              <c:f>'DHA5'!$B$30</c:f>
              <c:strCache>
                <c:ptCount val="1"/>
                <c:pt idx="0">
                  <c:v>D5.01</c:v>
                </c:pt>
              </c:strCache>
            </c:strRef>
          </c:tx>
          <c:spPr>
            <a:solidFill>
              <a:schemeClr val="accent3">
                <a:shade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30:$Q$30</c:f>
              <c:numCache>
                <c:formatCode>General</c:formatCode>
                <c:ptCount val="15"/>
                <c:pt idx="0">
                  <c:v>8.5433942981376827</c:v>
                </c:pt>
                <c:pt idx="1">
                  <c:v>3.4072610347771222</c:v>
                </c:pt>
                <c:pt idx="2">
                  <c:v>4.4047305307578553</c:v>
                </c:pt>
                <c:pt idx="3">
                  <c:v>17.232503645540156</c:v>
                </c:pt>
                <c:pt idx="4">
                  <c:v>1.4115953853384979</c:v>
                </c:pt>
                <c:pt idx="5">
                  <c:v>23.081668457962724</c:v>
                </c:pt>
                <c:pt idx="6">
                  <c:v>1.8493660342412528</c:v>
                </c:pt>
                <c:pt idx="7">
                  <c:v>4.998064199394757</c:v>
                </c:pt>
                <c:pt idx="8">
                  <c:v>0.38055197565830706</c:v>
                </c:pt>
                <c:pt idx="9">
                  <c:v>2.2569884835553542</c:v>
                </c:pt>
                <c:pt idx="10">
                  <c:v>2.1572630618243669</c:v>
                </c:pt>
                <c:pt idx="11">
                  <c:v>9.1803820345883942</c:v>
                </c:pt>
                <c:pt idx="12">
                  <c:v>4.5543959300323973</c:v>
                </c:pt>
                <c:pt idx="13">
                  <c:v>8.0103517108660753</c:v>
                </c:pt>
                <c:pt idx="14">
                  <c:v>7.38538372166077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AB9B-4168-92EB-30E74E1DA4E6}"/>
            </c:ext>
          </c:extLst>
        </c:ser>
        <c:ser>
          <c:idx val="27"/>
          <c:order val="27"/>
          <c:tx>
            <c:strRef>
              <c:f>'DHA5'!$B$31</c:f>
              <c:strCache>
                <c:ptCount val="1"/>
                <c:pt idx="0">
                  <c:v>D5.23</c:v>
                </c:pt>
              </c:strCache>
            </c:strRef>
          </c:tx>
          <c:spPr>
            <a:solidFill>
              <a:schemeClr val="accent3">
                <a:shade val="43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31:$Q$31</c:f>
              <c:numCache>
                <c:formatCode>General</c:formatCode>
                <c:ptCount val="15"/>
                <c:pt idx="0">
                  <c:v>7.4108372470043706</c:v>
                </c:pt>
                <c:pt idx="1">
                  <c:v>3.5376265886216181</c:v>
                </c:pt>
                <c:pt idx="2">
                  <c:v>4.6364087773903151</c:v>
                </c:pt>
                <c:pt idx="3">
                  <c:v>17.033906241668003</c:v>
                </c:pt>
                <c:pt idx="4">
                  <c:v>1.6176456469049143</c:v>
                </c:pt>
                <c:pt idx="5">
                  <c:v>22.022992245394434</c:v>
                </c:pt>
                <c:pt idx="6">
                  <c:v>2.054522590453451</c:v>
                </c:pt>
                <c:pt idx="7">
                  <c:v>5.3284080742853837</c:v>
                </c:pt>
                <c:pt idx="8">
                  <c:v>0.36732491494751207</c:v>
                </c:pt>
                <c:pt idx="9">
                  <c:v>2.4140406162034704</c:v>
                </c:pt>
                <c:pt idx="10">
                  <c:v>2.1555365876880384</c:v>
                </c:pt>
                <c:pt idx="11">
                  <c:v>10.250788893814921</c:v>
                </c:pt>
                <c:pt idx="12">
                  <c:v>5.3767649984857764</c:v>
                </c:pt>
                <c:pt idx="13">
                  <c:v>8.5077424913522908</c:v>
                </c:pt>
                <c:pt idx="14">
                  <c:v>6.61855802444046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AB9B-4168-92EB-30E74E1DA4E6}"/>
            </c:ext>
          </c:extLst>
        </c:ser>
        <c:ser>
          <c:idx val="28"/>
          <c:order val="28"/>
          <c:tx>
            <c:strRef>
              <c:f>'DHA5'!$B$32</c:f>
              <c:strCache>
                <c:ptCount val="1"/>
                <c:pt idx="0">
                  <c:v>D5.02</c:v>
                </c:pt>
              </c:strCache>
            </c:strRef>
          </c:tx>
          <c:spPr>
            <a:solidFill>
              <a:schemeClr val="accent3">
                <a:shade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32:$Q$32</c:f>
              <c:numCache>
                <c:formatCode>General</c:formatCode>
                <c:ptCount val="15"/>
                <c:pt idx="0">
                  <c:v>7.561919931410773</c:v>
                </c:pt>
                <c:pt idx="1">
                  <c:v>3.5369258709864502</c:v>
                </c:pt>
                <c:pt idx="2">
                  <c:v>4.5136475704989003</c:v>
                </c:pt>
                <c:pt idx="3">
                  <c:v>18.139761633139234</c:v>
                </c:pt>
                <c:pt idx="4">
                  <c:v>1.8029124361432778</c:v>
                </c:pt>
                <c:pt idx="5">
                  <c:v>19.927361101665209</c:v>
                </c:pt>
                <c:pt idx="6">
                  <c:v>1.9023234086860292</c:v>
                </c:pt>
                <c:pt idx="7">
                  <c:v>4.9643312444087044</c:v>
                </c:pt>
                <c:pt idx="8">
                  <c:v>0.43552118009121027</c:v>
                </c:pt>
                <c:pt idx="9">
                  <c:v>2.7603166773705428</c:v>
                </c:pt>
                <c:pt idx="10">
                  <c:v>2.1301147741225726</c:v>
                </c:pt>
                <c:pt idx="11">
                  <c:v>10.747309057720978</c:v>
                </c:pt>
                <c:pt idx="12">
                  <c:v>5.3453387431912729</c:v>
                </c:pt>
                <c:pt idx="13">
                  <c:v>8.5805844560338489</c:v>
                </c:pt>
                <c:pt idx="14">
                  <c:v>7.101426097589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AB9B-4168-92EB-30E74E1DA4E6}"/>
            </c:ext>
          </c:extLst>
        </c:ser>
        <c:ser>
          <c:idx val="29"/>
          <c:order val="29"/>
          <c:tx>
            <c:strRef>
              <c:f>'DHA5'!$B$33</c:f>
              <c:strCache>
                <c:ptCount val="1"/>
                <c:pt idx="0">
                  <c:v>D5.07</c:v>
                </c:pt>
              </c:strCache>
            </c:strRef>
          </c:tx>
          <c:spPr>
            <a:solidFill>
              <a:schemeClr val="accent3">
                <a:shade val="34000"/>
              </a:schemeClr>
            </a:solidFill>
            <a:ln>
              <a:noFill/>
            </a:ln>
            <a:effectLst/>
          </c:spPr>
          <c:invertIfNegative val="0"/>
          <c:cat>
            <c:strRef>
              <c:f>'DHA5'!$C$3:$Q$3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DHA5'!$C$33:$Q$33</c:f>
              <c:numCache>
                <c:formatCode>General</c:formatCode>
                <c:ptCount val="15"/>
                <c:pt idx="0">
                  <c:v>9.5472797002548635</c:v>
                </c:pt>
                <c:pt idx="1">
                  <c:v>4.3916106997644073</c:v>
                </c:pt>
                <c:pt idx="2">
                  <c:v>5.6231624529239737</c:v>
                </c:pt>
                <c:pt idx="3">
                  <c:v>21.910981128116738</c:v>
                </c:pt>
                <c:pt idx="4">
                  <c:v>2.2589168277211655</c:v>
                </c:pt>
                <c:pt idx="5">
                  <c:v>21.879991872763995</c:v>
                </c:pt>
                <c:pt idx="6">
                  <c:v>1.8616984556372638</c:v>
                </c:pt>
                <c:pt idx="7">
                  <c:v>5.2309257702707272</c:v>
                </c:pt>
                <c:pt idx="8">
                  <c:v>0.54749874244388985</c:v>
                </c:pt>
                <c:pt idx="9">
                  <c:v>3.2294305464397901</c:v>
                </c:pt>
                <c:pt idx="10">
                  <c:v>2.4509990736551681</c:v>
                </c:pt>
                <c:pt idx="11">
                  <c:v>0.55142383000918138</c:v>
                </c:pt>
                <c:pt idx="12">
                  <c:v>4.9434216440386756</c:v>
                </c:pt>
                <c:pt idx="13">
                  <c:v>8.6506604271500649</c:v>
                </c:pt>
                <c:pt idx="14">
                  <c:v>6.32105483487126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AB9B-4168-92EB-30E74E1DA4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296976880"/>
        <c:axId val="1296983112"/>
      </c:barChart>
      <c:catAx>
        <c:axId val="1296976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6983112"/>
        <c:crosses val="autoZero"/>
        <c:auto val="1"/>
        <c:lblAlgn val="ctr"/>
        <c:lblOffset val="100"/>
        <c:noMultiLvlLbl val="0"/>
      </c:catAx>
      <c:valAx>
        <c:axId val="12969831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dirty="0"/>
                  <a:t>FAMEs (mol%)</a:t>
                </a:r>
              </a:p>
            </c:rich>
          </c:tx>
          <c:layout>
            <c:manualLayout>
              <c:xMode val="edge"/>
              <c:yMode val="edge"/>
              <c:x val="2.8140402489980381E-2"/>
              <c:y val="6.320351697278550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697688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28103948153833"/>
          <c:y val="0.84303203946920557"/>
          <c:w val="0.8661501236462863"/>
          <c:h val="0.115558202849309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000"/>
              <a:t>EPA2015.4</a:t>
            </a:r>
          </a:p>
        </c:rich>
      </c:tx>
      <c:layout>
        <c:manualLayout>
          <c:xMode val="edge"/>
          <c:yMode val="edge"/>
          <c:x val="0.4343847018284494"/>
          <c:y val="0.182316305331361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59113622821146E-2"/>
          <c:y val="0.17880853024833895"/>
          <c:w val="0.8845451823445869"/>
          <c:h val="0.599074607976258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PA4'!$B$5</c:f>
              <c:strCache>
                <c:ptCount val="1"/>
                <c:pt idx="0">
                  <c:v>E4.25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5:$P$5</c:f>
              <c:numCache>
                <c:formatCode>General</c:formatCode>
                <c:ptCount val="14"/>
                <c:pt idx="0">
                  <c:v>8.8946514037531959</c:v>
                </c:pt>
                <c:pt idx="1">
                  <c:v>3.8833377367991404</c:v>
                </c:pt>
                <c:pt idx="2">
                  <c:v>18.228703376536927</c:v>
                </c:pt>
                <c:pt idx="3">
                  <c:v>12.952653839231363</c:v>
                </c:pt>
                <c:pt idx="4">
                  <c:v>1.8787789625032363</c:v>
                </c:pt>
                <c:pt idx="5">
                  <c:v>8.7806225006638918</c:v>
                </c:pt>
                <c:pt idx="6">
                  <c:v>1.7422952514727428</c:v>
                </c:pt>
                <c:pt idx="7">
                  <c:v>4.3017316156579817</c:v>
                </c:pt>
                <c:pt idx="8">
                  <c:v>1.6323938965854956</c:v>
                </c:pt>
                <c:pt idx="9">
                  <c:v>5.8987594537296371</c:v>
                </c:pt>
                <c:pt idx="10">
                  <c:v>1.862575501582052</c:v>
                </c:pt>
                <c:pt idx="11">
                  <c:v>17.260081283538536</c:v>
                </c:pt>
                <c:pt idx="12">
                  <c:v>0.55224911383277464</c:v>
                </c:pt>
                <c:pt idx="13">
                  <c:v>12.131166064113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21-4403-A889-C462BD2EAC6F}"/>
            </c:ext>
          </c:extLst>
        </c:ser>
        <c:ser>
          <c:idx val="1"/>
          <c:order val="1"/>
          <c:tx>
            <c:strRef>
              <c:f>'EPA4'!$B$6</c:f>
              <c:strCache>
                <c:ptCount val="1"/>
                <c:pt idx="0">
                  <c:v>E4.28</c:v>
                </c:pt>
              </c:strCache>
            </c:strRef>
          </c:tx>
          <c:spPr>
            <a:solidFill>
              <a:schemeClr val="accent3">
                <a:tint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6:$P$6</c:f>
              <c:numCache>
                <c:formatCode>General</c:formatCode>
                <c:ptCount val="14"/>
                <c:pt idx="0">
                  <c:v>8.4254423942292327</c:v>
                </c:pt>
                <c:pt idx="1">
                  <c:v>3.4561842414912207</c:v>
                </c:pt>
                <c:pt idx="2">
                  <c:v>15.282762742301951</c:v>
                </c:pt>
                <c:pt idx="3">
                  <c:v>15.749018962381099</c:v>
                </c:pt>
                <c:pt idx="4">
                  <c:v>2.0842804211040562</c:v>
                </c:pt>
                <c:pt idx="5">
                  <c:v>11.565867437937181</c:v>
                </c:pt>
                <c:pt idx="6">
                  <c:v>2.2261212043478151</c:v>
                </c:pt>
                <c:pt idx="7">
                  <c:v>5.1870068834796363</c:v>
                </c:pt>
                <c:pt idx="8">
                  <c:v>1.5530428661829527</c:v>
                </c:pt>
                <c:pt idx="9">
                  <c:v>5.4902710596080952</c:v>
                </c:pt>
                <c:pt idx="10">
                  <c:v>1.8103085211676859</c:v>
                </c:pt>
                <c:pt idx="11">
                  <c:v>18.753572123132859</c:v>
                </c:pt>
                <c:pt idx="12">
                  <c:v>0</c:v>
                </c:pt>
                <c:pt idx="13">
                  <c:v>8.41612114263622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21-4403-A889-C462BD2EAC6F}"/>
            </c:ext>
          </c:extLst>
        </c:ser>
        <c:ser>
          <c:idx val="2"/>
          <c:order val="2"/>
          <c:tx>
            <c:strRef>
              <c:f>'EPA4'!$B$7</c:f>
              <c:strCache>
                <c:ptCount val="1"/>
                <c:pt idx="0">
                  <c:v>E4.8</c:v>
                </c:pt>
              </c:strCache>
            </c:strRef>
          </c:tx>
          <c:spPr>
            <a:solidFill>
              <a:schemeClr val="accent3">
                <a:tint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7:$P$7</c:f>
              <c:numCache>
                <c:formatCode>General</c:formatCode>
                <c:ptCount val="14"/>
                <c:pt idx="0">
                  <c:v>8.0737142203385392</c:v>
                </c:pt>
                <c:pt idx="1">
                  <c:v>3.1162229049283985</c:v>
                </c:pt>
                <c:pt idx="2">
                  <c:v>16.467398384962497</c:v>
                </c:pt>
                <c:pt idx="3">
                  <c:v>13.369540577182324</c:v>
                </c:pt>
                <c:pt idx="4">
                  <c:v>2.2117693786088655</c:v>
                </c:pt>
                <c:pt idx="5">
                  <c:v>11.515257343049512</c:v>
                </c:pt>
                <c:pt idx="6">
                  <c:v>2.6396051626104917</c:v>
                </c:pt>
                <c:pt idx="7">
                  <c:v>3.6317929136572822</c:v>
                </c:pt>
                <c:pt idx="8">
                  <c:v>1.3361882972193502</c:v>
                </c:pt>
                <c:pt idx="9">
                  <c:v>5.4652591640075743</c:v>
                </c:pt>
                <c:pt idx="10">
                  <c:v>1.7581863627428631</c:v>
                </c:pt>
                <c:pt idx="11">
                  <c:v>19.308814746071384</c:v>
                </c:pt>
                <c:pt idx="12">
                  <c:v>0.43974132748488243</c:v>
                </c:pt>
                <c:pt idx="13">
                  <c:v>10.666509217136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21-4403-A889-C462BD2EAC6F}"/>
            </c:ext>
          </c:extLst>
        </c:ser>
        <c:ser>
          <c:idx val="3"/>
          <c:order val="3"/>
          <c:tx>
            <c:strRef>
              <c:f>'EPA4'!$B$8</c:f>
              <c:strCache>
                <c:ptCount val="1"/>
                <c:pt idx="0">
                  <c:v>E4.11</c:v>
                </c:pt>
              </c:strCache>
            </c:strRef>
          </c:tx>
          <c:spPr>
            <a:solidFill>
              <a:schemeClr val="accent3">
                <a:tint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8:$P$8</c:f>
              <c:numCache>
                <c:formatCode>General</c:formatCode>
                <c:ptCount val="14"/>
                <c:pt idx="0">
                  <c:v>8.256407049008418</c:v>
                </c:pt>
                <c:pt idx="1">
                  <c:v>3.5684199630136471</c:v>
                </c:pt>
                <c:pt idx="2">
                  <c:v>16.493710491758133</c:v>
                </c:pt>
                <c:pt idx="3">
                  <c:v>11.306401998313563</c:v>
                </c:pt>
                <c:pt idx="4">
                  <c:v>2.0292648361598364</c:v>
                </c:pt>
                <c:pt idx="5">
                  <c:v>12.248871653374897</c:v>
                </c:pt>
                <c:pt idx="6">
                  <c:v>2.0872942846809894</c:v>
                </c:pt>
                <c:pt idx="7">
                  <c:v>4.1122000989454799</c:v>
                </c:pt>
                <c:pt idx="8">
                  <c:v>0.9495242691979644</c:v>
                </c:pt>
                <c:pt idx="9">
                  <c:v>4.7171676661435926</c:v>
                </c:pt>
                <c:pt idx="10">
                  <c:v>1.4586529515907491</c:v>
                </c:pt>
                <c:pt idx="11">
                  <c:v>19.333813112451285</c:v>
                </c:pt>
                <c:pt idx="12">
                  <c:v>0.54234055917156931</c:v>
                </c:pt>
                <c:pt idx="13">
                  <c:v>12.8959310661898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421-4403-A889-C462BD2EAC6F}"/>
            </c:ext>
          </c:extLst>
        </c:ser>
        <c:ser>
          <c:idx val="4"/>
          <c:order val="4"/>
          <c:tx>
            <c:strRef>
              <c:f>'EPA4'!$B$9</c:f>
              <c:strCache>
                <c:ptCount val="1"/>
                <c:pt idx="0">
                  <c:v>E4.1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9:$P$9</c:f>
              <c:numCache>
                <c:formatCode>General</c:formatCode>
                <c:ptCount val="14"/>
                <c:pt idx="0">
                  <c:v>8.111284604091356</c:v>
                </c:pt>
                <c:pt idx="1">
                  <c:v>3.4620696684299905</c:v>
                </c:pt>
                <c:pt idx="2">
                  <c:v>14.204479112162902</c:v>
                </c:pt>
                <c:pt idx="3">
                  <c:v>14.024145200611811</c:v>
                </c:pt>
                <c:pt idx="4">
                  <c:v>2.425455378727527</c:v>
                </c:pt>
                <c:pt idx="5">
                  <c:v>12.146822559329552</c:v>
                </c:pt>
                <c:pt idx="6">
                  <c:v>2.8669879603166568</c:v>
                </c:pt>
                <c:pt idx="7">
                  <c:v>3.8901220766593805</c:v>
                </c:pt>
                <c:pt idx="8">
                  <c:v>1.3785602906173575</c:v>
                </c:pt>
                <c:pt idx="9">
                  <c:v>5.5114610273681031</c:v>
                </c:pt>
                <c:pt idx="10">
                  <c:v>1.8569392666992524</c:v>
                </c:pt>
                <c:pt idx="11">
                  <c:v>19.635598397150826</c:v>
                </c:pt>
                <c:pt idx="12">
                  <c:v>0.46820549114209764</c:v>
                </c:pt>
                <c:pt idx="13">
                  <c:v>10.017868966693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421-4403-A889-C462BD2EAC6F}"/>
            </c:ext>
          </c:extLst>
        </c:ser>
        <c:ser>
          <c:idx val="5"/>
          <c:order val="5"/>
          <c:tx>
            <c:strRef>
              <c:f>'EPA4'!$B$10</c:f>
              <c:strCache>
                <c:ptCount val="1"/>
                <c:pt idx="0">
                  <c:v>E4.3</c:v>
                </c:pt>
              </c:strCache>
            </c:strRef>
          </c:tx>
          <c:spPr>
            <a:solidFill>
              <a:schemeClr val="accent3">
                <a:tint val="9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0:$P$10</c:f>
              <c:numCache>
                <c:formatCode>General</c:formatCode>
                <c:ptCount val="14"/>
                <c:pt idx="0">
                  <c:v>8.7195514826411546</c:v>
                </c:pt>
                <c:pt idx="1">
                  <c:v>3.9251655716488298</c:v>
                </c:pt>
                <c:pt idx="2">
                  <c:v>13.327950685538122</c:v>
                </c:pt>
                <c:pt idx="3">
                  <c:v>12.547651741121896</c:v>
                </c:pt>
                <c:pt idx="4">
                  <c:v>2.7099402802492865</c:v>
                </c:pt>
                <c:pt idx="5">
                  <c:v>11.420528134314159</c:v>
                </c:pt>
                <c:pt idx="6">
                  <c:v>3.4995586209925049</c:v>
                </c:pt>
                <c:pt idx="7">
                  <c:v>4.0448819884368969</c:v>
                </c:pt>
                <c:pt idx="8">
                  <c:v>1.6067307497949608</c:v>
                </c:pt>
                <c:pt idx="9">
                  <c:v>5.2329712158348123</c:v>
                </c:pt>
                <c:pt idx="10">
                  <c:v>2.2470723528537264</c:v>
                </c:pt>
                <c:pt idx="11">
                  <c:v>20.475233539140117</c:v>
                </c:pt>
                <c:pt idx="12">
                  <c:v>0.63974957513702035</c:v>
                </c:pt>
                <c:pt idx="13">
                  <c:v>9.60301406229651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421-4403-A889-C462BD2EAC6F}"/>
            </c:ext>
          </c:extLst>
        </c:ser>
        <c:ser>
          <c:idx val="6"/>
          <c:order val="6"/>
          <c:tx>
            <c:strRef>
              <c:f>'EPA4'!$B$11</c:f>
              <c:strCache>
                <c:ptCount val="1"/>
                <c:pt idx="0">
                  <c:v>E4.27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1:$P$11</c:f>
              <c:numCache>
                <c:formatCode>General</c:formatCode>
                <c:ptCount val="14"/>
                <c:pt idx="0">
                  <c:v>8.8903914168135074</c:v>
                </c:pt>
                <c:pt idx="1">
                  <c:v>3.6498799538081603</c:v>
                </c:pt>
                <c:pt idx="2">
                  <c:v>12.971796807831655</c:v>
                </c:pt>
                <c:pt idx="3">
                  <c:v>12.757721861371405</c:v>
                </c:pt>
                <c:pt idx="4">
                  <c:v>2.9901078427125882</c:v>
                </c:pt>
                <c:pt idx="5">
                  <c:v>10.714633780907374</c:v>
                </c:pt>
                <c:pt idx="6">
                  <c:v>3.359097396011848</c:v>
                </c:pt>
                <c:pt idx="7">
                  <c:v>3.9883715981366152</c:v>
                </c:pt>
                <c:pt idx="8">
                  <c:v>1.9144638786097898</c:v>
                </c:pt>
                <c:pt idx="9">
                  <c:v>5.9870701058683924</c:v>
                </c:pt>
                <c:pt idx="10">
                  <c:v>2.4003351502124217</c:v>
                </c:pt>
                <c:pt idx="11">
                  <c:v>21.062720567569766</c:v>
                </c:pt>
                <c:pt idx="12">
                  <c:v>0.63089506428533426</c:v>
                </c:pt>
                <c:pt idx="13">
                  <c:v>8.6825145758611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421-4403-A889-C462BD2EAC6F}"/>
            </c:ext>
          </c:extLst>
        </c:ser>
        <c:ser>
          <c:idx val="7"/>
          <c:order val="7"/>
          <c:tx>
            <c:strRef>
              <c:f>'EPA4'!$B$12</c:f>
              <c:strCache>
                <c:ptCount val="1"/>
                <c:pt idx="0">
                  <c:v>E4.20</c:v>
                </c:pt>
              </c:strCache>
            </c:strRef>
          </c:tx>
          <c:spPr>
            <a:solidFill>
              <a:schemeClr val="accent3">
                <a:shade val="9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2:$P$12</c:f>
              <c:numCache>
                <c:formatCode>General</c:formatCode>
                <c:ptCount val="14"/>
                <c:pt idx="0">
                  <c:v>8.1887817203018312</c:v>
                </c:pt>
                <c:pt idx="1">
                  <c:v>3.3282765035645872</c:v>
                </c:pt>
                <c:pt idx="2">
                  <c:v>12.652072302596638</c:v>
                </c:pt>
                <c:pt idx="3">
                  <c:v>12.364808967980595</c:v>
                </c:pt>
                <c:pt idx="4">
                  <c:v>2.6386550855635282</c:v>
                </c:pt>
                <c:pt idx="5">
                  <c:v>12.09446479243643</c:v>
                </c:pt>
                <c:pt idx="6">
                  <c:v>3.0077822096021491</c:v>
                </c:pt>
                <c:pt idx="7">
                  <c:v>3.6164262349244485</c:v>
                </c:pt>
                <c:pt idx="8">
                  <c:v>1.4641917648679383</c:v>
                </c:pt>
                <c:pt idx="9">
                  <c:v>5.0177480711539966</c:v>
                </c:pt>
                <c:pt idx="10">
                  <c:v>2.0984793895370331</c:v>
                </c:pt>
                <c:pt idx="11">
                  <c:v>21.449860246597019</c:v>
                </c:pt>
                <c:pt idx="12">
                  <c:v>0.51315099335154457</c:v>
                </c:pt>
                <c:pt idx="13">
                  <c:v>11.5653017175222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421-4403-A889-C462BD2EAC6F}"/>
            </c:ext>
          </c:extLst>
        </c:ser>
        <c:ser>
          <c:idx val="8"/>
          <c:order val="8"/>
          <c:tx>
            <c:strRef>
              <c:f>'EPA4'!$B$13</c:f>
              <c:strCache>
                <c:ptCount val="1"/>
                <c:pt idx="0">
                  <c:v>E4.4</c:v>
                </c:pt>
              </c:strCache>
            </c:strRef>
          </c:tx>
          <c:spPr>
            <a:solidFill>
              <a:schemeClr val="accent3">
                <a:shade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3:$P$13</c:f>
              <c:numCache>
                <c:formatCode>General</c:formatCode>
                <c:ptCount val="14"/>
                <c:pt idx="0">
                  <c:v>8.6531283480099699</c:v>
                </c:pt>
                <c:pt idx="1">
                  <c:v>3.6589820498055263</c:v>
                </c:pt>
                <c:pt idx="2">
                  <c:v>13.080036180487607</c:v>
                </c:pt>
                <c:pt idx="3">
                  <c:v>11.358622046615967</c:v>
                </c:pt>
                <c:pt idx="4">
                  <c:v>2.9124532164439918</c:v>
                </c:pt>
                <c:pt idx="5">
                  <c:v>11.132300861725305</c:v>
                </c:pt>
                <c:pt idx="6">
                  <c:v>3.670554069809703</c:v>
                </c:pt>
                <c:pt idx="7">
                  <c:v>3.7047140196629003</c:v>
                </c:pt>
                <c:pt idx="8">
                  <c:v>1.5514714933034806</c:v>
                </c:pt>
                <c:pt idx="9">
                  <c:v>5.4626072323522843</c:v>
                </c:pt>
                <c:pt idx="10">
                  <c:v>2.3511253421587668</c:v>
                </c:pt>
                <c:pt idx="11">
                  <c:v>21.545913824856957</c:v>
                </c:pt>
                <c:pt idx="12">
                  <c:v>0.62649421897435875</c:v>
                </c:pt>
                <c:pt idx="13">
                  <c:v>10.2915970957931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421-4403-A889-C462BD2EAC6F}"/>
            </c:ext>
          </c:extLst>
        </c:ser>
        <c:ser>
          <c:idx val="9"/>
          <c:order val="9"/>
          <c:tx>
            <c:strRef>
              <c:f>'EPA4'!$B$14</c:f>
              <c:strCache>
                <c:ptCount val="1"/>
                <c:pt idx="0">
                  <c:v>E4.2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4:$P$14</c:f>
              <c:numCache>
                <c:formatCode>General</c:formatCode>
                <c:ptCount val="14"/>
                <c:pt idx="0">
                  <c:v>8.8942688664305827</c:v>
                </c:pt>
                <c:pt idx="1">
                  <c:v>4.0150535479198792</c:v>
                </c:pt>
                <c:pt idx="2">
                  <c:v>13.832115443024069</c:v>
                </c:pt>
                <c:pt idx="3">
                  <c:v>11.104276391391419</c:v>
                </c:pt>
                <c:pt idx="4">
                  <c:v>2.6340809768812687</c:v>
                </c:pt>
                <c:pt idx="5">
                  <c:v>10.66368586318084</c:v>
                </c:pt>
                <c:pt idx="6">
                  <c:v>3.6137034670047106</c:v>
                </c:pt>
                <c:pt idx="7">
                  <c:v>3.8685981616919878</c:v>
                </c:pt>
                <c:pt idx="8">
                  <c:v>1.7675578794383686</c:v>
                </c:pt>
                <c:pt idx="9">
                  <c:v>5.2423420513605814</c:v>
                </c:pt>
                <c:pt idx="10">
                  <c:v>2.3626550854833872</c:v>
                </c:pt>
                <c:pt idx="11">
                  <c:v>22.337098396636737</c:v>
                </c:pt>
                <c:pt idx="12">
                  <c:v>0.7374474373865697</c:v>
                </c:pt>
                <c:pt idx="13">
                  <c:v>8.92711643216961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421-4403-A889-C462BD2EAC6F}"/>
            </c:ext>
          </c:extLst>
        </c:ser>
        <c:ser>
          <c:idx val="10"/>
          <c:order val="10"/>
          <c:tx>
            <c:strRef>
              <c:f>'EPA4'!$B$15</c:f>
              <c:strCache>
                <c:ptCount val="1"/>
                <c:pt idx="0">
                  <c:v>E4.5</c:v>
                </c:pt>
              </c:strCache>
            </c:strRef>
          </c:tx>
          <c:spPr>
            <a:solidFill>
              <a:schemeClr val="accent3">
                <a:shade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5:$P$15</c:f>
              <c:numCache>
                <c:formatCode>General</c:formatCode>
                <c:ptCount val="14"/>
                <c:pt idx="0">
                  <c:v>9.073594190132745</c:v>
                </c:pt>
                <c:pt idx="1">
                  <c:v>3.3395139778673979</c:v>
                </c:pt>
                <c:pt idx="2">
                  <c:v>14.653083188051539</c:v>
                </c:pt>
                <c:pt idx="3">
                  <c:v>11.126111901047103</c:v>
                </c:pt>
                <c:pt idx="4">
                  <c:v>2.713128092949439</c:v>
                </c:pt>
                <c:pt idx="5">
                  <c:v>10.551671384002551</c:v>
                </c:pt>
                <c:pt idx="6">
                  <c:v>3.6747067122265973</c:v>
                </c:pt>
                <c:pt idx="7">
                  <c:v>3.5921934125914876</c:v>
                </c:pt>
                <c:pt idx="8">
                  <c:v>1.5704510165549006</c:v>
                </c:pt>
                <c:pt idx="9">
                  <c:v>5.5028623379677262</c:v>
                </c:pt>
                <c:pt idx="10">
                  <c:v>2.3398323308553426</c:v>
                </c:pt>
                <c:pt idx="11">
                  <c:v>22.56904645632569</c:v>
                </c:pt>
                <c:pt idx="12">
                  <c:v>0.67188478449994449</c:v>
                </c:pt>
                <c:pt idx="13">
                  <c:v>8.62192021492751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421-4403-A889-C462BD2EAC6F}"/>
            </c:ext>
          </c:extLst>
        </c:ser>
        <c:ser>
          <c:idx val="11"/>
          <c:order val="11"/>
          <c:tx>
            <c:strRef>
              <c:f>'EPA4'!$B$16</c:f>
              <c:strCache>
                <c:ptCount val="1"/>
                <c:pt idx="0">
                  <c:v>E4.19</c:v>
                </c:pt>
              </c:strCache>
            </c:strRef>
          </c:tx>
          <c:spPr>
            <a:solidFill>
              <a:schemeClr val="accent3">
                <a:shade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6:$P$16</c:f>
              <c:numCache>
                <c:formatCode>General</c:formatCode>
                <c:ptCount val="14"/>
                <c:pt idx="0">
                  <c:v>9.0454245165429246</c:v>
                </c:pt>
                <c:pt idx="1">
                  <c:v>3.3070551510636532</c:v>
                </c:pt>
                <c:pt idx="2">
                  <c:v>13.671927356433004</c:v>
                </c:pt>
                <c:pt idx="3">
                  <c:v>13.347132829753811</c:v>
                </c:pt>
                <c:pt idx="4">
                  <c:v>2.543985922583786</c:v>
                </c:pt>
                <c:pt idx="5">
                  <c:v>10.315613836545035</c:v>
                </c:pt>
                <c:pt idx="6">
                  <c:v>2.5485298363950331</c:v>
                </c:pt>
                <c:pt idx="7">
                  <c:v>3.5375761867995759</c:v>
                </c:pt>
                <c:pt idx="8">
                  <c:v>1.588022861187077</c:v>
                </c:pt>
                <c:pt idx="9">
                  <c:v>6.4836097581701067</c:v>
                </c:pt>
                <c:pt idx="10">
                  <c:v>1.9731560373665462</c:v>
                </c:pt>
                <c:pt idx="11">
                  <c:v>22.585959091439278</c:v>
                </c:pt>
                <c:pt idx="12">
                  <c:v>0.6480194148446673</c:v>
                </c:pt>
                <c:pt idx="13">
                  <c:v>8.40398720087549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421-4403-A889-C462BD2EAC6F}"/>
            </c:ext>
          </c:extLst>
        </c:ser>
        <c:ser>
          <c:idx val="12"/>
          <c:order val="12"/>
          <c:tx>
            <c:strRef>
              <c:f>'EPA4'!$B$17</c:f>
              <c:strCache>
                <c:ptCount val="1"/>
                <c:pt idx="0">
                  <c:v>E4.10</c:v>
                </c:pt>
              </c:strCache>
            </c:strRef>
          </c:tx>
          <c:spPr>
            <a:solidFill>
              <a:schemeClr val="accent3">
                <a:shade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4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4'!$C$17:$P$17</c:f>
              <c:numCache>
                <c:formatCode>General</c:formatCode>
                <c:ptCount val="14"/>
                <c:pt idx="0">
                  <c:v>8.493461967289381</c:v>
                </c:pt>
                <c:pt idx="1">
                  <c:v>3.3132963079349058</c:v>
                </c:pt>
                <c:pt idx="2">
                  <c:v>10.237427799116634</c:v>
                </c:pt>
                <c:pt idx="3">
                  <c:v>11.221835857127461</c:v>
                </c:pt>
                <c:pt idx="4">
                  <c:v>2.941277821730639</c:v>
                </c:pt>
                <c:pt idx="5">
                  <c:v>11.719539469492654</c:v>
                </c:pt>
                <c:pt idx="6">
                  <c:v>3.6794392929482806</c:v>
                </c:pt>
                <c:pt idx="7">
                  <c:v>4.033003052433445</c:v>
                </c:pt>
                <c:pt idx="8">
                  <c:v>1.73847950454019</c:v>
                </c:pt>
                <c:pt idx="9">
                  <c:v>5.6523246258338817</c:v>
                </c:pt>
                <c:pt idx="10">
                  <c:v>2.5639048646878169</c:v>
                </c:pt>
                <c:pt idx="11">
                  <c:v>22.589029342071292</c:v>
                </c:pt>
                <c:pt idx="12">
                  <c:v>0.62270830716798098</c:v>
                </c:pt>
                <c:pt idx="13">
                  <c:v>11.194271787625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421-4403-A889-C462BD2EAC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445620208"/>
        <c:axId val="445621848"/>
      </c:barChart>
      <c:catAx>
        <c:axId val="445620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5621848"/>
        <c:crosses val="autoZero"/>
        <c:auto val="1"/>
        <c:lblAlgn val="ctr"/>
        <c:lblOffset val="100"/>
        <c:noMultiLvlLbl val="0"/>
      </c:catAx>
      <c:valAx>
        <c:axId val="445621848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</a:p>
            </c:rich>
          </c:tx>
          <c:layout>
            <c:manualLayout>
              <c:xMode val="edge"/>
              <c:yMode val="edge"/>
              <c:x val="1.2459969798383647E-2"/>
              <c:y val="0.267945310309135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5620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/>
              <a:t>EPA2016.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7851646686056412E-2"/>
          <c:y val="2.3603564339550243E-2"/>
          <c:w val="0.89442151479545318"/>
          <c:h val="0.67655298559747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PA2016.1'!$B$5</c:f>
              <c:strCache>
                <c:ptCount val="1"/>
                <c:pt idx="0">
                  <c:v>E1.9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5:$P$5</c:f>
              <c:numCache>
                <c:formatCode>General</c:formatCode>
                <c:ptCount val="14"/>
                <c:pt idx="0">
                  <c:v>8.2887846995524264</c:v>
                </c:pt>
                <c:pt idx="1">
                  <c:v>3.1790616657266288</c:v>
                </c:pt>
                <c:pt idx="2">
                  <c:v>11.693626699697813</c:v>
                </c:pt>
                <c:pt idx="3">
                  <c:v>13.942998509095201</c:v>
                </c:pt>
                <c:pt idx="4">
                  <c:v>2.25975821488914</c:v>
                </c:pt>
                <c:pt idx="5">
                  <c:v>16.53904054579354</c:v>
                </c:pt>
                <c:pt idx="6">
                  <c:v>3.302385479317667</c:v>
                </c:pt>
                <c:pt idx="7">
                  <c:v>5.3882121148262252</c:v>
                </c:pt>
                <c:pt idx="8">
                  <c:v>1.1041434217860804</c:v>
                </c:pt>
                <c:pt idx="9">
                  <c:v>3.9748080089477762</c:v>
                </c:pt>
                <c:pt idx="10">
                  <c:v>1.9474644686643643</c:v>
                </c:pt>
                <c:pt idx="11">
                  <c:v>19.249135360531124</c:v>
                </c:pt>
                <c:pt idx="12">
                  <c:v>0.60604258812069822</c:v>
                </c:pt>
                <c:pt idx="13">
                  <c:v>8.52453822305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C5-4C8D-B3C1-ABD3B7B94A77}"/>
            </c:ext>
          </c:extLst>
        </c:ser>
        <c:ser>
          <c:idx val="1"/>
          <c:order val="1"/>
          <c:tx>
            <c:strRef>
              <c:f>'EPA2016.1'!$B$6</c:f>
              <c:strCache>
                <c:ptCount val="1"/>
                <c:pt idx="0">
                  <c:v>E1.10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6:$P$6</c:f>
              <c:numCache>
                <c:formatCode>General</c:formatCode>
                <c:ptCount val="14"/>
                <c:pt idx="0">
                  <c:v>8.592728424160196</c:v>
                </c:pt>
                <c:pt idx="1">
                  <c:v>2.7988137578363963</c:v>
                </c:pt>
                <c:pt idx="2">
                  <c:v>13.720553811148179</c:v>
                </c:pt>
                <c:pt idx="3">
                  <c:v>15.824760112518639</c:v>
                </c:pt>
                <c:pt idx="4">
                  <c:v>1.9399524087937361</c:v>
                </c:pt>
                <c:pt idx="5">
                  <c:v>13.96712226933278</c:v>
                </c:pt>
                <c:pt idx="6">
                  <c:v>2.3636304110238653</c:v>
                </c:pt>
                <c:pt idx="7">
                  <c:v>4.6471691962912152</c:v>
                </c:pt>
                <c:pt idx="8">
                  <c:v>0.98833514726210492</c:v>
                </c:pt>
                <c:pt idx="9">
                  <c:v>5.8514085504714153</c:v>
                </c:pt>
                <c:pt idx="10">
                  <c:v>1.3049232889782489</c:v>
                </c:pt>
                <c:pt idx="11">
                  <c:v>19.701856764072971</c:v>
                </c:pt>
                <c:pt idx="12">
                  <c:v>0.60445665942110305</c:v>
                </c:pt>
                <c:pt idx="13">
                  <c:v>7.69428919868914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2C5-4C8D-B3C1-ABD3B7B94A77}"/>
            </c:ext>
          </c:extLst>
        </c:ser>
        <c:ser>
          <c:idx val="2"/>
          <c:order val="2"/>
          <c:tx>
            <c:strRef>
              <c:f>'EPA2016.1'!$B$7</c:f>
              <c:strCache>
                <c:ptCount val="1"/>
                <c:pt idx="0">
                  <c:v>E1.2</c:v>
                </c:pt>
              </c:strCache>
            </c:strRef>
          </c:tx>
          <c:spPr>
            <a:solidFill>
              <a:schemeClr val="accent3">
                <a:tint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7:$P$7</c:f>
              <c:numCache>
                <c:formatCode>General</c:formatCode>
                <c:ptCount val="14"/>
                <c:pt idx="0">
                  <c:v>8.5044583304281218</c:v>
                </c:pt>
                <c:pt idx="1">
                  <c:v>3.7383178411512081</c:v>
                </c:pt>
                <c:pt idx="2">
                  <c:v>13.314939021403385</c:v>
                </c:pt>
                <c:pt idx="3">
                  <c:v>12.365932028794511</c:v>
                </c:pt>
                <c:pt idx="4">
                  <c:v>2.9061047718502135</c:v>
                </c:pt>
                <c:pt idx="5">
                  <c:v>10.586329007871386</c:v>
                </c:pt>
                <c:pt idx="6">
                  <c:v>3.3857989496992897</c:v>
                </c:pt>
                <c:pt idx="7">
                  <c:v>3.9413192471510219</c:v>
                </c:pt>
                <c:pt idx="8">
                  <c:v>1.9985720260114299</c:v>
                </c:pt>
                <c:pt idx="9">
                  <c:v>5.707185620105637</c:v>
                </c:pt>
                <c:pt idx="10">
                  <c:v>2.619455453421565</c:v>
                </c:pt>
                <c:pt idx="11">
                  <c:v>20.126176531320933</c:v>
                </c:pt>
                <c:pt idx="12">
                  <c:v>0.62354008772305913</c:v>
                </c:pt>
                <c:pt idx="13">
                  <c:v>10.181871083068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2C5-4C8D-B3C1-ABD3B7B94A77}"/>
            </c:ext>
          </c:extLst>
        </c:ser>
        <c:ser>
          <c:idx val="3"/>
          <c:order val="3"/>
          <c:tx>
            <c:strRef>
              <c:f>'EPA2016.1'!$B$8</c:f>
              <c:strCache>
                <c:ptCount val="1"/>
                <c:pt idx="0">
                  <c:v>E1.24</c:v>
                </c:pt>
              </c:strCache>
            </c:strRef>
          </c:tx>
          <c:spPr>
            <a:solidFill>
              <a:schemeClr val="accent3">
                <a:tint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8:$P$8</c:f>
              <c:numCache>
                <c:formatCode>General</c:formatCode>
                <c:ptCount val="14"/>
                <c:pt idx="0">
                  <c:v>8.3960857212878999</c:v>
                </c:pt>
                <c:pt idx="1">
                  <c:v>4.2013526487386441</c:v>
                </c:pt>
                <c:pt idx="2">
                  <c:v>12.263106745881668</c:v>
                </c:pt>
                <c:pt idx="3">
                  <c:v>14.824223946391266</c:v>
                </c:pt>
                <c:pt idx="4">
                  <c:v>2.2572417622253518</c:v>
                </c:pt>
                <c:pt idx="5">
                  <c:v>10.360818073108248</c:v>
                </c:pt>
                <c:pt idx="6">
                  <c:v>2.3775105906127711</c:v>
                </c:pt>
                <c:pt idx="7">
                  <c:v>3.5740711711105235</c:v>
                </c:pt>
                <c:pt idx="8">
                  <c:v>1.6928166029980409</c:v>
                </c:pt>
                <c:pt idx="9">
                  <c:v>5.3314594901612953</c:v>
                </c:pt>
                <c:pt idx="10">
                  <c:v>1.8756728945856587</c:v>
                </c:pt>
                <c:pt idx="11">
                  <c:v>20.242248143031585</c:v>
                </c:pt>
                <c:pt idx="12">
                  <c:v>0.55633077308732048</c:v>
                </c:pt>
                <c:pt idx="13">
                  <c:v>12.047061436779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2C5-4C8D-B3C1-ABD3B7B94A77}"/>
            </c:ext>
          </c:extLst>
        </c:ser>
        <c:ser>
          <c:idx val="4"/>
          <c:order val="4"/>
          <c:tx>
            <c:strRef>
              <c:f>'EPA2016.1'!$B$9</c:f>
              <c:strCache>
                <c:ptCount val="1"/>
                <c:pt idx="0">
                  <c:v>E1.13</c:v>
                </c:pt>
              </c:strCache>
            </c:strRef>
          </c:tx>
          <c:spPr>
            <a:solidFill>
              <a:schemeClr val="accent3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9:$P$9</c:f>
              <c:numCache>
                <c:formatCode>General</c:formatCode>
                <c:ptCount val="14"/>
                <c:pt idx="0">
                  <c:v>8.1432239899998766</c:v>
                </c:pt>
                <c:pt idx="1">
                  <c:v>4.0470510525092536</c:v>
                </c:pt>
                <c:pt idx="2">
                  <c:v>11.497662335921516</c:v>
                </c:pt>
                <c:pt idx="3">
                  <c:v>12.337174656991598</c:v>
                </c:pt>
                <c:pt idx="4">
                  <c:v>2.712804292999103</c:v>
                </c:pt>
                <c:pt idx="5">
                  <c:v>12.698506764963103</c:v>
                </c:pt>
                <c:pt idx="6">
                  <c:v>3.0559245861157325</c:v>
                </c:pt>
                <c:pt idx="7">
                  <c:v>4.0855342750953323</c:v>
                </c:pt>
                <c:pt idx="8">
                  <c:v>1.6611528263858397</c:v>
                </c:pt>
                <c:pt idx="9">
                  <c:v>4.2865762118799111</c:v>
                </c:pt>
                <c:pt idx="10">
                  <c:v>2.712602602840525</c:v>
                </c:pt>
                <c:pt idx="11">
                  <c:v>20.625533896803894</c:v>
                </c:pt>
                <c:pt idx="12">
                  <c:v>0.54177017894733048</c:v>
                </c:pt>
                <c:pt idx="13">
                  <c:v>11.594482328546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2C5-4C8D-B3C1-ABD3B7B94A77}"/>
            </c:ext>
          </c:extLst>
        </c:ser>
        <c:ser>
          <c:idx val="5"/>
          <c:order val="5"/>
          <c:tx>
            <c:strRef>
              <c:f>'EPA2016.1'!$B$10</c:f>
              <c:strCache>
                <c:ptCount val="1"/>
                <c:pt idx="0">
                  <c:v>E1.26</c:v>
                </c:pt>
              </c:strCache>
            </c:strRef>
          </c:tx>
          <c:spPr>
            <a:solidFill>
              <a:schemeClr val="accent3">
                <a:tint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0:$P$10</c:f>
              <c:numCache>
                <c:formatCode>General</c:formatCode>
                <c:ptCount val="14"/>
                <c:pt idx="0">
                  <c:v>8.5916758874460015</c:v>
                </c:pt>
                <c:pt idx="1">
                  <c:v>3.1660082025500533</c:v>
                </c:pt>
                <c:pt idx="2">
                  <c:v>15.153599186431428</c:v>
                </c:pt>
                <c:pt idx="3">
                  <c:v>13.006966916133804</c:v>
                </c:pt>
                <c:pt idx="4">
                  <c:v>2.7254347426015135</c:v>
                </c:pt>
                <c:pt idx="5">
                  <c:v>12.054492583554998</c:v>
                </c:pt>
                <c:pt idx="6">
                  <c:v>3.4032344371469181</c:v>
                </c:pt>
                <c:pt idx="7">
                  <c:v>3.5339811640898477</c:v>
                </c:pt>
                <c:pt idx="8">
                  <c:v>1.4323126725425279</c:v>
                </c:pt>
                <c:pt idx="9">
                  <c:v>5.7950849829026536</c:v>
                </c:pt>
                <c:pt idx="10">
                  <c:v>2.0068652728934531</c:v>
                </c:pt>
                <c:pt idx="11">
                  <c:v>20.634856038401729</c:v>
                </c:pt>
                <c:pt idx="12">
                  <c:v>0.50514738050356001</c:v>
                </c:pt>
                <c:pt idx="13">
                  <c:v>7.9903405328014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2C5-4C8D-B3C1-ABD3B7B94A77}"/>
            </c:ext>
          </c:extLst>
        </c:ser>
        <c:ser>
          <c:idx val="6"/>
          <c:order val="6"/>
          <c:tx>
            <c:strRef>
              <c:f>'EPA2016.1'!$B$11</c:f>
              <c:strCache>
                <c:ptCount val="1"/>
                <c:pt idx="0">
                  <c:v>E1.5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1:$P$11</c:f>
              <c:numCache>
                <c:formatCode>General</c:formatCode>
                <c:ptCount val="14"/>
                <c:pt idx="0">
                  <c:v>7.3089163528991641</c:v>
                </c:pt>
                <c:pt idx="1">
                  <c:v>3.4595443519159419</c:v>
                </c:pt>
                <c:pt idx="2">
                  <c:v>14.845036033560959</c:v>
                </c:pt>
                <c:pt idx="3">
                  <c:v>11.92173859368852</c:v>
                </c:pt>
                <c:pt idx="4">
                  <c:v>2.4590932721737873</c:v>
                </c:pt>
                <c:pt idx="5">
                  <c:v>12.151476023143507</c:v>
                </c:pt>
                <c:pt idx="6">
                  <c:v>2.9307713900762469</c:v>
                </c:pt>
                <c:pt idx="7">
                  <c:v>4.2390467503534257</c:v>
                </c:pt>
                <c:pt idx="8">
                  <c:v>1.447430826294348</c:v>
                </c:pt>
                <c:pt idx="9">
                  <c:v>4.6356686874197344</c:v>
                </c:pt>
                <c:pt idx="10">
                  <c:v>2.2864233946118966</c:v>
                </c:pt>
                <c:pt idx="11">
                  <c:v>20.700794157178883</c:v>
                </c:pt>
                <c:pt idx="12">
                  <c:v>0.55535262437926547</c:v>
                </c:pt>
                <c:pt idx="13">
                  <c:v>11.0587075423043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2C5-4C8D-B3C1-ABD3B7B94A77}"/>
            </c:ext>
          </c:extLst>
        </c:ser>
        <c:ser>
          <c:idx val="7"/>
          <c:order val="7"/>
          <c:tx>
            <c:strRef>
              <c:f>'EPA2016.1'!$B$12</c:f>
              <c:strCache>
                <c:ptCount val="1"/>
                <c:pt idx="0">
                  <c:v>E1.18</c:v>
                </c:pt>
              </c:strCache>
            </c:strRef>
          </c:tx>
          <c:spPr>
            <a:solidFill>
              <a:schemeClr val="accent3">
                <a:tint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2:$P$12</c:f>
              <c:numCache>
                <c:formatCode>General</c:formatCode>
                <c:ptCount val="14"/>
                <c:pt idx="0">
                  <c:v>9.1525277644784904</c:v>
                </c:pt>
                <c:pt idx="1">
                  <c:v>4.0797756104347256</c:v>
                </c:pt>
                <c:pt idx="2">
                  <c:v>17.285929313846811</c:v>
                </c:pt>
                <c:pt idx="3">
                  <c:v>11.949103756868309</c:v>
                </c:pt>
                <c:pt idx="4">
                  <c:v>1.8290328709076045</c:v>
                </c:pt>
                <c:pt idx="5">
                  <c:v>9.7545374991809979</c:v>
                </c:pt>
                <c:pt idx="6">
                  <c:v>2.3060238621628653</c:v>
                </c:pt>
                <c:pt idx="7">
                  <c:v>4.2899501744520459</c:v>
                </c:pt>
                <c:pt idx="8">
                  <c:v>1.3865065479259682</c:v>
                </c:pt>
                <c:pt idx="9">
                  <c:v>5.5890540994154625</c:v>
                </c:pt>
                <c:pt idx="10">
                  <c:v>1.7624474981791936</c:v>
                </c:pt>
                <c:pt idx="11">
                  <c:v>21.062487384081923</c:v>
                </c:pt>
                <c:pt idx="12">
                  <c:v>0.71564266409761401</c:v>
                </c:pt>
                <c:pt idx="13">
                  <c:v>8.83698095396797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2C5-4C8D-B3C1-ABD3B7B94A77}"/>
            </c:ext>
          </c:extLst>
        </c:ser>
        <c:ser>
          <c:idx val="8"/>
          <c:order val="8"/>
          <c:tx>
            <c:strRef>
              <c:f>'EPA2016.1'!$B$13</c:f>
              <c:strCache>
                <c:ptCount val="1"/>
                <c:pt idx="0">
                  <c:v>E1.28</c:v>
                </c:pt>
              </c:strCache>
            </c:strRef>
          </c:tx>
          <c:spPr>
            <a:solidFill>
              <a:schemeClr val="accent3">
                <a:tint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3:$P$13</c:f>
              <c:numCache>
                <c:formatCode>General</c:formatCode>
                <c:ptCount val="14"/>
                <c:pt idx="0">
                  <c:v>8.409748334205398</c:v>
                </c:pt>
                <c:pt idx="1">
                  <c:v>3.8126815041133555</c:v>
                </c:pt>
                <c:pt idx="2">
                  <c:v>12.894047256320462</c:v>
                </c:pt>
                <c:pt idx="3">
                  <c:v>12.134057307188304</c:v>
                </c:pt>
                <c:pt idx="4">
                  <c:v>2.3459688256430771</c:v>
                </c:pt>
                <c:pt idx="5">
                  <c:v>10.724288601475378</c:v>
                </c:pt>
                <c:pt idx="6">
                  <c:v>2.7883155043076582</c:v>
                </c:pt>
                <c:pt idx="7">
                  <c:v>5.4042416628927743</c:v>
                </c:pt>
                <c:pt idx="8">
                  <c:v>1.8344869498779848</c:v>
                </c:pt>
                <c:pt idx="9">
                  <c:v>4.926543641562013</c:v>
                </c:pt>
                <c:pt idx="10">
                  <c:v>2.6263037416117601</c:v>
                </c:pt>
                <c:pt idx="11">
                  <c:v>21.449534557696708</c:v>
                </c:pt>
                <c:pt idx="12">
                  <c:v>0.85761855660334207</c:v>
                </c:pt>
                <c:pt idx="13">
                  <c:v>9.79216355650177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2C5-4C8D-B3C1-ABD3B7B94A77}"/>
            </c:ext>
          </c:extLst>
        </c:ser>
        <c:ser>
          <c:idx val="9"/>
          <c:order val="9"/>
          <c:tx>
            <c:strRef>
              <c:f>'EPA2016.1'!$B$14</c:f>
              <c:strCache>
                <c:ptCount val="1"/>
                <c:pt idx="0">
                  <c:v>E1.27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4:$P$14</c:f>
              <c:numCache>
                <c:formatCode>General</c:formatCode>
                <c:ptCount val="14"/>
                <c:pt idx="0">
                  <c:v>8.8028763963203449</c:v>
                </c:pt>
                <c:pt idx="1">
                  <c:v>3.2574422353153563</c:v>
                </c:pt>
                <c:pt idx="2">
                  <c:v>10.910521582284535</c:v>
                </c:pt>
                <c:pt idx="3">
                  <c:v>11.959285518304224</c:v>
                </c:pt>
                <c:pt idx="4">
                  <c:v>3.3919883448834507</c:v>
                </c:pt>
                <c:pt idx="5">
                  <c:v>11.63507165873736</c:v>
                </c:pt>
                <c:pt idx="6">
                  <c:v>4.1407158559396526</c:v>
                </c:pt>
                <c:pt idx="7">
                  <c:v>4.1415704220136638</c:v>
                </c:pt>
                <c:pt idx="8">
                  <c:v>1.9045318181769948</c:v>
                </c:pt>
                <c:pt idx="9">
                  <c:v>5.1460812600594501</c:v>
                </c:pt>
                <c:pt idx="10">
                  <c:v>2.7575800440506861</c:v>
                </c:pt>
                <c:pt idx="11">
                  <c:v>21.50744329215965</c:v>
                </c:pt>
                <c:pt idx="12">
                  <c:v>0.69078290018015809</c:v>
                </c:pt>
                <c:pt idx="13">
                  <c:v>9.75410867157446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2C5-4C8D-B3C1-ABD3B7B94A77}"/>
            </c:ext>
          </c:extLst>
        </c:ser>
        <c:ser>
          <c:idx val="10"/>
          <c:order val="10"/>
          <c:tx>
            <c:strRef>
              <c:f>'EPA2016.1'!$B$15</c:f>
              <c:strCache>
                <c:ptCount val="1"/>
                <c:pt idx="0">
                  <c:v>E1.29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5:$P$15</c:f>
              <c:numCache>
                <c:formatCode>General</c:formatCode>
                <c:ptCount val="14"/>
                <c:pt idx="0">
                  <c:v>9.0588824676860984</c:v>
                </c:pt>
                <c:pt idx="1">
                  <c:v>3.1508935126133677</c:v>
                </c:pt>
                <c:pt idx="2">
                  <c:v>14.190354135989772</c:v>
                </c:pt>
                <c:pt idx="3">
                  <c:v>13.036490779174899</c:v>
                </c:pt>
                <c:pt idx="4">
                  <c:v>2.5905016390675923</c:v>
                </c:pt>
                <c:pt idx="5">
                  <c:v>10.396281491862817</c:v>
                </c:pt>
                <c:pt idx="6">
                  <c:v>2.9059371225038606</c:v>
                </c:pt>
                <c:pt idx="7">
                  <c:v>3.8047720083974399</c:v>
                </c:pt>
                <c:pt idx="8">
                  <c:v>1.6829610002550186</c:v>
                </c:pt>
                <c:pt idx="9">
                  <c:v>6.4008370514470823</c:v>
                </c:pt>
                <c:pt idx="10">
                  <c:v>2.0555708522837315</c:v>
                </c:pt>
                <c:pt idx="11">
                  <c:v>21.908625829811868</c:v>
                </c:pt>
                <c:pt idx="12">
                  <c:v>0.6419501917318009</c:v>
                </c:pt>
                <c:pt idx="13">
                  <c:v>8.1759419171746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2C5-4C8D-B3C1-ABD3B7B94A77}"/>
            </c:ext>
          </c:extLst>
        </c:ser>
        <c:ser>
          <c:idx val="11"/>
          <c:order val="11"/>
          <c:tx>
            <c:strRef>
              <c:f>'EPA2016.1'!$B$16</c:f>
              <c:strCache>
                <c:ptCount val="1"/>
                <c:pt idx="0">
                  <c:v>E1.12</c:v>
                </c:pt>
              </c:strCache>
            </c:strRef>
          </c:tx>
          <c:spPr>
            <a:solidFill>
              <a:schemeClr val="accent3">
                <a:tint val="9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6:$P$16</c:f>
              <c:numCache>
                <c:formatCode>General</c:formatCode>
                <c:ptCount val="14"/>
                <c:pt idx="0">
                  <c:v>8.7831061897480698</c:v>
                </c:pt>
                <c:pt idx="1">
                  <c:v>3.2606571902315422</c:v>
                </c:pt>
                <c:pt idx="2">
                  <c:v>12.864625710867573</c:v>
                </c:pt>
                <c:pt idx="3">
                  <c:v>13.245386955599567</c:v>
                </c:pt>
                <c:pt idx="4">
                  <c:v>2.0556639225495936</c:v>
                </c:pt>
                <c:pt idx="5">
                  <c:v>13.33838019176781</c:v>
                </c:pt>
                <c:pt idx="6">
                  <c:v>2.8549608760890353</c:v>
                </c:pt>
                <c:pt idx="7">
                  <c:v>4.4558097929606335</c:v>
                </c:pt>
                <c:pt idx="8">
                  <c:v>0.9167037441820759</c:v>
                </c:pt>
                <c:pt idx="9">
                  <c:v>5.4334037777118063</c:v>
                </c:pt>
                <c:pt idx="10">
                  <c:v>1.3642072673636259</c:v>
                </c:pt>
                <c:pt idx="11">
                  <c:v>22.035240118041905</c:v>
                </c:pt>
                <c:pt idx="12">
                  <c:v>0.66738258240469217</c:v>
                </c:pt>
                <c:pt idx="13">
                  <c:v>8.7244716804820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2C5-4C8D-B3C1-ABD3B7B94A77}"/>
            </c:ext>
          </c:extLst>
        </c:ser>
        <c:ser>
          <c:idx val="12"/>
          <c:order val="12"/>
          <c:tx>
            <c:strRef>
              <c:f>'EPA2016.1'!$B$17</c:f>
              <c:strCache>
                <c:ptCount val="1"/>
                <c:pt idx="0">
                  <c:v>E1.16</c:v>
                </c:pt>
              </c:strCache>
            </c:strRef>
          </c:tx>
          <c:spPr>
            <a:solidFill>
              <a:schemeClr val="accent3">
                <a:tint val="9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7:$P$17</c:f>
              <c:numCache>
                <c:formatCode>General</c:formatCode>
                <c:ptCount val="14"/>
                <c:pt idx="0">
                  <c:v>9.3769209656570371</c:v>
                </c:pt>
                <c:pt idx="1">
                  <c:v>3.2474428365783115</c:v>
                </c:pt>
                <c:pt idx="2">
                  <c:v>12.492685211608034</c:v>
                </c:pt>
                <c:pt idx="3">
                  <c:v>13.784151500033994</c:v>
                </c:pt>
                <c:pt idx="4">
                  <c:v>3.0351347405237874</c:v>
                </c:pt>
                <c:pt idx="5">
                  <c:v>10.642500232914642</c:v>
                </c:pt>
                <c:pt idx="6">
                  <c:v>2.825797617861491</c:v>
                </c:pt>
                <c:pt idx="7">
                  <c:v>3.7427701906362665</c:v>
                </c:pt>
                <c:pt idx="8">
                  <c:v>1.5482783285299833</c:v>
                </c:pt>
                <c:pt idx="9">
                  <c:v>6.5395812311201791</c:v>
                </c:pt>
                <c:pt idx="10">
                  <c:v>1.9615817296742644</c:v>
                </c:pt>
                <c:pt idx="11">
                  <c:v>22.293128282327615</c:v>
                </c:pt>
                <c:pt idx="12">
                  <c:v>0.62644180989564335</c:v>
                </c:pt>
                <c:pt idx="13">
                  <c:v>7.88358532263873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2C5-4C8D-B3C1-ABD3B7B94A77}"/>
            </c:ext>
          </c:extLst>
        </c:ser>
        <c:ser>
          <c:idx val="13"/>
          <c:order val="13"/>
          <c:tx>
            <c:strRef>
              <c:f>'EPA2016.1'!$B$18</c:f>
              <c:strCache>
                <c:ptCount val="1"/>
                <c:pt idx="0">
                  <c:v>E1.7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8:$P$18</c:f>
              <c:numCache>
                <c:formatCode>General</c:formatCode>
                <c:ptCount val="14"/>
                <c:pt idx="0">
                  <c:v>8.3953667134152266</c:v>
                </c:pt>
                <c:pt idx="1">
                  <c:v>3.5892579920034295</c:v>
                </c:pt>
                <c:pt idx="2">
                  <c:v>15.421893708861864</c:v>
                </c:pt>
                <c:pt idx="3">
                  <c:v>11.717906950972987</c:v>
                </c:pt>
                <c:pt idx="4">
                  <c:v>2.3829688373598907</c:v>
                </c:pt>
                <c:pt idx="5">
                  <c:v>10.310728095131982</c:v>
                </c:pt>
                <c:pt idx="6">
                  <c:v>2.9072368490967437</c:v>
                </c:pt>
                <c:pt idx="7">
                  <c:v>4.0016252077508812</c:v>
                </c:pt>
                <c:pt idx="8">
                  <c:v>1.4323047601053889</c:v>
                </c:pt>
                <c:pt idx="9">
                  <c:v>5.4826995395192046</c:v>
                </c:pt>
                <c:pt idx="10">
                  <c:v>1.9219992274621447</c:v>
                </c:pt>
                <c:pt idx="11">
                  <c:v>22.296645947462199</c:v>
                </c:pt>
                <c:pt idx="12">
                  <c:v>0.73260975301369269</c:v>
                </c:pt>
                <c:pt idx="13">
                  <c:v>9.4067564178443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2C5-4C8D-B3C1-ABD3B7B94A77}"/>
            </c:ext>
          </c:extLst>
        </c:ser>
        <c:ser>
          <c:idx val="14"/>
          <c:order val="14"/>
          <c:tx>
            <c:strRef>
              <c:f>'EPA2016.1'!$B$19</c:f>
              <c:strCache>
                <c:ptCount val="1"/>
                <c:pt idx="0">
                  <c:v>E1.21</c:v>
                </c:pt>
              </c:strCache>
            </c:strRef>
          </c:tx>
          <c:spPr>
            <a:solidFill>
              <a:schemeClr val="accent3">
                <a:shade val="9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19:$P$19</c:f>
              <c:numCache>
                <c:formatCode>General</c:formatCode>
                <c:ptCount val="14"/>
                <c:pt idx="0">
                  <c:v>8.3062313419043967</c:v>
                </c:pt>
                <c:pt idx="1">
                  <c:v>3.6456221668941793</c:v>
                </c:pt>
                <c:pt idx="2">
                  <c:v>13.36691761048767</c:v>
                </c:pt>
                <c:pt idx="3">
                  <c:v>12.425166615339847</c:v>
                </c:pt>
                <c:pt idx="4">
                  <c:v>2.5488748343705914</c:v>
                </c:pt>
                <c:pt idx="5">
                  <c:v>10.703991780691245</c:v>
                </c:pt>
                <c:pt idx="6">
                  <c:v>2.6824621795774632</c:v>
                </c:pt>
                <c:pt idx="7">
                  <c:v>3.5965918821752947</c:v>
                </c:pt>
                <c:pt idx="8">
                  <c:v>1.4503363157700544</c:v>
                </c:pt>
                <c:pt idx="9">
                  <c:v>5.5812264225802224</c:v>
                </c:pt>
                <c:pt idx="10">
                  <c:v>1.95350152000821</c:v>
                </c:pt>
                <c:pt idx="11">
                  <c:v>22.378621219699141</c:v>
                </c:pt>
                <c:pt idx="12">
                  <c:v>0.6315621506621959</c:v>
                </c:pt>
                <c:pt idx="13">
                  <c:v>10.7288939598394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E2C5-4C8D-B3C1-ABD3B7B94A77}"/>
            </c:ext>
          </c:extLst>
        </c:ser>
        <c:ser>
          <c:idx val="15"/>
          <c:order val="15"/>
          <c:tx>
            <c:strRef>
              <c:f>'EPA2016.1'!$B$20</c:f>
              <c:strCache>
                <c:ptCount val="1"/>
                <c:pt idx="0">
                  <c:v>E1.1</c:v>
                </c:pt>
              </c:strCache>
            </c:strRef>
          </c:tx>
          <c:spPr>
            <a:solidFill>
              <a:schemeClr val="accent3">
                <a:shade val="9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0:$P$20</c:f>
              <c:numCache>
                <c:formatCode>General</c:formatCode>
                <c:ptCount val="14"/>
                <c:pt idx="0">
                  <c:v>8.7232309498052913</c:v>
                </c:pt>
                <c:pt idx="1">
                  <c:v>2.8116622418633099</c:v>
                </c:pt>
                <c:pt idx="2">
                  <c:v>13.78970004361457</c:v>
                </c:pt>
                <c:pt idx="3">
                  <c:v>13.698435566839009</c:v>
                </c:pt>
                <c:pt idx="4">
                  <c:v>2.2763850417058022</c:v>
                </c:pt>
                <c:pt idx="5">
                  <c:v>10.777375304723678</c:v>
                </c:pt>
                <c:pt idx="6">
                  <c:v>2.428682128370208</c:v>
                </c:pt>
                <c:pt idx="7">
                  <c:v>3.491077885081816</c:v>
                </c:pt>
                <c:pt idx="8">
                  <c:v>1.5488811327471941</c:v>
                </c:pt>
                <c:pt idx="9">
                  <c:v>6.0364423847108517</c:v>
                </c:pt>
                <c:pt idx="10">
                  <c:v>2.0936082876252415</c:v>
                </c:pt>
                <c:pt idx="11">
                  <c:v>23.197365805014556</c:v>
                </c:pt>
                <c:pt idx="12">
                  <c:v>0.66968123901190324</c:v>
                </c:pt>
                <c:pt idx="13">
                  <c:v>8.45747198888659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E2C5-4C8D-B3C1-ABD3B7B94A77}"/>
            </c:ext>
          </c:extLst>
        </c:ser>
        <c:ser>
          <c:idx val="16"/>
          <c:order val="16"/>
          <c:tx>
            <c:strRef>
              <c:f>'EPA2016.1'!$B$21</c:f>
              <c:strCache>
                <c:ptCount val="1"/>
                <c:pt idx="0">
                  <c:v>E1.25</c:v>
                </c:pt>
              </c:strCache>
            </c:strRef>
          </c:tx>
          <c:spPr>
            <a:solidFill>
              <a:schemeClr val="accent3">
                <a:shade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1:$P$21</c:f>
              <c:numCache>
                <c:formatCode>General</c:formatCode>
                <c:ptCount val="14"/>
                <c:pt idx="0">
                  <c:v>9.0937375145380308</c:v>
                </c:pt>
                <c:pt idx="1">
                  <c:v>4.2317028755964801</c:v>
                </c:pt>
                <c:pt idx="2">
                  <c:v>13.176618505483177</c:v>
                </c:pt>
                <c:pt idx="3">
                  <c:v>10.319465783816957</c:v>
                </c:pt>
                <c:pt idx="4">
                  <c:v>2.2309671672260372</c:v>
                </c:pt>
                <c:pt idx="5">
                  <c:v>9.7700586599998136</c:v>
                </c:pt>
                <c:pt idx="6">
                  <c:v>2.9672070884536614</c:v>
                </c:pt>
                <c:pt idx="7">
                  <c:v>3.6093119345670139</c:v>
                </c:pt>
                <c:pt idx="8">
                  <c:v>1.5425241650643986</c:v>
                </c:pt>
                <c:pt idx="9">
                  <c:v>4.4591816390780536</c:v>
                </c:pt>
                <c:pt idx="10">
                  <c:v>2.5853228244161119</c:v>
                </c:pt>
                <c:pt idx="11">
                  <c:v>23.287754514462023</c:v>
                </c:pt>
                <c:pt idx="12">
                  <c:v>0.91725651837210853</c:v>
                </c:pt>
                <c:pt idx="13">
                  <c:v>11.808890808926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2C5-4C8D-B3C1-ABD3B7B94A77}"/>
            </c:ext>
          </c:extLst>
        </c:ser>
        <c:ser>
          <c:idx val="17"/>
          <c:order val="17"/>
          <c:tx>
            <c:strRef>
              <c:f>'EPA2016.1'!$B$22</c:f>
              <c:strCache>
                <c:ptCount val="1"/>
                <c:pt idx="0">
                  <c:v>E1.4</c:v>
                </c:pt>
              </c:strCache>
            </c:strRef>
          </c:tx>
          <c:spPr>
            <a:solidFill>
              <a:schemeClr val="accent3">
                <a:shade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2:$P$22</c:f>
              <c:numCache>
                <c:formatCode>General</c:formatCode>
                <c:ptCount val="14"/>
                <c:pt idx="0">
                  <c:v>7.8651282512402432</c:v>
                </c:pt>
                <c:pt idx="1">
                  <c:v>2.9893259054194101</c:v>
                </c:pt>
                <c:pt idx="2">
                  <c:v>9.8783526847087106</c:v>
                </c:pt>
                <c:pt idx="3">
                  <c:v>12.71992061284516</c:v>
                </c:pt>
                <c:pt idx="4">
                  <c:v>2.1334966458896196</c:v>
                </c:pt>
                <c:pt idx="5">
                  <c:v>16.821097077252865</c:v>
                </c:pt>
                <c:pt idx="6">
                  <c:v>4.0665244381853869</c:v>
                </c:pt>
                <c:pt idx="7">
                  <c:v>4.3003677250279821</c:v>
                </c:pt>
                <c:pt idx="8">
                  <c:v>0.97477371690036541</c:v>
                </c:pt>
                <c:pt idx="9">
                  <c:v>4.1437127430593854</c:v>
                </c:pt>
                <c:pt idx="10">
                  <c:v>1.9355367229079157</c:v>
                </c:pt>
                <c:pt idx="11">
                  <c:v>23.292033792053417</c:v>
                </c:pt>
                <c:pt idx="12">
                  <c:v>0.62859803482023413</c:v>
                </c:pt>
                <c:pt idx="13">
                  <c:v>8.25113164968930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E2C5-4C8D-B3C1-ABD3B7B94A77}"/>
            </c:ext>
          </c:extLst>
        </c:ser>
        <c:ser>
          <c:idx val="18"/>
          <c:order val="18"/>
          <c:tx>
            <c:strRef>
              <c:f>'EPA2016.1'!$B$23</c:f>
              <c:strCache>
                <c:ptCount val="1"/>
                <c:pt idx="0">
                  <c:v>E1.20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3:$P$23</c:f>
              <c:numCache>
                <c:formatCode>General</c:formatCode>
                <c:ptCount val="14"/>
                <c:pt idx="0">
                  <c:v>9.1856137226799266</c:v>
                </c:pt>
                <c:pt idx="1">
                  <c:v>3.0360108089599853</c:v>
                </c:pt>
                <c:pt idx="2">
                  <c:v>11.7218045789346</c:v>
                </c:pt>
                <c:pt idx="3">
                  <c:v>12.048739152087085</c:v>
                </c:pt>
                <c:pt idx="4">
                  <c:v>2.8646568603627305</c:v>
                </c:pt>
                <c:pt idx="5">
                  <c:v>12.649760165961203</c:v>
                </c:pt>
                <c:pt idx="6">
                  <c:v>3.9689843432194438</c:v>
                </c:pt>
                <c:pt idx="7">
                  <c:v>3.6383124820104507</c:v>
                </c:pt>
                <c:pt idx="8">
                  <c:v>1.4624847179743103</c:v>
                </c:pt>
                <c:pt idx="9">
                  <c:v>5.4199532439874476</c:v>
                </c:pt>
                <c:pt idx="10">
                  <c:v>2.2959389857809427</c:v>
                </c:pt>
                <c:pt idx="11">
                  <c:v>23.491255906715249</c:v>
                </c:pt>
                <c:pt idx="12">
                  <c:v>0.69949332122137131</c:v>
                </c:pt>
                <c:pt idx="13">
                  <c:v>7.5169917101052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E2C5-4C8D-B3C1-ABD3B7B94A77}"/>
            </c:ext>
          </c:extLst>
        </c:ser>
        <c:ser>
          <c:idx val="19"/>
          <c:order val="19"/>
          <c:tx>
            <c:strRef>
              <c:f>'EPA2016.1'!$B$24</c:f>
              <c:strCache>
                <c:ptCount val="1"/>
                <c:pt idx="0">
                  <c:v>E1.22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4:$P$24</c:f>
              <c:numCache>
                <c:formatCode>General</c:formatCode>
                <c:ptCount val="14"/>
                <c:pt idx="0">
                  <c:v>8.6981625863466263</c:v>
                </c:pt>
                <c:pt idx="1">
                  <c:v>2.9945870784817679</c:v>
                </c:pt>
                <c:pt idx="2">
                  <c:v>13.334827306982993</c:v>
                </c:pt>
                <c:pt idx="3">
                  <c:v>11.841777015378106</c:v>
                </c:pt>
                <c:pt idx="4">
                  <c:v>2.4871514520564597</c:v>
                </c:pt>
                <c:pt idx="5">
                  <c:v>11.691433421290904</c:v>
                </c:pt>
                <c:pt idx="6">
                  <c:v>3.4930122862261097</c:v>
                </c:pt>
                <c:pt idx="7">
                  <c:v>3.6344429544152477</c:v>
                </c:pt>
                <c:pt idx="8">
                  <c:v>1.5424617633938869</c:v>
                </c:pt>
                <c:pt idx="9">
                  <c:v>5.3381664880451893</c:v>
                </c:pt>
                <c:pt idx="10">
                  <c:v>2.4007588905509736</c:v>
                </c:pt>
                <c:pt idx="11">
                  <c:v>23.53433960338446</c:v>
                </c:pt>
                <c:pt idx="12">
                  <c:v>0.79810107498369898</c:v>
                </c:pt>
                <c:pt idx="13">
                  <c:v>8.21077807846357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E2C5-4C8D-B3C1-ABD3B7B94A77}"/>
            </c:ext>
          </c:extLst>
        </c:ser>
        <c:ser>
          <c:idx val="20"/>
          <c:order val="20"/>
          <c:tx>
            <c:strRef>
              <c:f>'EPA2016.1'!$B$25</c:f>
              <c:strCache>
                <c:ptCount val="1"/>
                <c:pt idx="0">
                  <c:v>E1.23</c:v>
                </c:pt>
              </c:strCache>
            </c:strRef>
          </c:tx>
          <c:spPr>
            <a:solidFill>
              <a:schemeClr val="accent3">
                <a:shade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5:$P$25</c:f>
              <c:numCache>
                <c:formatCode>General</c:formatCode>
                <c:ptCount val="14"/>
                <c:pt idx="0">
                  <c:v>9.0140571776820622</c:v>
                </c:pt>
                <c:pt idx="1">
                  <c:v>3.4888092526890819</c:v>
                </c:pt>
                <c:pt idx="2">
                  <c:v>12.510071186162396</c:v>
                </c:pt>
                <c:pt idx="3">
                  <c:v>11.393884221176487</c:v>
                </c:pt>
                <c:pt idx="4">
                  <c:v>2.5750712151893946</c:v>
                </c:pt>
                <c:pt idx="5">
                  <c:v>11.38410397633112</c:v>
                </c:pt>
                <c:pt idx="6">
                  <c:v>3.3242566651491914</c:v>
                </c:pt>
                <c:pt idx="7">
                  <c:v>3.6761315098144083</c:v>
                </c:pt>
                <c:pt idx="8">
                  <c:v>1.5164826844480441</c:v>
                </c:pt>
                <c:pt idx="9">
                  <c:v>5.7548923241707408</c:v>
                </c:pt>
                <c:pt idx="10">
                  <c:v>2.2302476262198452</c:v>
                </c:pt>
                <c:pt idx="11">
                  <c:v>23.869191597414755</c:v>
                </c:pt>
                <c:pt idx="12">
                  <c:v>0.74463249618966698</c:v>
                </c:pt>
                <c:pt idx="13">
                  <c:v>8.5181680673628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E2C5-4C8D-B3C1-ABD3B7B94A77}"/>
            </c:ext>
          </c:extLst>
        </c:ser>
        <c:ser>
          <c:idx val="21"/>
          <c:order val="21"/>
          <c:tx>
            <c:strRef>
              <c:f>'EPA2016.1'!$B$26</c:f>
              <c:strCache>
                <c:ptCount val="1"/>
                <c:pt idx="0">
                  <c:v>E1.17</c:v>
                </c:pt>
              </c:strCache>
            </c:strRef>
          </c:tx>
          <c:spPr>
            <a:solidFill>
              <a:schemeClr val="accent3">
                <a:shade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6:$P$26</c:f>
              <c:numCache>
                <c:formatCode>General</c:formatCode>
                <c:ptCount val="14"/>
                <c:pt idx="0">
                  <c:v>8.843756822860966</c:v>
                </c:pt>
                <c:pt idx="1">
                  <c:v>3.3972194145084527</c:v>
                </c:pt>
                <c:pt idx="2">
                  <c:v>10.072513330350546</c:v>
                </c:pt>
                <c:pt idx="3">
                  <c:v>9.3149737455581931</c:v>
                </c:pt>
                <c:pt idx="4">
                  <c:v>2.007622467195235</c:v>
                </c:pt>
                <c:pt idx="5">
                  <c:v>14.897129545833955</c:v>
                </c:pt>
                <c:pt idx="6">
                  <c:v>4.4451482114951446</c:v>
                </c:pt>
                <c:pt idx="7">
                  <c:v>5.4973196024282922</c:v>
                </c:pt>
                <c:pt idx="8">
                  <c:v>1.0225011700365918</c:v>
                </c:pt>
                <c:pt idx="9">
                  <c:v>4.703153316892732</c:v>
                </c:pt>
                <c:pt idx="10">
                  <c:v>2.1640755356142423</c:v>
                </c:pt>
                <c:pt idx="11">
                  <c:v>24.002732826139514</c:v>
                </c:pt>
                <c:pt idx="12">
                  <c:v>0.82466186686852905</c:v>
                </c:pt>
                <c:pt idx="13">
                  <c:v>8.8071921442176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E2C5-4C8D-B3C1-ABD3B7B94A77}"/>
            </c:ext>
          </c:extLst>
        </c:ser>
        <c:ser>
          <c:idx val="22"/>
          <c:order val="22"/>
          <c:tx>
            <c:strRef>
              <c:f>'EPA2016.1'!$B$27</c:f>
              <c:strCache>
                <c:ptCount val="1"/>
                <c:pt idx="0">
                  <c:v>E1.6</c:v>
                </c:pt>
              </c:strCache>
            </c:strRef>
          </c:tx>
          <c:spPr>
            <a:solidFill>
              <a:schemeClr val="accent3">
                <a:shade val="5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7:$P$27</c:f>
              <c:numCache>
                <c:formatCode>General</c:formatCode>
                <c:ptCount val="14"/>
                <c:pt idx="0">
                  <c:v>9.4015560974309</c:v>
                </c:pt>
                <c:pt idx="1">
                  <c:v>3.4826488210495046</c:v>
                </c:pt>
                <c:pt idx="2">
                  <c:v>11.288920651113775</c:v>
                </c:pt>
                <c:pt idx="3">
                  <c:v>9.4162353864603983</c:v>
                </c:pt>
                <c:pt idx="4">
                  <c:v>1.9332417086157432</c:v>
                </c:pt>
                <c:pt idx="5">
                  <c:v>14.441412859231034</c:v>
                </c:pt>
                <c:pt idx="6">
                  <c:v>4.2269657638546656</c:v>
                </c:pt>
                <c:pt idx="7">
                  <c:v>5.0466458861478074</c:v>
                </c:pt>
                <c:pt idx="8">
                  <c:v>0.78799239814493638</c:v>
                </c:pt>
                <c:pt idx="9">
                  <c:v>4.043671079051582</c:v>
                </c:pt>
                <c:pt idx="10">
                  <c:v>1.7349716844336964</c:v>
                </c:pt>
                <c:pt idx="11">
                  <c:v>24.345864550721984</c:v>
                </c:pt>
                <c:pt idx="12">
                  <c:v>0.96999174019113321</c:v>
                </c:pt>
                <c:pt idx="13">
                  <c:v>8.87988137355285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E2C5-4C8D-B3C1-ABD3B7B94A77}"/>
            </c:ext>
          </c:extLst>
        </c:ser>
        <c:ser>
          <c:idx val="23"/>
          <c:order val="23"/>
          <c:tx>
            <c:strRef>
              <c:f>'EPA2016.1'!$B$28</c:f>
              <c:strCache>
                <c:ptCount val="1"/>
                <c:pt idx="0">
                  <c:v>E1.11</c:v>
                </c:pt>
              </c:strCache>
            </c:strRef>
          </c:tx>
          <c:spPr>
            <a:solidFill>
              <a:schemeClr val="accent3">
                <a:shade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8:$P$28</c:f>
              <c:numCache>
                <c:formatCode>General</c:formatCode>
                <c:ptCount val="14"/>
                <c:pt idx="0">
                  <c:v>9.7399030792093448</c:v>
                </c:pt>
                <c:pt idx="1">
                  <c:v>3.9509625476959926</c:v>
                </c:pt>
                <c:pt idx="2">
                  <c:v>11.190737917586357</c:v>
                </c:pt>
                <c:pt idx="3">
                  <c:v>11.572169699972505</c:v>
                </c:pt>
                <c:pt idx="4">
                  <c:v>2.0399116158056656</c:v>
                </c:pt>
                <c:pt idx="5">
                  <c:v>11.603276807404548</c:v>
                </c:pt>
                <c:pt idx="6">
                  <c:v>2.9797588290797985</c:v>
                </c:pt>
                <c:pt idx="7">
                  <c:v>4.387919141889415</c:v>
                </c:pt>
                <c:pt idx="8">
                  <c:v>0.9102569068519758</c:v>
                </c:pt>
                <c:pt idx="9">
                  <c:v>5.2038583030525842</c:v>
                </c:pt>
                <c:pt idx="10">
                  <c:v>1.4440715223430198</c:v>
                </c:pt>
                <c:pt idx="11">
                  <c:v>24.653721694922428</c:v>
                </c:pt>
                <c:pt idx="12">
                  <c:v>0.99769544665889986</c:v>
                </c:pt>
                <c:pt idx="13">
                  <c:v>9.32575648752749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E2C5-4C8D-B3C1-ABD3B7B94A77}"/>
            </c:ext>
          </c:extLst>
        </c:ser>
        <c:ser>
          <c:idx val="24"/>
          <c:order val="24"/>
          <c:tx>
            <c:strRef>
              <c:f>'EPA2016.1'!$B$29</c:f>
              <c:strCache>
                <c:ptCount val="1"/>
                <c:pt idx="0">
                  <c:v>E1.8</c:v>
                </c:pt>
              </c:strCache>
            </c:strRef>
          </c:tx>
          <c:spPr>
            <a:solidFill>
              <a:schemeClr val="accent3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29:$P$29</c:f>
              <c:numCache>
                <c:formatCode>General</c:formatCode>
                <c:ptCount val="14"/>
                <c:pt idx="0">
                  <c:v>8.5878345371025855</c:v>
                </c:pt>
                <c:pt idx="1">
                  <c:v>3.3577228585548058</c:v>
                </c:pt>
                <c:pt idx="2">
                  <c:v>10.740870888099087</c:v>
                </c:pt>
                <c:pt idx="3">
                  <c:v>11.338544241179717</c:v>
                </c:pt>
                <c:pt idx="4">
                  <c:v>1.9792229406634692</c:v>
                </c:pt>
                <c:pt idx="5">
                  <c:v>14.164360693763186</c:v>
                </c:pt>
                <c:pt idx="6">
                  <c:v>3.7817923983260493</c:v>
                </c:pt>
                <c:pt idx="7">
                  <c:v>5.4996578997621279</c:v>
                </c:pt>
                <c:pt idx="8">
                  <c:v>0.88677307051032106</c:v>
                </c:pt>
                <c:pt idx="9">
                  <c:v>4.2978143190443143</c:v>
                </c:pt>
                <c:pt idx="10">
                  <c:v>1.7537098323702296</c:v>
                </c:pt>
                <c:pt idx="11">
                  <c:v>24.676600257259199</c:v>
                </c:pt>
                <c:pt idx="12">
                  <c:v>0.86064463725343532</c:v>
                </c:pt>
                <c:pt idx="13">
                  <c:v>8.0744514261114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E2C5-4C8D-B3C1-ABD3B7B94A77}"/>
            </c:ext>
          </c:extLst>
        </c:ser>
        <c:ser>
          <c:idx val="25"/>
          <c:order val="25"/>
          <c:tx>
            <c:strRef>
              <c:f>'EPA2016.1'!$B$30</c:f>
              <c:strCache>
                <c:ptCount val="1"/>
                <c:pt idx="0">
                  <c:v>E1.3</c:v>
                </c:pt>
              </c:strCache>
            </c:strRef>
          </c:tx>
          <c:spPr>
            <a:solidFill>
              <a:schemeClr val="accent3">
                <a:shade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30:$P$30</c:f>
              <c:numCache>
                <c:formatCode>General</c:formatCode>
                <c:ptCount val="14"/>
                <c:pt idx="0">
                  <c:v>8.1023744425235034</c:v>
                </c:pt>
                <c:pt idx="1">
                  <c:v>3.1193039723636113</c:v>
                </c:pt>
                <c:pt idx="2">
                  <c:v>8.4718999850466066</c:v>
                </c:pt>
                <c:pt idx="3">
                  <c:v>10.319824738385902</c:v>
                </c:pt>
                <c:pt idx="4">
                  <c:v>1.9918738457432077</c:v>
                </c:pt>
                <c:pt idx="5">
                  <c:v>16.697474865802576</c:v>
                </c:pt>
                <c:pt idx="6">
                  <c:v>4.404176182352499</c:v>
                </c:pt>
                <c:pt idx="7">
                  <c:v>5.0365196113274253</c:v>
                </c:pt>
                <c:pt idx="8">
                  <c:v>1.0289450181095441</c:v>
                </c:pt>
                <c:pt idx="9">
                  <c:v>3.5771040184354241</c:v>
                </c:pt>
                <c:pt idx="10">
                  <c:v>2.4732665178339128</c:v>
                </c:pt>
                <c:pt idx="11">
                  <c:v>25.52132448916252</c:v>
                </c:pt>
                <c:pt idx="12">
                  <c:v>0.76768759059898073</c:v>
                </c:pt>
                <c:pt idx="13">
                  <c:v>8.48822472231426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E2C5-4C8D-B3C1-ABD3B7B94A77}"/>
            </c:ext>
          </c:extLst>
        </c:ser>
        <c:ser>
          <c:idx val="26"/>
          <c:order val="26"/>
          <c:tx>
            <c:strRef>
              <c:f>'EPA2016.1'!$B$31</c:f>
              <c:strCache>
                <c:ptCount val="1"/>
                <c:pt idx="0">
                  <c:v>E1.14</c:v>
                </c:pt>
              </c:strCache>
            </c:strRef>
          </c:tx>
          <c:spPr>
            <a:solidFill>
              <a:schemeClr val="accent3">
                <a:shade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2016.1'!$C$4:$P$4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2016.1'!$C$31:$P$31</c:f>
              <c:numCache>
                <c:formatCode>General</c:formatCode>
                <c:ptCount val="14"/>
                <c:pt idx="0">
                  <c:v>8.8805673001256817</c:v>
                </c:pt>
                <c:pt idx="1">
                  <c:v>3.4576332632536824</c:v>
                </c:pt>
                <c:pt idx="2">
                  <c:v>11.416442686068009</c:v>
                </c:pt>
                <c:pt idx="3">
                  <c:v>9.3513993547674765</c:v>
                </c:pt>
                <c:pt idx="4">
                  <c:v>1.8973022735943126</c:v>
                </c:pt>
                <c:pt idx="5">
                  <c:v>12.813346781947054</c:v>
                </c:pt>
                <c:pt idx="6">
                  <c:v>3.4005127774889741</c:v>
                </c:pt>
                <c:pt idx="7">
                  <c:v>4.6653346636395874</c:v>
                </c:pt>
                <c:pt idx="8">
                  <c:v>0.85464152485081257</c:v>
                </c:pt>
                <c:pt idx="9">
                  <c:v>4.8224387379579934</c:v>
                </c:pt>
                <c:pt idx="10">
                  <c:v>1.6933533959298066</c:v>
                </c:pt>
                <c:pt idx="11">
                  <c:v>26.770672638182955</c:v>
                </c:pt>
                <c:pt idx="12">
                  <c:v>1.0668591861335799</c:v>
                </c:pt>
                <c:pt idx="13">
                  <c:v>8.9094954160600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E2C5-4C8D-B3C1-ABD3B7B94A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878745504"/>
        <c:axId val="878782240"/>
      </c:barChart>
      <c:catAx>
        <c:axId val="87874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8782240"/>
        <c:crosses val="autoZero"/>
        <c:auto val="1"/>
        <c:lblAlgn val="ctr"/>
        <c:lblOffset val="100"/>
        <c:noMultiLvlLbl val="0"/>
      </c:catAx>
      <c:valAx>
        <c:axId val="878782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FAMEs (mol%)</a:t>
                </a:r>
              </a:p>
            </c:rich>
          </c:tx>
          <c:layout>
            <c:manualLayout>
              <c:xMode val="edge"/>
              <c:yMode val="edge"/>
              <c:x val="0"/>
              <c:y val="0.147870184463325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87455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9008366113622261E-2"/>
          <c:y val="0.82680102129580446"/>
          <c:w val="0.90001675507507417"/>
          <c:h val="9.55673317001377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sz="1000"/>
              <a:t>EPA2015.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5647891866873604E-2"/>
          <c:y val="2.8194444444444446E-2"/>
          <c:w val="0.90359591087442492"/>
          <c:h val="0.68732174103237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PA8'!$B$4</c:f>
              <c:strCache>
                <c:ptCount val="1"/>
                <c:pt idx="0">
                  <c:v>E8.14</c:v>
                </c:pt>
              </c:strCache>
            </c:strRef>
          </c:tx>
          <c:spPr>
            <a:solidFill>
              <a:schemeClr val="accent3">
                <a:tint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4:$P$4</c:f>
              <c:numCache>
                <c:formatCode>General</c:formatCode>
                <c:ptCount val="14"/>
                <c:pt idx="0">
                  <c:v>9.3193960953822206</c:v>
                </c:pt>
                <c:pt idx="1">
                  <c:v>3.6060866947295227</c:v>
                </c:pt>
                <c:pt idx="2">
                  <c:v>15.808191795582283</c:v>
                </c:pt>
                <c:pt idx="3">
                  <c:v>14.193586328065489</c:v>
                </c:pt>
                <c:pt idx="4">
                  <c:v>2.1159815956638406</c:v>
                </c:pt>
                <c:pt idx="5">
                  <c:v>11.440483601987328</c:v>
                </c:pt>
                <c:pt idx="6">
                  <c:v>1.8394576302187162</c:v>
                </c:pt>
                <c:pt idx="7">
                  <c:v>4.8081919230659347</c:v>
                </c:pt>
                <c:pt idx="8">
                  <c:v>1.6516303853691829</c:v>
                </c:pt>
                <c:pt idx="9">
                  <c:v>4.7405993465553999</c:v>
                </c:pt>
                <c:pt idx="10">
                  <c:v>2.0753389823023412</c:v>
                </c:pt>
                <c:pt idx="11">
                  <c:v>16.281206968622506</c:v>
                </c:pt>
                <c:pt idx="12">
                  <c:v>0.44394200002950929</c:v>
                </c:pt>
                <c:pt idx="13">
                  <c:v>7.9965775549675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C0-47AB-9C21-FD1512B6756A}"/>
            </c:ext>
          </c:extLst>
        </c:ser>
        <c:ser>
          <c:idx val="1"/>
          <c:order val="1"/>
          <c:tx>
            <c:strRef>
              <c:f>'EPA8'!$B$5</c:f>
              <c:strCache>
                <c:ptCount val="1"/>
                <c:pt idx="0">
                  <c:v>E8.7</c:v>
                </c:pt>
              </c:strCache>
            </c:strRef>
          </c:tx>
          <c:spPr>
            <a:solidFill>
              <a:schemeClr val="accent3">
                <a:tint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5:$P$5</c:f>
              <c:numCache>
                <c:formatCode>General</c:formatCode>
                <c:ptCount val="14"/>
                <c:pt idx="0">
                  <c:v>7.8745981071112015</c:v>
                </c:pt>
                <c:pt idx="1">
                  <c:v>3.6588067470831973</c:v>
                </c:pt>
                <c:pt idx="2">
                  <c:v>15.810881171913373</c:v>
                </c:pt>
                <c:pt idx="3">
                  <c:v>15.668391891224454</c:v>
                </c:pt>
                <c:pt idx="4">
                  <c:v>2.2082384946294624</c:v>
                </c:pt>
                <c:pt idx="5">
                  <c:v>10.835915908032705</c:v>
                </c:pt>
                <c:pt idx="6">
                  <c:v>2.2553913575314906</c:v>
                </c:pt>
                <c:pt idx="7">
                  <c:v>4.9241858411893</c:v>
                </c:pt>
                <c:pt idx="8">
                  <c:v>1.7175355841045152</c:v>
                </c:pt>
                <c:pt idx="9">
                  <c:v>5.5549279593345897</c:v>
                </c:pt>
                <c:pt idx="10">
                  <c:v>1.9203722112854527</c:v>
                </c:pt>
                <c:pt idx="11">
                  <c:v>17.606101508072737</c:v>
                </c:pt>
                <c:pt idx="12">
                  <c:v>0.42186243871591667</c:v>
                </c:pt>
                <c:pt idx="13">
                  <c:v>11.6759066524257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C0-47AB-9C21-FD1512B6756A}"/>
            </c:ext>
          </c:extLst>
        </c:ser>
        <c:ser>
          <c:idx val="2"/>
          <c:order val="2"/>
          <c:tx>
            <c:strRef>
              <c:f>'EPA8'!$B$6</c:f>
              <c:strCache>
                <c:ptCount val="1"/>
                <c:pt idx="0">
                  <c:v>E8.24</c:v>
                </c:pt>
              </c:strCache>
            </c:strRef>
          </c:tx>
          <c:spPr>
            <a:solidFill>
              <a:schemeClr val="accent3">
                <a:tint val="44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6:$P$6</c:f>
              <c:numCache>
                <c:formatCode>General</c:formatCode>
                <c:ptCount val="14"/>
                <c:pt idx="0">
                  <c:v>7.8261327591692593</c:v>
                </c:pt>
                <c:pt idx="1">
                  <c:v>3.4818513810007183</c:v>
                </c:pt>
                <c:pt idx="2">
                  <c:v>16.331618912044867</c:v>
                </c:pt>
                <c:pt idx="3">
                  <c:v>14.324521770029619</c:v>
                </c:pt>
                <c:pt idx="4">
                  <c:v>2.0299449728599122</c:v>
                </c:pt>
                <c:pt idx="5">
                  <c:v>11.260482171177152</c:v>
                </c:pt>
                <c:pt idx="6">
                  <c:v>2.2367271839152707</c:v>
                </c:pt>
                <c:pt idx="7">
                  <c:v>4.5035322493573542</c:v>
                </c:pt>
                <c:pt idx="8">
                  <c:v>1.3804817405950902</c:v>
                </c:pt>
                <c:pt idx="9">
                  <c:v>5.4419763730786306</c:v>
                </c:pt>
                <c:pt idx="10">
                  <c:v>1.6808952428413955</c:v>
                </c:pt>
                <c:pt idx="11">
                  <c:v>18.786640310522312</c:v>
                </c:pt>
                <c:pt idx="12">
                  <c:v>0.50569741121003331</c:v>
                </c:pt>
                <c:pt idx="13">
                  <c:v>9.5427907797716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C0-47AB-9C21-FD1512B6756A}"/>
            </c:ext>
          </c:extLst>
        </c:ser>
        <c:ser>
          <c:idx val="3"/>
          <c:order val="3"/>
          <c:tx>
            <c:strRef>
              <c:f>'EPA8'!$B$7</c:f>
              <c:strCache>
                <c:ptCount val="1"/>
                <c:pt idx="0">
                  <c:v>E8.11</c:v>
                </c:pt>
              </c:strCache>
            </c:strRef>
          </c:tx>
          <c:spPr>
            <a:solidFill>
              <a:schemeClr val="accent3">
                <a:tint val="49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7:$P$7</c:f>
              <c:numCache>
                <c:formatCode>General</c:formatCode>
                <c:ptCount val="14"/>
                <c:pt idx="0">
                  <c:v>8.8983843742241575</c:v>
                </c:pt>
                <c:pt idx="1">
                  <c:v>3.7804020650738166</c:v>
                </c:pt>
                <c:pt idx="2">
                  <c:v>15.876881843230045</c:v>
                </c:pt>
                <c:pt idx="3">
                  <c:v>14.018850910196742</c:v>
                </c:pt>
                <c:pt idx="4">
                  <c:v>2.0748550013856182</c:v>
                </c:pt>
                <c:pt idx="5">
                  <c:v>10.190313791799973</c:v>
                </c:pt>
                <c:pt idx="6">
                  <c:v>2.1215606247421492</c:v>
                </c:pt>
                <c:pt idx="7">
                  <c:v>4.3940001185436746</c:v>
                </c:pt>
                <c:pt idx="8">
                  <c:v>1.546965692166175</c:v>
                </c:pt>
                <c:pt idx="9">
                  <c:v>5.7341331835246887</c:v>
                </c:pt>
                <c:pt idx="10">
                  <c:v>1.7969800402593206</c:v>
                </c:pt>
                <c:pt idx="11">
                  <c:v>19.322529213257944</c:v>
                </c:pt>
                <c:pt idx="12">
                  <c:v>0.53353832369610654</c:v>
                </c:pt>
                <c:pt idx="13">
                  <c:v>10.2094975221983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C0-47AB-9C21-FD1512B6756A}"/>
            </c:ext>
          </c:extLst>
        </c:ser>
        <c:ser>
          <c:idx val="4"/>
          <c:order val="4"/>
          <c:tx>
            <c:strRef>
              <c:f>'EPA8'!$B$8</c:f>
              <c:strCache>
                <c:ptCount val="1"/>
                <c:pt idx="0">
                  <c:v>E8.16</c:v>
                </c:pt>
              </c:strCache>
            </c:strRef>
          </c:tx>
          <c:spPr>
            <a:solidFill>
              <a:schemeClr val="accent3">
                <a:tint val="53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8:$P$8</c:f>
              <c:numCache>
                <c:formatCode>General</c:formatCode>
                <c:ptCount val="14"/>
                <c:pt idx="0">
                  <c:v>8.5198760569153507</c:v>
                </c:pt>
                <c:pt idx="1">
                  <c:v>3.9999127559903918</c:v>
                </c:pt>
                <c:pt idx="2">
                  <c:v>16.173331195750766</c:v>
                </c:pt>
                <c:pt idx="3">
                  <c:v>12.286714449004592</c:v>
                </c:pt>
                <c:pt idx="4">
                  <c:v>2.3557416229616148</c:v>
                </c:pt>
                <c:pt idx="5">
                  <c:v>11.129310782018928</c:v>
                </c:pt>
                <c:pt idx="6">
                  <c:v>2.8009171330681797</c:v>
                </c:pt>
                <c:pt idx="7">
                  <c:v>4.2148053314453175</c:v>
                </c:pt>
                <c:pt idx="8">
                  <c:v>1.2662028533933125</c:v>
                </c:pt>
                <c:pt idx="9">
                  <c:v>5.2613996460153336</c:v>
                </c:pt>
                <c:pt idx="10">
                  <c:v>1.6330191065932078</c:v>
                </c:pt>
                <c:pt idx="11">
                  <c:v>19.403513857534804</c:v>
                </c:pt>
                <c:pt idx="12">
                  <c:v>0.48791715217218834</c:v>
                </c:pt>
                <c:pt idx="13">
                  <c:v>9.7106048178996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C0-47AB-9C21-FD1512B6756A}"/>
            </c:ext>
          </c:extLst>
        </c:ser>
        <c:ser>
          <c:idx val="5"/>
          <c:order val="5"/>
          <c:tx>
            <c:strRef>
              <c:f>'EPA8'!$B$9</c:f>
              <c:strCache>
                <c:ptCount val="1"/>
                <c:pt idx="0">
                  <c:v>E8.17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9:$P$9</c:f>
              <c:numCache>
                <c:formatCode>General</c:formatCode>
                <c:ptCount val="14"/>
                <c:pt idx="0">
                  <c:v>7.9328923369858684</c:v>
                </c:pt>
                <c:pt idx="1">
                  <c:v>3.3316176546792224</c:v>
                </c:pt>
                <c:pt idx="2">
                  <c:v>16.682900542128117</c:v>
                </c:pt>
                <c:pt idx="3">
                  <c:v>12.676441506961403</c:v>
                </c:pt>
                <c:pt idx="4">
                  <c:v>2.1190915775602037</c:v>
                </c:pt>
                <c:pt idx="5">
                  <c:v>11.022337881388145</c:v>
                </c:pt>
                <c:pt idx="6">
                  <c:v>2.5884476186703975</c:v>
                </c:pt>
                <c:pt idx="7">
                  <c:v>4.1087214327424952</c:v>
                </c:pt>
                <c:pt idx="8">
                  <c:v>1.3658237222377296</c:v>
                </c:pt>
                <c:pt idx="9">
                  <c:v>5.6276205687018184</c:v>
                </c:pt>
                <c:pt idx="10">
                  <c:v>1.780629130668663</c:v>
                </c:pt>
                <c:pt idx="11">
                  <c:v>19.73085685449826</c:v>
                </c:pt>
                <c:pt idx="12">
                  <c:v>0.48737354523377019</c:v>
                </c:pt>
                <c:pt idx="13">
                  <c:v>10.467338057135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7C0-47AB-9C21-FD1512B6756A}"/>
            </c:ext>
          </c:extLst>
        </c:ser>
        <c:ser>
          <c:idx val="6"/>
          <c:order val="6"/>
          <c:tx>
            <c:strRef>
              <c:f>'EPA8'!$B$10</c:f>
              <c:strCache>
                <c:ptCount val="1"/>
                <c:pt idx="0">
                  <c:v>E8.27</c:v>
                </c:pt>
              </c:strCache>
            </c:strRef>
          </c:tx>
          <c:spPr>
            <a:solidFill>
              <a:schemeClr val="accent3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0:$P$10</c:f>
              <c:numCache>
                <c:formatCode>General</c:formatCode>
                <c:ptCount val="14"/>
                <c:pt idx="0">
                  <c:v>8.8094941459759362</c:v>
                </c:pt>
                <c:pt idx="1">
                  <c:v>3.8828186595913423</c:v>
                </c:pt>
                <c:pt idx="2">
                  <c:v>14.151671142796317</c:v>
                </c:pt>
                <c:pt idx="3">
                  <c:v>12.879451398581775</c:v>
                </c:pt>
                <c:pt idx="4">
                  <c:v>2.6429203814794908</c:v>
                </c:pt>
                <c:pt idx="5">
                  <c:v>10.674175681493827</c:v>
                </c:pt>
                <c:pt idx="6">
                  <c:v>2.9326964585593025</c:v>
                </c:pt>
                <c:pt idx="7">
                  <c:v>3.5843080153571178</c:v>
                </c:pt>
                <c:pt idx="8">
                  <c:v>1.7549343406755384</c:v>
                </c:pt>
                <c:pt idx="9">
                  <c:v>5.7344364368365897</c:v>
                </c:pt>
                <c:pt idx="10">
                  <c:v>2.1997088193467937</c:v>
                </c:pt>
                <c:pt idx="11">
                  <c:v>20.34722034627886</c:v>
                </c:pt>
                <c:pt idx="12">
                  <c:v>0.59237436142027711</c:v>
                </c:pt>
                <c:pt idx="13">
                  <c:v>10.545245627543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7C0-47AB-9C21-FD1512B6756A}"/>
            </c:ext>
          </c:extLst>
        </c:ser>
        <c:ser>
          <c:idx val="7"/>
          <c:order val="7"/>
          <c:tx>
            <c:strRef>
              <c:f>'EPA8'!$B$11</c:f>
              <c:strCache>
                <c:ptCount val="1"/>
                <c:pt idx="0">
                  <c:v>E8.13</c:v>
                </c:pt>
              </c:strCache>
            </c:strRef>
          </c:tx>
          <c:spPr>
            <a:solidFill>
              <a:schemeClr val="accent3">
                <a:tint val="67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1:$P$11</c:f>
              <c:numCache>
                <c:formatCode>General</c:formatCode>
                <c:ptCount val="14"/>
                <c:pt idx="0">
                  <c:v>8.4132848984672162</c:v>
                </c:pt>
                <c:pt idx="1">
                  <c:v>4.8722650635874194</c:v>
                </c:pt>
                <c:pt idx="2">
                  <c:v>18.627410933769273</c:v>
                </c:pt>
                <c:pt idx="3">
                  <c:v>9.5274877630582804</c:v>
                </c:pt>
                <c:pt idx="4">
                  <c:v>1.5165484376028202</c:v>
                </c:pt>
                <c:pt idx="5">
                  <c:v>9.6586864268337536</c:v>
                </c:pt>
                <c:pt idx="6">
                  <c:v>2.1207015652687971</c:v>
                </c:pt>
                <c:pt idx="7">
                  <c:v>4.0610187714813017</c:v>
                </c:pt>
                <c:pt idx="8">
                  <c:v>1.1074606078638909</c:v>
                </c:pt>
                <c:pt idx="9">
                  <c:v>4.4484761156167085</c:v>
                </c:pt>
                <c:pt idx="10">
                  <c:v>1.5543835007084996</c:v>
                </c:pt>
                <c:pt idx="11">
                  <c:v>20.39915697966946</c:v>
                </c:pt>
                <c:pt idx="12">
                  <c:v>0.68385074211634622</c:v>
                </c:pt>
                <c:pt idx="13">
                  <c:v>9.813789811606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7C0-47AB-9C21-FD1512B6756A}"/>
            </c:ext>
          </c:extLst>
        </c:ser>
        <c:ser>
          <c:idx val="8"/>
          <c:order val="8"/>
          <c:tx>
            <c:strRef>
              <c:f>'EPA8'!$B$12</c:f>
              <c:strCache>
                <c:ptCount val="1"/>
                <c:pt idx="0">
                  <c:v>E8.23</c:v>
                </c:pt>
              </c:strCache>
            </c:strRef>
          </c:tx>
          <c:spPr>
            <a:solidFill>
              <a:schemeClr val="accent3">
                <a:tint val="71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2:$P$12</c:f>
              <c:numCache>
                <c:formatCode>General</c:formatCode>
                <c:ptCount val="14"/>
                <c:pt idx="0">
                  <c:v>8.5002079727924222</c:v>
                </c:pt>
                <c:pt idx="1">
                  <c:v>3.6706955157325383</c:v>
                </c:pt>
                <c:pt idx="2">
                  <c:v>15.230418024308067</c:v>
                </c:pt>
                <c:pt idx="3">
                  <c:v>12.04319309762319</c:v>
                </c:pt>
                <c:pt idx="4">
                  <c:v>2.3804101910757445</c:v>
                </c:pt>
                <c:pt idx="5">
                  <c:v>10.880425166371445</c:v>
                </c:pt>
                <c:pt idx="6">
                  <c:v>3.0714519882897067</c:v>
                </c:pt>
                <c:pt idx="7">
                  <c:v>3.7132683064886254</c:v>
                </c:pt>
                <c:pt idx="8">
                  <c:v>1.4731603192406215</c:v>
                </c:pt>
                <c:pt idx="9">
                  <c:v>5.2657980053873485</c:v>
                </c:pt>
                <c:pt idx="10">
                  <c:v>2.0494096042317249</c:v>
                </c:pt>
                <c:pt idx="11">
                  <c:v>20.635091409366296</c:v>
                </c:pt>
                <c:pt idx="12">
                  <c:v>0.59530439803924495</c:v>
                </c:pt>
                <c:pt idx="13">
                  <c:v>13.009268193956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7C0-47AB-9C21-FD1512B6756A}"/>
            </c:ext>
          </c:extLst>
        </c:ser>
        <c:ser>
          <c:idx val="9"/>
          <c:order val="9"/>
          <c:tx>
            <c:strRef>
              <c:f>'EPA8'!$B$13</c:f>
              <c:strCache>
                <c:ptCount val="1"/>
                <c:pt idx="0">
                  <c:v>E8.20</c:v>
                </c:pt>
              </c:strCache>
            </c:strRef>
          </c:tx>
          <c:spPr>
            <a:solidFill>
              <a:schemeClr val="accent3">
                <a:tint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3:$P$13</c:f>
              <c:numCache>
                <c:formatCode>General</c:formatCode>
                <c:ptCount val="14"/>
                <c:pt idx="0">
                  <c:v>8.2032365762355699</c:v>
                </c:pt>
                <c:pt idx="1">
                  <c:v>4.0099597355198471</c:v>
                </c:pt>
                <c:pt idx="2">
                  <c:v>15.076177061061939</c:v>
                </c:pt>
                <c:pt idx="3">
                  <c:v>12.696822040382351</c:v>
                </c:pt>
                <c:pt idx="4">
                  <c:v>2.3649172012696487</c:v>
                </c:pt>
                <c:pt idx="5">
                  <c:v>10.505604805194945</c:v>
                </c:pt>
                <c:pt idx="6">
                  <c:v>2.5201033314574386</c:v>
                </c:pt>
                <c:pt idx="7">
                  <c:v>4.2441739360657271</c:v>
                </c:pt>
                <c:pt idx="8">
                  <c:v>1.5756151804970915</c:v>
                </c:pt>
                <c:pt idx="9">
                  <c:v>5.0528346001454763</c:v>
                </c:pt>
                <c:pt idx="10">
                  <c:v>1.9188898045125065</c:v>
                </c:pt>
                <c:pt idx="11">
                  <c:v>20.703037655508723</c:v>
                </c:pt>
                <c:pt idx="12">
                  <c:v>0.62076689141588415</c:v>
                </c:pt>
                <c:pt idx="13">
                  <c:v>10.491166001053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7C0-47AB-9C21-FD1512B6756A}"/>
            </c:ext>
          </c:extLst>
        </c:ser>
        <c:ser>
          <c:idx val="10"/>
          <c:order val="10"/>
          <c:tx>
            <c:strRef>
              <c:f>'EPA8'!$B$14</c:f>
              <c:strCache>
                <c:ptCount val="1"/>
                <c:pt idx="0">
                  <c:v>E8.28</c:v>
                </c:pt>
              </c:strCache>
            </c:strRef>
          </c:tx>
          <c:spPr>
            <a:solidFill>
              <a:schemeClr val="accent3">
                <a:tint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4:$P$14</c:f>
              <c:numCache>
                <c:formatCode>General</c:formatCode>
                <c:ptCount val="14"/>
                <c:pt idx="0">
                  <c:v>8.4467325480143085</c:v>
                </c:pt>
                <c:pt idx="1">
                  <c:v>3.2459326020490114</c:v>
                </c:pt>
                <c:pt idx="2">
                  <c:v>13.082727391722077</c:v>
                </c:pt>
                <c:pt idx="3">
                  <c:v>14.870912988374746</c:v>
                </c:pt>
                <c:pt idx="4">
                  <c:v>2.790644912946584</c:v>
                </c:pt>
                <c:pt idx="5">
                  <c:v>11.745898886978745</c:v>
                </c:pt>
                <c:pt idx="6">
                  <c:v>2.870283548920495</c:v>
                </c:pt>
                <c:pt idx="7">
                  <c:v>4.5420450443330198</c:v>
                </c:pt>
                <c:pt idx="8">
                  <c:v>1.6642958839312119</c:v>
                </c:pt>
                <c:pt idx="9">
                  <c:v>5.3830226754168242</c:v>
                </c:pt>
                <c:pt idx="10">
                  <c:v>2.1105148331910426</c:v>
                </c:pt>
                <c:pt idx="11">
                  <c:v>20.710640337939775</c:v>
                </c:pt>
                <c:pt idx="12">
                  <c:v>0.60265899573075721</c:v>
                </c:pt>
                <c:pt idx="13">
                  <c:v>10.5078611807328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7C0-47AB-9C21-FD1512B6756A}"/>
            </c:ext>
          </c:extLst>
        </c:ser>
        <c:ser>
          <c:idx val="11"/>
          <c:order val="11"/>
          <c:tx>
            <c:strRef>
              <c:f>'EPA8'!$B$15</c:f>
              <c:strCache>
                <c:ptCount val="1"/>
                <c:pt idx="0">
                  <c:v>E8.25</c:v>
                </c:pt>
              </c:strCache>
            </c:strRef>
          </c:tx>
          <c:spPr>
            <a:solidFill>
              <a:schemeClr val="accent3">
                <a:tint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5:$P$15</c:f>
              <c:numCache>
                <c:formatCode>General</c:formatCode>
                <c:ptCount val="14"/>
                <c:pt idx="0">
                  <c:v>7.8307786365403844</c:v>
                </c:pt>
                <c:pt idx="1">
                  <c:v>3.7766052608480236</c:v>
                </c:pt>
                <c:pt idx="2">
                  <c:v>18.451379953604892</c:v>
                </c:pt>
                <c:pt idx="3">
                  <c:v>11.878141275054578</c:v>
                </c:pt>
                <c:pt idx="4">
                  <c:v>1.9184968253245733</c:v>
                </c:pt>
                <c:pt idx="5">
                  <c:v>10.153168075967978</c:v>
                </c:pt>
                <c:pt idx="6">
                  <c:v>2.3392395160581385</c:v>
                </c:pt>
                <c:pt idx="7">
                  <c:v>4.2616881293051527</c:v>
                </c:pt>
                <c:pt idx="8">
                  <c:v>1.3962589720376839</c:v>
                </c:pt>
                <c:pt idx="9">
                  <c:v>5.5144749055766074</c:v>
                </c:pt>
                <c:pt idx="10">
                  <c:v>1.8594930175955533</c:v>
                </c:pt>
                <c:pt idx="11">
                  <c:v>20.922773753114281</c:v>
                </c:pt>
                <c:pt idx="12">
                  <c:v>0.62351401435202758</c:v>
                </c:pt>
                <c:pt idx="13">
                  <c:v>7.9336893504514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97C0-47AB-9C21-FD1512B6756A}"/>
            </c:ext>
          </c:extLst>
        </c:ser>
        <c:ser>
          <c:idx val="12"/>
          <c:order val="12"/>
          <c:tx>
            <c:strRef>
              <c:f>'EPA8'!$B$16</c:f>
              <c:strCache>
                <c:ptCount val="1"/>
                <c:pt idx="0">
                  <c:v>E8.8</c:v>
                </c:pt>
              </c:strCache>
            </c:strRef>
          </c:tx>
          <c:spPr>
            <a:solidFill>
              <a:schemeClr val="accent3">
                <a:tint val="89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6:$P$16</c:f>
              <c:numCache>
                <c:formatCode>General</c:formatCode>
                <c:ptCount val="14"/>
                <c:pt idx="0">
                  <c:v>8.4337553157489324</c:v>
                </c:pt>
                <c:pt idx="1">
                  <c:v>3.6116190117416083</c:v>
                </c:pt>
                <c:pt idx="2">
                  <c:v>15.608819552994598</c:v>
                </c:pt>
                <c:pt idx="3">
                  <c:v>12.861493867553085</c:v>
                </c:pt>
                <c:pt idx="4">
                  <c:v>2.3315474444807269</c:v>
                </c:pt>
                <c:pt idx="5">
                  <c:v>11.263183094243608</c:v>
                </c:pt>
                <c:pt idx="6">
                  <c:v>3.0354290312541279</c:v>
                </c:pt>
                <c:pt idx="7">
                  <c:v>3.9656113310799657</c:v>
                </c:pt>
                <c:pt idx="8">
                  <c:v>1.4823832661045229</c:v>
                </c:pt>
                <c:pt idx="9">
                  <c:v>5.1687417642421387</c:v>
                </c:pt>
                <c:pt idx="10">
                  <c:v>2.0626031370357798</c:v>
                </c:pt>
                <c:pt idx="11">
                  <c:v>21.130674984101166</c:v>
                </c:pt>
                <c:pt idx="12">
                  <c:v>0.60612274218205608</c:v>
                </c:pt>
                <c:pt idx="13">
                  <c:v>9.073987664620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7C0-47AB-9C21-FD1512B6756A}"/>
            </c:ext>
          </c:extLst>
        </c:ser>
        <c:ser>
          <c:idx val="13"/>
          <c:order val="13"/>
          <c:tx>
            <c:strRef>
              <c:f>'EPA8'!$B$17</c:f>
              <c:strCache>
                <c:ptCount val="1"/>
                <c:pt idx="0">
                  <c:v>E8.4</c:v>
                </c:pt>
              </c:strCache>
            </c:strRef>
          </c:tx>
          <c:spPr>
            <a:solidFill>
              <a:schemeClr val="accent3">
                <a:tint val="94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7:$P$17</c:f>
              <c:numCache>
                <c:formatCode>General</c:formatCode>
                <c:ptCount val="14"/>
                <c:pt idx="0">
                  <c:v>10.481286771358741</c:v>
                </c:pt>
                <c:pt idx="1">
                  <c:v>3.5516280594174661</c:v>
                </c:pt>
                <c:pt idx="2">
                  <c:v>13.049253937251981</c:v>
                </c:pt>
                <c:pt idx="3">
                  <c:v>11.64498980088206</c:v>
                </c:pt>
                <c:pt idx="4">
                  <c:v>2.5215688806690455</c:v>
                </c:pt>
                <c:pt idx="5">
                  <c:v>9.6970690872118137</c:v>
                </c:pt>
                <c:pt idx="6">
                  <c:v>2.6554326306863136</c:v>
                </c:pt>
                <c:pt idx="7">
                  <c:v>4.5317180446597654</c:v>
                </c:pt>
                <c:pt idx="8">
                  <c:v>1.7325344529057272</c:v>
                </c:pt>
                <c:pt idx="9">
                  <c:v>5.8364506775095277</c:v>
                </c:pt>
                <c:pt idx="10">
                  <c:v>2.3787443742008545</c:v>
                </c:pt>
                <c:pt idx="11">
                  <c:v>21.154456848705628</c:v>
                </c:pt>
                <c:pt idx="12">
                  <c:v>0.93066484540055305</c:v>
                </c:pt>
                <c:pt idx="13">
                  <c:v>8.4380154572377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97C0-47AB-9C21-FD1512B6756A}"/>
            </c:ext>
          </c:extLst>
        </c:ser>
        <c:ser>
          <c:idx val="14"/>
          <c:order val="14"/>
          <c:tx>
            <c:strRef>
              <c:f>'EPA8'!$B$18</c:f>
              <c:strCache>
                <c:ptCount val="1"/>
                <c:pt idx="0">
                  <c:v>E8.21</c:v>
                </c:pt>
              </c:strCache>
            </c:strRef>
          </c:tx>
          <c:spPr>
            <a:solidFill>
              <a:schemeClr val="accent3">
                <a:tint val="98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8:$P$18</c:f>
              <c:numCache>
                <c:formatCode>General</c:formatCode>
                <c:ptCount val="14"/>
                <c:pt idx="0">
                  <c:v>8.8648099995196006</c:v>
                </c:pt>
                <c:pt idx="1">
                  <c:v>3.2095119956451579</c:v>
                </c:pt>
                <c:pt idx="2">
                  <c:v>15.498399734055441</c:v>
                </c:pt>
                <c:pt idx="3">
                  <c:v>12.483613136745912</c:v>
                </c:pt>
                <c:pt idx="4">
                  <c:v>2.5698519930232848</c:v>
                </c:pt>
                <c:pt idx="5">
                  <c:v>11.447385732390288</c:v>
                </c:pt>
                <c:pt idx="6">
                  <c:v>3.278626421065383</c:v>
                </c:pt>
                <c:pt idx="7">
                  <c:v>3.2591040788267605</c:v>
                </c:pt>
                <c:pt idx="8">
                  <c:v>1.4381326080960684</c:v>
                </c:pt>
                <c:pt idx="9">
                  <c:v>5.7232605420753462</c:v>
                </c:pt>
                <c:pt idx="10">
                  <c:v>2.047534278862829</c:v>
                </c:pt>
                <c:pt idx="11">
                  <c:v>21.436143925768494</c:v>
                </c:pt>
                <c:pt idx="12">
                  <c:v>0.57957331917781518</c:v>
                </c:pt>
                <c:pt idx="13">
                  <c:v>9.834201589140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97C0-47AB-9C21-FD1512B6756A}"/>
            </c:ext>
          </c:extLst>
        </c:ser>
        <c:ser>
          <c:idx val="15"/>
          <c:order val="15"/>
          <c:tx>
            <c:strRef>
              <c:f>'EPA8'!$B$19</c:f>
              <c:strCache>
                <c:ptCount val="1"/>
                <c:pt idx="0">
                  <c:v>E8.3</c:v>
                </c:pt>
              </c:strCache>
            </c:strRef>
          </c:tx>
          <c:spPr>
            <a:solidFill>
              <a:schemeClr val="accent3">
                <a:shade val="97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19:$P$19</c:f>
              <c:numCache>
                <c:formatCode>General</c:formatCode>
                <c:ptCount val="14"/>
                <c:pt idx="0">
                  <c:v>8.3022739411461295</c:v>
                </c:pt>
                <c:pt idx="1">
                  <c:v>3.5721622502631765</c:v>
                </c:pt>
                <c:pt idx="2">
                  <c:v>14.958410116812743</c:v>
                </c:pt>
                <c:pt idx="3">
                  <c:v>12.05648953447259</c:v>
                </c:pt>
                <c:pt idx="4">
                  <c:v>2.3920831016177373</c:v>
                </c:pt>
                <c:pt idx="5">
                  <c:v>11.078192296915118</c:v>
                </c:pt>
                <c:pt idx="6">
                  <c:v>3.0489093392588726</c:v>
                </c:pt>
                <c:pt idx="7">
                  <c:v>4.0721029204452543</c:v>
                </c:pt>
                <c:pt idx="8">
                  <c:v>1.3779836839237785</c:v>
                </c:pt>
                <c:pt idx="9">
                  <c:v>5.4992771822075683</c:v>
                </c:pt>
                <c:pt idx="10">
                  <c:v>1.8783603053395108</c:v>
                </c:pt>
                <c:pt idx="11">
                  <c:v>22.159008487477358</c:v>
                </c:pt>
                <c:pt idx="12">
                  <c:v>0.65886808892507842</c:v>
                </c:pt>
                <c:pt idx="13">
                  <c:v>8.16405223474763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97C0-47AB-9C21-FD1512B6756A}"/>
            </c:ext>
          </c:extLst>
        </c:ser>
        <c:ser>
          <c:idx val="16"/>
          <c:order val="16"/>
          <c:tx>
            <c:strRef>
              <c:f>'EPA8'!$B$20</c:f>
              <c:strCache>
                <c:ptCount val="1"/>
                <c:pt idx="0">
                  <c:v>E8.6</c:v>
                </c:pt>
              </c:strCache>
            </c:strRef>
          </c:tx>
          <c:spPr>
            <a:solidFill>
              <a:schemeClr val="accent3">
                <a:shade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0:$P$20</c:f>
              <c:numCache>
                <c:formatCode>General</c:formatCode>
                <c:ptCount val="14"/>
                <c:pt idx="0">
                  <c:v>8.9745476623007541</c:v>
                </c:pt>
                <c:pt idx="1">
                  <c:v>3.8265622706695943</c:v>
                </c:pt>
                <c:pt idx="2">
                  <c:v>13.827897221269769</c:v>
                </c:pt>
                <c:pt idx="3">
                  <c:v>12.445626058107075</c:v>
                </c:pt>
                <c:pt idx="4">
                  <c:v>2.4890800922628769</c:v>
                </c:pt>
                <c:pt idx="5">
                  <c:v>10.472608361380427</c:v>
                </c:pt>
                <c:pt idx="6">
                  <c:v>3.1690287025037023</c:v>
                </c:pt>
                <c:pt idx="7">
                  <c:v>3.4372330589204103</c:v>
                </c:pt>
                <c:pt idx="8">
                  <c:v>1.6852317915633479</c:v>
                </c:pt>
                <c:pt idx="9">
                  <c:v>5.6396219227921254</c:v>
                </c:pt>
                <c:pt idx="10">
                  <c:v>2.262003163500327</c:v>
                </c:pt>
                <c:pt idx="11">
                  <c:v>22.904703674049436</c:v>
                </c:pt>
                <c:pt idx="12">
                  <c:v>0.69420814269925335</c:v>
                </c:pt>
                <c:pt idx="13">
                  <c:v>8.9458787511950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7C0-47AB-9C21-FD1512B6756A}"/>
            </c:ext>
          </c:extLst>
        </c:ser>
        <c:ser>
          <c:idx val="17"/>
          <c:order val="17"/>
          <c:tx>
            <c:strRef>
              <c:f>'EPA8'!$B$21</c:f>
              <c:strCache>
                <c:ptCount val="1"/>
                <c:pt idx="0">
                  <c:v>E8.12</c:v>
                </c:pt>
              </c:strCache>
            </c:strRef>
          </c:tx>
          <c:spPr>
            <a:solidFill>
              <a:schemeClr val="accent3">
                <a:shade val="88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1:$P$21</c:f>
              <c:numCache>
                <c:formatCode>General</c:formatCode>
                <c:ptCount val="14"/>
                <c:pt idx="0">
                  <c:v>9.2565537618748248</c:v>
                </c:pt>
                <c:pt idx="1">
                  <c:v>3.7925839714965663</c:v>
                </c:pt>
                <c:pt idx="2">
                  <c:v>13.873662091010136</c:v>
                </c:pt>
                <c:pt idx="3">
                  <c:v>11.003846710358506</c:v>
                </c:pt>
                <c:pt idx="4">
                  <c:v>2.4760001053714098</c:v>
                </c:pt>
                <c:pt idx="5">
                  <c:v>10.462025578578828</c:v>
                </c:pt>
                <c:pt idx="6">
                  <c:v>3.3392928838516598</c:v>
                </c:pt>
                <c:pt idx="7">
                  <c:v>3.6289049674554836</c:v>
                </c:pt>
                <c:pt idx="8">
                  <c:v>1.4181835558383071</c:v>
                </c:pt>
                <c:pt idx="9">
                  <c:v>5.3081519301379494</c:v>
                </c:pt>
                <c:pt idx="10">
                  <c:v>2.1370987696216712</c:v>
                </c:pt>
                <c:pt idx="11">
                  <c:v>22.921022252030561</c:v>
                </c:pt>
                <c:pt idx="12">
                  <c:v>0.76491229474762512</c:v>
                </c:pt>
                <c:pt idx="13">
                  <c:v>8.1716478779809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97C0-47AB-9C21-FD1512B6756A}"/>
            </c:ext>
          </c:extLst>
        </c:ser>
        <c:ser>
          <c:idx val="18"/>
          <c:order val="18"/>
          <c:tx>
            <c:strRef>
              <c:f>'EPA8'!$B$22</c:f>
              <c:strCache>
                <c:ptCount val="1"/>
                <c:pt idx="0">
                  <c:v>E8.9</c:v>
                </c:pt>
              </c:strCache>
            </c:strRef>
          </c:tx>
          <c:spPr>
            <a:solidFill>
              <a:schemeClr val="accent3">
                <a:shade val="84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2:$P$22</c:f>
              <c:numCache>
                <c:formatCode>General</c:formatCode>
                <c:ptCount val="14"/>
                <c:pt idx="0">
                  <c:v>8.8342540166880514</c:v>
                </c:pt>
                <c:pt idx="1">
                  <c:v>3.6339298601871661</c:v>
                </c:pt>
                <c:pt idx="2">
                  <c:v>13.425719134402639</c:v>
                </c:pt>
                <c:pt idx="3">
                  <c:v>11.350636790214176</c:v>
                </c:pt>
                <c:pt idx="4">
                  <c:v>2.6472406584739985</c:v>
                </c:pt>
                <c:pt idx="5">
                  <c:v>10.44012963778844</c:v>
                </c:pt>
                <c:pt idx="6">
                  <c:v>3.5314279131762496</c:v>
                </c:pt>
                <c:pt idx="7">
                  <c:v>3.7143605756761628</c:v>
                </c:pt>
                <c:pt idx="8">
                  <c:v>1.7222359003556185</c:v>
                </c:pt>
                <c:pt idx="9">
                  <c:v>5.6498530831455263</c:v>
                </c:pt>
                <c:pt idx="10">
                  <c:v>2.4540114339436667</c:v>
                </c:pt>
                <c:pt idx="11">
                  <c:v>23.428040049610765</c:v>
                </c:pt>
                <c:pt idx="12">
                  <c:v>0.70653425176360141</c:v>
                </c:pt>
                <c:pt idx="13">
                  <c:v>9.6177611276264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97C0-47AB-9C21-FD1512B6756A}"/>
            </c:ext>
          </c:extLst>
        </c:ser>
        <c:ser>
          <c:idx val="19"/>
          <c:order val="19"/>
          <c:tx>
            <c:strRef>
              <c:f>'EPA8'!$B$23</c:f>
              <c:strCache>
                <c:ptCount val="1"/>
                <c:pt idx="0">
                  <c:v>E8.19</c:v>
                </c:pt>
              </c:strCache>
            </c:strRef>
          </c:tx>
          <c:spPr>
            <a:solidFill>
              <a:schemeClr val="accent3">
                <a:shade val="79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3:$P$23</c:f>
              <c:numCache>
                <c:formatCode>General</c:formatCode>
                <c:ptCount val="14"/>
                <c:pt idx="0">
                  <c:v>9.7048512711508828</c:v>
                </c:pt>
                <c:pt idx="1">
                  <c:v>4.2468116287001898</c:v>
                </c:pt>
                <c:pt idx="2">
                  <c:v>11.708197454371735</c:v>
                </c:pt>
                <c:pt idx="3">
                  <c:v>11.131004675753823</c:v>
                </c:pt>
                <c:pt idx="4">
                  <c:v>2.7833959559572512</c:v>
                </c:pt>
                <c:pt idx="5">
                  <c:v>10.729571896975422</c:v>
                </c:pt>
                <c:pt idx="6">
                  <c:v>3.4975811535060521</c:v>
                </c:pt>
                <c:pt idx="7">
                  <c:v>3.6700815118627337</c:v>
                </c:pt>
                <c:pt idx="8">
                  <c:v>1.69755126726904</c:v>
                </c:pt>
                <c:pt idx="9">
                  <c:v>5.5165449249208081</c:v>
                </c:pt>
                <c:pt idx="10">
                  <c:v>2.4801872349495069</c:v>
                </c:pt>
                <c:pt idx="11">
                  <c:v>23.497033128736515</c:v>
                </c:pt>
                <c:pt idx="12">
                  <c:v>0.80395744698717797</c:v>
                </c:pt>
                <c:pt idx="13">
                  <c:v>8.4616266945739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97C0-47AB-9C21-FD1512B6756A}"/>
            </c:ext>
          </c:extLst>
        </c:ser>
        <c:ser>
          <c:idx val="20"/>
          <c:order val="20"/>
          <c:tx>
            <c:strRef>
              <c:f>'EPA8'!$B$24</c:f>
              <c:strCache>
                <c:ptCount val="1"/>
                <c:pt idx="0">
                  <c:v>E8.30</c:v>
                </c:pt>
              </c:strCache>
            </c:strRef>
          </c:tx>
          <c:spPr>
            <a:solidFill>
              <a:schemeClr val="accent3">
                <a:shade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4:$P$24</c:f>
              <c:numCache>
                <c:formatCode>General</c:formatCode>
                <c:ptCount val="14"/>
                <c:pt idx="0">
                  <c:v>9.1490958375157643</c:v>
                </c:pt>
                <c:pt idx="1">
                  <c:v>3.3641992597470165</c:v>
                </c:pt>
                <c:pt idx="2">
                  <c:v>11.516119930699626</c:v>
                </c:pt>
                <c:pt idx="3">
                  <c:v>12.371726569553735</c:v>
                </c:pt>
                <c:pt idx="4">
                  <c:v>2.6365184077315029</c:v>
                </c:pt>
                <c:pt idx="5">
                  <c:v>12.486824451455885</c:v>
                </c:pt>
                <c:pt idx="6">
                  <c:v>3.1169480970484522</c:v>
                </c:pt>
                <c:pt idx="7">
                  <c:v>3.7493741457069119</c:v>
                </c:pt>
                <c:pt idx="8">
                  <c:v>1.5629710543036894</c:v>
                </c:pt>
                <c:pt idx="9">
                  <c:v>5.2225509996346133</c:v>
                </c:pt>
                <c:pt idx="10">
                  <c:v>2.2839394215486588</c:v>
                </c:pt>
                <c:pt idx="11">
                  <c:v>23.503751985664444</c:v>
                </c:pt>
                <c:pt idx="12">
                  <c:v>0.61139176296067255</c:v>
                </c:pt>
                <c:pt idx="13">
                  <c:v>8.5332304488588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97C0-47AB-9C21-FD1512B6756A}"/>
            </c:ext>
          </c:extLst>
        </c:ser>
        <c:ser>
          <c:idx val="21"/>
          <c:order val="21"/>
          <c:tx>
            <c:strRef>
              <c:f>'EPA8'!$B$25</c:f>
              <c:strCache>
                <c:ptCount val="1"/>
                <c:pt idx="0">
                  <c:v>E8.5</c:v>
                </c:pt>
              </c:strCache>
            </c:strRef>
          </c:tx>
          <c:spPr>
            <a:solidFill>
              <a:schemeClr val="accent3">
                <a:shade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5:$P$25</c:f>
              <c:numCache>
                <c:formatCode>General</c:formatCode>
                <c:ptCount val="14"/>
                <c:pt idx="0">
                  <c:v>8.7816987330932328</c:v>
                </c:pt>
                <c:pt idx="1">
                  <c:v>3.3592285512034352</c:v>
                </c:pt>
                <c:pt idx="2">
                  <c:v>10.57463431689979</c:v>
                </c:pt>
                <c:pt idx="3">
                  <c:v>11.170641446348954</c:v>
                </c:pt>
                <c:pt idx="4">
                  <c:v>3.2018038692410347</c:v>
                </c:pt>
                <c:pt idx="5">
                  <c:v>11.624935722888047</c:v>
                </c:pt>
                <c:pt idx="6">
                  <c:v>4.1412894363117543</c:v>
                </c:pt>
                <c:pt idx="7">
                  <c:v>3.7528838260624626</c:v>
                </c:pt>
                <c:pt idx="8">
                  <c:v>1.6978327641513644</c:v>
                </c:pt>
                <c:pt idx="9">
                  <c:v>5.4444845174671741</c:v>
                </c:pt>
                <c:pt idx="10">
                  <c:v>2.6347965362493624</c:v>
                </c:pt>
                <c:pt idx="11">
                  <c:v>23.902293281253723</c:v>
                </c:pt>
                <c:pt idx="12">
                  <c:v>0.76486539930068553</c:v>
                </c:pt>
                <c:pt idx="13">
                  <c:v>8.42458807642904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97C0-47AB-9C21-FD1512B6756A}"/>
            </c:ext>
          </c:extLst>
        </c:ser>
        <c:ser>
          <c:idx val="22"/>
          <c:order val="22"/>
          <c:tx>
            <c:strRef>
              <c:f>'EPA8'!$B$26</c:f>
              <c:strCache>
                <c:ptCount val="1"/>
                <c:pt idx="0">
                  <c:v>E8.18</c:v>
                </c:pt>
              </c:strCache>
            </c:strRef>
          </c:tx>
          <c:spPr>
            <a:solidFill>
              <a:schemeClr val="accent3">
                <a:shade val="66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6:$P$26</c:f>
              <c:numCache>
                <c:formatCode>General</c:formatCode>
                <c:ptCount val="14"/>
                <c:pt idx="0">
                  <c:v>8.8566362449068787</c:v>
                </c:pt>
                <c:pt idx="1">
                  <c:v>3.1557059042101443</c:v>
                </c:pt>
                <c:pt idx="2">
                  <c:v>12.876061092605193</c:v>
                </c:pt>
                <c:pt idx="3">
                  <c:v>10.736155003823331</c:v>
                </c:pt>
                <c:pt idx="4">
                  <c:v>2.5137792659947391</c:v>
                </c:pt>
                <c:pt idx="5">
                  <c:v>12.08050425918695</c:v>
                </c:pt>
                <c:pt idx="6">
                  <c:v>3.4730985193052364</c:v>
                </c:pt>
                <c:pt idx="7">
                  <c:v>3.7941415981524274</c:v>
                </c:pt>
                <c:pt idx="8">
                  <c:v>1.2565913714220036</c:v>
                </c:pt>
                <c:pt idx="9">
                  <c:v>5.0317065521240094</c:v>
                </c:pt>
                <c:pt idx="10">
                  <c:v>2.1279543304075643</c:v>
                </c:pt>
                <c:pt idx="11">
                  <c:v>24.173920804244787</c:v>
                </c:pt>
                <c:pt idx="12">
                  <c:v>0.79663134814291137</c:v>
                </c:pt>
                <c:pt idx="13">
                  <c:v>8.94861159952899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97C0-47AB-9C21-FD1512B6756A}"/>
            </c:ext>
          </c:extLst>
        </c:ser>
        <c:ser>
          <c:idx val="23"/>
          <c:order val="23"/>
          <c:tx>
            <c:strRef>
              <c:f>'EPA8'!$B$27</c:f>
              <c:strCache>
                <c:ptCount val="1"/>
                <c:pt idx="0">
                  <c:v>E8.10</c:v>
                </c:pt>
              </c:strCache>
            </c:strRef>
          </c:tx>
          <c:spPr>
            <a:solidFill>
              <a:schemeClr val="accent3">
                <a:shade val="61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7:$P$27</c:f>
              <c:numCache>
                <c:formatCode>General</c:formatCode>
                <c:ptCount val="14"/>
                <c:pt idx="0">
                  <c:v>8.7070469540318705</c:v>
                </c:pt>
                <c:pt idx="1">
                  <c:v>4.2503993636494712</c:v>
                </c:pt>
                <c:pt idx="2">
                  <c:v>12.693965777867744</c:v>
                </c:pt>
                <c:pt idx="3">
                  <c:v>10.576600705025694</c:v>
                </c:pt>
                <c:pt idx="4">
                  <c:v>2.6155284290353933</c:v>
                </c:pt>
                <c:pt idx="5">
                  <c:v>10.589774363042846</c:v>
                </c:pt>
                <c:pt idx="6">
                  <c:v>3.7855943389054527</c:v>
                </c:pt>
                <c:pt idx="7">
                  <c:v>4.0429138268107057</c:v>
                </c:pt>
                <c:pt idx="8">
                  <c:v>1.6358975520923058</c:v>
                </c:pt>
                <c:pt idx="9">
                  <c:v>4.808646810407299</c:v>
                </c:pt>
                <c:pt idx="10">
                  <c:v>2.6238808846169568</c:v>
                </c:pt>
                <c:pt idx="11">
                  <c:v>24.180794045147881</c:v>
                </c:pt>
                <c:pt idx="12">
                  <c:v>0.86361696371660235</c:v>
                </c:pt>
                <c:pt idx="13">
                  <c:v>9.12711370547385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97C0-47AB-9C21-FD1512B6756A}"/>
            </c:ext>
          </c:extLst>
        </c:ser>
        <c:ser>
          <c:idx val="24"/>
          <c:order val="24"/>
          <c:tx>
            <c:strRef>
              <c:f>'EPA8'!$B$28</c:f>
              <c:strCache>
                <c:ptCount val="1"/>
                <c:pt idx="0">
                  <c:v>E8.2</c:v>
                </c:pt>
              </c:strCache>
            </c:strRef>
          </c:tx>
          <c:spPr>
            <a:solidFill>
              <a:schemeClr val="accent3">
                <a:shade val="57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8:$P$28</c:f>
              <c:numCache>
                <c:formatCode>General</c:formatCode>
                <c:ptCount val="14"/>
                <c:pt idx="0">
                  <c:v>8.1763426397357932</c:v>
                </c:pt>
                <c:pt idx="1">
                  <c:v>3.7617068035706649</c:v>
                </c:pt>
                <c:pt idx="2">
                  <c:v>12.372305423953749</c:v>
                </c:pt>
                <c:pt idx="3">
                  <c:v>10.244211547891974</c:v>
                </c:pt>
                <c:pt idx="4">
                  <c:v>2.6740147404714256</c:v>
                </c:pt>
                <c:pt idx="5">
                  <c:v>10.974792205874618</c:v>
                </c:pt>
                <c:pt idx="6">
                  <c:v>3.9271946353254519</c:v>
                </c:pt>
                <c:pt idx="7">
                  <c:v>4.0676926960740136</c:v>
                </c:pt>
                <c:pt idx="8">
                  <c:v>1.570703625699448</c:v>
                </c:pt>
                <c:pt idx="9">
                  <c:v>4.8557267821774888</c:v>
                </c:pt>
                <c:pt idx="10">
                  <c:v>2.6011076924296708</c:v>
                </c:pt>
                <c:pt idx="11">
                  <c:v>24.348087189091032</c:v>
                </c:pt>
                <c:pt idx="12">
                  <c:v>0.90699640720363939</c:v>
                </c:pt>
                <c:pt idx="13">
                  <c:v>8.62533998564979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97C0-47AB-9C21-FD1512B6756A}"/>
            </c:ext>
          </c:extLst>
        </c:ser>
        <c:ser>
          <c:idx val="25"/>
          <c:order val="25"/>
          <c:tx>
            <c:strRef>
              <c:f>'EPA8'!$B$29</c:f>
              <c:strCache>
                <c:ptCount val="1"/>
                <c:pt idx="0">
                  <c:v>E8.26</c:v>
                </c:pt>
              </c:strCache>
            </c:strRef>
          </c:tx>
          <c:spPr>
            <a:solidFill>
              <a:schemeClr val="accent3">
                <a:shade val="52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29:$P$29</c:f>
              <c:numCache>
                <c:formatCode>General</c:formatCode>
                <c:ptCount val="14"/>
                <c:pt idx="0">
                  <c:v>8.5125798808936715</c:v>
                </c:pt>
                <c:pt idx="1">
                  <c:v>3.4837008714667164</c:v>
                </c:pt>
                <c:pt idx="2">
                  <c:v>7.5183483458773246</c:v>
                </c:pt>
                <c:pt idx="3">
                  <c:v>12.745350220773444</c:v>
                </c:pt>
                <c:pt idx="4">
                  <c:v>3.2693700557333867</c:v>
                </c:pt>
                <c:pt idx="5">
                  <c:v>11.987753541500075</c:v>
                </c:pt>
                <c:pt idx="6">
                  <c:v>4.2952911010732127</c:v>
                </c:pt>
                <c:pt idx="7">
                  <c:v>3.8932476367162288</c:v>
                </c:pt>
                <c:pt idx="8">
                  <c:v>1.669590166901276</c:v>
                </c:pt>
                <c:pt idx="9">
                  <c:v>4.9330315596364942</c:v>
                </c:pt>
                <c:pt idx="10">
                  <c:v>2.5885134663403151</c:v>
                </c:pt>
                <c:pt idx="11">
                  <c:v>24.980157949830581</c:v>
                </c:pt>
                <c:pt idx="12">
                  <c:v>0.63735915426704681</c:v>
                </c:pt>
                <c:pt idx="13">
                  <c:v>9.5191176105010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97C0-47AB-9C21-FD1512B6756A}"/>
            </c:ext>
          </c:extLst>
        </c:ser>
        <c:ser>
          <c:idx val="26"/>
          <c:order val="26"/>
          <c:tx>
            <c:strRef>
              <c:f>'EPA8'!$B$30</c:f>
              <c:strCache>
                <c:ptCount val="1"/>
                <c:pt idx="0">
                  <c:v>E8.22</c:v>
                </c:pt>
              </c:strCache>
            </c:strRef>
          </c:tx>
          <c:spPr>
            <a:solidFill>
              <a:schemeClr val="accent3">
                <a:shade val="48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30:$P$30</c:f>
              <c:numCache>
                <c:formatCode>General</c:formatCode>
                <c:ptCount val="14"/>
                <c:pt idx="0">
                  <c:v>9.3326590252965289</c:v>
                </c:pt>
                <c:pt idx="1">
                  <c:v>3.4684237090892891</c:v>
                </c:pt>
                <c:pt idx="2">
                  <c:v>10.170389854537863</c:v>
                </c:pt>
                <c:pt idx="3">
                  <c:v>8.4418308311339061</c:v>
                </c:pt>
                <c:pt idx="4">
                  <c:v>2.4541111477982986</c:v>
                </c:pt>
                <c:pt idx="5">
                  <c:v>13.631927658205523</c:v>
                </c:pt>
                <c:pt idx="6">
                  <c:v>4.6237847442827711</c:v>
                </c:pt>
                <c:pt idx="7">
                  <c:v>3.6027095954145265</c:v>
                </c:pt>
                <c:pt idx="8">
                  <c:v>1.313668892655194</c:v>
                </c:pt>
                <c:pt idx="9">
                  <c:v>3.4014212672793374</c:v>
                </c:pt>
                <c:pt idx="10">
                  <c:v>3.2663435162129</c:v>
                </c:pt>
                <c:pt idx="11">
                  <c:v>26.340964156662004</c:v>
                </c:pt>
                <c:pt idx="12">
                  <c:v>0.88605466963664048</c:v>
                </c:pt>
                <c:pt idx="13">
                  <c:v>9.48570604899021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97C0-47AB-9C21-FD1512B6756A}"/>
            </c:ext>
          </c:extLst>
        </c:ser>
        <c:ser>
          <c:idx val="27"/>
          <c:order val="27"/>
          <c:tx>
            <c:strRef>
              <c:f>'EPA8'!$B$31</c:f>
              <c:strCache>
                <c:ptCount val="1"/>
                <c:pt idx="0">
                  <c:v>E8.15</c:v>
                </c:pt>
              </c:strCache>
            </c:strRef>
          </c:tx>
          <c:spPr>
            <a:solidFill>
              <a:schemeClr val="accent3">
                <a:shade val="43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31:$P$31</c:f>
              <c:numCache>
                <c:formatCode>General</c:formatCode>
                <c:ptCount val="14"/>
                <c:pt idx="0">
                  <c:v>8.3564017423545138</c:v>
                </c:pt>
                <c:pt idx="1">
                  <c:v>3.2257987080708759</c:v>
                </c:pt>
                <c:pt idx="2">
                  <c:v>8.8262674499806284</c:v>
                </c:pt>
                <c:pt idx="3">
                  <c:v>9.2285684993190511</c:v>
                </c:pt>
                <c:pt idx="4">
                  <c:v>2.6315516589434083</c:v>
                </c:pt>
                <c:pt idx="5">
                  <c:v>13.631379058525498</c:v>
                </c:pt>
                <c:pt idx="6">
                  <c:v>4.2956406478353086</c:v>
                </c:pt>
                <c:pt idx="7">
                  <c:v>3.7653345819219033</c:v>
                </c:pt>
                <c:pt idx="8">
                  <c:v>1.4947448234261502</c:v>
                </c:pt>
                <c:pt idx="9">
                  <c:v>3.7904704976486303</c:v>
                </c:pt>
                <c:pt idx="10">
                  <c:v>3.2136006302124325</c:v>
                </c:pt>
                <c:pt idx="11">
                  <c:v>27.354380524315371</c:v>
                </c:pt>
                <c:pt idx="12">
                  <c:v>0.94245341208619382</c:v>
                </c:pt>
                <c:pt idx="13">
                  <c:v>9.0657109317952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97C0-47AB-9C21-FD1512B6756A}"/>
            </c:ext>
          </c:extLst>
        </c:ser>
        <c:ser>
          <c:idx val="28"/>
          <c:order val="28"/>
          <c:tx>
            <c:strRef>
              <c:f>'EPA8'!$B$32</c:f>
              <c:strCache>
                <c:ptCount val="1"/>
                <c:pt idx="0">
                  <c:v>E8.1</c:v>
                </c:pt>
              </c:strCache>
            </c:strRef>
          </c:tx>
          <c:spPr>
            <a:solidFill>
              <a:schemeClr val="accent3">
                <a:shade val="39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32:$P$32</c:f>
              <c:numCache>
                <c:formatCode>General</c:formatCode>
                <c:ptCount val="14"/>
                <c:pt idx="0">
                  <c:v>9.4485551873206362</c:v>
                </c:pt>
                <c:pt idx="1">
                  <c:v>2.6815657266286177</c:v>
                </c:pt>
                <c:pt idx="2">
                  <c:v>8.7911885115013906</c:v>
                </c:pt>
                <c:pt idx="3">
                  <c:v>11.164107187856199</c:v>
                </c:pt>
                <c:pt idx="4">
                  <c:v>2.7266704144443397</c:v>
                </c:pt>
                <c:pt idx="5">
                  <c:v>12.697646656033406</c:v>
                </c:pt>
                <c:pt idx="6">
                  <c:v>3.5775865180522186</c:v>
                </c:pt>
                <c:pt idx="7">
                  <c:v>3.5425755450036815</c:v>
                </c:pt>
                <c:pt idx="8">
                  <c:v>1.5078101040667258</c:v>
                </c:pt>
                <c:pt idx="9">
                  <c:v>4.8810774726808646</c:v>
                </c:pt>
                <c:pt idx="10">
                  <c:v>2.6985844424605885</c:v>
                </c:pt>
                <c:pt idx="11">
                  <c:v>27.48025515640483</c:v>
                </c:pt>
                <c:pt idx="12">
                  <c:v>0.80579952257893495</c:v>
                </c:pt>
                <c:pt idx="13">
                  <c:v>9.24340776536003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97C0-47AB-9C21-FD1512B6756A}"/>
            </c:ext>
          </c:extLst>
        </c:ser>
        <c:ser>
          <c:idx val="29"/>
          <c:order val="29"/>
          <c:tx>
            <c:strRef>
              <c:f>'EPA8'!$B$33</c:f>
              <c:strCache>
                <c:ptCount val="1"/>
                <c:pt idx="0">
                  <c:v>E8.29</c:v>
                </c:pt>
              </c:strCache>
            </c:strRef>
          </c:tx>
          <c:spPr>
            <a:solidFill>
              <a:schemeClr val="accent3">
                <a:shade val="34000"/>
              </a:schemeClr>
            </a:solidFill>
            <a:ln>
              <a:noFill/>
            </a:ln>
            <a:effectLst/>
          </c:spPr>
          <c:invertIfNegative val="0"/>
          <c:cat>
            <c:strRef>
              <c:f>'EPA8'!$C$3:$P$3</c:f>
              <c:strCache>
                <c:ptCount val="14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GLA</c:v>
                </c:pt>
                <c:pt idx="5">
                  <c:v>ALA</c:v>
                </c:pt>
                <c:pt idx="6">
                  <c:v>SDA</c:v>
                </c:pt>
                <c:pt idx="7">
                  <c:v>C20:1</c:v>
                </c:pt>
                <c:pt idx="8">
                  <c:v>DGLA</c:v>
                </c:pt>
                <c:pt idx="9">
                  <c:v>ARA</c:v>
                </c:pt>
                <c:pt idx="10">
                  <c:v>ETA</c:v>
                </c:pt>
                <c:pt idx="11">
                  <c:v>EPA</c:v>
                </c:pt>
                <c:pt idx="12">
                  <c:v>DPA</c:v>
                </c:pt>
                <c:pt idx="13">
                  <c:v>Others</c:v>
                </c:pt>
              </c:strCache>
            </c:strRef>
          </c:cat>
          <c:val>
            <c:numRef>
              <c:f>'EPA8'!$C$33:$P$33</c:f>
              <c:numCache>
                <c:formatCode>General</c:formatCode>
                <c:ptCount val="14"/>
                <c:pt idx="0">
                  <c:v>9.1051148642109219</c:v>
                </c:pt>
                <c:pt idx="1">
                  <c:v>3.3375460238535259</c:v>
                </c:pt>
                <c:pt idx="2">
                  <c:v>8.0183373055162654</c:v>
                </c:pt>
                <c:pt idx="3">
                  <c:v>9.1894209461140086</c:v>
                </c:pt>
                <c:pt idx="4">
                  <c:v>2.8119932094682318</c:v>
                </c:pt>
                <c:pt idx="5">
                  <c:v>13.444169199416429</c:v>
                </c:pt>
                <c:pt idx="6">
                  <c:v>4.3840921248517111</c:v>
                </c:pt>
                <c:pt idx="7">
                  <c:v>3.6625812148656398</c:v>
                </c:pt>
                <c:pt idx="8">
                  <c:v>1.6592941337717122</c:v>
                </c:pt>
                <c:pt idx="9">
                  <c:v>3.8843720078531847</c:v>
                </c:pt>
                <c:pt idx="10">
                  <c:v>3.6041759923754983</c:v>
                </c:pt>
                <c:pt idx="11">
                  <c:v>27.773903371486298</c:v>
                </c:pt>
                <c:pt idx="12">
                  <c:v>0.8680003487782515</c:v>
                </c:pt>
                <c:pt idx="13">
                  <c:v>8.25699925743833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97C0-47AB-9C21-FD1512B675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236312968"/>
        <c:axId val="1236316576"/>
      </c:barChart>
      <c:catAx>
        <c:axId val="1236312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6316576"/>
        <c:crosses val="autoZero"/>
        <c:auto val="1"/>
        <c:lblAlgn val="ctr"/>
        <c:lblOffset val="100"/>
        <c:noMultiLvlLbl val="0"/>
      </c:catAx>
      <c:valAx>
        <c:axId val="1236316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dirty="0"/>
                  <a:t>FAMEs (mol%)</a:t>
                </a:r>
              </a:p>
            </c:rich>
          </c:tx>
          <c:layout>
            <c:manualLayout>
              <c:xMode val="edge"/>
              <c:yMode val="edge"/>
              <c:x val="0"/>
              <c:y val="0.175801019381951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6312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477139487916712"/>
          <c:y val="0.83149642018051018"/>
          <c:w val="0.79016854338816733"/>
          <c:h val="0.10328367662225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rgbClr val="BB5611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rgbClr val="BB5611"/>
                </a:solidFill>
              </a:rPr>
              <a:t>TAG containing EPA (20:5)</a:t>
            </a:r>
            <a:endParaRPr lang="en-GB" sz="1400" dirty="0">
              <a:solidFill>
                <a:srgbClr val="BB5611"/>
              </a:solidFill>
            </a:endParaRPr>
          </a:p>
        </c:rich>
      </c:tx>
      <c:layout>
        <c:manualLayout>
          <c:xMode val="edge"/>
          <c:yMode val="edge"/>
          <c:x val="0.57861213099785169"/>
          <c:y val="5.65522205153588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rgbClr val="BB561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5274130857779901E-2"/>
          <c:y val="5.5354432147499438E-2"/>
          <c:w val="0.86827462404435185"/>
          <c:h val="0.564595867976288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9-2 EPA (EPA line)'!$C$3</c:f>
              <c:strCache>
                <c:ptCount val="1"/>
                <c:pt idx="0">
                  <c:v>EPA2016.1</c:v>
                </c:pt>
              </c:strCache>
            </c:strRef>
          </c:tx>
          <c:spPr>
            <a:solidFill>
              <a:srgbClr val="BB561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2 EPA (EPA line)'!$F$4:$F$34</c:f>
                <c:numCache>
                  <c:formatCode>General</c:formatCode>
                  <c:ptCount val="31"/>
                  <c:pt idx="0">
                    <c:v>0.6127231598822086</c:v>
                  </c:pt>
                  <c:pt idx="1">
                    <c:v>8.8556629357410738E-2</c:v>
                  </c:pt>
                  <c:pt idx="2">
                    <c:v>0.381135966870849</c:v>
                  </c:pt>
                  <c:pt idx="3">
                    <c:v>1.1195311543054802</c:v>
                  </c:pt>
                  <c:pt idx="4">
                    <c:v>0.63684991077741593</c:v>
                  </c:pt>
                  <c:pt idx="5">
                    <c:v>0.47764014766825336</c:v>
                  </c:pt>
                  <c:pt idx="6">
                    <c:v>0.47436816245038899</c:v>
                  </c:pt>
                  <c:pt idx="7">
                    <c:v>0.74643906854588571</c:v>
                  </c:pt>
                  <c:pt idx="8">
                    <c:v>0.54882553414490376</c:v>
                  </c:pt>
                  <c:pt idx="9">
                    <c:v>0.28739822918313729</c:v>
                  </c:pt>
                  <c:pt idx="10">
                    <c:v>0.88310703795771262</c:v>
                  </c:pt>
                  <c:pt idx="11">
                    <c:v>0.39081446159111516</c:v>
                  </c:pt>
                  <c:pt idx="12">
                    <c:v>0.26985150314911999</c:v>
                  </c:pt>
                  <c:pt idx="13">
                    <c:v>0.49543558819829603</c:v>
                  </c:pt>
                  <c:pt idx="14">
                    <c:v>0.34585601612494687</c:v>
                  </c:pt>
                  <c:pt idx="15">
                    <c:v>0.24880388682209675</c:v>
                  </c:pt>
                  <c:pt idx="16">
                    <c:v>0.2351523145994476</c:v>
                  </c:pt>
                  <c:pt idx="17">
                    <c:v>0.32765649986339174</c:v>
                  </c:pt>
                  <c:pt idx="18">
                    <c:v>0</c:v>
                  </c:pt>
                  <c:pt idx="19">
                    <c:v>0.17748539110932682</c:v>
                  </c:pt>
                  <c:pt idx="20">
                    <c:v>0.10440005580566004</c:v>
                  </c:pt>
                  <c:pt idx="21">
                    <c:v>0.16743809580829708</c:v>
                  </c:pt>
                  <c:pt idx="22">
                    <c:v>8.6272886368639626E-2</c:v>
                  </c:pt>
                  <c:pt idx="23">
                    <c:v>0.2330568412365065</c:v>
                  </c:pt>
                  <c:pt idx="24">
                    <c:v>3.0027048790848616E-2</c:v>
                  </c:pt>
                  <c:pt idx="25">
                    <c:v>0</c:v>
                  </c:pt>
                  <c:pt idx="26">
                    <c:v>2.1485864007506832E-2</c:v>
                  </c:pt>
                  <c:pt idx="27">
                    <c:v>3.3326872073905778E-2</c:v>
                  </c:pt>
                  <c:pt idx="28">
                    <c:v>7.4566772653940502E-2</c:v>
                  </c:pt>
                  <c:pt idx="29">
                    <c:v>0</c:v>
                  </c:pt>
                  <c:pt idx="30">
                    <c:v>0</c:v>
                  </c:pt>
                </c:numCache>
              </c:numRef>
            </c:plus>
            <c:minus>
              <c:numRef>
                <c:f>'S9-2 EPA (EPA line)'!$F$4:$F$34</c:f>
                <c:numCache>
                  <c:formatCode>General</c:formatCode>
                  <c:ptCount val="31"/>
                  <c:pt idx="0">
                    <c:v>0.6127231598822086</c:v>
                  </c:pt>
                  <c:pt idx="1">
                    <c:v>8.8556629357410738E-2</c:v>
                  </c:pt>
                  <c:pt idx="2">
                    <c:v>0.381135966870849</c:v>
                  </c:pt>
                  <c:pt idx="3">
                    <c:v>1.1195311543054802</c:v>
                  </c:pt>
                  <c:pt idx="4">
                    <c:v>0.63684991077741593</c:v>
                  </c:pt>
                  <c:pt idx="5">
                    <c:v>0.47764014766825336</c:v>
                  </c:pt>
                  <c:pt idx="6">
                    <c:v>0.47436816245038899</c:v>
                  </c:pt>
                  <c:pt idx="7">
                    <c:v>0.74643906854588571</c:v>
                  </c:pt>
                  <c:pt idx="8">
                    <c:v>0.54882553414490376</c:v>
                  </c:pt>
                  <c:pt idx="9">
                    <c:v>0.28739822918313729</c:v>
                  </c:pt>
                  <c:pt idx="10">
                    <c:v>0.88310703795771262</c:v>
                  </c:pt>
                  <c:pt idx="11">
                    <c:v>0.39081446159111516</c:v>
                  </c:pt>
                  <c:pt idx="12">
                    <c:v>0.26985150314911999</c:v>
                  </c:pt>
                  <c:pt idx="13">
                    <c:v>0.49543558819829603</c:v>
                  </c:pt>
                  <c:pt idx="14">
                    <c:v>0.34585601612494687</c:v>
                  </c:pt>
                  <c:pt idx="15">
                    <c:v>0.24880388682209675</c:v>
                  </c:pt>
                  <c:pt idx="16">
                    <c:v>0.2351523145994476</c:v>
                  </c:pt>
                  <c:pt idx="17">
                    <c:v>0.32765649986339174</c:v>
                  </c:pt>
                  <c:pt idx="18">
                    <c:v>0</c:v>
                  </c:pt>
                  <c:pt idx="19">
                    <c:v>0.17748539110932682</c:v>
                  </c:pt>
                  <c:pt idx="20">
                    <c:v>0.10440005580566004</c:v>
                  </c:pt>
                  <c:pt idx="21">
                    <c:v>0.16743809580829708</c:v>
                  </c:pt>
                  <c:pt idx="22">
                    <c:v>8.6272886368639626E-2</c:v>
                  </c:pt>
                  <c:pt idx="23">
                    <c:v>0.2330568412365065</c:v>
                  </c:pt>
                  <c:pt idx="24">
                    <c:v>3.0027048790848616E-2</c:v>
                  </c:pt>
                  <c:pt idx="25">
                    <c:v>0</c:v>
                  </c:pt>
                  <c:pt idx="26">
                    <c:v>2.1485864007506832E-2</c:v>
                  </c:pt>
                  <c:pt idx="27">
                    <c:v>3.3326872073905778E-2</c:v>
                  </c:pt>
                  <c:pt idx="28">
                    <c:v>7.4566772653940502E-2</c:v>
                  </c:pt>
                  <c:pt idx="29">
                    <c:v>0</c:v>
                  </c:pt>
                  <c:pt idx="3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2 EPA (EPA line)'!$B$4:$B$34</c:f>
              <c:strCache>
                <c:ptCount val="31"/>
                <c:pt idx="0">
                  <c:v>54:7(20:5)</c:v>
                </c:pt>
                <c:pt idx="1">
                  <c:v>54:8(20:5)</c:v>
                </c:pt>
                <c:pt idx="2">
                  <c:v>56:6(20:5)</c:v>
                </c:pt>
                <c:pt idx="3">
                  <c:v>56:7(20:5)</c:v>
                </c:pt>
                <c:pt idx="4">
                  <c:v>56:8(20:5)</c:v>
                </c:pt>
                <c:pt idx="5">
                  <c:v>56:9(20:5)</c:v>
                </c:pt>
                <c:pt idx="6">
                  <c:v>56:10(20:5)</c:v>
                </c:pt>
                <c:pt idx="7">
                  <c:v>56:11(20:5)</c:v>
                </c:pt>
                <c:pt idx="8">
                  <c:v>58:6(20:5)</c:v>
                </c:pt>
                <c:pt idx="9">
                  <c:v>58:7(20:5)</c:v>
                </c:pt>
                <c:pt idx="10">
                  <c:v>58:8(20:5)</c:v>
                </c:pt>
                <c:pt idx="11">
                  <c:v>58:9(20:5)</c:v>
                </c:pt>
                <c:pt idx="12">
                  <c:v>58:10(20:5)</c:v>
                </c:pt>
                <c:pt idx="13">
                  <c:v>58:11(20:5)</c:v>
                </c:pt>
                <c:pt idx="14">
                  <c:v>58:12(20:5)</c:v>
                </c:pt>
                <c:pt idx="15">
                  <c:v>58:13(20:5)</c:v>
                </c:pt>
                <c:pt idx="16">
                  <c:v>60:7(20:5)</c:v>
                </c:pt>
                <c:pt idx="17">
                  <c:v>60:8(20:5)</c:v>
                </c:pt>
                <c:pt idx="18">
                  <c:v>60:9(20:5)</c:v>
                </c:pt>
                <c:pt idx="19">
                  <c:v>60:10(20:5)</c:v>
                </c:pt>
                <c:pt idx="20">
                  <c:v>60:11(20:5)</c:v>
                </c:pt>
                <c:pt idx="21">
                  <c:v>60:12(20:5)</c:v>
                </c:pt>
                <c:pt idx="22">
                  <c:v>60:13(20:5)</c:v>
                </c:pt>
                <c:pt idx="23">
                  <c:v>60:14(20:5)</c:v>
                </c:pt>
                <c:pt idx="24">
                  <c:v>60:15(20:5)</c:v>
                </c:pt>
                <c:pt idx="25">
                  <c:v>62:12(20:5)</c:v>
                </c:pt>
                <c:pt idx="26">
                  <c:v>62:13(20:5)</c:v>
                </c:pt>
                <c:pt idx="27">
                  <c:v>62:14(20:5)</c:v>
                </c:pt>
                <c:pt idx="28">
                  <c:v>62:15(20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2 EPA (EPA line)'!$C$4:$C$34</c:f>
              <c:numCache>
                <c:formatCode>General</c:formatCode>
                <c:ptCount val="31"/>
                <c:pt idx="0">
                  <c:v>3.3574804471219579</c:v>
                </c:pt>
                <c:pt idx="1">
                  <c:v>4.6532109101397978</c:v>
                </c:pt>
                <c:pt idx="2">
                  <c:v>2.4602543813926174</c:v>
                </c:pt>
                <c:pt idx="3">
                  <c:v>7.0781294040472353</c:v>
                </c:pt>
                <c:pt idx="4">
                  <c:v>7.8253045079324517</c:v>
                </c:pt>
                <c:pt idx="5">
                  <c:v>7.9595294836183852</c:v>
                </c:pt>
                <c:pt idx="6">
                  <c:v>7.1004144195391738</c:v>
                </c:pt>
                <c:pt idx="7">
                  <c:v>5.7276652074530459</c:v>
                </c:pt>
                <c:pt idx="8">
                  <c:v>1.419178794776994</c:v>
                </c:pt>
                <c:pt idx="9">
                  <c:v>6.9172119568781456</c:v>
                </c:pt>
                <c:pt idx="10">
                  <c:v>7.5908068552437227</c:v>
                </c:pt>
                <c:pt idx="11">
                  <c:v>9.0851472587312738</c:v>
                </c:pt>
                <c:pt idx="12">
                  <c:v>3.8330445248100879</c:v>
                </c:pt>
                <c:pt idx="13">
                  <c:v>5.6615461869416706</c:v>
                </c:pt>
                <c:pt idx="14">
                  <c:v>2.6242827583689987</c:v>
                </c:pt>
                <c:pt idx="15">
                  <c:v>1.7359469300154207</c:v>
                </c:pt>
                <c:pt idx="16">
                  <c:v>1.1204669530110893</c:v>
                </c:pt>
                <c:pt idx="17">
                  <c:v>0.32765649986339174</c:v>
                </c:pt>
                <c:pt idx="18">
                  <c:v>0</c:v>
                </c:pt>
                <c:pt idx="19">
                  <c:v>1.0884201581881296</c:v>
                </c:pt>
                <c:pt idx="20">
                  <c:v>2.1777779453434074</c:v>
                </c:pt>
                <c:pt idx="21">
                  <c:v>0.5943186295296905</c:v>
                </c:pt>
                <c:pt idx="22">
                  <c:v>1.1821070992351295</c:v>
                </c:pt>
                <c:pt idx="23">
                  <c:v>0.45253609543658441</c:v>
                </c:pt>
                <c:pt idx="24">
                  <c:v>0.98913671435639661</c:v>
                </c:pt>
                <c:pt idx="25">
                  <c:v>0</c:v>
                </c:pt>
                <c:pt idx="26">
                  <c:v>2.1485864007506832E-2</c:v>
                </c:pt>
                <c:pt idx="27">
                  <c:v>3.3326872073905778E-2</c:v>
                </c:pt>
                <c:pt idx="28">
                  <c:v>7.4566772653940502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A8-4F33-8ABE-961B3F5A90E0}"/>
            </c:ext>
          </c:extLst>
        </c:ser>
        <c:ser>
          <c:idx val="1"/>
          <c:order val="1"/>
          <c:tx>
            <c:strRef>
              <c:f>'S9-2 EPA (EPA line)'!$D$3</c:f>
              <c:strCache>
                <c:ptCount val="1"/>
                <c:pt idx="0">
                  <c:v>EPA2015.8</c:v>
                </c:pt>
              </c:strCache>
            </c:strRef>
          </c:tx>
          <c:spPr>
            <a:solidFill>
              <a:srgbClr val="F2BAA8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2 EPA (EPA line)'!$G$4:$G$34</c:f>
                <c:numCache>
                  <c:formatCode>General</c:formatCode>
                  <c:ptCount val="31"/>
                  <c:pt idx="0">
                    <c:v>1.5332005941562987</c:v>
                  </c:pt>
                  <c:pt idx="1">
                    <c:v>0.4917736360563138</c:v>
                  </c:pt>
                  <c:pt idx="2">
                    <c:v>0.68194633556647077</c:v>
                  </c:pt>
                  <c:pt idx="3">
                    <c:v>2.231437624360959</c:v>
                  </c:pt>
                  <c:pt idx="4">
                    <c:v>2.5737409218683078</c:v>
                  </c:pt>
                  <c:pt idx="5">
                    <c:v>2.8824367921696568</c:v>
                  </c:pt>
                  <c:pt idx="6">
                    <c:v>1.5773380432313913</c:v>
                  </c:pt>
                  <c:pt idx="7">
                    <c:v>0.2078189935317577</c:v>
                  </c:pt>
                  <c:pt idx="8">
                    <c:v>0.29418255108362307</c:v>
                  </c:pt>
                  <c:pt idx="9">
                    <c:v>0.2263436110945764</c:v>
                  </c:pt>
                  <c:pt idx="10">
                    <c:v>1.6465730750866965</c:v>
                  </c:pt>
                  <c:pt idx="11">
                    <c:v>0.6861910997360865</c:v>
                  </c:pt>
                  <c:pt idx="12">
                    <c:v>1.2293193454098157</c:v>
                  </c:pt>
                  <c:pt idx="13">
                    <c:v>1.3459234275712668</c:v>
                  </c:pt>
                  <c:pt idx="14">
                    <c:v>0.64309062316461096</c:v>
                  </c:pt>
                  <c:pt idx="15">
                    <c:v>0.39480493638659575</c:v>
                  </c:pt>
                  <c:pt idx="16">
                    <c:v>0.20433155231098321</c:v>
                  </c:pt>
                  <c:pt idx="17">
                    <c:v>0.18247031170186151</c:v>
                  </c:pt>
                  <c:pt idx="18">
                    <c:v>0.38482600030618824</c:v>
                  </c:pt>
                  <c:pt idx="19">
                    <c:v>0.75997343875844736</c:v>
                  </c:pt>
                  <c:pt idx="20">
                    <c:v>0.75197486450782636</c:v>
                  </c:pt>
                  <c:pt idx="21">
                    <c:v>0.50748388609170536</c:v>
                  </c:pt>
                  <c:pt idx="22">
                    <c:v>0.19911638849798674</c:v>
                  </c:pt>
                  <c:pt idx="23">
                    <c:v>0.65275347474031808</c:v>
                  </c:pt>
                  <c:pt idx="24">
                    <c:v>8.6566453744427355E-2</c:v>
                  </c:pt>
                  <c:pt idx="25">
                    <c:v>3.5298260067147792E-2</c:v>
                  </c:pt>
                  <c:pt idx="26">
                    <c:v>5.4145969254576452E-2</c:v>
                  </c:pt>
                  <c:pt idx="27">
                    <c:v>0</c:v>
                  </c:pt>
                  <c:pt idx="28">
                    <c:v>0.13725401683888785</c:v>
                  </c:pt>
                  <c:pt idx="29">
                    <c:v>0</c:v>
                  </c:pt>
                  <c:pt idx="30">
                    <c:v>0</c:v>
                  </c:pt>
                </c:numCache>
              </c:numRef>
            </c:plus>
            <c:minus>
              <c:numRef>
                <c:f>'S9-2 EPA (EPA line)'!$G$4:$G$34</c:f>
                <c:numCache>
                  <c:formatCode>General</c:formatCode>
                  <c:ptCount val="31"/>
                  <c:pt idx="0">
                    <c:v>1.5332005941562987</c:v>
                  </c:pt>
                  <c:pt idx="1">
                    <c:v>0.4917736360563138</c:v>
                  </c:pt>
                  <c:pt idx="2">
                    <c:v>0.68194633556647077</c:v>
                  </c:pt>
                  <c:pt idx="3">
                    <c:v>2.231437624360959</c:v>
                  </c:pt>
                  <c:pt idx="4">
                    <c:v>2.5737409218683078</c:v>
                  </c:pt>
                  <c:pt idx="5">
                    <c:v>2.8824367921696568</c:v>
                  </c:pt>
                  <c:pt idx="6">
                    <c:v>1.5773380432313913</c:v>
                  </c:pt>
                  <c:pt idx="7">
                    <c:v>0.2078189935317577</c:v>
                  </c:pt>
                  <c:pt idx="8">
                    <c:v>0.29418255108362307</c:v>
                  </c:pt>
                  <c:pt idx="9">
                    <c:v>0.2263436110945764</c:v>
                  </c:pt>
                  <c:pt idx="10">
                    <c:v>1.6465730750866965</c:v>
                  </c:pt>
                  <c:pt idx="11">
                    <c:v>0.6861910997360865</c:v>
                  </c:pt>
                  <c:pt idx="12">
                    <c:v>1.2293193454098157</c:v>
                  </c:pt>
                  <c:pt idx="13">
                    <c:v>1.3459234275712668</c:v>
                  </c:pt>
                  <c:pt idx="14">
                    <c:v>0.64309062316461096</c:v>
                  </c:pt>
                  <c:pt idx="15">
                    <c:v>0.39480493638659575</c:v>
                  </c:pt>
                  <c:pt idx="16">
                    <c:v>0.20433155231098321</c:v>
                  </c:pt>
                  <c:pt idx="17">
                    <c:v>0.18247031170186151</c:v>
                  </c:pt>
                  <c:pt idx="18">
                    <c:v>0.38482600030618824</c:v>
                  </c:pt>
                  <c:pt idx="19">
                    <c:v>0.75997343875844736</c:v>
                  </c:pt>
                  <c:pt idx="20">
                    <c:v>0.75197486450782636</c:v>
                  </c:pt>
                  <c:pt idx="21">
                    <c:v>0.50748388609170536</c:v>
                  </c:pt>
                  <c:pt idx="22">
                    <c:v>0.19911638849798674</c:v>
                  </c:pt>
                  <c:pt idx="23">
                    <c:v>0.65275347474031808</c:v>
                  </c:pt>
                  <c:pt idx="24">
                    <c:v>8.6566453744427355E-2</c:v>
                  </c:pt>
                  <c:pt idx="25">
                    <c:v>3.5298260067147792E-2</c:v>
                  </c:pt>
                  <c:pt idx="26">
                    <c:v>5.4145969254576452E-2</c:v>
                  </c:pt>
                  <c:pt idx="27">
                    <c:v>0</c:v>
                  </c:pt>
                  <c:pt idx="28">
                    <c:v>0.13725401683888785</c:v>
                  </c:pt>
                  <c:pt idx="29">
                    <c:v>0</c:v>
                  </c:pt>
                  <c:pt idx="3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2 EPA (EPA line)'!$B$4:$B$34</c:f>
              <c:strCache>
                <c:ptCount val="31"/>
                <c:pt idx="0">
                  <c:v>54:7(20:5)</c:v>
                </c:pt>
                <c:pt idx="1">
                  <c:v>54:8(20:5)</c:v>
                </c:pt>
                <c:pt idx="2">
                  <c:v>56:6(20:5)</c:v>
                </c:pt>
                <c:pt idx="3">
                  <c:v>56:7(20:5)</c:v>
                </c:pt>
                <c:pt idx="4">
                  <c:v>56:8(20:5)</c:v>
                </c:pt>
                <c:pt idx="5">
                  <c:v>56:9(20:5)</c:v>
                </c:pt>
                <c:pt idx="6">
                  <c:v>56:10(20:5)</c:v>
                </c:pt>
                <c:pt idx="7">
                  <c:v>56:11(20:5)</c:v>
                </c:pt>
                <c:pt idx="8">
                  <c:v>58:6(20:5)</c:v>
                </c:pt>
                <c:pt idx="9">
                  <c:v>58:7(20:5)</c:v>
                </c:pt>
                <c:pt idx="10">
                  <c:v>58:8(20:5)</c:v>
                </c:pt>
                <c:pt idx="11">
                  <c:v>58:9(20:5)</c:v>
                </c:pt>
                <c:pt idx="12">
                  <c:v>58:10(20:5)</c:v>
                </c:pt>
                <c:pt idx="13">
                  <c:v>58:11(20:5)</c:v>
                </c:pt>
                <c:pt idx="14">
                  <c:v>58:12(20:5)</c:v>
                </c:pt>
                <c:pt idx="15">
                  <c:v>58:13(20:5)</c:v>
                </c:pt>
                <c:pt idx="16">
                  <c:v>60:7(20:5)</c:v>
                </c:pt>
                <c:pt idx="17">
                  <c:v>60:8(20:5)</c:v>
                </c:pt>
                <c:pt idx="18">
                  <c:v>60:9(20:5)</c:v>
                </c:pt>
                <c:pt idx="19">
                  <c:v>60:10(20:5)</c:v>
                </c:pt>
                <c:pt idx="20">
                  <c:v>60:11(20:5)</c:v>
                </c:pt>
                <c:pt idx="21">
                  <c:v>60:12(20:5)</c:v>
                </c:pt>
                <c:pt idx="22">
                  <c:v>60:13(20:5)</c:v>
                </c:pt>
                <c:pt idx="23">
                  <c:v>60:14(20:5)</c:v>
                </c:pt>
                <c:pt idx="24">
                  <c:v>60:15(20:5)</c:v>
                </c:pt>
                <c:pt idx="25">
                  <c:v>62:12(20:5)</c:v>
                </c:pt>
                <c:pt idx="26">
                  <c:v>62:13(20:5)</c:v>
                </c:pt>
                <c:pt idx="27">
                  <c:v>62:14(20:5)</c:v>
                </c:pt>
                <c:pt idx="28">
                  <c:v>62:15(20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2 EPA (EPA line)'!$D$4:$D$34</c:f>
              <c:numCache>
                <c:formatCode>General</c:formatCode>
                <c:ptCount val="31"/>
                <c:pt idx="0">
                  <c:v>6.460481692179985</c:v>
                </c:pt>
                <c:pt idx="1">
                  <c:v>4.7015119904711744</c:v>
                </c:pt>
                <c:pt idx="2">
                  <c:v>3.8607174937215323</c:v>
                </c:pt>
                <c:pt idx="3">
                  <c:v>2.9208208348518525</c:v>
                </c:pt>
                <c:pt idx="4">
                  <c:v>3.1074471888894268</c:v>
                </c:pt>
                <c:pt idx="5">
                  <c:v>2.8824367921696563</c:v>
                </c:pt>
                <c:pt idx="6">
                  <c:v>1.5773380432313913</c:v>
                </c:pt>
                <c:pt idx="7">
                  <c:v>2.3438068300049619</c:v>
                </c:pt>
                <c:pt idx="8">
                  <c:v>1.8106495474332795</c:v>
                </c:pt>
                <c:pt idx="9">
                  <c:v>8.2868452983051135</c:v>
                </c:pt>
                <c:pt idx="10">
                  <c:v>8.7605801486915489</c:v>
                </c:pt>
                <c:pt idx="11">
                  <c:v>9.9277294813707204</c:v>
                </c:pt>
                <c:pt idx="12">
                  <c:v>8.0833624643557034</c:v>
                </c:pt>
                <c:pt idx="13">
                  <c:v>8.5607739919478334</c:v>
                </c:pt>
                <c:pt idx="14">
                  <c:v>4.1230214286679541</c:v>
                </c:pt>
                <c:pt idx="15">
                  <c:v>2.0841325561353079</c:v>
                </c:pt>
                <c:pt idx="16">
                  <c:v>0.72958304564746967</c:v>
                </c:pt>
                <c:pt idx="17">
                  <c:v>1.3112636945623883</c:v>
                </c:pt>
                <c:pt idx="18">
                  <c:v>0.66613608701702942</c:v>
                </c:pt>
                <c:pt idx="19">
                  <c:v>1.4498309551461874</c:v>
                </c:pt>
                <c:pt idx="20">
                  <c:v>1.0285904196908153</c:v>
                </c:pt>
                <c:pt idx="21">
                  <c:v>2.0614028885262541</c:v>
                </c:pt>
                <c:pt idx="22">
                  <c:v>1.3524940311846068</c:v>
                </c:pt>
                <c:pt idx="23">
                  <c:v>1.2618376427333735</c:v>
                </c:pt>
                <c:pt idx="24">
                  <c:v>1.0888735823498739</c:v>
                </c:pt>
                <c:pt idx="25">
                  <c:v>6.8555915714492197E-2</c:v>
                </c:pt>
                <c:pt idx="26">
                  <c:v>0.10411471873001048</c:v>
                </c:pt>
                <c:pt idx="27">
                  <c:v>0</c:v>
                </c:pt>
                <c:pt idx="28">
                  <c:v>0.2246496888174313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A8-4F33-8ABE-961B3F5A90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2609136"/>
        <c:axId val="802606184"/>
      </c:barChart>
      <c:catAx>
        <c:axId val="80260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2606184"/>
        <c:crosses val="autoZero"/>
        <c:auto val="1"/>
        <c:lblAlgn val="ctr"/>
        <c:lblOffset val="100"/>
        <c:noMultiLvlLbl val="0"/>
      </c:catAx>
      <c:valAx>
        <c:axId val="802606184"/>
        <c:scaling>
          <c:orientation val="minMax"/>
          <c:max val="13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nmol %</a:t>
                </a:r>
                <a:endParaRPr lang="en-GB" sz="1200"/>
              </a:p>
            </c:rich>
          </c:tx>
          <c:layout>
            <c:manualLayout>
              <c:xMode val="edge"/>
              <c:yMode val="edge"/>
              <c:x val="2.7565957757222169E-2"/>
              <c:y val="0.286906490109400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260913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2355822322994159"/>
          <c:y val="0.21353892787577883"/>
          <c:w val="0.30016267249660161"/>
          <c:h val="0.145460637789383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rgbClr val="BB5611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rgbClr val="BB5611"/>
                </a:solidFill>
              </a:rPr>
              <a:t>TAG containing EPA (20:5)</a:t>
            </a:r>
            <a:endParaRPr lang="en-GB" sz="1400" dirty="0">
              <a:solidFill>
                <a:srgbClr val="BB5611"/>
              </a:solidFill>
            </a:endParaRPr>
          </a:p>
        </c:rich>
      </c:tx>
      <c:layout>
        <c:manualLayout>
          <c:xMode val="edge"/>
          <c:yMode val="edge"/>
          <c:x val="0.48902314200821728"/>
          <c:y val="5.5111960838673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rgbClr val="BB561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8813092184433692E-2"/>
          <c:y val="5.4768883056284641E-2"/>
          <c:w val="0.88989210191149803"/>
          <c:h val="0.65449772346353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9-1 EPA (DHAline)'!$C$4</c:f>
              <c:strCache>
                <c:ptCount val="1"/>
                <c:pt idx="0">
                  <c:v>DHA2015.1</c:v>
                </c:pt>
              </c:strCache>
            </c:strRef>
          </c:tx>
          <c:spPr>
            <a:solidFill>
              <a:srgbClr val="18377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1 EPA (DHAline)'!$F$5:$F$35</c:f>
                <c:numCache>
                  <c:formatCode>General</c:formatCode>
                  <c:ptCount val="31"/>
                  <c:pt idx="0">
                    <c:v>2.5104584007852533</c:v>
                  </c:pt>
                  <c:pt idx="1">
                    <c:v>0.39097715079543627</c:v>
                  </c:pt>
                  <c:pt idx="2">
                    <c:v>0.7002227885348612</c:v>
                  </c:pt>
                  <c:pt idx="3">
                    <c:v>2.2587827514652985</c:v>
                  </c:pt>
                  <c:pt idx="4">
                    <c:v>1.708987320659725</c:v>
                  </c:pt>
                  <c:pt idx="5">
                    <c:v>2.8116079564182619</c:v>
                  </c:pt>
                  <c:pt idx="6">
                    <c:v>2.8444683610582975</c:v>
                  </c:pt>
                  <c:pt idx="7">
                    <c:v>2.1847880161588638</c:v>
                  </c:pt>
                  <c:pt idx="8">
                    <c:v>0.4855016453062333</c:v>
                  </c:pt>
                  <c:pt idx="9">
                    <c:v>2.4857541914609103</c:v>
                  </c:pt>
                  <c:pt idx="10">
                    <c:v>0.63138439675760427</c:v>
                  </c:pt>
                  <c:pt idx="11">
                    <c:v>1.0897759052843354</c:v>
                  </c:pt>
                  <c:pt idx="12">
                    <c:v>0.18958158458486152</c:v>
                  </c:pt>
                  <c:pt idx="13">
                    <c:v>1.6373689103156255</c:v>
                  </c:pt>
                  <c:pt idx="14">
                    <c:v>1.2269027720280379</c:v>
                  </c:pt>
                  <c:pt idx="15">
                    <c:v>0.13616569590732266</c:v>
                  </c:pt>
                  <c:pt idx="16">
                    <c:v>0.39666316186638528</c:v>
                  </c:pt>
                  <c:pt idx="17">
                    <c:v>0.39687994419103872</c:v>
                  </c:pt>
                  <c:pt idx="18">
                    <c:v>5.7329968459585837E-2</c:v>
                  </c:pt>
                  <c:pt idx="19">
                    <c:v>0.56549445836153311</c:v>
                  </c:pt>
                  <c:pt idx="20">
                    <c:v>1.9778962595036684</c:v>
                  </c:pt>
                  <c:pt idx="21">
                    <c:v>1.8397424829489375</c:v>
                  </c:pt>
                  <c:pt idx="22">
                    <c:v>1.0417441458582615</c:v>
                  </c:pt>
                  <c:pt idx="23">
                    <c:v>0.80337947023990908</c:v>
                  </c:pt>
                  <c:pt idx="24">
                    <c:v>0.10128556935070353</c:v>
                  </c:pt>
                  <c:pt idx="25">
                    <c:v>0.21848606659115294</c:v>
                  </c:pt>
                  <c:pt idx="26">
                    <c:v>0.25068837951939738</c:v>
                  </c:pt>
                  <c:pt idx="27">
                    <c:v>0.36412650051464429</c:v>
                  </c:pt>
                  <c:pt idx="28">
                    <c:v>0.27628214583834571</c:v>
                  </c:pt>
                  <c:pt idx="29">
                    <c:v>0</c:v>
                  </c:pt>
                  <c:pt idx="30">
                    <c:v>6.78531687489803E-2</c:v>
                  </c:pt>
                </c:numCache>
              </c:numRef>
            </c:plus>
            <c:minus>
              <c:numRef>
                <c:f>'S9-1 EPA (DHAline)'!$F$5:$F$35</c:f>
                <c:numCache>
                  <c:formatCode>General</c:formatCode>
                  <c:ptCount val="31"/>
                  <c:pt idx="0">
                    <c:v>2.5104584007852533</c:v>
                  </c:pt>
                  <c:pt idx="1">
                    <c:v>0.39097715079543627</c:v>
                  </c:pt>
                  <c:pt idx="2">
                    <c:v>0.7002227885348612</c:v>
                  </c:pt>
                  <c:pt idx="3">
                    <c:v>2.2587827514652985</c:v>
                  </c:pt>
                  <c:pt idx="4">
                    <c:v>1.708987320659725</c:v>
                  </c:pt>
                  <c:pt idx="5">
                    <c:v>2.8116079564182619</c:v>
                  </c:pt>
                  <c:pt idx="6">
                    <c:v>2.8444683610582975</c:v>
                  </c:pt>
                  <c:pt idx="7">
                    <c:v>2.1847880161588638</c:v>
                  </c:pt>
                  <c:pt idx="8">
                    <c:v>0.4855016453062333</c:v>
                  </c:pt>
                  <c:pt idx="9">
                    <c:v>2.4857541914609103</c:v>
                  </c:pt>
                  <c:pt idx="10">
                    <c:v>0.63138439675760427</c:v>
                  </c:pt>
                  <c:pt idx="11">
                    <c:v>1.0897759052843354</c:v>
                  </c:pt>
                  <c:pt idx="12">
                    <c:v>0.18958158458486152</c:v>
                  </c:pt>
                  <c:pt idx="13">
                    <c:v>1.6373689103156255</c:v>
                  </c:pt>
                  <c:pt idx="14">
                    <c:v>1.2269027720280379</c:v>
                  </c:pt>
                  <c:pt idx="15">
                    <c:v>0.13616569590732266</c:v>
                  </c:pt>
                  <c:pt idx="16">
                    <c:v>0.39666316186638528</c:v>
                  </c:pt>
                  <c:pt idx="17">
                    <c:v>0.39687994419103872</c:v>
                  </c:pt>
                  <c:pt idx="18">
                    <c:v>5.7329968459585837E-2</c:v>
                  </c:pt>
                  <c:pt idx="19">
                    <c:v>0.56549445836153311</c:v>
                  </c:pt>
                  <c:pt idx="20">
                    <c:v>1.9778962595036684</c:v>
                  </c:pt>
                  <c:pt idx="21">
                    <c:v>1.8397424829489375</c:v>
                  </c:pt>
                  <c:pt idx="22">
                    <c:v>1.0417441458582615</c:v>
                  </c:pt>
                  <c:pt idx="23">
                    <c:v>0.80337947023990908</c:v>
                  </c:pt>
                  <c:pt idx="24">
                    <c:v>0.10128556935070353</c:v>
                  </c:pt>
                  <c:pt idx="25">
                    <c:v>0.21848606659115294</c:v>
                  </c:pt>
                  <c:pt idx="26">
                    <c:v>0.25068837951939738</c:v>
                  </c:pt>
                  <c:pt idx="27">
                    <c:v>0.36412650051464429</c:v>
                  </c:pt>
                  <c:pt idx="28">
                    <c:v>0.27628214583834571</c:v>
                  </c:pt>
                  <c:pt idx="29">
                    <c:v>0</c:v>
                  </c:pt>
                  <c:pt idx="30">
                    <c:v>6.785316874898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1 EPA (DHAline)'!$B$5:$B$35</c:f>
              <c:strCache>
                <c:ptCount val="31"/>
                <c:pt idx="0">
                  <c:v>54:7(20:5)</c:v>
                </c:pt>
                <c:pt idx="1">
                  <c:v>54:8(20:5)</c:v>
                </c:pt>
                <c:pt idx="2">
                  <c:v>56:6(20:5)</c:v>
                </c:pt>
                <c:pt idx="3">
                  <c:v>56:7(20:5)</c:v>
                </c:pt>
                <c:pt idx="4">
                  <c:v>56:8(20:5)</c:v>
                </c:pt>
                <c:pt idx="5">
                  <c:v>56:9(20:5)</c:v>
                </c:pt>
                <c:pt idx="6">
                  <c:v>56:10(20:5)</c:v>
                </c:pt>
                <c:pt idx="7">
                  <c:v>56:11(20:5)</c:v>
                </c:pt>
                <c:pt idx="8">
                  <c:v>58:6(20:5)</c:v>
                </c:pt>
                <c:pt idx="9">
                  <c:v>58:7(20:5)</c:v>
                </c:pt>
                <c:pt idx="10">
                  <c:v>58:8(20:5)</c:v>
                </c:pt>
                <c:pt idx="11">
                  <c:v>58:9(20:5)</c:v>
                </c:pt>
                <c:pt idx="12">
                  <c:v>58:10(20:5)</c:v>
                </c:pt>
                <c:pt idx="13">
                  <c:v>58:11(20:5)</c:v>
                </c:pt>
                <c:pt idx="14">
                  <c:v>58:12(20:5)</c:v>
                </c:pt>
                <c:pt idx="15">
                  <c:v>58:13(20:5)</c:v>
                </c:pt>
                <c:pt idx="16">
                  <c:v>60:7(20:5)</c:v>
                </c:pt>
                <c:pt idx="17">
                  <c:v>60:8(20:5)</c:v>
                </c:pt>
                <c:pt idx="18">
                  <c:v>60:9(20:5)</c:v>
                </c:pt>
                <c:pt idx="19">
                  <c:v>60:10(20:5)</c:v>
                </c:pt>
                <c:pt idx="20">
                  <c:v>60:11(20:5)</c:v>
                </c:pt>
                <c:pt idx="21">
                  <c:v>60:12(20:5)</c:v>
                </c:pt>
                <c:pt idx="22">
                  <c:v>60:13(20:5)</c:v>
                </c:pt>
                <c:pt idx="23">
                  <c:v>60:14(20:5)</c:v>
                </c:pt>
                <c:pt idx="24">
                  <c:v>60:15(20:5)</c:v>
                </c:pt>
                <c:pt idx="25">
                  <c:v>62:12(20:5)</c:v>
                </c:pt>
                <c:pt idx="26">
                  <c:v>62:13(20:5)</c:v>
                </c:pt>
                <c:pt idx="27">
                  <c:v>62:14(20:5)</c:v>
                </c:pt>
                <c:pt idx="28">
                  <c:v>62:15(20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1 EPA (DHAline)'!$C$5:$C$35</c:f>
              <c:numCache>
                <c:formatCode>General</c:formatCode>
                <c:ptCount val="31"/>
                <c:pt idx="0">
                  <c:v>7.0563337153012746</c:v>
                </c:pt>
                <c:pt idx="1">
                  <c:v>2.5323846223082613</c:v>
                </c:pt>
                <c:pt idx="2">
                  <c:v>1.3665624080187626</c:v>
                </c:pt>
                <c:pt idx="3">
                  <c:v>4.5044188692362876</c:v>
                </c:pt>
                <c:pt idx="4">
                  <c:v>4.7028234212096507</c:v>
                </c:pt>
                <c:pt idx="5">
                  <c:v>5.5865312445773361</c:v>
                </c:pt>
                <c:pt idx="6">
                  <c:v>5.0231608466191675</c:v>
                </c:pt>
                <c:pt idx="7">
                  <c:v>5.3590319739176904</c:v>
                </c:pt>
                <c:pt idx="8">
                  <c:v>0.94453995405121927</c:v>
                </c:pt>
                <c:pt idx="9">
                  <c:v>7.3344046588715726</c:v>
                </c:pt>
                <c:pt idx="10">
                  <c:v>9.1001805708676997</c:v>
                </c:pt>
                <c:pt idx="11">
                  <c:v>8.1470304106596103</c:v>
                </c:pt>
                <c:pt idx="12">
                  <c:v>3.4436878119956185</c:v>
                </c:pt>
                <c:pt idx="13">
                  <c:v>4.8231069841971603</c:v>
                </c:pt>
                <c:pt idx="14">
                  <c:v>3.3783584864898888</c:v>
                </c:pt>
                <c:pt idx="15">
                  <c:v>0.62018931126224541</c:v>
                </c:pt>
                <c:pt idx="16">
                  <c:v>2.033822091750896</c:v>
                </c:pt>
                <c:pt idx="17">
                  <c:v>0.39687994419103867</c:v>
                </c:pt>
                <c:pt idx="18">
                  <c:v>0.94461632524746852</c:v>
                </c:pt>
                <c:pt idx="19">
                  <c:v>0.565494458361533</c:v>
                </c:pt>
                <c:pt idx="20">
                  <c:v>3.6586280750180156</c:v>
                </c:pt>
                <c:pt idx="21">
                  <c:v>6.1832956472464913</c:v>
                </c:pt>
                <c:pt idx="22">
                  <c:v>6.8892460301649558</c:v>
                </c:pt>
                <c:pt idx="23">
                  <c:v>0.80337947023990897</c:v>
                </c:pt>
                <c:pt idx="24">
                  <c:v>0.10128556935070353</c:v>
                </c:pt>
                <c:pt idx="25">
                  <c:v>0.21848606659115291</c:v>
                </c:pt>
                <c:pt idx="26">
                  <c:v>0.37092906692655259</c:v>
                </c:pt>
                <c:pt idx="27">
                  <c:v>0.69664616119930101</c:v>
                </c:pt>
                <c:pt idx="28">
                  <c:v>1.0651902174226118</c:v>
                </c:pt>
                <c:pt idx="29">
                  <c:v>0</c:v>
                </c:pt>
                <c:pt idx="30">
                  <c:v>6.785316874898028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7F-4299-B4F2-94D1FE5067B4}"/>
            </c:ext>
          </c:extLst>
        </c:ser>
        <c:ser>
          <c:idx val="1"/>
          <c:order val="1"/>
          <c:tx>
            <c:strRef>
              <c:f>'S9-1 EPA (DHAline)'!$D$4</c:f>
              <c:strCache>
                <c:ptCount val="1"/>
                <c:pt idx="0">
                  <c:v>DHA2015.5</c:v>
                </c:pt>
              </c:strCache>
            </c:strRef>
          </c:tx>
          <c:spPr>
            <a:solidFill>
              <a:srgbClr val="D8DFFB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1 EPA (DHAline)'!$G$5:$G$35</c:f>
                <c:numCache>
                  <c:formatCode>General</c:formatCode>
                  <c:ptCount val="31"/>
                  <c:pt idx="0">
                    <c:v>1.7912973925447913</c:v>
                  </c:pt>
                  <c:pt idx="1">
                    <c:v>0.47146712514799372</c:v>
                  </c:pt>
                  <c:pt idx="2">
                    <c:v>0.19960608475301214</c:v>
                  </c:pt>
                  <c:pt idx="3">
                    <c:v>1.4368317413303859</c:v>
                  </c:pt>
                  <c:pt idx="4">
                    <c:v>1.6854389251917863</c:v>
                  </c:pt>
                  <c:pt idx="5">
                    <c:v>2.3754823132180873</c:v>
                  </c:pt>
                  <c:pt idx="6">
                    <c:v>4.0328504112371686</c:v>
                  </c:pt>
                  <c:pt idx="7">
                    <c:v>0.87253075145242154</c:v>
                  </c:pt>
                  <c:pt idx="8">
                    <c:v>0.34821287318403921</c:v>
                  </c:pt>
                  <c:pt idx="9">
                    <c:v>0.52611238140013306</c:v>
                  </c:pt>
                  <c:pt idx="10">
                    <c:v>2.1859470117671815</c:v>
                  </c:pt>
                  <c:pt idx="11">
                    <c:v>1.504881985423282</c:v>
                  </c:pt>
                  <c:pt idx="12">
                    <c:v>0.34857761282563854</c:v>
                  </c:pt>
                  <c:pt idx="13">
                    <c:v>0.70258733442331089</c:v>
                  </c:pt>
                  <c:pt idx="14">
                    <c:v>1.0809004276423253</c:v>
                  </c:pt>
                  <c:pt idx="15">
                    <c:v>0.21337435508185598</c:v>
                  </c:pt>
                  <c:pt idx="16">
                    <c:v>0.37585708929819134</c:v>
                  </c:pt>
                  <c:pt idx="17">
                    <c:v>0.29482781785746465</c:v>
                  </c:pt>
                  <c:pt idx="18">
                    <c:v>0.23756468304442924</c:v>
                  </c:pt>
                  <c:pt idx="19">
                    <c:v>0.64283081358877525</c:v>
                  </c:pt>
                  <c:pt idx="20">
                    <c:v>0.91545838580530847</c:v>
                  </c:pt>
                  <c:pt idx="21">
                    <c:v>0.69686638275393198</c:v>
                  </c:pt>
                  <c:pt idx="22">
                    <c:v>1.448889521986328</c:v>
                  </c:pt>
                  <c:pt idx="23">
                    <c:v>1.3809221907965841</c:v>
                  </c:pt>
                  <c:pt idx="24">
                    <c:v>0.14255443756976266</c:v>
                  </c:pt>
                  <c:pt idx="25">
                    <c:v>0.19135470269807878</c:v>
                  </c:pt>
                  <c:pt idx="26">
                    <c:v>0.12803441084132605</c:v>
                  </c:pt>
                  <c:pt idx="27">
                    <c:v>0.36294113927004867</c:v>
                  </c:pt>
                  <c:pt idx="28">
                    <c:v>4.6702087823446682E-2</c:v>
                  </c:pt>
                  <c:pt idx="29">
                    <c:v>0.2281925090376398</c:v>
                  </c:pt>
                  <c:pt idx="30">
                    <c:v>0.20687510955304467</c:v>
                  </c:pt>
                </c:numCache>
              </c:numRef>
            </c:plus>
            <c:minus>
              <c:numRef>
                <c:f>'S9-1 EPA (DHAline)'!$G$5:$G$35</c:f>
                <c:numCache>
                  <c:formatCode>General</c:formatCode>
                  <c:ptCount val="31"/>
                  <c:pt idx="0">
                    <c:v>1.7912973925447913</c:v>
                  </c:pt>
                  <c:pt idx="1">
                    <c:v>0.47146712514799372</c:v>
                  </c:pt>
                  <c:pt idx="2">
                    <c:v>0.19960608475301214</c:v>
                  </c:pt>
                  <c:pt idx="3">
                    <c:v>1.4368317413303859</c:v>
                  </c:pt>
                  <c:pt idx="4">
                    <c:v>1.6854389251917863</c:v>
                  </c:pt>
                  <c:pt idx="5">
                    <c:v>2.3754823132180873</c:v>
                  </c:pt>
                  <c:pt idx="6">
                    <c:v>4.0328504112371686</c:v>
                  </c:pt>
                  <c:pt idx="7">
                    <c:v>0.87253075145242154</c:v>
                  </c:pt>
                  <c:pt idx="8">
                    <c:v>0.34821287318403921</c:v>
                  </c:pt>
                  <c:pt idx="9">
                    <c:v>0.52611238140013306</c:v>
                  </c:pt>
                  <c:pt idx="10">
                    <c:v>2.1859470117671815</c:v>
                  </c:pt>
                  <c:pt idx="11">
                    <c:v>1.504881985423282</c:v>
                  </c:pt>
                  <c:pt idx="12">
                    <c:v>0.34857761282563854</c:v>
                  </c:pt>
                  <c:pt idx="13">
                    <c:v>0.70258733442331089</c:v>
                  </c:pt>
                  <c:pt idx="14">
                    <c:v>1.0809004276423253</c:v>
                  </c:pt>
                  <c:pt idx="15">
                    <c:v>0.21337435508185598</c:v>
                  </c:pt>
                  <c:pt idx="16">
                    <c:v>0.37585708929819134</c:v>
                  </c:pt>
                  <c:pt idx="17">
                    <c:v>0.29482781785746465</c:v>
                  </c:pt>
                  <c:pt idx="18">
                    <c:v>0.23756468304442924</c:v>
                  </c:pt>
                  <c:pt idx="19">
                    <c:v>0.64283081358877525</c:v>
                  </c:pt>
                  <c:pt idx="20">
                    <c:v>0.91545838580530847</c:v>
                  </c:pt>
                  <c:pt idx="21">
                    <c:v>0.69686638275393198</c:v>
                  </c:pt>
                  <c:pt idx="22">
                    <c:v>1.448889521986328</c:v>
                  </c:pt>
                  <c:pt idx="23">
                    <c:v>1.3809221907965841</c:v>
                  </c:pt>
                  <c:pt idx="24">
                    <c:v>0.14255443756976266</c:v>
                  </c:pt>
                  <c:pt idx="25">
                    <c:v>0.19135470269807878</c:v>
                  </c:pt>
                  <c:pt idx="26">
                    <c:v>0.12803441084132605</c:v>
                  </c:pt>
                  <c:pt idx="27">
                    <c:v>0.36294113927004867</c:v>
                  </c:pt>
                  <c:pt idx="28">
                    <c:v>4.6702087823446682E-2</c:v>
                  </c:pt>
                  <c:pt idx="29">
                    <c:v>0.2281925090376398</c:v>
                  </c:pt>
                  <c:pt idx="30">
                    <c:v>0.206875109553044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1 EPA (DHAline)'!$B$5:$B$35</c:f>
              <c:strCache>
                <c:ptCount val="31"/>
                <c:pt idx="0">
                  <c:v>54:7(20:5)</c:v>
                </c:pt>
                <c:pt idx="1">
                  <c:v>54:8(20:5)</c:v>
                </c:pt>
                <c:pt idx="2">
                  <c:v>56:6(20:5)</c:v>
                </c:pt>
                <c:pt idx="3">
                  <c:v>56:7(20:5)</c:v>
                </c:pt>
                <c:pt idx="4">
                  <c:v>56:8(20:5)</c:v>
                </c:pt>
                <c:pt idx="5">
                  <c:v>56:9(20:5)</c:v>
                </c:pt>
                <c:pt idx="6">
                  <c:v>56:10(20:5)</c:v>
                </c:pt>
                <c:pt idx="7">
                  <c:v>56:11(20:5)</c:v>
                </c:pt>
                <c:pt idx="8">
                  <c:v>58:6(20:5)</c:v>
                </c:pt>
                <c:pt idx="9">
                  <c:v>58:7(20:5)</c:v>
                </c:pt>
                <c:pt idx="10">
                  <c:v>58:8(20:5)</c:v>
                </c:pt>
                <c:pt idx="11">
                  <c:v>58:9(20:5)</c:v>
                </c:pt>
                <c:pt idx="12">
                  <c:v>58:10(20:5)</c:v>
                </c:pt>
                <c:pt idx="13">
                  <c:v>58:11(20:5)</c:v>
                </c:pt>
                <c:pt idx="14">
                  <c:v>58:12(20:5)</c:v>
                </c:pt>
                <c:pt idx="15">
                  <c:v>58:13(20:5)</c:v>
                </c:pt>
                <c:pt idx="16">
                  <c:v>60:7(20:5)</c:v>
                </c:pt>
                <c:pt idx="17">
                  <c:v>60:8(20:5)</c:v>
                </c:pt>
                <c:pt idx="18">
                  <c:v>60:9(20:5)</c:v>
                </c:pt>
                <c:pt idx="19">
                  <c:v>60:10(20:5)</c:v>
                </c:pt>
                <c:pt idx="20">
                  <c:v>60:11(20:5)</c:v>
                </c:pt>
                <c:pt idx="21">
                  <c:v>60:12(20:5)</c:v>
                </c:pt>
                <c:pt idx="22">
                  <c:v>60:13(20:5)</c:v>
                </c:pt>
                <c:pt idx="23">
                  <c:v>60:14(20:5)</c:v>
                </c:pt>
                <c:pt idx="24">
                  <c:v>60:15(20:5)</c:v>
                </c:pt>
                <c:pt idx="25">
                  <c:v>62:12(20:5)</c:v>
                </c:pt>
                <c:pt idx="26">
                  <c:v>62:13(20:5)</c:v>
                </c:pt>
                <c:pt idx="27">
                  <c:v>62:14(20:5)</c:v>
                </c:pt>
                <c:pt idx="28">
                  <c:v>62:15(20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1 EPA (DHAline)'!$D$5:$D$35</c:f>
              <c:numCache>
                <c:formatCode>General</c:formatCode>
                <c:ptCount val="31"/>
                <c:pt idx="0">
                  <c:v>6.278791618038813</c:v>
                </c:pt>
                <c:pt idx="1">
                  <c:v>4.7651041636655735</c:v>
                </c:pt>
                <c:pt idx="2">
                  <c:v>2.0762923305628447</c:v>
                </c:pt>
                <c:pt idx="3">
                  <c:v>2.8593023093936374</c:v>
                </c:pt>
                <c:pt idx="4">
                  <c:v>3.34232096524214</c:v>
                </c:pt>
                <c:pt idx="5">
                  <c:v>4.6639716847366417</c:v>
                </c:pt>
                <c:pt idx="6">
                  <c:v>6.7887112480711354</c:v>
                </c:pt>
                <c:pt idx="7">
                  <c:v>5.5639332341384486</c:v>
                </c:pt>
                <c:pt idx="8">
                  <c:v>0.66532611702620592</c:v>
                </c:pt>
                <c:pt idx="9">
                  <c:v>4.0997531987852307</c:v>
                </c:pt>
                <c:pt idx="10">
                  <c:v>9.8616527859261449</c:v>
                </c:pt>
                <c:pt idx="11">
                  <c:v>8.2154125976950692</c:v>
                </c:pt>
                <c:pt idx="12">
                  <c:v>4.7419647838734589</c:v>
                </c:pt>
                <c:pt idx="13">
                  <c:v>4.3706003978864878</c:v>
                </c:pt>
                <c:pt idx="14">
                  <c:v>4.026982554236068</c:v>
                </c:pt>
                <c:pt idx="15">
                  <c:v>0.74406276089436607</c:v>
                </c:pt>
                <c:pt idx="16">
                  <c:v>0.91712219168137155</c:v>
                </c:pt>
                <c:pt idx="17">
                  <c:v>1.4849438621943758</c:v>
                </c:pt>
                <c:pt idx="18">
                  <c:v>0.79166147995608693</c:v>
                </c:pt>
                <c:pt idx="19">
                  <c:v>0.64283081358877514</c:v>
                </c:pt>
                <c:pt idx="20">
                  <c:v>2.7297978610624951</c:v>
                </c:pt>
                <c:pt idx="21">
                  <c:v>5.588788393881682</c:v>
                </c:pt>
                <c:pt idx="22">
                  <c:v>6.4080872061169813</c:v>
                </c:pt>
                <c:pt idx="23">
                  <c:v>1.4523918674692202</c:v>
                </c:pt>
                <c:pt idx="24">
                  <c:v>0.28094763133797745</c:v>
                </c:pt>
                <c:pt idx="25">
                  <c:v>0.19135470269807875</c:v>
                </c:pt>
                <c:pt idx="26">
                  <c:v>0.34723024250825157</c:v>
                </c:pt>
                <c:pt idx="27">
                  <c:v>0.62074738732103685</c:v>
                </c:pt>
                <c:pt idx="28">
                  <c:v>0.95639954684998063</c:v>
                </c:pt>
                <c:pt idx="29">
                  <c:v>0.2281925090376398</c:v>
                </c:pt>
                <c:pt idx="30">
                  <c:v>0.33358306797830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7F-4299-B4F2-94D1FE5067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6161728"/>
        <c:axId val="336164352"/>
      </c:barChart>
      <c:catAx>
        <c:axId val="336161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164352"/>
        <c:crosses val="autoZero"/>
        <c:auto val="1"/>
        <c:lblAlgn val="ctr"/>
        <c:lblOffset val="100"/>
        <c:noMultiLvlLbl val="0"/>
      </c:catAx>
      <c:valAx>
        <c:axId val="336164352"/>
        <c:scaling>
          <c:orientation val="minMax"/>
          <c:max val="13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solidFill>
                      <a:schemeClr val="tx1"/>
                    </a:solidFill>
                  </a:rPr>
                  <a:t>nmol %</a:t>
                </a:r>
                <a:endParaRPr lang="en-GB" sz="120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4.9364007469750231E-3"/>
              <c:y val="0.310022486883860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161728"/>
        <c:crosses val="autoZero"/>
        <c:crossBetween val="between"/>
        <c:majorUnit val="2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3388202212591995"/>
          <c:y val="0.14213557699759433"/>
          <c:w val="0.39490595203092954"/>
          <c:h val="0.175578419725113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rgbClr val="008000"/>
                </a:solidFill>
              </a:rPr>
              <a:t>TAG containing DPA (22:5)</a:t>
            </a:r>
            <a:endParaRPr lang="en-GB" sz="1400" dirty="0">
              <a:solidFill>
                <a:srgbClr val="008000"/>
              </a:solidFill>
            </a:endParaRPr>
          </a:p>
        </c:rich>
      </c:tx>
      <c:layout>
        <c:manualLayout>
          <c:xMode val="edge"/>
          <c:yMode val="edge"/>
          <c:x val="0.51082919113087155"/>
          <c:y val="9.29987121543817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77082718979698"/>
          <c:y val="8.2187591134441518E-2"/>
          <c:w val="0.85344411142351762"/>
          <c:h val="0.57413536691781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9-3 DPA'!$C$4</c:f>
              <c:strCache>
                <c:ptCount val="1"/>
                <c:pt idx="0">
                  <c:v>DHA2015.1</c:v>
                </c:pt>
              </c:strCache>
            </c:strRef>
          </c:tx>
          <c:spPr>
            <a:solidFill>
              <a:srgbClr val="18377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3 DPA'!$F$5:$F$35</c:f>
                <c:numCache>
                  <c:formatCode>General</c:formatCode>
                  <c:ptCount val="31"/>
                  <c:pt idx="0">
                    <c:v>0</c:v>
                  </c:pt>
                  <c:pt idx="1">
                    <c:v>0.38804284999662636</c:v>
                  </c:pt>
                  <c:pt idx="2">
                    <c:v>1.8466565136446895</c:v>
                  </c:pt>
                  <c:pt idx="3">
                    <c:v>0.55667720662886067</c:v>
                  </c:pt>
                  <c:pt idx="4">
                    <c:v>0.13911578992338558</c:v>
                  </c:pt>
                  <c:pt idx="5">
                    <c:v>1.4981077019957085</c:v>
                  </c:pt>
                  <c:pt idx="6">
                    <c:v>0.75792530443256323</c:v>
                  </c:pt>
                  <c:pt idx="7">
                    <c:v>5.3426152583328301</c:v>
                  </c:pt>
                  <c:pt idx="8">
                    <c:v>1.735567545242829</c:v>
                  </c:pt>
                  <c:pt idx="9">
                    <c:v>3.9648980712337605</c:v>
                  </c:pt>
                  <c:pt idx="10">
                    <c:v>0</c:v>
                  </c:pt>
                  <c:pt idx="11">
                    <c:v>0.10074130936381955</c:v>
                  </c:pt>
                  <c:pt idx="12">
                    <c:v>0.39516507806622053</c:v>
                  </c:pt>
                  <c:pt idx="13">
                    <c:v>0.51693391432163238</c:v>
                  </c:pt>
                  <c:pt idx="14">
                    <c:v>0.5541435349497924</c:v>
                  </c:pt>
                  <c:pt idx="15">
                    <c:v>1.4608394823262585</c:v>
                  </c:pt>
                  <c:pt idx="16">
                    <c:v>0.44070780325656267</c:v>
                  </c:pt>
                  <c:pt idx="17">
                    <c:v>1.9516984814732612</c:v>
                  </c:pt>
                  <c:pt idx="18">
                    <c:v>0.24252668670530766</c:v>
                  </c:pt>
                  <c:pt idx="19">
                    <c:v>0.18957468711756045</c:v>
                  </c:pt>
                  <c:pt idx="20">
                    <c:v>0.18647503595889356</c:v>
                  </c:pt>
                  <c:pt idx="21">
                    <c:v>0.63894311783388502</c:v>
                  </c:pt>
                  <c:pt idx="22">
                    <c:v>0.63259932988025758</c:v>
                  </c:pt>
                  <c:pt idx="23">
                    <c:v>0.78733386533019967</c:v>
                  </c:pt>
                  <c:pt idx="24">
                    <c:v>1.1475242349411969</c:v>
                  </c:pt>
                  <c:pt idx="25">
                    <c:v>7.3200919108208098E-2</c:v>
                  </c:pt>
                  <c:pt idx="26">
                    <c:v>0.10601900927531857</c:v>
                  </c:pt>
                  <c:pt idx="27">
                    <c:v>0.48786166631999794</c:v>
                  </c:pt>
                  <c:pt idx="28">
                    <c:v>0.19106675742718582</c:v>
                  </c:pt>
                  <c:pt idx="29">
                    <c:v>0</c:v>
                  </c:pt>
                  <c:pt idx="30">
                    <c:v>6.78531687489803E-2</c:v>
                  </c:pt>
                </c:numCache>
              </c:numRef>
            </c:plus>
            <c:minus>
              <c:numRef>
                <c:f>'S9-3 DPA'!$F$5:$F$35</c:f>
                <c:numCache>
                  <c:formatCode>General</c:formatCode>
                  <c:ptCount val="31"/>
                  <c:pt idx="0">
                    <c:v>0</c:v>
                  </c:pt>
                  <c:pt idx="1">
                    <c:v>0.38804284999662636</c:v>
                  </c:pt>
                  <c:pt idx="2">
                    <c:v>1.8466565136446895</c:v>
                  </c:pt>
                  <c:pt idx="3">
                    <c:v>0.55667720662886067</c:v>
                  </c:pt>
                  <c:pt idx="4">
                    <c:v>0.13911578992338558</c:v>
                  </c:pt>
                  <c:pt idx="5">
                    <c:v>1.4981077019957085</c:v>
                  </c:pt>
                  <c:pt idx="6">
                    <c:v>0.75792530443256323</c:v>
                  </c:pt>
                  <c:pt idx="7">
                    <c:v>5.3426152583328301</c:v>
                  </c:pt>
                  <c:pt idx="8">
                    <c:v>1.735567545242829</c:v>
                  </c:pt>
                  <c:pt idx="9">
                    <c:v>3.9648980712337605</c:v>
                  </c:pt>
                  <c:pt idx="10">
                    <c:v>0</c:v>
                  </c:pt>
                  <c:pt idx="11">
                    <c:v>0.10074130936381955</c:v>
                  </c:pt>
                  <c:pt idx="12">
                    <c:v>0.39516507806622053</c:v>
                  </c:pt>
                  <c:pt idx="13">
                    <c:v>0.51693391432163238</c:v>
                  </c:pt>
                  <c:pt idx="14">
                    <c:v>0.5541435349497924</c:v>
                  </c:pt>
                  <c:pt idx="15">
                    <c:v>1.4608394823262585</c:v>
                  </c:pt>
                  <c:pt idx="16">
                    <c:v>0.44070780325656267</c:v>
                  </c:pt>
                  <c:pt idx="17">
                    <c:v>1.9516984814732612</c:v>
                  </c:pt>
                  <c:pt idx="18">
                    <c:v>0.24252668670530766</c:v>
                  </c:pt>
                  <c:pt idx="19">
                    <c:v>0.18957468711756045</c:v>
                  </c:pt>
                  <c:pt idx="20">
                    <c:v>0.18647503595889356</c:v>
                  </c:pt>
                  <c:pt idx="21">
                    <c:v>0.63894311783388502</c:v>
                  </c:pt>
                  <c:pt idx="22">
                    <c:v>0.63259932988025758</c:v>
                  </c:pt>
                  <c:pt idx="23">
                    <c:v>0.78733386533019967</c:v>
                  </c:pt>
                  <c:pt idx="24">
                    <c:v>1.1475242349411969</c:v>
                  </c:pt>
                  <c:pt idx="25">
                    <c:v>7.3200919108208098E-2</c:v>
                  </c:pt>
                  <c:pt idx="26">
                    <c:v>0.10601900927531857</c:v>
                  </c:pt>
                  <c:pt idx="27">
                    <c:v>0.48786166631999794</c:v>
                  </c:pt>
                  <c:pt idx="28">
                    <c:v>0.19106675742718582</c:v>
                  </c:pt>
                  <c:pt idx="29">
                    <c:v>0</c:v>
                  </c:pt>
                  <c:pt idx="30">
                    <c:v>6.785316874898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3 DPA'!$B$5:$B$35</c:f>
              <c:strCache>
                <c:ptCount val="31"/>
                <c:pt idx="0">
                  <c:v> 52:6(22:5)</c:v>
                </c:pt>
                <c:pt idx="1">
                  <c:v> 56:6(22:5)</c:v>
                </c:pt>
                <c:pt idx="2">
                  <c:v> 56:7(22:5)</c:v>
                </c:pt>
                <c:pt idx="3">
                  <c:v> 56:8(22:5)</c:v>
                </c:pt>
                <c:pt idx="4">
                  <c:v> 56:9(22:5)</c:v>
                </c:pt>
                <c:pt idx="5">
                  <c:v> 58:7(22:5)</c:v>
                </c:pt>
                <c:pt idx="6">
                  <c:v> 58:8(22:5)</c:v>
                </c:pt>
                <c:pt idx="7">
                  <c:v> 58:9(22:5)</c:v>
                </c:pt>
                <c:pt idx="8">
                  <c:v> 58:10(22:5)</c:v>
                </c:pt>
                <c:pt idx="9">
                  <c:v> 58:11(22:5)</c:v>
                </c:pt>
                <c:pt idx="10">
                  <c:v> 58:12(22:5)</c:v>
                </c:pt>
                <c:pt idx="11">
                  <c:v> 60:5(22:5)</c:v>
                </c:pt>
                <c:pt idx="12">
                  <c:v> 60:7(22:5)</c:v>
                </c:pt>
                <c:pt idx="13">
                  <c:v> 60:8(22:5)</c:v>
                </c:pt>
                <c:pt idx="14">
                  <c:v> 60:9(22:5)</c:v>
                </c:pt>
                <c:pt idx="15">
                  <c:v> 60:10(22:5)</c:v>
                </c:pt>
                <c:pt idx="16">
                  <c:v> 60:11(22:5)</c:v>
                </c:pt>
                <c:pt idx="17">
                  <c:v> 60:12(22:5)</c:v>
                </c:pt>
                <c:pt idx="18">
                  <c:v> 60:14(22:5)</c:v>
                </c:pt>
                <c:pt idx="19">
                  <c:v> 62:6(22:5)</c:v>
                </c:pt>
                <c:pt idx="20">
                  <c:v> 62:10(22:5)</c:v>
                </c:pt>
                <c:pt idx="21">
                  <c:v> 62:11(22:5)</c:v>
                </c:pt>
                <c:pt idx="22">
                  <c:v> 62:12(22:5)</c:v>
                </c:pt>
                <c:pt idx="23">
                  <c:v> 62:13(22:5)</c:v>
                </c:pt>
                <c:pt idx="24">
                  <c:v> 62:14(22:5)</c:v>
                </c:pt>
                <c:pt idx="25">
                  <c:v> 62:15(22:5)</c:v>
                </c:pt>
                <c:pt idx="26">
                  <c:v> 64:13(22:5)</c:v>
                </c:pt>
                <c:pt idx="27">
                  <c:v> 64:15(22:5)</c:v>
                </c:pt>
                <c:pt idx="28">
                  <c:v> 66:17(22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3 DPA'!$C$5:$C$35</c:f>
              <c:numCache>
                <c:formatCode>General</c:formatCode>
                <c:ptCount val="31"/>
                <c:pt idx="0">
                  <c:v>0</c:v>
                </c:pt>
                <c:pt idx="1">
                  <c:v>0.38804284999662636</c:v>
                </c:pt>
                <c:pt idx="2">
                  <c:v>5.485357594492374</c:v>
                </c:pt>
                <c:pt idx="3">
                  <c:v>4.4618757498427444</c:v>
                </c:pt>
                <c:pt idx="4">
                  <c:v>0.23906327078223799</c:v>
                </c:pt>
                <c:pt idx="5">
                  <c:v>7.4201312912844761</c:v>
                </c:pt>
                <c:pt idx="6">
                  <c:v>8.2058711398482558</c:v>
                </c:pt>
                <c:pt idx="7">
                  <c:v>18.09271571304232</c:v>
                </c:pt>
                <c:pt idx="8">
                  <c:v>18.303487633963158</c:v>
                </c:pt>
                <c:pt idx="9">
                  <c:v>7.4107998928616539</c:v>
                </c:pt>
                <c:pt idx="10">
                  <c:v>0</c:v>
                </c:pt>
                <c:pt idx="11">
                  <c:v>0.20070537944116396</c:v>
                </c:pt>
                <c:pt idx="12">
                  <c:v>0.77423964771000386</c:v>
                </c:pt>
                <c:pt idx="13">
                  <c:v>4.0017358490023911</c:v>
                </c:pt>
                <c:pt idx="14">
                  <c:v>3.9937990625550821</c:v>
                </c:pt>
                <c:pt idx="15">
                  <c:v>1.4608394823262583</c:v>
                </c:pt>
                <c:pt idx="16">
                  <c:v>7.0680458553332057</c:v>
                </c:pt>
                <c:pt idx="17">
                  <c:v>1.951698481473261</c:v>
                </c:pt>
                <c:pt idx="18">
                  <c:v>0.24252668670530764</c:v>
                </c:pt>
                <c:pt idx="19">
                  <c:v>0.33908144801536028</c:v>
                </c:pt>
                <c:pt idx="20">
                  <c:v>0.18647503595889359</c:v>
                </c:pt>
                <c:pt idx="21">
                  <c:v>1.169875794376531</c:v>
                </c:pt>
                <c:pt idx="22">
                  <c:v>1.5410752354324533</c:v>
                </c:pt>
                <c:pt idx="23">
                  <c:v>3.3993272406263642</c:v>
                </c:pt>
                <c:pt idx="24">
                  <c:v>2.2554422512978602</c:v>
                </c:pt>
                <c:pt idx="25">
                  <c:v>7.3200919108208085E-2</c:v>
                </c:pt>
                <c:pt idx="26">
                  <c:v>0.18129695763918871</c:v>
                </c:pt>
                <c:pt idx="27">
                  <c:v>0.48786166631999789</c:v>
                </c:pt>
                <c:pt idx="28">
                  <c:v>0.19106675742718582</c:v>
                </c:pt>
                <c:pt idx="29">
                  <c:v>0</c:v>
                </c:pt>
                <c:pt idx="30">
                  <c:v>6.785316874898028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4A-4AE3-B0E1-6EF4323B7795}"/>
            </c:ext>
          </c:extLst>
        </c:ser>
        <c:ser>
          <c:idx val="1"/>
          <c:order val="1"/>
          <c:tx>
            <c:strRef>
              <c:f>'S9-3 DPA'!$D$4</c:f>
              <c:strCache>
                <c:ptCount val="1"/>
                <c:pt idx="0">
                  <c:v>DHA2015.5</c:v>
                </c:pt>
              </c:strCache>
            </c:strRef>
          </c:tx>
          <c:spPr>
            <a:solidFill>
              <a:srgbClr val="D8DFFB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3 DPA'!$G$5:$G$35</c:f>
                <c:numCache>
                  <c:formatCode>General</c:formatCode>
                  <c:ptCount val="31"/>
                  <c:pt idx="0">
                    <c:v>8.8010422123445564E-2</c:v>
                  </c:pt>
                  <c:pt idx="1">
                    <c:v>0.29771686068991743</c:v>
                  </c:pt>
                  <c:pt idx="2">
                    <c:v>1.1005391598903351</c:v>
                  </c:pt>
                  <c:pt idx="3">
                    <c:v>3.1183730956396642E-2</c:v>
                  </c:pt>
                  <c:pt idx="4">
                    <c:v>0.18415565095435124</c:v>
                  </c:pt>
                  <c:pt idx="5">
                    <c:v>0.24998870794400466</c:v>
                  </c:pt>
                  <c:pt idx="6">
                    <c:v>0.47814542402360372</c:v>
                  </c:pt>
                  <c:pt idx="7">
                    <c:v>1.985288108895944</c:v>
                  </c:pt>
                  <c:pt idx="8">
                    <c:v>2.8563506372568304</c:v>
                  </c:pt>
                  <c:pt idx="9">
                    <c:v>5.1378161792908559</c:v>
                  </c:pt>
                  <c:pt idx="10">
                    <c:v>0.41583967320722492</c:v>
                  </c:pt>
                  <c:pt idx="11">
                    <c:v>9.3065256658957818E-2</c:v>
                  </c:pt>
                  <c:pt idx="12">
                    <c:v>0.2592303305024386</c:v>
                  </c:pt>
                  <c:pt idx="13">
                    <c:v>0.37695761694508517</c:v>
                  </c:pt>
                  <c:pt idx="14">
                    <c:v>0.78354610838218564</c:v>
                  </c:pt>
                  <c:pt idx="15">
                    <c:v>1.9001901671565047</c:v>
                  </c:pt>
                  <c:pt idx="16">
                    <c:v>0.8355157832259108</c:v>
                  </c:pt>
                  <c:pt idx="17">
                    <c:v>1.9726036077462605</c:v>
                  </c:pt>
                  <c:pt idx="18">
                    <c:v>0.13363859270207826</c:v>
                  </c:pt>
                  <c:pt idx="19">
                    <c:v>0.21707607826688968</c:v>
                  </c:pt>
                  <c:pt idx="20">
                    <c:v>0.14564549599142829</c:v>
                  </c:pt>
                  <c:pt idx="21">
                    <c:v>0.64773036684862817</c:v>
                  </c:pt>
                  <c:pt idx="22">
                    <c:v>7.9866275436835443E-2</c:v>
                  </c:pt>
                  <c:pt idx="23">
                    <c:v>0.43519058372024538</c:v>
                  </c:pt>
                  <c:pt idx="24">
                    <c:v>1.2448432296397498</c:v>
                  </c:pt>
                  <c:pt idx="25">
                    <c:v>0.10570129832379835</c:v>
                  </c:pt>
                  <c:pt idx="26">
                    <c:v>9.0329746257320626E-2</c:v>
                  </c:pt>
                  <c:pt idx="27">
                    <c:v>0.27048095738152445</c:v>
                  </c:pt>
                  <c:pt idx="28">
                    <c:v>0.29578156729081445</c:v>
                  </c:pt>
                  <c:pt idx="29">
                    <c:v>0.2281925090376398</c:v>
                  </c:pt>
                  <c:pt idx="30">
                    <c:v>0.20687510955304467</c:v>
                  </c:pt>
                </c:numCache>
              </c:numRef>
            </c:plus>
            <c:minus>
              <c:numRef>
                <c:f>'S9-3 DPA'!$G$5:$G$35</c:f>
                <c:numCache>
                  <c:formatCode>General</c:formatCode>
                  <c:ptCount val="31"/>
                  <c:pt idx="0">
                    <c:v>8.8010422123445564E-2</c:v>
                  </c:pt>
                  <c:pt idx="1">
                    <c:v>0.29771686068991743</c:v>
                  </c:pt>
                  <c:pt idx="2">
                    <c:v>1.1005391598903351</c:v>
                  </c:pt>
                  <c:pt idx="3">
                    <c:v>3.1183730956396642E-2</c:v>
                  </c:pt>
                  <c:pt idx="4">
                    <c:v>0.18415565095435124</c:v>
                  </c:pt>
                  <c:pt idx="5">
                    <c:v>0.24998870794400466</c:v>
                  </c:pt>
                  <c:pt idx="6">
                    <c:v>0.47814542402360372</c:v>
                  </c:pt>
                  <c:pt idx="7">
                    <c:v>1.985288108895944</c:v>
                  </c:pt>
                  <c:pt idx="8">
                    <c:v>2.8563506372568304</c:v>
                  </c:pt>
                  <c:pt idx="9">
                    <c:v>5.1378161792908559</c:v>
                  </c:pt>
                  <c:pt idx="10">
                    <c:v>0.41583967320722492</c:v>
                  </c:pt>
                  <c:pt idx="11">
                    <c:v>9.3065256658957818E-2</c:v>
                  </c:pt>
                  <c:pt idx="12">
                    <c:v>0.2592303305024386</c:v>
                  </c:pt>
                  <c:pt idx="13">
                    <c:v>0.37695761694508517</c:v>
                  </c:pt>
                  <c:pt idx="14">
                    <c:v>0.78354610838218564</c:v>
                  </c:pt>
                  <c:pt idx="15">
                    <c:v>1.9001901671565047</c:v>
                  </c:pt>
                  <c:pt idx="16">
                    <c:v>0.8355157832259108</c:v>
                  </c:pt>
                  <c:pt idx="17">
                    <c:v>1.9726036077462605</c:v>
                  </c:pt>
                  <c:pt idx="18">
                    <c:v>0.13363859270207826</c:v>
                  </c:pt>
                  <c:pt idx="19">
                    <c:v>0.21707607826688968</c:v>
                  </c:pt>
                  <c:pt idx="20">
                    <c:v>0.14564549599142829</c:v>
                  </c:pt>
                  <c:pt idx="21">
                    <c:v>0.64773036684862817</c:v>
                  </c:pt>
                  <c:pt idx="22">
                    <c:v>7.9866275436835443E-2</c:v>
                  </c:pt>
                  <c:pt idx="23">
                    <c:v>0.43519058372024538</c:v>
                  </c:pt>
                  <c:pt idx="24">
                    <c:v>1.2448432296397498</c:v>
                  </c:pt>
                  <c:pt idx="25">
                    <c:v>0.10570129832379835</c:v>
                  </c:pt>
                  <c:pt idx="26">
                    <c:v>9.0329746257320626E-2</c:v>
                  </c:pt>
                  <c:pt idx="27">
                    <c:v>0.27048095738152445</c:v>
                  </c:pt>
                  <c:pt idx="28">
                    <c:v>0.29578156729081445</c:v>
                  </c:pt>
                  <c:pt idx="29">
                    <c:v>0.2281925090376398</c:v>
                  </c:pt>
                  <c:pt idx="30">
                    <c:v>0.206875109553044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3 DPA'!$B$5:$B$35</c:f>
              <c:strCache>
                <c:ptCount val="31"/>
                <c:pt idx="0">
                  <c:v> 52:6(22:5)</c:v>
                </c:pt>
                <c:pt idx="1">
                  <c:v> 56:6(22:5)</c:v>
                </c:pt>
                <c:pt idx="2">
                  <c:v> 56:7(22:5)</c:v>
                </c:pt>
                <c:pt idx="3">
                  <c:v> 56:8(22:5)</c:v>
                </c:pt>
                <c:pt idx="4">
                  <c:v> 56:9(22:5)</c:v>
                </c:pt>
                <c:pt idx="5">
                  <c:v> 58:7(22:5)</c:v>
                </c:pt>
                <c:pt idx="6">
                  <c:v> 58:8(22:5)</c:v>
                </c:pt>
                <c:pt idx="7">
                  <c:v> 58:9(22:5)</c:v>
                </c:pt>
                <c:pt idx="8">
                  <c:v> 58:10(22:5)</c:v>
                </c:pt>
                <c:pt idx="9">
                  <c:v> 58:11(22:5)</c:v>
                </c:pt>
                <c:pt idx="10">
                  <c:v> 58:12(22:5)</c:v>
                </c:pt>
                <c:pt idx="11">
                  <c:v> 60:5(22:5)</c:v>
                </c:pt>
                <c:pt idx="12">
                  <c:v> 60:7(22:5)</c:v>
                </c:pt>
                <c:pt idx="13">
                  <c:v> 60:8(22:5)</c:v>
                </c:pt>
                <c:pt idx="14">
                  <c:v> 60:9(22:5)</c:v>
                </c:pt>
                <c:pt idx="15">
                  <c:v> 60:10(22:5)</c:v>
                </c:pt>
                <c:pt idx="16">
                  <c:v> 60:11(22:5)</c:v>
                </c:pt>
                <c:pt idx="17">
                  <c:v> 60:12(22:5)</c:v>
                </c:pt>
                <c:pt idx="18">
                  <c:v> 60:14(22:5)</c:v>
                </c:pt>
                <c:pt idx="19">
                  <c:v> 62:6(22:5)</c:v>
                </c:pt>
                <c:pt idx="20">
                  <c:v> 62:10(22:5)</c:v>
                </c:pt>
                <c:pt idx="21">
                  <c:v> 62:11(22:5)</c:v>
                </c:pt>
                <c:pt idx="22">
                  <c:v> 62:12(22:5)</c:v>
                </c:pt>
                <c:pt idx="23">
                  <c:v> 62:13(22:5)</c:v>
                </c:pt>
                <c:pt idx="24">
                  <c:v> 62:14(22:5)</c:v>
                </c:pt>
                <c:pt idx="25">
                  <c:v> 62:15(22:5)</c:v>
                </c:pt>
                <c:pt idx="26">
                  <c:v> 64:13(22:5)</c:v>
                </c:pt>
                <c:pt idx="27">
                  <c:v> 64:15(22:5)</c:v>
                </c:pt>
                <c:pt idx="28">
                  <c:v> 66:17(22:5)</c:v>
                </c:pt>
                <c:pt idx="29">
                  <c:v>64:16(20:5)</c:v>
                </c:pt>
                <c:pt idx="30">
                  <c:v>64:17(20:5)</c:v>
                </c:pt>
              </c:strCache>
            </c:strRef>
          </c:cat>
          <c:val>
            <c:numRef>
              <c:f>'S9-3 DPA'!$D$5:$D$35</c:f>
              <c:numCache>
                <c:formatCode>General</c:formatCode>
                <c:ptCount val="31"/>
                <c:pt idx="0">
                  <c:v>0.16640031361900681</c:v>
                </c:pt>
                <c:pt idx="1">
                  <c:v>0.59045196889243268</c:v>
                </c:pt>
                <c:pt idx="2">
                  <c:v>4.7278592147377179</c:v>
                </c:pt>
                <c:pt idx="3">
                  <c:v>4.2229794794146107</c:v>
                </c:pt>
                <c:pt idx="4">
                  <c:v>0.36808638055525095</c:v>
                </c:pt>
                <c:pt idx="5">
                  <c:v>4.5061695037099305</c:v>
                </c:pt>
                <c:pt idx="6">
                  <c:v>7.1108934989438559</c:v>
                </c:pt>
                <c:pt idx="7">
                  <c:v>14.134396733472363</c:v>
                </c:pt>
                <c:pt idx="8">
                  <c:v>22.879878418884726</c:v>
                </c:pt>
                <c:pt idx="9">
                  <c:v>10.183491036570842</c:v>
                </c:pt>
                <c:pt idx="10">
                  <c:v>0.41583967320722487</c:v>
                </c:pt>
                <c:pt idx="11">
                  <c:v>0.35127704767270213</c:v>
                </c:pt>
                <c:pt idx="12">
                  <c:v>0.4966768293738113</c:v>
                </c:pt>
                <c:pt idx="13">
                  <c:v>2.2750042037063962</c:v>
                </c:pt>
                <c:pt idx="14">
                  <c:v>2.8963150496757684</c:v>
                </c:pt>
                <c:pt idx="15">
                  <c:v>3.6992049643572051</c:v>
                </c:pt>
                <c:pt idx="16">
                  <c:v>5.0262086347883104</c:v>
                </c:pt>
                <c:pt idx="17">
                  <c:v>1.9726036077462605</c:v>
                </c:pt>
                <c:pt idx="18">
                  <c:v>0.13363859270207826</c:v>
                </c:pt>
                <c:pt idx="19">
                  <c:v>0.53321475304721211</c:v>
                </c:pt>
                <c:pt idx="20">
                  <c:v>0.14564549599142826</c:v>
                </c:pt>
                <c:pt idx="21">
                  <c:v>1.4830552321683304</c:v>
                </c:pt>
                <c:pt idx="22">
                  <c:v>1.6846906026637367</c:v>
                </c:pt>
                <c:pt idx="23">
                  <c:v>4.6424400458769908</c:v>
                </c:pt>
                <c:pt idx="24">
                  <c:v>2.4718889682509855</c:v>
                </c:pt>
                <c:pt idx="25">
                  <c:v>0.62321119641890677</c:v>
                </c:pt>
                <c:pt idx="26">
                  <c:v>0.34781806472379007</c:v>
                </c:pt>
                <c:pt idx="27">
                  <c:v>0.27048095738152439</c:v>
                </c:pt>
                <c:pt idx="28">
                  <c:v>0.2957815672908144</c:v>
                </c:pt>
                <c:pt idx="29">
                  <c:v>0.2281925090376398</c:v>
                </c:pt>
                <c:pt idx="30">
                  <c:v>0.33358306797830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4A-4AE3-B0E1-6EF4323B77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2551816"/>
        <c:axId val="802553128"/>
      </c:barChart>
      <c:catAx>
        <c:axId val="802551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2553128"/>
        <c:crosses val="autoZero"/>
        <c:auto val="1"/>
        <c:lblAlgn val="ctr"/>
        <c:lblOffset val="100"/>
        <c:noMultiLvlLbl val="0"/>
      </c:catAx>
      <c:valAx>
        <c:axId val="802553128"/>
        <c:scaling>
          <c:orientation val="minMax"/>
          <c:max val="3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nmol %</a:t>
                </a:r>
                <a:endParaRPr lang="en-GB" sz="1200"/>
              </a:p>
            </c:rich>
          </c:tx>
          <c:layout>
            <c:manualLayout>
              <c:xMode val="edge"/>
              <c:yMode val="edge"/>
              <c:x val="2.3151915015994912E-2"/>
              <c:y val="0.299598894382779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255181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56141132871145794"/>
          <c:y val="0.18971549022991538"/>
          <c:w val="0.37565800489580037"/>
          <c:h val="0.133526629024874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6350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rgbClr val="183775"/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>
                <a:solidFill>
                  <a:srgbClr val="183775"/>
                </a:solidFill>
              </a:rPr>
              <a:t>TAG Containing DHA (22:6)</a:t>
            </a:r>
            <a:endParaRPr lang="en-GB" sz="1400" dirty="0">
              <a:solidFill>
                <a:srgbClr val="183775"/>
              </a:solidFill>
            </a:endParaRPr>
          </a:p>
        </c:rich>
      </c:tx>
      <c:layout>
        <c:manualLayout>
          <c:xMode val="edge"/>
          <c:yMode val="edge"/>
          <c:x val="0.57224505819502314"/>
          <c:y val="3.240736730285322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rgbClr val="183775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4872909689598074E-2"/>
          <c:y val="2.4674888421109369E-2"/>
          <c:w val="0.86771440957341939"/>
          <c:h val="0.542746802624313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9-4 DHA'!$C$4</c:f>
              <c:strCache>
                <c:ptCount val="1"/>
                <c:pt idx="0">
                  <c:v>DHA2015.1</c:v>
                </c:pt>
              </c:strCache>
            </c:strRef>
          </c:tx>
          <c:spPr>
            <a:solidFill>
              <a:srgbClr val="18377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4 DHA'!$F$5:$F$40</c:f>
                <c:numCache>
                  <c:formatCode>General</c:formatCode>
                  <c:ptCount val="36"/>
                  <c:pt idx="0">
                    <c:v>0.25315783308637207</c:v>
                  </c:pt>
                  <c:pt idx="1">
                    <c:v>0.1334338021195782</c:v>
                  </c:pt>
                  <c:pt idx="2">
                    <c:v>7.5142973890876374E-2</c:v>
                  </c:pt>
                  <c:pt idx="3">
                    <c:v>4.568810197290931E-2</c:v>
                  </c:pt>
                  <c:pt idx="4">
                    <c:v>8.1131466799543153E-2</c:v>
                  </c:pt>
                  <c:pt idx="5">
                    <c:v>1.8201743594150206</c:v>
                  </c:pt>
                  <c:pt idx="6">
                    <c:v>1.681939731269815</c:v>
                  </c:pt>
                  <c:pt idx="7">
                    <c:v>0.81259185383744681</c:v>
                  </c:pt>
                  <c:pt idx="8">
                    <c:v>0.38857679411375073</c:v>
                  </c:pt>
                  <c:pt idx="9">
                    <c:v>0.27354889150473954</c:v>
                  </c:pt>
                  <c:pt idx="10">
                    <c:v>0.1549449270161275</c:v>
                  </c:pt>
                  <c:pt idx="11">
                    <c:v>0.35756531957620297</c:v>
                  </c:pt>
                  <c:pt idx="12">
                    <c:v>0.3809535282870114</c:v>
                  </c:pt>
                  <c:pt idx="13">
                    <c:v>0.26102740343555275</c:v>
                  </c:pt>
                  <c:pt idx="14">
                    <c:v>0.19907267530656142</c:v>
                  </c:pt>
                  <c:pt idx="15">
                    <c:v>0.22849442348950616</c:v>
                  </c:pt>
                  <c:pt idx="16">
                    <c:v>2.2440562772227262</c:v>
                  </c:pt>
                  <c:pt idx="17">
                    <c:v>2.3082138681367579</c:v>
                  </c:pt>
                  <c:pt idx="18">
                    <c:v>0.29983552532305385</c:v>
                  </c:pt>
                  <c:pt idx="19">
                    <c:v>0.14259365271438015</c:v>
                  </c:pt>
                  <c:pt idx="20">
                    <c:v>0.24642383611083951</c:v>
                  </c:pt>
                  <c:pt idx="21">
                    <c:v>0.22036060820110337</c:v>
                  </c:pt>
                  <c:pt idx="22">
                    <c:v>0.14952648201736674</c:v>
                  </c:pt>
                  <c:pt idx="23">
                    <c:v>1.0981048987325361</c:v>
                  </c:pt>
                  <c:pt idx="24">
                    <c:v>0.44926663003893336</c:v>
                  </c:pt>
                  <c:pt idx="25">
                    <c:v>2.8588592409870222</c:v>
                  </c:pt>
                  <c:pt idx="26">
                    <c:v>0.37305071821932512</c:v>
                  </c:pt>
                  <c:pt idx="27">
                    <c:v>0.48491217498903438</c:v>
                  </c:pt>
                  <c:pt idx="28">
                    <c:v>0.12783736306814469</c:v>
                  </c:pt>
                  <c:pt idx="29">
                    <c:v>0.56138585010724062</c:v>
                  </c:pt>
                  <c:pt idx="30">
                    <c:v>0.38212067686425766</c:v>
                  </c:pt>
                  <c:pt idx="31">
                    <c:v>0</c:v>
                  </c:pt>
                  <c:pt idx="32">
                    <c:v>0.71175766303972909</c:v>
                  </c:pt>
                  <c:pt idx="33">
                    <c:v>0.75128725035856736</c:v>
                  </c:pt>
                  <c:pt idx="34">
                    <c:v>6.5613207701475093E-2</c:v>
                  </c:pt>
                  <c:pt idx="35">
                    <c:v>0.20171018022225798</c:v>
                  </c:pt>
                </c:numCache>
              </c:numRef>
            </c:plus>
            <c:minus>
              <c:numRef>
                <c:f>'S9-4 DHA'!$F$5:$F$40</c:f>
                <c:numCache>
                  <c:formatCode>General</c:formatCode>
                  <c:ptCount val="36"/>
                  <c:pt idx="0">
                    <c:v>0.25315783308637207</c:v>
                  </c:pt>
                  <c:pt idx="1">
                    <c:v>0.1334338021195782</c:v>
                  </c:pt>
                  <c:pt idx="2">
                    <c:v>7.5142973890876374E-2</c:v>
                  </c:pt>
                  <c:pt idx="3">
                    <c:v>4.568810197290931E-2</c:v>
                  </c:pt>
                  <c:pt idx="4">
                    <c:v>8.1131466799543153E-2</c:v>
                  </c:pt>
                  <c:pt idx="5">
                    <c:v>1.8201743594150206</c:v>
                  </c:pt>
                  <c:pt idx="6">
                    <c:v>1.681939731269815</c:v>
                  </c:pt>
                  <c:pt idx="7">
                    <c:v>0.81259185383744681</c:v>
                  </c:pt>
                  <c:pt idx="8">
                    <c:v>0.38857679411375073</c:v>
                  </c:pt>
                  <c:pt idx="9">
                    <c:v>0.27354889150473954</c:v>
                  </c:pt>
                  <c:pt idx="10">
                    <c:v>0.1549449270161275</c:v>
                  </c:pt>
                  <c:pt idx="11">
                    <c:v>0.35756531957620297</c:v>
                  </c:pt>
                  <c:pt idx="12">
                    <c:v>0.3809535282870114</c:v>
                  </c:pt>
                  <c:pt idx="13">
                    <c:v>0.26102740343555275</c:v>
                  </c:pt>
                  <c:pt idx="14">
                    <c:v>0.19907267530656142</c:v>
                  </c:pt>
                  <c:pt idx="15">
                    <c:v>0.22849442348950616</c:v>
                  </c:pt>
                  <c:pt idx="16">
                    <c:v>2.2440562772227262</c:v>
                  </c:pt>
                  <c:pt idx="17">
                    <c:v>2.3082138681367579</c:v>
                  </c:pt>
                  <c:pt idx="18">
                    <c:v>0.29983552532305385</c:v>
                  </c:pt>
                  <c:pt idx="19">
                    <c:v>0.14259365271438015</c:v>
                  </c:pt>
                  <c:pt idx="20">
                    <c:v>0.24642383611083951</c:v>
                  </c:pt>
                  <c:pt idx="21">
                    <c:v>0.22036060820110337</c:v>
                  </c:pt>
                  <c:pt idx="22">
                    <c:v>0.14952648201736674</c:v>
                  </c:pt>
                  <c:pt idx="23">
                    <c:v>1.0981048987325361</c:v>
                  </c:pt>
                  <c:pt idx="24">
                    <c:v>0.44926663003893336</c:v>
                  </c:pt>
                  <c:pt idx="25">
                    <c:v>2.8588592409870222</c:v>
                  </c:pt>
                  <c:pt idx="26">
                    <c:v>0.37305071821932512</c:v>
                  </c:pt>
                  <c:pt idx="27">
                    <c:v>0.48491217498903438</c:v>
                  </c:pt>
                  <c:pt idx="28">
                    <c:v>0.12783736306814469</c:v>
                  </c:pt>
                  <c:pt idx="29">
                    <c:v>0.56138585010724062</c:v>
                  </c:pt>
                  <c:pt idx="30">
                    <c:v>0.38212067686425766</c:v>
                  </c:pt>
                  <c:pt idx="31">
                    <c:v>0</c:v>
                  </c:pt>
                  <c:pt idx="32">
                    <c:v>0.71175766303972909</c:v>
                  </c:pt>
                  <c:pt idx="33">
                    <c:v>0.75128725035856736</c:v>
                  </c:pt>
                  <c:pt idx="34">
                    <c:v>6.5613207701475093E-2</c:v>
                  </c:pt>
                  <c:pt idx="35">
                    <c:v>0.201710180222257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4 DHA'!$B$5:$B$40</c:f>
              <c:strCache>
                <c:ptCount val="36"/>
                <c:pt idx="0">
                  <c:v>56:6(22:6)</c:v>
                </c:pt>
                <c:pt idx="1">
                  <c:v>56:7(22:6)</c:v>
                </c:pt>
                <c:pt idx="2">
                  <c:v>56:8(22:6)</c:v>
                </c:pt>
                <c:pt idx="3">
                  <c:v>56:10(22:6)</c:v>
                </c:pt>
                <c:pt idx="4">
                  <c:v>56:11(22:6)</c:v>
                </c:pt>
                <c:pt idx="5">
                  <c:v>58:6(22:6)</c:v>
                </c:pt>
                <c:pt idx="6">
                  <c:v>58:7(22:6)</c:v>
                </c:pt>
                <c:pt idx="7">
                  <c:v>58:8(22:6)</c:v>
                </c:pt>
                <c:pt idx="8">
                  <c:v>58:9(22:6)</c:v>
                </c:pt>
                <c:pt idx="9">
                  <c:v>58:10(22:6)</c:v>
                </c:pt>
                <c:pt idx="10">
                  <c:v>58:11(22:6)</c:v>
                </c:pt>
                <c:pt idx="11">
                  <c:v>58:12(22:6)</c:v>
                </c:pt>
                <c:pt idx="12">
                  <c:v>58:13(22:6)</c:v>
                </c:pt>
                <c:pt idx="13">
                  <c:v>60:6(22:6)</c:v>
                </c:pt>
                <c:pt idx="14">
                  <c:v>60:7(22:6)</c:v>
                </c:pt>
                <c:pt idx="15">
                  <c:v>60:8(22:6)</c:v>
                </c:pt>
                <c:pt idx="16">
                  <c:v>60:9(22:6)</c:v>
                </c:pt>
                <c:pt idx="17">
                  <c:v>60:10(22:6)</c:v>
                </c:pt>
                <c:pt idx="18">
                  <c:v>60:11(22:6)</c:v>
                </c:pt>
                <c:pt idx="19">
                  <c:v>60:12(22:6)</c:v>
                </c:pt>
                <c:pt idx="20">
                  <c:v>60:14(22:6)</c:v>
                </c:pt>
                <c:pt idx="21">
                  <c:v>62:6(22:6)</c:v>
                </c:pt>
                <c:pt idx="22">
                  <c:v>62:8(22:6)</c:v>
                </c:pt>
                <c:pt idx="23">
                  <c:v>62:9(22:6)</c:v>
                </c:pt>
                <c:pt idx="24">
                  <c:v>62:10(22:6)</c:v>
                </c:pt>
                <c:pt idx="25">
                  <c:v>62:11(22:6)</c:v>
                </c:pt>
                <c:pt idx="26">
                  <c:v>62:12(22:6)</c:v>
                </c:pt>
                <c:pt idx="27">
                  <c:v>62:13(22:6)</c:v>
                </c:pt>
                <c:pt idx="28">
                  <c:v>64:6(22:6)</c:v>
                </c:pt>
                <c:pt idx="29">
                  <c:v>64:10(22:6)</c:v>
                </c:pt>
                <c:pt idx="30">
                  <c:v>64:11(22:6)</c:v>
                </c:pt>
                <c:pt idx="31">
                  <c:v>64:12(22:6)</c:v>
                </c:pt>
                <c:pt idx="32">
                  <c:v>64:13(22:6)</c:v>
                </c:pt>
                <c:pt idx="33">
                  <c:v>64:14(22:6)</c:v>
                </c:pt>
                <c:pt idx="34">
                  <c:v>66:10(22:6)</c:v>
                </c:pt>
                <c:pt idx="35">
                  <c:v>66:11(22:6)</c:v>
                </c:pt>
              </c:strCache>
            </c:strRef>
          </c:cat>
          <c:val>
            <c:numRef>
              <c:f>'S9-4 DHA'!$C$5:$C$40</c:f>
              <c:numCache>
                <c:formatCode>General</c:formatCode>
                <c:ptCount val="36"/>
                <c:pt idx="0">
                  <c:v>4.4439812181845655</c:v>
                </c:pt>
                <c:pt idx="1">
                  <c:v>2.9712475309209254</c:v>
                </c:pt>
                <c:pt idx="2">
                  <c:v>0.53964410792260398</c:v>
                </c:pt>
                <c:pt idx="3">
                  <c:v>7.090353761610084E-2</c:v>
                </c:pt>
                <c:pt idx="4">
                  <c:v>1.1564575924405018</c:v>
                </c:pt>
                <c:pt idx="5">
                  <c:v>3.6213983011270989</c:v>
                </c:pt>
                <c:pt idx="6">
                  <c:v>12.405735338382257</c:v>
                </c:pt>
                <c:pt idx="7">
                  <c:v>13.119411322550194</c:v>
                </c:pt>
                <c:pt idx="8">
                  <c:v>6.4162268346896454</c:v>
                </c:pt>
                <c:pt idx="9">
                  <c:v>0.54682818225459173</c:v>
                </c:pt>
                <c:pt idx="10">
                  <c:v>0.3373675316615441</c:v>
                </c:pt>
                <c:pt idx="11">
                  <c:v>0.35756531957620297</c:v>
                </c:pt>
                <c:pt idx="12">
                  <c:v>0.38095352828701134</c:v>
                </c:pt>
                <c:pt idx="13">
                  <c:v>3.794817891252293</c:v>
                </c:pt>
                <c:pt idx="14">
                  <c:v>5.7173757122567368</c:v>
                </c:pt>
                <c:pt idx="15">
                  <c:v>5.1576609336332782</c:v>
                </c:pt>
                <c:pt idx="16">
                  <c:v>2.2440562772227262</c:v>
                </c:pt>
                <c:pt idx="17">
                  <c:v>2.3287264943889134</c:v>
                </c:pt>
                <c:pt idx="18">
                  <c:v>2.6519647900402372</c:v>
                </c:pt>
                <c:pt idx="19">
                  <c:v>0.44930966897853214</c:v>
                </c:pt>
                <c:pt idx="20">
                  <c:v>0.48409531773992248</c:v>
                </c:pt>
                <c:pt idx="21">
                  <c:v>0.44041956201147908</c:v>
                </c:pt>
                <c:pt idx="22">
                  <c:v>1.43162407522867</c:v>
                </c:pt>
                <c:pt idx="23">
                  <c:v>2.1894373560083324</c:v>
                </c:pt>
                <c:pt idx="24">
                  <c:v>4.4364626689541309</c:v>
                </c:pt>
                <c:pt idx="25">
                  <c:v>2.8588592409870217</c:v>
                </c:pt>
                <c:pt idx="26">
                  <c:v>4.2765024789564974</c:v>
                </c:pt>
                <c:pt idx="27">
                  <c:v>0.91519986854567537</c:v>
                </c:pt>
                <c:pt idx="28">
                  <c:v>0.42136816007794181</c:v>
                </c:pt>
                <c:pt idx="29">
                  <c:v>1.102699034280938</c:v>
                </c:pt>
                <c:pt idx="30">
                  <c:v>0.76261742419885825</c:v>
                </c:pt>
                <c:pt idx="31">
                  <c:v>0</c:v>
                </c:pt>
                <c:pt idx="32">
                  <c:v>1.3846754924115026</c:v>
                </c:pt>
                <c:pt idx="33">
                  <c:v>1.4982110598430729</c:v>
                </c:pt>
                <c:pt idx="34">
                  <c:v>1.0760571789861768</c:v>
                </c:pt>
                <c:pt idx="35">
                  <c:v>1.83235364634101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B4-4D76-8C61-97A62E132FEA}"/>
            </c:ext>
          </c:extLst>
        </c:ser>
        <c:ser>
          <c:idx val="1"/>
          <c:order val="1"/>
          <c:tx>
            <c:strRef>
              <c:f>'S9-4 DHA'!$D$4</c:f>
              <c:strCache>
                <c:ptCount val="1"/>
                <c:pt idx="0">
                  <c:v>DHA2015.5</c:v>
                </c:pt>
              </c:strCache>
            </c:strRef>
          </c:tx>
          <c:spPr>
            <a:solidFill>
              <a:srgbClr val="D8DFFB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9-4 DHA'!$G$5:$G$40</c:f>
                <c:numCache>
                  <c:formatCode>General</c:formatCode>
                  <c:ptCount val="36"/>
                  <c:pt idx="0">
                    <c:v>0.20760855810464862</c:v>
                  </c:pt>
                  <c:pt idx="1">
                    <c:v>0.60574122004457864</c:v>
                  </c:pt>
                  <c:pt idx="2">
                    <c:v>2.1503649194232834E-2</c:v>
                  </c:pt>
                  <c:pt idx="3">
                    <c:v>9.1504209761660529E-2</c:v>
                  </c:pt>
                  <c:pt idx="4">
                    <c:v>0.12702237771072644</c:v>
                  </c:pt>
                  <c:pt idx="5">
                    <c:v>1.6009992859704176</c:v>
                  </c:pt>
                  <c:pt idx="6">
                    <c:v>0.3884782521017468</c:v>
                  </c:pt>
                  <c:pt idx="7">
                    <c:v>1.0610138654232828</c:v>
                  </c:pt>
                  <c:pt idx="8">
                    <c:v>0.70923401266536124</c:v>
                  </c:pt>
                  <c:pt idx="9">
                    <c:v>0.35691922631890288</c:v>
                  </c:pt>
                  <c:pt idx="10">
                    <c:v>7.1531553425765809E-2</c:v>
                  </c:pt>
                  <c:pt idx="11">
                    <c:v>0.1007408131597749</c:v>
                  </c:pt>
                  <c:pt idx="12">
                    <c:v>0.24170155066055335</c:v>
                  </c:pt>
                  <c:pt idx="13">
                    <c:v>0.15519041520950508</c:v>
                  </c:pt>
                  <c:pt idx="14">
                    <c:v>4.5921639323106458E-2</c:v>
                  </c:pt>
                  <c:pt idx="15">
                    <c:v>8.4472895219203162E-2</c:v>
                  </c:pt>
                  <c:pt idx="16">
                    <c:v>2.2143958944755826</c:v>
                  </c:pt>
                  <c:pt idx="17">
                    <c:v>1.7227390353565915</c:v>
                  </c:pt>
                  <c:pt idx="18">
                    <c:v>0.28210856799358436</c:v>
                  </c:pt>
                  <c:pt idx="19">
                    <c:v>7.5814286354375024E-2</c:v>
                  </c:pt>
                  <c:pt idx="20">
                    <c:v>4.9560017491012659E-2</c:v>
                  </c:pt>
                  <c:pt idx="21">
                    <c:v>7.4786638554170462E-2</c:v>
                  </c:pt>
                  <c:pt idx="22">
                    <c:v>0.11559147907951325</c:v>
                  </c:pt>
                  <c:pt idx="23">
                    <c:v>0.15583643864519511</c:v>
                  </c:pt>
                  <c:pt idx="24">
                    <c:v>0.2027684868489569</c:v>
                  </c:pt>
                  <c:pt idx="25">
                    <c:v>2.7162821510414727</c:v>
                  </c:pt>
                  <c:pt idx="26">
                    <c:v>0.41975706936424495</c:v>
                  </c:pt>
                  <c:pt idx="27">
                    <c:v>0.35659391965727028</c:v>
                  </c:pt>
                  <c:pt idx="28">
                    <c:v>4.4964770858160466E-3</c:v>
                  </c:pt>
                  <c:pt idx="29">
                    <c:v>0.47131366528889135</c:v>
                  </c:pt>
                  <c:pt idx="30">
                    <c:v>0.28827243828866078</c:v>
                  </c:pt>
                  <c:pt idx="31">
                    <c:v>2.5834760855591225E-2</c:v>
                  </c:pt>
                  <c:pt idx="32">
                    <c:v>0.39628540368175358</c:v>
                  </c:pt>
                  <c:pt idx="33">
                    <c:v>0.57369180608194248</c:v>
                  </c:pt>
                  <c:pt idx="34">
                    <c:v>0.12585274693534837</c:v>
                  </c:pt>
                  <c:pt idx="35">
                    <c:v>3.611707774187125E-3</c:v>
                  </c:pt>
                </c:numCache>
              </c:numRef>
            </c:plus>
            <c:minus>
              <c:numRef>
                <c:f>'S9-4 DHA'!$G$5:$G$40</c:f>
                <c:numCache>
                  <c:formatCode>General</c:formatCode>
                  <c:ptCount val="36"/>
                  <c:pt idx="0">
                    <c:v>0.20760855810464862</c:v>
                  </c:pt>
                  <c:pt idx="1">
                    <c:v>0.60574122004457864</c:v>
                  </c:pt>
                  <c:pt idx="2">
                    <c:v>2.1503649194232834E-2</c:v>
                  </c:pt>
                  <c:pt idx="3">
                    <c:v>9.1504209761660529E-2</c:v>
                  </c:pt>
                  <c:pt idx="4">
                    <c:v>0.12702237771072644</c:v>
                  </c:pt>
                  <c:pt idx="5">
                    <c:v>1.6009992859704176</c:v>
                  </c:pt>
                  <c:pt idx="6">
                    <c:v>0.3884782521017468</c:v>
                  </c:pt>
                  <c:pt idx="7">
                    <c:v>1.0610138654232828</c:v>
                  </c:pt>
                  <c:pt idx="8">
                    <c:v>0.70923401266536124</c:v>
                  </c:pt>
                  <c:pt idx="9">
                    <c:v>0.35691922631890288</c:v>
                  </c:pt>
                  <c:pt idx="10">
                    <c:v>7.1531553425765809E-2</c:v>
                  </c:pt>
                  <c:pt idx="11">
                    <c:v>0.1007408131597749</c:v>
                  </c:pt>
                  <c:pt idx="12">
                    <c:v>0.24170155066055335</c:v>
                  </c:pt>
                  <c:pt idx="13">
                    <c:v>0.15519041520950508</c:v>
                  </c:pt>
                  <c:pt idx="14">
                    <c:v>4.5921639323106458E-2</c:v>
                  </c:pt>
                  <c:pt idx="15">
                    <c:v>8.4472895219203162E-2</c:v>
                  </c:pt>
                  <c:pt idx="16">
                    <c:v>2.2143958944755826</c:v>
                  </c:pt>
                  <c:pt idx="17">
                    <c:v>1.7227390353565915</c:v>
                  </c:pt>
                  <c:pt idx="18">
                    <c:v>0.28210856799358436</c:v>
                  </c:pt>
                  <c:pt idx="19">
                    <c:v>7.5814286354375024E-2</c:v>
                  </c:pt>
                  <c:pt idx="20">
                    <c:v>4.9560017491012659E-2</c:v>
                  </c:pt>
                  <c:pt idx="21">
                    <c:v>7.4786638554170462E-2</c:v>
                  </c:pt>
                  <c:pt idx="22">
                    <c:v>0.11559147907951325</c:v>
                  </c:pt>
                  <c:pt idx="23">
                    <c:v>0.15583643864519511</c:v>
                  </c:pt>
                  <c:pt idx="24">
                    <c:v>0.2027684868489569</c:v>
                  </c:pt>
                  <c:pt idx="25">
                    <c:v>2.7162821510414727</c:v>
                  </c:pt>
                  <c:pt idx="26">
                    <c:v>0.41975706936424495</c:v>
                  </c:pt>
                  <c:pt idx="27">
                    <c:v>0.35659391965727028</c:v>
                  </c:pt>
                  <c:pt idx="28">
                    <c:v>4.4964770858160466E-3</c:v>
                  </c:pt>
                  <c:pt idx="29">
                    <c:v>0.47131366528889135</c:v>
                  </c:pt>
                  <c:pt idx="30">
                    <c:v>0.28827243828866078</c:v>
                  </c:pt>
                  <c:pt idx="31">
                    <c:v>2.5834760855591225E-2</c:v>
                  </c:pt>
                  <c:pt idx="32">
                    <c:v>0.39628540368175358</c:v>
                  </c:pt>
                  <c:pt idx="33">
                    <c:v>0.57369180608194248</c:v>
                  </c:pt>
                  <c:pt idx="34">
                    <c:v>0.12585274693534837</c:v>
                  </c:pt>
                  <c:pt idx="35">
                    <c:v>3.61170777418712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9-4 DHA'!$B$5:$B$40</c:f>
              <c:strCache>
                <c:ptCount val="36"/>
                <c:pt idx="0">
                  <c:v>56:6(22:6)</c:v>
                </c:pt>
                <c:pt idx="1">
                  <c:v>56:7(22:6)</c:v>
                </c:pt>
                <c:pt idx="2">
                  <c:v>56:8(22:6)</c:v>
                </c:pt>
                <c:pt idx="3">
                  <c:v>56:10(22:6)</c:v>
                </c:pt>
                <c:pt idx="4">
                  <c:v>56:11(22:6)</c:v>
                </c:pt>
                <c:pt idx="5">
                  <c:v>58:6(22:6)</c:v>
                </c:pt>
                <c:pt idx="6">
                  <c:v>58:7(22:6)</c:v>
                </c:pt>
                <c:pt idx="7">
                  <c:v>58:8(22:6)</c:v>
                </c:pt>
                <c:pt idx="8">
                  <c:v>58:9(22:6)</c:v>
                </c:pt>
                <c:pt idx="9">
                  <c:v>58:10(22:6)</c:v>
                </c:pt>
                <c:pt idx="10">
                  <c:v>58:11(22:6)</c:v>
                </c:pt>
                <c:pt idx="11">
                  <c:v>58:12(22:6)</c:v>
                </c:pt>
                <c:pt idx="12">
                  <c:v>58:13(22:6)</c:v>
                </c:pt>
                <c:pt idx="13">
                  <c:v>60:6(22:6)</c:v>
                </c:pt>
                <c:pt idx="14">
                  <c:v>60:7(22:6)</c:v>
                </c:pt>
                <c:pt idx="15">
                  <c:v>60:8(22:6)</c:v>
                </c:pt>
                <c:pt idx="16">
                  <c:v>60:9(22:6)</c:v>
                </c:pt>
                <c:pt idx="17">
                  <c:v>60:10(22:6)</c:v>
                </c:pt>
                <c:pt idx="18">
                  <c:v>60:11(22:6)</c:v>
                </c:pt>
                <c:pt idx="19">
                  <c:v>60:12(22:6)</c:v>
                </c:pt>
                <c:pt idx="20">
                  <c:v>60:14(22:6)</c:v>
                </c:pt>
                <c:pt idx="21">
                  <c:v>62:6(22:6)</c:v>
                </c:pt>
                <c:pt idx="22">
                  <c:v>62:8(22:6)</c:v>
                </c:pt>
                <c:pt idx="23">
                  <c:v>62:9(22:6)</c:v>
                </c:pt>
                <c:pt idx="24">
                  <c:v>62:10(22:6)</c:v>
                </c:pt>
                <c:pt idx="25">
                  <c:v>62:11(22:6)</c:v>
                </c:pt>
                <c:pt idx="26">
                  <c:v>62:12(22:6)</c:v>
                </c:pt>
                <c:pt idx="27">
                  <c:v>62:13(22:6)</c:v>
                </c:pt>
                <c:pt idx="28">
                  <c:v>64:6(22:6)</c:v>
                </c:pt>
                <c:pt idx="29">
                  <c:v>64:10(22:6)</c:v>
                </c:pt>
                <c:pt idx="30">
                  <c:v>64:11(22:6)</c:v>
                </c:pt>
                <c:pt idx="31">
                  <c:v>64:12(22:6)</c:v>
                </c:pt>
                <c:pt idx="32">
                  <c:v>64:13(22:6)</c:v>
                </c:pt>
                <c:pt idx="33">
                  <c:v>64:14(22:6)</c:v>
                </c:pt>
                <c:pt idx="34">
                  <c:v>66:10(22:6)</c:v>
                </c:pt>
                <c:pt idx="35">
                  <c:v>66:11(22:6)</c:v>
                </c:pt>
              </c:strCache>
            </c:strRef>
          </c:cat>
          <c:val>
            <c:numRef>
              <c:f>'S9-4 DHA'!$D$5:$D$40</c:f>
              <c:numCache>
                <c:formatCode>General</c:formatCode>
                <c:ptCount val="36"/>
                <c:pt idx="0">
                  <c:v>3.8907602414602542</c:v>
                </c:pt>
                <c:pt idx="1">
                  <c:v>4.3915045268620236</c:v>
                </c:pt>
                <c:pt idx="2">
                  <c:v>0.5961288723195296</c:v>
                </c:pt>
                <c:pt idx="3">
                  <c:v>0.16810352221366187</c:v>
                </c:pt>
                <c:pt idx="4">
                  <c:v>1.1206203239841124</c:v>
                </c:pt>
                <c:pt idx="5">
                  <c:v>3.2084011434250272</c:v>
                </c:pt>
                <c:pt idx="6">
                  <c:v>9.367364509875058</c:v>
                </c:pt>
                <c:pt idx="7">
                  <c:v>13.952640198204945</c:v>
                </c:pt>
                <c:pt idx="8">
                  <c:v>7.7764524704636964</c:v>
                </c:pt>
                <c:pt idx="9">
                  <c:v>0.71381691367612043</c:v>
                </c:pt>
                <c:pt idx="10">
                  <c:v>0.41256863930875393</c:v>
                </c:pt>
                <c:pt idx="11">
                  <c:v>0.12223842155075061</c:v>
                </c:pt>
                <c:pt idx="12">
                  <c:v>0.24756380689577587</c:v>
                </c:pt>
                <c:pt idx="13">
                  <c:v>3.1292147858186805</c:v>
                </c:pt>
                <c:pt idx="14">
                  <c:v>5.5708213118120682</c:v>
                </c:pt>
                <c:pt idx="15">
                  <c:v>5.2220456561161805</c:v>
                </c:pt>
                <c:pt idx="16">
                  <c:v>4.4086022143443309</c:v>
                </c:pt>
                <c:pt idx="17">
                  <c:v>1.7227390353565915</c:v>
                </c:pt>
                <c:pt idx="18">
                  <c:v>3.1099420471602079</c:v>
                </c:pt>
                <c:pt idx="19">
                  <c:v>0.31574694899020334</c:v>
                </c:pt>
                <c:pt idx="20">
                  <c:v>0.60860774657493266</c:v>
                </c:pt>
                <c:pt idx="21">
                  <c:v>0.55921168613223016</c:v>
                </c:pt>
                <c:pt idx="22">
                  <c:v>1.0321303055466846</c:v>
                </c:pt>
                <c:pt idx="23">
                  <c:v>2.2913219050813427</c:v>
                </c:pt>
                <c:pt idx="24">
                  <c:v>4.6396986205771151</c:v>
                </c:pt>
                <c:pt idx="25">
                  <c:v>2.7428131952018364</c:v>
                </c:pt>
                <c:pt idx="26">
                  <c:v>5.1533002391484279</c:v>
                </c:pt>
                <c:pt idx="27">
                  <c:v>0.70438260056999624</c:v>
                </c:pt>
                <c:pt idx="28">
                  <c:v>0.43306680896165223</c:v>
                </c:pt>
                <c:pt idx="29">
                  <c:v>0.92481553850462772</c:v>
                </c:pt>
                <c:pt idx="30">
                  <c:v>0.57214527855950914</c:v>
                </c:pt>
                <c:pt idx="31">
                  <c:v>2.5834760855591221E-2</c:v>
                </c:pt>
                <c:pt idx="32">
                  <c:v>1.1785505648771997</c:v>
                </c:pt>
                <c:pt idx="33">
                  <c:v>1.1339367113271457</c:v>
                </c:pt>
                <c:pt idx="34">
                  <c:v>1.2470705847287602</c:v>
                </c:pt>
                <c:pt idx="35">
                  <c:v>1.7314652086206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B4-4D76-8C61-97A62E132F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5227320"/>
        <c:axId val="735226992"/>
      </c:barChart>
      <c:catAx>
        <c:axId val="735227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5226992"/>
        <c:crosses val="autoZero"/>
        <c:auto val="1"/>
        <c:lblAlgn val="ctr"/>
        <c:lblOffset val="100"/>
        <c:noMultiLvlLbl val="0"/>
      </c:catAx>
      <c:valAx>
        <c:axId val="735226992"/>
        <c:scaling>
          <c:orientation val="minMax"/>
          <c:max val="18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baseline="0">
                    <a:effectLst/>
                  </a:rPr>
                  <a:t>nmol %</a:t>
                </a:r>
                <a:endParaRPr lang="en-GB" sz="12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5227320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0250971591431612"/>
          <c:y val="0.1179840691877352"/>
          <c:w val="0.31831877781564455"/>
          <c:h val="8.95731858897833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282893518518518"/>
          <c:y val="4.6995238095238104E-2"/>
          <c:w val="0.80661550925925929"/>
          <c:h val="0.752993799376281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DHA charts'!$AD$73</c:f>
              <c:strCache>
                <c:ptCount val="1"/>
                <c:pt idx="0">
                  <c:v>DHA1</c:v>
                </c:pt>
              </c:strCache>
            </c:strRef>
          </c:tx>
          <c:spPr>
            <a:solidFill>
              <a:srgbClr val="18377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77:$AS$7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plus>
            <c:minus>
              <c:numRef>
                <c:f>'FT2018 DHA charts'!$AE$77:$AS$7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72:$AS$7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73:$AS$73</c:f>
              <c:numCache>
                <c:formatCode>0</c:formatCode>
                <c:ptCount val="15"/>
                <c:pt idx="0">
                  <c:v>8.2710144397972503</c:v>
                </c:pt>
                <c:pt idx="1">
                  <c:v>4.5881471674217345</c:v>
                </c:pt>
                <c:pt idx="2">
                  <c:v>5.0036967655752855</c:v>
                </c:pt>
                <c:pt idx="3">
                  <c:v>20.986278449836853</c:v>
                </c:pt>
                <c:pt idx="4">
                  <c:v>2.7225284814036752</c:v>
                </c:pt>
                <c:pt idx="5">
                  <c:v>13.615698491926382</c:v>
                </c:pt>
                <c:pt idx="6">
                  <c:v>1.9902900511693129</c:v>
                </c:pt>
                <c:pt idx="7">
                  <c:v>4.3843471499260485</c:v>
                </c:pt>
                <c:pt idx="8">
                  <c:v>0.65267945689110618</c:v>
                </c:pt>
                <c:pt idx="9">
                  <c:v>2.9245015805479837</c:v>
                </c:pt>
                <c:pt idx="10">
                  <c:v>2.6839962456606936</c:v>
                </c:pt>
                <c:pt idx="11">
                  <c:v>10.605406223208179</c:v>
                </c:pt>
                <c:pt idx="12">
                  <c:v>4.0354133372372276</c:v>
                </c:pt>
                <c:pt idx="13">
                  <c:v>8.5803454825515466</c:v>
                </c:pt>
                <c:pt idx="14">
                  <c:v>8.9556566768467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C1-4D3C-BA75-6419D259F917}"/>
            </c:ext>
          </c:extLst>
        </c:ser>
        <c:ser>
          <c:idx val="1"/>
          <c:order val="1"/>
          <c:tx>
            <c:strRef>
              <c:f>'FT2018 DHA charts'!$AD$74</c:f>
              <c:strCache>
                <c:ptCount val="1"/>
                <c:pt idx="0">
                  <c:v>DHA2</c:v>
                </c:pt>
              </c:strCache>
            </c:strRef>
          </c:tx>
          <c:spPr>
            <a:solidFill>
              <a:srgbClr val="395BA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78:$AS$78</c:f>
                <c:numCache>
                  <c:formatCode>General</c:formatCode>
                  <c:ptCount val="15"/>
                  <c:pt idx="0">
                    <c:v>0.5723272392769484</c:v>
                  </c:pt>
                  <c:pt idx="1">
                    <c:v>0.23711517775090943</c:v>
                  </c:pt>
                  <c:pt idx="2">
                    <c:v>1.1728445741342732</c:v>
                  </c:pt>
                  <c:pt idx="3">
                    <c:v>1.0641340043891037</c:v>
                  </c:pt>
                  <c:pt idx="4">
                    <c:v>1.8931408775521976</c:v>
                  </c:pt>
                  <c:pt idx="5">
                    <c:v>1.9275194503981161</c:v>
                  </c:pt>
                  <c:pt idx="6">
                    <c:v>4.9248235847327662</c:v>
                  </c:pt>
                  <c:pt idx="7">
                    <c:v>0.64389442837754596</c:v>
                  </c:pt>
                  <c:pt idx="8">
                    <c:v>0.60296463047272997</c:v>
                  </c:pt>
                  <c:pt idx="9">
                    <c:v>0.15592565918634915</c:v>
                  </c:pt>
                  <c:pt idx="10">
                    <c:v>0.68158833694089371</c:v>
                  </c:pt>
                  <c:pt idx="11">
                    <c:v>0.13776811600603489</c:v>
                  </c:pt>
                  <c:pt idx="12">
                    <c:v>8.0112449351945586E-2</c:v>
                  </c:pt>
                  <c:pt idx="13">
                    <c:v>0</c:v>
                  </c:pt>
                  <c:pt idx="14">
                    <c:v>4.2459000014078931</c:v>
                  </c:pt>
                </c:numCache>
              </c:numRef>
            </c:plus>
            <c:minus>
              <c:numRef>
                <c:f>'FT2018 DHA charts'!$AE$78:$AS$78</c:f>
                <c:numCache>
                  <c:formatCode>General</c:formatCode>
                  <c:ptCount val="15"/>
                  <c:pt idx="0">
                    <c:v>0.5723272392769484</c:v>
                  </c:pt>
                  <c:pt idx="1">
                    <c:v>0.23711517775090943</c:v>
                  </c:pt>
                  <c:pt idx="2">
                    <c:v>1.1728445741342732</c:v>
                  </c:pt>
                  <c:pt idx="3">
                    <c:v>1.0641340043891037</c:v>
                  </c:pt>
                  <c:pt idx="4">
                    <c:v>1.8931408775521976</c:v>
                  </c:pt>
                  <c:pt idx="5">
                    <c:v>1.9275194503981161</c:v>
                  </c:pt>
                  <c:pt idx="6">
                    <c:v>4.9248235847327662</c:v>
                  </c:pt>
                  <c:pt idx="7">
                    <c:v>0.64389442837754596</c:v>
                  </c:pt>
                  <c:pt idx="8">
                    <c:v>0.60296463047272997</c:v>
                  </c:pt>
                  <c:pt idx="9">
                    <c:v>0.15592565918634915</c:v>
                  </c:pt>
                  <c:pt idx="10">
                    <c:v>0.68158833694089371</c:v>
                  </c:pt>
                  <c:pt idx="11">
                    <c:v>0.13776811600603489</c:v>
                  </c:pt>
                  <c:pt idx="12">
                    <c:v>8.0112449351945586E-2</c:v>
                  </c:pt>
                  <c:pt idx="13">
                    <c:v>0</c:v>
                  </c:pt>
                  <c:pt idx="14">
                    <c:v>4.24590000140789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72:$AS$7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74:$AS$74</c:f>
              <c:numCache>
                <c:formatCode>0</c:formatCode>
                <c:ptCount val="15"/>
                <c:pt idx="0">
                  <c:v>7.0793085696414755</c:v>
                </c:pt>
                <c:pt idx="1">
                  <c:v>2.7065894197472642</c:v>
                </c:pt>
                <c:pt idx="2">
                  <c:v>9.3096910785588651</c:v>
                </c:pt>
                <c:pt idx="3">
                  <c:v>14.172030366225865</c:v>
                </c:pt>
                <c:pt idx="4">
                  <c:v>12.757443209456151</c:v>
                </c:pt>
                <c:pt idx="5">
                  <c:v>17.256575193789605</c:v>
                </c:pt>
                <c:pt idx="6">
                  <c:v>16.355287614279629</c:v>
                </c:pt>
                <c:pt idx="7">
                  <c:v>8.9625175033538085</c:v>
                </c:pt>
                <c:pt idx="8">
                  <c:v>0.52398154408144226</c:v>
                </c:pt>
                <c:pt idx="9">
                  <c:v>0.13693390487182938</c:v>
                </c:pt>
                <c:pt idx="10">
                  <c:v>0.72000214527861306</c:v>
                </c:pt>
                <c:pt idx="11">
                  <c:v>1.5168271044032811</c:v>
                </c:pt>
                <c:pt idx="12">
                  <c:v>0.36503088649721427</c:v>
                </c:pt>
                <c:pt idx="13">
                  <c:v>0</c:v>
                </c:pt>
                <c:pt idx="14">
                  <c:v>8.13778145981495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C1-4D3C-BA75-6419D259F9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1433360"/>
        <c:axId val="364561696"/>
      </c:barChart>
      <c:catAx>
        <c:axId val="641433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4561696"/>
        <c:crosses val="autoZero"/>
        <c:auto val="1"/>
        <c:lblAlgn val="ctr"/>
        <c:lblOffset val="100"/>
        <c:noMultiLvlLbl val="0"/>
      </c:catAx>
      <c:valAx>
        <c:axId val="36456169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u="none" strike="noStrike" baseline="0">
                    <a:solidFill>
                      <a:sysClr val="windowText" lastClr="000000"/>
                    </a:solidFill>
                  </a:rPr>
                  <a:t>FAMEs (mol%)</a:t>
                </a:r>
                <a:endParaRPr lang="en-GB" altLang="zh-CN" sz="1200" b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5.3898137024960435E-2"/>
              <c:y val="0.258003865236453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1433360"/>
        <c:crossesAt val="1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9134209411345104"/>
          <c:y val="6.0226910598235296E-2"/>
          <c:w val="0.26938774119312148"/>
          <c:h val="9.90516838592284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/>
              <a:t>Field Trial 2018 - TAG Profile</a:t>
            </a:r>
            <a:endParaRPr lang="en-GB" sz="1600"/>
          </a:p>
        </c:rich>
      </c:tx>
      <c:layout>
        <c:manualLayout>
          <c:xMode val="edge"/>
          <c:yMode val="edge"/>
          <c:x val="0.62423353435335627"/>
          <c:y val="5.34554878723260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6169646854343877E-2"/>
          <c:y val="3.8526155021000388E-2"/>
          <c:w val="0.93156725392603512"/>
          <c:h val="0.740880542853105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10'!$C$3</c:f>
              <c:strCache>
                <c:ptCount val="1"/>
                <c:pt idx="0">
                  <c:v>DHA2015.1</c:v>
                </c:pt>
              </c:strCache>
            </c:strRef>
          </c:tx>
          <c:spPr>
            <a:solidFill>
              <a:srgbClr val="18377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10'!$F$4:$F$75</c:f>
                <c:numCache>
                  <c:formatCode>General</c:formatCode>
                  <c:ptCount val="72"/>
                  <c:pt idx="0">
                    <c:v>5.0969727447161266E-2</c:v>
                  </c:pt>
                  <c:pt idx="1">
                    <c:v>0.13232872428294556</c:v>
                  </c:pt>
                  <c:pt idx="2">
                    <c:v>7.4843719080312954E-2</c:v>
                  </c:pt>
                  <c:pt idx="3">
                    <c:v>0.22588928919230769</c:v>
                  </c:pt>
                  <c:pt idx="4">
                    <c:v>0.35240644042784575</c:v>
                  </c:pt>
                  <c:pt idx="5">
                    <c:v>0.52267335900657219</c:v>
                  </c:pt>
                  <c:pt idx="6">
                    <c:v>8.9667412779626018E-2</c:v>
                  </c:pt>
                  <c:pt idx="7">
                    <c:v>0.23374191232785629</c:v>
                  </c:pt>
                  <c:pt idx="8">
                    <c:v>1.8077123507386009E-2</c:v>
                  </c:pt>
                  <c:pt idx="9">
                    <c:v>3.3097428798199081E-2</c:v>
                  </c:pt>
                  <c:pt idx="10">
                    <c:v>0.22713251119546898</c:v>
                  </c:pt>
                  <c:pt idx="11">
                    <c:v>0.40281053467042111</c:v>
                  </c:pt>
                  <c:pt idx="12">
                    <c:v>0.34079781671995096</c:v>
                  </c:pt>
                  <c:pt idx="13">
                    <c:v>0.4320985018939717</c:v>
                  </c:pt>
                  <c:pt idx="14">
                    <c:v>0.28139122167728875</c:v>
                  </c:pt>
                  <c:pt idx="15">
                    <c:v>0.38892993784382812</c:v>
                  </c:pt>
                  <c:pt idx="16">
                    <c:v>0.18511330405369222</c:v>
                  </c:pt>
                  <c:pt idx="17">
                    <c:v>8.2290759536398139E-2</c:v>
                  </c:pt>
                  <c:pt idx="18">
                    <c:v>4.0710463847968573E-2</c:v>
                  </c:pt>
                  <c:pt idx="19">
                    <c:v>7.1129089556342659E-2</c:v>
                  </c:pt>
                  <c:pt idx="20">
                    <c:v>4.5162553203112792E-2</c:v>
                  </c:pt>
                  <c:pt idx="21">
                    <c:v>3.6149649865487958E-2</c:v>
                  </c:pt>
                  <c:pt idx="22">
                    <c:v>0.10440427227951743</c:v>
                  </c:pt>
                  <c:pt idx="23">
                    <c:v>0.25445694035542132</c:v>
                  </c:pt>
                  <c:pt idx="24">
                    <c:v>0.54803698527371669</c:v>
                  </c:pt>
                  <c:pt idx="25">
                    <c:v>0.25381333535473732</c:v>
                  </c:pt>
                  <c:pt idx="26">
                    <c:v>0.25524965379467729</c:v>
                  </c:pt>
                  <c:pt idx="27">
                    <c:v>0.29833762925330298</c:v>
                  </c:pt>
                  <c:pt idx="28">
                    <c:v>0.41900324451748899</c:v>
                  </c:pt>
                  <c:pt idx="29">
                    <c:v>0.22621659751483228</c:v>
                  </c:pt>
                  <c:pt idx="30">
                    <c:v>0.14434105219459128</c:v>
                  </c:pt>
                  <c:pt idx="31">
                    <c:v>4.9475932798248107E-2</c:v>
                  </c:pt>
                  <c:pt idx="32">
                    <c:v>2.3388188425076128E-2</c:v>
                  </c:pt>
                  <c:pt idx="33">
                    <c:v>4.9454193783399672E-2</c:v>
                  </c:pt>
                  <c:pt idx="34">
                    <c:v>4.4829683968414497E-2</c:v>
                  </c:pt>
                  <c:pt idx="35">
                    <c:v>0.10506162003711025</c:v>
                  </c:pt>
                  <c:pt idx="36">
                    <c:v>3.3738729112180621E-2</c:v>
                  </c:pt>
                  <c:pt idx="37">
                    <c:v>2.5623768779977459E-2</c:v>
                  </c:pt>
                  <c:pt idx="38">
                    <c:v>0.10083901713937458</c:v>
                  </c:pt>
                  <c:pt idx="39">
                    <c:v>0.1588858892660969</c:v>
                  </c:pt>
                  <c:pt idx="40">
                    <c:v>0.19278623938216688</c:v>
                  </c:pt>
                  <c:pt idx="41">
                    <c:v>0.40477179635077692</c:v>
                  </c:pt>
                  <c:pt idx="42">
                    <c:v>0.42355325444376379</c:v>
                  </c:pt>
                  <c:pt idx="43">
                    <c:v>0.25215997272715968</c:v>
                  </c:pt>
                  <c:pt idx="44">
                    <c:v>7.7790287342761069E-2</c:v>
                  </c:pt>
                  <c:pt idx="45">
                    <c:v>1.7603947583300483E-2</c:v>
                  </c:pt>
                  <c:pt idx="46">
                    <c:v>3.9337061052966936E-2</c:v>
                  </c:pt>
                  <c:pt idx="47">
                    <c:v>4.0357439535268477E-2</c:v>
                  </c:pt>
                  <c:pt idx="48">
                    <c:v>5.8013031666112443E-2</c:v>
                  </c:pt>
                  <c:pt idx="49">
                    <c:v>5.3353151589143243E-2</c:v>
                  </c:pt>
                  <c:pt idx="50">
                    <c:v>0.11969248193506392</c:v>
                  </c:pt>
                  <c:pt idx="51">
                    <c:v>0.20161866947707807</c:v>
                  </c:pt>
                  <c:pt idx="52">
                    <c:v>0.21681733947623416</c:v>
                  </c:pt>
                  <c:pt idx="53">
                    <c:v>0.23902674356529621</c:v>
                  </c:pt>
                  <c:pt idx="54">
                    <c:v>0.35102330524205488</c:v>
                  </c:pt>
                  <c:pt idx="55">
                    <c:v>0.26803652661190924</c:v>
                  </c:pt>
                  <c:pt idx="56">
                    <c:v>0.13636657219903336</c:v>
                  </c:pt>
                  <c:pt idx="57">
                    <c:v>4.6904621401126542E-2</c:v>
                  </c:pt>
                  <c:pt idx="58">
                    <c:v>7.2815923308181346E-2</c:v>
                  </c:pt>
                  <c:pt idx="59">
                    <c:v>0.28203714435257604</c:v>
                  </c:pt>
                  <c:pt idx="60">
                    <c:v>0.29048047993721293</c:v>
                  </c:pt>
                  <c:pt idx="61">
                    <c:v>0.33903944363606053</c:v>
                  </c:pt>
                  <c:pt idx="62">
                    <c:v>0.13930235193459567</c:v>
                  </c:pt>
                  <c:pt idx="63">
                    <c:v>0.12413069963447851</c:v>
                  </c:pt>
                  <c:pt idx="64">
                    <c:v>0.14124978812662056</c:v>
                  </c:pt>
                  <c:pt idx="65">
                    <c:v>9.5589307945236984E-2</c:v>
                  </c:pt>
                  <c:pt idx="66">
                    <c:v>0.13608883508469058</c:v>
                  </c:pt>
                  <c:pt idx="67">
                    <c:v>0.1123684744003423</c:v>
                  </c:pt>
                  <c:pt idx="68">
                    <c:v>0.17785273222843445</c:v>
                  </c:pt>
                  <c:pt idx="69">
                    <c:v>2.7011886528262606E-2</c:v>
                  </c:pt>
                  <c:pt idx="70">
                    <c:v>2.2174924326748658E-2</c:v>
                  </c:pt>
                  <c:pt idx="71">
                    <c:v>0.1049359886892024</c:v>
                  </c:pt>
                </c:numCache>
              </c:numRef>
            </c:plus>
            <c:minus>
              <c:numRef>
                <c:f>'S10'!$F$4:$F$75</c:f>
                <c:numCache>
                  <c:formatCode>General</c:formatCode>
                  <c:ptCount val="72"/>
                  <c:pt idx="0">
                    <c:v>5.0969727447161266E-2</c:v>
                  </c:pt>
                  <c:pt idx="1">
                    <c:v>0.13232872428294556</c:v>
                  </c:pt>
                  <c:pt idx="2">
                    <c:v>7.4843719080312954E-2</c:v>
                  </c:pt>
                  <c:pt idx="3">
                    <c:v>0.22588928919230769</c:v>
                  </c:pt>
                  <c:pt idx="4">
                    <c:v>0.35240644042784575</c:v>
                  </c:pt>
                  <c:pt idx="5">
                    <c:v>0.52267335900657219</c:v>
                  </c:pt>
                  <c:pt idx="6">
                    <c:v>8.9667412779626018E-2</c:v>
                  </c:pt>
                  <c:pt idx="7">
                    <c:v>0.23374191232785629</c:v>
                  </c:pt>
                  <c:pt idx="8">
                    <c:v>1.8077123507386009E-2</c:v>
                  </c:pt>
                  <c:pt idx="9">
                    <c:v>3.3097428798199081E-2</c:v>
                  </c:pt>
                  <c:pt idx="10">
                    <c:v>0.22713251119546898</c:v>
                  </c:pt>
                  <c:pt idx="11">
                    <c:v>0.40281053467042111</c:v>
                  </c:pt>
                  <c:pt idx="12">
                    <c:v>0.34079781671995096</c:v>
                  </c:pt>
                  <c:pt idx="13">
                    <c:v>0.4320985018939717</c:v>
                  </c:pt>
                  <c:pt idx="14">
                    <c:v>0.28139122167728875</c:v>
                  </c:pt>
                  <c:pt idx="15">
                    <c:v>0.38892993784382812</c:v>
                  </c:pt>
                  <c:pt idx="16">
                    <c:v>0.18511330405369222</c:v>
                  </c:pt>
                  <c:pt idx="17">
                    <c:v>8.2290759536398139E-2</c:v>
                  </c:pt>
                  <c:pt idx="18">
                    <c:v>4.0710463847968573E-2</c:v>
                  </c:pt>
                  <c:pt idx="19">
                    <c:v>7.1129089556342659E-2</c:v>
                  </c:pt>
                  <c:pt idx="20">
                    <c:v>4.5162553203112792E-2</c:v>
                  </c:pt>
                  <c:pt idx="21">
                    <c:v>3.6149649865487958E-2</c:v>
                  </c:pt>
                  <c:pt idx="22">
                    <c:v>0.10440427227951743</c:v>
                  </c:pt>
                  <c:pt idx="23">
                    <c:v>0.25445694035542132</c:v>
                  </c:pt>
                  <c:pt idx="24">
                    <c:v>0.54803698527371669</c:v>
                  </c:pt>
                  <c:pt idx="25">
                    <c:v>0.25381333535473732</c:v>
                  </c:pt>
                  <c:pt idx="26">
                    <c:v>0.25524965379467729</c:v>
                  </c:pt>
                  <c:pt idx="27">
                    <c:v>0.29833762925330298</c:v>
                  </c:pt>
                  <c:pt idx="28">
                    <c:v>0.41900324451748899</c:v>
                  </c:pt>
                  <c:pt idx="29">
                    <c:v>0.22621659751483228</c:v>
                  </c:pt>
                  <c:pt idx="30">
                    <c:v>0.14434105219459128</c:v>
                  </c:pt>
                  <c:pt idx="31">
                    <c:v>4.9475932798248107E-2</c:v>
                  </c:pt>
                  <c:pt idx="32">
                    <c:v>2.3388188425076128E-2</c:v>
                  </c:pt>
                  <c:pt idx="33">
                    <c:v>4.9454193783399672E-2</c:v>
                  </c:pt>
                  <c:pt idx="34">
                    <c:v>4.4829683968414497E-2</c:v>
                  </c:pt>
                  <c:pt idx="35">
                    <c:v>0.10506162003711025</c:v>
                  </c:pt>
                  <c:pt idx="36">
                    <c:v>3.3738729112180621E-2</c:v>
                  </c:pt>
                  <c:pt idx="37">
                    <c:v>2.5623768779977459E-2</c:v>
                  </c:pt>
                  <c:pt idx="38">
                    <c:v>0.10083901713937458</c:v>
                  </c:pt>
                  <c:pt idx="39">
                    <c:v>0.1588858892660969</c:v>
                  </c:pt>
                  <c:pt idx="40">
                    <c:v>0.19278623938216688</c:v>
                  </c:pt>
                  <c:pt idx="41">
                    <c:v>0.40477179635077692</c:v>
                  </c:pt>
                  <c:pt idx="42">
                    <c:v>0.42355325444376379</c:v>
                  </c:pt>
                  <c:pt idx="43">
                    <c:v>0.25215997272715968</c:v>
                  </c:pt>
                  <c:pt idx="44">
                    <c:v>7.7790287342761069E-2</c:v>
                  </c:pt>
                  <c:pt idx="45">
                    <c:v>1.7603947583300483E-2</c:v>
                  </c:pt>
                  <c:pt idx="46">
                    <c:v>3.9337061052966936E-2</c:v>
                  </c:pt>
                  <c:pt idx="47">
                    <c:v>4.0357439535268477E-2</c:v>
                  </c:pt>
                  <c:pt idx="48">
                    <c:v>5.8013031666112443E-2</c:v>
                  </c:pt>
                  <c:pt idx="49">
                    <c:v>5.3353151589143243E-2</c:v>
                  </c:pt>
                  <c:pt idx="50">
                    <c:v>0.11969248193506392</c:v>
                  </c:pt>
                  <c:pt idx="51">
                    <c:v>0.20161866947707807</c:v>
                  </c:pt>
                  <c:pt idx="52">
                    <c:v>0.21681733947623416</c:v>
                  </c:pt>
                  <c:pt idx="53">
                    <c:v>0.23902674356529621</c:v>
                  </c:pt>
                  <c:pt idx="54">
                    <c:v>0.35102330524205488</c:v>
                  </c:pt>
                  <c:pt idx="55">
                    <c:v>0.26803652661190924</c:v>
                  </c:pt>
                  <c:pt idx="56">
                    <c:v>0.13636657219903336</c:v>
                  </c:pt>
                  <c:pt idx="57">
                    <c:v>4.6904621401126542E-2</c:v>
                  </c:pt>
                  <c:pt idx="58">
                    <c:v>7.2815923308181346E-2</c:v>
                  </c:pt>
                  <c:pt idx="59">
                    <c:v>0.28203714435257604</c:v>
                  </c:pt>
                  <c:pt idx="60">
                    <c:v>0.29048047993721293</c:v>
                  </c:pt>
                  <c:pt idx="61">
                    <c:v>0.33903944363606053</c:v>
                  </c:pt>
                  <c:pt idx="62">
                    <c:v>0.13930235193459567</c:v>
                  </c:pt>
                  <c:pt idx="63">
                    <c:v>0.12413069963447851</c:v>
                  </c:pt>
                  <c:pt idx="64">
                    <c:v>0.14124978812662056</c:v>
                  </c:pt>
                  <c:pt idx="65">
                    <c:v>9.5589307945236984E-2</c:v>
                  </c:pt>
                  <c:pt idx="66">
                    <c:v>0.13608883508469058</c:v>
                  </c:pt>
                  <c:pt idx="67">
                    <c:v>0.1123684744003423</c:v>
                  </c:pt>
                  <c:pt idx="68">
                    <c:v>0.17785273222843445</c:v>
                  </c:pt>
                  <c:pt idx="69">
                    <c:v>2.7011886528262606E-2</c:v>
                  </c:pt>
                  <c:pt idx="70">
                    <c:v>2.2174924326748658E-2</c:v>
                  </c:pt>
                  <c:pt idx="71">
                    <c:v>0.10493598868920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10'!$B$4:$B$75</c:f>
              <c:strCache>
                <c:ptCount val="72"/>
                <c:pt idx="0">
                  <c:v> 50:1</c:v>
                </c:pt>
                <c:pt idx="1">
                  <c:v> 50:2</c:v>
                </c:pt>
                <c:pt idx="2">
                  <c:v> 50:3</c:v>
                </c:pt>
                <c:pt idx="3">
                  <c:v> 52:2</c:v>
                </c:pt>
                <c:pt idx="4">
                  <c:v> 52:3</c:v>
                </c:pt>
                <c:pt idx="5">
                  <c:v> 52:4</c:v>
                </c:pt>
                <c:pt idx="6">
                  <c:v> 52:5</c:v>
                </c:pt>
                <c:pt idx="7">
                  <c:v> 52:6</c:v>
                </c:pt>
                <c:pt idx="8">
                  <c:v> 52:7</c:v>
                </c:pt>
                <c:pt idx="9">
                  <c:v> 54:1</c:v>
                </c:pt>
                <c:pt idx="10">
                  <c:v> 54:2</c:v>
                </c:pt>
                <c:pt idx="11">
                  <c:v> 54:3</c:v>
                </c:pt>
                <c:pt idx="12">
                  <c:v> 54:4</c:v>
                </c:pt>
                <c:pt idx="13">
                  <c:v> 54:5</c:v>
                </c:pt>
                <c:pt idx="14">
                  <c:v> 54:6</c:v>
                </c:pt>
                <c:pt idx="15">
                  <c:v> 54:7</c:v>
                </c:pt>
                <c:pt idx="16">
                  <c:v> 54:8</c:v>
                </c:pt>
                <c:pt idx="17">
                  <c:v> 54:9</c:v>
                </c:pt>
                <c:pt idx="18">
                  <c:v> 54:10</c:v>
                </c:pt>
                <c:pt idx="19">
                  <c:v> 54:11</c:v>
                </c:pt>
                <c:pt idx="20">
                  <c:v> 54:12</c:v>
                </c:pt>
                <c:pt idx="21">
                  <c:v> 56:1</c:v>
                </c:pt>
                <c:pt idx="22">
                  <c:v> 56:2</c:v>
                </c:pt>
                <c:pt idx="23">
                  <c:v> 56:3</c:v>
                </c:pt>
                <c:pt idx="24">
                  <c:v> 56:4</c:v>
                </c:pt>
                <c:pt idx="25">
                  <c:v> 56:5</c:v>
                </c:pt>
                <c:pt idx="26">
                  <c:v> 56:6</c:v>
                </c:pt>
                <c:pt idx="27">
                  <c:v> 56:7</c:v>
                </c:pt>
                <c:pt idx="28">
                  <c:v> 56:8</c:v>
                </c:pt>
                <c:pt idx="29">
                  <c:v> 56:9</c:v>
                </c:pt>
                <c:pt idx="30">
                  <c:v> 56:10</c:v>
                </c:pt>
                <c:pt idx="31">
                  <c:v> 56:11</c:v>
                </c:pt>
                <c:pt idx="32">
                  <c:v> 56:12</c:v>
                </c:pt>
                <c:pt idx="33">
                  <c:v> 58:2</c:v>
                </c:pt>
                <c:pt idx="34">
                  <c:v> 58:3</c:v>
                </c:pt>
                <c:pt idx="35">
                  <c:v> 58:4</c:v>
                </c:pt>
                <c:pt idx="36">
                  <c:v> 58:5</c:v>
                </c:pt>
                <c:pt idx="37">
                  <c:v> 58:6</c:v>
                </c:pt>
                <c:pt idx="38">
                  <c:v> 58:7</c:v>
                </c:pt>
                <c:pt idx="39">
                  <c:v> 58:8</c:v>
                </c:pt>
                <c:pt idx="40">
                  <c:v> 58:9</c:v>
                </c:pt>
                <c:pt idx="41">
                  <c:v> 58:10</c:v>
                </c:pt>
                <c:pt idx="42">
                  <c:v> 58:11</c:v>
                </c:pt>
                <c:pt idx="43">
                  <c:v> 58:12</c:v>
                </c:pt>
                <c:pt idx="44">
                  <c:v> 58:13</c:v>
                </c:pt>
                <c:pt idx="45">
                  <c:v> 60:3</c:v>
                </c:pt>
                <c:pt idx="46">
                  <c:v> 60:4</c:v>
                </c:pt>
                <c:pt idx="47">
                  <c:v> 60:5</c:v>
                </c:pt>
                <c:pt idx="48">
                  <c:v> 60:6</c:v>
                </c:pt>
                <c:pt idx="49">
                  <c:v> 60:7</c:v>
                </c:pt>
                <c:pt idx="50">
                  <c:v> 60:8</c:v>
                </c:pt>
                <c:pt idx="51">
                  <c:v> 60:9</c:v>
                </c:pt>
                <c:pt idx="52">
                  <c:v> 60:10</c:v>
                </c:pt>
                <c:pt idx="53">
                  <c:v> 60:11</c:v>
                </c:pt>
                <c:pt idx="54">
                  <c:v> 60:12</c:v>
                </c:pt>
                <c:pt idx="55">
                  <c:v> 60:13</c:v>
                </c:pt>
                <c:pt idx="56">
                  <c:v> 60:14</c:v>
                </c:pt>
                <c:pt idx="57">
                  <c:v> 60:15</c:v>
                </c:pt>
                <c:pt idx="58">
                  <c:v> 62:11</c:v>
                </c:pt>
                <c:pt idx="59">
                  <c:v> 62:12</c:v>
                </c:pt>
                <c:pt idx="60">
                  <c:v> 62:13</c:v>
                </c:pt>
                <c:pt idx="61">
                  <c:v> 62:14</c:v>
                </c:pt>
                <c:pt idx="62">
                  <c:v> 62:15</c:v>
                </c:pt>
                <c:pt idx="63">
                  <c:v> 62:16</c:v>
                </c:pt>
                <c:pt idx="64">
                  <c:v> 64:13</c:v>
                </c:pt>
                <c:pt idx="65">
                  <c:v> 64:14</c:v>
                </c:pt>
                <c:pt idx="66">
                  <c:v> 64:15</c:v>
                </c:pt>
                <c:pt idx="67">
                  <c:v> 64:16</c:v>
                </c:pt>
                <c:pt idx="68">
                  <c:v> 64:17</c:v>
                </c:pt>
                <c:pt idx="69">
                  <c:v> 66:16</c:v>
                </c:pt>
                <c:pt idx="70">
                  <c:v> 66:17</c:v>
                </c:pt>
                <c:pt idx="71">
                  <c:v> 66:18</c:v>
                </c:pt>
              </c:strCache>
            </c:strRef>
          </c:cat>
          <c:val>
            <c:numRef>
              <c:f>'S10'!$C$4:$C$75</c:f>
              <c:numCache>
                <c:formatCode>General</c:formatCode>
                <c:ptCount val="72"/>
                <c:pt idx="0">
                  <c:v>0.10017326944068773</c:v>
                </c:pt>
                <c:pt idx="1">
                  <c:v>0.43204070556597357</c:v>
                </c:pt>
                <c:pt idx="2">
                  <c:v>0.28226133357146499</c:v>
                </c:pt>
                <c:pt idx="3">
                  <c:v>1.1062550896296808</c:v>
                </c:pt>
                <c:pt idx="4">
                  <c:v>1.3194641756072267</c:v>
                </c:pt>
                <c:pt idx="5">
                  <c:v>2.6053811523434116</c:v>
                </c:pt>
                <c:pt idx="6">
                  <c:v>1.1607626555812247</c:v>
                </c:pt>
                <c:pt idx="7">
                  <c:v>1.3255510030332374</c:v>
                </c:pt>
                <c:pt idx="8">
                  <c:v>5.7214556164397412E-2</c:v>
                </c:pt>
                <c:pt idx="9">
                  <c:v>8.5815016045884596E-2</c:v>
                </c:pt>
                <c:pt idx="10">
                  <c:v>1.1401699614813123</c:v>
                </c:pt>
                <c:pt idx="11">
                  <c:v>2.7262103683418561</c:v>
                </c:pt>
                <c:pt idx="12">
                  <c:v>3.4742190863418458</c:v>
                </c:pt>
                <c:pt idx="13">
                  <c:v>3.9916569443986201</c:v>
                </c:pt>
                <c:pt idx="14">
                  <c:v>3.5124546355362729</c:v>
                </c:pt>
                <c:pt idx="15">
                  <c:v>2.4948575270323552</c:v>
                </c:pt>
                <c:pt idx="16">
                  <c:v>1.3680382646154159</c:v>
                </c:pt>
                <c:pt idx="17">
                  <c:v>0.44050705401321544</c:v>
                </c:pt>
                <c:pt idx="18">
                  <c:v>7.8128163821799643E-2</c:v>
                </c:pt>
                <c:pt idx="19">
                  <c:v>0.1997074798330242</c:v>
                </c:pt>
                <c:pt idx="20">
                  <c:v>0.12784554064651496</c:v>
                </c:pt>
                <c:pt idx="21">
                  <c:v>8.1305669711863052E-2</c:v>
                </c:pt>
                <c:pt idx="22">
                  <c:v>0.41514632280207436</c:v>
                </c:pt>
                <c:pt idx="23">
                  <c:v>1.8984402516437555</c:v>
                </c:pt>
                <c:pt idx="24">
                  <c:v>3.5758374534251018</c:v>
                </c:pt>
                <c:pt idx="25">
                  <c:v>5.6496979990437088</c:v>
                </c:pt>
                <c:pt idx="26">
                  <c:v>5.6556482991322534</c:v>
                </c:pt>
                <c:pt idx="27">
                  <c:v>4.3090382501531215</c:v>
                </c:pt>
                <c:pt idx="28">
                  <c:v>4.1580308496990481</c:v>
                </c:pt>
                <c:pt idx="29">
                  <c:v>2.5782071726204379</c:v>
                </c:pt>
                <c:pt idx="30">
                  <c:v>1.2213470329162572</c:v>
                </c:pt>
                <c:pt idx="31">
                  <c:v>0.27713744530655271</c:v>
                </c:pt>
                <c:pt idx="32">
                  <c:v>0.10532681504640327</c:v>
                </c:pt>
                <c:pt idx="33">
                  <c:v>0.25403145209141559</c:v>
                </c:pt>
                <c:pt idx="34">
                  <c:v>0.71429174106942928</c:v>
                </c:pt>
                <c:pt idx="35">
                  <c:v>0.9578702723329332</c:v>
                </c:pt>
                <c:pt idx="36">
                  <c:v>1.2413834921246236</c:v>
                </c:pt>
                <c:pt idx="37">
                  <c:v>1.4835789869146392</c:v>
                </c:pt>
                <c:pt idx="38">
                  <c:v>2.5540529541189136</c:v>
                </c:pt>
                <c:pt idx="39">
                  <c:v>3.1434694345716454</c:v>
                </c:pt>
                <c:pt idx="40">
                  <c:v>3.5911650034378599</c:v>
                </c:pt>
                <c:pt idx="41">
                  <c:v>4.5746224326374065</c:v>
                </c:pt>
                <c:pt idx="42">
                  <c:v>4.2535546716294226</c:v>
                </c:pt>
                <c:pt idx="43">
                  <c:v>1.7902860792882249</c:v>
                </c:pt>
                <c:pt idx="44">
                  <c:v>0.32330018095021934</c:v>
                </c:pt>
                <c:pt idx="45">
                  <c:v>0.11567696333753202</c:v>
                </c:pt>
                <c:pt idx="46">
                  <c:v>9.7587489329018062E-2</c:v>
                </c:pt>
                <c:pt idx="47">
                  <c:v>0.17125523547660479</c:v>
                </c:pt>
                <c:pt idx="48">
                  <c:v>0.242417606254552</c:v>
                </c:pt>
                <c:pt idx="49">
                  <c:v>0.42350427892128201</c:v>
                </c:pt>
                <c:pt idx="50">
                  <c:v>0.62820533459614492</c:v>
                </c:pt>
                <c:pt idx="51">
                  <c:v>1.29672368650533</c:v>
                </c:pt>
                <c:pt idx="52">
                  <c:v>1.6573604925163232</c:v>
                </c:pt>
                <c:pt idx="53">
                  <c:v>1.8609840074242305</c:v>
                </c:pt>
                <c:pt idx="54">
                  <c:v>1.3696555460784008</c:v>
                </c:pt>
                <c:pt idx="55">
                  <c:v>0.81334675869433204</c:v>
                </c:pt>
                <c:pt idx="56">
                  <c:v>0.58723383972741983</c:v>
                </c:pt>
                <c:pt idx="57">
                  <c:v>0.1072561091257959</c:v>
                </c:pt>
                <c:pt idx="58">
                  <c:v>0.35639521366871724</c:v>
                </c:pt>
                <c:pt idx="59">
                  <c:v>0.56789054656971782</c:v>
                </c:pt>
                <c:pt idx="60">
                  <c:v>1.1223978599648696</c:v>
                </c:pt>
                <c:pt idx="61">
                  <c:v>1.7076425858162796</c:v>
                </c:pt>
                <c:pt idx="62">
                  <c:v>0.8384864367442848</c:v>
                </c:pt>
                <c:pt idx="63">
                  <c:v>0.20433362487436021</c:v>
                </c:pt>
                <c:pt idx="64">
                  <c:v>0.24394778617692295</c:v>
                </c:pt>
                <c:pt idx="65">
                  <c:v>0.1762444769545084</c:v>
                </c:pt>
                <c:pt idx="66">
                  <c:v>0.23008549582604809</c:v>
                </c:pt>
                <c:pt idx="67">
                  <c:v>0.40686863537717738</c:v>
                </c:pt>
                <c:pt idx="68">
                  <c:v>0.31485247725699966</c:v>
                </c:pt>
                <c:pt idx="69">
                  <c:v>0.11452235237884323</c:v>
                </c:pt>
                <c:pt idx="70">
                  <c:v>0.20180160505303049</c:v>
                </c:pt>
                <c:pt idx="71">
                  <c:v>0.35227287024820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3E-4E72-8920-CE5C37577880}"/>
            </c:ext>
          </c:extLst>
        </c:ser>
        <c:ser>
          <c:idx val="1"/>
          <c:order val="1"/>
          <c:tx>
            <c:strRef>
              <c:f>'S10'!$D$3</c:f>
              <c:strCache>
                <c:ptCount val="1"/>
                <c:pt idx="0">
                  <c:v>DHA2015.5</c:v>
                </c:pt>
              </c:strCache>
            </c:strRef>
          </c:tx>
          <c:spPr>
            <a:solidFill>
              <a:srgbClr val="D8DFFB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10'!$G$4:$G$75</c:f>
                <c:numCache>
                  <c:formatCode>General</c:formatCode>
                  <c:ptCount val="72"/>
                  <c:pt idx="0">
                    <c:v>2.8233999894388784E-2</c:v>
                  </c:pt>
                  <c:pt idx="1">
                    <c:v>8.8185573205749573E-2</c:v>
                  </c:pt>
                  <c:pt idx="2">
                    <c:v>0.11164580742421293</c:v>
                  </c:pt>
                  <c:pt idx="3">
                    <c:v>0.18717956248290607</c:v>
                  </c:pt>
                  <c:pt idx="4">
                    <c:v>0.29448037686163125</c:v>
                  </c:pt>
                  <c:pt idx="5">
                    <c:v>0.42155705589009057</c:v>
                  </c:pt>
                  <c:pt idx="6">
                    <c:v>0.88881165120382888</c:v>
                  </c:pt>
                  <c:pt idx="7">
                    <c:v>0.38482632530533112</c:v>
                  </c:pt>
                  <c:pt idx="8">
                    <c:v>5.2874169276101571E-2</c:v>
                  </c:pt>
                  <c:pt idx="9">
                    <c:v>1.6073164415821458E-2</c:v>
                  </c:pt>
                  <c:pt idx="10">
                    <c:v>0.13518966460896648</c:v>
                  </c:pt>
                  <c:pt idx="11">
                    <c:v>0.22093580941082286</c:v>
                  </c:pt>
                  <c:pt idx="12">
                    <c:v>0.32006404118064735</c:v>
                  </c:pt>
                  <c:pt idx="13">
                    <c:v>0.40715552636240065</c:v>
                  </c:pt>
                  <c:pt idx="14">
                    <c:v>0.32583418576393547</c:v>
                  </c:pt>
                  <c:pt idx="15">
                    <c:v>0.26156076162979369</c:v>
                  </c:pt>
                  <c:pt idx="16">
                    <c:v>0.18522342556416677</c:v>
                  </c:pt>
                  <c:pt idx="17">
                    <c:v>6.5983288435447637E-2</c:v>
                  </c:pt>
                  <c:pt idx="18">
                    <c:v>2.861270801892114E-2</c:v>
                  </c:pt>
                  <c:pt idx="19">
                    <c:v>6.0258914672928376E-2</c:v>
                  </c:pt>
                  <c:pt idx="20">
                    <c:v>6.8619380153749868E-2</c:v>
                  </c:pt>
                  <c:pt idx="21">
                    <c:v>4.4904859957751751E-2</c:v>
                  </c:pt>
                  <c:pt idx="22">
                    <c:v>0.12114114580481919</c:v>
                  </c:pt>
                  <c:pt idx="23">
                    <c:v>0.19951323091309539</c:v>
                  </c:pt>
                  <c:pt idx="24">
                    <c:v>0.44511233868437677</c:v>
                  </c:pt>
                  <c:pt idx="25">
                    <c:v>0.43803114747128274</c:v>
                  </c:pt>
                  <c:pt idx="26">
                    <c:v>0.21802855989377137</c:v>
                  </c:pt>
                  <c:pt idx="27">
                    <c:v>0.33065658639928414</c:v>
                  </c:pt>
                  <c:pt idx="28">
                    <c:v>0.24784093311541189</c:v>
                  </c:pt>
                  <c:pt idx="29">
                    <c:v>0.34924160270017046</c:v>
                  </c:pt>
                  <c:pt idx="30">
                    <c:v>9.900829586536726E-2</c:v>
                  </c:pt>
                  <c:pt idx="31">
                    <c:v>5.2897700060765836E-2</c:v>
                  </c:pt>
                  <c:pt idx="32">
                    <c:v>4.7646938129491917E-2</c:v>
                  </c:pt>
                  <c:pt idx="33">
                    <c:v>6.5745220145438973E-2</c:v>
                  </c:pt>
                  <c:pt idx="34">
                    <c:v>0.12421072912512368</c:v>
                  </c:pt>
                  <c:pt idx="35">
                    <c:v>0.13246130983041407</c:v>
                  </c:pt>
                  <c:pt idx="36">
                    <c:v>0.11927273591476459</c:v>
                  </c:pt>
                  <c:pt idx="37">
                    <c:v>0.14289153603675542</c:v>
                  </c:pt>
                  <c:pt idx="38">
                    <c:v>0.12534987673772796</c:v>
                  </c:pt>
                  <c:pt idx="39">
                    <c:v>0.11908461572923752</c:v>
                  </c:pt>
                  <c:pt idx="40">
                    <c:v>0.23802950387598074</c:v>
                  </c:pt>
                  <c:pt idx="41">
                    <c:v>0.48410176563772167</c:v>
                  </c:pt>
                  <c:pt idx="42">
                    <c:v>0.79563338103311687</c:v>
                  </c:pt>
                  <c:pt idx="43">
                    <c:v>0.37258692137740568</c:v>
                  </c:pt>
                  <c:pt idx="44">
                    <c:v>0.12777558538917055</c:v>
                  </c:pt>
                  <c:pt idx="45">
                    <c:v>3.6625624240317955E-2</c:v>
                  </c:pt>
                  <c:pt idx="46">
                    <c:v>7.2946351390054828E-2</c:v>
                  </c:pt>
                  <c:pt idx="47">
                    <c:v>5.6093306402290238E-2</c:v>
                  </c:pt>
                  <c:pt idx="48">
                    <c:v>5.8810541301715993E-2</c:v>
                  </c:pt>
                  <c:pt idx="49">
                    <c:v>7.643524543682588E-2</c:v>
                  </c:pt>
                  <c:pt idx="50">
                    <c:v>7.974796662973678E-2</c:v>
                  </c:pt>
                  <c:pt idx="51">
                    <c:v>0.18756766140018646</c:v>
                  </c:pt>
                  <c:pt idx="52">
                    <c:v>0.34865010831447035</c:v>
                  </c:pt>
                  <c:pt idx="53">
                    <c:v>0.33638230908227684</c:v>
                  </c:pt>
                  <c:pt idx="54">
                    <c:v>0.51193171312306318</c:v>
                  </c:pt>
                  <c:pt idx="55">
                    <c:v>0.1662329488641161</c:v>
                  </c:pt>
                  <c:pt idx="56">
                    <c:v>0.21144814054232905</c:v>
                  </c:pt>
                  <c:pt idx="57">
                    <c:v>2.6633106636843259E-2</c:v>
                  </c:pt>
                  <c:pt idx="58">
                    <c:v>7.1502568369649064E-2</c:v>
                  </c:pt>
                  <c:pt idx="59">
                    <c:v>0.18483962600108464</c:v>
                  </c:pt>
                  <c:pt idx="60">
                    <c:v>0.30111539721624936</c:v>
                  </c:pt>
                  <c:pt idx="61">
                    <c:v>0.52798145981679534</c:v>
                  </c:pt>
                  <c:pt idx="62">
                    <c:v>0.29091681038675488</c:v>
                  </c:pt>
                  <c:pt idx="63">
                    <c:v>8.291140815588402E-2</c:v>
                  </c:pt>
                  <c:pt idx="64">
                    <c:v>0.13518089922867793</c:v>
                  </c:pt>
                  <c:pt idx="65">
                    <c:v>8.0125478901226704E-2</c:v>
                  </c:pt>
                  <c:pt idx="66">
                    <c:v>0.1124081381105574</c:v>
                  </c:pt>
                  <c:pt idx="67">
                    <c:v>0.10482564903166935</c:v>
                  </c:pt>
                  <c:pt idx="68">
                    <c:v>0.13263821375432511</c:v>
                  </c:pt>
                  <c:pt idx="69">
                    <c:v>3.5387368311419844E-2</c:v>
                  </c:pt>
                  <c:pt idx="70">
                    <c:v>9.6947130055148281E-2</c:v>
                  </c:pt>
                  <c:pt idx="71">
                    <c:v>0.11446093395338466</c:v>
                  </c:pt>
                </c:numCache>
              </c:numRef>
            </c:plus>
            <c:minus>
              <c:numRef>
                <c:f>'S10'!$G$4:$G$75</c:f>
                <c:numCache>
                  <c:formatCode>General</c:formatCode>
                  <c:ptCount val="72"/>
                  <c:pt idx="0">
                    <c:v>2.8233999894388784E-2</c:v>
                  </c:pt>
                  <c:pt idx="1">
                    <c:v>8.8185573205749573E-2</c:v>
                  </c:pt>
                  <c:pt idx="2">
                    <c:v>0.11164580742421293</c:v>
                  </c:pt>
                  <c:pt idx="3">
                    <c:v>0.18717956248290607</c:v>
                  </c:pt>
                  <c:pt idx="4">
                    <c:v>0.29448037686163125</c:v>
                  </c:pt>
                  <c:pt idx="5">
                    <c:v>0.42155705589009057</c:v>
                  </c:pt>
                  <c:pt idx="6">
                    <c:v>0.88881165120382888</c:v>
                  </c:pt>
                  <c:pt idx="7">
                    <c:v>0.38482632530533112</c:v>
                  </c:pt>
                  <c:pt idx="8">
                    <c:v>5.2874169276101571E-2</c:v>
                  </c:pt>
                  <c:pt idx="9">
                    <c:v>1.6073164415821458E-2</c:v>
                  </c:pt>
                  <c:pt idx="10">
                    <c:v>0.13518966460896648</c:v>
                  </c:pt>
                  <c:pt idx="11">
                    <c:v>0.22093580941082286</c:v>
                  </c:pt>
                  <c:pt idx="12">
                    <c:v>0.32006404118064735</c:v>
                  </c:pt>
                  <c:pt idx="13">
                    <c:v>0.40715552636240065</c:v>
                  </c:pt>
                  <c:pt idx="14">
                    <c:v>0.32583418576393547</c:v>
                  </c:pt>
                  <c:pt idx="15">
                    <c:v>0.26156076162979369</c:v>
                  </c:pt>
                  <c:pt idx="16">
                    <c:v>0.18522342556416677</c:v>
                  </c:pt>
                  <c:pt idx="17">
                    <c:v>6.5983288435447637E-2</c:v>
                  </c:pt>
                  <c:pt idx="18">
                    <c:v>2.861270801892114E-2</c:v>
                  </c:pt>
                  <c:pt idx="19">
                    <c:v>6.0258914672928376E-2</c:v>
                  </c:pt>
                  <c:pt idx="20">
                    <c:v>6.8619380153749868E-2</c:v>
                  </c:pt>
                  <c:pt idx="21">
                    <c:v>4.4904859957751751E-2</c:v>
                  </c:pt>
                  <c:pt idx="22">
                    <c:v>0.12114114580481919</c:v>
                  </c:pt>
                  <c:pt idx="23">
                    <c:v>0.19951323091309539</c:v>
                  </c:pt>
                  <c:pt idx="24">
                    <c:v>0.44511233868437677</c:v>
                  </c:pt>
                  <c:pt idx="25">
                    <c:v>0.43803114747128274</c:v>
                  </c:pt>
                  <c:pt idx="26">
                    <c:v>0.21802855989377137</c:v>
                  </c:pt>
                  <c:pt idx="27">
                    <c:v>0.33065658639928414</c:v>
                  </c:pt>
                  <c:pt idx="28">
                    <c:v>0.24784093311541189</c:v>
                  </c:pt>
                  <c:pt idx="29">
                    <c:v>0.34924160270017046</c:v>
                  </c:pt>
                  <c:pt idx="30">
                    <c:v>9.900829586536726E-2</c:v>
                  </c:pt>
                  <c:pt idx="31">
                    <c:v>5.2897700060765836E-2</c:v>
                  </c:pt>
                  <c:pt idx="32">
                    <c:v>4.7646938129491917E-2</c:v>
                  </c:pt>
                  <c:pt idx="33">
                    <c:v>6.5745220145438973E-2</c:v>
                  </c:pt>
                  <c:pt idx="34">
                    <c:v>0.12421072912512368</c:v>
                  </c:pt>
                  <c:pt idx="35">
                    <c:v>0.13246130983041407</c:v>
                  </c:pt>
                  <c:pt idx="36">
                    <c:v>0.11927273591476459</c:v>
                  </c:pt>
                  <c:pt idx="37">
                    <c:v>0.14289153603675542</c:v>
                  </c:pt>
                  <c:pt idx="38">
                    <c:v>0.12534987673772796</c:v>
                  </c:pt>
                  <c:pt idx="39">
                    <c:v>0.11908461572923752</c:v>
                  </c:pt>
                  <c:pt idx="40">
                    <c:v>0.23802950387598074</c:v>
                  </c:pt>
                  <c:pt idx="41">
                    <c:v>0.48410176563772167</c:v>
                  </c:pt>
                  <c:pt idx="42">
                    <c:v>0.79563338103311687</c:v>
                  </c:pt>
                  <c:pt idx="43">
                    <c:v>0.37258692137740568</c:v>
                  </c:pt>
                  <c:pt idx="44">
                    <c:v>0.12777558538917055</c:v>
                  </c:pt>
                  <c:pt idx="45">
                    <c:v>3.6625624240317955E-2</c:v>
                  </c:pt>
                  <c:pt idx="46">
                    <c:v>7.2946351390054828E-2</c:v>
                  </c:pt>
                  <c:pt idx="47">
                    <c:v>5.6093306402290238E-2</c:v>
                  </c:pt>
                  <c:pt idx="48">
                    <c:v>5.8810541301715993E-2</c:v>
                  </c:pt>
                  <c:pt idx="49">
                    <c:v>7.643524543682588E-2</c:v>
                  </c:pt>
                  <c:pt idx="50">
                    <c:v>7.974796662973678E-2</c:v>
                  </c:pt>
                  <c:pt idx="51">
                    <c:v>0.18756766140018646</c:v>
                  </c:pt>
                  <c:pt idx="52">
                    <c:v>0.34865010831447035</c:v>
                  </c:pt>
                  <c:pt idx="53">
                    <c:v>0.33638230908227684</c:v>
                  </c:pt>
                  <c:pt idx="54">
                    <c:v>0.51193171312306318</c:v>
                  </c:pt>
                  <c:pt idx="55">
                    <c:v>0.1662329488641161</c:v>
                  </c:pt>
                  <c:pt idx="56">
                    <c:v>0.21144814054232905</c:v>
                  </c:pt>
                  <c:pt idx="57">
                    <c:v>2.6633106636843259E-2</c:v>
                  </c:pt>
                  <c:pt idx="58">
                    <c:v>7.1502568369649064E-2</c:v>
                  </c:pt>
                  <c:pt idx="59">
                    <c:v>0.18483962600108464</c:v>
                  </c:pt>
                  <c:pt idx="60">
                    <c:v>0.30111539721624936</c:v>
                  </c:pt>
                  <c:pt idx="61">
                    <c:v>0.52798145981679534</c:v>
                  </c:pt>
                  <c:pt idx="62">
                    <c:v>0.29091681038675488</c:v>
                  </c:pt>
                  <c:pt idx="63">
                    <c:v>8.291140815588402E-2</c:v>
                  </c:pt>
                  <c:pt idx="64">
                    <c:v>0.13518089922867793</c:v>
                  </c:pt>
                  <c:pt idx="65">
                    <c:v>8.0125478901226704E-2</c:v>
                  </c:pt>
                  <c:pt idx="66">
                    <c:v>0.1124081381105574</c:v>
                  </c:pt>
                  <c:pt idx="67">
                    <c:v>0.10482564903166935</c:v>
                  </c:pt>
                  <c:pt idx="68">
                    <c:v>0.13263821375432511</c:v>
                  </c:pt>
                  <c:pt idx="69">
                    <c:v>3.5387368311419844E-2</c:v>
                  </c:pt>
                  <c:pt idx="70">
                    <c:v>9.6947130055148281E-2</c:v>
                  </c:pt>
                  <c:pt idx="71">
                    <c:v>0.114460933953384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10'!$B$4:$B$75</c:f>
              <c:strCache>
                <c:ptCount val="72"/>
                <c:pt idx="0">
                  <c:v> 50:1</c:v>
                </c:pt>
                <c:pt idx="1">
                  <c:v> 50:2</c:v>
                </c:pt>
                <c:pt idx="2">
                  <c:v> 50:3</c:v>
                </c:pt>
                <c:pt idx="3">
                  <c:v> 52:2</c:v>
                </c:pt>
                <c:pt idx="4">
                  <c:v> 52:3</c:v>
                </c:pt>
                <c:pt idx="5">
                  <c:v> 52:4</c:v>
                </c:pt>
                <c:pt idx="6">
                  <c:v> 52:5</c:v>
                </c:pt>
                <c:pt idx="7">
                  <c:v> 52:6</c:v>
                </c:pt>
                <c:pt idx="8">
                  <c:v> 52:7</c:v>
                </c:pt>
                <c:pt idx="9">
                  <c:v> 54:1</c:v>
                </c:pt>
                <c:pt idx="10">
                  <c:v> 54:2</c:v>
                </c:pt>
                <c:pt idx="11">
                  <c:v> 54:3</c:v>
                </c:pt>
                <c:pt idx="12">
                  <c:v> 54:4</c:v>
                </c:pt>
                <c:pt idx="13">
                  <c:v> 54:5</c:v>
                </c:pt>
                <c:pt idx="14">
                  <c:v> 54:6</c:v>
                </c:pt>
                <c:pt idx="15">
                  <c:v> 54:7</c:v>
                </c:pt>
                <c:pt idx="16">
                  <c:v> 54:8</c:v>
                </c:pt>
                <c:pt idx="17">
                  <c:v> 54:9</c:v>
                </c:pt>
                <c:pt idx="18">
                  <c:v> 54:10</c:v>
                </c:pt>
                <c:pt idx="19">
                  <c:v> 54:11</c:v>
                </c:pt>
                <c:pt idx="20">
                  <c:v> 54:12</c:v>
                </c:pt>
                <c:pt idx="21">
                  <c:v> 56:1</c:v>
                </c:pt>
                <c:pt idx="22">
                  <c:v> 56:2</c:v>
                </c:pt>
                <c:pt idx="23">
                  <c:v> 56:3</c:v>
                </c:pt>
                <c:pt idx="24">
                  <c:v> 56:4</c:v>
                </c:pt>
                <c:pt idx="25">
                  <c:v> 56:5</c:v>
                </c:pt>
                <c:pt idx="26">
                  <c:v> 56:6</c:v>
                </c:pt>
                <c:pt idx="27">
                  <c:v> 56:7</c:v>
                </c:pt>
                <c:pt idx="28">
                  <c:v> 56:8</c:v>
                </c:pt>
                <c:pt idx="29">
                  <c:v> 56:9</c:v>
                </c:pt>
                <c:pt idx="30">
                  <c:v> 56:10</c:v>
                </c:pt>
                <c:pt idx="31">
                  <c:v> 56:11</c:v>
                </c:pt>
                <c:pt idx="32">
                  <c:v> 56:12</c:v>
                </c:pt>
                <c:pt idx="33">
                  <c:v> 58:2</c:v>
                </c:pt>
                <c:pt idx="34">
                  <c:v> 58:3</c:v>
                </c:pt>
                <c:pt idx="35">
                  <c:v> 58:4</c:v>
                </c:pt>
                <c:pt idx="36">
                  <c:v> 58:5</c:v>
                </c:pt>
                <c:pt idx="37">
                  <c:v> 58:6</c:v>
                </c:pt>
                <c:pt idx="38">
                  <c:v> 58:7</c:v>
                </c:pt>
                <c:pt idx="39">
                  <c:v> 58:8</c:v>
                </c:pt>
                <c:pt idx="40">
                  <c:v> 58:9</c:v>
                </c:pt>
                <c:pt idx="41">
                  <c:v> 58:10</c:v>
                </c:pt>
                <c:pt idx="42">
                  <c:v> 58:11</c:v>
                </c:pt>
                <c:pt idx="43">
                  <c:v> 58:12</c:v>
                </c:pt>
                <c:pt idx="44">
                  <c:v> 58:13</c:v>
                </c:pt>
                <c:pt idx="45">
                  <c:v> 60:3</c:v>
                </c:pt>
                <c:pt idx="46">
                  <c:v> 60:4</c:v>
                </c:pt>
                <c:pt idx="47">
                  <c:v> 60:5</c:v>
                </c:pt>
                <c:pt idx="48">
                  <c:v> 60:6</c:v>
                </c:pt>
                <c:pt idx="49">
                  <c:v> 60:7</c:v>
                </c:pt>
                <c:pt idx="50">
                  <c:v> 60:8</c:v>
                </c:pt>
                <c:pt idx="51">
                  <c:v> 60:9</c:v>
                </c:pt>
                <c:pt idx="52">
                  <c:v> 60:10</c:v>
                </c:pt>
                <c:pt idx="53">
                  <c:v> 60:11</c:v>
                </c:pt>
                <c:pt idx="54">
                  <c:v> 60:12</c:v>
                </c:pt>
                <c:pt idx="55">
                  <c:v> 60:13</c:v>
                </c:pt>
                <c:pt idx="56">
                  <c:v> 60:14</c:v>
                </c:pt>
                <c:pt idx="57">
                  <c:v> 60:15</c:v>
                </c:pt>
                <c:pt idx="58">
                  <c:v> 62:11</c:v>
                </c:pt>
                <c:pt idx="59">
                  <c:v> 62:12</c:v>
                </c:pt>
                <c:pt idx="60">
                  <c:v> 62:13</c:v>
                </c:pt>
                <c:pt idx="61">
                  <c:v> 62:14</c:v>
                </c:pt>
                <c:pt idx="62">
                  <c:v> 62:15</c:v>
                </c:pt>
                <c:pt idx="63">
                  <c:v> 62:16</c:v>
                </c:pt>
                <c:pt idx="64">
                  <c:v> 64:13</c:v>
                </c:pt>
                <c:pt idx="65">
                  <c:v> 64:14</c:v>
                </c:pt>
                <c:pt idx="66">
                  <c:v> 64:15</c:v>
                </c:pt>
                <c:pt idx="67">
                  <c:v> 64:16</c:v>
                </c:pt>
                <c:pt idx="68">
                  <c:v> 64:17</c:v>
                </c:pt>
                <c:pt idx="69">
                  <c:v> 66:16</c:v>
                </c:pt>
                <c:pt idx="70">
                  <c:v> 66:17</c:v>
                </c:pt>
                <c:pt idx="71">
                  <c:v> 66:18</c:v>
                </c:pt>
              </c:strCache>
            </c:strRef>
          </c:cat>
          <c:val>
            <c:numRef>
              <c:f>'S10'!$D$4:$D$75</c:f>
              <c:numCache>
                <c:formatCode>General</c:formatCode>
                <c:ptCount val="72"/>
                <c:pt idx="0">
                  <c:v>0.13806419947580464</c:v>
                </c:pt>
                <c:pt idx="1">
                  <c:v>0.43001141291905659</c:v>
                </c:pt>
                <c:pt idx="2">
                  <c:v>0.39100710269635935</c:v>
                </c:pt>
                <c:pt idx="3">
                  <c:v>1.1213508204189211</c:v>
                </c:pt>
                <c:pt idx="4">
                  <c:v>1.4705875254297289</c:v>
                </c:pt>
                <c:pt idx="5">
                  <c:v>2.5787179393351392</c:v>
                </c:pt>
                <c:pt idx="6">
                  <c:v>2.9637976631990344</c:v>
                </c:pt>
                <c:pt idx="7">
                  <c:v>2.372852061535538</c:v>
                </c:pt>
                <c:pt idx="8">
                  <c:v>0.21597096971019203</c:v>
                </c:pt>
                <c:pt idx="9">
                  <c:v>9.8661753737611879E-2</c:v>
                </c:pt>
                <c:pt idx="10">
                  <c:v>0.93626362718627798</c:v>
                </c:pt>
                <c:pt idx="11">
                  <c:v>2.2788606203351369</c:v>
                </c:pt>
                <c:pt idx="12">
                  <c:v>3.2032796982840943</c:v>
                </c:pt>
                <c:pt idx="13">
                  <c:v>3.9916505764891705</c:v>
                </c:pt>
                <c:pt idx="14">
                  <c:v>3.61991207187558</c:v>
                </c:pt>
                <c:pt idx="15">
                  <c:v>2.4121940099192645</c:v>
                </c:pt>
                <c:pt idx="16">
                  <c:v>1.827538428476398</c:v>
                </c:pt>
                <c:pt idx="17">
                  <c:v>0.64840194351191227</c:v>
                </c:pt>
                <c:pt idx="18">
                  <c:v>0.25760330937369447</c:v>
                </c:pt>
                <c:pt idx="19">
                  <c:v>0.2479313104933637</c:v>
                </c:pt>
                <c:pt idx="20">
                  <c:v>0.25390163936383348</c:v>
                </c:pt>
                <c:pt idx="21">
                  <c:v>7.540491279824188E-2</c:v>
                </c:pt>
                <c:pt idx="22">
                  <c:v>0.56504026043032785</c:v>
                </c:pt>
                <c:pt idx="23">
                  <c:v>1.6689489883017783</c:v>
                </c:pt>
                <c:pt idx="24">
                  <c:v>3.5700300608421145</c:v>
                </c:pt>
                <c:pt idx="25">
                  <c:v>5.0813963807607152</c:v>
                </c:pt>
                <c:pt idx="26">
                  <c:v>5.595323302884375</c:v>
                </c:pt>
                <c:pt idx="27">
                  <c:v>4.745796628305599</c:v>
                </c:pt>
                <c:pt idx="28">
                  <c:v>3.6879835354700155</c:v>
                </c:pt>
                <c:pt idx="29">
                  <c:v>2.8883176283747587</c:v>
                </c:pt>
                <c:pt idx="30">
                  <c:v>1.4485625916273908</c:v>
                </c:pt>
                <c:pt idx="31">
                  <c:v>0.44516062878566459</c:v>
                </c:pt>
                <c:pt idx="32">
                  <c:v>0.1387137065833591</c:v>
                </c:pt>
                <c:pt idx="33">
                  <c:v>0.2363688044216142</c:v>
                </c:pt>
                <c:pt idx="34">
                  <c:v>0.66201895181227943</c:v>
                </c:pt>
                <c:pt idx="35">
                  <c:v>0.94092738085432936</c:v>
                </c:pt>
                <c:pt idx="36">
                  <c:v>1.2412500248151705</c:v>
                </c:pt>
                <c:pt idx="37">
                  <c:v>1.3362385353858848</c:v>
                </c:pt>
                <c:pt idx="38">
                  <c:v>1.9466066750211892</c:v>
                </c:pt>
                <c:pt idx="39">
                  <c:v>2.690869272734433</c:v>
                </c:pt>
                <c:pt idx="40">
                  <c:v>3.3013820451927898</c:v>
                </c:pt>
                <c:pt idx="41">
                  <c:v>4.1799103606390169</c:v>
                </c:pt>
                <c:pt idx="42">
                  <c:v>4.3621233403712401</c:v>
                </c:pt>
                <c:pt idx="43">
                  <c:v>1.8548658836871086</c:v>
                </c:pt>
                <c:pt idx="44">
                  <c:v>0.43741602546809205</c:v>
                </c:pt>
                <c:pt idx="45">
                  <c:v>0.12360189404556292</c:v>
                </c:pt>
                <c:pt idx="46">
                  <c:v>0.15753629218796952</c:v>
                </c:pt>
                <c:pt idx="47">
                  <c:v>0.21398283160835363</c:v>
                </c:pt>
                <c:pt idx="48">
                  <c:v>0.2869819677928635</c:v>
                </c:pt>
                <c:pt idx="49">
                  <c:v>0.3313023622047151</c:v>
                </c:pt>
                <c:pt idx="50">
                  <c:v>0.50562334580846269</c:v>
                </c:pt>
                <c:pt idx="51">
                  <c:v>0.96799781519734329</c:v>
                </c:pt>
                <c:pt idx="52">
                  <c:v>1.4768331769594152</c:v>
                </c:pt>
                <c:pt idx="53">
                  <c:v>1.4569198622925279</c:v>
                </c:pt>
                <c:pt idx="54">
                  <c:v>1.7490994804810238</c:v>
                </c:pt>
                <c:pt idx="55">
                  <c:v>0.71630586346281999</c:v>
                </c:pt>
                <c:pt idx="56">
                  <c:v>0.67078312300516874</c:v>
                </c:pt>
                <c:pt idx="57">
                  <c:v>7.3406001982931846E-2</c:v>
                </c:pt>
                <c:pt idx="58">
                  <c:v>0.23400152768800594</c:v>
                </c:pt>
                <c:pt idx="59">
                  <c:v>0.52209073071691947</c:v>
                </c:pt>
                <c:pt idx="60">
                  <c:v>1.0056785620529423</c:v>
                </c:pt>
                <c:pt idx="61">
                  <c:v>1.3567352659451271</c:v>
                </c:pt>
                <c:pt idx="62">
                  <c:v>0.86579544436671307</c:v>
                </c:pt>
                <c:pt idx="63">
                  <c:v>0.124297065334804</c:v>
                </c:pt>
                <c:pt idx="64">
                  <c:v>0.20013774275539595</c:v>
                </c:pt>
                <c:pt idx="65">
                  <c:v>0.1123700400893682</c:v>
                </c:pt>
                <c:pt idx="66">
                  <c:v>0.16822162200902868</c:v>
                </c:pt>
                <c:pt idx="67">
                  <c:v>0.29894142093337478</c:v>
                </c:pt>
                <c:pt idx="68">
                  <c:v>0.20134378202142147</c:v>
                </c:pt>
                <c:pt idx="69">
                  <c:v>8.0663988545373488E-2</c:v>
                </c:pt>
                <c:pt idx="70">
                  <c:v>0.20832627771891579</c:v>
                </c:pt>
                <c:pt idx="71">
                  <c:v>0.271047773805279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3E-4E72-8920-CE5C375778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78803232"/>
        <c:axId val="878801592"/>
      </c:barChart>
      <c:catAx>
        <c:axId val="878803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8801592"/>
        <c:crosses val="autoZero"/>
        <c:auto val="1"/>
        <c:lblAlgn val="ctr"/>
        <c:lblOffset val="100"/>
        <c:noMultiLvlLbl val="0"/>
      </c:catAx>
      <c:valAx>
        <c:axId val="87880159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0" i="0" baseline="0">
                    <a:effectLst/>
                  </a:rPr>
                  <a:t>nmol %</a:t>
                </a:r>
                <a:endParaRPr lang="en-GB" sz="1400">
                  <a:effectLst/>
                </a:endParaRPr>
              </a:p>
            </c:rich>
          </c:tx>
          <c:layout>
            <c:manualLayout>
              <c:xMode val="edge"/>
              <c:yMode val="edge"/>
              <c:x val="1.0637587130332611E-2"/>
              <c:y val="0.314224021867343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8803232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2602463153644261"/>
          <c:y val="0.14556160031020124"/>
          <c:w val="0.25907962924448807"/>
          <c:h val="8.06023025470523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12700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/>
              <a:t>Field Trial 2018 - TAG Profile</a:t>
            </a:r>
          </a:p>
        </c:rich>
      </c:tx>
      <c:layout>
        <c:manualLayout>
          <c:xMode val="edge"/>
          <c:yMode val="edge"/>
          <c:x val="0.60799491469816269"/>
          <c:y val="7.63524115280848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5443569553805753E-2"/>
          <c:y val="4.7332428274051951E-2"/>
          <c:w val="0.91384957349081364"/>
          <c:h val="0.84481020906869397"/>
        </c:manualLayout>
      </c:layout>
      <c:barChart>
        <c:barDir val="col"/>
        <c:grouping val="clustered"/>
        <c:varyColors val="0"/>
        <c:ser>
          <c:idx val="5"/>
          <c:order val="0"/>
          <c:tx>
            <c:strRef>
              <c:f>'nmol %'!$AD$378</c:f>
              <c:strCache>
                <c:ptCount val="1"/>
                <c:pt idx="0">
                  <c:v>EPA2016.1</c:v>
                </c:pt>
              </c:strCache>
            </c:strRef>
          </c:tx>
          <c:spPr>
            <a:solidFill>
              <a:srgbClr val="BB561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mol %'!$AM$379:$AM$450</c:f>
                <c:numCache>
                  <c:formatCode>General</c:formatCode>
                  <c:ptCount val="72"/>
                  <c:pt idx="0">
                    <c:v>0.19189939113645366</c:v>
                  </c:pt>
                  <c:pt idx="1">
                    <c:v>0.17985347989377978</c:v>
                  </c:pt>
                  <c:pt idx="2">
                    <c:v>0.22095600071000079</c:v>
                  </c:pt>
                  <c:pt idx="3">
                    <c:v>0.63397052847308044</c:v>
                  </c:pt>
                  <c:pt idx="4">
                    <c:v>0.29000644819202581</c:v>
                  </c:pt>
                  <c:pt idx="5">
                    <c:v>0.75767760813126861</c:v>
                  </c:pt>
                  <c:pt idx="6">
                    <c:v>0.89088523493748806</c:v>
                  </c:pt>
                  <c:pt idx="7">
                    <c:v>0.61905375127241558</c:v>
                  </c:pt>
                  <c:pt idx="8">
                    <c:v>6.4376707645250927E-2</c:v>
                  </c:pt>
                  <c:pt idx="9">
                    <c:v>9.0251274231883963E-2</c:v>
                  </c:pt>
                  <c:pt idx="10">
                    <c:v>0.3334521876028152</c:v>
                  </c:pt>
                  <c:pt idx="11">
                    <c:v>0.54301565252605077</c:v>
                  </c:pt>
                  <c:pt idx="12">
                    <c:v>0.38320341745516029</c:v>
                  </c:pt>
                  <c:pt idx="13">
                    <c:v>0.16658897672600087</c:v>
                  </c:pt>
                  <c:pt idx="14">
                    <c:v>0.16930282790380619</c:v>
                  </c:pt>
                  <c:pt idx="15">
                    <c:v>0.24087849862015628</c:v>
                  </c:pt>
                  <c:pt idx="16">
                    <c:v>6.1224762614463864E-2</c:v>
                  </c:pt>
                  <c:pt idx="17">
                    <c:v>6.3480536111323288E-2</c:v>
                  </c:pt>
                  <c:pt idx="18">
                    <c:v>0.10511985936363043</c:v>
                  </c:pt>
                  <c:pt idx="19">
                    <c:v>8.4362635593777394E-2</c:v>
                  </c:pt>
                  <c:pt idx="20">
                    <c:v>0.12083409540334103</c:v>
                  </c:pt>
                  <c:pt idx="21">
                    <c:v>3.4703964064895405E-2</c:v>
                  </c:pt>
                  <c:pt idx="22">
                    <c:v>0.15898387311258955</c:v>
                  </c:pt>
                  <c:pt idx="23">
                    <c:v>3.989769242761642E-2</c:v>
                  </c:pt>
                  <c:pt idx="24">
                    <c:v>0.19266579931722821</c:v>
                  </c:pt>
                  <c:pt idx="25">
                    <c:v>0.25443298344689913</c:v>
                  </c:pt>
                  <c:pt idx="26">
                    <c:v>0.68194002617954341</c:v>
                  </c:pt>
                  <c:pt idx="27">
                    <c:v>0.60119243837833825</c:v>
                  </c:pt>
                  <c:pt idx="28">
                    <c:v>0.20831320760857097</c:v>
                  </c:pt>
                  <c:pt idx="29">
                    <c:v>0.43190332110075319</c:v>
                  </c:pt>
                  <c:pt idx="30">
                    <c:v>0.15528034754706124</c:v>
                  </c:pt>
                  <c:pt idx="31">
                    <c:v>0.13138958058605499</c:v>
                  </c:pt>
                  <c:pt idx="32">
                    <c:v>3.5584096337345474E-2</c:v>
                  </c:pt>
                  <c:pt idx="33">
                    <c:v>1.8132943197007572E-2</c:v>
                  </c:pt>
                  <c:pt idx="34">
                    <c:v>6.9993694436243439E-2</c:v>
                  </c:pt>
                  <c:pt idx="35">
                    <c:v>0.13172659663906308</c:v>
                  </c:pt>
                  <c:pt idx="36">
                    <c:v>0.3180205483477519</c:v>
                  </c:pt>
                  <c:pt idx="37">
                    <c:v>0.28506800504656282</c:v>
                  </c:pt>
                  <c:pt idx="38">
                    <c:v>0.52098727026744052</c:v>
                  </c:pt>
                  <c:pt idx="39">
                    <c:v>0.47876629483573979</c:v>
                  </c:pt>
                  <c:pt idx="40">
                    <c:v>0.44929427362248586</c:v>
                  </c:pt>
                  <c:pt idx="41">
                    <c:v>0.24649977392041836</c:v>
                  </c:pt>
                  <c:pt idx="42">
                    <c:v>0.30335300904444917</c:v>
                  </c:pt>
                  <c:pt idx="43">
                    <c:v>0.18888946506126436</c:v>
                  </c:pt>
                  <c:pt idx="44">
                    <c:v>0.20536999388249957</c:v>
                  </c:pt>
                  <c:pt idx="45">
                    <c:v>3.2965198088383469E-3</c:v>
                  </c:pt>
                  <c:pt idx="46">
                    <c:v>3.2927544938877E-2</c:v>
                  </c:pt>
                  <c:pt idx="47">
                    <c:v>7.6690582398495244E-2</c:v>
                  </c:pt>
                  <c:pt idx="48">
                    <c:v>4.3832078109529118E-2</c:v>
                  </c:pt>
                  <c:pt idx="49">
                    <c:v>7.9129966038452113E-2</c:v>
                  </c:pt>
                  <c:pt idx="50">
                    <c:v>1.8987790375380603E-2</c:v>
                  </c:pt>
                  <c:pt idx="51">
                    <c:v>5.6937255335896934E-2</c:v>
                  </c:pt>
                  <c:pt idx="52">
                    <c:v>0.13559485694231974</c:v>
                  </c:pt>
                  <c:pt idx="53">
                    <c:v>0.13449258445801987</c:v>
                  </c:pt>
                  <c:pt idx="54">
                    <c:v>7.0473741724524294E-3</c:v>
                  </c:pt>
                  <c:pt idx="55">
                    <c:v>0.13264138075347029</c:v>
                  </c:pt>
                  <c:pt idx="56">
                    <c:v>9.9149490238417959E-2</c:v>
                  </c:pt>
                  <c:pt idx="57">
                    <c:v>6.1853380506658388E-2</c:v>
                  </c:pt>
                  <c:pt idx="58">
                    <c:v>6.1340588564239851E-3</c:v>
                  </c:pt>
                  <c:pt idx="59">
                    <c:v>5.7370421803248865E-3</c:v>
                  </c:pt>
                  <c:pt idx="60">
                    <c:v>2.1204319172132769E-2</c:v>
                  </c:pt>
                  <c:pt idx="61">
                    <c:v>1.0155392687981438E-2</c:v>
                  </c:pt>
                  <c:pt idx="62">
                    <c:v>4.0503172134067206E-3</c:v>
                  </c:pt>
                  <c:pt idx="63">
                    <c:v>2.2848239929753416E-2</c:v>
                  </c:pt>
                  <c:pt idx="64">
                    <c:v>0</c:v>
                  </c:pt>
                  <c:pt idx="65">
                    <c:v>1.5539679839563778E-3</c:v>
                  </c:pt>
                  <c:pt idx="66">
                    <c:v>1.651982988260679E-3</c:v>
                  </c:pt>
                  <c:pt idx="67">
                    <c:v>1.6234285202527603E-3</c:v>
                  </c:pt>
                  <c:pt idx="68">
                    <c:v>5.9703675611843471E-3</c:v>
                  </c:pt>
                  <c:pt idx="69">
                    <c:v>0</c:v>
                  </c:pt>
                  <c:pt idx="70">
                    <c:v>0</c:v>
                  </c:pt>
                  <c:pt idx="71">
                    <c:v>0</c:v>
                  </c:pt>
                </c:numCache>
              </c:numRef>
            </c:plus>
            <c:minus>
              <c:numRef>
                <c:f>'nmol %'!$AM$379:$AM$450</c:f>
                <c:numCache>
                  <c:formatCode>General</c:formatCode>
                  <c:ptCount val="72"/>
                  <c:pt idx="0">
                    <c:v>0.19189939113645366</c:v>
                  </c:pt>
                  <c:pt idx="1">
                    <c:v>0.17985347989377978</c:v>
                  </c:pt>
                  <c:pt idx="2">
                    <c:v>0.22095600071000079</c:v>
                  </c:pt>
                  <c:pt idx="3">
                    <c:v>0.63397052847308044</c:v>
                  </c:pt>
                  <c:pt idx="4">
                    <c:v>0.29000644819202581</c:v>
                  </c:pt>
                  <c:pt idx="5">
                    <c:v>0.75767760813126861</c:v>
                  </c:pt>
                  <c:pt idx="6">
                    <c:v>0.89088523493748806</c:v>
                  </c:pt>
                  <c:pt idx="7">
                    <c:v>0.61905375127241558</c:v>
                  </c:pt>
                  <c:pt idx="8">
                    <c:v>6.4376707645250927E-2</c:v>
                  </c:pt>
                  <c:pt idx="9">
                    <c:v>9.0251274231883963E-2</c:v>
                  </c:pt>
                  <c:pt idx="10">
                    <c:v>0.3334521876028152</c:v>
                  </c:pt>
                  <c:pt idx="11">
                    <c:v>0.54301565252605077</c:v>
                  </c:pt>
                  <c:pt idx="12">
                    <c:v>0.38320341745516029</c:v>
                  </c:pt>
                  <c:pt idx="13">
                    <c:v>0.16658897672600087</c:v>
                  </c:pt>
                  <c:pt idx="14">
                    <c:v>0.16930282790380619</c:v>
                  </c:pt>
                  <c:pt idx="15">
                    <c:v>0.24087849862015628</c:v>
                  </c:pt>
                  <c:pt idx="16">
                    <c:v>6.1224762614463864E-2</c:v>
                  </c:pt>
                  <c:pt idx="17">
                    <c:v>6.3480536111323288E-2</c:v>
                  </c:pt>
                  <c:pt idx="18">
                    <c:v>0.10511985936363043</c:v>
                  </c:pt>
                  <c:pt idx="19">
                    <c:v>8.4362635593777394E-2</c:v>
                  </c:pt>
                  <c:pt idx="20">
                    <c:v>0.12083409540334103</c:v>
                  </c:pt>
                  <c:pt idx="21">
                    <c:v>3.4703964064895405E-2</c:v>
                  </c:pt>
                  <c:pt idx="22">
                    <c:v>0.15898387311258955</c:v>
                  </c:pt>
                  <c:pt idx="23">
                    <c:v>3.989769242761642E-2</c:v>
                  </c:pt>
                  <c:pt idx="24">
                    <c:v>0.19266579931722821</c:v>
                  </c:pt>
                  <c:pt idx="25">
                    <c:v>0.25443298344689913</c:v>
                  </c:pt>
                  <c:pt idx="26">
                    <c:v>0.68194002617954341</c:v>
                  </c:pt>
                  <c:pt idx="27">
                    <c:v>0.60119243837833825</c:v>
                  </c:pt>
                  <c:pt idx="28">
                    <c:v>0.20831320760857097</c:v>
                  </c:pt>
                  <c:pt idx="29">
                    <c:v>0.43190332110075319</c:v>
                  </c:pt>
                  <c:pt idx="30">
                    <c:v>0.15528034754706124</c:v>
                  </c:pt>
                  <c:pt idx="31">
                    <c:v>0.13138958058605499</c:v>
                  </c:pt>
                  <c:pt idx="32">
                    <c:v>3.5584096337345474E-2</c:v>
                  </c:pt>
                  <c:pt idx="33">
                    <c:v>1.8132943197007572E-2</c:v>
                  </c:pt>
                  <c:pt idx="34">
                    <c:v>6.9993694436243439E-2</c:v>
                  </c:pt>
                  <c:pt idx="35">
                    <c:v>0.13172659663906308</c:v>
                  </c:pt>
                  <c:pt idx="36">
                    <c:v>0.3180205483477519</c:v>
                  </c:pt>
                  <c:pt idx="37">
                    <c:v>0.28506800504656282</c:v>
                  </c:pt>
                  <c:pt idx="38">
                    <c:v>0.52098727026744052</c:v>
                  </c:pt>
                  <c:pt idx="39">
                    <c:v>0.47876629483573979</c:v>
                  </c:pt>
                  <c:pt idx="40">
                    <c:v>0.44929427362248586</c:v>
                  </c:pt>
                  <c:pt idx="41">
                    <c:v>0.24649977392041836</c:v>
                  </c:pt>
                  <c:pt idx="42">
                    <c:v>0.30335300904444917</c:v>
                  </c:pt>
                  <c:pt idx="43">
                    <c:v>0.18888946506126436</c:v>
                  </c:pt>
                  <c:pt idx="44">
                    <c:v>0.20536999388249957</c:v>
                  </c:pt>
                  <c:pt idx="45">
                    <c:v>3.2965198088383469E-3</c:v>
                  </c:pt>
                  <c:pt idx="46">
                    <c:v>3.2927544938877E-2</c:v>
                  </c:pt>
                  <c:pt idx="47">
                    <c:v>7.6690582398495244E-2</c:v>
                  </c:pt>
                  <c:pt idx="48">
                    <c:v>4.3832078109529118E-2</c:v>
                  </c:pt>
                  <c:pt idx="49">
                    <c:v>7.9129966038452113E-2</c:v>
                  </c:pt>
                  <c:pt idx="50">
                    <c:v>1.8987790375380603E-2</c:v>
                  </c:pt>
                  <c:pt idx="51">
                    <c:v>5.6937255335896934E-2</c:v>
                  </c:pt>
                  <c:pt idx="52">
                    <c:v>0.13559485694231974</c:v>
                  </c:pt>
                  <c:pt idx="53">
                    <c:v>0.13449258445801987</c:v>
                  </c:pt>
                  <c:pt idx="54">
                    <c:v>7.0473741724524294E-3</c:v>
                  </c:pt>
                  <c:pt idx="55">
                    <c:v>0.13264138075347029</c:v>
                  </c:pt>
                  <c:pt idx="56">
                    <c:v>9.9149490238417959E-2</c:v>
                  </c:pt>
                  <c:pt idx="57">
                    <c:v>6.1853380506658388E-2</c:v>
                  </c:pt>
                  <c:pt idx="58">
                    <c:v>6.1340588564239851E-3</c:v>
                  </c:pt>
                  <c:pt idx="59">
                    <c:v>5.7370421803248865E-3</c:v>
                  </c:pt>
                  <c:pt idx="60">
                    <c:v>2.1204319172132769E-2</c:v>
                  </c:pt>
                  <c:pt idx="61">
                    <c:v>1.0155392687981438E-2</c:v>
                  </c:pt>
                  <c:pt idx="62">
                    <c:v>4.0503172134067206E-3</c:v>
                  </c:pt>
                  <c:pt idx="63">
                    <c:v>2.2848239929753416E-2</c:v>
                  </c:pt>
                  <c:pt idx="64">
                    <c:v>0</c:v>
                  </c:pt>
                  <c:pt idx="65">
                    <c:v>1.5539679839563778E-3</c:v>
                  </c:pt>
                  <c:pt idx="66">
                    <c:v>1.651982988260679E-3</c:v>
                  </c:pt>
                  <c:pt idx="67">
                    <c:v>1.6234285202527603E-3</c:v>
                  </c:pt>
                  <c:pt idx="68">
                    <c:v>5.9703675611843471E-3</c:v>
                  </c:pt>
                  <c:pt idx="69">
                    <c:v>0</c:v>
                  </c:pt>
                  <c:pt idx="70">
                    <c:v>0</c:v>
                  </c:pt>
                  <c:pt idx="7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mol %'!$X$379:$X$450</c:f>
              <c:strCache>
                <c:ptCount val="72"/>
                <c:pt idx="0">
                  <c:v> 50:1</c:v>
                </c:pt>
                <c:pt idx="1">
                  <c:v> 50:2</c:v>
                </c:pt>
                <c:pt idx="2">
                  <c:v> 50:3</c:v>
                </c:pt>
                <c:pt idx="3">
                  <c:v> 52:2</c:v>
                </c:pt>
                <c:pt idx="4">
                  <c:v> 52:3</c:v>
                </c:pt>
                <c:pt idx="5">
                  <c:v> 52:4</c:v>
                </c:pt>
                <c:pt idx="6">
                  <c:v> 52:5</c:v>
                </c:pt>
                <c:pt idx="7">
                  <c:v> 52:6</c:v>
                </c:pt>
                <c:pt idx="8">
                  <c:v> 52:7</c:v>
                </c:pt>
                <c:pt idx="9">
                  <c:v> 54:1</c:v>
                </c:pt>
                <c:pt idx="10">
                  <c:v> 54:2</c:v>
                </c:pt>
                <c:pt idx="11">
                  <c:v> 54:3</c:v>
                </c:pt>
                <c:pt idx="12">
                  <c:v> 54:4</c:v>
                </c:pt>
                <c:pt idx="13">
                  <c:v> 54:5</c:v>
                </c:pt>
                <c:pt idx="14">
                  <c:v> 54:6</c:v>
                </c:pt>
                <c:pt idx="15">
                  <c:v> 54:7</c:v>
                </c:pt>
                <c:pt idx="16">
                  <c:v> 54:8</c:v>
                </c:pt>
                <c:pt idx="17">
                  <c:v> 54:9</c:v>
                </c:pt>
                <c:pt idx="18">
                  <c:v> 54:10</c:v>
                </c:pt>
                <c:pt idx="19">
                  <c:v> 54:11</c:v>
                </c:pt>
                <c:pt idx="20">
                  <c:v> 54:12</c:v>
                </c:pt>
                <c:pt idx="21">
                  <c:v> 56:1</c:v>
                </c:pt>
                <c:pt idx="22">
                  <c:v> 56:2</c:v>
                </c:pt>
                <c:pt idx="23">
                  <c:v> 56:3</c:v>
                </c:pt>
                <c:pt idx="24">
                  <c:v> 56:4</c:v>
                </c:pt>
                <c:pt idx="25">
                  <c:v> 56:5</c:v>
                </c:pt>
                <c:pt idx="26">
                  <c:v> 56:6</c:v>
                </c:pt>
                <c:pt idx="27">
                  <c:v> 56:7</c:v>
                </c:pt>
                <c:pt idx="28">
                  <c:v> 56:8</c:v>
                </c:pt>
                <c:pt idx="29">
                  <c:v> 56:9</c:v>
                </c:pt>
                <c:pt idx="30">
                  <c:v> 56:10</c:v>
                </c:pt>
                <c:pt idx="31">
                  <c:v> 56:11</c:v>
                </c:pt>
                <c:pt idx="32">
                  <c:v> 56:12</c:v>
                </c:pt>
                <c:pt idx="33">
                  <c:v> 58:2</c:v>
                </c:pt>
                <c:pt idx="34">
                  <c:v> 58:3</c:v>
                </c:pt>
                <c:pt idx="35">
                  <c:v> 58:4</c:v>
                </c:pt>
                <c:pt idx="36">
                  <c:v> 58:5</c:v>
                </c:pt>
                <c:pt idx="37">
                  <c:v> 58:6</c:v>
                </c:pt>
                <c:pt idx="38">
                  <c:v> 58:7</c:v>
                </c:pt>
                <c:pt idx="39">
                  <c:v> 58:8</c:v>
                </c:pt>
                <c:pt idx="40">
                  <c:v> 58:9</c:v>
                </c:pt>
                <c:pt idx="41">
                  <c:v> 58:10</c:v>
                </c:pt>
                <c:pt idx="42">
                  <c:v> 58:11</c:v>
                </c:pt>
                <c:pt idx="43">
                  <c:v> 58:12</c:v>
                </c:pt>
                <c:pt idx="44">
                  <c:v> 58:13</c:v>
                </c:pt>
                <c:pt idx="45">
                  <c:v> 60:3</c:v>
                </c:pt>
                <c:pt idx="46">
                  <c:v> 60:4</c:v>
                </c:pt>
                <c:pt idx="47">
                  <c:v> 60:5</c:v>
                </c:pt>
                <c:pt idx="48">
                  <c:v> 60:6</c:v>
                </c:pt>
                <c:pt idx="49">
                  <c:v> 60:7</c:v>
                </c:pt>
                <c:pt idx="50">
                  <c:v> 60:8</c:v>
                </c:pt>
                <c:pt idx="51">
                  <c:v> 60:9</c:v>
                </c:pt>
                <c:pt idx="52">
                  <c:v> 60:10</c:v>
                </c:pt>
                <c:pt idx="53">
                  <c:v> 60:11</c:v>
                </c:pt>
                <c:pt idx="54">
                  <c:v> 60:12</c:v>
                </c:pt>
                <c:pt idx="55">
                  <c:v> 60:13</c:v>
                </c:pt>
                <c:pt idx="56">
                  <c:v> 60:14</c:v>
                </c:pt>
                <c:pt idx="57">
                  <c:v> 60:15</c:v>
                </c:pt>
                <c:pt idx="58">
                  <c:v> 62:11</c:v>
                </c:pt>
                <c:pt idx="59">
                  <c:v> 62:12</c:v>
                </c:pt>
                <c:pt idx="60">
                  <c:v> 62:13</c:v>
                </c:pt>
                <c:pt idx="61">
                  <c:v> 62:14</c:v>
                </c:pt>
                <c:pt idx="62">
                  <c:v> 62:15</c:v>
                </c:pt>
                <c:pt idx="63">
                  <c:v> 62:16</c:v>
                </c:pt>
                <c:pt idx="64">
                  <c:v> 64:13</c:v>
                </c:pt>
                <c:pt idx="65">
                  <c:v> 64:14</c:v>
                </c:pt>
                <c:pt idx="66">
                  <c:v> 64:15</c:v>
                </c:pt>
                <c:pt idx="67">
                  <c:v> 64:16</c:v>
                </c:pt>
                <c:pt idx="68">
                  <c:v> 64:17</c:v>
                </c:pt>
                <c:pt idx="69">
                  <c:v> 66:16</c:v>
                </c:pt>
                <c:pt idx="70">
                  <c:v> 66:17</c:v>
                </c:pt>
                <c:pt idx="71">
                  <c:v> 66:18</c:v>
                </c:pt>
              </c:strCache>
            </c:strRef>
          </c:cat>
          <c:val>
            <c:numRef>
              <c:f>'nmol %'!$AD$379:$AD$450</c:f>
              <c:numCache>
                <c:formatCode>0.00</c:formatCode>
                <c:ptCount val="72"/>
                <c:pt idx="0">
                  <c:v>0.28812711820428122</c:v>
                </c:pt>
                <c:pt idx="1">
                  <c:v>0.36815134798120169</c:v>
                </c:pt>
                <c:pt idx="2">
                  <c:v>0.44310569551974432</c:v>
                </c:pt>
                <c:pt idx="3">
                  <c:v>1.9008989287171809</c:v>
                </c:pt>
                <c:pt idx="4">
                  <c:v>1.1386559757034564</c:v>
                </c:pt>
                <c:pt idx="5">
                  <c:v>3.2526809854745209</c:v>
                </c:pt>
                <c:pt idx="6">
                  <c:v>2.505883894350784</c:v>
                </c:pt>
                <c:pt idx="7">
                  <c:v>2.7129196368181447</c:v>
                </c:pt>
                <c:pt idx="8">
                  <c:v>0.19901729268611079</c:v>
                </c:pt>
                <c:pt idx="9">
                  <c:v>0.20394623437849488</c:v>
                </c:pt>
                <c:pt idx="10">
                  <c:v>1.8698259564352433</c:v>
                </c:pt>
                <c:pt idx="11">
                  <c:v>3.1378487933449328</c:v>
                </c:pt>
                <c:pt idx="12">
                  <c:v>4.3781551297949077</c:v>
                </c:pt>
                <c:pt idx="13">
                  <c:v>4.2956714220811696</c:v>
                </c:pt>
                <c:pt idx="14">
                  <c:v>4.3067984188791444</c:v>
                </c:pt>
                <c:pt idx="15">
                  <c:v>3.1390284904595807</c:v>
                </c:pt>
                <c:pt idx="16">
                  <c:v>2.4145467421042217</c:v>
                </c:pt>
                <c:pt idx="17">
                  <c:v>0.67519982883571339</c:v>
                </c:pt>
                <c:pt idx="18">
                  <c:v>0.40508297134438948</c:v>
                </c:pt>
                <c:pt idx="19">
                  <c:v>0.245662937970439</c:v>
                </c:pt>
                <c:pt idx="20">
                  <c:v>0.33100058572696922</c:v>
                </c:pt>
                <c:pt idx="21">
                  <c:v>0.10704680689425494</c:v>
                </c:pt>
                <c:pt idx="22">
                  <c:v>0.76184124805261566</c:v>
                </c:pt>
                <c:pt idx="23">
                  <c:v>2.5750372499140664</c:v>
                </c:pt>
                <c:pt idx="24">
                  <c:v>4.8166453750517375</c:v>
                </c:pt>
                <c:pt idx="25">
                  <c:v>6.2633280231626891</c:v>
                </c:pt>
                <c:pt idx="26">
                  <c:v>6.9197554053633041</c:v>
                </c:pt>
                <c:pt idx="27">
                  <c:v>6.7513789449279527</c:v>
                </c:pt>
                <c:pt idx="28">
                  <c:v>3.7919988790495682</c:v>
                </c:pt>
                <c:pt idx="29">
                  <c:v>2.6674720806386265</c:v>
                </c:pt>
                <c:pt idx="30">
                  <c:v>2.1718293085838964</c:v>
                </c:pt>
                <c:pt idx="31">
                  <c:v>1.1281431845218335</c:v>
                </c:pt>
                <c:pt idx="32">
                  <c:v>0.21491474836585547</c:v>
                </c:pt>
                <c:pt idx="33">
                  <c:v>0.26772233345516777</c:v>
                </c:pt>
                <c:pt idx="34">
                  <c:v>0.95564624245336793</c:v>
                </c:pt>
                <c:pt idx="35">
                  <c:v>1.3747012105856704</c:v>
                </c:pt>
                <c:pt idx="36">
                  <c:v>1.871926602197785</c:v>
                </c:pt>
                <c:pt idx="37">
                  <c:v>2.0045145319949755</c:v>
                </c:pt>
                <c:pt idx="38">
                  <c:v>2.8718492183374624</c:v>
                </c:pt>
                <c:pt idx="39">
                  <c:v>2.3230053692742882</c:v>
                </c:pt>
                <c:pt idx="40">
                  <c:v>2.2469055384129959</c:v>
                </c:pt>
                <c:pt idx="41">
                  <c:v>1.5168412830433231</c:v>
                </c:pt>
                <c:pt idx="42">
                  <c:v>1.6068693858664156</c:v>
                </c:pt>
                <c:pt idx="43">
                  <c:v>0.96455695140228637</c:v>
                </c:pt>
                <c:pt idx="44">
                  <c:v>1.0180472602368509</c:v>
                </c:pt>
                <c:pt idx="45">
                  <c:v>0.12762358027516288</c:v>
                </c:pt>
                <c:pt idx="46">
                  <c:v>0.16126666385392099</c:v>
                </c:pt>
                <c:pt idx="47">
                  <c:v>0.26559610550462692</c:v>
                </c:pt>
                <c:pt idx="48">
                  <c:v>0.32357708167672922</c:v>
                </c:pt>
                <c:pt idx="49">
                  <c:v>0.4004103202919882</c:v>
                </c:pt>
                <c:pt idx="50">
                  <c:v>0.19761204404198832</c:v>
                </c:pt>
                <c:pt idx="51">
                  <c:v>0.2550807743430496</c:v>
                </c:pt>
                <c:pt idx="52">
                  <c:v>0.46976228923750546</c:v>
                </c:pt>
                <c:pt idx="53">
                  <c:v>0.49988132907151134</c:v>
                </c:pt>
                <c:pt idx="54">
                  <c:v>0.23292984324715971</c:v>
                </c:pt>
                <c:pt idx="55">
                  <c:v>0.46286168149666951</c:v>
                </c:pt>
                <c:pt idx="56">
                  <c:v>0.33268918028893746</c:v>
                </c:pt>
                <c:pt idx="57">
                  <c:v>0.19325547201078655</c:v>
                </c:pt>
                <c:pt idx="58">
                  <c:v>1.2032728935737735E-2</c:v>
                </c:pt>
                <c:pt idx="59">
                  <c:v>9.9338504113712627E-3</c:v>
                </c:pt>
                <c:pt idx="60">
                  <c:v>4.4283126755077028E-2</c:v>
                </c:pt>
                <c:pt idx="61">
                  <c:v>2.9658753983066222E-2</c:v>
                </c:pt>
                <c:pt idx="62">
                  <c:v>5.9046338605890786E-3</c:v>
                </c:pt>
                <c:pt idx="63">
                  <c:v>3.4983996415508867E-2</c:v>
                </c:pt>
                <c:pt idx="64">
                  <c:v>0</c:v>
                </c:pt>
                <c:pt idx="65">
                  <c:v>1.5539679839563778E-3</c:v>
                </c:pt>
                <c:pt idx="66">
                  <c:v>1.6519829882606788E-3</c:v>
                </c:pt>
                <c:pt idx="67">
                  <c:v>1.62342852025276E-3</c:v>
                </c:pt>
                <c:pt idx="68">
                  <c:v>5.9703675611843471E-3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D6-49DB-B61E-071883C4D4F5}"/>
            </c:ext>
          </c:extLst>
        </c:ser>
        <c:ser>
          <c:idx val="6"/>
          <c:order val="1"/>
          <c:tx>
            <c:strRef>
              <c:f>'nmol %'!$AE$378</c:f>
              <c:strCache>
                <c:ptCount val="1"/>
                <c:pt idx="0">
                  <c:v>EPA2015.8</c:v>
                </c:pt>
              </c:strCache>
            </c:strRef>
          </c:tx>
          <c:spPr>
            <a:solidFill>
              <a:srgbClr val="F2BAA8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mol %'!$AN$379:$AN$450</c:f>
                <c:numCache>
                  <c:formatCode>General</c:formatCode>
                  <c:ptCount val="72"/>
                  <c:pt idx="0">
                    <c:v>0.16982863691041972</c:v>
                  </c:pt>
                  <c:pt idx="1">
                    <c:v>0.19489062707252156</c:v>
                  </c:pt>
                  <c:pt idx="2">
                    <c:v>0.22069906510672985</c:v>
                  </c:pt>
                  <c:pt idx="3">
                    <c:v>0.44282067176554041</c:v>
                  </c:pt>
                  <c:pt idx="4">
                    <c:v>0.17578739346211228</c:v>
                  </c:pt>
                  <c:pt idx="5">
                    <c:v>0.34152844800881238</c:v>
                  </c:pt>
                  <c:pt idx="6">
                    <c:v>0.95703242843593583</c:v>
                  </c:pt>
                  <c:pt idx="7">
                    <c:v>0.3968141786962065</c:v>
                  </c:pt>
                  <c:pt idx="8">
                    <c:v>9.5765683135206184E-2</c:v>
                  </c:pt>
                  <c:pt idx="9">
                    <c:v>2.5551443323215024E-2</c:v>
                  </c:pt>
                  <c:pt idx="10">
                    <c:v>0.13023555349904156</c:v>
                  </c:pt>
                  <c:pt idx="11">
                    <c:v>0.3997697248940883</c:v>
                  </c:pt>
                  <c:pt idx="12">
                    <c:v>0.34899199982430607</c:v>
                  </c:pt>
                  <c:pt idx="13">
                    <c:v>0.37186147178649437</c:v>
                  </c:pt>
                  <c:pt idx="14">
                    <c:v>0.12887886493623546</c:v>
                  </c:pt>
                  <c:pt idx="15">
                    <c:v>0.31187179109964758</c:v>
                  </c:pt>
                  <c:pt idx="16">
                    <c:v>0.12923103744289949</c:v>
                  </c:pt>
                  <c:pt idx="17">
                    <c:v>0.11948029120430158</c:v>
                  </c:pt>
                  <c:pt idx="18">
                    <c:v>7.5457731600114097E-2</c:v>
                  </c:pt>
                  <c:pt idx="19">
                    <c:v>8.0918748343548896E-2</c:v>
                  </c:pt>
                  <c:pt idx="20">
                    <c:v>5.7777541460776669E-2</c:v>
                  </c:pt>
                  <c:pt idx="21">
                    <c:v>4.2800814825363416E-2</c:v>
                  </c:pt>
                  <c:pt idx="22">
                    <c:v>5.2614006351643046E-2</c:v>
                  </c:pt>
                  <c:pt idx="23">
                    <c:v>4.0655772332877774E-2</c:v>
                  </c:pt>
                  <c:pt idx="24">
                    <c:v>0.22402237489941215</c:v>
                  </c:pt>
                  <c:pt idx="25">
                    <c:v>5.4112648528066937E-2</c:v>
                  </c:pt>
                  <c:pt idx="26">
                    <c:v>0.1080928791812643</c:v>
                  </c:pt>
                  <c:pt idx="27">
                    <c:v>0.16093929540610105</c:v>
                  </c:pt>
                  <c:pt idx="28">
                    <c:v>0.3133858119024574</c:v>
                  </c:pt>
                  <c:pt idx="29">
                    <c:v>0.36485833258883171</c:v>
                  </c:pt>
                  <c:pt idx="30">
                    <c:v>0.12178624037153546</c:v>
                  </c:pt>
                  <c:pt idx="31">
                    <c:v>0.12533008741493609</c:v>
                  </c:pt>
                  <c:pt idx="32">
                    <c:v>4.8202690422118326E-2</c:v>
                  </c:pt>
                  <c:pt idx="33">
                    <c:v>3.1180354756058994E-2</c:v>
                  </c:pt>
                  <c:pt idx="34">
                    <c:v>5.6270006815374897E-2</c:v>
                  </c:pt>
                  <c:pt idx="35">
                    <c:v>0.10533855262764166</c:v>
                  </c:pt>
                  <c:pt idx="36">
                    <c:v>0.25627911382970087</c:v>
                  </c:pt>
                  <c:pt idx="37">
                    <c:v>0.23216642182348871</c:v>
                  </c:pt>
                  <c:pt idx="38">
                    <c:v>0.57236915049402826</c:v>
                  </c:pt>
                  <c:pt idx="39">
                    <c:v>0.55085774550823419</c:v>
                  </c:pt>
                  <c:pt idx="40">
                    <c:v>0.45276368849039106</c:v>
                  </c:pt>
                  <c:pt idx="41">
                    <c:v>0.46712201060267394</c:v>
                  </c:pt>
                  <c:pt idx="42">
                    <c:v>0.22260119630957853</c:v>
                  </c:pt>
                  <c:pt idx="43">
                    <c:v>0.13196699745705989</c:v>
                  </c:pt>
                  <c:pt idx="44">
                    <c:v>7.5382486200748861E-2</c:v>
                  </c:pt>
                  <c:pt idx="45">
                    <c:v>2.7751123788952548E-2</c:v>
                  </c:pt>
                  <c:pt idx="46">
                    <c:v>3.5053347221427326E-2</c:v>
                  </c:pt>
                  <c:pt idx="47">
                    <c:v>3.0498940474975762E-2</c:v>
                  </c:pt>
                  <c:pt idx="48">
                    <c:v>3.9733969544807582E-2</c:v>
                  </c:pt>
                  <c:pt idx="49">
                    <c:v>6.0130003852056094E-2</c:v>
                  </c:pt>
                  <c:pt idx="50">
                    <c:v>6.739300035440042E-2</c:v>
                  </c:pt>
                  <c:pt idx="51">
                    <c:v>8.5817447128771832E-2</c:v>
                  </c:pt>
                  <c:pt idx="52">
                    <c:v>0.17587300377572782</c:v>
                  </c:pt>
                  <c:pt idx="53">
                    <c:v>0.14431526764563871</c:v>
                  </c:pt>
                  <c:pt idx="54">
                    <c:v>0.16003114370381458</c:v>
                  </c:pt>
                  <c:pt idx="55">
                    <c:v>0.16048717997960357</c:v>
                  </c:pt>
                  <c:pt idx="56">
                    <c:v>0.10488743226024459</c:v>
                  </c:pt>
                  <c:pt idx="57">
                    <c:v>1.4294649193360489E-2</c:v>
                  </c:pt>
                  <c:pt idx="58">
                    <c:v>3.4527591483760707E-3</c:v>
                  </c:pt>
                  <c:pt idx="59">
                    <c:v>9.6072601940716904E-3</c:v>
                  </c:pt>
                  <c:pt idx="60">
                    <c:v>1.3889220263233576E-2</c:v>
                  </c:pt>
                  <c:pt idx="61">
                    <c:v>1.9136361891507213E-2</c:v>
                  </c:pt>
                  <c:pt idx="62">
                    <c:v>6.7017371976798266E-3</c:v>
                  </c:pt>
                  <c:pt idx="63">
                    <c:v>0</c:v>
                  </c:pt>
                  <c:pt idx="64">
                    <c:v>0</c:v>
                  </c:pt>
                  <c:pt idx="65">
                    <c:v>0</c:v>
                  </c:pt>
                  <c:pt idx="66">
                    <c:v>5.914678863917234E-4</c:v>
                  </c:pt>
                  <c:pt idx="67">
                    <c:v>2.1689623449719472E-3</c:v>
                  </c:pt>
                  <c:pt idx="68">
                    <c:v>0</c:v>
                  </c:pt>
                  <c:pt idx="69">
                    <c:v>0</c:v>
                  </c:pt>
                  <c:pt idx="70">
                    <c:v>2.2639198743828314E-3</c:v>
                  </c:pt>
                  <c:pt idx="71">
                    <c:v>0</c:v>
                  </c:pt>
                </c:numCache>
              </c:numRef>
            </c:plus>
            <c:minus>
              <c:numRef>
                <c:f>'nmol %'!$AN$379:$AN$450</c:f>
                <c:numCache>
                  <c:formatCode>General</c:formatCode>
                  <c:ptCount val="72"/>
                  <c:pt idx="0">
                    <c:v>0.16982863691041972</c:v>
                  </c:pt>
                  <c:pt idx="1">
                    <c:v>0.19489062707252156</c:v>
                  </c:pt>
                  <c:pt idx="2">
                    <c:v>0.22069906510672985</c:v>
                  </c:pt>
                  <c:pt idx="3">
                    <c:v>0.44282067176554041</c:v>
                  </c:pt>
                  <c:pt idx="4">
                    <c:v>0.17578739346211228</c:v>
                  </c:pt>
                  <c:pt idx="5">
                    <c:v>0.34152844800881238</c:v>
                  </c:pt>
                  <c:pt idx="6">
                    <c:v>0.95703242843593583</c:v>
                  </c:pt>
                  <c:pt idx="7">
                    <c:v>0.3968141786962065</c:v>
                  </c:pt>
                  <c:pt idx="8">
                    <c:v>9.5765683135206184E-2</c:v>
                  </c:pt>
                  <c:pt idx="9">
                    <c:v>2.5551443323215024E-2</c:v>
                  </c:pt>
                  <c:pt idx="10">
                    <c:v>0.13023555349904156</c:v>
                  </c:pt>
                  <c:pt idx="11">
                    <c:v>0.3997697248940883</c:v>
                  </c:pt>
                  <c:pt idx="12">
                    <c:v>0.34899199982430607</c:v>
                  </c:pt>
                  <c:pt idx="13">
                    <c:v>0.37186147178649437</c:v>
                  </c:pt>
                  <c:pt idx="14">
                    <c:v>0.12887886493623546</c:v>
                  </c:pt>
                  <c:pt idx="15">
                    <c:v>0.31187179109964758</c:v>
                  </c:pt>
                  <c:pt idx="16">
                    <c:v>0.12923103744289949</c:v>
                  </c:pt>
                  <c:pt idx="17">
                    <c:v>0.11948029120430158</c:v>
                  </c:pt>
                  <c:pt idx="18">
                    <c:v>7.5457731600114097E-2</c:v>
                  </c:pt>
                  <c:pt idx="19">
                    <c:v>8.0918748343548896E-2</c:v>
                  </c:pt>
                  <c:pt idx="20">
                    <c:v>5.7777541460776669E-2</c:v>
                  </c:pt>
                  <c:pt idx="21">
                    <c:v>4.2800814825363416E-2</c:v>
                  </c:pt>
                  <c:pt idx="22">
                    <c:v>5.2614006351643046E-2</c:v>
                  </c:pt>
                  <c:pt idx="23">
                    <c:v>4.0655772332877774E-2</c:v>
                  </c:pt>
                  <c:pt idx="24">
                    <c:v>0.22402237489941215</c:v>
                  </c:pt>
                  <c:pt idx="25">
                    <c:v>5.4112648528066937E-2</c:v>
                  </c:pt>
                  <c:pt idx="26">
                    <c:v>0.1080928791812643</c:v>
                  </c:pt>
                  <c:pt idx="27">
                    <c:v>0.16093929540610105</c:v>
                  </c:pt>
                  <c:pt idx="28">
                    <c:v>0.3133858119024574</c:v>
                  </c:pt>
                  <c:pt idx="29">
                    <c:v>0.36485833258883171</c:v>
                  </c:pt>
                  <c:pt idx="30">
                    <c:v>0.12178624037153546</c:v>
                  </c:pt>
                  <c:pt idx="31">
                    <c:v>0.12533008741493609</c:v>
                  </c:pt>
                  <c:pt idx="32">
                    <c:v>4.8202690422118326E-2</c:v>
                  </c:pt>
                  <c:pt idx="33">
                    <c:v>3.1180354756058994E-2</c:v>
                  </c:pt>
                  <c:pt idx="34">
                    <c:v>5.6270006815374897E-2</c:v>
                  </c:pt>
                  <c:pt idx="35">
                    <c:v>0.10533855262764166</c:v>
                  </c:pt>
                  <c:pt idx="36">
                    <c:v>0.25627911382970087</c:v>
                  </c:pt>
                  <c:pt idx="37">
                    <c:v>0.23216642182348871</c:v>
                  </c:pt>
                  <c:pt idx="38">
                    <c:v>0.57236915049402826</c:v>
                  </c:pt>
                  <c:pt idx="39">
                    <c:v>0.55085774550823419</c:v>
                  </c:pt>
                  <c:pt idx="40">
                    <c:v>0.45276368849039106</c:v>
                  </c:pt>
                  <c:pt idx="41">
                    <c:v>0.46712201060267394</c:v>
                  </c:pt>
                  <c:pt idx="42">
                    <c:v>0.22260119630957853</c:v>
                  </c:pt>
                  <c:pt idx="43">
                    <c:v>0.13196699745705989</c:v>
                  </c:pt>
                  <c:pt idx="44">
                    <c:v>7.5382486200748861E-2</c:v>
                  </c:pt>
                  <c:pt idx="45">
                    <c:v>2.7751123788952548E-2</c:v>
                  </c:pt>
                  <c:pt idx="46">
                    <c:v>3.5053347221427326E-2</c:v>
                  </c:pt>
                  <c:pt idx="47">
                    <c:v>3.0498940474975762E-2</c:v>
                  </c:pt>
                  <c:pt idx="48">
                    <c:v>3.9733969544807582E-2</c:v>
                  </c:pt>
                  <c:pt idx="49">
                    <c:v>6.0130003852056094E-2</c:v>
                  </c:pt>
                  <c:pt idx="50">
                    <c:v>6.739300035440042E-2</c:v>
                  </c:pt>
                  <c:pt idx="51">
                    <c:v>8.5817447128771832E-2</c:v>
                  </c:pt>
                  <c:pt idx="52">
                    <c:v>0.17587300377572782</c:v>
                  </c:pt>
                  <c:pt idx="53">
                    <c:v>0.14431526764563871</c:v>
                  </c:pt>
                  <c:pt idx="54">
                    <c:v>0.16003114370381458</c:v>
                  </c:pt>
                  <c:pt idx="55">
                    <c:v>0.16048717997960357</c:v>
                  </c:pt>
                  <c:pt idx="56">
                    <c:v>0.10488743226024459</c:v>
                  </c:pt>
                  <c:pt idx="57">
                    <c:v>1.4294649193360489E-2</c:v>
                  </c:pt>
                  <c:pt idx="58">
                    <c:v>3.4527591483760707E-3</c:v>
                  </c:pt>
                  <c:pt idx="59">
                    <c:v>9.6072601940716904E-3</c:v>
                  </c:pt>
                  <c:pt idx="60">
                    <c:v>1.3889220263233576E-2</c:v>
                  </c:pt>
                  <c:pt idx="61">
                    <c:v>1.9136361891507213E-2</c:v>
                  </c:pt>
                  <c:pt idx="62">
                    <c:v>6.7017371976798266E-3</c:v>
                  </c:pt>
                  <c:pt idx="63">
                    <c:v>0</c:v>
                  </c:pt>
                  <c:pt idx="64">
                    <c:v>0</c:v>
                  </c:pt>
                  <c:pt idx="65">
                    <c:v>0</c:v>
                  </c:pt>
                  <c:pt idx="66">
                    <c:v>5.914678863917234E-4</c:v>
                  </c:pt>
                  <c:pt idx="67">
                    <c:v>2.1689623449719472E-3</c:v>
                  </c:pt>
                  <c:pt idx="68">
                    <c:v>0</c:v>
                  </c:pt>
                  <c:pt idx="69">
                    <c:v>0</c:v>
                  </c:pt>
                  <c:pt idx="70">
                    <c:v>2.2639198743828314E-3</c:v>
                  </c:pt>
                  <c:pt idx="7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mol %'!$X$379:$X$450</c:f>
              <c:strCache>
                <c:ptCount val="72"/>
                <c:pt idx="0">
                  <c:v> 50:1</c:v>
                </c:pt>
                <c:pt idx="1">
                  <c:v> 50:2</c:v>
                </c:pt>
                <c:pt idx="2">
                  <c:v> 50:3</c:v>
                </c:pt>
                <c:pt idx="3">
                  <c:v> 52:2</c:v>
                </c:pt>
                <c:pt idx="4">
                  <c:v> 52:3</c:v>
                </c:pt>
                <c:pt idx="5">
                  <c:v> 52:4</c:v>
                </c:pt>
                <c:pt idx="6">
                  <c:v> 52:5</c:v>
                </c:pt>
                <c:pt idx="7">
                  <c:v> 52:6</c:v>
                </c:pt>
                <c:pt idx="8">
                  <c:v> 52:7</c:v>
                </c:pt>
                <c:pt idx="9">
                  <c:v> 54:1</c:v>
                </c:pt>
                <c:pt idx="10">
                  <c:v> 54:2</c:v>
                </c:pt>
                <c:pt idx="11">
                  <c:v> 54:3</c:v>
                </c:pt>
                <c:pt idx="12">
                  <c:v> 54:4</c:v>
                </c:pt>
                <c:pt idx="13">
                  <c:v> 54:5</c:v>
                </c:pt>
                <c:pt idx="14">
                  <c:v> 54:6</c:v>
                </c:pt>
                <c:pt idx="15">
                  <c:v> 54:7</c:v>
                </c:pt>
                <c:pt idx="16">
                  <c:v> 54:8</c:v>
                </c:pt>
                <c:pt idx="17">
                  <c:v> 54:9</c:v>
                </c:pt>
                <c:pt idx="18">
                  <c:v> 54:10</c:v>
                </c:pt>
                <c:pt idx="19">
                  <c:v> 54:11</c:v>
                </c:pt>
                <c:pt idx="20">
                  <c:v> 54:12</c:v>
                </c:pt>
                <c:pt idx="21">
                  <c:v> 56:1</c:v>
                </c:pt>
                <c:pt idx="22">
                  <c:v> 56:2</c:v>
                </c:pt>
                <c:pt idx="23">
                  <c:v> 56:3</c:v>
                </c:pt>
                <c:pt idx="24">
                  <c:v> 56:4</c:v>
                </c:pt>
                <c:pt idx="25">
                  <c:v> 56:5</c:v>
                </c:pt>
                <c:pt idx="26">
                  <c:v> 56:6</c:v>
                </c:pt>
                <c:pt idx="27">
                  <c:v> 56:7</c:v>
                </c:pt>
                <c:pt idx="28">
                  <c:v> 56:8</c:v>
                </c:pt>
                <c:pt idx="29">
                  <c:v> 56:9</c:v>
                </c:pt>
                <c:pt idx="30">
                  <c:v> 56:10</c:v>
                </c:pt>
                <c:pt idx="31">
                  <c:v> 56:11</c:v>
                </c:pt>
                <c:pt idx="32">
                  <c:v> 56:12</c:v>
                </c:pt>
                <c:pt idx="33">
                  <c:v> 58:2</c:v>
                </c:pt>
                <c:pt idx="34">
                  <c:v> 58:3</c:v>
                </c:pt>
                <c:pt idx="35">
                  <c:v> 58:4</c:v>
                </c:pt>
                <c:pt idx="36">
                  <c:v> 58:5</c:v>
                </c:pt>
                <c:pt idx="37">
                  <c:v> 58:6</c:v>
                </c:pt>
                <c:pt idx="38">
                  <c:v> 58:7</c:v>
                </c:pt>
                <c:pt idx="39">
                  <c:v> 58:8</c:v>
                </c:pt>
                <c:pt idx="40">
                  <c:v> 58:9</c:v>
                </c:pt>
                <c:pt idx="41">
                  <c:v> 58:10</c:v>
                </c:pt>
                <c:pt idx="42">
                  <c:v> 58:11</c:v>
                </c:pt>
                <c:pt idx="43">
                  <c:v> 58:12</c:v>
                </c:pt>
                <c:pt idx="44">
                  <c:v> 58:13</c:v>
                </c:pt>
                <c:pt idx="45">
                  <c:v> 60:3</c:v>
                </c:pt>
                <c:pt idx="46">
                  <c:v> 60:4</c:v>
                </c:pt>
                <c:pt idx="47">
                  <c:v> 60:5</c:v>
                </c:pt>
                <c:pt idx="48">
                  <c:v> 60:6</c:v>
                </c:pt>
                <c:pt idx="49">
                  <c:v> 60:7</c:v>
                </c:pt>
                <c:pt idx="50">
                  <c:v> 60:8</c:v>
                </c:pt>
                <c:pt idx="51">
                  <c:v> 60:9</c:v>
                </c:pt>
                <c:pt idx="52">
                  <c:v> 60:10</c:v>
                </c:pt>
                <c:pt idx="53">
                  <c:v> 60:11</c:v>
                </c:pt>
                <c:pt idx="54">
                  <c:v> 60:12</c:v>
                </c:pt>
                <c:pt idx="55">
                  <c:v> 60:13</c:v>
                </c:pt>
                <c:pt idx="56">
                  <c:v> 60:14</c:v>
                </c:pt>
                <c:pt idx="57">
                  <c:v> 60:15</c:v>
                </c:pt>
                <c:pt idx="58">
                  <c:v> 62:11</c:v>
                </c:pt>
                <c:pt idx="59">
                  <c:v> 62:12</c:v>
                </c:pt>
                <c:pt idx="60">
                  <c:v> 62:13</c:v>
                </c:pt>
                <c:pt idx="61">
                  <c:v> 62:14</c:v>
                </c:pt>
                <c:pt idx="62">
                  <c:v> 62:15</c:v>
                </c:pt>
                <c:pt idx="63">
                  <c:v> 62:16</c:v>
                </c:pt>
                <c:pt idx="64">
                  <c:v> 64:13</c:v>
                </c:pt>
                <c:pt idx="65">
                  <c:v> 64:14</c:v>
                </c:pt>
                <c:pt idx="66">
                  <c:v> 64:15</c:v>
                </c:pt>
                <c:pt idx="67">
                  <c:v> 64:16</c:v>
                </c:pt>
                <c:pt idx="68">
                  <c:v> 64:17</c:v>
                </c:pt>
                <c:pt idx="69">
                  <c:v> 66:16</c:v>
                </c:pt>
                <c:pt idx="70">
                  <c:v> 66:17</c:v>
                </c:pt>
                <c:pt idx="71">
                  <c:v> 66:18</c:v>
                </c:pt>
              </c:strCache>
            </c:strRef>
          </c:cat>
          <c:val>
            <c:numRef>
              <c:f>'nmol %'!$AE$379:$AE$450</c:f>
              <c:numCache>
                <c:formatCode>0.00</c:formatCode>
                <c:ptCount val="72"/>
                <c:pt idx="0">
                  <c:v>0.46480292648776622</c:v>
                </c:pt>
                <c:pt idx="1">
                  <c:v>0.54058621944729901</c:v>
                </c:pt>
                <c:pt idx="2">
                  <c:v>0.37132910171227484</c:v>
                </c:pt>
                <c:pt idx="3">
                  <c:v>2.4839591905901819</c:v>
                </c:pt>
                <c:pt idx="4">
                  <c:v>1.8920205101887426</c:v>
                </c:pt>
                <c:pt idx="5">
                  <c:v>2.7353365001864005</c:v>
                </c:pt>
                <c:pt idx="6">
                  <c:v>2.182845120460001</c:v>
                </c:pt>
                <c:pt idx="7">
                  <c:v>1.6031773049890994</c:v>
                </c:pt>
                <c:pt idx="8">
                  <c:v>0.19982407785811926</c:v>
                </c:pt>
                <c:pt idx="9">
                  <c:v>0.25644785765429401</c:v>
                </c:pt>
                <c:pt idx="10">
                  <c:v>2.1207961950965619</c:v>
                </c:pt>
                <c:pt idx="11">
                  <c:v>3.6576465085273795</c:v>
                </c:pt>
                <c:pt idx="12">
                  <c:v>4.3909164729221191</c:v>
                </c:pt>
                <c:pt idx="13">
                  <c:v>5.3679908170636628</c:v>
                </c:pt>
                <c:pt idx="14">
                  <c:v>3.9933091698663339</c:v>
                </c:pt>
                <c:pt idx="15">
                  <c:v>3.4927433531333905</c:v>
                </c:pt>
                <c:pt idx="16">
                  <c:v>2.0002700268442881</c:v>
                </c:pt>
                <c:pt idx="17">
                  <c:v>0.61912730743329092</c:v>
                </c:pt>
                <c:pt idx="18">
                  <c:v>0.29173528214350292</c:v>
                </c:pt>
                <c:pt idx="19">
                  <c:v>0.23253144244261334</c:v>
                </c:pt>
                <c:pt idx="20">
                  <c:v>0.16253366944343817</c:v>
                </c:pt>
                <c:pt idx="21">
                  <c:v>0.10532947736501851</c:v>
                </c:pt>
                <c:pt idx="22">
                  <c:v>0.61446682642871675</c:v>
                </c:pt>
                <c:pt idx="23">
                  <c:v>2.5124969781980457</c:v>
                </c:pt>
                <c:pt idx="24">
                  <c:v>4.3490377653918548</c:v>
                </c:pt>
                <c:pt idx="25">
                  <c:v>5.5055277994079832</c:v>
                </c:pt>
                <c:pt idx="26">
                  <c:v>6.3235325556482307</c:v>
                </c:pt>
                <c:pt idx="27">
                  <c:v>5.3884541189271085</c:v>
                </c:pt>
                <c:pt idx="28">
                  <c:v>4.4692981265201155</c:v>
                </c:pt>
                <c:pt idx="29">
                  <c:v>3.0797628310827783</c:v>
                </c:pt>
                <c:pt idx="30">
                  <c:v>1.9150512197183858</c:v>
                </c:pt>
                <c:pt idx="31">
                  <c:v>0.60873202412403082</c:v>
                </c:pt>
                <c:pt idx="32">
                  <c:v>0.20223381579728783</c:v>
                </c:pt>
                <c:pt idx="33">
                  <c:v>0.21318082321759757</c:v>
                </c:pt>
                <c:pt idx="34">
                  <c:v>0.61982356837185038</c:v>
                </c:pt>
                <c:pt idx="35">
                  <c:v>0.92102920922126741</c:v>
                </c:pt>
                <c:pt idx="36">
                  <c:v>1.3364329858272435</c:v>
                </c:pt>
                <c:pt idx="37">
                  <c:v>2.0906507108410302</c:v>
                </c:pt>
                <c:pt idx="38">
                  <c:v>3.2926959625882048</c:v>
                </c:pt>
                <c:pt idx="39">
                  <c:v>3.3374544238575976</c:v>
                </c:pt>
                <c:pt idx="40">
                  <c:v>2.6580597344068693</c:v>
                </c:pt>
                <c:pt idx="41">
                  <c:v>2.2528719859275514</c:v>
                </c:pt>
                <c:pt idx="42">
                  <c:v>2.1779627332632874</c:v>
                </c:pt>
                <c:pt idx="43">
                  <c:v>0.99194206632095783</c:v>
                </c:pt>
                <c:pt idx="44">
                  <c:v>0.45902101940088946</c:v>
                </c:pt>
                <c:pt idx="45">
                  <c:v>7.4466137018008582E-2</c:v>
                </c:pt>
                <c:pt idx="46">
                  <c:v>8.9297099032034713E-2</c:v>
                </c:pt>
                <c:pt idx="47">
                  <c:v>0.14352422118094824</c:v>
                </c:pt>
                <c:pt idx="48">
                  <c:v>0.24545689393857173</c:v>
                </c:pt>
                <c:pt idx="49">
                  <c:v>0.33018474025780031</c:v>
                </c:pt>
                <c:pt idx="50">
                  <c:v>0.33981273290960096</c:v>
                </c:pt>
                <c:pt idx="51">
                  <c:v>0.49905965081610398</c:v>
                </c:pt>
                <c:pt idx="52">
                  <c:v>0.65064336850676552</c:v>
                </c:pt>
                <c:pt idx="53">
                  <c:v>0.65720831315230177</c:v>
                </c:pt>
                <c:pt idx="54">
                  <c:v>0.596510279154427</c:v>
                </c:pt>
                <c:pt idx="55">
                  <c:v>0.59807508957506494</c:v>
                </c:pt>
                <c:pt idx="56">
                  <c:v>0.4490948128215832</c:v>
                </c:pt>
                <c:pt idx="57">
                  <c:v>9.6017927251782417E-2</c:v>
                </c:pt>
                <c:pt idx="58">
                  <c:v>1.6564479965623907E-2</c:v>
                </c:pt>
                <c:pt idx="59">
                  <c:v>2.9894660802600295E-2</c:v>
                </c:pt>
                <c:pt idx="60">
                  <c:v>3.5560334687189409E-2</c:v>
                </c:pt>
                <c:pt idx="61">
                  <c:v>4.603962978954252E-2</c:v>
                </c:pt>
                <c:pt idx="62">
                  <c:v>2.4703125345055046E-2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5.914678863917234E-4</c:v>
                </c:pt>
                <c:pt idx="67">
                  <c:v>2.1689623449719472E-3</c:v>
                </c:pt>
                <c:pt idx="68">
                  <c:v>0</c:v>
                </c:pt>
                <c:pt idx="69">
                  <c:v>0</c:v>
                </c:pt>
                <c:pt idx="70">
                  <c:v>2.2639198743828319E-3</c:v>
                </c:pt>
                <c:pt idx="7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D6-49DB-B61E-071883C4D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9523776"/>
        <c:axId val="619531648"/>
      </c:barChart>
      <c:catAx>
        <c:axId val="619523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531648"/>
        <c:crosses val="autoZero"/>
        <c:auto val="1"/>
        <c:lblAlgn val="ctr"/>
        <c:lblOffset val="100"/>
        <c:noMultiLvlLbl val="0"/>
      </c:catAx>
      <c:valAx>
        <c:axId val="6195316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nmol %</a:t>
                </a:r>
              </a:p>
            </c:rich>
          </c:tx>
          <c:layout>
            <c:manualLayout>
              <c:xMode val="edge"/>
              <c:yMode val="edge"/>
              <c:x val="3.0019767060367453E-2"/>
              <c:y val="0.400880638507377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523776"/>
        <c:crosses val="autoZero"/>
        <c:crossBetween val="between"/>
        <c:majorUnit val="1"/>
      </c:valAx>
      <c:spPr>
        <a:noFill/>
        <a:ln>
          <a:solidFill>
            <a:sysClr val="windowText" lastClr="000000"/>
          </a:solidFill>
        </a:ln>
        <a:effectLst/>
      </c:spPr>
    </c:plotArea>
    <c:legend>
      <c:legendPos val="t"/>
      <c:layout>
        <c:manualLayout>
          <c:xMode val="edge"/>
          <c:yMode val="edge"/>
          <c:x val="0.6125609416010499"/>
          <c:y val="0.15696946843559348"/>
          <c:w val="0.18595833333333336"/>
          <c:h val="6.50071370732269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44004629629629"/>
          <c:y val="4.4964687357508866E-2"/>
          <c:w val="0.81300439814814818"/>
          <c:h val="0.741917341398896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DHA charts'!$AD$83</c:f>
              <c:strCache>
                <c:ptCount val="1"/>
                <c:pt idx="0">
                  <c:v>DHA1</c:v>
                </c:pt>
              </c:strCache>
            </c:strRef>
          </c:tx>
          <c:spPr>
            <a:solidFill>
              <a:srgbClr val="18377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87:$AS$8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plus>
            <c:minus>
              <c:numRef>
                <c:f>'FT2018 DHA charts'!$AE$87:$AS$8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82:$AS$8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83:$AS$83</c:f>
              <c:numCache>
                <c:formatCode>0</c:formatCode>
                <c:ptCount val="15"/>
                <c:pt idx="0">
                  <c:v>8.2710144397972503</c:v>
                </c:pt>
                <c:pt idx="1">
                  <c:v>4.5881471674217345</c:v>
                </c:pt>
                <c:pt idx="2">
                  <c:v>5.0036967655752855</c:v>
                </c:pt>
                <c:pt idx="3">
                  <c:v>20.986278449836853</c:v>
                </c:pt>
                <c:pt idx="4">
                  <c:v>2.7225284814036752</c:v>
                </c:pt>
                <c:pt idx="5">
                  <c:v>13.615698491926382</c:v>
                </c:pt>
                <c:pt idx="6">
                  <c:v>1.9902900511693129</c:v>
                </c:pt>
                <c:pt idx="7">
                  <c:v>4.3843471499260485</c:v>
                </c:pt>
                <c:pt idx="8">
                  <c:v>0.65267945689110618</c:v>
                </c:pt>
                <c:pt idx="9">
                  <c:v>2.9245015805479837</c:v>
                </c:pt>
                <c:pt idx="10">
                  <c:v>2.6839962456606936</c:v>
                </c:pt>
                <c:pt idx="11">
                  <c:v>10.605406223208179</c:v>
                </c:pt>
                <c:pt idx="12">
                  <c:v>4.0354133372372276</c:v>
                </c:pt>
                <c:pt idx="13">
                  <c:v>8.5803454825515466</c:v>
                </c:pt>
                <c:pt idx="14">
                  <c:v>8.9556566768467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E5-441E-A3A7-C7B329F24B9E}"/>
            </c:ext>
          </c:extLst>
        </c:ser>
        <c:ser>
          <c:idx val="1"/>
          <c:order val="1"/>
          <c:tx>
            <c:strRef>
              <c:f>'FT2018 DHA charts'!$AD$84</c:f>
              <c:strCache>
                <c:ptCount val="1"/>
                <c:pt idx="0">
                  <c:v>DHA3</c:v>
                </c:pt>
              </c:strCache>
            </c:strRef>
          </c:tx>
          <c:spPr>
            <a:solidFill>
              <a:srgbClr val="6D89CB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88:$AS$88</c:f>
                <c:numCache>
                  <c:formatCode>General</c:formatCode>
                  <c:ptCount val="15"/>
                  <c:pt idx="0">
                    <c:v>0.79020270122542613</c:v>
                  </c:pt>
                  <c:pt idx="1">
                    <c:v>0.38614298394888363</c:v>
                  </c:pt>
                  <c:pt idx="2">
                    <c:v>1.590454459611687</c:v>
                  </c:pt>
                  <c:pt idx="3">
                    <c:v>1.1523017339230672</c:v>
                  </c:pt>
                  <c:pt idx="4">
                    <c:v>0.43085101693688799</c:v>
                  </c:pt>
                  <c:pt idx="5">
                    <c:v>3.3681762758890024</c:v>
                  </c:pt>
                  <c:pt idx="6">
                    <c:v>0.2906325292159726</c:v>
                  </c:pt>
                  <c:pt idx="7">
                    <c:v>0.57480371383329232</c:v>
                  </c:pt>
                  <c:pt idx="8">
                    <c:v>0.39758551115357371</c:v>
                  </c:pt>
                  <c:pt idx="9">
                    <c:v>0.81417256507021452</c:v>
                  </c:pt>
                  <c:pt idx="10">
                    <c:v>0.38196660894370293</c:v>
                  </c:pt>
                  <c:pt idx="11">
                    <c:v>0.78428359573072737</c:v>
                  </c:pt>
                  <c:pt idx="12">
                    <c:v>0.23924150935971791</c:v>
                  </c:pt>
                  <c:pt idx="13">
                    <c:v>0.68891592740747232</c:v>
                  </c:pt>
                  <c:pt idx="14">
                    <c:v>1.1416936640361768</c:v>
                  </c:pt>
                </c:numCache>
              </c:numRef>
            </c:plus>
            <c:minus>
              <c:numRef>
                <c:f>'FT2018 DHA charts'!$AE$88:$AS$88</c:f>
                <c:numCache>
                  <c:formatCode>General</c:formatCode>
                  <c:ptCount val="15"/>
                  <c:pt idx="0">
                    <c:v>0.79020270122542613</c:v>
                  </c:pt>
                  <c:pt idx="1">
                    <c:v>0.38614298394888363</c:v>
                  </c:pt>
                  <c:pt idx="2">
                    <c:v>1.590454459611687</c:v>
                  </c:pt>
                  <c:pt idx="3">
                    <c:v>1.1523017339230672</c:v>
                  </c:pt>
                  <c:pt idx="4">
                    <c:v>0.43085101693688799</c:v>
                  </c:pt>
                  <c:pt idx="5">
                    <c:v>3.3681762758890024</c:v>
                  </c:pt>
                  <c:pt idx="6">
                    <c:v>0.2906325292159726</c:v>
                  </c:pt>
                  <c:pt idx="7">
                    <c:v>0.57480371383329232</c:v>
                  </c:pt>
                  <c:pt idx="8">
                    <c:v>0.39758551115357371</c:v>
                  </c:pt>
                  <c:pt idx="9">
                    <c:v>0.81417256507021452</c:v>
                  </c:pt>
                  <c:pt idx="10">
                    <c:v>0.38196660894370293</c:v>
                  </c:pt>
                  <c:pt idx="11">
                    <c:v>0.78428359573072737</c:v>
                  </c:pt>
                  <c:pt idx="12">
                    <c:v>0.23924150935971791</c:v>
                  </c:pt>
                  <c:pt idx="13">
                    <c:v>0.68891592740747232</c:v>
                  </c:pt>
                  <c:pt idx="14">
                    <c:v>1.14169366403617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82:$AS$8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84:$AS$84</c:f>
              <c:numCache>
                <c:formatCode>0</c:formatCode>
                <c:ptCount val="15"/>
                <c:pt idx="0">
                  <c:v>7.6791329101143058</c:v>
                </c:pt>
                <c:pt idx="1">
                  <c:v>3.4379658633258612</c:v>
                </c:pt>
                <c:pt idx="2">
                  <c:v>12.534081608710929</c:v>
                </c:pt>
                <c:pt idx="3">
                  <c:v>15.308952071256133</c:v>
                </c:pt>
                <c:pt idx="4">
                  <c:v>1.6132857078796552</c:v>
                </c:pt>
                <c:pt idx="5">
                  <c:v>15.979143159326266</c:v>
                </c:pt>
                <c:pt idx="6">
                  <c:v>1.4681994892529926</c:v>
                </c:pt>
                <c:pt idx="7">
                  <c:v>5.97518644778651</c:v>
                </c:pt>
                <c:pt idx="8">
                  <c:v>1.1588089810478919</c:v>
                </c:pt>
                <c:pt idx="9">
                  <c:v>5.9608472748388719</c:v>
                </c:pt>
                <c:pt idx="10">
                  <c:v>1.7765229410831975</c:v>
                </c:pt>
                <c:pt idx="11">
                  <c:v>13.873845782221844</c:v>
                </c:pt>
                <c:pt idx="12">
                  <c:v>1.7039042795034607</c:v>
                </c:pt>
                <c:pt idx="13">
                  <c:v>2.7883958908280819</c:v>
                </c:pt>
                <c:pt idx="14">
                  <c:v>8.74172759282401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E5-441E-A3A7-C7B329F24B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7013056"/>
        <c:axId val="638373472"/>
      </c:barChart>
      <c:catAx>
        <c:axId val="797013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373472"/>
        <c:crosses val="autoZero"/>
        <c:auto val="1"/>
        <c:lblAlgn val="ctr"/>
        <c:lblOffset val="100"/>
        <c:noMultiLvlLbl val="0"/>
      </c:catAx>
      <c:valAx>
        <c:axId val="638373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baseline="0">
                    <a:solidFill>
                      <a:sysClr val="windowText" lastClr="000000"/>
                    </a:solidFill>
                    <a:effectLst/>
                  </a:rPr>
                  <a:t>FAMEs (mol%)</a:t>
                </a:r>
                <a:endParaRPr lang="zh-CN" altLang="zh-CN" sz="1200" b="0">
                  <a:solidFill>
                    <a:sysClr val="windowText" lastClr="00000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701305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8212209493002207"/>
          <c:y val="5.2920644820393457E-2"/>
          <c:w val="0.28019592690029677"/>
          <c:h val="9.90516838592284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907893518518518"/>
          <c:y val="5.8055555555555555E-2"/>
          <c:w val="0.81085162037037051"/>
          <c:h val="0.725632142857142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DHA charts'!$AD$93</c:f>
              <c:strCache>
                <c:ptCount val="1"/>
                <c:pt idx="0">
                  <c:v>DHA1</c:v>
                </c:pt>
              </c:strCache>
            </c:strRef>
          </c:tx>
          <c:spPr>
            <a:solidFill>
              <a:srgbClr val="18377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97:$AS$9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plus>
            <c:minus>
              <c:numRef>
                <c:f>'FT2018 DHA charts'!$AE$97:$AS$9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92:$AS$9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93:$AS$93</c:f>
              <c:numCache>
                <c:formatCode>0</c:formatCode>
                <c:ptCount val="15"/>
                <c:pt idx="0">
                  <c:v>8.2710144397972503</c:v>
                </c:pt>
                <c:pt idx="1">
                  <c:v>4.5881471674217345</c:v>
                </c:pt>
                <c:pt idx="2">
                  <c:v>5.0036967655752855</c:v>
                </c:pt>
                <c:pt idx="3">
                  <c:v>20.986278449836853</c:v>
                </c:pt>
                <c:pt idx="4">
                  <c:v>2.7225284814036752</c:v>
                </c:pt>
                <c:pt idx="5">
                  <c:v>13.615698491926382</c:v>
                </c:pt>
                <c:pt idx="6">
                  <c:v>1.9902900511693129</c:v>
                </c:pt>
                <c:pt idx="7">
                  <c:v>4.3843471499260485</c:v>
                </c:pt>
                <c:pt idx="8">
                  <c:v>0.65267945689110618</c:v>
                </c:pt>
                <c:pt idx="9">
                  <c:v>2.9245015805479837</c:v>
                </c:pt>
                <c:pt idx="10">
                  <c:v>2.6839962456606936</c:v>
                </c:pt>
                <c:pt idx="11">
                  <c:v>10.605406223208179</c:v>
                </c:pt>
                <c:pt idx="12">
                  <c:v>4.0354133372372276</c:v>
                </c:pt>
                <c:pt idx="13">
                  <c:v>8.5803454825515466</c:v>
                </c:pt>
                <c:pt idx="14">
                  <c:v>8.9556566768467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D5-4B1B-AD97-BD4738C94AE4}"/>
            </c:ext>
          </c:extLst>
        </c:ser>
        <c:ser>
          <c:idx val="1"/>
          <c:order val="1"/>
          <c:tx>
            <c:strRef>
              <c:f>'FT2018 DHA charts'!$AD$94</c:f>
              <c:strCache>
                <c:ptCount val="1"/>
                <c:pt idx="0">
                  <c:v>DHA4</c:v>
                </c:pt>
              </c:strCache>
            </c:strRef>
          </c:tx>
          <c:spPr>
            <a:solidFill>
              <a:srgbClr val="A8BDE7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98:$AS$98</c:f>
                <c:numCache>
                  <c:formatCode>General</c:formatCode>
                  <c:ptCount val="15"/>
                  <c:pt idx="0">
                    <c:v>0.60789085776018026</c:v>
                  </c:pt>
                  <c:pt idx="1">
                    <c:v>0.43627239644349197</c:v>
                  </c:pt>
                  <c:pt idx="2">
                    <c:v>1.6393402289368686</c:v>
                  </c:pt>
                  <c:pt idx="3">
                    <c:v>1.2940066900688307</c:v>
                  </c:pt>
                  <c:pt idx="4">
                    <c:v>0.19127531476619339</c:v>
                  </c:pt>
                  <c:pt idx="5">
                    <c:v>1.9736284176609662</c:v>
                  </c:pt>
                  <c:pt idx="6">
                    <c:v>0.34247192096489626</c:v>
                  </c:pt>
                  <c:pt idx="7">
                    <c:v>0.47105752259200073</c:v>
                  </c:pt>
                  <c:pt idx="8">
                    <c:v>0.43704618418374652</c:v>
                  </c:pt>
                  <c:pt idx="9">
                    <c:v>1.301989275743328</c:v>
                  </c:pt>
                  <c:pt idx="10">
                    <c:v>0.61641068591714998</c:v>
                  </c:pt>
                  <c:pt idx="11">
                    <c:v>1.0195535554815072</c:v>
                  </c:pt>
                  <c:pt idx="12">
                    <c:v>0.16250397150409074</c:v>
                  </c:pt>
                  <c:pt idx="13">
                    <c:v>0.29738043369148603</c:v>
                  </c:pt>
                  <c:pt idx="14">
                    <c:v>0.63698790783321502</c:v>
                  </c:pt>
                </c:numCache>
              </c:numRef>
            </c:plus>
            <c:minus>
              <c:numRef>
                <c:f>'FT2018 DHA charts'!$AE$98:$AS$98</c:f>
                <c:numCache>
                  <c:formatCode>General</c:formatCode>
                  <c:ptCount val="15"/>
                  <c:pt idx="0">
                    <c:v>0.60789085776018026</c:v>
                  </c:pt>
                  <c:pt idx="1">
                    <c:v>0.43627239644349197</c:v>
                  </c:pt>
                  <c:pt idx="2">
                    <c:v>1.6393402289368686</c:v>
                  </c:pt>
                  <c:pt idx="3">
                    <c:v>1.2940066900688307</c:v>
                  </c:pt>
                  <c:pt idx="4">
                    <c:v>0.19127531476619339</c:v>
                  </c:pt>
                  <c:pt idx="5">
                    <c:v>1.9736284176609662</c:v>
                  </c:pt>
                  <c:pt idx="6">
                    <c:v>0.34247192096489626</c:v>
                  </c:pt>
                  <c:pt idx="7">
                    <c:v>0.47105752259200073</c:v>
                  </c:pt>
                  <c:pt idx="8">
                    <c:v>0.43704618418374652</c:v>
                  </c:pt>
                  <c:pt idx="9">
                    <c:v>1.301989275743328</c:v>
                  </c:pt>
                  <c:pt idx="10">
                    <c:v>0.61641068591714998</c:v>
                  </c:pt>
                  <c:pt idx="11">
                    <c:v>1.0195535554815072</c:v>
                  </c:pt>
                  <c:pt idx="12">
                    <c:v>0.16250397150409074</c:v>
                  </c:pt>
                  <c:pt idx="13">
                    <c:v>0.29738043369148603</c:v>
                  </c:pt>
                  <c:pt idx="14">
                    <c:v>0.636987907833215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92:$AS$9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94:$AS$94</c:f>
              <c:numCache>
                <c:formatCode>0</c:formatCode>
                <c:ptCount val="15"/>
                <c:pt idx="0">
                  <c:v>7.9572958632675563</c:v>
                </c:pt>
                <c:pt idx="1">
                  <c:v>3.5038174849052846</c:v>
                </c:pt>
                <c:pt idx="2">
                  <c:v>11.140024585788801</c:v>
                </c:pt>
                <c:pt idx="3">
                  <c:v>18.023400382104764</c:v>
                </c:pt>
                <c:pt idx="4">
                  <c:v>2.780813719256257</c:v>
                </c:pt>
                <c:pt idx="5">
                  <c:v>9.5522495093099451</c:v>
                </c:pt>
                <c:pt idx="6">
                  <c:v>2.4071747318186096</c:v>
                </c:pt>
                <c:pt idx="7">
                  <c:v>5.0527089837695645</c:v>
                </c:pt>
                <c:pt idx="8">
                  <c:v>2.6346693178920932</c:v>
                </c:pt>
                <c:pt idx="9">
                  <c:v>7.8803213819172555</c:v>
                </c:pt>
                <c:pt idx="10">
                  <c:v>2.7568861617672131</c:v>
                </c:pt>
                <c:pt idx="11">
                  <c:v>14.260406264357133</c:v>
                </c:pt>
                <c:pt idx="12">
                  <c:v>0.98663354271084447</c:v>
                </c:pt>
                <c:pt idx="13">
                  <c:v>2.2514278179197702</c:v>
                </c:pt>
                <c:pt idx="14">
                  <c:v>8.81217025321490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D5-4B1B-AD97-BD4738C94A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2643776"/>
        <c:axId val="374406224"/>
      </c:barChart>
      <c:catAx>
        <c:axId val="952643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4406224"/>
        <c:crosses val="autoZero"/>
        <c:auto val="1"/>
        <c:lblAlgn val="ctr"/>
        <c:lblOffset val="100"/>
        <c:noMultiLvlLbl val="0"/>
      </c:catAx>
      <c:valAx>
        <c:axId val="3744062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baseline="0">
                    <a:solidFill>
                      <a:sysClr val="windowText" lastClr="000000"/>
                    </a:solidFill>
                    <a:effectLst/>
                  </a:rPr>
                  <a:t>FAMEs (mol%)</a:t>
                </a:r>
                <a:endParaRPr lang="zh-CN" altLang="zh-CN" sz="1200" b="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5.5580153690673685E-2"/>
              <c:y val="0.268407489051011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264377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9319454967250238"/>
          <c:y val="7.6229579837673464E-2"/>
          <c:w val="0.25977049618547499"/>
          <c:h val="9.93922163121233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73171296296296"/>
          <c:y val="5.5995008928980267E-2"/>
          <c:w val="0.81071273148148137"/>
          <c:h val="0.727692857142857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DHA charts'!$AD$103</c:f>
              <c:strCache>
                <c:ptCount val="1"/>
                <c:pt idx="0">
                  <c:v>DHA1</c:v>
                </c:pt>
              </c:strCache>
            </c:strRef>
          </c:tx>
          <c:spPr>
            <a:solidFill>
              <a:srgbClr val="18377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107:$AS$10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plus>
            <c:minus>
              <c:numRef>
                <c:f>'FT2018 DHA charts'!$AE$107:$AS$107</c:f>
                <c:numCache>
                  <c:formatCode>General</c:formatCode>
                  <c:ptCount val="15"/>
                  <c:pt idx="0">
                    <c:v>0.79666526611789723</c:v>
                  </c:pt>
                  <c:pt idx="1">
                    <c:v>0.58452285535462434</c:v>
                  </c:pt>
                  <c:pt idx="2">
                    <c:v>1.1212011492047724</c:v>
                  </c:pt>
                  <c:pt idx="3">
                    <c:v>2.5761591667453216</c:v>
                  </c:pt>
                  <c:pt idx="4">
                    <c:v>0.50254058092589771</c:v>
                  </c:pt>
                  <c:pt idx="5">
                    <c:v>3.1053086350912866</c:v>
                  </c:pt>
                  <c:pt idx="6">
                    <c:v>0.33553132259115953</c:v>
                  </c:pt>
                  <c:pt idx="7">
                    <c:v>0.52638453376921579</c:v>
                  </c:pt>
                  <c:pt idx="8">
                    <c:v>0.14416515610107358</c:v>
                  </c:pt>
                  <c:pt idx="9">
                    <c:v>0.51093545996335366</c:v>
                  </c:pt>
                  <c:pt idx="10">
                    <c:v>0.47474646992653674</c:v>
                  </c:pt>
                  <c:pt idx="11">
                    <c:v>0.80871812033374202</c:v>
                  </c:pt>
                  <c:pt idx="12">
                    <c:v>0.53812519989248497</c:v>
                  </c:pt>
                  <c:pt idx="13">
                    <c:v>0.92116719604445707</c:v>
                  </c:pt>
                  <c:pt idx="14">
                    <c:v>0.955253208372870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102:$AS$10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103:$AS$103</c:f>
              <c:numCache>
                <c:formatCode>0</c:formatCode>
                <c:ptCount val="15"/>
                <c:pt idx="0">
                  <c:v>8.2710144397972503</c:v>
                </c:pt>
                <c:pt idx="1">
                  <c:v>4.5881471674217345</c:v>
                </c:pt>
                <c:pt idx="2">
                  <c:v>5.0036967655752855</c:v>
                </c:pt>
                <c:pt idx="3">
                  <c:v>20.986278449836853</c:v>
                </c:pt>
                <c:pt idx="4">
                  <c:v>2.7225284814036752</c:v>
                </c:pt>
                <c:pt idx="5">
                  <c:v>13.615698491926382</c:v>
                </c:pt>
                <c:pt idx="6">
                  <c:v>1.9902900511693129</c:v>
                </c:pt>
                <c:pt idx="7">
                  <c:v>4.3843471499260485</c:v>
                </c:pt>
                <c:pt idx="8">
                  <c:v>0.65267945689110618</c:v>
                </c:pt>
                <c:pt idx="9">
                  <c:v>2.9245015805479837</c:v>
                </c:pt>
                <c:pt idx="10">
                  <c:v>2.6839962456606936</c:v>
                </c:pt>
                <c:pt idx="11">
                  <c:v>10.605406223208179</c:v>
                </c:pt>
                <c:pt idx="12">
                  <c:v>4.0354133372372276</c:v>
                </c:pt>
                <c:pt idx="13">
                  <c:v>8.5803454825515466</c:v>
                </c:pt>
                <c:pt idx="14">
                  <c:v>8.9556566768467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39-466D-B7F1-EA72FBA47640}"/>
            </c:ext>
          </c:extLst>
        </c:ser>
        <c:ser>
          <c:idx val="1"/>
          <c:order val="1"/>
          <c:tx>
            <c:strRef>
              <c:f>'FT2018 DHA charts'!$AD$104</c:f>
              <c:strCache>
                <c:ptCount val="1"/>
                <c:pt idx="0">
                  <c:v>DHA5</c:v>
                </c:pt>
              </c:strCache>
            </c:strRef>
          </c:tx>
          <c:spPr>
            <a:solidFill>
              <a:srgbClr val="D8DFFB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DHA charts'!$AE$108:$AS$108</c:f>
                <c:numCache>
                  <c:formatCode>General</c:formatCode>
                  <c:ptCount val="15"/>
                  <c:pt idx="0">
                    <c:v>0.64890959339244791</c:v>
                  </c:pt>
                  <c:pt idx="1">
                    <c:v>0.31397915290486</c:v>
                  </c:pt>
                  <c:pt idx="2">
                    <c:v>0.42334518957686001</c:v>
                  </c:pt>
                  <c:pt idx="3">
                    <c:v>2.1887285506942846</c:v>
                  </c:pt>
                  <c:pt idx="4">
                    <c:v>0.5439588434386462</c:v>
                  </c:pt>
                  <c:pt idx="5">
                    <c:v>2.4853774495257963</c:v>
                  </c:pt>
                  <c:pt idx="6">
                    <c:v>0.22566952964842915</c:v>
                  </c:pt>
                  <c:pt idx="7">
                    <c:v>0.54326501373004743</c:v>
                  </c:pt>
                  <c:pt idx="8">
                    <c:v>5.2563812065668077E-2</c:v>
                  </c:pt>
                  <c:pt idx="9">
                    <c:v>0.40261516130949843</c:v>
                  </c:pt>
                  <c:pt idx="10">
                    <c:v>0.16050130471331717</c:v>
                  </c:pt>
                  <c:pt idx="11">
                    <c:v>0.71447179061164501</c:v>
                  </c:pt>
                  <c:pt idx="12">
                    <c:v>0.35065659845718306</c:v>
                  </c:pt>
                  <c:pt idx="13">
                    <c:v>0.52576296481024354</c:v>
                  </c:pt>
                  <c:pt idx="14">
                    <c:v>0.66248680769861867</c:v>
                  </c:pt>
                </c:numCache>
              </c:numRef>
            </c:plus>
            <c:minus>
              <c:numRef>
                <c:f>'FT2018 DHA charts'!$AE$108:$AS$108</c:f>
                <c:numCache>
                  <c:formatCode>General</c:formatCode>
                  <c:ptCount val="15"/>
                  <c:pt idx="0">
                    <c:v>0.64890959339244791</c:v>
                  </c:pt>
                  <c:pt idx="1">
                    <c:v>0.31397915290486</c:v>
                  </c:pt>
                  <c:pt idx="2">
                    <c:v>0.42334518957686001</c:v>
                  </c:pt>
                  <c:pt idx="3">
                    <c:v>2.1887285506942846</c:v>
                  </c:pt>
                  <c:pt idx="4">
                    <c:v>0.5439588434386462</c:v>
                  </c:pt>
                  <c:pt idx="5">
                    <c:v>2.4853774495257963</c:v>
                  </c:pt>
                  <c:pt idx="6">
                    <c:v>0.22566952964842915</c:v>
                  </c:pt>
                  <c:pt idx="7">
                    <c:v>0.54326501373004743</c:v>
                  </c:pt>
                  <c:pt idx="8">
                    <c:v>5.2563812065668077E-2</c:v>
                  </c:pt>
                  <c:pt idx="9">
                    <c:v>0.40261516130949843</c:v>
                  </c:pt>
                  <c:pt idx="10">
                    <c:v>0.16050130471331717</c:v>
                  </c:pt>
                  <c:pt idx="11">
                    <c:v>0.71447179061164501</c:v>
                  </c:pt>
                  <c:pt idx="12">
                    <c:v>0.35065659845718306</c:v>
                  </c:pt>
                  <c:pt idx="13">
                    <c:v>0.52576296481024354</c:v>
                  </c:pt>
                  <c:pt idx="14">
                    <c:v>0.66248680769861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DHA charts'!$AE$102:$AS$102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DHA charts'!$AE$104:$AS$104</c:f>
              <c:numCache>
                <c:formatCode>0</c:formatCode>
                <c:ptCount val="15"/>
                <c:pt idx="0">
                  <c:v>8.301491579129161</c:v>
                </c:pt>
                <c:pt idx="1">
                  <c:v>3.7755643589203682</c:v>
                </c:pt>
                <c:pt idx="2">
                  <c:v>4.5211780056580029</c:v>
                </c:pt>
                <c:pt idx="3">
                  <c:v>19.600421391331505</c:v>
                </c:pt>
                <c:pt idx="4">
                  <c:v>1.8378755057045604</c:v>
                </c:pt>
                <c:pt idx="5">
                  <c:v>18.939242099638463</c:v>
                </c:pt>
                <c:pt idx="6">
                  <c:v>1.9806754801512119</c:v>
                </c:pt>
                <c:pt idx="7">
                  <c:v>4.3997777459678673</c:v>
                </c:pt>
                <c:pt idx="8">
                  <c:v>0.45006583474044148</c:v>
                </c:pt>
                <c:pt idx="9">
                  <c:v>2.7676866703439069</c:v>
                </c:pt>
                <c:pt idx="10">
                  <c:v>2.0693977267758723</c:v>
                </c:pt>
                <c:pt idx="11">
                  <c:v>10.688852504645523</c:v>
                </c:pt>
                <c:pt idx="12">
                  <c:v>4.7882792880524159</c:v>
                </c:pt>
                <c:pt idx="13">
                  <c:v>7.617961910966196</c:v>
                </c:pt>
                <c:pt idx="14">
                  <c:v>8.2615298979745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39-466D-B7F1-EA72FBA476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7021856"/>
        <c:axId val="638360160"/>
      </c:barChart>
      <c:catAx>
        <c:axId val="797021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360160"/>
        <c:crosses val="autoZero"/>
        <c:auto val="1"/>
        <c:lblAlgn val="ctr"/>
        <c:lblOffset val="100"/>
        <c:noMultiLvlLbl val="0"/>
      </c:catAx>
      <c:valAx>
        <c:axId val="63836016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baseline="0">
                    <a:solidFill>
                      <a:sysClr val="windowText" lastClr="000000"/>
                    </a:solidFill>
                    <a:effectLst/>
                  </a:rPr>
                  <a:t>FAMEs (mol%)</a:t>
                </a:r>
                <a:endParaRPr lang="zh-CN" altLang="zh-CN" sz="1200" b="0">
                  <a:solidFill>
                    <a:sysClr val="windowText" lastClr="00000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702185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8885567646991341"/>
          <c:y val="7.2472969855029948E-2"/>
          <c:w val="0.26704459803818764"/>
          <c:h val="9.93922163121233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73403375081228"/>
          <c:y val="3.2953261400316014E-2"/>
          <c:w val="0.85170913435341888"/>
          <c:h val="0.753743794542027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EPA charts'!$AI$47</c:f>
              <c:strCache>
                <c:ptCount val="1"/>
                <c:pt idx="0">
                  <c:v>EPA_B4.1</c:v>
                </c:pt>
              </c:strCache>
            </c:strRef>
          </c:tx>
          <c:spPr>
            <a:solidFill>
              <a:srgbClr val="64321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51:$AX$51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plus>
            <c:minus>
              <c:numRef>
                <c:f>'FT2018 EPA charts'!$AJ$51:$AX$51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46:$AX$4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47:$AX$47</c:f>
              <c:numCache>
                <c:formatCode>0</c:formatCode>
                <c:ptCount val="15"/>
                <c:pt idx="0">
                  <c:v>5.6740129866984432</c:v>
                </c:pt>
                <c:pt idx="1">
                  <c:v>3.626323386359251</c:v>
                </c:pt>
                <c:pt idx="2">
                  <c:v>11.698698973715929</c:v>
                </c:pt>
                <c:pt idx="3">
                  <c:v>11.790007256574512</c:v>
                </c:pt>
                <c:pt idx="4">
                  <c:v>1.1170779874656427</c:v>
                </c:pt>
                <c:pt idx="5">
                  <c:v>17.597763498969261</c:v>
                </c:pt>
                <c:pt idx="6">
                  <c:v>1.6969078571079723</c:v>
                </c:pt>
                <c:pt idx="7">
                  <c:v>11.407326916344738</c:v>
                </c:pt>
                <c:pt idx="8">
                  <c:v>0.82793623666034033</c:v>
                </c:pt>
                <c:pt idx="9">
                  <c:v>2.8770976231695897</c:v>
                </c:pt>
                <c:pt idx="10">
                  <c:v>1.9110822176934665</c:v>
                </c:pt>
                <c:pt idx="11">
                  <c:v>15.883233796640171</c:v>
                </c:pt>
                <c:pt idx="12">
                  <c:v>0.79410506937119729</c:v>
                </c:pt>
                <c:pt idx="13">
                  <c:v>0</c:v>
                </c:pt>
                <c:pt idx="14">
                  <c:v>13.0984261932294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7C-4388-9D8E-DE4331DDE70F}"/>
            </c:ext>
          </c:extLst>
        </c:ser>
        <c:ser>
          <c:idx val="1"/>
          <c:order val="1"/>
          <c:tx>
            <c:strRef>
              <c:f>'FT2018 EPA charts'!$AI$48</c:f>
              <c:strCache>
                <c:ptCount val="1"/>
                <c:pt idx="0">
                  <c:v>EPA4</c:v>
                </c:pt>
              </c:strCache>
            </c:strRef>
          </c:tx>
          <c:spPr>
            <a:solidFill>
              <a:srgbClr val="EA7F54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52:$AX$52</c:f>
                <c:numCache>
                  <c:formatCode>General</c:formatCode>
                  <c:ptCount val="15"/>
                  <c:pt idx="0">
                    <c:v>0.31035581059555789</c:v>
                  </c:pt>
                  <c:pt idx="1">
                    <c:v>0.29626904267257337</c:v>
                  </c:pt>
                  <c:pt idx="2">
                    <c:v>1.0127365174797067</c:v>
                  </c:pt>
                  <c:pt idx="3">
                    <c:v>0.10563173287563615</c:v>
                  </c:pt>
                  <c:pt idx="4">
                    <c:v>1.4348905760111594</c:v>
                  </c:pt>
                  <c:pt idx="5">
                    <c:v>3.7708242934030012</c:v>
                  </c:pt>
                  <c:pt idx="6">
                    <c:v>3.2649489048994584</c:v>
                  </c:pt>
                  <c:pt idx="7">
                    <c:v>1.1238342419198157</c:v>
                  </c:pt>
                  <c:pt idx="8">
                    <c:v>0.38952180979455026</c:v>
                  </c:pt>
                  <c:pt idx="9">
                    <c:v>1.5717468693985326</c:v>
                  </c:pt>
                  <c:pt idx="10">
                    <c:v>0.38385757914072366</c:v>
                  </c:pt>
                  <c:pt idx="11">
                    <c:v>5.0035602246453994</c:v>
                  </c:pt>
                  <c:pt idx="12">
                    <c:v>0.33789812332553704</c:v>
                  </c:pt>
                  <c:pt idx="13">
                    <c:v>0</c:v>
                  </c:pt>
                  <c:pt idx="14">
                    <c:v>0.20240767574154656</c:v>
                  </c:pt>
                </c:numCache>
              </c:numRef>
            </c:plus>
            <c:minus>
              <c:numRef>
                <c:f>'FT2018 EPA charts'!$AJ$52:$AX$52</c:f>
                <c:numCache>
                  <c:formatCode>General</c:formatCode>
                  <c:ptCount val="15"/>
                  <c:pt idx="0">
                    <c:v>0.31035581059555789</c:v>
                  </c:pt>
                  <c:pt idx="1">
                    <c:v>0.29626904267257337</c:v>
                  </c:pt>
                  <c:pt idx="2">
                    <c:v>1.0127365174797067</c:v>
                  </c:pt>
                  <c:pt idx="3">
                    <c:v>0.10563173287563615</c:v>
                  </c:pt>
                  <c:pt idx="4">
                    <c:v>1.4348905760111594</c:v>
                  </c:pt>
                  <c:pt idx="5">
                    <c:v>3.7708242934030012</c:v>
                  </c:pt>
                  <c:pt idx="6">
                    <c:v>3.2649489048994584</c:v>
                  </c:pt>
                  <c:pt idx="7">
                    <c:v>1.1238342419198157</c:v>
                  </c:pt>
                  <c:pt idx="8">
                    <c:v>0.38952180979455026</c:v>
                  </c:pt>
                  <c:pt idx="9">
                    <c:v>1.5717468693985326</c:v>
                  </c:pt>
                  <c:pt idx="10">
                    <c:v>0.38385757914072366</c:v>
                  </c:pt>
                  <c:pt idx="11">
                    <c:v>5.0035602246453994</c:v>
                  </c:pt>
                  <c:pt idx="12">
                    <c:v>0.33789812332553704</c:v>
                  </c:pt>
                  <c:pt idx="13">
                    <c:v>0</c:v>
                  </c:pt>
                  <c:pt idx="14">
                    <c:v>0.202407675741546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46:$AX$46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48:$AX$48</c:f>
              <c:numCache>
                <c:formatCode>0</c:formatCode>
                <c:ptCount val="15"/>
                <c:pt idx="0">
                  <c:v>7.2427041835304662</c:v>
                </c:pt>
                <c:pt idx="1">
                  <c:v>2.9709323004223975</c:v>
                </c:pt>
                <c:pt idx="2">
                  <c:v>11.511948663508567</c:v>
                </c:pt>
                <c:pt idx="3">
                  <c:v>13.494231282928547</c:v>
                </c:pt>
                <c:pt idx="4">
                  <c:v>4.3366132975537388</c:v>
                </c:pt>
                <c:pt idx="5">
                  <c:v>17.492424381673221</c:v>
                </c:pt>
                <c:pt idx="6">
                  <c:v>7.8207658039796044</c:v>
                </c:pt>
                <c:pt idx="7">
                  <c:v>7.2093845296677044</c:v>
                </c:pt>
                <c:pt idx="8">
                  <c:v>1.3923234765550603</c:v>
                </c:pt>
                <c:pt idx="9">
                  <c:v>3.1282259596234243</c:v>
                </c:pt>
                <c:pt idx="10">
                  <c:v>2.6140369756022479</c:v>
                </c:pt>
                <c:pt idx="11">
                  <c:v>10.084583930695883</c:v>
                </c:pt>
                <c:pt idx="12">
                  <c:v>0.52784758008106814</c:v>
                </c:pt>
                <c:pt idx="13">
                  <c:v>0</c:v>
                </c:pt>
                <c:pt idx="14">
                  <c:v>10.1739776341780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7C-4388-9D8E-DE4331DDE7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2636576"/>
        <c:axId val="638363904"/>
      </c:barChart>
      <c:catAx>
        <c:axId val="952636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363904"/>
        <c:crosses val="autoZero"/>
        <c:auto val="1"/>
        <c:lblAlgn val="ctr"/>
        <c:lblOffset val="100"/>
        <c:noMultiLvlLbl val="0"/>
      </c:catAx>
      <c:valAx>
        <c:axId val="638363904"/>
        <c:scaling>
          <c:orientation val="minMax"/>
          <c:max val="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baseline="0">
                    <a:solidFill>
                      <a:sysClr val="windowText" lastClr="000000"/>
                    </a:solidFill>
                    <a:effectLst/>
                  </a:rPr>
                  <a:t>FAMEs (mol%)</a:t>
                </a:r>
                <a:endParaRPr lang="zh-CN" altLang="zh-CN" sz="1200" b="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2.5951839907651444E-2"/>
              <c:y val="0.263057288335154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263657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1026004556172986"/>
          <c:y val="4.6476360273105338E-2"/>
          <c:w val="0.37215842686759598"/>
          <c:h val="0.125653945040148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23334598644903"/>
          <c:y val="4.2198832856231522E-2"/>
          <c:w val="0.85836456580669751"/>
          <c:h val="0.749176180842642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EPA charts'!$AI$56</c:f>
              <c:strCache>
                <c:ptCount val="1"/>
                <c:pt idx="0">
                  <c:v>EPA_B4.1</c:v>
                </c:pt>
              </c:strCache>
            </c:strRef>
          </c:tx>
          <c:spPr>
            <a:solidFill>
              <a:srgbClr val="64321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60:$AX$60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plus>
            <c:minus>
              <c:numRef>
                <c:f>'FT2018 EPA charts'!$AJ$60:$AX$60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55:$AX$5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56:$AX$56</c:f>
              <c:numCache>
                <c:formatCode>0</c:formatCode>
                <c:ptCount val="15"/>
                <c:pt idx="0">
                  <c:v>5.6740129866984432</c:v>
                </c:pt>
                <c:pt idx="1">
                  <c:v>3.626323386359251</c:v>
                </c:pt>
                <c:pt idx="2">
                  <c:v>11.698698973715929</c:v>
                </c:pt>
                <c:pt idx="3">
                  <c:v>11.790007256574512</c:v>
                </c:pt>
                <c:pt idx="4">
                  <c:v>1.1170779874656427</c:v>
                </c:pt>
                <c:pt idx="5">
                  <c:v>17.597763498969261</c:v>
                </c:pt>
                <c:pt idx="6">
                  <c:v>1.6969078571079723</c:v>
                </c:pt>
                <c:pt idx="7">
                  <c:v>11.407326916344738</c:v>
                </c:pt>
                <c:pt idx="8">
                  <c:v>0.82793623666034033</c:v>
                </c:pt>
                <c:pt idx="9">
                  <c:v>2.8770976231695897</c:v>
                </c:pt>
                <c:pt idx="10">
                  <c:v>1.9110822176934665</c:v>
                </c:pt>
                <c:pt idx="11">
                  <c:v>15.883233796640171</c:v>
                </c:pt>
                <c:pt idx="12">
                  <c:v>0.79410506937119729</c:v>
                </c:pt>
                <c:pt idx="13">
                  <c:v>0</c:v>
                </c:pt>
                <c:pt idx="14">
                  <c:v>13.0984261932294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D4-487B-B7B1-452526F4727E}"/>
            </c:ext>
          </c:extLst>
        </c:ser>
        <c:ser>
          <c:idx val="1"/>
          <c:order val="1"/>
          <c:tx>
            <c:strRef>
              <c:f>'FT2018 EPA charts'!$AI$57</c:f>
              <c:strCache>
                <c:ptCount val="1"/>
                <c:pt idx="0">
                  <c:v>EPA8</c:v>
                </c:pt>
              </c:strCache>
            </c:strRef>
          </c:tx>
          <c:spPr>
            <a:solidFill>
              <a:srgbClr val="F2BAA8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61:$AX$61</c:f>
                <c:numCache>
                  <c:formatCode>General</c:formatCode>
                  <c:ptCount val="15"/>
                  <c:pt idx="0">
                    <c:v>6.8038194901542295E-2</c:v>
                  </c:pt>
                  <c:pt idx="1">
                    <c:v>0.15815418131596434</c:v>
                  </c:pt>
                  <c:pt idx="2">
                    <c:v>0.60784926742134726</c:v>
                  </c:pt>
                  <c:pt idx="3">
                    <c:v>0.13230753170979664</c:v>
                  </c:pt>
                  <c:pt idx="4">
                    <c:v>9.2101624845676827E-2</c:v>
                  </c:pt>
                  <c:pt idx="5">
                    <c:v>0.41029666783458152</c:v>
                  </c:pt>
                  <c:pt idx="6">
                    <c:v>5.1960622726602623E-2</c:v>
                  </c:pt>
                  <c:pt idx="7">
                    <c:v>8.4620184794619011E-2</c:v>
                  </c:pt>
                  <c:pt idx="8">
                    <c:v>3.3033142366826411E-2</c:v>
                  </c:pt>
                  <c:pt idx="9">
                    <c:v>0.25647911104213439</c:v>
                  </c:pt>
                  <c:pt idx="10">
                    <c:v>9.9551590895948658E-2</c:v>
                  </c:pt>
                  <c:pt idx="11">
                    <c:v>0.30112296690002033</c:v>
                  </c:pt>
                  <c:pt idx="12">
                    <c:v>0.1144050226440608</c:v>
                  </c:pt>
                  <c:pt idx="13">
                    <c:v>0</c:v>
                  </c:pt>
                  <c:pt idx="14">
                    <c:v>0.37669370707899064</c:v>
                  </c:pt>
                </c:numCache>
              </c:numRef>
            </c:plus>
            <c:minus>
              <c:numRef>
                <c:f>'FT2018 EPA charts'!$AJ$61:$AX$61</c:f>
                <c:numCache>
                  <c:formatCode>General</c:formatCode>
                  <c:ptCount val="15"/>
                  <c:pt idx="0">
                    <c:v>6.8038194901542295E-2</c:v>
                  </c:pt>
                  <c:pt idx="1">
                    <c:v>0.15815418131596434</c:v>
                  </c:pt>
                  <c:pt idx="2">
                    <c:v>0.60784926742134726</c:v>
                  </c:pt>
                  <c:pt idx="3">
                    <c:v>0.13230753170979664</c:v>
                  </c:pt>
                  <c:pt idx="4">
                    <c:v>9.2101624845676827E-2</c:v>
                  </c:pt>
                  <c:pt idx="5">
                    <c:v>0.41029666783458152</c:v>
                  </c:pt>
                  <c:pt idx="6">
                    <c:v>5.1960622726602623E-2</c:v>
                  </c:pt>
                  <c:pt idx="7">
                    <c:v>8.4620184794619011E-2</c:v>
                  </c:pt>
                  <c:pt idx="8">
                    <c:v>3.3033142366826411E-2</c:v>
                  </c:pt>
                  <c:pt idx="9">
                    <c:v>0.25647911104213439</c:v>
                  </c:pt>
                  <c:pt idx="10">
                    <c:v>9.9551590895948658E-2</c:v>
                  </c:pt>
                  <c:pt idx="11">
                    <c:v>0.30112296690002033</c:v>
                  </c:pt>
                  <c:pt idx="12">
                    <c:v>0.1144050226440608</c:v>
                  </c:pt>
                  <c:pt idx="13">
                    <c:v>0</c:v>
                  </c:pt>
                  <c:pt idx="14">
                    <c:v>0.376693707078990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55:$AX$55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57:$AX$57</c:f>
              <c:numCache>
                <c:formatCode>0</c:formatCode>
                <c:ptCount val="15"/>
                <c:pt idx="0">
                  <c:v>7.6722314259562028</c:v>
                </c:pt>
                <c:pt idx="1">
                  <c:v>3.7173536791101047</c:v>
                </c:pt>
                <c:pt idx="2">
                  <c:v>13.673868873574937</c:v>
                </c:pt>
                <c:pt idx="3">
                  <c:v>12.761716290515594</c:v>
                </c:pt>
                <c:pt idx="4">
                  <c:v>2.1640083026057368</c:v>
                </c:pt>
                <c:pt idx="5">
                  <c:v>9.9077732072369713</c:v>
                </c:pt>
                <c:pt idx="6">
                  <c:v>2.4153998593679114</c:v>
                </c:pt>
                <c:pt idx="7">
                  <c:v>4.5435931776409211</c:v>
                </c:pt>
                <c:pt idx="8">
                  <c:v>1.670151221065475</c:v>
                </c:pt>
                <c:pt idx="9">
                  <c:v>5.5196269340258981</c:v>
                </c:pt>
                <c:pt idx="10">
                  <c:v>2.6172246694103016</c:v>
                </c:pt>
                <c:pt idx="11">
                  <c:v>20.57151512611533</c:v>
                </c:pt>
                <c:pt idx="12">
                  <c:v>1.068212608304248</c:v>
                </c:pt>
                <c:pt idx="13">
                  <c:v>0</c:v>
                </c:pt>
                <c:pt idx="14">
                  <c:v>11.697324625070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4D4-487B-B7B1-452526F472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2636176"/>
        <c:axId val="638357664"/>
      </c:barChart>
      <c:catAx>
        <c:axId val="952636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8357664"/>
        <c:crosses val="autoZero"/>
        <c:auto val="1"/>
        <c:lblAlgn val="ctr"/>
        <c:lblOffset val="100"/>
        <c:noMultiLvlLbl val="0"/>
      </c:catAx>
      <c:valAx>
        <c:axId val="638357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altLang="zh-CN" sz="1200" b="0" i="0" baseline="0">
                    <a:solidFill>
                      <a:sysClr val="windowText" lastClr="000000"/>
                    </a:solidFill>
                    <a:effectLst/>
                  </a:rPr>
                  <a:t>FAMEs (mol%)</a:t>
                </a:r>
                <a:endParaRPr lang="zh-CN" altLang="zh-CN" sz="1200" b="0">
                  <a:solidFill>
                    <a:sysClr val="windowText" lastClr="00000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2636176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091101566386391"/>
          <c:y val="6.0396596100779236E-2"/>
          <c:w val="0.37700738213969387"/>
          <c:h val="6.19389887111479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16932060762058"/>
          <c:y val="3.4583465305752216E-2"/>
          <c:w val="0.84553468677799937"/>
          <c:h val="0.7584324386794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T2018 EPA charts'!$AI$65</c:f>
              <c:strCache>
                <c:ptCount val="1"/>
                <c:pt idx="0">
                  <c:v>EPA_B4.1</c:v>
                </c:pt>
              </c:strCache>
            </c:strRef>
          </c:tx>
          <c:spPr>
            <a:solidFill>
              <a:srgbClr val="64321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69:$AX$69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plus>
            <c:minus>
              <c:numRef>
                <c:f>'FT2018 EPA charts'!$AJ$69:$AX$69</c:f>
                <c:numCache>
                  <c:formatCode>General</c:formatCode>
                  <c:ptCount val="15"/>
                  <c:pt idx="0">
                    <c:v>0.11104899228272122</c:v>
                  </c:pt>
                  <c:pt idx="1">
                    <c:v>0.10863754511180097</c:v>
                  </c:pt>
                  <c:pt idx="2">
                    <c:v>0.45652673718513853</c:v>
                  </c:pt>
                  <c:pt idx="3">
                    <c:v>0.90626288154079226</c:v>
                  </c:pt>
                  <c:pt idx="4">
                    <c:v>1.0287039647982553E-2</c:v>
                  </c:pt>
                  <c:pt idx="5">
                    <c:v>0.55943600181968856</c:v>
                  </c:pt>
                  <c:pt idx="6">
                    <c:v>5.6737398494256013E-2</c:v>
                  </c:pt>
                  <c:pt idx="7">
                    <c:v>0.25461749424586783</c:v>
                  </c:pt>
                  <c:pt idx="8">
                    <c:v>2.9923853155117645E-2</c:v>
                  </c:pt>
                  <c:pt idx="9">
                    <c:v>7.9899338650479476E-2</c:v>
                  </c:pt>
                  <c:pt idx="10">
                    <c:v>3.065100052455141E-2</c:v>
                  </c:pt>
                  <c:pt idx="11">
                    <c:v>0.71843194281362133</c:v>
                  </c:pt>
                  <c:pt idx="12">
                    <c:v>3.4966317962323266E-2</c:v>
                  </c:pt>
                  <c:pt idx="13">
                    <c:v>0</c:v>
                  </c:pt>
                  <c:pt idx="14">
                    <c:v>0.406607165994236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64:$AX$64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65:$AX$65</c:f>
              <c:numCache>
                <c:formatCode>0</c:formatCode>
                <c:ptCount val="15"/>
                <c:pt idx="0">
                  <c:v>5.6740129866984432</c:v>
                </c:pt>
                <c:pt idx="1">
                  <c:v>3.626323386359251</c:v>
                </c:pt>
                <c:pt idx="2">
                  <c:v>11.698698973715929</c:v>
                </c:pt>
                <c:pt idx="3">
                  <c:v>11.790007256574512</c:v>
                </c:pt>
                <c:pt idx="4">
                  <c:v>1.1170779874656427</c:v>
                </c:pt>
                <c:pt idx="5">
                  <c:v>17.597763498969261</c:v>
                </c:pt>
                <c:pt idx="6">
                  <c:v>1.6969078571079723</c:v>
                </c:pt>
                <c:pt idx="7">
                  <c:v>11.407326916344738</c:v>
                </c:pt>
                <c:pt idx="8">
                  <c:v>0.82793623666034033</c:v>
                </c:pt>
                <c:pt idx="9">
                  <c:v>2.8770976231695897</c:v>
                </c:pt>
                <c:pt idx="10">
                  <c:v>1.9110822176934665</c:v>
                </c:pt>
                <c:pt idx="11">
                  <c:v>15.883233796640171</c:v>
                </c:pt>
                <c:pt idx="12">
                  <c:v>0.79410506937119729</c:v>
                </c:pt>
                <c:pt idx="13">
                  <c:v>0</c:v>
                </c:pt>
                <c:pt idx="14">
                  <c:v>13.0984261932294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F2-40AA-BD64-E4BB5B024A12}"/>
            </c:ext>
          </c:extLst>
        </c:ser>
        <c:ser>
          <c:idx val="1"/>
          <c:order val="1"/>
          <c:tx>
            <c:strRef>
              <c:f>'FT2018 EPA charts'!$AI$66</c:f>
              <c:strCache>
                <c:ptCount val="1"/>
                <c:pt idx="0">
                  <c:v>EPA1</c:v>
                </c:pt>
              </c:strCache>
            </c:strRef>
          </c:tx>
          <c:spPr>
            <a:solidFill>
              <a:srgbClr val="BB561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T2018 EPA charts'!$AJ$70:$AX$70</c:f>
                <c:numCache>
                  <c:formatCode>General</c:formatCode>
                  <c:ptCount val="15"/>
                  <c:pt idx="0">
                    <c:v>0.324791873475542</c:v>
                  </c:pt>
                  <c:pt idx="1">
                    <c:v>0.11626174784967619</c:v>
                  </c:pt>
                  <c:pt idx="2">
                    <c:v>0.97319165813796071</c:v>
                  </c:pt>
                  <c:pt idx="3">
                    <c:v>0.69820434778395135</c:v>
                  </c:pt>
                  <c:pt idx="4">
                    <c:v>1.1305739179659622</c:v>
                  </c:pt>
                  <c:pt idx="5">
                    <c:v>1.0690876634803059</c:v>
                  </c:pt>
                  <c:pt idx="6">
                    <c:v>0.12227046428761087</c:v>
                  </c:pt>
                  <c:pt idx="7">
                    <c:v>0.50117679652765978</c:v>
                  </c:pt>
                  <c:pt idx="8">
                    <c:v>0.28745216175193133</c:v>
                  </c:pt>
                  <c:pt idx="9">
                    <c:v>0.47532815460798972</c:v>
                  </c:pt>
                  <c:pt idx="10">
                    <c:v>0.2006360795674601</c:v>
                  </c:pt>
                  <c:pt idx="11">
                    <c:v>0.57093379146053813</c:v>
                  </c:pt>
                  <c:pt idx="12">
                    <c:v>0.50290344183007096</c:v>
                  </c:pt>
                  <c:pt idx="13">
                    <c:v>0</c:v>
                  </c:pt>
                  <c:pt idx="14">
                    <c:v>0.29496609068085888</c:v>
                  </c:pt>
                </c:numCache>
              </c:numRef>
            </c:plus>
            <c:minus>
              <c:numRef>
                <c:f>'FT2018 EPA charts'!$AJ$70:$AX$70</c:f>
                <c:numCache>
                  <c:formatCode>General</c:formatCode>
                  <c:ptCount val="15"/>
                  <c:pt idx="0">
                    <c:v>0.324791873475542</c:v>
                  </c:pt>
                  <c:pt idx="1">
                    <c:v>0.11626174784967619</c:v>
                  </c:pt>
                  <c:pt idx="2">
                    <c:v>0.97319165813796071</c:v>
                  </c:pt>
                  <c:pt idx="3">
                    <c:v>0.69820434778395135</c:v>
                  </c:pt>
                  <c:pt idx="4">
                    <c:v>1.1305739179659622</c:v>
                  </c:pt>
                  <c:pt idx="5">
                    <c:v>1.0690876634803059</c:v>
                  </c:pt>
                  <c:pt idx="6">
                    <c:v>0.12227046428761087</c:v>
                  </c:pt>
                  <c:pt idx="7">
                    <c:v>0.50117679652765978</c:v>
                  </c:pt>
                  <c:pt idx="8">
                    <c:v>0.28745216175193133</c:v>
                  </c:pt>
                  <c:pt idx="9">
                    <c:v>0.47532815460798972</c:v>
                  </c:pt>
                  <c:pt idx="10">
                    <c:v>0.2006360795674601</c:v>
                  </c:pt>
                  <c:pt idx="11">
                    <c:v>0.57093379146053813</c:v>
                  </c:pt>
                  <c:pt idx="12">
                    <c:v>0.50290344183007096</c:v>
                  </c:pt>
                  <c:pt idx="13">
                    <c:v>0</c:v>
                  </c:pt>
                  <c:pt idx="14">
                    <c:v>0.294966090680858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T2018 EPA charts'!$AJ$64:$AX$64</c:f>
              <c:strCache>
                <c:ptCount val="15"/>
                <c:pt idx="0">
                  <c:v>C16:0</c:v>
                </c:pt>
                <c:pt idx="1">
                  <c:v>C18:0</c:v>
                </c:pt>
                <c:pt idx="2">
                  <c:v>OA</c:v>
                </c:pt>
                <c:pt idx="3">
                  <c:v>LA</c:v>
                </c:pt>
                <c:pt idx="4">
                  <c:v> GLA</c:v>
                </c:pt>
                <c:pt idx="5">
                  <c:v> ALA</c:v>
                </c:pt>
                <c:pt idx="6">
                  <c:v> SDA</c:v>
                </c:pt>
                <c:pt idx="7">
                  <c:v>C20:1</c:v>
                </c:pt>
                <c:pt idx="8">
                  <c:v> DGLA</c:v>
                </c:pt>
                <c:pt idx="9">
                  <c:v> ARA</c:v>
                </c:pt>
                <c:pt idx="10">
                  <c:v>ETA</c:v>
                </c:pt>
                <c:pt idx="11">
                  <c:v>EPA</c:v>
                </c:pt>
                <c:pt idx="12">
                  <c:v> DPA</c:v>
                </c:pt>
                <c:pt idx="13">
                  <c:v>DHA</c:v>
                </c:pt>
                <c:pt idx="14">
                  <c:v>Others</c:v>
                </c:pt>
              </c:strCache>
            </c:strRef>
          </c:cat>
          <c:val>
            <c:numRef>
              <c:f>'FT2018 EPA charts'!$AJ$66:$AX$66</c:f>
              <c:numCache>
                <c:formatCode>0</c:formatCode>
                <c:ptCount val="15"/>
                <c:pt idx="0">
                  <c:v>7.6187169190972126</c:v>
                </c:pt>
                <c:pt idx="1">
                  <c:v>3.8294484570249456</c:v>
                </c:pt>
                <c:pt idx="2">
                  <c:v>13.598146248373373</c:v>
                </c:pt>
                <c:pt idx="3">
                  <c:v>11.45462168132083</c:v>
                </c:pt>
                <c:pt idx="4">
                  <c:v>1.3946619579847177</c:v>
                </c:pt>
                <c:pt idx="5">
                  <c:v>11.07599092876257</c:v>
                </c:pt>
                <c:pt idx="6">
                  <c:v>2.5850325620838688</c:v>
                </c:pt>
                <c:pt idx="7">
                  <c:v>5.6372099165591925</c:v>
                </c:pt>
                <c:pt idx="8">
                  <c:v>1.5260505403269147</c:v>
                </c:pt>
                <c:pt idx="9">
                  <c:v>5.3360969243667862</c:v>
                </c:pt>
                <c:pt idx="10">
                  <c:v>2.609684383063934</c:v>
                </c:pt>
                <c:pt idx="11">
                  <c:v>21.58133769203808</c:v>
                </c:pt>
                <c:pt idx="12">
                  <c:v>0.82074160806707985</c:v>
                </c:pt>
                <c:pt idx="13">
                  <c:v>0</c:v>
                </c:pt>
                <c:pt idx="14">
                  <c:v>10.9322601809305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F2-40AA-BD64-E4BB5B024A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03172592"/>
        <c:axId val="374421200"/>
      </c:barChart>
      <c:catAx>
        <c:axId val="903172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4421200"/>
        <c:crosses val="autoZero"/>
        <c:auto val="1"/>
        <c:lblAlgn val="ctr"/>
        <c:lblOffset val="100"/>
        <c:noMultiLvlLbl val="0"/>
      </c:catAx>
      <c:valAx>
        <c:axId val="3744212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0" dirty="0"/>
                  <a:t>FAMEs (mol%)</a:t>
                </a:r>
                <a:endParaRPr lang="zh-CN" b="0" dirty="0"/>
              </a:p>
            </c:rich>
          </c:tx>
          <c:layout>
            <c:manualLayout>
              <c:xMode val="edge"/>
              <c:yMode val="edge"/>
              <c:x val="3.1933342544061757E-2"/>
              <c:y val="0.264591688488584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3172592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0383009557986269"/>
          <c:y val="2.140757516001774E-2"/>
          <c:w val="0.49265456510194661"/>
          <c:h val="0.115616570310239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19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0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2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3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4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5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8D4573-E497-4D15-89B7-95C2B1FCC736}" type="datetimeFigureOut">
              <a:rPr lang="en-GB" smtClean="0"/>
              <a:t>12/05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9100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963"/>
            <a:ext cx="543560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100" y="9432925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373535-49E0-47C7-B166-F17997364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331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09BBE-0622-414B-88E7-CEF4EEE9EC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8096E9-8391-458D-B48C-B0F6E3CEB9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55FE2-F61C-4342-A8CA-DA6688779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D50F0-9748-4925-87B6-0E9529B87814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BFDB0-B146-42D0-9D20-E46E07148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C0CA5-6CEF-4565-A448-F0B994AE5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7826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1369F3-598F-4E51-A4DF-0F2A7E10F0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F38089-FF1B-401E-BE75-4C14A9BABE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22213-D485-4C8A-9DDF-1A181CFDF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15E24A-650E-4728-AFB6-4D07853597B4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BAE065-F8AB-4980-BFE9-55A0E951E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24956-6411-4427-B6D8-B55E131C8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669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4DF50D-6FD9-4355-B2F7-C2172D0C77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467F16-4566-47DD-B30B-B4CDB9492B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B8520-BE25-48D0-B745-EF0E312D9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A596A-8534-4477-BF9F-72FAB6D641D3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37BCF-4690-45DA-85C2-B1859609C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E641A-BB37-48BD-B273-72AA0D7F5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5403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17C93-0A5A-4BE4-A4FB-04BC219684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738438-8D8E-4E41-83DE-CFE54A98CF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43DA3-CDBF-451A-8C14-D4D736BA8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04C3A-3AA2-42F0-B03C-B1B54BC5733A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322E2-5326-45E9-9C3E-3F726294C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4E26ED-C506-4ED4-8BAC-FA2799B29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1197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A21C9-1C53-4E50-BAC6-FF21FDCD8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4CC3BB-40BC-40AE-B5F6-63D725715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D6AA9-4656-4A29-B9E8-439501E1F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22C4F8-C541-4D71-A8DF-D5884D12E52D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441E2-45E3-4C8E-B848-1B121ADED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27BFE2-CDB9-41C4-9715-4D2F4B50F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265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FC5BF-2773-4AB0-ACB0-9EC92C68C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D5EF52-8F99-4617-8776-45D2858B45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438814-5BCE-47FE-BDD4-584AEE209F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1FC4AC-CB20-4B8A-9A90-E766D7469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4EDE0-B73A-4372-9CC7-B219424DC52C}" type="datetime1">
              <a:rPr lang="en-GB" smtClean="0"/>
              <a:t>12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9C9259-D971-4EEF-807C-2C31D14AA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E00E2D-A5D0-4341-A3BE-01A3315A4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3347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A61B6-57FC-4258-B157-EDE1ADBA7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D7CA3-674A-4374-B74A-885AAE9D3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891704-440E-4BC6-8233-A5BD53B2C1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C1654D-9DD5-4C9C-A0CA-BB7CC7FC75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A8D7F8-7B17-4FA0-B875-FC9393A413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0B3013-151B-4D0D-BBD1-A8DAF229D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00561-5278-4520-B54A-76953F89D520}" type="datetime1">
              <a:rPr lang="en-GB" smtClean="0"/>
              <a:t>12/05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BEA136-6A8E-4E51-927D-4D5C46B20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65771F-118B-4D3B-9BEC-111D7FB97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467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7517F-3AFD-4E7F-ACC8-80D114782F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42BB3D-3C15-40E4-B56D-5AD5E16E1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D0F51-E9B4-4459-8C36-D85727D68C99}" type="datetime1">
              <a:rPr lang="en-GB" smtClean="0"/>
              <a:t>12/05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3DB66-E18A-4786-BBF9-B736FB853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4D23C5-348D-4444-BB1B-5DC72E4F6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926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B8FBAB-0A07-4605-BFD9-569D4DCE2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A6A0D-12ED-4A7B-A4BC-4956CF54D6D0}" type="datetime1">
              <a:rPr lang="en-GB" smtClean="0"/>
              <a:t>12/05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24EC21-FE4E-4AEB-9411-756D69550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358BE1-1FCC-4F03-BFAE-90F92BBE3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352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3FDB1-24C4-4F08-8517-F4ECFCAE25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84DFA9-45DD-4BE4-BF62-B4435723C4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1B1933-D864-4542-998C-F9FAD276D9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FC16CB-187D-43E2-8B80-29596DF27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DABDE-A21C-4BDF-A8B1-A79F1ADE4F0B}" type="datetime1">
              <a:rPr lang="en-GB" smtClean="0"/>
              <a:t>12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D1B114-534F-42B9-9551-40153CD67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BB752F-CCE7-4244-9AB7-C8B00D394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494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B92A4-0443-4D88-B5CE-3D870C8A1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E84582-C041-423D-9573-CC839FD01F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577BE4-A7FB-4270-BBA2-90C989BC7A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D53F83-1E95-4C0A-8DCD-FE4CF76E8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E2ECD-60A2-4BC3-AB98-0D22B2D22D10}" type="datetime1">
              <a:rPr lang="en-GB" smtClean="0"/>
              <a:t>12/05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714B3-1099-4E13-9495-B3A144192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1C4F7A-25A4-4340-8DAC-A5D49F285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5587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A4D9A9-F04F-4B06-9E26-19851AEAA1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CDCCB5-0DB4-40DB-A8B8-6C3BF419B7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426F9-66C0-4E7A-9B1A-EC945173EB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D9A76-BAE5-4950-8776-40D36015D865}" type="datetime1">
              <a:rPr lang="en-GB" smtClean="0"/>
              <a:t>12/05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BDDBA-43D8-47D9-BDF9-C6C0C74C67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1296C-1633-4960-BEF0-F25B2D2EF9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C05C8-D6D5-465C-8739-5921383B45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496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7.xml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9.xml"/><Relationship Id="rId4" Type="http://schemas.openxmlformats.org/officeDocument/2006/relationships/chart" Target="../charts/chart28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1.xml"/><Relationship Id="rId3" Type="http://schemas.openxmlformats.org/officeDocument/2006/relationships/chart" Target="../charts/chart19.xml"/><Relationship Id="rId7" Type="http://schemas.openxmlformats.org/officeDocument/2006/relationships/image" Target="../media/image4.png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0.xml"/><Relationship Id="rId11" Type="http://schemas.openxmlformats.org/officeDocument/2006/relationships/chart" Target="../charts/chart22.xml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chart" Target="../charts/chart25.xml"/><Relationship Id="rId2" Type="http://schemas.openxmlformats.org/officeDocument/2006/relationships/chart" Target="../charts/chart2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4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13A0FE5-39E3-41C3-9BB1-BAE0213CAB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9823050"/>
              </p:ext>
            </p:extLst>
          </p:nvPr>
        </p:nvGraphicFramePr>
        <p:xfrm>
          <a:off x="838200" y="1012793"/>
          <a:ext cx="5057245" cy="577215"/>
        </p:xfrm>
        <a:graphic>
          <a:graphicData uri="http://schemas.openxmlformats.org/drawingml/2006/table">
            <a:tbl>
              <a:tblPr/>
              <a:tblGrid>
                <a:gridCol w="2043457">
                  <a:extLst>
                    <a:ext uri="{9D8B030D-6E8A-4147-A177-3AD203B41FA5}">
                      <a16:colId xmlns:a16="http://schemas.microsoft.com/office/drawing/2014/main" val="2606206273"/>
                    </a:ext>
                  </a:extLst>
                </a:gridCol>
                <a:gridCol w="3013788">
                  <a:extLst>
                    <a:ext uri="{9D8B030D-6E8A-4147-A177-3AD203B41FA5}">
                      <a16:colId xmlns:a16="http://schemas.microsoft.com/office/drawing/2014/main" val="1177313744"/>
                    </a:ext>
                  </a:extLst>
                </a:gridCol>
              </a:tblGrid>
              <a:tr h="135021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eld trial location 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125390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tio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S co-ordinat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26670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Appletr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° 48' 19.062'' N    0° 22' 34.3452'' W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4936257"/>
                  </a:ext>
                </a:extLst>
              </a:tr>
            </a:tbl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47108D30-2DD0-4CE0-8AE0-7217C1810703}"/>
              </a:ext>
            </a:extLst>
          </p:cNvPr>
          <p:cNvSpPr/>
          <p:nvPr/>
        </p:nvSpPr>
        <p:spPr>
          <a:xfrm>
            <a:off x="668933" y="389923"/>
            <a:ext cx="61121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000000"/>
                </a:solidFill>
                <a:cs typeface="Arial" panose="020B0604020202020204" pitchFamily="34" charset="0"/>
              </a:rPr>
              <a:t>Table S1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etails of field trial (location, weather, harvest date).</a:t>
            </a:r>
            <a:endParaRPr lang="en-GB" dirty="0">
              <a:cs typeface="Arial" panose="020B0604020202020204" pitchFamily="34" charset="0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46C94216-7312-42CD-B68F-49D7468B3C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8002411"/>
              </p:ext>
            </p:extLst>
          </p:nvPr>
        </p:nvGraphicFramePr>
        <p:xfrm>
          <a:off x="838200" y="4853305"/>
          <a:ext cx="8191500" cy="1333500"/>
        </p:xfrm>
        <a:graphic>
          <a:graphicData uri="http://schemas.openxmlformats.org/drawingml/2006/table">
            <a:tbl>
              <a:tblPr/>
              <a:tblGrid>
                <a:gridCol w="2273300">
                  <a:extLst>
                    <a:ext uri="{9D8B030D-6E8A-4147-A177-3AD203B41FA5}">
                      <a16:colId xmlns:a16="http://schemas.microsoft.com/office/drawing/2014/main" val="1991372905"/>
                    </a:ext>
                  </a:extLst>
                </a:gridCol>
                <a:gridCol w="1841500">
                  <a:extLst>
                    <a:ext uri="{9D8B030D-6E8A-4147-A177-3AD203B41FA5}">
                      <a16:colId xmlns:a16="http://schemas.microsoft.com/office/drawing/2014/main" val="67042123"/>
                    </a:ext>
                  </a:extLst>
                </a:gridCol>
                <a:gridCol w="1358900">
                  <a:extLst>
                    <a:ext uri="{9D8B030D-6E8A-4147-A177-3AD203B41FA5}">
                      <a16:colId xmlns:a16="http://schemas.microsoft.com/office/drawing/2014/main" val="1364837642"/>
                    </a:ext>
                  </a:extLst>
                </a:gridCol>
                <a:gridCol w="1358900">
                  <a:extLst>
                    <a:ext uri="{9D8B030D-6E8A-4147-A177-3AD203B41FA5}">
                      <a16:colId xmlns:a16="http://schemas.microsoft.com/office/drawing/2014/main" val="754827413"/>
                    </a:ext>
                  </a:extLst>
                </a:gridCol>
                <a:gridCol w="1358900">
                  <a:extLst>
                    <a:ext uri="{9D8B030D-6E8A-4147-A177-3AD203B41FA5}">
                      <a16:colId xmlns:a16="http://schemas.microsoft.com/office/drawing/2014/main" val="2553027344"/>
                    </a:ext>
                  </a:extLst>
                </a:gridCol>
              </a:tblGrid>
              <a:tr h="163754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eld trial Camelina growth seaso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6784445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5526589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eld trial nam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wing dat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th day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rvest tim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ys to harv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6681511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.06.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.09.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.09.2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6610752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.05.2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.09.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.10.0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7281648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8.06.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8.09.1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8.09.2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292347"/>
                  </a:ext>
                </a:extLst>
              </a:tr>
              <a:tr h="1637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.05.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.08.2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.09.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3540488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AB4A77ED-EBD3-43FD-8269-337B1A235D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2726651"/>
              </p:ext>
            </p:extLst>
          </p:nvPr>
        </p:nvGraphicFramePr>
        <p:xfrm>
          <a:off x="838202" y="2004695"/>
          <a:ext cx="10515598" cy="2255516"/>
        </p:xfrm>
        <a:graphic>
          <a:graphicData uri="http://schemas.openxmlformats.org/drawingml/2006/table">
            <a:tbl>
              <a:tblPr/>
              <a:tblGrid>
                <a:gridCol w="1948543">
                  <a:extLst>
                    <a:ext uri="{9D8B030D-6E8A-4147-A177-3AD203B41FA5}">
                      <a16:colId xmlns:a16="http://schemas.microsoft.com/office/drawing/2014/main" val="2258132569"/>
                    </a:ext>
                  </a:extLst>
                </a:gridCol>
                <a:gridCol w="1578429">
                  <a:extLst>
                    <a:ext uri="{9D8B030D-6E8A-4147-A177-3AD203B41FA5}">
                      <a16:colId xmlns:a16="http://schemas.microsoft.com/office/drawing/2014/main" val="3292510849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164549565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3491848918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1416157708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234256748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2653344571"/>
                    </a:ext>
                  </a:extLst>
                </a:gridCol>
                <a:gridCol w="1164771">
                  <a:extLst>
                    <a:ext uri="{9D8B030D-6E8A-4147-A177-3AD203B41FA5}">
                      <a16:colId xmlns:a16="http://schemas.microsoft.com/office/drawing/2014/main" val="2839090871"/>
                    </a:ext>
                  </a:extLst>
                </a:gridCol>
              </a:tblGrid>
              <a:tr h="195943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-2019 Rothamsted Research field trial weather condition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74406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42424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42424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42424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42424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42424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8844557"/>
                  </a:ext>
                </a:extLst>
              </a:tr>
              <a:tr h="189411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meters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eld trial name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Y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N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L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G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P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T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1532918"/>
                  </a:ext>
                </a:extLst>
              </a:tr>
              <a:tr h="189411"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cipitation (mm)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6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4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3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0417773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5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6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6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9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6146817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9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3667667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9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.6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1174868"/>
                  </a:ext>
                </a:extLst>
              </a:tr>
              <a:tr h="189411"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erature (°C)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6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 - 17.4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 - 19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8 - 22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 - 22.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2 - 20.4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 - 14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5484444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 - 17.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 - 21.5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2 - 21.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8 - 20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 - 17.3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 - 15.4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4516282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 - 18.7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9 - 21.5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 - 26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 - 22.3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 - 19.0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 - 14.9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8647126"/>
                  </a:ext>
                </a:extLst>
              </a:tr>
              <a:tr h="1894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hamsted 2019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 - 16.3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2 - 19.3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0 - 23.1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 - 23.2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 - 19.5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 - 13.8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0037885"/>
                  </a:ext>
                </a:extLst>
              </a:tr>
              <a:tr h="19594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ata source: rom Rothamsted farm dat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531" marR="6531" marT="653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15845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6387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94CA165-0C28-435A-82D2-12B08B2580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665492"/>
              </p:ext>
            </p:extLst>
          </p:nvPr>
        </p:nvGraphicFramePr>
        <p:xfrm>
          <a:off x="5721944" y="542561"/>
          <a:ext cx="6470055" cy="2841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Rectangle 14">
            <a:extLst>
              <a:ext uri="{FF2B5EF4-FFF2-40B4-BE49-F238E27FC236}">
                <a16:creationId xmlns:a16="http://schemas.microsoft.com/office/drawing/2014/main" id="{618B5785-4316-4B46-BDA6-2EA0D4EFBD3A}"/>
              </a:ext>
            </a:extLst>
          </p:cNvPr>
          <p:cNvSpPr/>
          <p:nvPr/>
        </p:nvSpPr>
        <p:spPr>
          <a:xfrm>
            <a:off x="508692" y="92823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Figure S9</a:t>
            </a:r>
            <a:endParaRPr lang="en-GB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C61FC615-596B-4C41-829F-F59E74ED4C2A}"/>
              </a:ext>
            </a:extLst>
          </p:cNvPr>
          <p:cNvSpPr/>
          <p:nvPr/>
        </p:nvSpPr>
        <p:spPr>
          <a:xfrm>
            <a:off x="438241" y="5954914"/>
            <a:ext cx="1144659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/>
              <a:t>Figure S9  </a:t>
            </a:r>
            <a:r>
              <a:rPr lang="en-GB" altLang="zh-CN" sz="1400" dirty="0"/>
              <a:t>Analysis of triacylglycerols from DHA2015.1, DHA2015.5, EPA2016.1 and EPA2015.8 seeds of </a:t>
            </a:r>
            <a:r>
              <a:rPr lang="en-GB" altLang="zh-CN" sz="1400" i="1" dirty="0"/>
              <a:t>C. sativa</a:t>
            </a:r>
            <a:r>
              <a:rPr lang="en-GB" sz="1400" dirty="0"/>
              <a:t>.  Values are mean ± SE, n=3.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table increases between DHA1 and DHA5, EPA1 and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EPA8 lines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e highlighted with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blue or yellow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oxes individually. TAG species decreased in the transgenic lines are indicated with the open arrows.</a:t>
            </a:r>
            <a:endParaRPr lang="en-GB" sz="1400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45F842C-8071-4E1E-9538-730CE19A84D3}"/>
              </a:ext>
            </a:extLst>
          </p:cNvPr>
          <p:cNvGrpSpPr/>
          <p:nvPr/>
        </p:nvGrpSpPr>
        <p:grpSpPr>
          <a:xfrm>
            <a:off x="65903" y="548830"/>
            <a:ext cx="5894173" cy="2574769"/>
            <a:chOff x="65903" y="548830"/>
            <a:chExt cx="5894173" cy="2574769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B9F9893D-9B31-402C-9225-122078409C3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30183011"/>
                </p:ext>
              </p:extLst>
            </p:nvPr>
          </p:nvGraphicFramePr>
          <p:xfrm>
            <a:off x="65903" y="548830"/>
            <a:ext cx="5894173" cy="25032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20AA4ED0-2D1D-4B36-93AF-1F9B366C2710}"/>
                </a:ext>
              </a:extLst>
            </p:cNvPr>
            <p:cNvSpPr/>
            <p:nvPr/>
          </p:nvSpPr>
          <p:spPr>
            <a:xfrm>
              <a:off x="704675" y="1521944"/>
              <a:ext cx="176169" cy="782718"/>
            </a:xfrm>
            <a:prstGeom prst="rect">
              <a:avLst/>
            </a:prstGeom>
            <a:solidFill>
              <a:schemeClr val="accent5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B0F7DBDA-106B-41C1-B808-443497F9FAB7}"/>
                </a:ext>
              </a:extLst>
            </p:cNvPr>
            <p:cNvSpPr/>
            <p:nvPr/>
          </p:nvSpPr>
          <p:spPr>
            <a:xfrm>
              <a:off x="2569283" y="1544170"/>
              <a:ext cx="176169" cy="760491"/>
            </a:xfrm>
            <a:prstGeom prst="rect">
              <a:avLst/>
            </a:prstGeom>
            <a:solidFill>
              <a:schemeClr val="accent5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57" name="Arrow: Up 56">
              <a:extLst>
                <a:ext uri="{FF2B5EF4-FFF2-40B4-BE49-F238E27FC236}">
                  <a16:creationId xmlns:a16="http://schemas.microsoft.com/office/drawing/2014/main" id="{EDDDFDE4-0FDF-4E4C-8A1B-D7FD9A278F5A}"/>
                </a:ext>
              </a:extLst>
            </p:cNvPr>
            <p:cNvSpPr/>
            <p:nvPr/>
          </p:nvSpPr>
          <p:spPr>
            <a:xfrm rot="10800000">
              <a:off x="2075487" y="2921194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19223B6F-1343-4497-8D88-D076A9E46372}"/>
              </a:ext>
            </a:extLst>
          </p:cNvPr>
          <p:cNvGrpSpPr/>
          <p:nvPr/>
        </p:nvGrpSpPr>
        <p:grpSpPr>
          <a:xfrm>
            <a:off x="-65905" y="3219438"/>
            <a:ext cx="6025981" cy="2804684"/>
            <a:chOff x="-65905" y="3314028"/>
            <a:chExt cx="6025981" cy="2804684"/>
          </a:xfrm>
        </p:grpSpPr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78F6E1E1-6C99-43C7-9966-F4EE5684E7C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8936504"/>
                </p:ext>
              </p:extLst>
            </p:nvPr>
          </p:nvGraphicFramePr>
          <p:xfrm>
            <a:off x="-65905" y="3314028"/>
            <a:ext cx="6025981" cy="28046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8" name="Arrow: Up 57">
              <a:extLst>
                <a:ext uri="{FF2B5EF4-FFF2-40B4-BE49-F238E27FC236}">
                  <a16:creationId xmlns:a16="http://schemas.microsoft.com/office/drawing/2014/main" id="{19C90FB2-DFD7-4810-9659-3A0F3DE2C8C8}"/>
                </a:ext>
              </a:extLst>
            </p:cNvPr>
            <p:cNvSpPr/>
            <p:nvPr/>
          </p:nvSpPr>
          <p:spPr>
            <a:xfrm rot="10800000">
              <a:off x="2771327" y="5808635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59" name="Arrow: Up 58">
              <a:extLst>
                <a:ext uri="{FF2B5EF4-FFF2-40B4-BE49-F238E27FC236}">
                  <a16:creationId xmlns:a16="http://schemas.microsoft.com/office/drawing/2014/main" id="{6F7B5B8D-6314-4387-AB65-0CA31F6E358E}"/>
                </a:ext>
              </a:extLst>
            </p:cNvPr>
            <p:cNvSpPr/>
            <p:nvPr/>
          </p:nvSpPr>
          <p:spPr>
            <a:xfrm rot="10800000">
              <a:off x="1434055" y="5802938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45C49011-6FA5-4B2C-9829-2D06A8086433}"/>
              </a:ext>
            </a:extLst>
          </p:cNvPr>
          <p:cNvGrpSpPr/>
          <p:nvPr/>
        </p:nvGrpSpPr>
        <p:grpSpPr>
          <a:xfrm>
            <a:off x="6373314" y="1194570"/>
            <a:ext cx="4291944" cy="2020385"/>
            <a:chOff x="6373314" y="1194570"/>
            <a:chExt cx="4291944" cy="2020385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590BC19-F1A6-412C-87B3-38E45E288748}"/>
                </a:ext>
              </a:extLst>
            </p:cNvPr>
            <p:cNvGrpSpPr/>
            <p:nvPr/>
          </p:nvGrpSpPr>
          <p:grpSpPr>
            <a:xfrm>
              <a:off x="6921645" y="3012550"/>
              <a:ext cx="847583" cy="202405"/>
              <a:chOff x="6921645" y="3280812"/>
              <a:chExt cx="847583" cy="202405"/>
            </a:xfrm>
          </p:grpSpPr>
          <p:sp>
            <p:nvSpPr>
              <p:cNvPr id="60" name="Arrow: Up 59">
                <a:extLst>
                  <a:ext uri="{FF2B5EF4-FFF2-40B4-BE49-F238E27FC236}">
                    <a16:creationId xmlns:a16="http://schemas.microsoft.com/office/drawing/2014/main" id="{729747FC-88A0-4485-A698-3B6A90896DEE}"/>
                  </a:ext>
                </a:extLst>
              </p:cNvPr>
              <p:cNvSpPr/>
              <p:nvPr/>
            </p:nvSpPr>
            <p:spPr>
              <a:xfrm rot="10800000">
                <a:off x="6921645" y="3280812"/>
                <a:ext cx="127168" cy="202405"/>
              </a:xfrm>
              <a:prstGeom prst="up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61" name="Arrow: Up 60">
                <a:extLst>
                  <a:ext uri="{FF2B5EF4-FFF2-40B4-BE49-F238E27FC236}">
                    <a16:creationId xmlns:a16="http://schemas.microsoft.com/office/drawing/2014/main" id="{0B721877-DDCD-4D47-B5A0-B8118BCF33F6}"/>
                  </a:ext>
                </a:extLst>
              </p:cNvPr>
              <p:cNvSpPr/>
              <p:nvPr/>
            </p:nvSpPr>
            <p:spPr>
              <a:xfrm rot="10800000">
                <a:off x="7101749" y="3280812"/>
                <a:ext cx="127168" cy="202405"/>
              </a:xfrm>
              <a:prstGeom prst="up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62" name="Arrow: Up 61">
                <a:extLst>
                  <a:ext uri="{FF2B5EF4-FFF2-40B4-BE49-F238E27FC236}">
                    <a16:creationId xmlns:a16="http://schemas.microsoft.com/office/drawing/2014/main" id="{BD5720C3-75CD-420D-A0CD-4118CD74CB6C}"/>
                  </a:ext>
                </a:extLst>
              </p:cNvPr>
              <p:cNvSpPr/>
              <p:nvPr/>
            </p:nvSpPr>
            <p:spPr>
              <a:xfrm rot="10800000">
                <a:off x="7281853" y="3280812"/>
                <a:ext cx="127168" cy="202405"/>
              </a:xfrm>
              <a:prstGeom prst="up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63" name="Arrow: Up 62">
                <a:extLst>
                  <a:ext uri="{FF2B5EF4-FFF2-40B4-BE49-F238E27FC236}">
                    <a16:creationId xmlns:a16="http://schemas.microsoft.com/office/drawing/2014/main" id="{03F1094F-0C79-4ED4-852F-5C6B7871F310}"/>
                  </a:ext>
                </a:extLst>
              </p:cNvPr>
              <p:cNvSpPr/>
              <p:nvPr/>
            </p:nvSpPr>
            <p:spPr>
              <a:xfrm rot="10800000">
                <a:off x="7461957" y="3280812"/>
                <a:ext cx="127168" cy="202405"/>
              </a:xfrm>
              <a:prstGeom prst="up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64" name="Arrow: Up 63">
                <a:extLst>
                  <a:ext uri="{FF2B5EF4-FFF2-40B4-BE49-F238E27FC236}">
                    <a16:creationId xmlns:a16="http://schemas.microsoft.com/office/drawing/2014/main" id="{7DE1A3E6-F6C2-42DE-BC8F-742EE79D7AC7}"/>
                  </a:ext>
                </a:extLst>
              </p:cNvPr>
              <p:cNvSpPr/>
              <p:nvPr/>
            </p:nvSpPr>
            <p:spPr>
              <a:xfrm rot="10800000">
                <a:off x="7642060" y="3280812"/>
                <a:ext cx="127168" cy="202405"/>
              </a:xfrm>
              <a:prstGeom prst="up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5349029F-AFF7-4AAA-B375-29E758C10BDF}"/>
                </a:ext>
              </a:extLst>
            </p:cNvPr>
            <p:cNvSpPr/>
            <p:nvPr/>
          </p:nvSpPr>
          <p:spPr>
            <a:xfrm>
              <a:off x="8533314" y="1194570"/>
              <a:ext cx="552338" cy="111009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D78E86BC-A026-4044-86AB-69DFA638A3BD}"/>
                </a:ext>
              </a:extLst>
            </p:cNvPr>
            <p:cNvSpPr/>
            <p:nvPr/>
          </p:nvSpPr>
          <p:spPr>
            <a:xfrm>
              <a:off x="7997694" y="1194570"/>
              <a:ext cx="141045" cy="111009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0A7C0A15-3E10-4BB9-BCDF-8EA6E6FE1843}"/>
                </a:ext>
              </a:extLst>
            </p:cNvPr>
            <p:cNvSpPr/>
            <p:nvPr/>
          </p:nvSpPr>
          <p:spPr>
            <a:xfrm>
              <a:off x="6373314" y="1194570"/>
              <a:ext cx="141045" cy="111009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DDCD1F7E-897E-47BC-A0AF-08CBEF1EB02B}"/>
                </a:ext>
              </a:extLst>
            </p:cNvPr>
            <p:cNvSpPr/>
            <p:nvPr/>
          </p:nvSpPr>
          <p:spPr>
            <a:xfrm>
              <a:off x="10524213" y="1891229"/>
              <a:ext cx="141045" cy="417218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015AE6AF-BA48-4A87-A5B1-C17DA3B6648D}"/>
                </a:ext>
              </a:extLst>
            </p:cNvPr>
            <p:cNvSpPr/>
            <p:nvPr/>
          </p:nvSpPr>
          <p:spPr>
            <a:xfrm>
              <a:off x="10161001" y="1891229"/>
              <a:ext cx="141045" cy="41343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85E412D-77EE-4EBA-AA45-986D8748ED24}"/>
              </a:ext>
            </a:extLst>
          </p:cNvPr>
          <p:cNvGrpSpPr/>
          <p:nvPr/>
        </p:nvGrpSpPr>
        <p:grpSpPr>
          <a:xfrm>
            <a:off x="5858854" y="3373875"/>
            <a:ext cx="6470055" cy="2928488"/>
            <a:chOff x="5858854" y="3468465"/>
            <a:chExt cx="6470055" cy="2928488"/>
          </a:xfrm>
        </p:grpSpPr>
        <p:graphicFrame>
          <p:nvGraphicFramePr>
            <p:cNvPr id="14" name="Chart 13">
              <a:extLst>
                <a:ext uri="{FF2B5EF4-FFF2-40B4-BE49-F238E27FC236}">
                  <a16:creationId xmlns:a16="http://schemas.microsoft.com/office/drawing/2014/main" id="{88ED1A4C-2844-4DAB-AB8B-E9014F2D29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5232435"/>
                </p:ext>
              </p:extLst>
            </p:nvPr>
          </p:nvGraphicFramePr>
          <p:xfrm>
            <a:off x="5858854" y="3468465"/>
            <a:ext cx="6470055" cy="2928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D5A47BF9-56E3-4982-9D76-71903064B787}"/>
                </a:ext>
              </a:extLst>
            </p:cNvPr>
            <p:cNvSpPr/>
            <p:nvPr/>
          </p:nvSpPr>
          <p:spPr>
            <a:xfrm>
              <a:off x="6416747" y="4371151"/>
              <a:ext cx="176169" cy="760491"/>
            </a:xfrm>
            <a:prstGeom prst="rect">
              <a:avLst/>
            </a:prstGeom>
            <a:solidFill>
              <a:schemeClr val="accent5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38A1FDB6-DF59-4DC8-AA55-6C219ADE68A6}"/>
                </a:ext>
              </a:extLst>
            </p:cNvPr>
            <p:cNvSpPr/>
            <p:nvPr/>
          </p:nvSpPr>
          <p:spPr>
            <a:xfrm>
              <a:off x="7540941" y="4372183"/>
              <a:ext cx="176169" cy="760491"/>
            </a:xfrm>
            <a:prstGeom prst="rect">
              <a:avLst/>
            </a:prstGeom>
            <a:solidFill>
              <a:schemeClr val="accent5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74" name="Arrow: Up 73">
              <a:extLst>
                <a:ext uri="{FF2B5EF4-FFF2-40B4-BE49-F238E27FC236}">
                  <a16:creationId xmlns:a16="http://schemas.microsoft.com/office/drawing/2014/main" id="{9546E3E7-74AF-4E5D-ACB2-55288DBEEFB4}"/>
                </a:ext>
              </a:extLst>
            </p:cNvPr>
            <p:cNvSpPr/>
            <p:nvPr/>
          </p:nvSpPr>
          <p:spPr>
            <a:xfrm rot="10800000">
              <a:off x="7251158" y="5793192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109499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FDD3DB3-ECA5-47EE-B063-F3E2331682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6839573"/>
              </p:ext>
            </p:extLst>
          </p:nvPr>
        </p:nvGraphicFramePr>
        <p:xfrm>
          <a:off x="226127" y="915022"/>
          <a:ext cx="11659975" cy="4712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Rectangle 15">
            <a:extLst>
              <a:ext uri="{FF2B5EF4-FFF2-40B4-BE49-F238E27FC236}">
                <a16:creationId xmlns:a16="http://schemas.microsoft.com/office/drawing/2014/main" id="{54CF306D-A463-4AD3-B701-95C4E942331D}"/>
              </a:ext>
            </a:extLst>
          </p:cNvPr>
          <p:cNvSpPr/>
          <p:nvPr/>
        </p:nvSpPr>
        <p:spPr>
          <a:xfrm>
            <a:off x="836276" y="5473914"/>
            <a:ext cx="10924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/>
              <a:t>Figure S10   </a:t>
            </a:r>
            <a:r>
              <a:rPr lang="en-GB" altLang="zh-CN" sz="1400" dirty="0"/>
              <a:t>Analysis of triacylglycerols from DHA2015.1 and DHA2015.5 seeds of </a:t>
            </a:r>
            <a:r>
              <a:rPr lang="en-GB" altLang="zh-CN" sz="1400" i="1" dirty="0"/>
              <a:t>C. sativa</a:t>
            </a:r>
            <a:r>
              <a:rPr lang="en-GB" sz="1400" dirty="0"/>
              <a:t>.  Values are mean ± SE, n=3.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table increases between DHA2015.1 and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DHA2015.5 lines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e highlighted with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blue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oxes. TAG species decreased in the transgenic lines are indicated with the open arrows.</a:t>
            </a:r>
            <a:endParaRPr lang="en-GB" sz="14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86888EA-6AFB-4BFD-B755-D532D6DD6046}"/>
              </a:ext>
            </a:extLst>
          </p:cNvPr>
          <p:cNvSpPr/>
          <p:nvPr/>
        </p:nvSpPr>
        <p:spPr>
          <a:xfrm>
            <a:off x="370100" y="101595"/>
            <a:ext cx="11695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Figure S10</a:t>
            </a:r>
            <a:endParaRPr lang="en-GB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6AEA099-17B2-4AD8-A2CB-195AE3D1F5B1}"/>
              </a:ext>
            </a:extLst>
          </p:cNvPr>
          <p:cNvSpPr/>
          <p:nvPr/>
        </p:nvSpPr>
        <p:spPr>
          <a:xfrm>
            <a:off x="1792761" y="2814223"/>
            <a:ext cx="301656" cy="1779691"/>
          </a:xfrm>
          <a:prstGeom prst="rect">
            <a:avLst/>
          </a:prstGeom>
          <a:solidFill>
            <a:schemeClr val="accent5">
              <a:lumMod val="60000"/>
              <a:lumOff val="40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A12C06B-9865-4D87-B68F-D610C2A96941}"/>
              </a:ext>
            </a:extLst>
          </p:cNvPr>
          <p:cNvSpPr/>
          <p:nvPr/>
        </p:nvSpPr>
        <p:spPr>
          <a:xfrm>
            <a:off x="3295108" y="2814223"/>
            <a:ext cx="301656" cy="1779691"/>
          </a:xfrm>
          <a:prstGeom prst="rect">
            <a:avLst/>
          </a:prstGeom>
          <a:solidFill>
            <a:schemeClr val="accent5">
              <a:lumMod val="60000"/>
              <a:lumOff val="40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5C91657-08C8-493C-892E-AED34C491F0A}"/>
              </a:ext>
            </a:extLst>
          </p:cNvPr>
          <p:cNvGrpSpPr/>
          <p:nvPr/>
        </p:nvGrpSpPr>
        <p:grpSpPr>
          <a:xfrm>
            <a:off x="6623444" y="4960862"/>
            <a:ext cx="282197" cy="202406"/>
            <a:chOff x="6611332" y="5213105"/>
            <a:chExt cx="282197" cy="202406"/>
          </a:xfrm>
        </p:grpSpPr>
        <p:sp>
          <p:nvSpPr>
            <p:cNvPr id="21" name="Arrow: Up 20">
              <a:extLst>
                <a:ext uri="{FF2B5EF4-FFF2-40B4-BE49-F238E27FC236}">
                  <a16:creationId xmlns:a16="http://schemas.microsoft.com/office/drawing/2014/main" id="{FD79CDF0-8198-420E-86B4-19F25529FCF6}"/>
                </a:ext>
              </a:extLst>
            </p:cNvPr>
            <p:cNvSpPr/>
            <p:nvPr/>
          </p:nvSpPr>
          <p:spPr>
            <a:xfrm rot="10800000">
              <a:off x="6611332" y="5213105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22" name="Arrow: Up 21">
              <a:extLst>
                <a:ext uri="{FF2B5EF4-FFF2-40B4-BE49-F238E27FC236}">
                  <a16:creationId xmlns:a16="http://schemas.microsoft.com/office/drawing/2014/main" id="{D5BD6058-CAF3-4C76-9689-1BD3D176C0FF}"/>
                </a:ext>
              </a:extLst>
            </p:cNvPr>
            <p:cNvSpPr/>
            <p:nvPr/>
          </p:nvSpPr>
          <p:spPr>
            <a:xfrm rot="10800000">
              <a:off x="6766361" y="5213106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99215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0BE12C-C63B-4C36-9CD3-85743E609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9510" y="208108"/>
            <a:ext cx="6068538" cy="700612"/>
          </a:xfrm>
        </p:spPr>
        <p:txBody>
          <a:bodyPr>
            <a:normAutofit/>
          </a:bodyPr>
          <a:lstStyle/>
          <a:p>
            <a:r>
              <a:rPr lang="en-GB" sz="1400" b="1" dirty="0"/>
              <a:t>	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1B87F7D-651F-4954-B69D-01388E0A4F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2158800"/>
              </p:ext>
            </p:extLst>
          </p:nvPr>
        </p:nvGraphicFramePr>
        <p:xfrm>
          <a:off x="-119866" y="791734"/>
          <a:ext cx="12192000" cy="47233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5197AD38-0293-4D7A-8FB2-221E102B6EDF}"/>
              </a:ext>
            </a:extLst>
          </p:cNvPr>
          <p:cNvSpPr/>
          <p:nvPr/>
        </p:nvSpPr>
        <p:spPr>
          <a:xfrm>
            <a:off x="772805" y="5781849"/>
            <a:ext cx="1113002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/>
              <a:t>Figure S11  </a:t>
            </a:r>
            <a:r>
              <a:rPr lang="en-GB" altLang="zh-CN" sz="1400" dirty="0"/>
              <a:t>Analysis of triacylglycerols from EPA2016.1 and EPA2015.8 seeds of </a:t>
            </a:r>
            <a:r>
              <a:rPr lang="en-GB" altLang="zh-CN" sz="1400" i="1" dirty="0"/>
              <a:t>C. sativa</a:t>
            </a:r>
            <a:r>
              <a:rPr lang="en-GB" sz="1400" dirty="0"/>
              <a:t>.  Values are mean ± SE, n=3.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table increases between EPA2016.1 and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EPA2015.8 lines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e highlighted with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yellow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oxes. TAG species decreased in the transgenic lines are indicated with the open arrows.</a:t>
            </a:r>
            <a:endParaRPr lang="en-GB" sz="14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3878442-BD63-45CF-A2DE-CCBB68BA43AC}"/>
              </a:ext>
            </a:extLst>
          </p:cNvPr>
          <p:cNvSpPr/>
          <p:nvPr/>
        </p:nvSpPr>
        <p:spPr>
          <a:xfrm>
            <a:off x="373722" y="208108"/>
            <a:ext cx="11695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Figure S11</a:t>
            </a:r>
            <a:endParaRPr lang="en-GB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9DCF6DD-C263-41FB-B3C0-F60913ACBE42}"/>
              </a:ext>
            </a:extLst>
          </p:cNvPr>
          <p:cNvSpPr/>
          <p:nvPr/>
        </p:nvSpPr>
        <p:spPr>
          <a:xfrm>
            <a:off x="2803631" y="1875934"/>
            <a:ext cx="165812" cy="3126529"/>
          </a:xfrm>
          <a:prstGeom prst="rect">
            <a:avLst/>
          </a:prstGeom>
          <a:solidFill>
            <a:schemeClr val="accent4">
              <a:lumMod val="60000"/>
              <a:lumOff val="40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40F1A77-3862-444F-A2C4-CB56F80861AA}"/>
              </a:ext>
            </a:extLst>
          </p:cNvPr>
          <p:cNvSpPr/>
          <p:nvPr/>
        </p:nvSpPr>
        <p:spPr>
          <a:xfrm>
            <a:off x="5144440" y="1872030"/>
            <a:ext cx="165812" cy="3126529"/>
          </a:xfrm>
          <a:prstGeom prst="rect">
            <a:avLst/>
          </a:prstGeom>
          <a:solidFill>
            <a:schemeClr val="accent4">
              <a:lumMod val="60000"/>
              <a:lumOff val="40000"/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249102C-6499-4889-93EC-CD416E4635A3}"/>
              </a:ext>
            </a:extLst>
          </p:cNvPr>
          <p:cNvGrpSpPr/>
          <p:nvPr/>
        </p:nvGrpSpPr>
        <p:grpSpPr>
          <a:xfrm>
            <a:off x="4682089" y="5384591"/>
            <a:ext cx="3076338" cy="202405"/>
            <a:chOff x="4682089" y="5384591"/>
            <a:chExt cx="3076338" cy="202405"/>
          </a:xfrm>
        </p:grpSpPr>
        <p:sp>
          <p:nvSpPr>
            <p:cNvPr id="14" name="Arrow: Up 13">
              <a:extLst>
                <a:ext uri="{FF2B5EF4-FFF2-40B4-BE49-F238E27FC236}">
                  <a16:creationId xmlns:a16="http://schemas.microsoft.com/office/drawing/2014/main" id="{E37E7442-49EA-4825-A021-4B090E4A223A}"/>
                </a:ext>
              </a:extLst>
            </p:cNvPr>
            <p:cNvSpPr/>
            <p:nvPr/>
          </p:nvSpPr>
          <p:spPr>
            <a:xfrm rot="10800000">
              <a:off x="4996544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5" name="Arrow: Up 14">
              <a:extLst>
                <a:ext uri="{FF2B5EF4-FFF2-40B4-BE49-F238E27FC236}">
                  <a16:creationId xmlns:a16="http://schemas.microsoft.com/office/drawing/2014/main" id="{0B4EDB91-292F-472D-918A-A683D0CE6855}"/>
                </a:ext>
              </a:extLst>
            </p:cNvPr>
            <p:cNvSpPr/>
            <p:nvPr/>
          </p:nvSpPr>
          <p:spPr>
            <a:xfrm rot="10800000">
              <a:off x="4682089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16" name="Arrow: Up 15">
              <a:extLst>
                <a:ext uri="{FF2B5EF4-FFF2-40B4-BE49-F238E27FC236}">
                  <a16:creationId xmlns:a16="http://schemas.microsoft.com/office/drawing/2014/main" id="{E9DC9046-15C1-4B19-A91E-6C77028F7150}"/>
                </a:ext>
              </a:extLst>
            </p:cNvPr>
            <p:cNvSpPr/>
            <p:nvPr/>
          </p:nvSpPr>
          <p:spPr>
            <a:xfrm rot="10800000">
              <a:off x="5611775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7" name="Arrow: Up 16">
              <a:extLst>
                <a:ext uri="{FF2B5EF4-FFF2-40B4-BE49-F238E27FC236}">
                  <a16:creationId xmlns:a16="http://schemas.microsoft.com/office/drawing/2014/main" id="{907C8F0C-4DC8-41F8-8F13-87D77FCFCE7F}"/>
                </a:ext>
              </a:extLst>
            </p:cNvPr>
            <p:cNvSpPr/>
            <p:nvPr/>
          </p:nvSpPr>
          <p:spPr>
            <a:xfrm rot="10800000">
              <a:off x="6086500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8" name="Arrow: Up 17">
              <a:extLst>
                <a:ext uri="{FF2B5EF4-FFF2-40B4-BE49-F238E27FC236}">
                  <a16:creationId xmlns:a16="http://schemas.microsoft.com/office/drawing/2014/main" id="{DABB3037-CD1A-469F-8965-DC27349BC9EE}"/>
                </a:ext>
              </a:extLst>
            </p:cNvPr>
            <p:cNvSpPr/>
            <p:nvPr/>
          </p:nvSpPr>
          <p:spPr>
            <a:xfrm rot="10800000">
              <a:off x="6230500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9" name="Arrow: Up 18">
              <a:extLst>
                <a:ext uri="{FF2B5EF4-FFF2-40B4-BE49-F238E27FC236}">
                  <a16:creationId xmlns:a16="http://schemas.microsoft.com/office/drawing/2014/main" id="{899B24CA-C975-497C-8AB9-C299A1A060EB}"/>
                </a:ext>
              </a:extLst>
            </p:cNvPr>
            <p:cNvSpPr/>
            <p:nvPr/>
          </p:nvSpPr>
          <p:spPr>
            <a:xfrm rot="10800000">
              <a:off x="7631259" y="5384591"/>
              <a:ext cx="127168" cy="20240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39675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E42D194-2864-441E-9825-94C9AF9DB8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7838585"/>
              </p:ext>
            </p:extLst>
          </p:nvPr>
        </p:nvGraphicFramePr>
        <p:xfrm>
          <a:off x="454386" y="1139611"/>
          <a:ext cx="10905066" cy="4187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71E17B3-B1E7-4DA8-9912-47D41B9C5BB8}"/>
              </a:ext>
            </a:extLst>
          </p:cNvPr>
          <p:cNvSpPr txBox="1"/>
          <p:nvPr/>
        </p:nvSpPr>
        <p:spPr>
          <a:xfrm>
            <a:off x="1459005" y="5579889"/>
            <a:ext cx="8771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400" b="1" dirty="0"/>
              <a:t>Figure S1  </a:t>
            </a:r>
            <a:r>
              <a:rPr lang="en-GB" altLang="zh-CN" sz="1400" dirty="0"/>
              <a:t>T3 greenhouse grown seeds fames data for WT and DHAs lines DHA2015.1-5. </a:t>
            </a:r>
            <a:r>
              <a:rPr lang="en-GB" sz="1400" dirty="0"/>
              <a:t>Values are mean ± SE, n=3.</a:t>
            </a:r>
            <a:endParaRPr lang="en-GB" altLang="zh-CN" sz="1400" b="1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EEE1CEE-61FA-48C8-82C2-1AAB37D4A130}"/>
              </a:ext>
            </a:extLst>
          </p:cNvPr>
          <p:cNvSpPr/>
          <p:nvPr/>
        </p:nvSpPr>
        <p:spPr>
          <a:xfrm>
            <a:off x="454386" y="307496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/>
              <a:t>Figure S1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49200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3D65E0A-5999-4661-8FB2-16DBBF7FA7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5048065"/>
              </p:ext>
            </p:extLst>
          </p:nvPr>
        </p:nvGraphicFramePr>
        <p:xfrm>
          <a:off x="643467" y="1012800"/>
          <a:ext cx="10905066" cy="42907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A39AFE1-1C8E-4A92-8AE0-B848F645A6B3}"/>
              </a:ext>
            </a:extLst>
          </p:cNvPr>
          <p:cNvSpPr txBox="1"/>
          <p:nvPr/>
        </p:nvSpPr>
        <p:spPr>
          <a:xfrm>
            <a:off x="1523928" y="5484798"/>
            <a:ext cx="96339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400" b="1" dirty="0"/>
              <a:t>Figure S2  </a:t>
            </a:r>
            <a:r>
              <a:rPr lang="en-GB" altLang="zh-CN" sz="1400" dirty="0"/>
              <a:t>T3 greenhouse grown seeds fames data for WT and EPAs lines EPA2015.4, EPA2015.8 and EPA2016.1. </a:t>
            </a:r>
            <a:r>
              <a:rPr lang="en-GB" sz="1400" dirty="0"/>
              <a:t>Values are mean ± SE, n=3.</a:t>
            </a:r>
            <a:r>
              <a:rPr lang="en-GB" altLang="zh-CN" sz="1400" b="1" dirty="0"/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CFE5C20-1308-4F41-AD14-EC33815D5926}"/>
              </a:ext>
            </a:extLst>
          </p:cNvPr>
          <p:cNvSpPr/>
          <p:nvPr/>
        </p:nvSpPr>
        <p:spPr>
          <a:xfrm>
            <a:off x="643467" y="275224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/>
              <a:t>Figure S2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707282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3540721"/>
              </p:ext>
            </p:extLst>
          </p:nvPr>
        </p:nvGraphicFramePr>
        <p:xfrm>
          <a:off x="2898454" y="3700811"/>
          <a:ext cx="6844359" cy="2118585"/>
        </p:xfrm>
        <a:graphic>
          <a:graphicData uri="http://schemas.openxmlformats.org/drawingml/2006/table">
            <a:tbl>
              <a:tblPr/>
              <a:tblGrid>
                <a:gridCol w="342218">
                  <a:extLst>
                    <a:ext uri="{9D8B030D-6E8A-4147-A177-3AD203B41FA5}">
                      <a16:colId xmlns:a16="http://schemas.microsoft.com/office/drawing/2014/main" val="2605112591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4132393716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1689905586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7618329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3284726022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707632886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4094718914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1335275983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2383531615"/>
                    </a:ext>
                  </a:extLst>
                </a:gridCol>
                <a:gridCol w="292621">
                  <a:extLst>
                    <a:ext uri="{9D8B030D-6E8A-4147-A177-3AD203B41FA5}">
                      <a16:colId xmlns:a16="http://schemas.microsoft.com/office/drawing/2014/main" val="2805654272"/>
                    </a:ext>
                  </a:extLst>
                </a:gridCol>
                <a:gridCol w="391815">
                  <a:extLst>
                    <a:ext uri="{9D8B030D-6E8A-4147-A177-3AD203B41FA5}">
                      <a16:colId xmlns:a16="http://schemas.microsoft.com/office/drawing/2014/main" val="3809170392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2337615626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2302016094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2525838978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3599443948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4011595574"/>
                    </a:ext>
                  </a:extLst>
                </a:gridCol>
                <a:gridCol w="343871">
                  <a:extLst>
                    <a:ext uri="{9D8B030D-6E8A-4147-A177-3AD203B41FA5}">
                      <a16:colId xmlns:a16="http://schemas.microsoft.com/office/drawing/2014/main" val="528051957"/>
                    </a:ext>
                  </a:extLst>
                </a:gridCol>
                <a:gridCol w="340564">
                  <a:extLst>
                    <a:ext uri="{9D8B030D-6E8A-4147-A177-3AD203B41FA5}">
                      <a16:colId xmlns:a16="http://schemas.microsoft.com/office/drawing/2014/main" val="3326112405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3503678129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4019281600"/>
                    </a:ext>
                  </a:extLst>
                </a:gridCol>
              </a:tblGrid>
              <a:tr h="260349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</a:t>
                      </a:r>
                    </a:p>
                  </a:txBody>
                  <a:tcPr marL="4613" marR="4613" marT="461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242647"/>
                  </a:ext>
                </a:extLst>
              </a:tr>
              <a:tr h="784235"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1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2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3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4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5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5.4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5.8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6.1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T_C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148060"/>
                  </a:ext>
                </a:extLst>
              </a:tr>
              <a:tr h="260349"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3934831"/>
                  </a:ext>
                </a:extLst>
              </a:tr>
              <a:tr h="813652"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1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2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3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4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HA2015.5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5.4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5.8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A2016.1</a:t>
                      </a: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T_C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613" marR="4613" marT="4613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811801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E71B1D9-DBB4-4C2B-A42C-FAB75166E0DE}"/>
              </a:ext>
            </a:extLst>
          </p:cNvPr>
          <p:cNvSpPr txBox="1"/>
          <p:nvPr/>
        </p:nvSpPr>
        <p:spPr>
          <a:xfrm>
            <a:off x="2799827" y="6016380"/>
            <a:ext cx="70416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gure S3  </a:t>
            </a:r>
            <a:r>
              <a:rPr lang="en-GB" sz="1400" dirty="0"/>
              <a:t>2018 field trial plot map on the </a:t>
            </a:r>
            <a:r>
              <a:rPr lang="en-GB" sz="1400" dirty="0" err="1"/>
              <a:t>Rothamsted</a:t>
            </a:r>
            <a:r>
              <a:rPr lang="en-GB" sz="1400" dirty="0"/>
              <a:t> experimental farm Appletree location.  The detailed plot name is indicated. Each line with two replicate plots.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CBF86AE-509E-4CE4-8828-4B19FD4C23F1}"/>
              </a:ext>
            </a:extLst>
          </p:cNvPr>
          <p:cNvGrpSpPr/>
          <p:nvPr/>
        </p:nvGrpSpPr>
        <p:grpSpPr>
          <a:xfrm>
            <a:off x="2898454" y="580010"/>
            <a:ext cx="5809331" cy="2972407"/>
            <a:chOff x="3266108" y="362217"/>
            <a:chExt cx="5809331" cy="297240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77F758D-4F2B-4C0A-ACE0-2A17C600F3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6108" y="362217"/>
              <a:ext cx="5809331" cy="2972407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43E370D8-2F66-4777-BF19-90C6F66DAAF3}"/>
                </a:ext>
              </a:extLst>
            </p:cNvPr>
            <p:cNvSpPr/>
            <p:nvPr/>
          </p:nvSpPr>
          <p:spPr>
            <a:xfrm>
              <a:off x="4479721" y="1238915"/>
              <a:ext cx="1904301" cy="136740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104B6975-E2E6-4250-8525-92AC5B7652A3}"/>
              </a:ext>
            </a:extLst>
          </p:cNvPr>
          <p:cNvSpPr/>
          <p:nvPr/>
        </p:nvSpPr>
        <p:spPr>
          <a:xfrm>
            <a:off x="583478" y="210678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Figure S3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16538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982F880-A48C-4E82-A45D-A316EF79A858}"/>
              </a:ext>
            </a:extLst>
          </p:cNvPr>
          <p:cNvGrpSpPr/>
          <p:nvPr/>
        </p:nvGrpSpPr>
        <p:grpSpPr>
          <a:xfrm>
            <a:off x="836067" y="475824"/>
            <a:ext cx="10286596" cy="5592583"/>
            <a:chOff x="-9289" y="-19174"/>
            <a:chExt cx="8807307" cy="4983822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83FDA453-EBE5-4212-A971-0DCC098C324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474744733"/>
                </p:ext>
              </p:extLst>
            </p:nvPr>
          </p:nvGraphicFramePr>
          <p:xfrm>
            <a:off x="-9289" y="-19174"/>
            <a:ext cx="4280305" cy="254590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C90ED75F-D9E4-40F0-81A2-F62B63BAFFF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140601632"/>
                </p:ext>
              </p:extLst>
            </p:nvPr>
          </p:nvGraphicFramePr>
          <p:xfrm>
            <a:off x="4521257" y="13048"/>
            <a:ext cx="4262112" cy="24139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2BC6BC7B-60B2-47C2-8D51-2C6F09A366B4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913535931"/>
                </p:ext>
              </p:extLst>
            </p:nvPr>
          </p:nvGraphicFramePr>
          <p:xfrm>
            <a:off x="0" y="2545907"/>
            <a:ext cx="4280305" cy="24056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9E277C1D-833C-46FB-9FD2-53F70D855E33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115876535"/>
                </p:ext>
              </p:extLst>
            </p:nvPr>
          </p:nvGraphicFramePr>
          <p:xfrm>
            <a:off x="4518944" y="2558956"/>
            <a:ext cx="4279074" cy="24056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74BB3B2-4F2E-4727-8FF5-28C4A9F4374C}"/>
              </a:ext>
            </a:extLst>
          </p:cNvPr>
          <p:cNvSpPr txBox="1"/>
          <p:nvPr/>
        </p:nvSpPr>
        <p:spPr>
          <a:xfrm>
            <a:off x="1597625" y="6243676"/>
            <a:ext cx="9384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400" b="1" dirty="0"/>
              <a:t>Figure S4   </a:t>
            </a:r>
            <a:r>
              <a:rPr lang="en-GB" altLang="zh-CN" sz="1400" dirty="0"/>
              <a:t>2018 field trial different DHAs lines DHA2015.2-4 comparing with DHA2015.1 FAMEs.</a:t>
            </a:r>
            <a:r>
              <a:rPr lang="en-GB" sz="1400" dirty="0"/>
              <a:t> Values are mean ± SE, n=3.</a:t>
            </a:r>
            <a:r>
              <a:rPr lang="en-GB" altLang="zh-CN" sz="1400" b="1" dirty="0"/>
              <a:t> </a:t>
            </a:r>
            <a:endParaRPr lang="zh-CN" altLang="en-US" sz="1400" b="1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BDEC825-123F-409D-BF98-6A2E9B832154}"/>
              </a:ext>
            </a:extLst>
          </p:cNvPr>
          <p:cNvSpPr/>
          <p:nvPr/>
        </p:nvSpPr>
        <p:spPr>
          <a:xfrm>
            <a:off x="325294" y="128180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/>
              <a:t>Figure S4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436229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D073FD68-B515-45E4-BF04-E797B4B3D319}"/>
              </a:ext>
            </a:extLst>
          </p:cNvPr>
          <p:cNvGrpSpPr/>
          <p:nvPr/>
        </p:nvGrpSpPr>
        <p:grpSpPr>
          <a:xfrm>
            <a:off x="1256653" y="1027916"/>
            <a:ext cx="10256922" cy="5693559"/>
            <a:chOff x="1256653" y="1027916"/>
            <a:chExt cx="10256922" cy="5693559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74A5ADBD-BB23-4869-87A7-A39D66B1DC3B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505663717"/>
                </p:ext>
              </p:extLst>
            </p:nvPr>
          </p:nvGraphicFramePr>
          <p:xfrm>
            <a:off x="6424342" y="1040899"/>
            <a:ext cx="4701753" cy="27047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7506D07E-AFAD-473B-A513-31689FAF7F3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112781753"/>
                </p:ext>
              </p:extLst>
            </p:nvPr>
          </p:nvGraphicFramePr>
          <p:xfrm>
            <a:off x="1337187" y="4006471"/>
            <a:ext cx="4672350" cy="27150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E3ABF701-4EB2-45BD-BEAE-FA58614DD2E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197184092"/>
                </p:ext>
              </p:extLst>
            </p:nvPr>
          </p:nvGraphicFramePr>
          <p:xfrm>
            <a:off x="1256653" y="1027916"/>
            <a:ext cx="4752884" cy="26851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3F8F9EA-DFAD-4778-8BE6-934EB54FF509}"/>
                </a:ext>
              </a:extLst>
            </p:cNvPr>
            <p:cNvSpPr txBox="1"/>
            <p:nvPr/>
          </p:nvSpPr>
          <p:spPr>
            <a:xfrm>
              <a:off x="6711023" y="4647449"/>
              <a:ext cx="480255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altLang="zh-CN" sz="1400" b="1" dirty="0"/>
                <a:t>Figure S5   </a:t>
              </a:r>
              <a:r>
                <a:rPr lang="en-GB" altLang="zh-CN" sz="1400" dirty="0"/>
                <a:t>2018 field trial different EPAs lines EPA2016.1, EPA2015.4 and EPA2015.8 comparing with EPA_B4.1 FAMEs. </a:t>
              </a:r>
              <a:r>
                <a:rPr lang="en-GB" sz="1400" dirty="0"/>
                <a:t>Values are mean ± SE, n=3.</a:t>
              </a:r>
              <a:r>
                <a:rPr lang="en-GB" altLang="zh-CN" sz="1400" b="1" dirty="0"/>
                <a:t> </a:t>
              </a:r>
              <a:endParaRPr lang="zh-CN" altLang="en-US" sz="1400" b="1" dirty="0"/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5991F005-30E4-4A48-9C95-BAE9BA63ADD8}"/>
              </a:ext>
            </a:extLst>
          </p:cNvPr>
          <p:cNvSpPr/>
          <p:nvPr/>
        </p:nvSpPr>
        <p:spPr>
          <a:xfrm>
            <a:off x="345272" y="210979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/>
              <a:t>Figure S5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336585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2D240EEB-3970-42A1-8A96-185FAC3E8C44}"/>
              </a:ext>
            </a:extLst>
          </p:cNvPr>
          <p:cNvSpPr/>
          <p:nvPr/>
        </p:nvSpPr>
        <p:spPr>
          <a:xfrm>
            <a:off x="997626" y="6198255"/>
            <a:ext cx="1023321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sz="1400" b="1" dirty="0"/>
              <a:t>Figure S6  </a:t>
            </a:r>
            <a:r>
              <a:rPr lang="en-GB" altLang="zh-CN" sz="1400" dirty="0"/>
              <a:t>Omega-3 LC-PUFA content in DHAs and EPAs lines of different generations. </a:t>
            </a:r>
            <a:r>
              <a:rPr lang="en-GB" sz="1400" dirty="0"/>
              <a:t>Values are mean ± SE. T2 greenhouse (GH) n=4, T3 GH n=3. Field trial (FT) data was collected from Figure 3 &amp; 4.</a:t>
            </a:r>
            <a:r>
              <a:rPr lang="en-GB" altLang="zh-CN" sz="1400" b="1" dirty="0"/>
              <a:t> </a:t>
            </a:r>
            <a:endParaRPr lang="zh-CN" altLang="en-US" sz="1400" b="1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203810A-5683-487E-ABAD-71B3D2D6E06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60666076"/>
              </p:ext>
            </p:extLst>
          </p:nvPr>
        </p:nvGraphicFramePr>
        <p:xfrm>
          <a:off x="7962231" y="136525"/>
          <a:ext cx="3268613" cy="19808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9B89775-1529-4D04-BFB0-D8C6A4EF22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89295521"/>
              </p:ext>
            </p:extLst>
          </p:nvPr>
        </p:nvGraphicFramePr>
        <p:xfrm>
          <a:off x="735013" y="2178215"/>
          <a:ext cx="3270656" cy="19825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D1A5A00-A0F3-4528-ACEF-46D8280F306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20601349"/>
              </p:ext>
            </p:extLst>
          </p:nvPr>
        </p:nvGraphicFramePr>
        <p:xfrm>
          <a:off x="4289081" y="2178215"/>
          <a:ext cx="3268114" cy="19831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42376-D9BC-46E9-9C9F-E843891EB34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70655350"/>
              </p:ext>
            </p:extLst>
          </p:nvPr>
        </p:nvGraphicFramePr>
        <p:xfrm>
          <a:off x="7962231" y="2178215"/>
          <a:ext cx="3271154" cy="19784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D49544D-A6CE-4197-8B55-6B9453A0981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93327127"/>
              </p:ext>
            </p:extLst>
          </p:nvPr>
        </p:nvGraphicFramePr>
        <p:xfrm>
          <a:off x="4294299" y="4188907"/>
          <a:ext cx="3268115" cy="19784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B050F97D-BE45-42E8-8E6D-23E4E36E350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25992156"/>
              </p:ext>
            </p:extLst>
          </p:nvPr>
        </p:nvGraphicFramePr>
        <p:xfrm>
          <a:off x="7976189" y="4184201"/>
          <a:ext cx="3270656" cy="19831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C9981B78-CB51-492C-B51F-3AAE9FED037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640503443"/>
              </p:ext>
            </p:extLst>
          </p:nvPr>
        </p:nvGraphicFramePr>
        <p:xfrm>
          <a:off x="715834" y="4184201"/>
          <a:ext cx="3268613" cy="19831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31ECB1A8-0DA6-40F0-BDCA-43381119282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94546267"/>
              </p:ext>
            </p:extLst>
          </p:nvPr>
        </p:nvGraphicFramePr>
        <p:xfrm>
          <a:off x="735013" y="136525"/>
          <a:ext cx="5885957" cy="1972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19" name="Group 18">
            <a:extLst>
              <a:ext uri="{FF2B5EF4-FFF2-40B4-BE49-F238E27FC236}">
                <a16:creationId xmlns:a16="http://schemas.microsoft.com/office/drawing/2014/main" id="{441A7214-E239-4806-BD87-80A25342D873}"/>
              </a:ext>
            </a:extLst>
          </p:cNvPr>
          <p:cNvGrpSpPr/>
          <p:nvPr/>
        </p:nvGrpSpPr>
        <p:grpSpPr>
          <a:xfrm>
            <a:off x="4289081" y="339337"/>
            <a:ext cx="2060880" cy="327548"/>
            <a:chOff x="3447535" y="826714"/>
            <a:chExt cx="2087880" cy="331839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A3FB3ED-F507-4DAD-8246-F0BF3C8919CD}"/>
                </a:ext>
              </a:extLst>
            </p:cNvPr>
            <p:cNvSpPr/>
            <p:nvPr/>
          </p:nvSpPr>
          <p:spPr>
            <a:xfrm>
              <a:off x="3447535" y="939114"/>
              <a:ext cx="148281" cy="139748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highlight>
                  <a:srgbClr val="00FF00"/>
                </a:highlight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7A1B323-53F7-456A-B827-F45148AD3ADB}"/>
                </a:ext>
              </a:extLst>
            </p:cNvPr>
            <p:cNvSpPr txBox="1"/>
            <p:nvPr/>
          </p:nvSpPr>
          <p:spPr>
            <a:xfrm>
              <a:off x="3595816" y="839665"/>
              <a:ext cx="580767" cy="318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440" dirty="0"/>
                <a:t>EPA</a:t>
              </a:r>
              <a:endParaRPr lang="zh-CN" altLang="en-US" sz="1440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2ADFC1A9-2254-4E88-94AE-451D9DB3D03A}"/>
                </a:ext>
              </a:extLst>
            </p:cNvPr>
            <p:cNvSpPr/>
            <p:nvPr/>
          </p:nvSpPr>
          <p:spPr>
            <a:xfrm>
              <a:off x="4126951" y="926757"/>
              <a:ext cx="148281" cy="139748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highlight>
                  <a:srgbClr val="00FF00"/>
                </a:highlight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00CC966-7F90-4FE0-8D28-EDB5A4CAA94D}"/>
                </a:ext>
              </a:extLst>
            </p:cNvPr>
            <p:cNvSpPr txBox="1"/>
            <p:nvPr/>
          </p:nvSpPr>
          <p:spPr>
            <a:xfrm>
              <a:off x="4275232" y="840508"/>
              <a:ext cx="580767" cy="318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440" dirty="0"/>
                <a:t>DPA</a:t>
              </a:r>
              <a:endParaRPr lang="zh-CN" altLang="en-US" sz="1440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402CCE4-55FF-45B2-9541-B6E88F392069}"/>
                </a:ext>
              </a:extLst>
            </p:cNvPr>
            <p:cNvSpPr/>
            <p:nvPr/>
          </p:nvSpPr>
          <p:spPr>
            <a:xfrm>
              <a:off x="4806367" y="926757"/>
              <a:ext cx="148281" cy="139748"/>
            </a:xfrm>
            <a:prstGeom prst="rect">
              <a:avLst/>
            </a:prstGeom>
            <a:solidFill>
              <a:srgbClr val="A5A5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highlight>
                  <a:srgbClr val="00FF00"/>
                </a:highlight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7AE91CD-7134-4C49-A648-7B368DC31CDB}"/>
                </a:ext>
              </a:extLst>
            </p:cNvPr>
            <p:cNvSpPr txBox="1"/>
            <p:nvPr/>
          </p:nvSpPr>
          <p:spPr>
            <a:xfrm>
              <a:off x="4954648" y="826714"/>
              <a:ext cx="580767" cy="318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440" dirty="0"/>
                <a:t>DHA</a:t>
              </a:r>
              <a:endParaRPr lang="zh-CN" altLang="en-US" sz="1440" dirty="0"/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00EEDB93-07AE-4DAB-99AF-435EABC21E27}"/>
              </a:ext>
            </a:extLst>
          </p:cNvPr>
          <p:cNvSpPr/>
          <p:nvPr/>
        </p:nvSpPr>
        <p:spPr>
          <a:xfrm>
            <a:off x="362480" y="149922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/>
              <a:t>Figure S6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448963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E85DC9EB-9186-4BC3-B598-DE2F10494C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9162637"/>
              </p:ext>
            </p:extLst>
          </p:nvPr>
        </p:nvGraphicFramePr>
        <p:xfrm>
          <a:off x="6457226" y="2978565"/>
          <a:ext cx="4512257" cy="17802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F07F591C-F968-451F-BE69-0384FA7A90CC}"/>
              </a:ext>
            </a:extLst>
          </p:cNvPr>
          <p:cNvSpPr/>
          <p:nvPr/>
        </p:nvSpPr>
        <p:spPr>
          <a:xfrm>
            <a:off x="226562" y="241327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>
                <a:latin typeface="Calibri-Bold"/>
              </a:rPr>
              <a:t>Figure S7 </a:t>
            </a:r>
            <a:endParaRPr lang="en-GB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5D4C014-8AAB-4586-9213-E7CBBBD567E1}"/>
              </a:ext>
            </a:extLst>
          </p:cNvPr>
          <p:cNvSpPr/>
          <p:nvPr/>
        </p:nvSpPr>
        <p:spPr>
          <a:xfrm>
            <a:off x="6524006" y="4971355"/>
            <a:ext cx="485528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sz="1400" b="1" dirty="0"/>
              <a:t>Figure S7   </a:t>
            </a:r>
            <a:r>
              <a:rPr lang="en-GB" altLang="zh-CN" sz="1400" dirty="0"/>
              <a:t>Single seed fatty acid composition analysis from the 2018 field trial DHA2015.1-5 lines</a:t>
            </a:r>
            <a:r>
              <a:rPr lang="en-GB" sz="1400" dirty="0"/>
              <a:t>. </a:t>
            </a:r>
            <a:endParaRPr lang="zh-CN" altLang="en-US" sz="1400" dirty="0"/>
          </a:p>
        </p:txBody>
      </p: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3BDE8ED3-CB93-469C-B8FD-6A481E12577C}"/>
              </a:ext>
            </a:extLst>
          </p:cNvPr>
          <p:cNvGrpSpPr/>
          <p:nvPr/>
        </p:nvGrpSpPr>
        <p:grpSpPr>
          <a:xfrm>
            <a:off x="1173317" y="329884"/>
            <a:ext cx="4690800" cy="2305409"/>
            <a:chOff x="1173317" y="329884"/>
            <a:chExt cx="4690800" cy="2305409"/>
          </a:xfrm>
        </p:grpSpPr>
        <p:graphicFrame>
          <p:nvGraphicFramePr>
            <p:cNvPr id="121" name="Chart 120">
              <a:extLst>
                <a:ext uri="{FF2B5EF4-FFF2-40B4-BE49-F238E27FC236}">
                  <a16:creationId xmlns:a16="http://schemas.microsoft.com/office/drawing/2014/main" id="{4130AA1C-6772-4B92-B3EA-5D372A66066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76356836"/>
                </p:ext>
              </p:extLst>
            </p:nvPr>
          </p:nvGraphicFramePr>
          <p:xfrm>
            <a:off x="1173317" y="704932"/>
            <a:ext cx="4690800" cy="19303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63F854D-1E6D-490A-9BE4-117EE32367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6407" r="4659" b="76853"/>
            <a:stretch/>
          </p:blipFill>
          <p:spPr>
            <a:xfrm>
              <a:off x="1623675" y="329884"/>
              <a:ext cx="4118613" cy="329815"/>
            </a:xfrm>
            <a:prstGeom prst="rect">
              <a:avLst/>
            </a:prstGeom>
          </p:spPr>
        </p:pic>
      </p:grp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64E9C05E-1D85-4659-8C00-D2FBCA1D6DFC}"/>
              </a:ext>
            </a:extLst>
          </p:cNvPr>
          <p:cNvCxnSpPr>
            <a:cxnSpLocks/>
          </p:cNvCxnSpPr>
          <p:nvPr/>
        </p:nvCxnSpPr>
        <p:spPr>
          <a:xfrm>
            <a:off x="2519094" y="822562"/>
            <a:ext cx="252918" cy="18015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37358724-4E44-42D7-A9B3-CEC8C5AB4901}"/>
              </a:ext>
            </a:extLst>
          </p:cNvPr>
          <p:cNvCxnSpPr>
            <a:cxnSpLocks/>
          </p:cNvCxnSpPr>
          <p:nvPr/>
        </p:nvCxnSpPr>
        <p:spPr>
          <a:xfrm flipV="1">
            <a:off x="4644216" y="1332931"/>
            <a:ext cx="261826" cy="14668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1800724E-7109-4764-8FA2-A52C361E2B1C}"/>
              </a:ext>
            </a:extLst>
          </p:cNvPr>
          <p:cNvCxnSpPr>
            <a:cxnSpLocks/>
          </p:cNvCxnSpPr>
          <p:nvPr/>
        </p:nvCxnSpPr>
        <p:spPr>
          <a:xfrm flipV="1">
            <a:off x="5216435" y="1408533"/>
            <a:ext cx="250765" cy="16879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0B7A7BFA-2910-4C1F-865B-2A5880E42632}"/>
              </a:ext>
            </a:extLst>
          </p:cNvPr>
          <p:cNvGrpSpPr/>
          <p:nvPr/>
        </p:nvGrpSpPr>
        <p:grpSpPr>
          <a:xfrm>
            <a:off x="6321052" y="341179"/>
            <a:ext cx="4690800" cy="2210432"/>
            <a:chOff x="6321052" y="341179"/>
            <a:chExt cx="4690800" cy="2210432"/>
          </a:xfrm>
        </p:grpSpPr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2D06C51B-E324-492B-82A8-A8AF684D00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84295"/>
            <a:stretch/>
          </p:blipFill>
          <p:spPr>
            <a:xfrm>
              <a:off x="6617499" y="341179"/>
              <a:ext cx="4223521" cy="329815"/>
            </a:xfrm>
            <a:prstGeom prst="rect">
              <a:avLst/>
            </a:prstGeom>
          </p:spPr>
        </p:pic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7E17DDA6-F543-4C34-A44B-DAD934BEBBD2}"/>
                </a:ext>
              </a:extLst>
            </p:cNvPr>
            <p:cNvGrpSpPr/>
            <p:nvPr/>
          </p:nvGrpSpPr>
          <p:grpSpPr>
            <a:xfrm>
              <a:off x="6321052" y="704932"/>
              <a:ext cx="4690800" cy="1846679"/>
              <a:chOff x="6321052" y="704932"/>
              <a:chExt cx="4690800" cy="1846679"/>
            </a:xfrm>
          </p:grpSpPr>
          <p:graphicFrame>
            <p:nvGraphicFramePr>
              <p:cNvPr id="124" name="Chart 123">
                <a:extLst>
                  <a:ext uri="{FF2B5EF4-FFF2-40B4-BE49-F238E27FC236}">
                    <a16:creationId xmlns:a16="http://schemas.microsoft.com/office/drawing/2014/main" id="{E83ACD5F-34BF-4441-AEAD-E58E360E9B0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95934879"/>
                  </p:ext>
                </p:extLst>
              </p:nvPr>
            </p:nvGraphicFramePr>
            <p:xfrm>
              <a:off x="6321052" y="704932"/>
              <a:ext cx="4690800" cy="184667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22" name="Star: 5 Points 121">
                <a:extLst>
                  <a:ext uri="{FF2B5EF4-FFF2-40B4-BE49-F238E27FC236}">
                    <a16:creationId xmlns:a16="http://schemas.microsoft.com/office/drawing/2014/main" id="{70CF4192-7342-4861-B6A5-A8193B091C2F}"/>
                  </a:ext>
                </a:extLst>
              </p:cNvPr>
              <p:cNvSpPr/>
              <p:nvPr/>
            </p:nvSpPr>
            <p:spPr>
              <a:xfrm>
                <a:off x="8014252" y="1042328"/>
                <a:ext cx="111705" cy="111705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3" name="Star: 5 Points 122">
                <a:extLst>
                  <a:ext uri="{FF2B5EF4-FFF2-40B4-BE49-F238E27FC236}">
                    <a16:creationId xmlns:a16="http://schemas.microsoft.com/office/drawing/2014/main" id="{235E9E7F-9A1A-445B-81EF-D11558B0D6AD}"/>
                  </a:ext>
                </a:extLst>
              </p:cNvPr>
              <p:cNvSpPr/>
              <p:nvPr/>
            </p:nvSpPr>
            <p:spPr>
              <a:xfrm>
                <a:off x="8545948" y="1038732"/>
                <a:ext cx="111705" cy="111705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81253078-4837-409E-A7D4-010AB4C2421E}"/>
              </a:ext>
            </a:extLst>
          </p:cNvPr>
          <p:cNvGrpSpPr/>
          <p:nvPr/>
        </p:nvGrpSpPr>
        <p:grpSpPr>
          <a:xfrm>
            <a:off x="1155737" y="2566651"/>
            <a:ext cx="4690800" cy="2093276"/>
            <a:chOff x="1155737" y="2566651"/>
            <a:chExt cx="4690800" cy="2093276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BBDAFFE-F3F7-4E30-A449-3C47E506BF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19040" b="86531"/>
            <a:stretch/>
          </p:blipFill>
          <p:spPr>
            <a:xfrm>
              <a:off x="1331993" y="2566651"/>
              <a:ext cx="3420466" cy="285708"/>
            </a:xfrm>
            <a:prstGeom prst="rect">
              <a:avLst/>
            </a:prstGeom>
          </p:spPr>
        </p:pic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DE9E3ED1-49BB-4A6E-A277-AB682A8A9C68}"/>
                </a:ext>
              </a:extLst>
            </p:cNvPr>
            <p:cNvGrpSpPr/>
            <p:nvPr/>
          </p:nvGrpSpPr>
          <p:grpSpPr>
            <a:xfrm>
              <a:off x="1155737" y="2894634"/>
              <a:ext cx="4690800" cy="1765293"/>
              <a:chOff x="1155737" y="2894634"/>
              <a:chExt cx="4690800" cy="1765293"/>
            </a:xfrm>
          </p:grpSpPr>
          <p:graphicFrame>
            <p:nvGraphicFramePr>
              <p:cNvPr id="125" name="Chart 124">
                <a:extLst>
                  <a:ext uri="{FF2B5EF4-FFF2-40B4-BE49-F238E27FC236}">
                    <a16:creationId xmlns:a16="http://schemas.microsoft.com/office/drawing/2014/main" id="{E9B5DEF7-419D-4349-B7C0-225D72E80FE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60913674"/>
                  </p:ext>
                </p:extLst>
              </p:nvPr>
            </p:nvGraphicFramePr>
            <p:xfrm>
              <a:off x="1155737" y="2894634"/>
              <a:ext cx="4690800" cy="17652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cxnSp>
            <p:nvCxnSpPr>
              <p:cNvPr id="127" name="Straight Arrow Connector 126">
                <a:extLst>
                  <a:ext uri="{FF2B5EF4-FFF2-40B4-BE49-F238E27FC236}">
                    <a16:creationId xmlns:a16="http://schemas.microsoft.com/office/drawing/2014/main" id="{F6F6BCB6-2D8E-4697-91D8-21706F8C14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5754" y="3286688"/>
                <a:ext cx="255769" cy="161669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Arrow Connector 127">
                <a:extLst>
                  <a:ext uri="{FF2B5EF4-FFF2-40B4-BE49-F238E27FC236}">
                    <a16:creationId xmlns:a16="http://schemas.microsoft.com/office/drawing/2014/main" id="{D60153B2-BF51-4623-960A-637891AE05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95287" y="3921706"/>
                <a:ext cx="261826" cy="146682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Arrow Connector 128">
                <a:extLst>
                  <a:ext uri="{FF2B5EF4-FFF2-40B4-BE49-F238E27FC236}">
                    <a16:creationId xmlns:a16="http://schemas.microsoft.com/office/drawing/2014/main" id="{2ECAC991-6443-457F-BC39-663CFD9A4B0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644216" y="3448357"/>
                <a:ext cx="261826" cy="146682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6763CA3C-201A-4873-9CA4-80BA93DBA08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028" r="8359" b="86531"/>
          <a:stretch/>
        </p:blipFill>
        <p:spPr>
          <a:xfrm>
            <a:off x="6857790" y="2533060"/>
            <a:ext cx="3717694" cy="285708"/>
          </a:xfrm>
          <a:prstGeom prst="rect">
            <a:avLst/>
          </a:prstGeom>
        </p:spPr>
      </p:pic>
      <p:cxnSp>
        <p:nvCxnSpPr>
          <p:cNvPr id="140" name="Straight Arrow Connector 139">
            <a:extLst>
              <a:ext uri="{FF2B5EF4-FFF2-40B4-BE49-F238E27FC236}">
                <a16:creationId xmlns:a16="http://schemas.microsoft.com/office/drawing/2014/main" id="{1CBCFE39-532F-42D1-BA0E-2170243DB4B7}"/>
              </a:ext>
            </a:extLst>
          </p:cNvPr>
          <p:cNvCxnSpPr>
            <a:cxnSpLocks/>
          </p:cNvCxnSpPr>
          <p:nvPr/>
        </p:nvCxnSpPr>
        <p:spPr>
          <a:xfrm>
            <a:off x="8241423" y="3602800"/>
            <a:ext cx="246091" cy="17374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CFE960A3-7212-4FE1-98D3-A9827B81BC3F}"/>
              </a:ext>
            </a:extLst>
          </p:cNvPr>
          <p:cNvCxnSpPr>
            <a:cxnSpLocks/>
          </p:cNvCxnSpPr>
          <p:nvPr/>
        </p:nvCxnSpPr>
        <p:spPr>
          <a:xfrm flipV="1">
            <a:off x="9280354" y="3730528"/>
            <a:ext cx="250723" cy="12274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A44F9520-00D3-4939-B1E9-6DE3DF46983E}"/>
              </a:ext>
            </a:extLst>
          </p:cNvPr>
          <p:cNvCxnSpPr>
            <a:cxnSpLocks/>
          </p:cNvCxnSpPr>
          <p:nvPr/>
        </p:nvCxnSpPr>
        <p:spPr>
          <a:xfrm flipV="1">
            <a:off x="9803704" y="3467025"/>
            <a:ext cx="270328" cy="14668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AEA7BEB8-F1C6-4542-A4DB-9A420062F650}"/>
              </a:ext>
            </a:extLst>
          </p:cNvPr>
          <p:cNvCxnSpPr>
            <a:cxnSpLocks/>
          </p:cNvCxnSpPr>
          <p:nvPr/>
        </p:nvCxnSpPr>
        <p:spPr>
          <a:xfrm>
            <a:off x="3109007" y="3220412"/>
            <a:ext cx="255769" cy="16166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29C0F9C2-71F3-4426-815D-C3E7DD87A450}"/>
              </a:ext>
            </a:extLst>
          </p:cNvPr>
          <p:cNvGrpSpPr/>
          <p:nvPr/>
        </p:nvGrpSpPr>
        <p:grpSpPr>
          <a:xfrm>
            <a:off x="1173317" y="4758803"/>
            <a:ext cx="4747114" cy="2024634"/>
            <a:chOff x="1173317" y="4758803"/>
            <a:chExt cx="4747114" cy="2024634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5E7F7E3C-6047-4699-899A-AAF7D12AE4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82805"/>
            <a:stretch/>
          </p:blipFill>
          <p:spPr>
            <a:xfrm>
              <a:off x="1665292" y="4758803"/>
              <a:ext cx="4255139" cy="336657"/>
            </a:xfrm>
            <a:prstGeom prst="rect">
              <a:avLst/>
            </a:prstGeom>
          </p:spPr>
        </p:pic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B3DA9B49-92AD-48D0-BBC2-18522192DFBE}"/>
                </a:ext>
              </a:extLst>
            </p:cNvPr>
            <p:cNvGrpSpPr/>
            <p:nvPr/>
          </p:nvGrpSpPr>
          <p:grpSpPr>
            <a:xfrm>
              <a:off x="1173317" y="5108815"/>
              <a:ext cx="4690800" cy="1674622"/>
              <a:chOff x="1173317" y="5108815"/>
              <a:chExt cx="4690800" cy="1674622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B24CDABA-840E-45AB-BDE5-7B38B4209EA0}"/>
                  </a:ext>
                </a:extLst>
              </p:cNvPr>
              <p:cNvSpPr/>
              <p:nvPr/>
            </p:nvSpPr>
            <p:spPr>
              <a:xfrm>
                <a:off x="3744166" y="5295520"/>
                <a:ext cx="97392" cy="1406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aphicFrame>
            <p:nvGraphicFramePr>
              <p:cNvPr id="149" name="Chart 148">
                <a:extLst>
                  <a:ext uri="{FF2B5EF4-FFF2-40B4-BE49-F238E27FC236}">
                    <a16:creationId xmlns:a16="http://schemas.microsoft.com/office/drawing/2014/main" id="{8824DC63-3AE6-42B9-829C-7FC848414FA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0440531"/>
                  </p:ext>
                </p:extLst>
              </p:nvPr>
            </p:nvGraphicFramePr>
            <p:xfrm>
              <a:off x="1173317" y="5108815"/>
              <a:ext cx="4690800" cy="16746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cxnSp>
            <p:nvCxnSpPr>
              <p:cNvPr id="153" name="Straight Arrow Connector 152">
                <a:extLst>
                  <a:ext uri="{FF2B5EF4-FFF2-40B4-BE49-F238E27FC236}">
                    <a16:creationId xmlns:a16="http://schemas.microsoft.com/office/drawing/2014/main" id="{1891CDAE-3E01-462C-8CEB-C046375274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4022" y="5274470"/>
                <a:ext cx="255769" cy="161669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Arrow Connector 153">
                <a:extLst>
                  <a:ext uri="{FF2B5EF4-FFF2-40B4-BE49-F238E27FC236}">
                    <a16:creationId xmlns:a16="http://schemas.microsoft.com/office/drawing/2014/main" id="{098C24F7-CA1D-4756-BC0D-7E7266C2C9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671972" y="5718549"/>
                <a:ext cx="261826" cy="146682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Arrow Connector 154">
                <a:extLst>
                  <a:ext uri="{FF2B5EF4-FFF2-40B4-BE49-F238E27FC236}">
                    <a16:creationId xmlns:a16="http://schemas.microsoft.com/office/drawing/2014/main" id="{DDD325D1-A34B-43A1-86E0-4C5F06E0E22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93153" y="5847586"/>
                <a:ext cx="261826" cy="146682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A6A69750-B30C-4EFA-A624-F10895D1CD46}"/>
              </a:ext>
            </a:extLst>
          </p:cNvPr>
          <p:cNvCxnSpPr>
            <a:cxnSpLocks/>
          </p:cNvCxnSpPr>
          <p:nvPr/>
        </p:nvCxnSpPr>
        <p:spPr>
          <a:xfrm flipV="1">
            <a:off x="10366940" y="4051558"/>
            <a:ext cx="225374" cy="4119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4BFF9ED-E8B5-41E8-A9B9-472A2CA6247F}"/>
              </a:ext>
            </a:extLst>
          </p:cNvPr>
          <p:cNvSpPr txBox="1"/>
          <p:nvPr/>
        </p:nvSpPr>
        <p:spPr>
          <a:xfrm>
            <a:off x="10860007" y="2566651"/>
            <a:ext cx="144465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I have re-</a:t>
            </a:r>
            <a:r>
              <a:rPr lang="en-GB" sz="1100" dirty="0" err="1">
                <a:solidFill>
                  <a:srgbClr val="FF0000"/>
                </a:solidFill>
              </a:rPr>
              <a:t>ploted</a:t>
            </a:r>
            <a:r>
              <a:rPr lang="en-GB" sz="1100" dirty="0">
                <a:solidFill>
                  <a:srgbClr val="FF0000"/>
                </a:solidFill>
              </a:rPr>
              <a:t> the DHA2015.4 data. Previously you rank-ordered by EPA content. Now it is based on DHA.</a:t>
            </a:r>
          </a:p>
          <a:p>
            <a:endParaRPr lang="en-GB" sz="1100" dirty="0">
              <a:solidFill>
                <a:srgbClr val="FF0000"/>
              </a:solidFill>
            </a:endParaRPr>
          </a:p>
          <a:p>
            <a:r>
              <a:rPr lang="en-GB" sz="1100" dirty="0">
                <a:solidFill>
                  <a:srgbClr val="FF0000"/>
                </a:solidFill>
              </a:rPr>
              <a:t>After the DHA rank-order, it seems the ARA does not have a clear trend. Should we delete the arrow? </a:t>
            </a:r>
          </a:p>
        </p:txBody>
      </p:sp>
    </p:spTree>
    <p:extLst>
      <p:ext uri="{BB962C8B-B14F-4D97-AF65-F5344CB8AC3E}">
        <p14:creationId xmlns:p14="http://schemas.microsoft.com/office/powerpoint/2010/main" val="29950478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86187C0B-AA88-4BFB-9CAB-FE846677CE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1663793"/>
              </p:ext>
            </p:extLst>
          </p:nvPr>
        </p:nvGraphicFramePr>
        <p:xfrm>
          <a:off x="6574122" y="529845"/>
          <a:ext cx="5130189" cy="2446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4123866A-7B65-4662-94B2-60D7F11E48E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363" r="27632" b="88921"/>
          <a:stretch/>
        </p:blipFill>
        <p:spPr>
          <a:xfrm>
            <a:off x="1717752" y="514042"/>
            <a:ext cx="2847097" cy="31981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A6F7F0B-E973-473A-9B8F-4DB953D717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701" r="17448" b="84272"/>
          <a:stretch/>
        </p:blipFill>
        <p:spPr>
          <a:xfrm>
            <a:off x="1740513" y="3319572"/>
            <a:ext cx="3449496" cy="37271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19CB86CA-C799-44CF-B789-5012C5B46C18}"/>
              </a:ext>
            </a:extLst>
          </p:cNvPr>
          <p:cNvSpPr/>
          <p:nvPr/>
        </p:nvSpPr>
        <p:spPr>
          <a:xfrm>
            <a:off x="522276" y="146848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b="1" dirty="0">
                <a:latin typeface="Calibri-Bold"/>
              </a:rPr>
              <a:t>Figure S8 </a:t>
            </a:r>
            <a:endParaRPr lang="en-GB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967C941-425A-4479-8DCB-99CD11C56E9C}"/>
              </a:ext>
            </a:extLst>
          </p:cNvPr>
          <p:cNvSpPr/>
          <p:nvPr/>
        </p:nvSpPr>
        <p:spPr>
          <a:xfrm>
            <a:off x="6866320" y="3466523"/>
            <a:ext cx="485528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sz="1400" b="1" dirty="0"/>
              <a:t>Figure S8   </a:t>
            </a:r>
            <a:r>
              <a:rPr lang="en-GB" altLang="zh-CN" sz="1400" dirty="0"/>
              <a:t>Single seed fatty acid composition analysis from the 2018 field trial  EPA2016.1, EPA2015.4 and EPA2015.8 lines. </a:t>
            </a:r>
            <a:endParaRPr lang="zh-CN" altLang="en-US" sz="1400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AB23F2A-85AD-41CA-91EF-4235849C5BE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86557"/>
          <a:stretch/>
        </p:blipFill>
        <p:spPr>
          <a:xfrm>
            <a:off x="6445235" y="490263"/>
            <a:ext cx="5045836" cy="384924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8BC8B294-2585-4FF0-981F-024808735719}"/>
              </a:ext>
            </a:extLst>
          </p:cNvPr>
          <p:cNvGrpSpPr/>
          <p:nvPr/>
        </p:nvGrpSpPr>
        <p:grpSpPr>
          <a:xfrm>
            <a:off x="979097" y="910051"/>
            <a:ext cx="5060406" cy="2126710"/>
            <a:chOff x="1289815" y="875187"/>
            <a:chExt cx="5252140" cy="2126710"/>
          </a:xfrm>
        </p:grpSpPr>
        <p:graphicFrame>
          <p:nvGraphicFramePr>
            <p:cNvPr id="14" name="Chart 13">
              <a:extLst>
                <a:ext uri="{FF2B5EF4-FFF2-40B4-BE49-F238E27FC236}">
                  <a16:creationId xmlns:a16="http://schemas.microsoft.com/office/drawing/2014/main" id="{F1A0778A-D61E-494E-A7C9-5155A0456FE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5939663"/>
                </p:ext>
              </p:extLst>
            </p:nvPr>
          </p:nvGraphicFramePr>
          <p:xfrm>
            <a:off x="1289815" y="875187"/>
            <a:ext cx="5252140" cy="2126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60F5F2FB-B71E-4CE8-A1F9-42C0436C27F2}"/>
                </a:ext>
              </a:extLst>
            </p:cNvPr>
            <p:cNvCxnSpPr>
              <a:cxnSpLocks/>
            </p:cNvCxnSpPr>
            <p:nvPr/>
          </p:nvCxnSpPr>
          <p:spPr>
            <a:xfrm>
              <a:off x="2761575" y="1492583"/>
              <a:ext cx="331541" cy="22727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3127970-B129-4086-B127-145C1B07DA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42696" y="1012701"/>
              <a:ext cx="322492" cy="299289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45FA6D30-F778-42F1-A239-1B3AD460F3CC}"/>
              </a:ext>
            </a:extLst>
          </p:cNvPr>
          <p:cNvCxnSpPr>
            <a:cxnSpLocks/>
          </p:cNvCxnSpPr>
          <p:nvPr/>
        </p:nvCxnSpPr>
        <p:spPr>
          <a:xfrm>
            <a:off x="8059881" y="1525493"/>
            <a:ext cx="290225" cy="23856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A74B455D-EA69-462B-AE87-62BC5D180877}"/>
              </a:ext>
            </a:extLst>
          </p:cNvPr>
          <p:cNvCxnSpPr>
            <a:cxnSpLocks/>
          </p:cNvCxnSpPr>
          <p:nvPr/>
        </p:nvCxnSpPr>
        <p:spPr>
          <a:xfrm>
            <a:off x="7735568" y="1392603"/>
            <a:ext cx="290225" cy="23856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A5B5B37-21FA-45C4-80D4-6B94DC6B7ABB}"/>
              </a:ext>
            </a:extLst>
          </p:cNvPr>
          <p:cNvCxnSpPr>
            <a:cxnSpLocks/>
          </p:cNvCxnSpPr>
          <p:nvPr/>
        </p:nvCxnSpPr>
        <p:spPr>
          <a:xfrm flipV="1">
            <a:off x="10628221" y="1135297"/>
            <a:ext cx="275039" cy="24962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A5EC01DD-4252-479C-8B7F-52929CC1B7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5332304"/>
              </p:ext>
            </p:extLst>
          </p:nvPr>
        </p:nvGraphicFramePr>
        <p:xfrm>
          <a:off x="979097" y="3728133"/>
          <a:ext cx="5060406" cy="2336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1601BC3-8B14-4A89-B3A6-30BE8CAF929D}"/>
              </a:ext>
            </a:extLst>
          </p:cNvPr>
          <p:cNvCxnSpPr>
            <a:cxnSpLocks/>
          </p:cNvCxnSpPr>
          <p:nvPr/>
        </p:nvCxnSpPr>
        <p:spPr>
          <a:xfrm>
            <a:off x="2426342" y="4439641"/>
            <a:ext cx="290225" cy="23856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C7644F2-2B5C-4E11-AB9F-5B322C973A60}"/>
              </a:ext>
            </a:extLst>
          </p:cNvPr>
          <p:cNvCxnSpPr>
            <a:cxnSpLocks/>
          </p:cNvCxnSpPr>
          <p:nvPr/>
        </p:nvCxnSpPr>
        <p:spPr>
          <a:xfrm>
            <a:off x="2043774" y="4264374"/>
            <a:ext cx="290225" cy="238563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7C86001F-595C-4863-8397-7F79FB940B6C}"/>
              </a:ext>
            </a:extLst>
          </p:cNvPr>
          <p:cNvCxnSpPr>
            <a:cxnSpLocks/>
          </p:cNvCxnSpPr>
          <p:nvPr/>
        </p:nvCxnSpPr>
        <p:spPr>
          <a:xfrm flipV="1">
            <a:off x="4994228" y="3836427"/>
            <a:ext cx="275039" cy="33094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7950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88</TotalTime>
  <Words>921</Words>
  <Application>Microsoft Office PowerPoint</Application>
  <PresentationFormat>Widescreen</PresentationFormat>
  <Paragraphs>25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Calibri-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athan Napier</dc:creator>
  <cp:lastModifiedBy>Johnathan Napier</cp:lastModifiedBy>
  <cp:revision>145</cp:revision>
  <cp:lastPrinted>2021-12-07T14:57:55Z</cp:lastPrinted>
  <dcterms:created xsi:type="dcterms:W3CDTF">2021-10-12T14:56:24Z</dcterms:created>
  <dcterms:modified xsi:type="dcterms:W3CDTF">2022-05-12T11:28:45Z</dcterms:modified>
</cp:coreProperties>
</file>